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  <p:sldId id="272" r:id="rId3"/>
  </p:sldIdLst>
  <p:sldSz cx="9906000" cy="6858000" type="A4"/>
  <p:notesSz cx="9144000" cy="6858000"/>
  <p:defaultTextStyle>
    <a:defPPr>
      <a:defRPr lang="de-DE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56" d="100"/>
          <a:sy n="156" d="100"/>
        </p:scale>
        <p:origin x="1572" y="13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\\Datastore01\Benutzer$\WolffA\AW\Assays\Trocknung\Logger%20Daten%20Temp%20und%20RLF\TTr6&amp;7%20und%20TTr8&amp;9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\\Datastore01\Benutzer$\WolffA\AW\Assays\Trocknung\Logger%20Daten%20Temp%20und%20RLF\TTr6&amp;7%20und%20TTr8&amp;9.xls" TargetMode="External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1"/>
          <c:order val="0"/>
          <c:tx>
            <c:strRef>
              <c:f>Tabelle1!$E$10</c:f>
              <c:strCache>
                <c:ptCount val="1"/>
                <c:pt idx="0">
                  <c:v>Temperature [°C]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2"/>
            <c:spPr>
              <a:solidFill>
                <a:schemeClr val="accent5"/>
              </a:solidFill>
              <a:ln>
                <a:solidFill>
                  <a:schemeClr val="accent5"/>
                </a:solidFill>
              </a:ln>
            </c:spPr>
          </c:marker>
          <c:xVal>
            <c:numRef>
              <c:f>Tabelle1!$C$13:$C$1351</c:f>
              <c:numCache>
                <c:formatCode>0.00000000000000000</c:formatCode>
                <c:ptCount val="1339"/>
                <c:pt idx="0">
                  <c:v>5.9523809523809521E-3</c:v>
                </c:pt>
                <c:pt idx="1">
                  <c:v>1.1904761904761904E-2</c:v>
                </c:pt>
                <c:pt idx="2">
                  <c:v>1.7857142857142856E-2</c:v>
                </c:pt>
                <c:pt idx="3">
                  <c:v>2.3809523809523808E-2</c:v>
                </c:pt>
                <c:pt idx="4">
                  <c:v>2.976190476190476E-2</c:v>
                </c:pt>
                <c:pt idx="5">
                  <c:v>3.5714285714285712E-2</c:v>
                </c:pt>
                <c:pt idx="6">
                  <c:v>4.1666666666666664E-2</c:v>
                </c:pt>
                <c:pt idx="7">
                  <c:v>4.7619047619047616E-2</c:v>
                </c:pt>
                <c:pt idx="8">
                  <c:v>5.3571428571428568E-2</c:v>
                </c:pt>
                <c:pt idx="9">
                  <c:v>5.9523809523809521E-2</c:v>
                </c:pt>
                <c:pt idx="10">
                  <c:v>6.5476190476190479E-2</c:v>
                </c:pt>
                <c:pt idx="11">
                  <c:v>7.1428571428571425E-2</c:v>
                </c:pt>
                <c:pt idx="12">
                  <c:v>7.7380952380952384E-2</c:v>
                </c:pt>
                <c:pt idx="13">
                  <c:v>8.3333333333333329E-2</c:v>
                </c:pt>
                <c:pt idx="14">
                  <c:v>8.9285714285714288E-2</c:v>
                </c:pt>
                <c:pt idx="15">
                  <c:v>9.5238095238095233E-2</c:v>
                </c:pt>
                <c:pt idx="16">
                  <c:v>0.10119047619047619</c:v>
                </c:pt>
                <c:pt idx="17">
                  <c:v>0.10714285714285714</c:v>
                </c:pt>
                <c:pt idx="18">
                  <c:v>0.1130952380952381</c:v>
                </c:pt>
                <c:pt idx="19">
                  <c:v>0.11904761904761904</c:v>
                </c:pt>
                <c:pt idx="20">
                  <c:v>0.125</c:v>
                </c:pt>
                <c:pt idx="21">
                  <c:v>0.13095238095238096</c:v>
                </c:pt>
                <c:pt idx="22">
                  <c:v>0.13690476190476192</c:v>
                </c:pt>
                <c:pt idx="23">
                  <c:v>0.14285714285714285</c:v>
                </c:pt>
                <c:pt idx="24">
                  <c:v>0.14880952380952381</c:v>
                </c:pt>
                <c:pt idx="25">
                  <c:v>0.15476190476190477</c:v>
                </c:pt>
                <c:pt idx="26">
                  <c:v>0.16071428571428573</c:v>
                </c:pt>
                <c:pt idx="27">
                  <c:v>0.16666666666666666</c:v>
                </c:pt>
                <c:pt idx="28">
                  <c:v>0.17261904761904762</c:v>
                </c:pt>
                <c:pt idx="29">
                  <c:v>0.17857142857142858</c:v>
                </c:pt>
                <c:pt idx="30">
                  <c:v>0.18452380952380953</c:v>
                </c:pt>
                <c:pt idx="31">
                  <c:v>0.19047619047619047</c:v>
                </c:pt>
                <c:pt idx="32">
                  <c:v>0.19642857142857142</c:v>
                </c:pt>
                <c:pt idx="33">
                  <c:v>0.20238095238095238</c:v>
                </c:pt>
                <c:pt idx="34">
                  <c:v>0.20833333333333334</c:v>
                </c:pt>
                <c:pt idx="35">
                  <c:v>0.21428571428571427</c:v>
                </c:pt>
                <c:pt idx="36">
                  <c:v>0.22023809523809523</c:v>
                </c:pt>
                <c:pt idx="37">
                  <c:v>0.22619047619047619</c:v>
                </c:pt>
                <c:pt idx="38">
                  <c:v>0.23214285714285715</c:v>
                </c:pt>
                <c:pt idx="39">
                  <c:v>0.23809523809523808</c:v>
                </c:pt>
                <c:pt idx="40">
                  <c:v>0.24404761904761904</c:v>
                </c:pt>
                <c:pt idx="41">
                  <c:v>0.25</c:v>
                </c:pt>
                <c:pt idx="42">
                  <c:v>0.25595238095238093</c:v>
                </c:pt>
                <c:pt idx="43">
                  <c:v>0.26190476190476192</c:v>
                </c:pt>
                <c:pt idx="44">
                  <c:v>0.26785714285714285</c:v>
                </c:pt>
                <c:pt idx="45">
                  <c:v>0.27380952380952384</c:v>
                </c:pt>
                <c:pt idx="46">
                  <c:v>0.27976190476190477</c:v>
                </c:pt>
                <c:pt idx="47">
                  <c:v>0.2857142857142857</c:v>
                </c:pt>
                <c:pt idx="48">
                  <c:v>0.29166666666666669</c:v>
                </c:pt>
                <c:pt idx="49">
                  <c:v>0.29761904761904762</c:v>
                </c:pt>
                <c:pt idx="50">
                  <c:v>0.30357142857142855</c:v>
                </c:pt>
                <c:pt idx="51">
                  <c:v>0.30952380952380953</c:v>
                </c:pt>
                <c:pt idx="52">
                  <c:v>0.31547619047619047</c:v>
                </c:pt>
                <c:pt idx="53">
                  <c:v>0.32142857142857145</c:v>
                </c:pt>
                <c:pt idx="54">
                  <c:v>0.32738095238095238</c:v>
                </c:pt>
                <c:pt idx="55">
                  <c:v>0.33333333333333331</c:v>
                </c:pt>
                <c:pt idx="56">
                  <c:v>0.3392857142857143</c:v>
                </c:pt>
                <c:pt idx="57">
                  <c:v>0.34523809523809523</c:v>
                </c:pt>
                <c:pt idx="58">
                  <c:v>0.35119047619047616</c:v>
                </c:pt>
                <c:pt idx="59">
                  <c:v>0.35714285714285715</c:v>
                </c:pt>
                <c:pt idx="60">
                  <c:v>0.36309523809523808</c:v>
                </c:pt>
                <c:pt idx="61">
                  <c:v>0.36904761904761907</c:v>
                </c:pt>
                <c:pt idx="62">
                  <c:v>0.375</c:v>
                </c:pt>
                <c:pt idx="63">
                  <c:v>0.38095238095238093</c:v>
                </c:pt>
                <c:pt idx="64">
                  <c:v>0.38690476190476192</c:v>
                </c:pt>
                <c:pt idx="65">
                  <c:v>0.39285714285714285</c:v>
                </c:pt>
                <c:pt idx="66">
                  <c:v>0.39880952380952384</c:v>
                </c:pt>
                <c:pt idx="67">
                  <c:v>0.40476190476190477</c:v>
                </c:pt>
                <c:pt idx="68">
                  <c:v>0.4107142857142857</c:v>
                </c:pt>
                <c:pt idx="69">
                  <c:v>0.41666666666666669</c:v>
                </c:pt>
                <c:pt idx="70">
                  <c:v>0.42261904761904762</c:v>
                </c:pt>
                <c:pt idx="71">
                  <c:v>0.42857142857142855</c:v>
                </c:pt>
                <c:pt idx="72">
                  <c:v>0.43452380952380953</c:v>
                </c:pt>
                <c:pt idx="73">
                  <c:v>0.44047619047619047</c:v>
                </c:pt>
                <c:pt idx="74">
                  <c:v>0.44642857142857145</c:v>
                </c:pt>
                <c:pt idx="75">
                  <c:v>0.45238095238095238</c:v>
                </c:pt>
                <c:pt idx="76">
                  <c:v>0.45833333333333331</c:v>
                </c:pt>
                <c:pt idx="77">
                  <c:v>0.4642857142857143</c:v>
                </c:pt>
                <c:pt idx="78">
                  <c:v>0.47023809523809523</c:v>
                </c:pt>
                <c:pt idx="79">
                  <c:v>0.47619047619047616</c:v>
                </c:pt>
                <c:pt idx="80">
                  <c:v>0.48214285714285715</c:v>
                </c:pt>
                <c:pt idx="81">
                  <c:v>0.48809523809523808</c:v>
                </c:pt>
                <c:pt idx="82">
                  <c:v>0.49404761904761907</c:v>
                </c:pt>
                <c:pt idx="83">
                  <c:v>0.5</c:v>
                </c:pt>
                <c:pt idx="84">
                  <c:v>0.50595238095238093</c:v>
                </c:pt>
                <c:pt idx="85">
                  <c:v>0.51190476190476186</c:v>
                </c:pt>
                <c:pt idx="86">
                  <c:v>0.5178571428571429</c:v>
                </c:pt>
                <c:pt idx="87">
                  <c:v>0.52380952380952384</c:v>
                </c:pt>
                <c:pt idx="88">
                  <c:v>0.52976190476190477</c:v>
                </c:pt>
                <c:pt idx="89">
                  <c:v>0.5357142857142857</c:v>
                </c:pt>
                <c:pt idx="90">
                  <c:v>0.54166666666666663</c:v>
                </c:pt>
                <c:pt idx="91">
                  <c:v>0.54761904761904767</c:v>
                </c:pt>
                <c:pt idx="92">
                  <c:v>0.5535714285714286</c:v>
                </c:pt>
                <c:pt idx="93">
                  <c:v>0.55952380952380953</c:v>
                </c:pt>
                <c:pt idx="94">
                  <c:v>0.56547619047619047</c:v>
                </c:pt>
                <c:pt idx="95">
                  <c:v>0.5714285714285714</c:v>
                </c:pt>
                <c:pt idx="96">
                  <c:v>0.57738095238095233</c:v>
                </c:pt>
                <c:pt idx="97">
                  <c:v>0.58333333333333337</c:v>
                </c:pt>
                <c:pt idx="98">
                  <c:v>0.5892857142857143</c:v>
                </c:pt>
                <c:pt idx="99">
                  <c:v>0.59523809523809523</c:v>
                </c:pt>
                <c:pt idx="100">
                  <c:v>0.60119047619047616</c:v>
                </c:pt>
                <c:pt idx="101">
                  <c:v>0.6071428571428571</c:v>
                </c:pt>
                <c:pt idx="102">
                  <c:v>0.61309523809523814</c:v>
                </c:pt>
                <c:pt idx="103">
                  <c:v>0.61904761904761907</c:v>
                </c:pt>
                <c:pt idx="104">
                  <c:v>0.625</c:v>
                </c:pt>
                <c:pt idx="105">
                  <c:v>0.63095238095238093</c:v>
                </c:pt>
                <c:pt idx="106">
                  <c:v>0.63690476190476186</c:v>
                </c:pt>
                <c:pt idx="107">
                  <c:v>0.6428571428571429</c:v>
                </c:pt>
                <c:pt idx="108">
                  <c:v>0.64880952380952384</c:v>
                </c:pt>
                <c:pt idx="109">
                  <c:v>0.65476190476190477</c:v>
                </c:pt>
                <c:pt idx="110">
                  <c:v>0.6607142857142857</c:v>
                </c:pt>
                <c:pt idx="111">
                  <c:v>0.66666666666666663</c:v>
                </c:pt>
                <c:pt idx="112">
                  <c:v>0.67261904761904767</c:v>
                </c:pt>
                <c:pt idx="113">
                  <c:v>0.6785714285714286</c:v>
                </c:pt>
                <c:pt idx="114">
                  <c:v>0.68452380952380953</c:v>
                </c:pt>
                <c:pt idx="115">
                  <c:v>0.69047619047619047</c:v>
                </c:pt>
                <c:pt idx="116">
                  <c:v>0.6964285714285714</c:v>
                </c:pt>
                <c:pt idx="117">
                  <c:v>0.70238095238095233</c:v>
                </c:pt>
                <c:pt idx="118">
                  <c:v>0.70833333333333337</c:v>
                </c:pt>
                <c:pt idx="119">
                  <c:v>0.7142857142857143</c:v>
                </c:pt>
                <c:pt idx="120">
                  <c:v>0.72023809523809523</c:v>
                </c:pt>
                <c:pt idx="121">
                  <c:v>0.72619047619047616</c:v>
                </c:pt>
                <c:pt idx="122">
                  <c:v>0.7321428571428571</c:v>
                </c:pt>
                <c:pt idx="123">
                  <c:v>0.73809523809523814</c:v>
                </c:pt>
                <c:pt idx="124">
                  <c:v>0.74404761904761907</c:v>
                </c:pt>
                <c:pt idx="125">
                  <c:v>0.75</c:v>
                </c:pt>
                <c:pt idx="126">
                  <c:v>0.75595238095238093</c:v>
                </c:pt>
                <c:pt idx="127">
                  <c:v>0.76190476190476186</c:v>
                </c:pt>
                <c:pt idx="128">
                  <c:v>0.7678571428571429</c:v>
                </c:pt>
                <c:pt idx="129">
                  <c:v>0.77380952380952384</c:v>
                </c:pt>
                <c:pt idx="130">
                  <c:v>0.77976190476190477</c:v>
                </c:pt>
                <c:pt idx="131">
                  <c:v>0.7857142857142857</c:v>
                </c:pt>
                <c:pt idx="132">
                  <c:v>0.79166666666666663</c:v>
                </c:pt>
                <c:pt idx="133">
                  <c:v>0.79761904761904767</c:v>
                </c:pt>
                <c:pt idx="134">
                  <c:v>0.8035714285714286</c:v>
                </c:pt>
                <c:pt idx="135">
                  <c:v>0.80952380952380953</c:v>
                </c:pt>
                <c:pt idx="136">
                  <c:v>0.81547619047619047</c:v>
                </c:pt>
                <c:pt idx="137">
                  <c:v>0.8214285714285714</c:v>
                </c:pt>
                <c:pt idx="138">
                  <c:v>0.82738095238095233</c:v>
                </c:pt>
                <c:pt idx="139">
                  <c:v>0.83333333333333337</c:v>
                </c:pt>
                <c:pt idx="140">
                  <c:v>0.8392857142857143</c:v>
                </c:pt>
                <c:pt idx="141">
                  <c:v>0.84523809523809523</c:v>
                </c:pt>
                <c:pt idx="142">
                  <c:v>0.85119047619047616</c:v>
                </c:pt>
                <c:pt idx="143">
                  <c:v>0.8571428571428571</c:v>
                </c:pt>
                <c:pt idx="144">
                  <c:v>0.86309523809523814</c:v>
                </c:pt>
                <c:pt idx="145">
                  <c:v>0.86904761904761907</c:v>
                </c:pt>
                <c:pt idx="146">
                  <c:v>0.875</c:v>
                </c:pt>
                <c:pt idx="147">
                  <c:v>0.88095238095238093</c:v>
                </c:pt>
                <c:pt idx="148">
                  <c:v>0.88690476190476186</c:v>
                </c:pt>
                <c:pt idx="149">
                  <c:v>0.8928571428571429</c:v>
                </c:pt>
                <c:pt idx="150">
                  <c:v>0.89880952380952384</c:v>
                </c:pt>
                <c:pt idx="151">
                  <c:v>0.90476190476190477</c:v>
                </c:pt>
                <c:pt idx="152">
                  <c:v>0.9107142857142857</c:v>
                </c:pt>
                <c:pt idx="153">
                  <c:v>0.91666666666666663</c:v>
                </c:pt>
                <c:pt idx="154">
                  <c:v>0.92261904761904767</c:v>
                </c:pt>
                <c:pt idx="155">
                  <c:v>0.9285714285714286</c:v>
                </c:pt>
                <c:pt idx="156">
                  <c:v>0.93452380952380953</c:v>
                </c:pt>
                <c:pt idx="157">
                  <c:v>0.94047619047619047</c:v>
                </c:pt>
                <c:pt idx="158">
                  <c:v>0.9464285714285714</c:v>
                </c:pt>
                <c:pt idx="159">
                  <c:v>0.95238095238095233</c:v>
                </c:pt>
                <c:pt idx="160">
                  <c:v>0.95833333333333337</c:v>
                </c:pt>
                <c:pt idx="161">
                  <c:v>0.9642857142857143</c:v>
                </c:pt>
                <c:pt idx="162">
                  <c:v>0.97023809523809523</c:v>
                </c:pt>
                <c:pt idx="163">
                  <c:v>0.97619047619047616</c:v>
                </c:pt>
                <c:pt idx="164">
                  <c:v>0.9821428571428571</c:v>
                </c:pt>
                <c:pt idx="165">
                  <c:v>0.98809523809523814</c:v>
                </c:pt>
                <c:pt idx="166">
                  <c:v>0.99404761904761907</c:v>
                </c:pt>
                <c:pt idx="167">
                  <c:v>1</c:v>
                </c:pt>
                <c:pt idx="168">
                  <c:v>1.0059523809523809</c:v>
                </c:pt>
                <c:pt idx="169">
                  <c:v>1.0119047619047619</c:v>
                </c:pt>
                <c:pt idx="170">
                  <c:v>1.0178571428571428</c:v>
                </c:pt>
                <c:pt idx="171">
                  <c:v>1.0238095238095237</c:v>
                </c:pt>
                <c:pt idx="172">
                  <c:v>1.0297619047619047</c:v>
                </c:pt>
                <c:pt idx="173">
                  <c:v>1.0357142857142858</c:v>
                </c:pt>
                <c:pt idx="174">
                  <c:v>1.0416666666666667</c:v>
                </c:pt>
                <c:pt idx="175">
                  <c:v>1.0476190476190477</c:v>
                </c:pt>
                <c:pt idx="176">
                  <c:v>1.0535714285714286</c:v>
                </c:pt>
                <c:pt idx="177">
                  <c:v>1.0595238095238095</c:v>
                </c:pt>
                <c:pt idx="178">
                  <c:v>1.0654761904761905</c:v>
                </c:pt>
                <c:pt idx="179">
                  <c:v>1.0714285714285714</c:v>
                </c:pt>
                <c:pt idx="180">
                  <c:v>1.0773809523809523</c:v>
                </c:pt>
                <c:pt idx="181">
                  <c:v>1.0833333333333333</c:v>
                </c:pt>
                <c:pt idx="182">
                  <c:v>1.0892857142857142</c:v>
                </c:pt>
                <c:pt idx="183">
                  <c:v>1.0952380952380953</c:v>
                </c:pt>
                <c:pt idx="184">
                  <c:v>1.1011904761904763</c:v>
                </c:pt>
                <c:pt idx="185">
                  <c:v>1.1071428571428572</c:v>
                </c:pt>
                <c:pt idx="186">
                  <c:v>1.1130952380952381</c:v>
                </c:pt>
                <c:pt idx="187">
                  <c:v>1.1190476190476191</c:v>
                </c:pt>
                <c:pt idx="188">
                  <c:v>1.125</c:v>
                </c:pt>
                <c:pt idx="189">
                  <c:v>1.1309523809523809</c:v>
                </c:pt>
                <c:pt idx="190">
                  <c:v>1.1369047619047619</c:v>
                </c:pt>
                <c:pt idx="191">
                  <c:v>1.1428571428571428</c:v>
                </c:pt>
                <c:pt idx="192">
                  <c:v>1.1488095238095237</c:v>
                </c:pt>
                <c:pt idx="193">
                  <c:v>1.1547619047619047</c:v>
                </c:pt>
                <c:pt idx="194">
                  <c:v>1.1607142857142858</c:v>
                </c:pt>
                <c:pt idx="195">
                  <c:v>1.1666666666666667</c:v>
                </c:pt>
                <c:pt idx="196">
                  <c:v>1.1726190476190477</c:v>
                </c:pt>
                <c:pt idx="197">
                  <c:v>1.1785714285714286</c:v>
                </c:pt>
                <c:pt idx="198">
                  <c:v>1.1845238095238095</c:v>
                </c:pt>
                <c:pt idx="199">
                  <c:v>1.1904761904761905</c:v>
                </c:pt>
                <c:pt idx="200">
                  <c:v>1.1964285714285714</c:v>
                </c:pt>
                <c:pt idx="201">
                  <c:v>1.2023809523809523</c:v>
                </c:pt>
                <c:pt idx="202">
                  <c:v>1.2083333333333333</c:v>
                </c:pt>
                <c:pt idx="203">
                  <c:v>1.2142857142857142</c:v>
                </c:pt>
                <c:pt idx="204">
                  <c:v>1.2202380952380953</c:v>
                </c:pt>
                <c:pt idx="205">
                  <c:v>1.2261904761904763</c:v>
                </c:pt>
                <c:pt idx="206">
                  <c:v>1.2321428571428572</c:v>
                </c:pt>
                <c:pt idx="207">
                  <c:v>1.2380952380952381</c:v>
                </c:pt>
                <c:pt idx="208">
                  <c:v>1.2440476190476191</c:v>
                </c:pt>
                <c:pt idx="209">
                  <c:v>1.25</c:v>
                </c:pt>
                <c:pt idx="210">
                  <c:v>1.2559523809523809</c:v>
                </c:pt>
                <c:pt idx="211">
                  <c:v>1.2619047619047619</c:v>
                </c:pt>
                <c:pt idx="212">
                  <c:v>1.2678571428571428</c:v>
                </c:pt>
                <c:pt idx="213">
                  <c:v>1.2738095238095237</c:v>
                </c:pt>
                <c:pt idx="214">
                  <c:v>1.2797619047619047</c:v>
                </c:pt>
                <c:pt idx="215">
                  <c:v>1.2857142857142858</c:v>
                </c:pt>
                <c:pt idx="216">
                  <c:v>1.2916666666666667</c:v>
                </c:pt>
                <c:pt idx="217">
                  <c:v>1.2976190476190477</c:v>
                </c:pt>
                <c:pt idx="218">
                  <c:v>1.3035714285714286</c:v>
                </c:pt>
                <c:pt idx="219">
                  <c:v>1.3095238095238095</c:v>
                </c:pt>
                <c:pt idx="220">
                  <c:v>1.3154761904761905</c:v>
                </c:pt>
                <c:pt idx="221">
                  <c:v>1.3214285714285714</c:v>
                </c:pt>
                <c:pt idx="222">
                  <c:v>1.3273809523809523</c:v>
                </c:pt>
                <c:pt idx="223">
                  <c:v>1.3333333333333333</c:v>
                </c:pt>
                <c:pt idx="224">
                  <c:v>1.3392857142857142</c:v>
                </c:pt>
                <c:pt idx="225">
                  <c:v>1.3452380952380953</c:v>
                </c:pt>
                <c:pt idx="226">
                  <c:v>1.3511904761904763</c:v>
                </c:pt>
                <c:pt idx="227">
                  <c:v>1.3571428571428572</c:v>
                </c:pt>
                <c:pt idx="228">
                  <c:v>1.3630952380952381</c:v>
                </c:pt>
                <c:pt idx="229">
                  <c:v>1.3690476190476191</c:v>
                </c:pt>
                <c:pt idx="230">
                  <c:v>1.375</c:v>
                </c:pt>
                <c:pt idx="231">
                  <c:v>1.3809523809523809</c:v>
                </c:pt>
                <c:pt idx="232">
                  <c:v>1.3869047619047619</c:v>
                </c:pt>
                <c:pt idx="233">
                  <c:v>1.3928571428571428</c:v>
                </c:pt>
                <c:pt idx="234">
                  <c:v>1.3988095238095237</c:v>
                </c:pt>
                <c:pt idx="235">
                  <c:v>1.4047619047619047</c:v>
                </c:pt>
                <c:pt idx="236">
                  <c:v>1.4107142857142858</c:v>
                </c:pt>
                <c:pt idx="237">
                  <c:v>1.4166666666666667</c:v>
                </c:pt>
                <c:pt idx="238">
                  <c:v>1.4226190476190477</c:v>
                </c:pt>
                <c:pt idx="239">
                  <c:v>1.4285714285714286</c:v>
                </c:pt>
                <c:pt idx="240">
                  <c:v>1.4345238095238095</c:v>
                </c:pt>
                <c:pt idx="241">
                  <c:v>1.4404761904761905</c:v>
                </c:pt>
                <c:pt idx="242">
                  <c:v>1.4464285714285714</c:v>
                </c:pt>
                <c:pt idx="243">
                  <c:v>1.4523809523809523</c:v>
                </c:pt>
                <c:pt idx="244">
                  <c:v>1.4583333333333333</c:v>
                </c:pt>
                <c:pt idx="245">
                  <c:v>1.4642857142857142</c:v>
                </c:pt>
                <c:pt idx="246">
                  <c:v>1.4702380952380953</c:v>
                </c:pt>
                <c:pt idx="247">
                  <c:v>1.4761904761904763</c:v>
                </c:pt>
                <c:pt idx="248">
                  <c:v>1.4821428571428572</c:v>
                </c:pt>
                <c:pt idx="249">
                  <c:v>1.4880952380952381</c:v>
                </c:pt>
                <c:pt idx="250">
                  <c:v>1.4940476190476191</c:v>
                </c:pt>
                <c:pt idx="251">
                  <c:v>1.5</c:v>
                </c:pt>
                <c:pt idx="252">
                  <c:v>1.5059523809523809</c:v>
                </c:pt>
                <c:pt idx="253">
                  <c:v>1.5119047619047619</c:v>
                </c:pt>
                <c:pt idx="254">
                  <c:v>1.5178571428571428</c:v>
                </c:pt>
                <c:pt idx="255">
                  <c:v>1.5238095238095237</c:v>
                </c:pt>
                <c:pt idx="256">
                  <c:v>1.5297619047619047</c:v>
                </c:pt>
                <c:pt idx="257">
                  <c:v>1.5357142857142858</c:v>
                </c:pt>
                <c:pt idx="258">
                  <c:v>1.5416666666666667</c:v>
                </c:pt>
                <c:pt idx="259">
                  <c:v>1.5476190476190477</c:v>
                </c:pt>
                <c:pt idx="260">
                  <c:v>1.5535714285714286</c:v>
                </c:pt>
                <c:pt idx="261">
                  <c:v>1.5595238095238095</c:v>
                </c:pt>
                <c:pt idx="262">
                  <c:v>1.5654761904761905</c:v>
                </c:pt>
                <c:pt idx="263">
                  <c:v>1.5714285714285714</c:v>
                </c:pt>
                <c:pt idx="264">
                  <c:v>1.5773809523809523</c:v>
                </c:pt>
                <c:pt idx="265">
                  <c:v>1.5833333333333333</c:v>
                </c:pt>
                <c:pt idx="266">
                  <c:v>1.5892857142857142</c:v>
                </c:pt>
                <c:pt idx="267">
                  <c:v>1.5952380952380953</c:v>
                </c:pt>
                <c:pt idx="268">
                  <c:v>1.6011904761904763</c:v>
                </c:pt>
                <c:pt idx="269">
                  <c:v>1.6071428571428572</c:v>
                </c:pt>
                <c:pt idx="270">
                  <c:v>1.6130952380952381</c:v>
                </c:pt>
                <c:pt idx="271">
                  <c:v>1.6190476190476191</c:v>
                </c:pt>
                <c:pt idx="272">
                  <c:v>1.625</c:v>
                </c:pt>
                <c:pt idx="273">
                  <c:v>1.6309523809523809</c:v>
                </c:pt>
                <c:pt idx="274">
                  <c:v>1.6369047619047619</c:v>
                </c:pt>
                <c:pt idx="275">
                  <c:v>1.6428571428571428</c:v>
                </c:pt>
                <c:pt idx="276">
                  <c:v>1.6488095238095237</c:v>
                </c:pt>
                <c:pt idx="277">
                  <c:v>1.6547619047619047</c:v>
                </c:pt>
                <c:pt idx="278">
                  <c:v>1.6607142857142858</c:v>
                </c:pt>
                <c:pt idx="279">
                  <c:v>1.6666666666666667</c:v>
                </c:pt>
                <c:pt idx="280">
                  <c:v>1.6726190476190477</c:v>
                </c:pt>
                <c:pt idx="281">
                  <c:v>1.6785714285714286</c:v>
                </c:pt>
                <c:pt idx="282">
                  <c:v>1.6845238095238095</c:v>
                </c:pt>
                <c:pt idx="283">
                  <c:v>1.6904761904761905</c:v>
                </c:pt>
                <c:pt idx="284">
                  <c:v>1.6964285714285714</c:v>
                </c:pt>
                <c:pt idx="285">
                  <c:v>1.7023809523809523</c:v>
                </c:pt>
                <c:pt idx="286">
                  <c:v>1.7083333333333333</c:v>
                </c:pt>
                <c:pt idx="287">
                  <c:v>1.7142857142857142</c:v>
                </c:pt>
                <c:pt idx="288">
                  <c:v>1.7202380952380953</c:v>
                </c:pt>
                <c:pt idx="289">
                  <c:v>1.7261904761904763</c:v>
                </c:pt>
                <c:pt idx="290">
                  <c:v>1.7321428571428572</c:v>
                </c:pt>
                <c:pt idx="291">
                  <c:v>1.7380952380952381</c:v>
                </c:pt>
                <c:pt idx="292">
                  <c:v>1.7440476190476191</c:v>
                </c:pt>
                <c:pt idx="293">
                  <c:v>1.75</c:v>
                </c:pt>
                <c:pt idx="294">
                  <c:v>1.7559523809523809</c:v>
                </c:pt>
                <c:pt idx="295">
                  <c:v>1.7619047619047619</c:v>
                </c:pt>
                <c:pt idx="296">
                  <c:v>1.7678571428571428</c:v>
                </c:pt>
                <c:pt idx="297">
                  <c:v>1.7738095238095237</c:v>
                </c:pt>
                <c:pt idx="298">
                  <c:v>1.7797619047619047</c:v>
                </c:pt>
                <c:pt idx="299">
                  <c:v>1.7857142857142858</c:v>
                </c:pt>
                <c:pt idx="300">
                  <c:v>1.7916666666666667</c:v>
                </c:pt>
                <c:pt idx="301">
                  <c:v>1.7976190476190477</c:v>
                </c:pt>
                <c:pt idx="302">
                  <c:v>1.8035714285714286</c:v>
                </c:pt>
                <c:pt idx="303">
                  <c:v>1.8095238095238095</c:v>
                </c:pt>
                <c:pt idx="304">
                  <c:v>1.8154761904761905</c:v>
                </c:pt>
                <c:pt idx="305">
                  <c:v>1.8214285714285714</c:v>
                </c:pt>
                <c:pt idx="306">
                  <c:v>1.8273809523809523</c:v>
                </c:pt>
                <c:pt idx="307">
                  <c:v>1.8333333333333333</c:v>
                </c:pt>
                <c:pt idx="308">
                  <c:v>1.8392857142857142</c:v>
                </c:pt>
                <c:pt idx="309">
                  <c:v>1.8452380952380953</c:v>
                </c:pt>
                <c:pt idx="310">
                  <c:v>1.8511904761904763</c:v>
                </c:pt>
                <c:pt idx="311">
                  <c:v>1.8571428571428572</c:v>
                </c:pt>
                <c:pt idx="312">
                  <c:v>1.8630952380952381</c:v>
                </c:pt>
                <c:pt idx="313">
                  <c:v>1.8690476190476191</c:v>
                </c:pt>
                <c:pt idx="314">
                  <c:v>1.875</c:v>
                </c:pt>
                <c:pt idx="315">
                  <c:v>1.8809523809523809</c:v>
                </c:pt>
                <c:pt idx="316">
                  <c:v>1.8869047619047619</c:v>
                </c:pt>
                <c:pt idx="317">
                  <c:v>1.8928571428571428</c:v>
                </c:pt>
                <c:pt idx="318">
                  <c:v>1.8988095238095237</c:v>
                </c:pt>
                <c:pt idx="319">
                  <c:v>1.9047619047619047</c:v>
                </c:pt>
                <c:pt idx="320">
                  <c:v>1.9107142857142858</c:v>
                </c:pt>
                <c:pt idx="321">
                  <c:v>1.9166666666666667</c:v>
                </c:pt>
                <c:pt idx="322">
                  <c:v>1.9226190476190477</c:v>
                </c:pt>
                <c:pt idx="323">
                  <c:v>1.9285714285714286</c:v>
                </c:pt>
                <c:pt idx="324">
                  <c:v>1.9345238095238095</c:v>
                </c:pt>
                <c:pt idx="325">
                  <c:v>1.9404761904761905</c:v>
                </c:pt>
                <c:pt idx="326">
                  <c:v>1.9464285714285714</c:v>
                </c:pt>
                <c:pt idx="327">
                  <c:v>1.9523809523809523</c:v>
                </c:pt>
                <c:pt idx="328">
                  <c:v>1.9583333333333333</c:v>
                </c:pt>
                <c:pt idx="329">
                  <c:v>1.9642857142857142</c:v>
                </c:pt>
                <c:pt idx="330">
                  <c:v>1.9702380952380953</c:v>
                </c:pt>
                <c:pt idx="331">
                  <c:v>1.9761904761904763</c:v>
                </c:pt>
                <c:pt idx="332">
                  <c:v>1.9821428571428572</c:v>
                </c:pt>
                <c:pt idx="333">
                  <c:v>1.9880952380952381</c:v>
                </c:pt>
                <c:pt idx="334">
                  <c:v>1.9940476190476191</c:v>
                </c:pt>
                <c:pt idx="335">
                  <c:v>2</c:v>
                </c:pt>
                <c:pt idx="336">
                  <c:v>2.0059523809523809</c:v>
                </c:pt>
                <c:pt idx="337">
                  <c:v>2.0119047619047619</c:v>
                </c:pt>
                <c:pt idx="338">
                  <c:v>2.0178571428571428</c:v>
                </c:pt>
                <c:pt idx="339">
                  <c:v>2.0238095238095237</c:v>
                </c:pt>
                <c:pt idx="340">
                  <c:v>2.0297619047619047</c:v>
                </c:pt>
                <c:pt idx="341">
                  <c:v>2.0357142857142856</c:v>
                </c:pt>
                <c:pt idx="342">
                  <c:v>2.0416666666666665</c:v>
                </c:pt>
                <c:pt idx="343">
                  <c:v>2.0476190476190474</c:v>
                </c:pt>
                <c:pt idx="344">
                  <c:v>2.0535714285714284</c:v>
                </c:pt>
                <c:pt idx="345">
                  <c:v>2.0595238095238093</c:v>
                </c:pt>
                <c:pt idx="346">
                  <c:v>2.0654761904761907</c:v>
                </c:pt>
                <c:pt idx="347">
                  <c:v>2.0714285714285716</c:v>
                </c:pt>
                <c:pt idx="348">
                  <c:v>2.0773809523809526</c:v>
                </c:pt>
                <c:pt idx="349">
                  <c:v>2.0833333333333335</c:v>
                </c:pt>
                <c:pt idx="350">
                  <c:v>2.0892857142857144</c:v>
                </c:pt>
                <c:pt idx="351">
                  <c:v>2.0952380952380953</c:v>
                </c:pt>
                <c:pt idx="352">
                  <c:v>2.1011904761904763</c:v>
                </c:pt>
                <c:pt idx="353">
                  <c:v>2.1071428571428572</c:v>
                </c:pt>
                <c:pt idx="354">
                  <c:v>2.1130952380952381</c:v>
                </c:pt>
                <c:pt idx="355">
                  <c:v>2.1190476190476191</c:v>
                </c:pt>
                <c:pt idx="356">
                  <c:v>2.125</c:v>
                </c:pt>
                <c:pt idx="357">
                  <c:v>2.1309523809523809</c:v>
                </c:pt>
                <c:pt idx="358">
                  <c:v>2.1369047619047619</c:v>
                </c:pt>
                <c:pt idx="359">
                  <c:v>2.1428571428571428</c:v>
                </c:pt>
                <c:pt idx="360">
                  <c:v>2.1488095238095237</c:v>
                </c:pt>
                <c:pt idx="361">
                  <c:v>2.1547619047619047</c:v>
                </c:pt>
                <c:pt idx="362">
                  <c:v>2.1607142857142856</c:v>
                </c:pt>
                <c:pt idx="363">
                  <c:v>2.1666666666666665</c:v>
                </c:pt>
                <c:pt idx="364">
                  <c:v>2.1726190476190474</c:v>
                </c:pt>
                <c:pt idx="365">
                  <c:v>2.1785714285714284</c:v>
                </c:pt>
                <c:pt idx="366">
                  <c:v>2.1845238095238093</c:v>
                </c:pt>
                <c:pt idx="367">
                  <c:v>2.1904761904761907</c:v>
                </c:pt>
                <c:pt idx="368">
                  <c:v>2.1964285714285716</c:v>
                </c:pt>
                <c:pt idx="369">
                  <c:v>2.2023809523809526</c:v>
                </c:pt>
                <c:pt idx="370">
                  <c:v>2.2083333333333335</c:v>
                </c:pt>
                <c:pt idx="371">
                  <c:v>2.2142857142857144</c:v>
                </c:pt>
                <c:pt idx="372">
                  <c:v>2.2202380952380953</c:v>
                </c:pt>
                <c:pt idx="373">
                  <c:v>2.2261904761904763</c:v>
                </c:pt>
                <c:pt idx="374">
                  <c:v>2.2321428571428572</c:v>
                </c:pt>
                <c:pt idx="375">
                  <c:v>2.2380952380952381</c:v>
                </c:pt>
                <c:pt idx="376">
                  <c:v>2.2440476190476191</c:v>
                </c:pt>
                <c:pt idx="377">
                  <c:v>2.25</c:v>
                </c:pt>
                <c:pt idx="378">
                  <c:v>2.2559523809523809</c:v>
                </c:pt>
                <c:pt idx="379">
                  <c:v>2.2619047619047619</c:v>
                </c:pt>
                <c:pt idx="380">
                  <c:v>2.2678571428571428</c:v>
                </c:pt>
                <c:pt idx="381">
                  <c:v>2.2738095238095237</c:v>
                </c:pt>
                <c:pt idx="382">
                  <c:v>2.2797619047619047</c:v>
                </c:pt>
                <c:pt idx="383">
                  <c:v>2.2857142857142856</c:v>
                </c:pt>
                <c:pt idx="384">
                  <c:v>2.2916666666666665</c:v>
                </c:pt>
                <c:pt idx="385">
                  <c:v>2.2976190476190474</c:v>
                </c:pt>
                <c:pt idx="386">
                  <c:v>2.3035714285714284</c:v>
                </c:pt>
                <c:pt idx="387">
                  <c:v>2.3095238095238093</c:v>
                </c:pt>
                <c:pt idx="388">
                  <c:v>2.3154761904761907</c:v>
                </c:pt>
                <c:pt idx="389">
                  <c:v>2.3214285714285716</c:v>
                </c:pt>
                <c:pt idx="390">
                  <c:v>2.3273809523809526</c:v>
                </c:pt>
                <c:pt idx="391">
                  <c:v>2.3333333333333335</c:v>
                </c:pt>
                <c:pt idx="392">
                  <c:v>2.3392857142857144</c:v>
                </c:pt>
                <c:pt idx="393">
                  <c:v>2.3452380952380953</c:v>
                </c:pt>
                <c:pt idx="394">
                  <c:v>2.3511904761904763</c:v>
                </c:pt>
                <c:pt idx="395">
                  <c:v>2.3571428571428572</c:v>
                </c:pt>
                <c:pt idx="396">
                  <c:v>2.3630952380952381</c:v>
                </c:pt>
                <c:pt idx="397">
                  <c:v>2.3690476190476191</c:v>
                </c:pt>
                <c:pt idx="398">
                  <c:v>2.375</c:v>
                </c:pt>
                <c:pt idx="399">
                  <c:v>2.3809523809523809</c:v>
                </c:pt>
                <c:pt idx="400">
                  <c:v>2.3869047619047619</c:v>
                </c:pt>
                <c:pt idx="401">
                  <c:v>2.3928571428571428</c:v>
                </c:pt>
                <c:pt idx="402">
                  <c:v>2.3988095238095237</c:v>
                </c:pt>
                <c:pt idx="403">
                  <c:v>2.4047619047619047</c:v>
                </c:pt>
                <c:pt idx="404">
                  <c:v>2.4107142857142856</c:v>
                </c:pt>
                <c:pt idx="405">
                  <c:v>2.4166666666666665</c:v>
                </c:pt>
                <c:pt idx="406">
                  <c:v>2.4226190476190474</c:v>
                </c:pt>
                <c:pt idx="407">
                  <c:v>2.4285714285714284</c:v>
                </c:pt>
                <c:pt idx="408">
                  <c:v>2.4345238095238093</c:v>
                </c:pt>
                <c:pt idx="409">
                  <c:v>2.4404761904761907</c:v>
                </c:pt>
                <c:pt idx="410">
                  <c:v>2.4464285714285716</c:v>
                </c:pt>
                <c:pt idx="411">
                  <c:v>2.4523809523809526</c:v>
                </c:pt>
                <c:pt idx="412">
                  <c:v>2.4583333333333335</c:v>
                </c:pt>
                <c:pt idx="413">
                  <c:v>2.4642857142857144</c:v>
                </c:pt>
                <c:pt idx="414">
                  <c:v>2.4702380952380953</c:v>
                </c:pt>
                <c:pt idx="415">
                  <c:v>2.4761904761904763</c:v>
                </c:pt>
                <c:pt idx="416">
                  <c:v>2.4821428571428572</c:v>
                </c:pt>
                <c:pt idx="417">
                  <c:v>2.4880952380952381</c:v>
                </c:pt>
                <c:pt idx="418">
                  <c:v>2.4940476190476191</c:v>
                </c:pt>
                <c:pt idx="419">
                  <c:v>2.5</c:v>
                </c:pt>
                <c:pt idx="420">
                  <c:v>2.5059523809523809</c:v>
                </c:pt>
                <c:pt idx="421">
                  <c:v>2.5119047619047619</c:v>
                </c:pt>
                <c:pt idx="422">
                  <c:v>2.5178571428571428</c:v>
                </c:pt>
                <c:pt idx="423">
                  <c:v>2.5238095238095237</c:v>
                </c:pt>
                <c:pt idx="424">
                  <c:v>2.5297619047619047</c:v>
                </c:pt>
                <c:pt idx="425">
                  <c:v>2.5357142857142856</c:v>
                </c:pt>
                <c:pt idx="426">
                  <c:v>2.5416666666666665</c:v>
                </c:pt>
                <c:pt idx="427">
                  <c:v>2.5476190476190474</c:v>
                </c:pt>
                <c:pt idx="428">
                  <c:v>2.5535714285714284</c:v>
                </c:pt>
                <c:pt idx="429">
                  <c:v>2.5595238095238093</c:v>
                </c:pt>
                <c:pt idx="430">
                  <c:v>2.5654761904761907</c:v>
                </c:pt>
                <c:pt idx="431">
                  <c:v>2.5714285714285716</c:v>
                </c:pt>
                <c:pt idx="432">
                  <c:v>2.5773809523809526</c:v>
                </c:pt>
                <c:pt idx="433">
                  <c:v>2.5833333333333335</c:v>
                </c:pt>
                <c:pt idx="434">
                  <c:v>2.5892857142857144</c:v>
                </c:pt>
                <c:pt idx="435">
                  <c:v>2.5952380952380953</c:v>
                </c:pt>
                <c:pt idx="436">
                  <c:v>2.6011904761904763</c:v>
                </c:pt>
                <c:pt idx="437">
                  <c:v>2.6071428571428572</c:v>
                </c:pt>
                <c:pt idx="438">
                  <c:v>2.6130952380952381</c:v>
                </c:pt>
                <c:pt idx="439">
                  <c:v>2.6190476190476191</c:v>
                </c:pt>
                <c:pt idx="440">
                  <c:v>2.625</c:v>
                </c:pt>
                <c:pt idx="441">
                  <c:v>2.6309523809523809</c:v>
                </c:pt>
                <c:pt idx="442">
                  <c:v>2.6369047619047619</c:v>
                </c:pt>
                <c:pt idx="443">
                  <c:v>2.6428571428571428</c:v>
                </c:pt>
                <c:pt idx="444">
                  <c:v>2.6488095238095237</c:v>
                </c:pt>
                <c:pt idx="445">
                  <c:v>2.6547619047619047</c:v>
                </c:pt>
                <c:pt idx="446">
                  <c:v>2.6607142857142856</c:v>
                </c:pt>
                <c:pt idx="447">
                  <c:v>2.6666666666666665</c:v>
                </c:pt>
                <c:pt idx="448">
                  <c:v>2.6726190476190474</c:v>
                </c:pt>
                <c:pt idx="449">
                  <c:v>2.6785714285714284</c:v>
                </c:pt>
                <c:pt idx="450">
                  <c:v>2.6845238095238093</c:v>
                </c:pt>
                <c:pt idx="451">
                  <c:v>2.6904761904761907</c:v>
                </c:pt>
                <c:pt idx="452">
                  <c:v>2.6964285714285716</c:v>
                </c:pt>
                <c:pt idx="453">
                  <c:v>2.7023809523809526</c:v>
                </c:pt>
                <c:pt idx="454">
                  <c:v>2.7083333333333335</c:v>
                </c:pt>
                <c:pt idx="455">
                  <c:v>2.7142857142857144</c:v>
                </c:pt>
                <c:pt idx="456">
                  <c:v>2.7202380952380953</c:v>
                </c:pt>
                <c:pt idx="457">
                  <c:v>2.7261904761904763</c:v>
                </c:pt>
                <c:pt idx="458">
                  <c:v>2.7321428571428572</c:v>
                </c:pt>
                <c:pt idx="459">
                  <c:v>2.7380952380952381</c:v>
                </c:pt>
                <c:pt idx="460">
                  <c:v>2.7440476190476191</c:v>
                </c:pt>
                <c:pt idx="461">
                  <c:v>2.75</c:v>
                </c:pt>
                <c:pt idx="462">
                  <c:v>2.7559523809523809</c:v>
                </c:pt>
                <c:pt idx="463">
                  <c:v>2.7619047619047619</c:v>
                </c:pt>
                <c:pt idx="464">
                  <c:v>2.7678571428571428</c:v>
                </c:pt>
                <c:pt idx="465">
                  <c:v>2.7738095238095237</c:v>
                </c:pt>
                <c:pt idx="466">
                  <c:v>2.7797619047619047</c:v>
                </c:pt>
                <c:pt idx="467">
                  <c:v>2.7857142857142856</c:v>
                </c:pt>
                <c:pt idx="468">
                  <c:v>2.7916666666666665</c:v>
                </c:pt>
                <c:pt idx="469">
                  <c:v>2.7976190476190474</c:v>
                </c:pt>
                <c:pt idx="470">
                  <c:v>2.8035714285714284</c:v>
                </c:pt>
                <c:pt idx="471">
                  <c:v>2.8095238095238093</c:v>
                </c:pt>
                <c:pt idx="472">
                  <c:v>2.8154761904761907</c:v>
                </c:pt>
                <c:pt idx="473">
                  <c:v>2.8214285714285716</c:v>
                </c:pt>
                <c:pt idx="474">
                  <c:v>2.8273809523809526</c:v>
                </c:pt>
                <c:pt idx="475">
                  <c:v>2.8333333333333335</c:v>
                </c:pt>
                <c:pt idx="476">
                  <c:v>2.8392857142857144</c:v>
                </c:pt>
                <c:pt idx="477">
                  <c:v>2.8452380952380953</c:v>
                </c:pt>
                <c:pt idx="478">
                  <c:v>2.8511904761904763</c:v>
                </c:pt>
                <c:pt idx="479">
                  <c:v>2.8571428571428572</c:v>
                </c:pt>
                <c:pt idx="480">
                  <c:v>2.8630952380952381</c:v>
                </c:pt>
                <c:pt idx="481">
                  <c:v>2.8690476190476191</c:v>
                </c:pt>
                <c:pt idx="482">
                  <c:v>2.875</c:v>
                </c:pt>
                <c:pt idx="483">
                  <c:v>2.8809523809523809</c:v>
                </c:pt>
                <c:pt idx="484">
                  <c:v>2.8869047619047619</c:v>
                </c:pt>
                <c:pt idx="485">
                  <c:v>2.8928571428571428</c:v>
                </c:pt>
                <c:pt idx="486">
                  <c:v>2.8988095238095237</c:v>
                </c:pt>
                <c:pt idx="487">
                  <c:v>2.9047619047619047</c:v>
                </c:pt>
                <c:pt idx="488">
                  <c:v>2.9107142857142856</c:v>
                </c:pt>
                <c:pt idx="489">
                  <c:v>2.9166666666666665</c:v>
                </c:pt>
                <c:pt idx="490">
                  <c:v>2.9226190476190474</c:v>
                </c:pt>
                <c:pt idx="491">
                  <c:v>2.9285714285714284</c:v>
                </c:pt>
                <c:pt idx="492">
                  <c:v>2.9345238095238093</c:v>
                </c:pt>
                <c:pt idx="493">
                  <c:v>2.9404761904761907</c:v>
                </c:pt>
                <c:pt idx="494">
                  <c:v>2.9464285714285716</c:v>
                </c:pt>
                <c:pt idx="495">
                  <c:v>2.9523809523809526</c:v>
                </c:pt>
                <c:pt idx="496">
                  <c:v>2.9583333333333335</c:v>
                </c:pt>
                <c:pt idx="497">
                  <c:v>2.9642857142857144</c:v>
                </c:pt>
                <c:pt idx="498">
                  <c:v>2.9702380952380953</c:v>
                </c:pt>
                <c:pt idx="499">
                  <c:v>2.9761904761904763</c:v>
                </c:pt>
                <c:pt idx="500">
                  <c:v>2.9821428571428572</c:v>
                </c:pt>
                <c:pt idx="501">
                  <c:v>2.9880952380952381</c:v>
                </c:pt>
                <c:pt idx="502">
                  <c:v>2.9940476190476191</c:v>
                </c:pt>
                <c:pt idx="503">
                  <c:v>3</c:v>
                </c:pt>
                <c:pt idx="504">
                  <c:v>3.0059523809523809</c:v>
                </c:pt>
                <c:pt idx="505">
                  <c:v>3.0119047619047619</c:v>
                </c:pt>
                <c:pt idx="506">
                  <c:v>3.0178571428571428</c:v>
                </c:pt>
                <c:pt idx="507">
                  <c:v>3.0238095238095237</c:v>
                </c:pt>
                <c:pt idx="508">
                  <c:v>3.0297619047619047</c:v>
                </c:pt>
                <c:pt idx="509">
                  <c:v>3.0357142857142856</c:v>
                </c:pt>
                <c:pt idx="510">
                  <c:v>3.0416666666666665</c:v>
                </c:pt>
                <c:pt idx="511">
                  <c:v>3.0476190476190474</c:v>
                </c:pt>
                <c:pt idx="512">
                  <c:v>3.0535714285714284</c:v>
                </c:pt>
                <c:pt idx="513">
                  <c:v>3.0595238095238093</c:v>
                </c:pt>
                <c:pt idx="514">
                  <c:v>3.0654761904761907</c:v>
                </c:pt>
                <c:pt idx="515">
                  <c:v>3.0714285714285716</c:v>
                </c:pt>
                <c:pt idx="516">
                  <c:v>3.0773809523809526</c:v>
                </c:pt>
                <c:pt idx="517">
                  <c:v>3.0833333333333335</c:v>
                </c:pt>
                <c:pt idx="518">
                  <c:v>3.0892857142857144</c:v>
                </c:pt>
                <c:pt idx="519">
                  <c:v>3.0952380952380953</c:v>
                </c:pt>
                <c:pt idx="520">
                  <c:v>3.1011904761904763</c:v>
                </c:pt>
                <c:pt idx="521">
                  <c:v>3.1071428571428572</c:v>
                </c:pt>
                <c:pt idx="522">
                  <c:v>3.1130952380952381</c:v>
                </c:pt>
                <c:pt idx="523">
                  <c:v>3.1190476190476191</c:v>
                </c:pt>
                <c:pt idx="524">
                  <c:v>3.125</c:v>
                </c:pt>
                <c:pt idx="525">
                  <c:v>3.1309523809523809</c:v>
                </c:pt>
                <c:pt idx="526">
                  <c:v>3.1369047619047619</c:v>
                </c:pt>
                <c:pt idx="527">
                  <c:v>3.1428571428571428</c:v>
                </c:pt>
                <c:pt idx="528">
                  <c:v>3.1488095238095237</c:v>
                </c:pt>
                <c:pt idx="529">
                  <c:v>3.1547619047619047</c:v>
                </c:pt>
                <c:pt idx="530">
                  <c:v>3.1607142857142856</c:v>
                </c:pt>
                <c:pt idx="531">
                  <c:v>3.1666666666666665</c:v>
                </c:pt>
                <c:pt idx="532">
                  <c:v>3.1726190476190474</c:v>
                </c:pt>
                <c:pt idx="533">
                  <c:v>3.1785714285714284</c:v>
                </c:pt>
                <c:pt idx="534">
                  <c:v>3.1845238095238093</c:v>
                </c:pt>
                <c:pt idx="535">
                  <c:v>3.1904761904761907</c:v>
                </c:pt>
                <c:pt idx="536">
                  <c:v>3.1964285714285716</c:v>
                </c:pt>
                <c:pt idx="537">
                  <c:v>3.2023809523809526</c:v>
                </c:pt>
                <c:pt idx="538">
                  <c:v>3.2083333333333335</c:v>
                </c:pt>
                <c:pt idx="539">
                  <c:v>3.2142857142857144</c:v>
                </c:pt>
                <c:pt idx="540">
                  <c:v>3.2202380952380953</c:v>
                </c:pt>
                <c:pt idx="541">
                  <c:v>3.2261904761904763</c:v>
                </c:pt>
                <c:pt idx="542">
                  <c:v>3.2321428571428572</c:v>
                </c:pt>
                <c:pt idx="543">
                  <c:v>3.2380952380952381</c:v>
                </c:pt>
                <c:pt idx="544">
                  <c:v>3.2440476190476191</c:v>
                </c:pt>
                <c:pt idx="545">
                  <c:v>3.25</c:v>
                </c:pt>
                <c:pt idx="546">
                  <c:v>3.2559523809523809</c:v>
                </c:pt>
                <c:pt idx="547">
                  <c:v>3.2619047619047619</c:v>
                </c:pt>
                <c:pt idx="548">
                  <c:v>3.2678571428571428</c:v>
                </c:pt>
                <c:pt idx="549">
                  <c:v>3.2738095238095237</c:v>
                </c:pt>
                <c:pt idx="550">
                  <c:v>3.2797619047619047</c:v>
                </c:pt>
                <c:pt idx="551">
                  <c:v>3.2857142857142856</c:v>
                </c:pt>
                <c:pt idx="552">
                  <c:v>3.2916666666666665</c:v>
                </c:pt>
                <c:pt idx="553">
                  <c:v>3.2976190476190474</c:v>
                </c:pt>
                <c:pt idx="554">
                  <c:v>3.3035714285714284</c:v>
                </c:pt>
                <c:pt idx="555">
                  <c:v>3.3095238095238093</c:v>
                </c:pt>
                <c:pt idx="556">
                  <c:v>3.3154761904761907</c:v>
                </c:pt>
                <c:pt idx="557">
                  <c:v>3.3214285714285716</c:v>
                </c:pt>
                <c:pt idx="558">
                  <c:v>3.3273809523809526</c:v>
                </c:pt>
                <c:pt idx="559">
                  <c:v>3.3333333333333335</c:v>
                </c:pt>
                <c:pt idx="560">
                  <c:v>3.3392857142857144</c:v>
                </c:pt>
                <c:pt idx="561">
                  <c:v>3.3452380952380953</c:v>
                </c:pt>
                <c:pt idx="562">
                  <c:v>3.3511904761904763</c:v>
                </c:pt>
                <c:pt idx="563">
                  <c:v>3.3571428571428572</c:v>
                </c:pt>
                <c:pt idx="564">
                  <c:v>3.3630952380952381</c:v>
                </c:pt>
                <c:pt idx="565">
                  <c:v>3.3690476190476191</c:v>
                </c:pt>
                <c:pt idx="566">
                  <c:v>3.375</c:v>
                </c:pt>
                <c:pt idx="567">
                  <c:v>3.3809523809523809</c:v>
                </c:pt>
                <c:pt idx="568">
                  <c:v>3.3869047619047619</c:v>
                </c:pt>
                <c:pt idx="569">
                  <c:v>3.3928571428571428</c:v>
                </c:pt>
                <c:pt idx="570">
                  <c:v>3.3988095238095237</c:v>
                </c:pt>
                <c:pt idx="571">
                  <c:v>3.4047619047619047</c:v>
                </c:pt>
                <c:pt idx="572">
                  <c:v>3.4107142857142856</c:v>
                </c:pt>
                <c:pt idx="573">
                  <c:v>3.4166666666666665</c:v>
                </c:pt>
                <c:pt idx="574">
                  <c:v>3.4226190476190474</c:v>
                </c:pt>
                <c:pt idx="575">
                  <c:v>3.4285714285714284</c:v>
                </c:pt>
                <c:pt idx="576">
                  <c:v>3.4345238095238093</c:v>
                </c:pt>
                <c:pt idx="577">
                  <c:v>3.4404761904761907</c:v>
                </c:pt>
                <c:pt idx="578">
                  <c:v>3.4464285714285716</c:v>
                </c:pt>
                <c:pt idx="579">
                  <c:v>3.4523809523809526</c:v>
                </c:pt>
                <c:pt idx="580">
                  <c:v>3.4583333333333335</c:v>
                </c:pt>
                <c:pt idx="581">
                  <c:v>3.4642857142857144</c:v>
                </c:pt>
                <c:pt idx="582">
                  <c:v>3.4702380952380953</c:v>
                </c:pt>
                <c:pt idx="583">
                  <c:v>3.4761904761904763</c:v>
                </c:pt>
                <c:pt idx="584">
                  <c:v>3.4821428571428572</c:v>
                </c:pt>
                <c:pt idx="585">
                  <c:v>3.4880952380952381</c:v>
                </c:pt>
                <c:pt idx="586">
                  <c:v>3.4940476190476191</c:v>
                </c:pt>
                <c:pt idx="587">
                  <c:v>3.5</c:v>
                </c:pt>
                <c:pt idx="588">
                  <c:v>3.5059523809523809</c:v>
                </c:pt>
                <c:pt idx="589">
                  <c:v>3.5119047619047619</c:v>
                </c:pt>
                <c:pt idx="590">
                  <c:v>3.5178571428571428</c:v>
                </c:pt>
                <c:pt idx="591">
                  <c:v>3.5238095238095237</c:v>
                </c:pt>
                <c:pt idx="592">
                  <c:v>3.5297619047619047</c:v>
                </c:pt>
                <c:pt idx="593">
                  <c:v>3.5357142857142856</c:v>
                </c:pt>
                <c:pt idx="594">
                  <c:v>3.5416666666666665</c:v>
                </c:pt>
                <c:pt idx="595">
                  <c:v>3.5476190476190474</c:v>
                </c:pt>
                <c:pt idx="596">
                  <c:v>3.5535714285714284</c:v>
                </c:pt>
                <c:pt idx="597">
                  <c:v>3.5595238095238093</c:v>
                </c:pt>
                <c:pt idx="598">
                  <c:v>3.5654761904761907</c:v>
                </c:pt>
                <c:pt idx="599">
                  <c:v>3.5714285714285716</c:v>
                </c:pt>
                <c:pt idx="600">
                  <c:v>3.5773809523809526</c:v>
                </c:pt>
                <c:pt idx="601">
                  <c:v>3.5833333333333335</c:v>
                </c:pt>
                <c:pt idx="602">
                  <c:v>3.5892857142857144</c:v>
                </c:pt>
                <c:pt idx="603">
                  <c:v>3.5952380952380953</c:v>
                </c:pt>
                <c:pt idx="604">
                  <c:v>3.6011904761904763</c:v>
                </c:pt>
                <c:pt idx="605">
                  <c:v>3.6071428571428572</c:v>
                </c:pt>
                <c:pt idx="606">
                  <c:v>3.6130952380952381</c:v>
                </c:pt>
                <c:pt idx="607">
                  <c:v>3.6190476190476191</c:v>
                </c:pt>
                <c:pt idx="608">
                  <c:v>3.625</c:v>
                </c:pt>
                <c:pt idx="609">
                  <c:v>3.6309523809523809</c:v>
                </c:pt>
                <c:pt idx="610">
                  <c:v>3.6369047619047619</c:v>
                </c:pt>
                <c:pt idx="611">
                  <c:v>3.6428571428571428</c:v>
                </c:pt>
                <c:pt idx="612">
                  <c:v>3.6488095238095237</c:v>
                </c:pt>
                <c:pt idx="613">
                  <c:v>3.6547619047619047</c:v>
                </c:pt>
                <c:pt idx="614">
                  <c:v>3.6607142857142856</c:v>
                </c:pt>
                <c:pt idx="615">
                  <c:v>3.6666666666666665</c:v>
                </c:pt>
                <c:pt idx="616">
                  <c:v>3.6726190476190474</c:v>
                </c:pt>
                <c:pt idx="617">
                  <c:v>3.6785714285714284</c:v>
                </c:pt>
                <c:pt idx="618">
                  <c:v>3.6845238095238093</c:v>
                </c:pt>
                <c:pt idx="619">
                  <c:v>3.6904761904761907</c:v>
                </c:pt>
                <c:pt idx="620">
                  <c:v>3.6964285714285716</c:v>
                </c:pt>
                <c:pt idx="621">
                  <c:v>3.7023809523809526</c:v>
                </c:pt>
                <c:pt idx="622">
                  <c:v>3.7083333333333335</c:v>
                </c:pt>
                <c:pt idx="623">
                  <c:v>3.7142857142857144</c:v>
                </c:pt>
                <c:pt idx="624">
                  <c:v>3.7202380952380953</c:v>
                </c:pt>
                <c:pt idx="625">
                  <c:v>3.7261904761904763</c:v>
                </c:pt>
                <c:pt idx="626">
                  <c:v>3.7321428571428572</c:v>
                </c:pt>
                <c:pt idx="627">
                  <c:v>3.7380952380952381</c:v>
                </c:pt>
                <c:pt idx="628">
                  <c:v>3.7440476190476191</c:v>
                </c:pt>
                <c:pt idx="629">
                  <c:v>3.75</c:v>
                </c:pt>
                <c:pt idx="630">
                  <c:v>3.7559523809523809</c:v>
                </c:pt>
                <c:pt idx="631">
                  <c:v>3.7619047619047619</c:v>
                </c:pt>
                <c:pt idx="632">
                  <c:v>3.7678571428571428</c:v>
                </c:pt>
                <c:pt idx="633">
                  <c:v>3.7738095238095237</c:v>
                </c:pt>
                <c:pt idx="634">
                  <c:v>3.7797619047619047</c:v>
                </c:pt>
                <c:pt idx="635">
                  <c:v>3.7857142857142856</c:v>
                </c:pt>
                <c:pt idx="636">
                  <c:v>3.7916666666666665</c:v>
                </c:pt>
                <c:pt idx="637">
                  <c:v>3.7976190476190474</c:v>
                </c:pt>
                <c:pt idx="638">
                  <c:v>3.8035714285714284</c:v>
                </c:pt>
                <c:pt idx="639">
                  <c:v>3.8095238095238093</c:v>
                </c:pt>
                <c:pt idx="640">
                  <c:v>3.8154761904761907</c:v>
                </c:pt>
                <c:pt idx="641">
                  <c:v>3.8214285714285716</c:v>
                </c:pt>
                <c:pt idx="642">
                  <c:v>3.8273809523809526</c:v>
                </c:pt>
                <c:pt idx="643">
                  <c:v>3.8333333333333335</c:v>
                </c:pt>
                <c:pt idx="644">
                  <c:v>3.8392857142857144</c:v>
                </c:pt>
                <c:pt idx="645">
                  <c:v>3.8452380952380953</c:v>
                </c:pt>
                <c:pt idx="646">
                  <c:v>3.8511904761904763</c:v>
                </c:pt>
                <c:pt idx="647">
                  <c:v>3.8571428571428572</c:v>
                </c:pt>
                <c:pt idx="648">
                  <c:v>3.8630952380952381</c:v>
                </c:pt>
                <c:pt idx="649">
                  <c:v>3.8690476190476191</c:v>
                </c:pt>
                <c:pt idx="650">
                  <c:v>3.875</c:v>
                </c:pt>
                <c:pt idx="651">
                  <c:v>3.8809523809523809</c:v>
                </c:pt>
                <c:pt idx="652">
                  <c:v>3.8869047619047619</c:v>
                </c:pt>
                <c:pt idx="653">
                  <c:v>3.8928571428571428</c:v>
                </c:pt>
                <c:pt idx="654">
                  <c:v>3.8988095238095237</c:v>
                </c:pt>
                <c:pt idx="655">
                  <c:v>3.9047619047619047</c:v>
                </c:pt>
                <c:pt idx="656">
                  <c:v>3.9107142857142856</c:v>
                </c:pt>
                <c:pt idx="657">
                  <c:v>3.9166666666666665</c:v>
                </c:pt>
                <c:pt idx="658">
                  <c:v>3.9226190476190474</c:v>
                </c:pt>
                <c:pt idx="659">
                  <c:v>3.9285714285714284</c:v>
                </c:pt>
                <c:pt idx="660">
                  <c:v>3.9345238095238093</c:v>
                </c:pt>
                <c:pt idx="661">
                  <c:v>3.9404761904761907</c:v>
                </c:pt>
                <c:pt idx="662">
                  <c:v>3.9464285714285716</c:v>
                </c:pt>
                <c:pt idx="663">
                  <c:v>3.9523809523809526</c:v>
                </c:pt>
                <c:pt idx="664">
                  <c:v>3.9583333333333335</c:v>
                </c:pt>
                <c:pt idx="665">
                  <c:v>3.9642857142857144</c:v>
                </c:pt>
                <c:pt idx="666">
                  <c:v>3.9702380952380953</c:v>
                </c:pt>
                <c:pt idx="667">
                  <c:v>3.9761904761904763</c:v>
                </c:pt>
                <c:pt idx="668">
                  <c:v>3.9821428571428572</c:v>
                </c:pt>
                <c:pt idx="669">
                  <c:v>3.9880952380952381</c:v>
                </c:pt>
                <c:pt idx="670">
                  <c:v>3.9940476190476191</c:v>
                </c:pt>
                <c:pt idx="671">
                  <c:v>4</c:v>
                </c:pt>
                <c:pt idx="672">
                  <c:v>4.0059523809523814</c:v>
                </c:pt>
                <c:pt idx="673">
                  <c:v>4.0119047619047619</c:v>
                </c:pt>
                <c:pt idx="674">
                  <c:v>4.0178571428571432</c:v>
                </c:pt>
                <c:pt idx="675">
                  <c:v>4.0238095238095237</c:v>
                </c:pt>
                <c:pt idx="676">
                  <c:v>4.0297619047619051</c:v>
                </c:pt>
                <c:pt idx="677">
                  <c:v>4.0357142857142856</c:v>
                </c:pt>
                <c:pt idx="678">
                  <c:v>4.041666666666667</c:v>
                </c:pt>
                <c:pt idx="679">
                  <c:v>4.0476190476190474</c:v>
                </c:pt>
                <c:pt idx="680">
                  <c:v>4.0535714285714288</c:v>
                </c:pt>
                <c:pt idx="681">
                  <c:v>4.0595238095238093</c:v>
                </c:pt>
                <c:pt idx="682">
                  <c:v>4.0654761904761907</c:v>
                </c:pt>
                <c:pt idx="683">
                  <c:v>4.0714285714285712</c:v>
                </c:pt>
                <c:pt idx="684">
                  <c:v>4.0773809523809526</c:v>
                </c:pt>
                <c:pt idx="685">
                  <c:v>4.083333333333333</c:v>
                </c:pt>
                <c:pt idx="686">
                  <c:v>4.0892857142857144</c:v>
                </c:pt>
                <c:pt idx="687">
                  <c:v>4.0952380952380949</c:v>
                </c:pt>
                <c:pt idx="688">
                  <c:v>4.1011904761904763</c:v>
                </c:pt>
                <c:pt idx="689">
                  <c:v>4.1071428571428568</c:v>
                </c:pt>
                <c:pt idx="690">
                  <c:v>4.1130952380952381</c:v>
                </c:pt>
                <c:pt idx="691">
                  <c:v>4.1190476190476186</c:v>
                </c:pt>
                <c:pt idx="692">
                  <c:v>4.125</c:v>
                </c:pt>
                <c:pt idx="693">
                  <c:v>4.1309523809523814</c:v>
                </c:pt>
                <c:pt idx="694">
                  <c:v>4.1369047619047619</c:v>
                </c:pt>
                <c:pt idx="695">
                  <c:v>4.1428571428571432</c:v>
                </c:pt>
                <c:pt idx="696">
                  <c:v>4.1488095238095237</c:v>
                </c:pt>
                <c:pt idx="697">
                  <c:v>4.1547619047619051</c:v>
                </c:pt>
                <c:pt idx="698">
                  <c:v>4.1607142857142856</c:v>
                </c:pt>
                <c:pt idx="699">
                  <c:v>4.166666666666667</c:v>
                </c:pt>
                <c:pt idx="700">
                  <c:v>4.1726190476190474</c:v>
                </c:pt>
                <c:pt idx="701">
                  <c:v>4.1785714285714288</c:v>
                </c:pt>
                <c:pt idx="702">
                  <c:v>4.1845238095238093</c:v>
                </c:pt>
                <c:pt idx="703">
                  <c:v>4.1904761904761907</c:v>
                </c:pt>
                <c:pt idx="704">
                  <c:v>4.1964285714285712</c:v>
                </c:pt>
                <c:pt idx="705">
                  <c:v>4.2023809523809526</c:v>
                </c:pt>
                <c:pt idx="706">
                  <c:v>4.208333333333333</c:v>
                </c:pt>
                <c:pt idx="707">
                  <c:v>4.2142857142857144</c:v>
                </c:pt>
                <c:pt idx="708">
                  <c:v>4.2202380952380949</c:v>
                </c:pt>
                <c:pt idx="709">
                  <c:v>4.2261904761904763</c:v>
                </c:pt>
                <c:pt idx="710">
                  <c:v>4.2321428571428568</c:v>
                </c:pt>
                <c:pt idx="711">
                  <c:v>4.2380952380952381</c:v>
                </c:pt>
                <c:pt idx="712">
                  <c:v>4.2440476190476186</c:v>
                </c:pt>
                <c:pt idx="713">
                  <c:v>4.25</c:v>
                </c:pt>
                <c:pt idx="714">
                  <c:v>4.2559523809523814</c:v>
                </c:pt>
                <c:pt idx="715">
                  <c:v>4.2619047619047619</c:v>
                </c:pt>
                <c:pt idx="716">
                  <c:v>4.2678571428571432</c:v>
                </c:pt>
                <c:pt idx="717">
                  <c:v>4.2738095238095237</c:v>
                </c:pt>
                <c:pt idx="718">
                  <c:v>4.2797619047619051</c:v>
                </c:pt>
                <c:pt idx="719">
                  <c:v>4.2857142857142856</c:v>
                </c:pt>
                <c:pt idx="720">
                  <c:v>4.291666666666667</c:v>
                </c:pt>
                <c:pt idx="721">
                  <c:v>4.2976190476190474</c:v>
                </c:pt>
                <c:pt idx="722">
                  <c:v>4.3035714285714288</c:v>
                </c:pt>
                <c:pt idx="723">
                  <c:v>4.3095238095238093</c:v>
                </c:pt>
                <c:pt idx="724">
                  <c:v>4.3154761904761907</c:v>
                </c:pt>
                <c:pt idx="725">
                  <c:v>4.3214285714285712</c:v>
                </c:pt>
                <c:pt idx="726">
                  <c:v>4.3273809523809526</c:v>
                </c:pt>
                <c:pt idx="727">
                  <c:v>4.333333333333333</c:v>
                </c:pt>
                <c:pt idx="728">
                  <c:v>4.3392857142857144</c:v>
                </c:pt>
                <c:pt idx="729">
                  <c:v>4.3452380952380949</c:v>
                </c:pt>
                <c:pt idx="730">
                  <c:v>4.3511904761904763</c:v>
                </c:pt>
                <c:pt idx="731">
                  <c:v>4.3571428571428568</c:v>
                </c:pt>
                <c:pt idx="732">
                  <c:v>4.3630952380952381</c:v>
                </c:pt>
                <c:pt idx="733">
                  <c:v>4.3690476190476186</c:v>
                </c:pt>
                <c:pt idx="734">
                  <c:v>4.375</c:v>
                </c:pt>
                <c:pt idx="735">
                  <c:v>4.3809523809523814</c:v>
                </c:pt>
                <c:pt idx="736">
                  <c:v>4.3869047619047619</c:v>
                </c:pt>
                <c:pt idx="737">
                  <c:v>4.3928571428571432</c:v>
                </c:pt>
                <c:pt idx="738">
                  <c:v>4.3988095238095237</c:v>
                </c:pt>
                <c:pt idx="739">
                  <c:v>4.4047619047619051</c:v>
                </c:pt>
                <c:pt idx="740">
                  <c:v>4.4107142857142856</c:v>
                </c:pt>
                <c:pt idx="741">
                  <c:v>4.416666666666667</c:v>
                </c:pt>
                <c:pt idx="742">
                  <c:v>4.4226190476190474</c:v>
                </c:pt>
                <c:pt idx="743">
                  <c:v>4.4285714285714288</c:v>
                </c:pt>
                <c:pt idx="744">
                  <c:v>4.4345238095238093</c:v>
                </c:pt>
                <c:pt idx="745">
                  <c:v>4.4404761904761907</c:v>
                </c:pt>
                <c:pt idx="746">
                  <c:v>4.4464285714285712</c:v>
                </c:pt>
                <c:pt idx="747">
                  <c:v>4.4523809523809526</c:v>
                </c:pt>
                <c:pt idx="748">
                  <c:v>4.458333333333333</c:v>
                </c:pt>
                <c:pt idx="749">
                  <c:v>4.4642857142857144</c:v>
                </c:pt>
                <c:pt idx="750">
                  <c:v>4.4702380952380949</c:v>
                </c:pt>
                <c:pt idx="751">
                  <c:v>4.4761904761904763</c:v>
                </c:pt>
                <c:pt idx="752">
                  <c:v>4.4821428571428568</c:v>
                </c:pt>
                <c:pt idx="753">
                  <c:v>4.4880952380952381</c:v>
                </c:pt>
                <c:pt idx="754">
                  <c:v>4.4940476190476186</c:v>
                </c:pt>
                <c:pt idx="755">
                  <c:v>4.5</c:v>
                </c:pt>
                <c:pt idx="756">
                  <c:v>4.5059523809523814</c:v>
                </c:pt>
                <c:pt idx="757">
                  <c:v>4.5119047619047619</c:v>
                </c:pt>
                <c:pt idx="758">
                  <c:v>4.5178571428571432</c:v>
                </c:pt>
                <c:pt idx="759">
                  <c:v>4.5238095238095237</c:v>
                </c:pt>
                <c:pt idx="760">
                  <c:v>4.5297619047619051</c:v>
                </c:pt>
                <c:pt idx="761">
                  <c:v>4.5357142857142856</c:v>
                </c:pt>
                <c:pt idx="762">
                  <c:v>4.541666666666667</c:v>
                </c:pt>
                <c:pt idx="763">
                  <c:v>4.5476190476190474</c:v>
                </c:pt>
                <c:pt idx="764">
                  <c:v>4.5535714285714288</c:v>
                </c:pt>
                <c:pt idx="765">
                  <c:v>4.5595238095238093</c:v>
                </c:pt>
                <c:pt idx="766">
                  <c:v>4.5654761904761907</c:v>
                </c:pt>
                <c:pt idx="767">
                  <c:v>4.5714285714285712</c:v>
                </c:pt>
                <c:pt idx="768">
                  <c:v>4.5773809523809526</c:v>
                </c:pt>
                <c:pt idx="769">
                  <c:v>4.583333333333333</c:v>
                </c:pt>
                <c:pt idx="770">
                  <c:v>4.5892857142857144</c:v>
                </c:pt>
                <c:pt idx="771">
                  <c:v>4.5952380952380949</c:v>
                </c:pt>
                <c:pt idx="772">
                  <c:v>4.6011904761904763</c:v>
                </c:pt>
                <c:pt idx="773">
                  <c:v>4.6071428571428568</c:v>
                </c:pt>
                <c:pt idx="774">
                  <c:v>4.6130952380952381</c:v>
                </c:pt>
                <c:pt idx="775">
                  <c:v>4.6190476190476186</c:v>
                </c:pt>
                <c:pt idx="776">
                  <c:v>4.625</c:v>
                </c:pt>
                <c:pt idx="777">
                  <c:v>4.6309523809523814</c:v>
                </c:pt>
                <c:pt idx="778">
                  <c:v>4.6369047619047619</c:v>
                </c:pt>
                <c:pt idx="779">
                  <c:v>4.6428571428571432</c:v>
                </c:pt>
                <c:pt idx="780">
                  <c:v>4.6488095238095237</c:v>
                </c:pt>
                <c:pt idx="781">
                  <c:v>4.6547619047619051</c:v>
                </c:pt>
                <c:pt idx="782">
                  <c:v>4.6607142857142856</c:v>
                </c:pt>
                <c:pt idx="783">
                  <c:v>4.666666666666667</c:v>
                </c:pt>
                <c:pt idx="784">
                  <c:v>4.6726190476190474</c:v>
                </c:pt>
                <c:pt idx="785">
                  <c:v>4.6785714285714288</c:v>
                </c:pt>
                <c:pt idx="786">
                  <c:v>4.6845238095238093</c:v>
                </c:pt>
                <c:pt idx="787">
                  <c:v>4.6904761904761907</c:v>
                </c:pt>
                <c:pt idx="788">
                  <c:v>4.6964285714285712</c:v>
                </c:pt>
                <c:pt idx="789">
                  <c:v>4.7023809523809526</c:v>
                </c:pt>
                <c:pt idx="790">
                  <c:v>4.708333333333333</c:v>
                </c:pt>
                <c:pt idx="791">
                  <c:v>4.7142857142857144</c:v>
                </c:pt>
                <c:pt idx="792">
                  <c:v>4.7202380952380949</c:v>
                </c:pt>
                <c:pt idx="793">
                  <c:v>4.7261904761904763</c:v>
                </c:pt>
                <c:pt idx="794">
                  <c:v>4.7321428571428568</c:v>
                </c:pt>
                <c:pt idx="795">
                  <c:v>4.7380952380952381</c:v>
                </c:pt>
                <c:pt idx="796">
                  <c:v>4.7440476190476186</c:v>
                </c:pt>
                <c:pt idx="797">
                  <c:v>4.75</c:v>
                </c:pt>
                <c:pt idx="798">
                  <c:v>4.7559523809523814</c:v>
                </c:pt>
                <c:pt idx="799">
                  <c:v>4.7619047619047619</c:v>
                </c:pt>
                <c:pt idx="800">
                  <c:v>4.7678571428571432</c:v>
                </c:pt>
                <c:pt idx="801">
                  <c:v>4.7738095238095237</c:v>
                </c:pt>
                <c:pt idx="802">
                  <c:v>4.7797619047619051</c:v>
                </c:pt>
                <c:pt idx="803">
                  <c:v>4.7857142857142856</c:v>
                </c:pt>
                <c:pt idx="804">
                  <c:v>4.791666666666667</c:v>
                </c:pt>
                <c:pt idx="805">
                  <c:v>4.7976190476190474</c:v>
                </c:pt>
                <c:pt idx="806">
                  <c:v>4.8035714285714288</c:v>
                </c:pt>
                <c:pt idx="807">
                  <c:v>4.8095238095238093</c:v>
                </c:pt>
                <c:pt idx="808">
                  <c:v>4.8154761904761907</c:v>
                </c:pt>
                <c:pt idx="809">
                  <c:v>4.8214285714285712</c:v>
                </c:pt>
                <c:pt idx="810">
                  <c:v>4.8273809523809526</c:v>
                </c:pt>
                <c:pt idx="811">
                  <c:v>4.833333333333333</c:v>
                </c:pt>
                <c:pt idx="812">
                  <c:v>4.8392857142857144</c:v>
                </c:pt>
                <c:pt idx="813">
                  <c:v>4.8452380952380949</c:v>
                </c:pt>
                <c:pt idx="814">
                  <c:v>4.8511904761904763</c:v>
                </c:pt>
                <c:pt idx="815">
                  <c:v>4.8571428571428568</c:v>
                </c:pt>
                <c:pt idx="816">
                  <c:v>4.8630952380952381</c:v>
                </c:pt>
                <c:pt idx="817">
                  <c:v>4.8690476190476186</c:v>
                </c:pt>
                <c:pt idx="818">
                  <c:v>4.875</c:v>
                </c:pt>
                <c:pt idx="819">
                  <c:v>4.8809523809523814</c:v>
                </c:pt>
                <c:pt idx="820">
                  <c:v>4.8869047619047619</c:v>
                </c:pt>
                <c:pt idx="821">
                  <c:v>4.8928571428571432</c:v>
                </c:pt>
                <c:pt idx="822">
                  <c:v>4.8988095238095237</c:v>
                </c:pt>
                <c:pt idx="823">
                  <c:v>4.9047619047619051</c:v>
                </c:pt>
                <c:pt idx="824">
                  <c:v>4.9107142857142856</c:v>
                </c:pt>
                <c:pt idx="825">
                  <c:v>4.916666666666667</c:v>
                </c:pt>
                <c:pt idx="826">
                  <c:v>4.9226190476190474</c:v>
                </c:pt>
                <c:pt idx="827">
                  <c:v>4.9285714285714288</c:v>
                </c:pt>
                <c:pt idx="828">
                  <c:v>4.9345238095238093</c:v>
                </c:pt>
                <c:pt idx="829">
                  <c:v>4.9404761904761907</c:v>
                </c:pt>
                <c:pt idx="830">
                  <c:v>4.9464285714285712</c:v>
                </c:pt>
                <c:pt idx="831">
                  <c:v>4.9523809523809526</c:v>
                </c:pt>
                <c:pt idx="832">
                  <c:v>4.958333333333333</c:v>
                </c:pt>
                <c:pt idx="833">
                  <c:v>4.9642857142857144</c:v>
                </c:pt>
                <c:pt idx="834">
                  <c:v>4.9702380952380949</c:v>
                </c:pt>
                <c:pt idx="835">
                  <c:v>4.9761904761904763</c:v>
                </c:pt>
                <c:pt idx="836">
                  <c:v>4.9821428571428568</c:v>
                </c:pt>
                <c:pt idx="837">
                  <c:v>4.9880952380952381</c:v>
                </c:pt>
                <c:pt idx="838">
                  <c:v>4.9940476190476186</c:v>
                </c:pt>
                <c:pt idx="839">
                  <c:v>5</c:v>
                </c:pt>
                <c:pt idx="840">
                  <c:v>5.0059523809523814</c:v>
                </c:pt>
                <c:pt idx="841">
                  <c:v>5.0119047619047619</c:v>
                </c:pt>
                <c:pt idx="842">
                  <c:v>5.0178571428571432</c:v>
                </c:pt>
                <c:pt idx="843">
                  <c:v>5.0238095238095237</c:v>
                </c:pt>
                <c:pt idx="844">
                  <c:v>5.0297619047619051</c:v>
                </c:pt>
                <c:pt idx="845">
                  <c:v>5.0357142857142856</c:v>
                </c:pt>
                <c:pt idx="846">
                  <c:v>5.041666666666667</c:v>
                </c:pt>
                <c:pt idx="847">
                  <c:v>5.0476190476190474</c:v>
                </c:pt>
                <c:pt idx="848">
                  <c:v>5.0535714285714288</c:v>
                </c:pt>
                <c:pt idx="849">
                  <c:v>5.0595238095238093</c:v>
                </c:pt>
                <c:pt idx="850">
                  <c:v>5.0654761904761907</c:v>
                </c:pt>
                <c:pt idx="851">
                  <c:v>5.0714285714285712</c:v>
                </c:pt>
                <c:pt idx="852">
                  <c:v>5.0773809523809526</c:v>
                </c:pt>
                <c:pt idx="853">
                  <c:v>5.083333333333333</c:v>
                </c:pt>
                <c:pt idx="854">
                  <c:v>5.0892857142857144</c:v>
                </c:pt>
                <c:pt idx="855">
                  <c:v>5.0952380952380949</c:v>
                </c:pt>
                <c:pt idx="856">
                  <c:v>5.1011904761904763</c:v>
                </c:pt>
                <c:pt idx="857">
                  <c:v>5.1071428571428568</c:v>
                </c:pt>
                <c:pt idx="858">
                  <c:v>5.1130952380952381</c:v>
                </c:pt>
                <c:pt idx="859">
                  <c:v>5.1190476190476186</c:v>
                </c:pt>
                <c:pt idx="860">
                  <c:v>5.125</c:v>
                </c:pt>
                <c:pt idx="861">
                  <c:v>5.1309523809523814</c:v>
                </c:pt>
                <c:pt idx="862">
                  <c:v>5.1369047619047619</c:v>
                </c:pt>
                <c:pt idx="863">
                  <c:v>5.1428571428571432</c:v>
                </c:pt>
                <c:pt idx="864">
                  <c:v>5.1488095238095237</c:v>
                </c:pt>
                <c:pt idx="865">
                  <c:v>5.1547619047619051</c:v>
                </c:pt>
                <c:pt idx="866">
                  <c:v>5.1607142857142856</c:v>
                </c:pt>
                <c:pt idx="867">
                  <c:v>5.166666666666667</c:v>
                </c:pt>
                <c:pt idx="868">
                  <c:v>5.1726190476190474</c:v>
                </c:pt>
                <c:pt idx="869">
                  <c:v>5.1785714285714288</c:v>
                </c:pt>
                <c:pt idx="870">
                  <c:v>5.1845238095238093</c:v>
                </c:pt>
                <c:pt idx="871">
                  <c:v>5.1904761904761907</c:v>
                </c:pt>
                <c:pt idx="872">
                  <c:v>5.1964285714285712</c:v>
                </c:pt>
                <c:pt idx="873">
                  <c:v>5.2023809523809526</c:v>
                </c:pt>
                <c:pt idx="874">
                  <c:v>5.208333333333333</c:v>
                </c:pt>
                <c:pt idx="875">
                  <c:v>5.2142857142857144</c:v>
                </c:pt>
                <c:pt idx="876">
                  <c:v>5.2202380952380949</c:v>
                </c:pt>
                <c:pt idx="877">
                  <c:v>5.2261904761904763</c:v>
                </c:pt>
                <c:pt idx="878">
                  <c:v>5.2321428571428568</c:v>
                </c:pt>
                <c:pt idx="879">
                  <c:v>5.2380952380952381</c:v>
                </c:pt>
                <c:pt idx="880">
                  <c:v>5.2440476190476186</c:v>
                </c:pt>
                <c:pt idx="881">
                  <c:v>5.25</c:v>
                </c:pt>
                <c:pt idx="882">
                  <c:v>5.2559523809523814</c:v>
                </c:pt>
                <c:pt idx="883">
                  <c:v>5.2619047619047619</c:v>
                </c:pt>
                <c:pt idx="884">
                  <c:v>5.2678571428571432</c:v>
                </c:pt>
                <c:pt idx="885">
                  <c:v>5.2738095238095237</c:v>
                </c:pt>
                <c:pt idx="886">
                  <c:v>5.2797619047619051</c:v>
                </c:pt>
                <c:pt idx="887">
                  <c:v>5.2857142857142856</c:v>
                </c:pt>
                <c:pt idx="888">
                  <c:v>5.291666666666667</c:v>
                </c:pt>
                <c:pt idx="889">
                  <c:v>5.2976190476190474</c:v>
                </c:pt>
                <c:pt idx="890">
                  <c:v>5.3035714285714288</c:v>
                </c:pt>
                <c:pt idx="891">
                  <c:v>5.3095238095238093</c:v>
                </c:pt>
                <c:pt idx="892">
                  <c:v>5.3154761904761907</c:v>
                </c:pt>
                <c:pt idx="893">
                  <c:v>5.3214285714285712</c:v>
                </c:pt>
                <c:pt idx="894">
                  <c:v>5.3273809523809526</c:v>
                </c:pt>
                <c:pt idx="895">
                  <c:v>5.333333333333333</c:v>
                </c:pt>
                <c:pt idx="896">
                  <c:v>5.3392857142857144</c:v>
                </c:pt>
                <c:pt idx="897">
                  <c:v>5.3452380952380949</c:v>
                </c:pt>
                <c:pt idx="898">
                  <c:v>5.3511904761904763</c:v>
                </c:pt>
                <c:pt idx="899">
                  <c:v>5.3571428571428568</c:v>
                </c:pt>
                <c:pt idx="900">
                  <c:v>5.3630952380952381</c:v>
                </c:pt>
                <c:pt idx="901">
                  <c:v>5.3690476190476186</c:v>
                </c:pt>
                <c:pt idx="902">
                  <c:v>5.375</c:v>
                </c:pt>
                <c:pt idx="903">
                  <c:v>5.3809523809523814</c:v>
                </c:pt>
                <c:pt idx="904">
                  <c:v>5.3869047619047619</c:v>
                </c:pt>
                <c:pt idx="905">
                  <c:v>5.3928571428571432</c:v>
                </c:pt>
                <c:pt idx="906">
                  <c:v>5.3988095238095237</c:v>
                </c:pt>
                <c:pt idx="907">
                  <c:v>5.4047619047619051</c:v>
                </c:pt>
                <c:pt idx="908">
                  <c:v>5.4107142857142856</c:v>
                </c:pt>
                <c:pt idx="909">
                  <c:v>5.416666666666667</c:v>
                </c:pt>
                <c:pt idx="910">
                  <c:v>5.4226190476190474</c:v>
                </c:pt>
                <c:pt idx="911">
                  <c:v>5.4285714285714288</c:v>
                </c:pt>
                <c:pt idx="912">
                  <c:v>5.4345238095238093</c:v>
                </c:pt>
                <c:pt idx="913">
                  <c:v>5.4404761904761907</c:v>
                </c:pt>
                <c:pt idx="914">
                  <c:v>5.4464285714285712</c:v>
                </c:pt>
                <c:pt idx="915">
                  <c:v>5.4523809523809526</c:v>
                </c:pt>
                <c:pt idx="916">
                  <c:v>5.458333333333333</c:v>
                </c:pt>
                <c:pt idx="917">
                  <c:v>5.4642857142857144</c:v>
                </c:pt>
                <c:pt idx="918">
                  <c:v>5.4702380952380949</c:v>
                </c:pt>
                <c:pt idx="919">
                  <c:v>5.4761904761904763</c:v>
                </c:pt>
                <c:pt idx="920">
                  <c:v>5.4821428571428568</c:v>
                </c:pt>
                <c:pt idx="921">
                  <c:v>5.4880952380952381</c:v>
                </c:pt>
                <c:pt idx="922">
                  <c:v>5.4940476190476186</c:v>
                </c:pt>
                <c:pt idx="923">
                  <c:v>5.5</c:v>
                </c:pt>
                <c:pt idx="924">
                  <c:v>5.5059523809523814</c:v>
                </c:pt>
                <c:pt idx="925">
                  <c:v>5.5119047619047619</c:v>
                </c:pt>
                <c:pt idx="926">
                  <c:v>5.5178571428571432</c:v>
                </c:pt>
                <c:pt idx="927">
                  <c:v>5.5238095238095237</c:v>
                </c:pt>
                <c:pt idx="928">
                  <c:v>5.5297619047619051</c:v>
                </c:pt>
                <c:pt idx="929">
                  <c:v>5.5357142857142856</c:v>
                </c:pt>
                <c:pt idx="930">
                  <c:v>5.541666666666667</c:v>
                </c:pt>
                <c:pt idx="931">
                  <c:v>5.5476190476190474</c:v>
                </c:pt>
                <c:pt idx="932">
                  <c:v>5.5535714285714288</c:v>
                </c:pt>
                <c:pt idx="933">
                  <c:v>5.5595238095238093</c:v>
                </c:pt>
                <c:pt idx="934">
                  <c:v>5.5654761904761907</c:v>
                </c:pt>
                <c:pt idx="935">
                  <c:v>5.5714285714285712</c:v>
                </c:pt>
                <c:pt idx="936">
                  <c:v>5.5773809523809526</c:v>
                </c:pt>
                <c:pt idx="937">
                  <c:v>5.583333333333333</c:v>
                </c:pt>
                <c:pt idx="938">
                  <c:v>5.5892857142857144</c:v>
                </c:pt>
                <c:pt idx="939">
                  <c:v>5.5952380952380949</c:v>
                </c:pt>
                <c:pt idx="940">
                  <c:v>5.6011904761904763</c:v>
                </c:pt>
                <c:pt idx="941">
                  <c:v>5.6071428571428568</c:v>
                </c:pt>
                <c:pt idx="942">
                  <c:v>5.6130952380952381</c:v>
                </c:pt>
                <c:pt idx="943">
                  <c:v>5.6190476190476186</c:v>
                </c:pt>
                <c:pt idx="944">
                  <c:v>5.625</c:v>
                </c:pt>
                <c:pt idx="945">
                  <c:v>5.6309523809523814</c:v>
                </c:pt>
                <c:pt idx="946">
                  <c:v>5.6369047619047619</c:v>
                </c:pt>
                <c:pt idx="947">
                  <c:v>5.6428571428571432</c:v>
                </c:pt>
                <c:pt idx="948">
                  <c:v>5.6488095238095237</c:v>
                </c:pt>
                <c:pt idx="949">
                  <c:v>5.6547619047619051</c:v>
                </c:pt>
                <c:pt idx="950">
                  <c:v>5.6607142857142856</c:v>
                </c:pt>
                <c:pt idx="951">
                  <c:v>5.666666666666667</c:v>
                </c:pt>
                <c:pt idx="952">
                  <c:v>5.6726190476190474</c:v>
                </c:pt>
                <c:pt idx="953">
                  <c:v>5.6785714285714288</c:v>
                </c:pt>
                <c:pt idx="954">
                  <c:v>5.6845238095238093</c:v>
                </c:pt>
                <c:pt idx="955">
                  <c:v>5.6904761904761907</c:v>
                </c:pt>
                <c:pt idx="956">
                  <c:v>5.6964285714285712</c:v>
                </c:pt>
                <c:pt idx="957">
                  <c:v>5.7023809523809526</c:v>
                </c:pt>
                <c:pt idx="958">
                  <c:v>5.708333333333333</c:v>
                </c:pt>
                <c:pt idx="959">
                  <c:v>5.7142857142857144</c:v>
                </c:pt>
                <c:pt idx="960">
                  <c:v>5.7202380952380949</c:v>
                </c:pt>
                <c:pt idx="961">
                  <c:v>5.7261904761904763</c:v>
                </c:pt>
                <c:pt idx="962">
                  <c:v>5.7321428571428568</c:v>
                </c:pt>
                <c:pt idx="963">
                  <c:v>5.7380952380952381</c:v>
                </c:pt>
                <c:pt idx="964">
                  <c:v>5.7440476190476186</c:v>
                </c:pt>
                <c:pt idx="965">
                  <c:v>5.75</c:v>
                </c:pt>
                <c:pt idx="966">
                  <c:v>5.7559523809523814</c:v>
                </c:pt>
                <c:pt idx="967">
                  <c:v>5.7619047619047619</c:v>
                </c:pt>
                <c:pt idx="968">
                  <c:v>5.7678571428571432</c:v>
                </c:pt>
                <c:pt idx="969">
                  <c:v>5.7738095238095237</c:v>
                </c:pt>
                <c:pt idx="970">
                  <c:v>5.7797619047619051</c:v>
                </c:pt>
                <c:pt idx="971">
                  <c:v>5.7857142857142856</c:v>
                </c:pt>
                <c:pt idx="972">
                  <c:v>5.791666666666667</c:v>
                </c:pt>
                <c:pt idx="973">
                  <c:v>5.7976190476190474</c:v>
                </c:pt>
                <c:pt idx="974">
                  <c:v>5.8035714285714288</c:v>
                </c:pt>
                <c:pt idx="975">
                  <c:v>5.8095238095238093</c:v>
                </c:pt>
                <c:pt idx="976">
                  <c:v>5.8154761904761907</c:v>
                </c:pt>
                <c:pt idx="977">
                  <c:v>5.8214285714285712</c:v>
                </c:pt>
                <c:pt idx="978">
                  <c:v>5.8273809523809526</c:v>
                </c:pt>
                <c:pt idx="979">
                  <c:v>5.833333333333333</c:v>
                </c:pt>
                <c:pt idx="980">
                  <c:v>5.8392857142857144</c:v>
                </c:pt>
                <c:pt idx="981">
                  <c:v>5.8452380952380949</c:v>
                </c:pt>
                <c:pt idx="982">
                  <c:v>5.8511904761904763</c:v>
                </c:pt>
                <c:pt idx="983">
                  <c:v>5.8571428571428568</c:v>
                </c:pt>
                <c:pt idx="984">
                  <c:v>5.8630952380952381</c:v>
                </c:pt>
                <c:pt idx="985">
                  <c:v>5.8690476190476186</c:v>
                </c:pt>
                <c:pt idx="986">
                  <c:v>5.875</c:v>
                </c:pt>
                <c:pt idx="987">
                  <c:v>5.8809523809523814</c:v>
                </c:pt>
                <c:pt idx="988">
                  <c:v>5.8869047619047619</c:v>
                </c:pt>
                <c:pt idx="989">
                  <c:v>5.8928571428571432</c:v>
                </c:pt>
                <c:pt idx="990">
                  <c:v>5.8988095238095237</c:v>
                </c:pt>
                <c:pt idx="991">
                  <c:v>5.9047619047619051</c:v>
                </c:pt>
                <c:pt idx="992">
                  <c:v>5.9107142857142856</c:v>
                </c:pt>
                <c:pt idx="993">
                  <c:v>5.916666666666667</c:v>
                </c:pt>
                <c:pt idx="994">
                  <c:v>5.9226190476190474</c:v>
                </c:pt>
                <c:pt idx="995">
                  <c:v>5.9285714285714288</c:v>
                </c:pt>
                <c:pt idx="996">
                  <c:v>5.9345238095238093</c:v>
                </c:pt>
                <c:pt idx="997">
                  <c:v>5.9404761904761907</c:v>
                </c:pt>
                <c:pt idx="998">
                  <c:v>5.9464285714285712</c:v>
                </c:pt>
                <c:pt idx="999">
                  <c:v>5.9523809523809526</c:v>
                </c:pt>
                <c:pt idx="1000">
                  <c:v>5.958333333333333</c:v>
                </c:pt>
                <c:pt idx="1001">
                  <c:v>5.9642857142857144</c:v>
                </c:pt>
                <c:pt idx="1002">
                  <c:v>5.9702380952380949</c:v>
                </c:pt>
                <c:pt idx="1003">
                  <c:v>5.9761904761904763</c:v>
                </c:pt>
                <c:pt idx="1004">
                  <c:v>5.9821428571428568</c:v>
                </c:pt>
                <c:pt idx="1005">
                  <c:v>5.9880952380952381</c:v>
                </c:pt>
                <c:pt idx="1006">
                  <c:v>5.9940476190476186</c:v>
                </c:pt>
                <c:pt idx="1007">
                  <c:v>6</c:v>
                </c:pt>
                <c:pt idx="1008">
                  <c:v>6.0059523809523814</c:v>
                </c:pt>
                <c:pt idx="1009">
                  <c:v>6.0119047619047619</c:v>
                </c:pt>
                <c:pt idx="1010">
                  <c:v>6.0178571428571432</c:v>
                </c:pt>
                <c:pt idx="1011">
                  <c:v>6.0238095238095237</c:v>
                </c:pt>
                <c:pt idx="1012">
                  <c:v>6.0297619047619051</c:v>
                </c:pt>
                <c:pt idx="1013">
                  <c:v>6.0357142857142856</c:v>
                </c:pt>
                <c:pt idx="1014">
                  <c:v>6.041666666666667</c:v>
                </c:pt>
                <c:pt idx="1015">
                  <c:v>6.0476190476190474</c:v>
                </c:pt>
                <c:pt idx="1016">
                  <c:v>6.0535714285714288</c:v>
                </c:pt>
                <c:pt idx="1017">
                  <c:v>6.0595238095238093</c:v>
                </c:pt>
                <c:pt idx="1018">
                  <c:v>6.0654761904761907</c:v>
                </c:pt>
                <c:pt idx="1019">
                  <c:v>6.0714285714285712</c:v>
                </c:pt>
                <c:pt idx="1020">
                  <c:v>6.0773809523809526</c:v>
                </c:pt>
                <c:pt idx="1021">
                  <c:v>6.083333333333333</c:v>
                </c:pt>
                <c:pt idx="1022">
                  <c:v>6.0892857142857144</c:v>
                </c:pt>
                <c:pt idx="1023">
                  <c:v>6.0952380952380949</c:v>
                </c:pt>
                <c:pt idx="1024">
                  <c:v>6.1011904761904763</c:v>
                </c:pt>
                <c:pt idx="1025">
                  <c:v>6.1071428571428568</c:v>
                </c:pt>
                <c:pt idx="1026">
                  <c:v>6.1130952380952381</c:v>
                </c:pt>
                <c:pt idx="1027">
                  <c:v>6.1190476190476186</c:v>
                </c:pt>
                <c:pt idx="1028">
                  <c:v>6.125</c:v>
                </c:pt>
                <c:pt idx="1029">
                  <c:v>6.1309523809523814</c:v>
                </c:pt>
                <c:pt idx="1030">
                  <c:v>6.1369047619047619</c:v>
                </c:pt>
                <c:pt idx="1031">
                  <c:v>6.1428571428571432</c:v>
                </c:pt>
                <c:pt idx="1032">
                  <c:v>6.1488095238095237</c:v>
                </c:pt>
                <c:pt idx="1033">
                  <c:v>6.1547619047619051</c:v>
                </c:pt>
                <c:pt idx="1034">
                  <c:v>6.1607142857142856</c:v>
                </c:pt>
                <c:pt idx="1035">
                  <c:v>6.166666666666667</c:v>
                </c:pt>
                <c:pt idx="1036">
                  <c:v>6.1726190476190474</c:v>
                </c:pt>
                <c:pt idx="1037">
                  <c:v>6.1785714285714288</c:v>
                </c:pt>
                <c:pt idx="1038">
                  <c:v>6.1845238095238093</c:v>
                </c:pt>
                <c:pt idx="1039">
                  <c:v>6.1904761904761907</c:v>
                </c:pt>
                <c:pt idx="1040">
                  <c:v>6.1964285714285712</c:v>
                </c:pt>
                <c:pt idx="1041">
                  <c:v>6.2023809523809526</c:v>
                </c:pt>
                <c:pt idx="1042">
                  <c:v>6.208333333333333</c:v>
                </c:pt>
                <c:pt idx="1043">
                  <c:v>6.2142857142857144</c:v>
                </c:pt>
                <c:pt idx="1044">
                  <c:v>6.2202380952380949</c:v>
                </c:pt>
                <c:pt idx="1045">
                  <c:v>6.2261904761904763</c:v>
                </c:pt>
                <c:pt idx="1046">
                  <c:v>6.2321428571428568</c:v>
                </c:pt>
                <c:pt idx="1047">
                  <c:v>6.2380952380952381</c:v>
                </c:pt>
                <c:pt idx="1048">
                  <c:v>6.2440476190476186</c:v>
                </c:pt>
                <c:pt idx="1049">
                  <c:v>6.25</c:v>
                </c:pt>
                <c:pt idx="1050">
                  <c:v>6.2559523809523814</c:v>
                </c:pt>
                <c:pt idx="1051">
                  <c:v>6.2619047619047619</c:v>
                </c:pt>
                <c:pt idx="1052">
                  <c:v>6.2678571428571432</c:v>
                </c:pt>
                <c:pt idx="1053">
                  <c:v>6.2738095238095237</c:v>
                </c:pt>
                <c:pt idx="1054">
                  <c:v>6.2797619047619051</c:v>
                </c:pt>
                <c:pt idx="1055">
                  <c:v>6.2857142857142856</c:v>
                </c:pt>
                <c:pt idx="1056">
                  <c:v>6.291666666666667</c:v>
                </c:pt>
                <c:pt idx="1057">
                  <c:v>6.2976190476190474</c:v>
                </c:pt>
                <c:pt idx="1058">
                  <c:v>6.3035714285714288</c:v>
                </c:pt>
                <c:pt idx="1059">
                  <c:v>6.3095238095238093</c:v>
                </c:pt>
                <c:pt idx="1060">
                  <c:v>6.3154761904761907</c:v>
                </c:pt>
                <c:pt idx="1061">
                  <c:v>6.3214285714285712</c:v>
                </c:pt>
                <c:pt idx="1062">
                  <c:v>6.3273809523809526</c:v>
                </c:pt>
                <c:pt idx="1063">
                  <c:v>6.333333333333333</c:v>
                </c:pt>
                <c:pt idx="1064">
                  <c:v>6.3392857142857144</c:v>
                </c:pt>
                <c:pt idx="1065">
                  <c:v>6.3452380952380949</c:v>
                </c:pt>
                <c:pt idx="1066">
                  <c:v>6.3511904761904763</c:v>
                </c:pt>
                <c:pt idx="1067">
                  <c:v>6.3571428571428568</c:v>
                </c:pt>
                <c:pt idx="1068">
                  <c:v>6.3630952380952381</c:v>
                </c:pt>
                <c:pt idx="1069">
                  <c:v>6.3690476190476186</c:v>
                </c:pt>
                <c:pt idx="1070">
                  <c:v>6.375</c:v>
                </c:pt>
                <c:pt idx="1071">
                  <c:v>6.3809523809523814</c:v>
                </c:pt>
                <c:pt idx="1072">
                  <c:v>6.3869047619047619</c:v>
                </c:pt>
                <c:pt idx="1073">
                  <c:v>6.3928571428571432</c:v>
                </c:pt>
                <c:pt idx="1074">
                  <c:v>6.3988095238095237</c:v>
                </c:pt>
                <c:pt idx="1075">
                  <c:v>6.4047619047619051</c:v>
                </c:pt>
                <c:pt idx="1076">
                  <c:v>6.4107142857142856</c:v>
                </c:pt>
                <c:pt idx="1077">
                  <c:v>6.416666666666667</c:v>
                </c:pt>
                <c:pt idx="1078">
                  <c:v>6.4226190476190474</c:v>
                </c:pt>
                <c:pt idx="1079">
                  <c:v>6.4285714285714288</c:v>
                </c:pt>
                <c:pt idx="1080">
                  <c:v>6.4345238095238093</c:v>
                </c:pt>
                <c:pt idx="1081">
                  <c:v>6.4404761904761907</c:v>
                </c:pt>
                <c:pt idx="1082">
                  <c:v>6.4464285714285712</c:v>
                </c:pt>
                <c:pt idx="1083">
                  <c:v>6.4523809523809526</c:v>
                </c:pt>
                <c:pt idx="1084">
                  <c:v>6.458333333333333</c:v>
                </c:pt>
                <c:pt idx="1085">
                  <c:v>6.4642857142857144</c:v>
                </c:pt>
                <c:pt idx="1086">
                  <c:v>6.4702380952380949</c:v>
                </c:pt>
                <c:pt idx="1087">
                  <c:v>6.4761904761904763</c:v>
                </c:pt>
                <c:pt idx="1088">
                  <c:v>6.4821428571428568</c:v>
                </c:pt>
                <c:pt idx="1089">
                  <c:v>6.4880952380952381</c:v>
                </c:pt>
                <c:pt idx="1090">
                  <c:v>6.4940476190476186</c:v>
                </c:pt>
                <c:pt idx="1091">
                  <c:v>6.5</c:v>
                </c:pt>
                <c:pt idx="1092">
                  <c:v>6.5059523809523814</c:v>
                </c:pt>
                <c:pt idx="1093">
                  <c:v>6.5119047619047619</c:v>
                </c:pt>
                <c:pt idx="1094">
                  <c:v>6.5178571428571432</c:v>
                </c:pt>
                <c:pt idx="1095">
                  <c:v>6.5238095238095237</c:v>
                </c:pt>
                <c:pt idx="1096">
                  <c:v>6.5297619047619051</c:v>
                </c:pt>
                <c:pt idx="1097">
                  <c:v>6.5357142857142856</c:v>
                </c:pt>
                <c:pt idx="1098">
                  <c:v>6.541666666666667</c:v>
                </c:pt>
                <c:pt idx="1099">
                  <c:v>6.5476190476190474</c:v>
                </c:pt>
                <c:pt idx="1100">
                  <c:v>6.5535714285714288</c:v>
                </c:pt>
                <c:pt idx="1101">
                  <c:v>6.5595238095238093</c:v>
                </c:pt>
                <c:pt idx="1102">
                  <c:v>6.5654761904761907</c:v>
                </c:pt>
                <c:pt idx="1103">
                  <c:v>6.5714285714285712</c:v>
                </c:pt>
                <c:pt idx="1104">
                  <c:v>6.5773809523809526</c:v>
                </c:pt>
                <c:pt idx="1105">
                  <c:v>6.583333333333333</c:v>
                </c:pt>
                <c:pt idx="1106">
                  <c:v>6.5892857142857144</c:v>
                </c:pt>
                <c:pt idx="1107">
                  <c:v>6.5952380952380949</c:v>
                </c:pt>
                <c:pt idx="1108">
                  <c:v>6.6011904761904763</c:v>
                </c:pt>
                <c:pt idx="1109">
                  <c:v>6.6071428571428568</c:v>
                </c:pt>
                <c:pt idx="1110">
                  <c:v>6.6130952380952381</c:v>
                </c:pt>
                <c:pt idx="1111">
                  <c:v>6.6190476190476186</c:v>
                </c:pt>
                <c:pt idx="1112">
                  <c:v>6.625</c:v>
                </c:pt>
                <c:pt idx="1113">
                  <c:v>6.6309523809523814</c:v>
                </c:pt>
                <c:pt idx="1114">
                  <c:v>6.6369047619047619</c:v>
                </c:pt>
                <c:pt idx="1115">
                  <c:v>6.6428571428571432</c:v>
                </c:pt>
                <c:pt idx="1116">
                  <c:v>6.6488095238095237</c:v>
                </c:pt>
                <c:pt idx="1117">
                  <c:v>6.6547619047619051</c:v>
                </c:pt>
                <c:pt idx="1118">
                  <c:v>6.6607142857142856</c:v>
                </c:pt>
                <c:pt idx="1119">
                  <c:v>6.666666666666667</c:v>
                </c:pt>
                <c:pt idx="1120">
                  <c:v>6.6726190476190474</c:v>
                </c:pt>
                <c:pt idx="1121">
                  <c:v>6.6785714285714288</c:v>
                </c:pt>
                <c:pt idx="1122">
                  <c:v>6.6845238095238093</c:v>
                </c:pt>
                <c:pt idx="1123">
                  <c:v>6.6904761904761907</c:v>
                </c:pt>
                <c:pt idx="1124">
                  <c:v>6.6964285714285712</c:v>
                </c:pt>
                <c:pt idx="1125">
                  <c:v>6.7023809523809526</c:v>
                </c:pt>
                <c:pt idx="1126">
                  <c:v>6.708333333333333</c:v>
                </c:pt>
                <c:pt idx="1127">
                  <c:v>6.7142857142857144</c:v>
                </c:pt>
                <c:pt idx="1128">
                  <c:v>6.7202380952380949</c:v>
                </c:pt>
                <c:pt idx="1129">
                  <c:v>6.7261904761904763</c:v>
                </c:pt>
                <c:pt idx="1130">
                  <c:v>6.7321428571428568</c:v>
                </c:pt>
                <c:pt idx="1131">
                  <c:v>6.7380952380952381</c:v>
                </c:pt>
                <c:pt idx="1132">
                  <c:v>6.7440476190476186</c:v>
                </c:pt>
                <c:pt idx="1133">
                  <c:v>6.75</c:v>
                </c:pt>
                <c:pt idx="1134">
                  <c:v>6.7559523809523814</c:v>
                </c:pt>
                <c:pt idx="1135">
                  <c:v>6.7619047619047619</c:v>
                </c:pt>
                <c:pt idx="1136">
                  <c:v>6.7678571428571432</c:v>
                </c:pt>
                <c:pt idx="1137">
                  <c:v>6.7738095238095237</c:v>
                </c:pt>
                <c:pt idx="1138">
                  <c:v>6.7797619047619051</c:v>
                </c:pt>
                <c:pt idx="1139">
                  <c:v>6.7857142857142856</c:v>
                </c:pt>
                <c:pt idx="1140">
                  <c:v>6.791666666666667</c:v>
                </c:pt>
                <c:pt idx="1141">
                  <c:v>6.7976190476190474</c:v>
                </c:pt>
                <c:pt idx="1142">
                  <c:v>6.8035714285714288</c:v>
                </c:pt>
                <c:pt idx="1143">
                  <c:v>6.8095238095238093</c:v>
                </c:pt>
                <c:pt idx="1144">
                  <c:v>6.8154761904761907</c:v>
                </c:pt>
                <c:pt idx="1145">
                  <c:v>6.8214285714285712</c:v>
                </c:pt>
                <c:pt idx="1146">
                  <c:v>6.8273809523809526</c:v>
                </c:pt>
                <c:pt idx="1147">
                  <c:v>6.833333333333333</c:v>
                </c:pt>
                <c:pt idx="1148">
                  <c:v>6.8392857142857144</c:v>
                </c:pt>
                <c:pt idx="1149">
                  <c:v>6.8452380952380949</c:v>
                </c:pt>
                <c:pt idx="1150">
                  <c:v>6.8511904761904763</c:v>
                </c:pt>
                <c:pt idx="1151">
                  <c:v>6.8571428571428568</c:v>
                </c:pt>
                <c:pt idx="1152">
                  <c:v>6.8630952380952381</c:v>
                </c:pt>
                <c:pt idx="1153">
                  <c:v>6.8690476190476186</c:v>
                </c:pt>
                <c:pt idx="1154">
                  <c:v>6.875</c:v>
                </c:pt>
                <c:pt idx="1155">
                  <c:v>6.8809523809523814</c:v>
                </c:pt>
                <c:pt idx="1156">
                  <c:v>6.8869047619047619</c:v>
                </c:pt>
                <c:pt idx="1157">
                  <c:v>6.8928571428571432</c:v>
                </c:pt>
                <c:pt idx="1158">
                  <c:v>6.8988095238095237</c:v>
                </c:pt>
                <c:pt idx="1159">
                  <c:v>6.9047619047619051</c:v>
                </c:pt>
                <c:pt idx="1160">
                  <c:v>6.9107142857142856</c:v>
                </c:pt>
                <c:pt idx="1161">
                  <c:v>6.916666666666667</c:v>
                </c:pt>
                <c:pt idx="1162">
                  <c:v>6.9226190476190474</c:v>
                </c:pt>
                <c:pt idx="1163">
                  <c:v>6.9285714285714288</c:v>
                </c:pt>
                <c:pt idx="1164">
                  <c:v>6.9345238095238093</c:v>
                </c:pt>
                <c:pt idx="1165">
                  <c:v>6.9404761904761907</c:v>
                </c:pt>
                <c:pt idx="1166">
                  <c:v>6.9464285714285712</c:v>
                </c:pt>
                <c:pt idx="1167">
                  <c:v>6.9523809523809526</c:v>
                </c:pt>
                <c:pt idx="1168">
                  <c:v>6.958333333333333</c:v>
                </c:pt>
                <c:pt idx="1169">
                  <c:v>6.9642857142857144</c:v>
                </c:pt>
                <c:pt idx="1170">
                  <c:v>6.9702380952380949</c:v>
                </c:pt>
                <c:pt idx="1171">
                  <c:v>6.9761904761904763</c:v>
                </c:pt>
                <c:pt idx="1172">
                  <c:v>6.9821428571428568</c:v>
                </c:pt>
                <c:pt idx="1173">
                  <c:v>6.9880952380952381</c:v>
                </c:pt>
                <c:pt idx="1174">
                  <c:v>6.9940476190476186</c:v>
                </c:pt>
                <c:pt idx="1175">
                  <c:v>7</c:v>
                </c:pt>
                <c:pt idx="1176">
                  <c:v>7.0059523809523814</c:v>
                </c:pt>
                <c:pt idx="1177">
                  <c:v>7.0119047619047619</c:v>
                </c:pt>
                <c:pt idx="1178">
                  <c:v>7.0178571428571432</c:v>
                </c:pt>
                <c:pt idx="1179">
                  <c:v>7.0238095238095237</c:v>
                </c:pt>
                <c:pt idx="1180">
                  <c:v>7.0297619047619051</c:v>
                </c:pt>
                <c:pt idx="1181">
                  <c:v>7.0357142857142856</c:v>
                </c:pt>
                <c:pt idx="1182">
                  <c:v>7.041666666666667</c:v>
                </c:pt>
                <c:pt idx="1183">
                  <c:v>7.0476190476190474</c:v>
                </c:pt>
                <c:pt idx="1184">
                  <c:v>7.0535714285714288</c:v>
                </c:pt>
                <c:pt idx="1185">
                  <c:v>7.0595238095238093</c:v>
                </c:pt>
                <c:pt idx="1186">
                  <c:v>7.0654761904761907</c:v>
                </c:pt>
                <c:pt idx="1187">
                  <c:v>7.0714285714285712</c:v>
                </c:pt>
                <c:pt idx="1188">
                  <c:v>7.0773809523809526</c:v>
                </c:pt>
                <c:pt idx="1189">
                  <c:v>7.083333333333333</c:v>
                </c:pt>
                <c:pt idx="1190">
                  <c:v>7.0892857142857144</c:v>
                </c:pt>
                <c:pt idx="1191">
                  <c:v>7.0952380952380949</c:v>
                </c:pt>
                <c:pt idx="1192">
                  <c:v>7.1011904761904763</c:v>
                </c:pt>
                <c:pt idx="1193">
                  <c:v>7.1071428571428568</c:v>
                </c:pt>
                <c:pt idx="1194">
                  <c:v>7.1130952380952381</c:v>
                </c:pt>
                <c:pt idx="1195">
                  <c:v>7.1190476190476186</c:v>
                </c:pt>
                <c:pt idx="1196">
                  <c:v>7.125</c:v>
                </c:pt>
                <c:pt idx="1197">
                  <c:v>7.1309523809523814</c:v>
                </c:pt>
                <c:pt idx="1198">
                  <c:v>7.1369047619047619</c:v>
                </c:pt>
                <c:pt idx="1199">
                  <c:v>7.1428571428571432</c:v>
                </c:pt>
                <c:pt idx="1200">
                  <c:v>7.1488095238095237</c:v>
                </c:pt>
                <c:pt idx="1201">
                  <c:v>7.1547619047619051</c:v>
                </c:pt>
                <c:pt idx="1202">
                  <c:v>7.1607142857142856</c:v>
                </c:pt>
                <c:pt idx="1203">
                  <c:v>7.166666666666667</c:v>
                </c:pt>
                <c:pt idx="1204">
                  <c:v>7.1726190476190474</c:v>
                </c:pt>
                <c:pt idx="1205">
                  <c:v>7.1785714285714288</c:v>
                </c:pt>
                <c:pt idx="1206">
                  <c:v>7.1845238095238093</c:v>
                </c:pt>
                <c:pt idx="1207">
                  <c:v>7.1904761904761907</c:v>
                </c:pt>
                <c:pt idx="1208">
                  <c:v>7.1964285714285712</c:v>
                </c:pt>
                <c:pt idx="1209">
                  <c:v>7.2023809523809526</c:v>
                </c:pt>
                <c:pt idx="1210">
                  <c:v>7.208333333333333</c:v>
                </c:pt>
                <c:pt idx="1211">
                  <c:v>7.2142857142857144</c:v>
                </c:pt>
                <c:pt idx="1212">
                  <c:v>7.2202380952380949</c:v>
                </c:pt>
                <c:pt idx="1213">
                  <c:v>7.2261904761904763</c:v>
                </c:pt>
                <c:pt idx="1214">
                  <c:v>7.2321428571428568</c:v>
                </c:pt>
                <c:pt idx="1215">
                  <c:v>7.2380952380952381</c:v>
                </c:pt>
                <c:pt idx="1216">
                  <c:v>7.2440476190476186</c:v>
                </c:pt>
                <c:pt idx="1217">
                  <c:v>7.25</c:v>
                </c:pt>
                <c:pt idx="1218">
                  <c:v>7.2559523809523814</c:v>
                </c:pt>
                <c:pt idx="1219">
                  <c:v>7.2619047619047619</c:v>
                </c:pt>
                <c:pt idx="1220">
                  <c:v>7.2678571428571432</c:v>
                </c:pt>
                <c:pt idx="1221">
                  <c:v>7.2738095238095237</c:v>
                </c:pt>
                <c:pt idx="1222">
                  <c:v>7.2797619047619051</c:v>
                </c:pt>
                <c:pt idx="1223">
                  <c:v>7.2857142857142856</c:v>
                </c:pt>
                <c:pt idx="1224">
                  <c:v>7.291666666666667</c:v>
                </c:pt>
                <c:pt idx="1225">
                  <c:v>7.2976190476190474</c:v>
                </c:pt>
                <c:pt idx="1226">
                  <c:v>7.3035714285714288</c:v>
                </c:pt>
                <c:pt idx="1227">
                  <c:v>7.3095238095238093</c:v>
                </c:pt>
                <c:pt idx="1228">
                  <c:v>7.3154761904761907</c:v>
                </c:pt>
                <c:pt idx="1229">
                  <c:v>7.3214285714285712</c:v>
                </c:pt>
                <c:pt idx="1230">
                  <c:v>7.3273809523809526</c:v>
                </c:pt>
                <c:pt idx="1231">
                  <c:v>7.333333333333333</c:v>
                </c:pt>
                <c:pt idx="1232">
                  <c:v>7.3392857142857144</c:v>
                </c:pt>
                <c:pt idx="1233">
                  <c:v>7.3452380952380949</c:v>
                </c:pt>
                <c:pt idx="1234">
                  <c:v>7.3511904761904763</c:v>
                </c:pt>
                <c:pt idx="1235">
                  <c:v>7.3571428571428568</c:v>
                </c:pt>
                <c:pt idx="1236">
                  <c:v>7.3630952380952381</c:v>
                </c:pt>
                <c:pt idx="1237">
                  <c:v>7.3690476190476186</c:v>
                </c:pt>
                <c:pt idx="1238">
                  <c:v>7.375</c:v>
                </c:pt>
                <c:pt idx="1239">
                  <c:v>7.3809523809523814</c:v>
                </c:pt>
                <c:pt idx="1240">
                  <c:v>7.3869047619047619</c:v>
                </c:pt>
                <c:pt idx="1241">
                  <c:v>7.3928571428571432</c:v>
                </c:pt>
                <c:pt idx="1242">
                  <c:v>7.3988095238095237</c:v>
                </c:pt>
                <c:pt idx="1243">
                  <c:v>7.4047619047619051</c:v>
                </c:pt>
                <c:pt idx="1244">
                  <c:v>7.4107142857142856</c:v>
                </c:pt>
                <c:pt idx="1245">
                  <c:v>7.416666666666667</c:v>
                </c:pt>
                <c:pt idx="1246">
                  <c:v>7.4226190476190474</c:v>
                </c:pt>
                <c:pt idx="1247">
                  <c:v>7.4285714285714288</c:v>
                </c:pt>
                <c:pt idx="1248">
                  <c:v>7.4345238095238093</c:v>
                </c:pt>
                <c:pt idx="1249">
                  <c:v>7.4404761904761907</c:v>
                </c:pt>
                <c:pt idx="1250">
                  <c:v>7.4464285714285712</c:v>
                </c:pt>
                <c:pt idx="1251">
                  <c:v>7.4523809523809526</c:v>
                </c:pt>
                <c:pt idx="1252">
                  <c:v>7.458333333333333</c:v>
                </c:pt>
                <c:pt idx="1253">
                  <c:v>7.4642857142857144</c:v>
                </c:pt>
                <c:pt idx="1254">
                  <c:v>7.4702380952380949</c:v>
                </c:pt>
                <c:pt idx="1255">
                  <c:v>7.4761904761904763</c:v>
                </c:pt>
                <c:pt idx="1256">
                  <c:v>7.4821428571428568</c:v>
                </c:pt>
                <c:pt idx="1257">
                  <c:v>7.4880952380952381</c:v>
                </c:pt>
                <c:pt idx="1258">
                  <c:v>7.4940476190476186</c:v>
                </c:pt>
                <c:pt idx="1259">
                  <c:v>7.5</c:v>
                </c:pt>
                <c:pt idx="1260">
                  <c:v>7.5059523809523814</c:v>
                </c:pt>
                <c:pt idx="1261">
                  <c:v>7.5119047619047619</c:v>
                </c:pt>
                <c:pt idx="1262">
                  <c:v>7.5178571428571432</c:v>
                </c:pt>
                <c:pt idx="1263">
                  <c:v>7.5238095238095237</c:v>
                </c:pt>
                <c:pt idx="1264">
                  <c:v>7.5297619047619051</c:v>
                </c:pt>
                <c:pt idx="1265">
                  <c:v>7.5357142857142856</c:v>
                </c:pt>
                <c:pt idx="1266">
                  <c:v>7.541666666666667</c:v>
                </c:pt>
                <c:pt idx="1267">
                  <c:v>7.5476190476190474</c:v>
                </c:pt>
                <c:pt idx="1268">
                  <c:v>7.5535714285714288</c:v>
                </c:pt>
                <c:pt idx="1269">
                  <c:v>7.5595238095238093</c:v>
                </c:pt>
                <c:pt idx="1270">
                  <c:v>7.5654761904761907</c:v>
                </c:pt>
                <c:pt idx="1271">
                  <c:v>7.5714285714285712</c:v>
                </c:pt>
                <c:pt idx="1272">
                  <c:v>7.5773809523809526</c:v>
                </c:pt>
                <c:pt idx="1273">
                  <c:v>7.583333333333333</c:v>
                </c:pt>
                <c:pt idx="1274">
                  <c:v>7.5892857142857144</c:v>
                </c:pt>
                <c:pt idx="1275">
                  <c:v>7.5952380952380949</c:v>
                </c:pt>
                <c:pt idx="1276">
                  <c:v>7.6011904761904763</c:v>
                </c:pt>
                <c:pt idx="1277">
                  <c:v>7.6071428571428568</c:v>
                </c:pt>
                <c:pt idx="1278">
                  <c:v>7.6130952380952381</c:v>
                </c:pt>
                <c:pt idx="1279">
                  <c:v>7.6190476190476186</c:v>
                </c:pt>
                <c:pt idx="1280">
                  <c:v>7.625</c:v>
                </c:pt>
                <c:pt idx="1281">
                  <c:v>7.6309523809523814</c:v>
                </c:pt>
                <c:pt idx="1282">
                  <c:v>7.6369047619047619</c:v>
                </c:pt>
                <c:pt idx="1283">
                  <c:v>7.6428571428571432</c:v>
                </c:pt>
                <c:pt idx="1284">
                  <c:v>7.6488095238095237</c:v>
                </c:pt>
                <c:pt idx="1285">
                  <c:v>7.6547619047619051</c:v>
                </c:pt>
                <c:pt idx="1286">
                  <c:v>7.6607142857142856</c:v>
                </c:pt>
                <c:pt idx="1287">
                  <c:v>7.666666666666667</c:v>
                </c:pt>
                <c:pt idx="1288">
                  <c:v>7.6726190476190474</c:v>
                </c:pt>
                <c:pt idx="1289">
                  <c:v>7.6785714285714288</c:v>
                </c:pt>
                <c:pt idx="1290">
                  <c:v>7.6845238095238093</c:v>
                </c:pt>
                <c:pt idx="1291">
                  <c:v>7.6904761904761907</c:v>
                </c:pt>
                <c:pt idx="1292">
                  <c:v>7.6964285714285712</c:v>
                </c:pt>
                <c:pt idx="1293">
                  <c:v>7.7023809523809526</c:v>
                </c:pt>
                <c:pt idx="1294">
                  <c:v>7.708333333333333</c:v>
                </c:pt>
                <c:pt idx="1295">
                  <c:v>7.7142857142857144</c:v>
                </c:pt>
                <c:pt idx="1296">
                  <c:v>7.7202380952380949</c:v>
                </c:pt>
                <c:pt idx="1297">
                  <c:v>7.7261904761904763</c:v>
                </c:pt>
                <c:pt idx="1298">
                  <c:v>7.7321428571428568</c:v>
                </c:pt>
                <c:pt idx="1299">
                  <c:v>7.7380952380952381</c:v>
                </c:pt>
                <c:pt idx="1300">
                  <c:v>7.7440476190476186</c:v>
                </c:pt>
                <c:pt idx="1301">
                  <c:v>7.75</c:v>
                </c:pt>
                <c:pt idx="1302">
                  <c:v>7.7559523809523814</c:v>
                </c:pt>
                <c:pt idx="1303">
                  <c:v>7.7619047619047619</c:v>
                </c:pt>
                <c:pt idx="1304">
                  <c:v>7.7678571428571432</c:v>
                </c:pt>
                <c:pt idx="1305">
                  <c:v>7.7738095238095237</c:v>
                </c:pt>
                <c:pt idx="1306">
                  <c:v>7.7797619047619051</c:v>
                </c:pt>
                <c:pt idx="1307">
                  <c:v>7.7857142857142856</c:v>
                </c:pt>
                <c:pt idx="1308">
                  <c:v>7.791666666666667</c:v>
                </c:pt>
                <c:pt idx="1309">
                  <c:v>7.7976190476190474</c:v>
                </c:pt>
                <c:pt idx="1310">
                  <c:v>7.8035714285714288</c:v>
                </c:pt>
                <c:pt idx="1311">
                  <c:v>7.8095238095238093</c:v>
                </c:pt>
                <c:pt idx="1312">
                  <c:v>7.8154761904761907</c:v>
                </c:pt>
                <c:pt idx="1313">
                  <c:v>7.8214285714285712</c:v>
                </c:pt>
                <c:pt idx="1314">
                  <c:v>7.8273809523809526</c:v>
                </c:pt>
                <c:pt idx="1315">
                  <c:v>7.833333333333333</c:v>
                </c:pt>
                <c:pt idx="1316">
                  <c:v>7.8392857142857144</c:v>
                </c:pt>
                <c:pt idx="1317">
                  <c:v>7.8452380952380949</c:v>
                </c:pt>
                <c:pt idx="1318">
                  <c:v>7.8511904761904763</c:v>
                </c:pt>
                <c:pt idx="1319">
                  <c:v>7.8571428571428568</c:v>
                </c:pt>
                <c:pt idx="1320">
                  <c:v>7.8630952380952381</c:v>
                </c:pt>
                <c:pt idx="1321">
                  <c:v>7.8690476190476186</c:v>
                </c:pt>
                <c:pt idx="1322">
                  <c:v>7.875</c:v>
                </c:pt>
                <c:pt idx="1323">
                  <c:v>7.8809523809523814</c:v>
                </c:pt>
                <c:pt idx="1324">
                  <c:v>7.8869047619047619</c:v>
                </c:pt>
                <c:pt idx="1325">
                  <c:v>7.8928571428571432</c:v>
                </c:pt>
                <c:pt idx="1326">
                  <c:v>7.8988095238095237</c:v>
                </c:pt>
                <c:pt idx="1327">
                  <c:v>7.9047619047619051</c:v>
                </c:pt>
                <c:pt idx="1328">
                  <c:v>7.9107142857142856</c:v>
                </c:pt>
                <c:pt idx="1329">
                  <c:v>7.916666666666667</c:v>
                </c:pt>
                <c:pt idx="1330">
                  <c:v>7.9226190476190474</c:v>
                </c:pt>
                <c:pt idx="1331">
                  <c:v>7.9285714285714288</c:v>
                </c:pt>
                <c:pt idx="1332">
                  <c:v>7.9345238095238093</c:v>
                </c:pt>
                <c:pt idx="1333">
                  <c:v>7.9404761904761907</c:v>
                </c:pt>
                <c:pt idx="1334">
                  <c:v>7.9464285714285712</c:v>
                </c:pt>
                <c:pt idx="1335">
                  <c:v>7.9523809523809526</c:v>
                </c:pt>
                <c:pt idx="1336">
                  <c:v>7.958333333333333</c:v>
                </c:pt>
                <c:pt idx="1337">
                  <c:v>7.9642857142857144</c:v>
                </c:pt>
                <c:pt idx="1338">
                  <c:v>7.9702380952380949</c:v>
                </c:pt>
              </c:numCache>
            </c:numRef>
          </c:xVal>
          <c:yVal>
            <c:numRef>
              <c:f>Tabelle1!$E$13:$E$1351</c:f>
              <c:numCache>
                <c:formatCode>0.0</c:formatCode>
                <c:ptCount val="1339"/>
                <c:pt idx="0">
                  <c:v>27.8</c:v>
                </c:pt>
                <c:pt idx="1">
                  <c:v>23.7</c:v>
                </c:pt>
                <c:pt idx="2">
                  <c:v>23.8</c:v>
                </c:pt>
                <c:pt idx="3">
                  <c:v>23.7</c:v>
                </c:pt>
                <c:pt idx="4">
                  <c:v>23.3</c:v>
                </c:pt>
                <c:pt idx="5">
                  <c:v>22.9</c:v>
                </c:pt>
                <c:pt idx="6">
                  <c:v>22.5</c:v>
                </c:pt>
                <c:pt idx="7">
                  <c:v>22.2</c:v>
                </c:pt>
                <c:pt idx="8">
                  <c:v>21.9</c:v>
                </c:pt>
                <c:pt idx="9">
                  <c:v>21.7</c:v>
                </c:pt>
                <c:pt idx="10">
                  <c:v>21.6</c:v>
                </c:pt>
                <c:pt idx="11">
                  <c:v>21.5</c:v>
                </c:pt>
                <c:pt idx="12">
                  <c:v>21.4</c:v>
                </c:pt>
                <c:pt idx="13">
                  <c:v>21.4</c:v>
                </c:pt>
                <c:pt idx="14">
                  <c:v>21.3</c:v>
                </c:pt>
                <c:pt idx="15">
                  <c:v>21.2</c:v>
                </c:pt>
                <c:pt idx="16">
                  <c:v>21.1</c:v>
                </c:pt>
                <c:pt idx="17">
                  <c:v>21.1</c:v>
                </c:pt>
                <c:pt idx="18">
                  <c:v>22.6</c:v>
                </c:pt>
                <c:pt idx="19">
                  <c:v>23.1</c:v>
                </c:pt>
                <c:pt idx="20">
                  <c:v>24.1</c:v>
                </c:pt>
                <c:pt idx="21">
                  <c:v>24.6</c:v>
                </c:pt>
                <c:pt idx="22">
                  <c:v>24.6</c:v>
                </c:pt>
                <c:pt idx="23">
                  <c:v>24.3</c:v>
                </c:pt>
                <c:pt idx="24">
                  <c:v>24.1</c:v>
                </c:pt>
                <c:pt idx="25">
                  <c:v>23.9</c:v>
                </c:pt>
                <c:pt idx="26">
                  <c:v>23.7</c:v>
                </c:pt>
                <c:pt idx="27">
                  <c:v>23.2</c:v>
                </c:pt>
                <c:pt idx="28">
                  <c:v>22.9</c:v>
                </c:pt>
                <c:pt idx="29">
                  <c:v>22.6</c:v>
                </c:pt>
                <c:pt idx="30">
                  <c:v>22.3</c:v>
                </c:pt>
                <c:pt idx="31">
                  <c:v>22.2</c:v>
                </c:pt>
                <c:pt idx="32">
                  <c:v>22.1</c:v>
                </c:pt>
                <c:pt idx="33">
                  <c:v>22</c:v>
                </c:pt>
                <c:pt idx="34">
                  <c:v>21.9</c:v>
                </c:pt>
                <c:pt idx="35">
                  <c:v>21.8</c:v>
                </c:pt>
                <c:pt idx="36">
                  <c:v>21.8</c:v>
                </c:pt>
                <c:pt idx="37">
                  <c:v>21.7</c:v>
                </c:pt>
                <c:pt idx="38">
                  <c:v>21.7</c:v>
                </c:pt>
                <c:pt idx="39">
                  <c:v>21.6</c:v>
                </c:pt>
                <c:pt idx="40">
                  <c:v>21.5</c:v>
                </c:pt>
                <c:pt idx="41">
                  <c:v>21.3</c:v>
                </c:pt>
                <c:pt idx="42">
                  <c:v>21.3</c:v>
                </c:pt>
                <c:pt idx="43">
                  <c:v>21.3</c:v>
                </c:pt>
                <c:pt idx="44">
                  <c:v>21.6</c:v>
                </c:pt>
                <c:pt idx="45">
                  <c:v>21.9</c:v>
                </c:pt>
                <c:pt idx="46">
                  <c:v>22.3</c:v>
                </c:pt>
                <c:pt idx="47">
                  <c:v>22.5</c:v>
                </c:pt>
                <c:pt idx="48">
                  <c:v>22.4</c:v>
                </c:pt>
                <c:pt idx="49">
                  <c:v>22.4</c:v>
                </c:pt>
                <c:pt idx="50">
                  <c:v>22.4</c:v>
                </c:pt>
                <c:pt idx="51">
                  <c:v>22.4</c:v>
                </c:pt>
                <c:pt idx="52">
                  <c:v>22.3</c:v>
                </c:pt>
                <c:pt idx="53">
                  <c:v>22.2</c:v>
                </c:pt>
                <c:pt idx="54">
                  <c:v>22.1</c:v>
                </c:pt>
                <c:pt idx="55">
                  <c:v>21.9</c:v>
                </c:pt>
                <c:pt idx="56">
                  <c:v>21.9</c:v>
                </c:pt>
                <c:pt idx="57">
                  <c:v>21.8</c:v>
                </c:pt>
                <c:pt idx="58">
                  <c:v>21.7</c:v>
                </c:pt>
                <c:pt idx="59">
                  <c:v>21.6</c:v>
                </c:pt>
                <c:pt idx="60">
                  <c:v>21.6</c:v>
                </c:pt>
                <c:pt idx="61">
                  <c:v>21.4</c:v>
                </c:pt>
                <c:pt idx="62">
                  <c:v>21.3</c:v>
                </c:pt>
                <c:pt idx="63">
                  <c:v>21.1</c:v>
                </c:pt>
                <c:pt idx="64">
                  <c:v>20.9</c:v>
                </c:pt>
                <c:pt idx="65">
                  <c:v>21.3</c:v>
                </c:pt>
                <c:pt idx="66">
                  <c:v>23.7</c:v>
                </c:pt>
                <c:pt idx="67">
                  <c:v>25.6</c:v>
                </c:pt>
                <c:pt idx="68">
                  <c:v>25.9</c:v>
                </c:pt>
                <c:pt idx="69">
                  <c:v>25.6</c:v>
                </c:pt>
                <c:pt idx="70">
                  <c:v>25</c:v>
                </c:pt>
                <c:pt idx="71">
                  <c:v>24.7</c:v>
                </c:pt>
                <c:pt idx="72">
                  <c:v>24.4</c:v>
                </c:pt>
                <c:pt idx="73">
                  <c:v>24.2</c:v>
                </c:pt>
                <c:pt idx="74">
                  <c:v>23.9</c:v>
                </c:pt>
                <c:pt idx="75">
                  <c:v>23.6</c:v>
                </c:pt>
                <c:pt idx="76">
                  <c:v>23.2</c:v>
                </c:pt>
                <c:pt idx="77">
                  <c:v>22.8</c:v>
                </c:pt>
                <c:pt idx="78">
                  <c:v>22.5</c:v>
                </c:pt>
                <c:pt idx="79">
                  <c:v>22.2</c:v>
                </c:pt>
                <c:pt idx="80">
                  <c:v>22</c:v>
                </c:pt>
                <c:pt idx="81">
                  <c:v>21.8</c:v>
                </c:pt>
                <c:pt idx="82">
                  <c:v>21.7</c:v>
                </c:pt>
                <c:pt idx="83">
                  <c:v>21.5</c:v>
                </c:pt>
                <c:pt idx="84">
                  <c:v>21.3</c:v>
                </c:pt>
                <c:pt idx="85">
                  <c:v>21.2</c:v>
                </c:pt>
                <c:pt idx="86">
                  <c:v>21.1</c:v>
                </c:pt>
                <c:pt idx="87">
                  <c:v>20.9</c:v>
                </c:pt>
                <c:pt idx="88">
                  <c:v>20.8</c:v>
                </c:pt>
                <c:pt idx="89">
                  <c:v>21.1</c:v>
                </c:pt>
                <c:pt idx="90">
                  <c:v>23.1</c:v>
                </c:pt>
                <c:pt idx="91">
                  <c:v>25.1</c:v>
                </c:pt>
                <c:pt idx="92">
                  <c:v>25.8</c:v>
                </c:pt>
                <c:pt idx="93">
                  <c:v>25.3</c:v>
                </c:pt>
                <c:pt idx="94">
                  <c:v>24.8</c:v>
                </c:pt>
                <c:pt idx="95">
                  <c:v>24.2</c:v>
                </c:pt>
                <c:pt idx="96">
                  <c:v>23.7</c:v>
                </c:pt>
                <c:pt idx="97">
                  <c:v>23.4</c:v>
                </c:pt>
                <c:pt idx="98">
                  <c:v>23</c:v>
                </c:pt>
                <c:pt idx="99">
                  <c:v>22.7</c:v>
                </c:pt>
                <c:pt idx="100">
                  <c:v>22.5</c:v>
                </c:pt>
                <c:pt idx="101">
                  <c:v>22.3</c:v>
                </c:pt>
                <c:pt idx="102">
                  <c:v>22.1</c:v>
                </c:pt>
                <c:pt idx="103">
                  <c:v>22</c:v>
                </c:pt>
                <c:pt idx="104">
                  <c:v>21.9</c:v>
                </c:pt>
                <c:pt idx="105">
                  <c:v>21.9</c:v>
                </c:pt>
                <c:pt idx="106">
                  <c:v>21.8</c:v>
                </c:pt>
                <c:pt idx="107">
                  <c:v>21.8</c:v>
                </c:pt>
                <c:pt idx="108">
                  <c:v>21.8</c:v>
                </c:pt>
                <c:pt idx="109">
                  <c:v>21.7</c:v>
                </c:pt>
                <c:pt idx="110">
                  <c:v>21.6</c:v>
                </c:pt>
                <c:pt idx="111">
                  <c:v>21.6</c:v>
                </c:pt>
                <c:pt idx="112">
                  <c:v>21.5</c:v>
                </c:pt>
                <c:pt idx="113">
                  <c:v>21.4</c:v>
                </c:pt>
                <c:pt idx="114">
                  <c:v>21.5</c:v>
                </c:pt>
                <c:pt idx="115">
                  <c:v>21.6</c:v>
                </c:pt>
                <c:pt idx="116">
                  <c:v>21.8</c:v>
                </c:pt>
                <c:pt idx="117">
                  <c:v>21.9</c:v>
                </c:pt>
                <c:pt idx="118">
                  <c:v>22</c:v>
                </c:pt>
                <c:pt idx="119">
                  <c:v>22.1</c:v>
                </c:pt>
                <c:pt idx="120">
                  <c:v>22</c:v>
                </c:pt>
                <c:pt idx="121">
                  <c:v>22.1</c:v>
                </c:pt>
                <c:pt idx="122">
                  <c:v>22.1</c:v>
                </c:pt>
                <c:pt idx="123">
                  <c:v>22</c:v>
                </c:pt>
                <c:pt idx="124">
                  <c:v>21.8</c:v>
                </c:pt>
                <c:pt idx="125">
                  <c:v>21.7</c:v>
                </c:pt>
                <c:pt idx="126">
                  <c:v>21.6</c:v>
                </c:pt>
                <c:pt idx="127">
                  <c:v>21.6</c:v>
                </c:pt>
                <c:pt idx="128">
                  <c:v>21.6</c:v>
                </c:pt>
                <c:pt idx="129">
                  <c:v>21.6</c:v>
                </c:pt>
                <c:pt idx="130">
                  <c:v>21.6</c:v>
                </c:pt>
                <c:pt idx="131">
                  <c:v>21.6</c:v>
                </c:pt>
                <c:pt idx="132">
                  <c:v>21.6</c:v>
                </c:pt>
                <c:pt idx="133">
                  <c:v>21.6</c:v>
                </c:pt>
                <c:pt idx="134">
                  <c:v>21.4</c:v>
                </c:pt>
                <c:pt idx="135">
                  <c:v>21.3</c:v>
                </c:pt>
                <c:pt idx="136">
                  <c:v>21.2</c:v>
                </c:pt>
                <c:pt idx="137">
                  <c:v>21.6</c:v>
                </c:pt>
                <c:pt idx="138">
                  <c:v>24.2</c:v>
                </c:pt>
                <c:pt idx="139">
                  <c:v>25.9</c:v>
                </c:pt>
                <c:pt idx="140">
                  <c:v>26.1</c:v>
                </c:pt>
                <c:pt idx="141">
                  <c:v>25.6</c:v>
                </c:pt>
                <c:pt idx="142">
                  <c:v>24.8</c:v>
                </c:pt>
                <c:pt idx="143">
                  <c:v>24.2</c:v>
                </c:pt>
                <c:pt idx="144">
                  <c:v>23.8</c:v>
                </c:pt>
                <c:pt idx="145">
                  <c:v>23.5</c:v>
                </c:pt>
                <c:pt idx="146">
                  <c:v>23.3</c:v>
                </c:pt>
                <c:pt idx="147">
                  <c:v>23.1</c:v>
                </c:pt>
                <c:pt idx="148">
                  <c:v>22.7</c:v>
                </c:pt>
                <c:pt idx="149">
                  <c:v>22.3</c:v>
                </c:pt>
                <c:pt idx="150">
                  <c:v>22.1</c:v>
                </c:pt>
                <c:pt idx="151">
                  <c:v>21.8</c:v>
                </c:pt>
                <c:pt idx="152">
                  <c:v>21.6</c:v>
                </c:pt>
                <c:pt idx="153">
                  <c:v>21.4</c:v>
                </c:pt>
                <c:pt idx="154">
                  <c:v>21.3</c:v>
                </c:pt>
                <c:pt idx="155">
                  <c:v>21.2</c:v>
                </c:pt>
                <c:pt idx="156">
                  <c:v>20.9</c:v>
                </c:pt>
                <c:pt idx="157">
                  <c:v>20.8</c:v>
                </c:pt>
                <c:pt idx="158">
                  <c:v>20.7</c:v>
                </c:pt>
                <c:pt idx="159">
                  <c:v>20.6</c:v>
                </c:pt>
                <c:pt idx="160">
                  <c:v>20.399999999999999</c:v>
                </c:pt>
                <c:pt idx="161">
                  <c:v>20.5</c:v>
                </c:pt>
                <c:pt idx="162">
                  <c:v>21.9</c:v>
                </c:pt>
                <c:pt idx="163">
                  <c:v>23.3</c:v>
                </c:pt>
                <c:pt idx="164">
                  <c:v>24.3</c:v>
                </c:pt>
                <c:pt idx="165">
                  <c:v>25.8</c:v>
                </c:pt>
                <c:pt idx="166">
                  <c:v>24.3</c:v>
                </c:pt>
                <c:pt idx="167">
                  <c:v>23.9</c:v>
                </c:pt>
                <c:pt idx="168">
                  <c:v>23.8</c:v>
                </c:pt>
                <c:pt idx="169">
                  <c:v>23.3</c:v>
                </c:pt>
                <c:pt idx="170">
                  <c:v>22.9</c:v>
                </c:pt>
                <c:pt idx="171">
                  <c:v>22.6</c:v>
                </c:pt>
                <c:pt idx="172">
                  <c:v>22.2</c:v>
                </c:pt>
                <c:pt idx="173">
                  <c:v>21.9</c:v>
                </c:pt>
                <c:pt idx="174">
                  <c:v>21.7</c:v>
                </c:pt>
                <c:pt idx="175">
                  <c:v>21.4</c:v>
                </c:pt>
                <c:pt idx="176">
                  <c:v>21.1</c:v>
                </c:pt>
                <c:pt idx="177">
                  <c:v>20.9</c:v>
                </c:pt>
                <c:pt idx="178">
                  <c:v>20.7</c:v>
                </c:pt>
                <c:pt idx="179">
                  <c:v>20.6</c:v>
                </c:pt>
                <c:pt idx="180">
                  <c:v>20.5</c:v>
                </c:pt>
                <c:pt idx="181">
                  <c:v>20.399999999999999</c:v>
                </c:pt>
                <c:pt idx="182">
                  <c:v>20.3</c:v>
                </c:pt>
                <c:pt idx="183">
                  <c:v>20.2</c:v>
                </c:pt>
                <c:pt idx="184">
                  <c:v>20.100000000000001</c:v>
                </c:pt>
                <c:pt idx="185">
                  <c:v>20.8</c:v>
                </c:pt>
                <c:pt idx="186">
                  <c:v>23.4</c:v>
                </c:pt>
                <c:pt idx="187">
                  <c:v>25.1</c:v>
                </c:pt>
                <c:pt idx="188">
                  <c:v>25.6</c:v>
                </c:pt>
                <c:pt idx="189">
                  <c:v>25.3</c:v>
                </c:pt>
                <c:pt idx="190">
                  <c:v>25.2</c:v>
                </c:pt>
                <c:pt idx="191">
                  <c:v>24.8</c:v>
                </c:pt>
                <c:pt idx="192">
                  <c:v>24.4</c:v>
                </c:pt>
                <c:pt idx="193">
                  <c:v>24.1</c:v>
                </c:pt>
                <c:pt idx="194">
                  <c:v>23.8</c:v>
                </c:pt>
                <c:pt idx="195">
                  <c:v>23.4</c:v>
                </c:pt>
                <c:pt idx="196">
                  <c:v>23</c:v>
                </c:pt>
                <c:pt idx="197">
                  <c:v>22.6</c:v>
                </c:pt>
                <c:pt idx="198">
                  <c:v>22.2</c:v>
                </c:pt>
                <c:pt idx="199">
                  <c:v>21.9</c:v>
                </c:pt>
                <c:pt idx="200">
                  <c:v>21.8</c:v>
                </c:pt>
                <c:pt idx="201">
                  <c:v>21.7</c:v>
                </c:pt>
                <c:pt idx="202">
                  <c:v>21.6</c:v>
                </c:pt>
                <c:pt idx="203">
                  <c:v>21.4</c:v>
                </c:pt>
                <c:pt idx="204">
                  <c:v>21.3</c:v>
                </c:pt>
                <c:pt idx="205">
                  <c:v>21.2</c:v>
                </c:pt>
                <c:pt idx="206">
                  <c:v>21.2</c:v>
                </c:pt>
                <c:pt idx="207">
                  <c:v>21.2</c:v>
                </c:pt>
                <c:pt idx="208">
                  <c:v>21.2</c:v>
                </c:pt>
                <c:pt idx="209">
                  <c:v>21.2</c:v>
                </c:pt>
                <c:pt idx="210">
                  <c:v>21.3</c:v>
                </c:pt>
                <c:pt idx="211">
                  <c:v>21.3</c:v>
                </c:pt>
                <c:pt idx="212">
                  <c:v>21.3</c:v>
                </c:pt>
                <c:pt idx="213">
                  <c:v>21.5</c:v>
                </c:pt>
                <c:pt idx="214">
                  <c:v>22.2</c:v>
                </c:pt>
                <c:pt idx="215">
                  <c:v>22.9</c:v>
                </c:pt>
                <c:pt idx="216">
                  <c:v>23.1</c:v>
                </c:pt>
                <c:pt idx="217">
                  <c:v>23.1</c:v>
                </c:pt>
                <c:pt idx="218">
                  <c:v>23.2</c:v>
                </c:pt>
                <c:pt idx="219">
                  <c:v>23.1</c:v>
                </c:pt>
                <c:pt idx="220">
                  <c:v>22.9</c:v>
                </c:pt>
                <c:pt idx="221">
                  <c:v>22.6</c:v>
                </c:pt>
                <c:pt idx="222">
                  <c:v>22.4</c:v>
                </c:pt>
                <c:pt idx="223">
                  <c:v>22.2</c:v>
                </c:pt>
                <c:pt idx="224">
                  <c:v>22.1</c:v>
                </c:pt>
                <c:pt idx="225">
                  <c:v>21.9</c:v>
                </c:pt>
                <c:pt idx="226">
                  <c:v>21.8</c:v>
                </c:pt>
                <c:pt idx="227">
                  <c:v>21.7</c:v>
                </c:pt>
                <c:pt idx="228">
                  <c:v>21.7</c:v>
                </c:pt>
                <c:pt idx="229">
                  <c:v>21.7</c:v>
                </c:pt>
                <c:pt idx="230">
                  <c:v>21.6</c:v>
                </c:pt>
                <c:pt idx="231">
                  <c:v>21.3</c:v>
                </c:pt>
                <c:pt idx="232">
                  <c:v>21.2</c:v>
                </c:pt>
                <c:pt idx="233">
                  <c:v>21.2</c:v>
                </c:pt>
                <c:pt idx="234">
                  <c:v>21.4</c:v>
                </c:pt>
                <c:pt idx="235">
                  <c:v>21.9</c:v>
                </c:pt>
                <c:pt idx="236">
                  <c:v>22.1</c:v>
                </c:pt>
                <c:pt idx="237">
                  <c:v>22.9</c:v>
                </c:pt>
                <c:pt idx="238">
                  <c:v>23.2</c:v>
                </c:pt>
                <c:pt idx="239">
                  <c:v>23.1</c:v>
                </c:pt>
                <c:pt idx="240">
                  <c:v>23.2</c:v>
                </c:pt>
                <c:pt idx="241">
                  <c:v>23.1</c:v>
                </c:pt>
                <c:pt idx="242">
                  <c:v>23.1</c:v>
                </c:pt>
                <c:pt idx="243">
                  <c:v>22.8</c:v>
                </c:pt>
                <c:pt idx="244">
                  <c:v>22.4</c:v>
                </c:pt>
                <c:pt idx="245">
                  <c:v>22.1</c:v>
                </c:pt>
                <c:pt idx="246">
                  <c:v>21.9</c:v>
                </c:pt>
                <c:pt idx="247">
                  <c:v>21.8</c:v>
                </c:pt>
                <c:pt idx="248">
                  <c:v>21.7</c:v>
                </c:pt>
                <c:pt idx="249">
                  <c:v>21.7</c:v>
                </c:pt>
                <c:pt idx="250">
                  <c:v>21.7</c:v>
                </c:pt>
                <c:pt idx="251">
                  <c:v>21.4</c:v>
                </c:pt>
                <c:pt idx="252">
                  <c:v>21.3</c:v>
                </c:pt>
                <c:pt idx="253">
                  <c:v>21.1</c:v>
                </c:pt>
                <c:pt idx="254">
                  <c:v>21</c:v>
                </c:pt>
                <c:pt idx="255">
                  <c:v>20.9</c:v>
                </c:pt>
                <c:pt idx="256">
                  <c:v>20.8</c:v>
                </c:pt>
                <c:pt idx="257">
                  <c:v>20.9</c:v>
                </c:pt>
                <c:pt idx="258">
                  <c:v>21.2</c:v>
                </c:pt>
                <c:pt idx="259">
                  <c:v>21.3</c:v>
                </c:pt>
                <c:pt idx="260">
                  <c:v>21.4</c:v>
                </c:pt>
                <c:pt idx="261">
                  <c:v>21.6</c:v>
                </c:pt>
                <c:pt idx="262">
                  <c:v>21.8</c:v>
                </c:pt>
                <c:pt idx="263">
                  <c:v>22.2</c:v>
                </c:pt>
                <c:pt idx="264">
                  <c:v>22.4</c:v>
                </c:pt>
                <c:pt idx="265">
                  <c:v>22.2</c:v>
                </c:pt>
                <c:pt idx="266">
                  <c:v>22.2</c:v>
                </c:pt>
                <c:pt idx="267">
                  <c:v>22.1</c:v>
                </c:pt>
                <c:pt idx="268">
                  <c:v>21.8</c:v>
                </c:pt>
                <c:pt idx="269">
                  <c:v>21.4</c:v>
                </c:pt>
                <c:pt idx="270">
                  <c:v>21.2</c:v>
                </c:pt>
                <c:pt idx="271">
                  <c:v>20.9</c:v>
                </c:pt>
                <c:pt idx="272">
                  <c:v>20.8</c:v>
                </c:pt>
                <c:pt idx="273">
                  <c:v>20.7</c:v>
                </c:pt>
                <c:pt idx="274">
                  <c:v>20.6</c:v>
                </c:pt>
                <c:pt idx="275">
                  <c:v>20.5</c:v>
                </c:pt>
                <c:pt idx="276">
                  <c:v>20.5</c:v>
                </c:pt>
                <c:pt idx="277">
                  <c:v>20.5</c:v>
                </c:pt>
                <c:pt idx="278">
                  <c:v>20.6</c:v>
                </c:pt>
                <c:pt idx="279">
                  <c:v>20.7</c:v>
                </c:pt>
                <c:pt idx="280">
                  <c:v>20.6</c:v>
                </c:pt>
                <c:pt idx="281">
                  <c:v>20.6</c:v>
                </c:pt>
                <c:pt idx="282">
                  <c:v>20.7</c:v>
                </c:pt>
                <c:pt idx="283">
                  <c:v>20.8</c:v>
                </c:pt>
                <c:pt idx="284">
                  <c:v>21</c:v>
                </c:pt>
                <c:pt idx="285">
                  <c:v>21.2</c:v>
                </c:pt>
                <c:pt idx="286">
                  <c:v>21.9</c:v>
                </c:pt>
                <c:pt idx="287">
                  <c:v>22.3</c:v>
                </c:pt>
                <c:pt idx="288">
                  <c:v>22.6</c:v>
                </c:pt>
                <c:pt idx="289">
                  <c:v>22.7</c:v>
                </c:pt>
                <c:pt idx="290">
                  <c:v>22.6</c:v>
                </c:pt>
                <c:pt idx="291">
                  <c:v>22.3</c:v>
                </c:pt>
                <c:pt idx="292">
                  <c:v>22</c:v>
                </c:pt>
                <c:pt idx="293">
                  <c:v>21.8</c:v>
                </c:pt>
                <c:pt idx="294">
                  <c:v>21.6</c:v>
                </c:pt>
                <c:pt idx="295">
                  <c:v>21.5</c:v>
                </c:pt>
                <c:pt idx="296">
                  <c:v>21.3</c:v>
                </c:pt>
                <c:pt idx="297">
                  <c:v>21.1</c:v>
                </c:pt>
                <c:pt idx="298">
                  <c:v>20.9</c:v>
                </c:pt>
                <c:pt idx="299">
                  <c:v>20.9</c:v>
                </c:pt>
                <c:pt idx="300">
                  <c:v>20.8</c:v>
                </c:pt>
                <c:pt idx="301">
                  <c:v>20.7</c:v>
                </c:pt>
                <c:pt idx="302">
                  <c:v>20.7</c:v>
                </c:pt>
                <c:pt idx="303">
                  <c:v>20.6</c:v>
                </c:pt>
                <c:pt idx="304">
                  <c:v>20.6</c:v>
                </c:pt>
                <c:pt idx="305">
                  <c:v>20.6</c:v>
                </c:pt>
                <c:pt idx="306">
                  <c:v>20.8</c:v>
                </c:pt>
                <c:pt idx="307">
                  <c:v>21.3</c:v>
                </c:pt>
                <c:pt idx="308">
                  <c:v>21.8</c:v>
                </c:pt>
                <c:pt idx="309">
                  <c:v>22.4</c:v>
                </c:pt>
                <c:pt idx="310">
                  <c:v>23.1</c:v>
                </c:pt>
                <c:pt idx="311">
                  <c:v>23.6</c:v>
                </c:pt>
                <c:pt idx="312">
                  <c:v>23.7</c:v>
                </c:pt>
                <c:pt idx="313">
                  <c:v>23.6</c:v>
                </c:pt>
                <c:pt idx="314">
                  <c:v>23.2</c:v>
                </c:pt>
                <c:pt idx="315">
                  <c:v>22.7</c:v>
                </c:pt>
                <c:pt idx="316">
                  <c:v>22.3</c:v>
                </c:pt>
                <c:pt idx="317">
                  <c:v>22.1</c:v>
                </c:pt>
                <c:pt idx="318">
                  <c:v>21.9</c:v>
                </c:pt>
                <c:pt idx="319">
                  <c:v>21.8</c:v>
                </c:pt>
                <c:pt idx="320">
                  <c:v>21.7</c:v>
                </c:pt>
                <c:pt idx="321">
                  <c:v>21.6</c:v>
                </c:pt>
                <c:pt idx="322">
                  <c:v>21.6</c:v>
                </c:pt>
                <c:pt idx="323">
                  <c:v>21.6</c:v>
                </c:pt>
                <c:pt idx="324">
                  <c:v>21.6</c:v>
                </c:pt>
                <c:pt idx="325">
                  <c:v>21.6</c:v>
                </c:pt>
                <c:pt idx="326">
                  <c:v>21.5</c:v>
                </c:pt>
                <c:pt idx="327">
                  <c:v>21.4</c:v>
                </c:pt>
                <c:pt idx="328">
                  <c:v>21.4</c:v>
                </c:pt>
                <c:pt idx="329">
                  <c:v>21.4</c:v>
                </c:pt>
                <c:pt idx="330">
                  <c:v>21.4</c:v>
                </c:pt>
                <c:pt idx="331">
                  <c:v>21.8</c:v>
                </c:pt>
                <c:pt idx="332">
                  <c:v>22.4</c:v>
                </c:pt>
                <c:pt idx="333">
                  <c:v>23.2</c:v>
                </c:pt>
                <c:pt idx="334">
                  <c:v>23.5</c:v>
                </c:pt>
                <c:pt idx="335">
                  <c:v>23.6</c:v>
                </c:pt>
                <c:pt idx="336">
                  <c:v>23.4</c:v>
                </c:pt>
                <c:pt idx="337">
                  <c:v>23.4</c:v>
                </c:pt>
                <c:pt idx="338">
                  <c:v>23.2</c:v>
                </c:pt>
                <c:pt idx="339">
                  <c:v>23</c:v>
                </c:pt>
                <c:pt idx="340">
                  <c:v>22.7</c:v>
                </c:pt>
                <c:pt idx="341">
                  <c:v>22.3</c:v>
                </c:pt>
                <c:pt idx="342">
                  <c:v>22.1</c:v>
                </c:pt>
                <c:pt idx="343">
                  <c:v>21.9</c:v>
                </c:pt>
                <c:pt idx="344">
                  <c:v>21.7</c:v>
                </c:pt>
                <c:pt idx="345">
                  <c:v>21.6</c:v>
                </c:pt>
                <c:pt idx="346">
                  <c:v>21.5</c:v>
                </c:pt>
                <c:pt idx="347">
                  <c:v>21.4</c:v>
                </c:pt>
                <c:pt idx="348">
                  <c:v>21.4</c:v>
                </c:pt>
                <c:pt idx="349">
                  <c:v>21.4</c:v>
                </c:pt>
                <c:pt idx="350">
                  <c:v>21.4</c:v>
                </c:pt>
                <c:pt idx="351">
                  <c:v>21.4</c:v>
                </c:pt>
                <c:pt idx="352">
                  <c:v>21.4</c:v>
                </c:pt>
                <c:pt idx="353">
                  <c:v>21.6</c:v>
                </c:pt>
                <c:pt idx="354">
                  <c:v>21.8</c:v>
                </c:pt>
                <c:pt idx="355">
                  <c:v>22.2</c:v>
                </c:pt>
                <c:pt idx="356">
                  <c:v>22.4</c:v>
                </c:pt>
                <c:pt idx="357">
                  <c:v>22.8</c:v>
                </c:pt>
                <c:pt idx="358">
                  <c:v>23</c:v>
                </c:pt>
                <c:pt idx="359">
                  <c:v>22.7</c:v>
                </c:pt>
                <c:pt idx="360">
                  <c:v>22.9</c:v>
                </c:pt>
                <c:pt idx="361">
                  <c:v>22.8</c:v>
                </c:pt>
                <c:pt idx="362">
                  <c:v>22.8</c:v>
                </c:pt>
                <c:pt idx="363">
                  <c:v>22.8</c:v>
                </c:pt>
                <c:pt idx="364">
                  <c:v>22.6</c:v>
                </c:pt>
                <c:pt idx="365">
                  <c:v>22.2</c:v>
                </c:pt>
                <c:pt idx="366">
                  <c:v>21.9</c:v>
                </c:pt>
                <c:pt idx="367">
                  <c:v>21.7</c:v>
                </c:pt>
                <c:pt idx="368">
                  <c:v>21.6</c:v>
                </c:pt>
                <c:pt idx="369">
                  <c:v>21.4</c:v>
                </c:pt>
                <c:pt idx="370">
                  <c:v>21.3</c:v>
                </c:pt>
                <c:pt idx="371">
                  <c:v>21.1</c:v>
                </c:pt>
                <c:pt idx="372">
                  <c:v>20.9</c:v>
                </c:pt>
                <c:pt idx="373">
                  <c:v>20.8</c:v>
                </c:pt>
                <c:pt idx="374">
                  <c:v>20.7</c:v>
                </c:pt>
                <c:pt idx="375">
                  <c:v>20.7</c:v>
                </c:pt>
                <c:pt idx="376">
                  <c:v>20.8</c:v>
                </c:pt>
                <c:pt idx="377">
                  <c:v>21</c:v>
                </c:pt>
                <c:pt idx="378">
                  <c:v>21.5</c:v>
                </c:pt>
                <c:pt idx="379">
                  <c:v>23.6</c:v>
                </c:pt>
                <c:pt idx="380">
                  <c:v>24.6</c:v>
                </c:pt>
                <c:pt idx="381">
                  <c:v>24.4</c:v>
                </c:pt>
                <c:pt idx="382">
                  <c:v>24.7</c:v>
                </c:pt>
                <c:pt idx="383">
                  <c:v>24.9</c:v>
                </c:pt>
                <c:pt idx="384">
                  <c:v>24.7</c:v>
                </c:pt>
                <c:pt idx="385">
                  <c:v>24.3</c:v>
                </c:pt>
                <c:pt idx="386">
                  <c:v>23.9</c:v>
                </c:pt>
                <c:pt idx="387">
                  <c:v>23.6</c:v>
                </c:pt>
                <c:pt idx="388">
                  <c:v>23.1</c:v>
                </c:pt>
                <c:pt idx="389">
                  <c:v>22.6</c:v>
                </c:pt>
                <c:pt idx="390">
                  <c:v>22.3</c:v>
                </c:pt>
                <c:pt idx="391">
                  <c:v>22.2</c:v>
                </c:pt>
                <c:pt idx="392">
                  <c:v>22</c:v>
                </c:pt>
                <c:pt idx="393">
                  <c:v>21.9</c:v>
                </c:pt>
                <c:pt idx="394">
                  <c:v>21.8</c:v>
                </c:pt>
                <c:pt idx="395">
                  <c:v>21.7</c:v>
                </c:pt>
                <c:pt idx="396">
                  <c:v>21.6</c:v>
                </c:pt>
                <c:pt idx="397">
                  <c:v>21.5</c:v>
                </c:pt>
                <c:pt idx="398">
                  <c:v>21.5</c:v>
                </c:pt>
                <c:pt idx="399">
                  <c:v>21.5</c:v>
                </c:pt>
                <c:pt idx="400">
                  <c:v>21.4</c:v>
                </c:pt>
                <c:pt idx="401">
                  <c:v>22.4</c:v>
                </c:pt>
                <c:pt idx="402">
                  <c:v>23.9</c:v>
                </c:pt>
                <c:pt idx="403">
                  <c:v>24.2</c:v>
                </c:pt>
                <c:pt idx="404">
                  <c:v>24.3</c:v>
                </c:pt>
                <c:pt idx="405">
                  <c:v>24.1</c:v>
                </c:pt>
                <c:pt idx="406">
                  <c:v>23.9</c:v>
                </c:pt>
                <c:pt idx="407">
                  <c:v>23.7</c:v>
                </c:pt>
                <c:pt idx="408">
                  <c:v>23.6</c:v>
                </c:pt>
                <c:pt idx="409">
                  <c:v>23.4</c:v>
                </c:pt>
                <c:pt idx="410">
                  <c:v>23.2</c:v>
                </c:pt>
                <c:pt idx="411">
                  <c:v>22.8</c:v>
                </c:pt>
                <c:pt idx="412">
                  <c:v>22.2</c:v>
                </c:pt>
                <c:pt idx="413">
                  <c:v>21.8</c:v>
                </c:pt>
                <c:pt idx="414">
                  <c:v>21.4</c:v>
                </c:pt>
                <c:pt idx="415">
                  <c:v>21.2</c:v>
                </c:pt>
                <c:pt idx="416">
                  <c:v>20.9</c:v>
                </c:pt>
                <c:pt idx="417">
                  <c:v>20.8</c:v>
                </c:pt>
                <c:pt idx="418">
                  <c:v>20.6</c:v>
                </c:pt>
                <c:pt idx="419">
                  <c:v>20.6</c:v>
                </c:pt>
                <c:pt idx="420">
                  <c:v>20.5</c:v>
                </c:pt>
                <c:pt idx="421">
                  <c:v>20.5</c:v>
                </c:pt>
                <c:pt idx="422">
                  <c:v>20.5</c:v>
                </c:pt>
                <c:pt idx="423">
                  <c:v>20.6</c:v>
                </c:pt>
                <c:pt idx="424">
                  <c:v>20.7</c:v>
                </c:pt>
                <c:pt idx="425">
                  <c:v>21.3</c:v>
                </c:pt>
                <c:pt idx="426">
                  <c:v>23.3</c:v>
                </c:pt>
                <c:pt idx="427">
                  <c:v>24.6</c:v>
                </c:pt>
                <c:pt idx="428">
                  <c:v>24.9</c:v>
                </c:pt>
                <c:pt idx="429">
                  <c:v>24.8</c:v>
                </c:pt>
                <c:pt idx="430">
                  <c:v>24.6</c:v>
                </c:pt>
                <c:pt idx="431">
                  <c:v>24.2</c:v>
                </c:pt>
                <c:pt idx="432">
                  <c:v>24</c:v>
                </c:pt>
                <c:pt idx="433">
                  <c:v>23.7</c:v>
                </c:pt>
                <c:pt idx="434">
                  <c:v>23.4</c:v>
                </c:pt>
                <c:pt idx="435">
                  <c:v>22.9</c:v>
                </c:pt>
                <c:pt idx="436">
                  <c:v>22.4</c:v>
                </c:pt>
                <c:pt idx="437">
                  <c:v>22.1</c:v>
                </c:pt>
                <c:pt idx="438">
                  <c:v>21.9</c:v>
                </c:pt>
                <c:pt idx="439">
                  <c:v>21.8</c:v>
                </c:pt>
                <c:pt idx="440">
                  <c:v>21.7</c:v>
                </c:pt>
                <c:pt idx="441">
                  <c:v>21.6</c:v>
                </c:pt>
                <c:pt idx="442">
                  <c:v>21.6</c:v>
                </c:pt>
                <c:pt idx="443">
                  <c:v>21.4</c:v>
                </c:pt>
                <c:pt idx="444">
                  <c:v>21.3</c:v>
                </c:pt>
                <c:pt idx="445">
                  <c:v>21.3</c:v>
                </c:pt>
                <c:pt idx="446">
                  <c:v>21.3</c:v>
                </c:pt>
                <c:pt idx="447">
                  <c:v>21.2</c:v>
                </c:pt>
                <c:pt idx="448">
                  <c:v>21.2</c:v>
                </c:pt>
                <c:pt idx="449">
                  <c:v>21.2</c:v>
                </c:pt>
                <c:pt idx="450">
                  <c:v>21.4</c:v>
                </c:pt>
                <c:pt idx="451">
                  <c:v>21.7</c:v>
                </c:pt>
                <c:pt idx="452">
                  <c:v>22.2</c:v>
                </c:pt>
                <c:pt idx="453">
                  <c:v>22.5</c:v>
                </c:pt>
                <c:pt idx="454">
                  <c:v>22.7</c:v>
                </c:pt>
                <c:pt idx="455">
                  <c:v>22.8</c:v>
                </c:pt>
                <c:pt idx="456">
                  <c:v>23.1</c:v>
                </c:pt>
                <c:pt idx="457">
                  <c:v>23.1</c:v>
                </c:pt>
                <c:pt idx="458">
                  <c:v>23</c:v>
                </c:pt>
                <c:pt idx="459">
                  <c:v>22.8</c:v>
                </c:pt>
                <c:pt idx="460">
                  <c:v>22.3</c:v>
                </c:pt>
                <c:pt idx="461">
                  <c:v>22</c:v>
                </c:pt>
                <c:pt idx="462">
                  <c:v>21.8</c:v>
                </c:pt>
                <c:pt idx="463">
                  <c:v>21.7</c:v>
                </c:pt>
                <c:pt idx="464">
                  <c:v>21.6</c:v>
                </c:pt>
                <c:pt idx="465">
                  <c:v>21.4</c:v>
                </c:pt>
                <c:pt idx="466">
                  <c:v>21.2</c:v>
                </c:pt>
                <c:pt idx="467">
                  <c:v>20.9</c:v>
                </c:pt>
                <c:pt idx="468">
                  <c:v>20.8</c:v>
                </c:pt>
                <c:pt idx="469">
                  <c:v>20.7</c:v>
                </c:pt>
                <c:pt idx="470">
                  <c:v>20.7</c:v>
                </c:pt>
                <c:pt idx="471">
                  <c:v>20.7</c:v>
                </c:pt>
                <c:pt idx="472">
                  <c:v>20.7</c:v>
                </c:pt>
                <c:pt idx="473">
                  <c:v>22.3</c:v>
                </c:pt>
                <c:pt idx="474">
                  <c:v>24.5</c:v>
                </c:pt>
                <c:pt idx="475">
                  <c:v>25.6</c:v>
                </c:pt>
                <c:pt idx="476">
                  <c:v>25.9</c:v>
                </c:pt>
                <c:pt idx="477">
                  <c:v>25.4</c:v>
                </c:pt>
                <c:pt idx="478">
                  <c:v>24.9</c:v>
                </c:pt>
                <c:pt idx="479">
                  <c:v>24.7</c:v>
                </c:pt>
                <c:pt idx="480">
                  <c:v>24.6</c:v>
                </c:pt>
                <c:pt idx="481">
                  <c:v>24.6</c:v>
                </c:pt>
                <c:pt idx="482">
                  <c:v>24.3</c:v>
                </c:pt>
                <c:pt idx="483">
                  <c:v>24</c:v>
                </c:pt>
                <c:pt idx="484">
                  <c:v>23.6</c:v>
                </c:pt>
                <c:pt idx="485">
                  <c:v>23.1</c:v>
                </c:pt>
                <c:pt idx="486">
                  <c:v>22.7</c:v>
                </c:pt>
                <c:pt idx="487">
                  <c:v>22.4</c:v>
                </c:pt>
                <c:pt idx="488">
                  <c:v>22.2</c:v>
                </c:pt>
                <c:pt idx="489">
                  <c:v>22.2</c:v>
                </c:pt>
                <c:pt idx="490">
                  <c:v>22.2</c:v>
                </c:pt>
                <c:pt idx="491">
                  <c:v>22.2</c:v>
                </c:pt>
                <c:pt idx="492">
                  <c:v>22.3</c:v>
                </c:pt>
                <c:pt idx="493">
                  <c:v>22.2</c:v>
                </c:pt>
                <c:pt idx="494">
                  <c:v>22.2</c:v>
                </c:pt>
                <c:pt idx="495">
                  <c:v>22.1</c:v>
                </c:pt>
                <c:pt idx="496">
                  <c:v>22.1</c:v>
                </c:pt>
                <c:pt idx="497">
                  <c:v>22.1</c:v>
                </c:pt>
                <c:pt idx="498">
                  <c:v>22.2</c:v>
                </c:pt>
                <c:pt idx="499">
                  <c:v>22.6</c:v>
                </c:pt>
                <c:pt idx="500">
                  <c:v>22.9</c:v>
                </c:pt>
                <c:pt idx="501">
                  <c:v>23.1</c:v>
                </c:pt>
                <c:pt idx="502">
                  <c:v>22.9</c:v>
                </c:pt>
                <c:pt idx="503">
                  <c:v>22.7</c:v>
                </c:pt>
                <c:pt idx="504">
                  <c:v>22.3</c:v>
                </c:pt>
                <c:pt idx="505">
                  <c:v>22.3</c:v>
                </c:pt>
                <c:pt idx="506">
                  <c:v>22.5</c:v>
                </c:pt>
                <c:pt idx="507">
                  <c:v>22.4</c:v>
                </c:pt>
                <c:pt idx="508">
                  <c:v>22.3</c:v>
                </c:pt>
                <c:pt idx="509">
                  <c:v>22.2</c:v>
                </c:pt>
                <c:pt idx="510">
                  <c:v>22.1</c:v>
                </c:pt>
                <c:pt idx="511">
                  <c:v>22</c:v>
                </c:pt>
                <c:pt idx="512">
                  <c:v>21.9</c:v>
                </c:pt>
                <c:pt idx="513">
                  <c:v>21.9</c:v>
                </c:pt>
                <c:pt idx="514">
                  <c:v>21.9</c:v>
                </c:pt>
                <c:pt idx="515">
                  <c:v>21.8</c:v>
                </c:pt>
                <c:pt idx="516">
                  <c:v>21.8</c:v>
                </c:pt>
                <c:pt idx="517">
                  <c:v>21.8</c:v>
                </c:pt>
                <c:pt idx="518">
                  <c:v>21.8</c:v>
                </c:pt>
                <c:pt idx="519">
                  <c:v>21.7</c:v>
                </c:pt>
                <c:pt idx="520">
                  <c:v>21.7</c:v>
                </c:pt>
                <c:pt idx="521">
                  <c:v>21.7</c:v>
                </c:pt>
                <c:pt idx="522">
                  <c:v>21.9</c:v>
                </c:pt>
                <c:pt idx="523">
                  <c:v>22.3</c:v>
                </c:pt>
                <c:pt idx="524">
                  <c:v>22.9</c:v>
                </c:pt>
                <c:pt idx="525">
                  <c:v>23.4</c:v>
                </c:pt>
                <c:pt idx="526">
                  <c:v>23.8</c:v>
                </c:pt>
                <c:pt idx="527">
                  <c:v>24</c:v>
                </c:pt>
                <c:pt idx="528">
                  <c:v>24</c:v>
                </c:pt>
                <c:pt idx="529">
                  <c:v>23.9</c:v>
                </c:pt>
                <c:pt idx="530">
                  <c:v>23.7</c:v>
                </c:pt>
                <c:pt idx="531">
                  <c:v>23.6</c:v>
                </c:pt>
                <c:pt idx="532">
                  <c:v>23.3</c:v>
                </c:pt>
                <c:pt idx="533">
                  <c:v>23</c:v>
                </c:pt>
                <c:pt idx="534">
                  <c:v>22.7</c:v>
                </c:pt>
                <c:pt idx="535">
                  <c:v>22.4</c:v>
                </c:pt>
                <c:pt idx="536">
                  <c:v>22.2</c:v>
                </c:pt>
                <c:pt idx="537">
                  <c:v>22.1</c:v>
                </c:pt>
                <c:pt idx="538">
                  <c:v>21.9</c:v>
                </c:pt>
                <c:pt idx="539">
                  <c:v>21.8</c:v>
                </c:pt>
                <c:pt idx="540">
                  <c:v>21.7</c:v>
                </c:pt>
                <c:pt idx="541">
                  <c:v>21.6</c:v>
                </c:pt>
                <c:pt idx="542">
                  <c:v>21.4</c:v>
                </c:pt>
                <c:pt idx="543">
                  <c:v>21.3</c:v>
                </c:pt>
                <c:pt idx="544">
                  <c:v>21.3</c:v>
                </c:pt>
                <c:pt idx="545">
                  <c:v>22.1</c:v>
                </c:pt>
                <c:pt idx="546">
                  <c:v>24.2</c:v>
                </c:pt>
                <c:pt idx="547">
                  <c:v>25.7</c:v>
                </c:pt>
                <c:pt idx="548">
                  <c:v>26</c:v>
                </c:pt>
                <c:pt idx="549">
                  <c:v>25.7</c:v>
                </c:pt>
                <c:pt idx="550">
                  <c:v>25.4</c:v>
                </c:pt>
                <c:pt idx="551">
                  <c:v>25.2</c:v>
                </c:pt>
                <c:pt idx="552">
                  <c:v>25.1</c:v>
                </c:pt>
                <c:pt idx="553">
                  <c:v>24.8</c:v>
                </c:pt>
                <c:pt idx="554">
                  <c:v>24.6</c:v>
                </c:pt>
                <c:pt idx="555">
                  <c:v>24.3</c:v>
                </c:pt>
                <c:pt idx="556">
                  <c:v>23.9</c:v>
                </c:pt>
                <c:pt idx="557">
                  <c:v>23.6</c:v>
                </c:pt>
                <c:pt idx="558">
                  <c:v>23.2</c:v>
                </c:pt>
                <c:pt idx="559">
                  <c:v>22.9</c:v>
                </c:pt>
                <c:pt idx="560">
                  <c:v>22.7</c:v>
                </c:pt>
                <c:pt idx="561">
                  <c:v>22.6</c:v>
                </c:pt>
                <c:pt idx="562">
                  <c:v>22.4</c:v>
                </c:pt>
                <c:pt idx="563">
                  <c:v>22.3</c:v>
                </c:pt>
                <c:pt idx="564">
                  <c:v>22.2</c:v>
                </c:pt>
                <c:pt idx="565">
                  <c:v>22.1</c:v>
                </c:pt>
                <c:pt idx="566">
                  <c:v>22.1</c:v>
                </c:pt>
                <c:pt idx="567">
                  <c:v>22.1</c:v>
                </c:pt>
                <c:pt idx="568">
                  <c:v>22.1</c:v>
                </c:pt>
                <c:pt idx="569">
                  <c:v>22.1</c:v>
                </c:pt>
                <c:pt idx="570">
                  <c:v>22.3</c:v>
                </c:pt>
                <c:pt idx="571">
                  <c:v>23.8</c:v>
                </c:pt>
                <c:pt idx="572">
                  <c:v>24.7</c:v>
                </c:pt>
                <c:pt idx="573">
                  <c:v>25</c:v>
                </c:pt>
                <c:pt idx="574">
                  <c:v>25.1</c:v>
                </c:pt>
                <c:pt idx="575">
                  <c:v>25</c:v>
                </c:pt>
                <c:pt idx="576">
                  <c:v>24.7</c:v>
                </c:pt>
                <c:pt idx="577">
                  <c:v>24.6</c:v>
                </c:pt>
                <c:pt idx="578">
                  <c:v>24.4</c:v>
                </c:pt>
                <c:pt idx="579">
                  <c:v>24.2</c:v>
                </c:pt>
                <c:pt idx="580">
                  <c:v>23.9</c:v>
                </c:pt>
                <c:pt idx="581">
                  <c:v>23.4</c:v>
                </c:pt>
                <c:pt idx="582">
                  <c:v>23.1</c:v>
                </c:pt>
                <c:pt idx="583">
                  <c:v>22.8</c:v>
                </c:pt>
                <c:pt idx="584">
                  <c:v>22.6</c:v>
                </c:pt>
                <c:pt idx="585">
                  <c:v>22.4</c:v>
                </c:pt>
                <c:pt idx="586">
                  <c:v>22.2</c:v>
                </c:pt>
                <c:pt idx="587">
                  <c:v>22.1</c:v>
                </c:pt>
                <c:pt idx="588">
                  <c:v>22</c:v>
                </c:pt>
                <c:pt idx="589">
                  <c:v>21.9</c:v>
                </c:pt>
                <c:pt idx="590">
                  <c:v>21.8</c:v>
                </c:pt>
                <c:pt idx="591">
                  <c:v>21.8</c:v>
                </c:pt>
                <c:pt idx="592">
                  <c:v>21.8</c:v>
                </c:pt>
                <c:pt idx="593">
                  <c:v>22.3</c:v>
                </c:pt>
                <c:pt idx="594">
                  <c:v>23.2</c:v>
                </c:pt>
                <c:pt idx="595">
                  <c:v>23.1</c:v>
                </c:pt>
                <c:pt idx="596">
                  <c:v>22.7</c:v>
                </c:pt>
                <c:pt idx="597">
                  <c:v>22.6</c:v>
                </c:pt>
                <c:pt idx="598">
                  <c:v>22.8</c:v>
                </c:pt>
                <c:pt idx="599">
                  <c:v>23</c:v>
                </c:pt>
                <c:pt idx="600">
                  <c:v>23.1</c:v>
                </c:pt>
                <c:pt idx="601">
                  <c:v>22.8</c:v>
                </c:pt>
                <c:pt idx="602">
                  <c:v>22.6</c:v>
                </c:pt>
                <c:pt idx="603">
                  <c:v>22.5</c:v>
                </c:pt>
                <c:pt idx="604">
                  <c:v>22.3</c:v>
                </c:pt>
                <c:pt idx="605">
                  <c:v>22.1</c:v>
                </c:pt>
                <c:pt idx="606">
                  <c:v>21.8</c:v>
                </c:pt>
                <c:pt idx="607">
                  <c:v>21.6</c:v>
                </c:pt>
                <c:pt idx="608">
                  <c:v>21.4</c:v>
                </c:pt>
                <c:pt idx="609">
                  <c:v>21.3</c:v>
                </c:pt>
                <c:pt idx="610">
                  <c:v>21.2</c:v>
                </c:pt>
                <c:pt idx="611">
                  <c:v>21.1</c:v>
                </c:pt>
                <c:pt idx="612">
                  <c:v>20.8</c:v>
                </c:pt>
                <c:pt idx="613">
                  <c:v>20.8</c:v>
                </c:pt>
                <c:pt idx="614">
                  <c:v>20.7</c:v>
                </c:pt>
                <c:pt idx="615">
                  <c:v>20.6</c:v>
                </c:pt>
                <c:pt idx="616">
                  <c:v>20.5</c:v>
                </c:pt>
                <c:pt idx="617">
                  <c:v>21.7</c:v>
                </c:pt>
                <c:pt idx="618">
                  <c:v>23.2</c:v>
                </c:pt>
                <c:pt idx="619">
                  <c:v>24</c:v>
                </c:pt>
                <c:pt idx="620">
                  <c:v>24.2</c:v>
                </c:pt>
                <c:pt idx="621">
                  <c:v>24.2</c:v>
                </c:pt>
                <c:pt idx="622">
                  <c:v>24.1</c:v>
                </c:pt>
                <c:pt idx="623">
                  <c:v>24</c:v>
                </c:pt>
                <c:pt idx="624">
                  <c:v>23.9</c:v>
                </c:pt>
                <c:pt idx="625">
                  <c:v>23.8</c:v>
                </c:pt>
                <c:pt idx="626">
                  <c:v>23.6</c:v>
                </c:pt>
                <c:pt idx="627">
                  <c:v>23.3</c:v>
                </c:pt>
                <c:pt idx="628">
                  <c:v>23</c:v>
                </c:pt>
                <c:pt idx="629">
                  <c:v>22.7</c:v>
                </c:pt>
                <c:pt idx="630">
                  <c:v>22.5</c:v>
                </c:pt>
                <c:pt idx="631">
                  <c:v>22.4</c:v>
                </c:pt>
                <c:pt idx="632">
                  <c:v>22.3</c:v>
                </c:pt>
                <c:pt idx="633">
                  <c:v>22.2</c:v>
                </c:pt>
                <c:pt idx="634">
                  <c:v>22.2</c:v>
                </c:pt>
                <c:pt idx="635">
                  <c:v>22.1</c:v>
                </c:pt>
                <c:pt idx="636">
                  <c:v>22.1</c:v>
                </c:pt>
                <c:pt idx="637">
                  <c:v>22.1</c:v>
                </c:pt>
                <c:pt idx="638">
                  <c:v>22</c:v>
                </c:pt>
                <c:pt idx="639">
                  <c:v>22</c:v>
                </c:pt>
                <c:pt idx="640">
                  <c:v>21.9</c:v>
                </c:pt>
                <c:pt idx="641">
                  <c:v>22</c:v>
                </c:pt>
                <c:pt idx="642">
                  <c:v>22.2</c:v>
                </c:pt>
                <c:pt idx="643">
                  <c:v>22.7</c:v>
                </c:pt>
                <c:pt idx="644">
                  <c:v>23.2</c:v>
                </c:pt>
                <c:pt idx="645">
                  <c:v>23.7</c:v>
                </c:pt>
                <c:pt idx="646">
                  <c:v>23.9</c:v>
                </c:pt>
                <c:pt idx="647">
                  <c:v>24.1</c:v>
                </c:pt>
                <c:pt idx="648">
                  <c:v>24.2</c:v>
                </c:pt>
                <c:pt idx="649">
                  <c:v>24.2</c:v>
                </c:pt>
                <c:pt idx="650">
                  <c:v>24.1</c:v>
                </c:pt>
                <c:pt idx="651">
                  <c:v>23.9</c:v>
                </c:pt>
                <c:pt idx="652">
                  <c:v>23.7</c:v>
                </c:pt>
                <c:pt idx="653">
                  <c:v>23.4</c:v>
                </c:pt>
                <c:pt idx="654">
                  <c:v>23.2</c:v>
                </c:pt>
                <c:pt idx="655">
                  <c:v>22.9</c:v>
                </c:pt>
                <c:pt idx="656">
                  <c:v>22.7</c:v>
                </c:pt>
                <c:pt idx="657">
                  <c:v>22.5</c:v>
                </c:pt>
                <c:pt idx="658">
                  <c:v>22.3</c:v>
                </c:pt>
                <c:pt idx="659">
                  <c:v>22.2</c:v>
                </c:pt>
                <c:pt idx="660">
                  <c:v>22.1</c:v>
                </c:pt>
                <c:pt idx="661">
                  <c:v>22</c:v>
                </c:pt>
                <c:pt idx="662">
                  <c:v>21.9</c:v>
                </c:pt>
                <c:pt idx="663">
                  <c:v>21.8</c:v>
                </c:pt>
                <c:pt idx="664">
                  <c:v>21.8</c:v>
                </c:pt>
                <c:pt idx="665">
                  <c:v>23.6</c:v>
                </c:pt>
                <c:pt idx="666">
                  <c:v>25.2</c:v>
                </c:pt>
                <c:pt idx="667">
                  <c:v>26.4</c:v>
                </c:pt>
                <c:pt idx="668">
                  <c:v>26.2</c:v>
                </c:pt>
                <c:pt idx="669">
                  <c:v>26.2</c:v>
                </c:pt>
                <c:pt idx="670">
                  <c:v>26</c:v>
                </c:pt>
                <c:pt idx="671">
                  <c:v>25.6</c:v>
                </c:pt>
                <c:pt idx="672">
                  <c:v>25.3</c:v>
                </c:pt>
                <c:pt idx="673">
                  <c:v>25.1</c:v>
                </c:pt>
                <c:pt idx="674">
                  <c:v>24.9</c:v>
                </c:pt>
                <c:pt idx="675">
                  <c:v>24.7</c:v>
                </c:pt>
                <c:pt idx="676">
                  <c:v>24.5</c:v>
                </c:pt>
                <c:pt idx="677">
                  <c:v>24.3</c:v>
                </c:pt>
                <c:pt idx="678">
                  <c:v>23.9</c:v>
                </c:pt>
                <c:pt idx="679">
                  <c:v>23.6</c:v>
                </c:pt>
                <c:pt idx="680">
                  <c:v>23.4</c:v>
                </c:pt>
                <c:pt idx="681">
                  <c:v>23.2</c:v>
                </c:pt>
                <c:pt idx="682">
                  <c:v>22.9</c:v>
                </c:pt>
                <c:pt idx="683">
                  <c:v>22.7</c:v>
                </c:pt>
                <c:pt idx="684">
                  <c:v>22.6</c:v>
                </c:pt>
                <c:pt idx="685">
                  <c:v>22.4</c:v>
                </c:pt>
                <c:pt idx="686">
                  <c:v>22.3</c:v>
                </c:pt>
                <c:pt idx="687">
                  <c:v>22.2</c:v>
                </c:pt>
                <c:pt idx="688">
                  <c:v>22.4</c:v>
                </c:pt>
                <c:pt idx="689">
                  <c:v>23.9</c:v>
                </c:pt>
                <c:pt idx="690">
                  <c:v>25.2</c:v>
                </c:pt>
                <c:pt idx="691">
                  <c:v>26</c:v>
                </c:pt>
                <c:pt idx="692">
                  <c:v>26.4</c:v>
                </c:pt>
                <c:pt idx="693">
                  <c:v>26.4</c:v>
                </c:pt>
                <c:pt idx="694">
                  <c:v>26</c:v>
                </c:pt>
                <c:pt idx="695">
                  <c:v>25.6</c:v>
                </c:pt>
                <c:pt idx="696">
                  <c:v>25.1</c:v>
                </c:pt>
                <c:pt idx="697">
                  <c:v>24.8</c:v>
                </c:pt>
                <c:pt idx="698">
                  <c:v>24.6</c:v>
                </c:pt>
                <c:pt idx="699">
                  <c:v>24.2</c:v>
                </c:pt>
                <c:pt idx="700">
                  <c:v>23.9</c:v>
                </c:pt>
                <c:pt idx="701">
                  <c:v>23.7</c:v>
                </c:pt>
                <c:pt idx="702">
                  <c:v>23.6</c:v>
                </c:pt>
                <c:pt idx="703">
                  <c:v>23.6</c:v>
                </c:pt>
                <c:pt idx="704">
                  <c:v>23.4</c:v>
                </c:pt>
                <c:pt idx="705">
                  <c:v>23.2</c:v>
                </c:pt>
                <c:pt idx="706">
                  <c:v>22.9</c:v>
                </c:pt>
                <c:pt idx="707">
                  <c:v>22.8</c:v>
                </c:pt>
                <c:pt idx="708">
                  <c:v>22.7</c:v>
                </c:pt>
                <c:pt idx="709">
                  <c:v>22.5</c:v>
                </c:pt>
                <c:pt idx="710">
                  <c:v>22.4</c:v>
                </c:pt>
                <c:pt idx="711">
                  <c:v>22.3</c:v>
                </c:pt>
                <c:pt idx="712">
                  <c:v>22.3</c:v>
                </c:pt>
                <c:pt idx="713">
                  <c:v>22.6</c:v>
                </c:pt>
                <c:pt idx="714">
                  <c:v>23.4</c:v>
                </c:pt>
                <c:pt idx="715">
                  <c:v>24.2</c:v>
                </c:pt>
                <c:pt idx="716">
                  <c:v>24.6</c:v>
                </c:pt>
                <c:pt idx="717">
                  <c:v>24.7</c:v>
                </c:pt>
                <c:pt idx="718">
                  <c:v>24.7</c:v>
                </c:pt>
                <c:pt idx="719">
                  <c:v>24.6</c:v>
                </c:pt>
                <c:pt idx="720">
                  <c:v>24.4</c:v>
                </c:pt>
                <c:pt idx="721">
                  <c:v>24.3</c:v>
                </c:pt>
                <c:pt idx="722">
                  <c:v>24.2</c:v>
                </c:pt>
                <c:pt idx="723">
                  <c:v>24</c:v>
                </c:pt>
                <c:pt idx="724">
                  <c:v>23.7</c:v>
                </c:pt>
                <c:pt idx="725">
                  <c:v>23.2</c:v>
                </c:pt>
                <c:pt idx="726">
                  <c:v>22.8</c:v>
                </c:pt>
                <c:pt idx="727">
                  <c:v>22.6</c:v>
                </c:pt>
                <c:pt idx="728">
                  <c:v>22.3</c:v>
                </c:pt>
                <c:pt idx="729">
                  <c:v>22.1</c:v>
                </c:pt>
                <c:pt idx="730">
                  <c:v>22</c:v>
                </c:pt>
                <c:pt idx="731">
                  <c:v>21.8</c:v>
                </c:pt>
                <c:pt idx="732">
                  <c:v>21.8</c:v>
                </c:pt>
                <c:pt idx="733">
                  <c:v>21.7</c:v>
                </c:pt>
                <c:pt idx="734">
                  <c:v>21.6</c:v>
                </c:pt>
                <c:pt idx="735">
                  <c:v>21.5</c:v>
                </c:pt>
                <c:pt idx="736">
                  <c:v>21.9</c:v>
                </c:pt>
                <c:pt idx="737">
                  <c:v>23.9</c:v>
                </c:pt>
                <c:pt idx="738">
                  <c:v>25.2</c:v>
                </c:pt>
                <c:pt idx="739">
                  <c:v>25.8</c:v>
                </c:pt>
                <c:pt idx="740">
                  <c:v>25.7</c:v>
                </c:pt>
                <c:pt idx="741">
                  <c:v>25.4</c:v>
                </c:pt>
                <c:pt idx="742">
                  <c:v>24.8</c:v>
                </c:pt>
                <c:pt idx="743">
                  <c:v>24.4</c:v>
                </c:pt>
                <c:pt idx="744">
                  <c:v>24.2</c:v>
                </c:pt>
                <c:pt idx="745">
                  <c:v>24.1</c:v>
                </c:pt>
                <c:pt idx="746">
                  <c:v>24</c:v>
                </c:pt>
                <c:pt idx="747">
                  <c:v>23.7</c:v>
                </c:pt>
                <c:pt idx="748">
                  <c:v>23.2</c:v>
                </c:pt>
                <c:pt idx="749">
                  <c:v>22.8</c:v>
                </c:pt>
                <c:pt idx="750">
                  <c:v>22.6</c:v>
                </c:pt>
                <c:pt idx="751">
                  <c:v>22.4</c:v>
                </c:pt>
                <c:pt idx="752">
                  <c:v>22.3</c:v>
                </c:pt>
                <c:pt idx="753">
                  <c:v>22.2</c:v>
                </c:pt>
                <c:pt idx="754">
                  <c:v>22.2</c:v>
                </c:pt>
                <c:pt idx="755">
                  <c:v>22.1</c:v>
                </c:pt>
                <c:pt idx="756">
                  <c:v>22</c:v>
                </c:pt>
                <c:pt idx="757">
                  <c:v>21.9</c:v>
                </c:pt>
                <c:pt idx="758">
                  <c:v>21.7</c:v>
                </c:pt>
                <c:pt idx="759">
                  <c:v>21.6</c:v>
                </c:pt>
                <c:pt idx="760">
                  <c:v>22.1</c:v>
                </c:pt>
                <c:pt idx="761">
                  <c:v>23.9</c:v>
                </c:pt>
                <c:pt idx="762">
                  <c:v>25.3</c:v>
                </c:pt>
                <c:pt idx="763">
                  <c:v>25.8</c:v>
                </c:pt>
                <c:pt idx="764">
                  <c:v>25.4</c:v>
                </c:pt>
                <c:pt idx="765">
                  <c:v>24.9</c:v>
                </c:pt>
                <c:pt idx="766">
                  <c:v>24.5</c:v>
                </c:pt>
                <c:pt idx="767">
                  <c:v>24.3</c:v>
                </c:pt>
                <c:pt idx="768">
                  <c:v>24.1</c:v>
                </c:pt>
                <c:pt idx="769">
                  <c:v>23.9</c:v>
                </c:pt>
                <c:pt idx="770">
                  <c:v>23.7</c:v>
                </c:pt>
                <c:pt idx="771">
                  <c:v>23.6</c:v>
                </c:pt>
                <c:pt idx="772">
                  <c:v>23.2</c:v>
                </c:pt>
                <c:pt idx="773">
                  <c:v>22.7</c:v>
                </c:pt>
                <c:pt idx="774">
                  <c:v>22.3</c:v>
                </c:pt>
                <c:pt idx="775">
                  <c:v>22.1</c:v>
                </c:pt>
                <c:pt idx="776">
                  <c:v>21.9</c:v>
                </c:pt>
                <c:pt idx="777">
                  <c:v>21.8</c:v>
                </c:pt>
                <c:pt idx="778">
                  <c:v>21.7</c:v>
                </c:pt>
                <c:pt idx="779">
                  <c:v>21.6</c:v>
                </c:pt>
                <c:pt idx="780">
                  <c:v>21.4</c:v>
                </c:pt>
                <c:pt idx="781">
                  <c:v>21.3</c:v>
                </c:pt>
                <c:pt idx="782">
                  <c:v>21.2</c:v>
                </c:pt>
                <c:pt idx="783">
                  <c:v>21.1</c:v>
                </c:pt>
                <c:pt idx="784">
                  <c:v>21.7</c:v>
                </c:pt>
                <c:pt idx="785">
                  <c:v>23.8</c:v>
                </c:pt>
                <c:pt idx="786">
                  <c:v>25.2</c:v>
                </c:pt>
                <c:pt idx="787">
                  <c:v>25.7</c:v>
                </c:pt>
                <c:pt idx="788">
                  <c:v>25.7</c:v>
                </c:pt>
                <c:pt idx="789">
                  <c:v>25.4</c:v>
                </c:pt>
                <c:pt idx="790">
                  <c:v>24.9</c:v>
                </c:pt>
                <c:pt idx="791">
                  <c:v>24.6</c:v>
                </c:pt>
                <c:pt idx="792">
                  <c:v>24.3</c:v>
                </c:pt>
                <c:pt idx="793">
                  <c:v>24.2</c:v>
                </c:pt>
                <c:pt idx="794">
                  <c:v>24</c:v>
                </c:pt>
                <c:pt idx="795">
                  <c:v>23.8</c:v>
                </c:pt>
                <c:pt idx="796">
                  <c:v>23.4</c:v>
                </c:pt>
                <c:pt idx="797">
                  <c:v>22.9</c:v>
                </c:pt>
                <c:pt idx="798">
                  <c:v>22.6</c:v>
                </c:pt>
                <c:pt idx="799">
                  <c:v>22.4</c:v>
                </c:pt>
                <c:pt idx="800">
                  <c:v>22.2</c:v>
                </c:pt>
                <c:pt idx="801">
                  <c:v>22.1</c:v>
                </c:pt>
                <c:pt idx="802">
                  <c:v>21.9</c:v>
                </c:pt>
                <c:pt idx="803">
                  <c:v>21.8</c:v>
                </c:pt>
                <c:pt idx="804">
                  <c:v>21.7</c:v>
                </c:pt>
                <c:pt idx="805">
                  <c:v>21.6</c:v>
                </c:pt>
                <c:pt idx="806">
                  <c:v>21.4</c:v>
                </c:pt>
                <c:pt idx="807">
                  <c:v>21.3</c:v>
                </c:pt>
                <c:pt idx="808">
                  <c:v>21.2</c:v>
                </c:pt>
                <c:pt idx="809">
                  <c:v>21.2</c:v>
                </c:pt>
                <c:pt idx="810">
                  <c:v>21.3</c:v>
                </c:pt>
                <c:pt idx="811">
                  <c:v>21.5</c:v>
                </c:pt>
                <c:pt idx="812">
                  <c:v>21.7</c:v>
                </c:pt>
                <c:pt idx="813">
                  <c:v>21.7</c:v>
                </c:pt>
                <c:pt idx="814">
                  <c:v>21.8</c:v>
                </c:pt>
                <c:pt idx="815">
                  <c:v>21.9</c:v>
                </c:pt>
                <c:pt idx="816">
                  <c:v>22.1</c:v>
                </c:pt>
                <c:pt idx="817">
                  <c:v>22.3</c:v>
                </c:pt>
                <c:pt idx="818">
                  <c:v>22.2</c:v>
                </c:pt>
                <c:pt idx="819">
                  <c:v>22.1</c:v>
                </c:pt>
                <c:pt idx="820">
                  <c:v>21.8</c:v>
                </c:pt>
                <c:pt idx="821">
                  <c:v>21.6</c:v>
                </c:pt>
                <c:pt idx="822">
                  <c:v>21.3</c:v>
                </c:pt>
                <c:pt idx="823">
                  <c:v>21</c:v>
                </c:pt>
                <c:pt idx="824">
                  <c:v>20.8</c:v>
                </c:pt>
                <c:pt idx="825">
                  <c:v>20.7</c:v>
                </c:pt>
                <c:pt idx="826">
                  <c:v>20.6</c:v>
                </c:pt>
                <c:pt idx="827">
                  <c:v>20.399999999999999</c:v>
                </c:pt>
                <c:pt idx="828">
                  <c:v>20.399999999999999</c:v>
                </c:pt>
                <c:pt idx="829">
                  <c:v>20.3</c:v>
                </c:pt>
                <c:pt idx="830">
                  <c:v>20.2</c:v>
                </c:pt>
                <c:pt idx="831">
                  <c:v>20.2</c:v>
                </c:pt>
                <c:pt idx="832">
                  <c:v>20.6</c:v>
                </c:pt>
                <c:pt idx="833">
                  <c:v>22.9</c:v>
                </c:pt>
                <c:pt idx="834">
                  <c:v>24.3</c:v>
                </c:pt>
                <c:pt idx="835">
                  <c:v>24.9</c:v>
                </c:pt>
                <c:pt idx="836">
                  <c:v>24.8</c:v>
                </c:pt>
                <c:pt idx="837">
                  <c:v>24.7</c:v>
                </c:pt>
                <c:pt idx="838">
                  <c:v>24.6</c:v>
                </c:pt>
                <c:pt idx="839">
                  <c:v>24.1</c:v>
                </c:pt>
                <c:pt idx="840">
                  <c:v>23.6</c:v>
                </c:pt>
                <c:pt idx="841">
                  <c:v>23.4</c:v>
                </c:pt>
                <c:pt idx="842">
                  <c:v>23.1</c:v>
                </c:pt>
                <c:pt idx="843">
                  <c:v>22.9</c:v>
                </c:pt>
                <c:pt idx="844">
                  <c:v>22.5</c:v>
                </c:pt>
                <c:pt idx="845">
                  <c:v>22.1</c:v>
                </c:pt>
                <c:pt idx="846">
                  <c:v>21.8</c:v>
                </c:pt>
                <c:pt idx="847">
                  <c:v>21.6</c:v>
                </c:pt>
                <c:pt idx="848">
                  <c:v>21.4</c:v>
                </c:pt>
                <c:pt idx="849">
                  <c:v>21.2</c:v>
                </c:pt>
                <c:pt idx="850">
                  <c:v>21.2</c:v>
                </c:pt>
                <c:pt idx="851">
                  <c:v>21.1</c:v>
                </c:pt>
                <c:pt idx="852">
                  <c:v>21.1</c:v>
                </c:pt>
                <c:pt idx="853">
                  <c:v>21</c:v>
                </c:pt>
                <c:pt idx="854">
                  <c:v>20.9</c:v>
                </c:pt>
                <c:pt idx="855">
                  <c:v>20.9</c:v>
                </c:pt>
                <c:pt idx="856">
                  <c:v>20.9</c:v>
                </c:pt>
                <c:pt idx="857">
                  <c:v>21.1</c:v>
                </c:pt>
                <c:pt idx="858">
                  <c:v>21.3</c:v>
                </c:pt>
                <c:pt idx="859">
                  <c:v>21.7</c:v>
                </c:pt>
                <c:pt idx="860">
                  <c:v>22.4</c:v>
                </c:pt>
                <c:pt idx="861">
                  <c:v>22.9</c:v>
                </c:pt>
                <c:pt idx="862">
                  <c:v>23.1</c:v>
                </c:pt>
                <c:pt idx="863">
                  <c:v>23.1</c:v>
                </c:pt>
                <c:pt idx="864">
                  <c:v>23</c:v>
                </c:pt>
                <c:pt idx="865">
                  <c:v>22.8</c:v>
                </c:pt>
                <c:pt idx="866">
                  <c:v>22.5</c:v>
                </c:pt>
                <c:pt idx="867">
                  <c:v>22.3</c:v>
                </c:pt>
                <c:pt idx="868">
                  <c:v>22.1</c:v>
                </c:pt>
                <c:pt idx="869">
                  <c:v>21.9</c:v>
                </c:pt>
                <c:pt idx="870">
                  <c:v>21.7</c:v>
                </c:pt>
                <c:pt idx="871">
                  <c:v>21.6</c:v>
                </c:pt>
                <c:pt idx="872">
                  <c:v>21.4</c:v>
                </c:pt>
                <c:pt idx="873">
                  <c:v>21.4</c:v>
                </c:pt>
                <c:pt idx="874">
                  <c:v>21.3</c:v>
                </c:pt>
                <c:pt idx="875">
                  <c:v>21.2</c:v>
                </c:pt>
                <c:pt idx="876">
                  <c:v>21.1</c:v>
                </c:pt>
                <c:pt idx="877">
                  <c:v>21</c:v>
                </c:pt>
                <c:pt idx="878">
                  <c:v>21</c:v>
                </c:pt>
                <c:pt idx="879">
                  <c:v>21</c:v>
                </c:pt>
                <c:pt idx="880">
                  <c:v>21</c:v>
                </c:pt>
                <c:pt idx="881">
                  <c:v>21.1</c:v>
                </c:pt>
                <c:pt idx="882">
                  <c:v>21.9</c:v>
                </c:pt>
                <c:pt idx="883">
                  <c:v>22.7</c:v>
                </c:pt>
                <c:pt idx="884">
                  <c:v>23.7</c:v>
                </c:pt>
                <c:pt idx="885">
                  <c:v>23.9</c:v>
                </c:pt>
                <c:pt idx="886">
                  <c:v>23.8</c:v>
                </c:pt>
                <c:pt idx="887">
                  <c:v>23.7</c:v>
                </c:pt>
                <c:pt idx="888">
                  <c:v>23.5</c:v>
                </c:pt>
                <c:pt idx="889">
                  <c:v>23.2</c:v>
                </c:pt>
                <c:pt idx="890">
                  <c:v>22.9</c:v>
                </c:pt>
                <c:pt idx="891">
                  <c:v>22.6</c:v>
                </c:pt>
                <c:pt idx="892">
                  <c:v>22.2</c:v>
                </c:pt>
                <c:pt idx="893">
                  <c:v>22</c:v>
                </c:pt>
                <c:pt idx="894">
                  <c:v>21.8</c:v>
                </c:pt>
                <c:pt idx="895">
                  <c:v>21.7</c:v>
                </c:pt>
                <c:pt idx="896">
                  <c:v>21.6</c:v>
                </c:pt>
                <c:pt idx="897">
                  <c:v>21.4</c:v>
                </c:pt>
                <c:pt idx="898">
                  <c:v>21.3</c:v>
                </c:pt>
                <c:pt idx="899">
                  <c:v>21.1</c:v>
                </c:pt>
                <c:pt idx="900">
                  <c:v>20.9</c:v>
                </c:pt>
                <c:pt idx="901">
                  <c:v>20.7</c:v>
                </c:pt>
                <c:pt idx="902">
                  <c:v>20.6</c:v>
                </c:pt>
                <c:pt idx="903">
                  <c:v>20.399999999999999</c:v>
                </c:pt>
                <c:pt idx="904">
                  <c:v>21.2</c:v>
                </c:pt>
                <c:pt idx="905">
                  <c:v>23</c:v>
                </c:pt>
                <c:pt idx="906">
                  <c:v>23.6</c:v>
                </c:pt>
                <c:pt idx="907">
                  <c:v>24.3</c:v>
                </c:pt>
                <c:pt idx="908">
                  <c:v>24.4</c:v>
                </c:pt>
                <c:pt idx="909">
                  <c:v>24.3</c:v>
                </c:pt>
                <c:pt idx="910">
                  <c:v>24.1</c:v>
                </c:pt>
                <c:pt idx="911">
                  <c:v>23.9</c:v>
                </c:pt>
                <c:pt idx="912">
                  <c:v>23.7</c:v>
                </c:pt>
                <c:pt idx="913">
                  <c:v>23.6</c:v>
                </c:pt>
                <c:pt idx="914">
                  <c:v>23.5</c:v>
                </c:pt>
                <c:pt idx="915">
                  <c:v>23.3</c:v>
                </c:pt>
                <c:pt idx="916">
                  <c:v>23.1</c:v>
                </c:pt>
                <c:pt idx="917">
                  <c:v>22.8</c:v>
                </c:pt>
                <c:pt idx="918">
                  <c:v>22.6</c:v>
                </c:pt>
                <c:pt idx="919">
                  <c:v>22.3</c:v>
                </c:pt>
                <c:pt idx="920">
                  <c:v>22.2</c:v>
                </c:pt>
                <c:pt idx="921">
                  <c:v>22.1</c:v>
                </c:pt>
                <c:pt idx="922">
                  <c:v>21.9</c:v>
                </c:pt>
                <c:pt idx="923">
                  <c:v>21.8</c:v>
                </c:pt>
                <c:pt idx="924">
                  <c:v>21.7</c:v>
                </c:pt>
                <c:pt idx="925">
                  <c:v>21.7</c:v>
                </c:pt>
                <c:pt idx="926">
                  <c:v>21.6</c:v>
                </c:pt>
                <c:pt idx="927">
                  <c:v>21.7</c:v>
                </c:pt>
                <c:pt idx="928">
                  <c:v>21.7</c:v>
                </c:pt>
                <c:pt idx="929">
                  <c:v>21.8</c:v>
                </c:pt>
                <c:pt idx="930">
                  <c:v>21.8</c:v>
                </c:pt>
                <c:pt idx="931">
                  <c:v>21.8</c:v>
                </c:pt>
                <c:pt idx="932">
                  <c:v>21.9</c:v>
                </c:pt>
                <c:pt idx="933">
                  <c:v>22.5</c:v>
                </c:pt>
                <c:pt idx="934">
                  <c:v>22.8</c:v>
                </c:pt>
                <c:pt idx="935">
                  <c:v>22.9</c:v>
                </c:pt>
                <c:pt idx="936">
                  <c:v>22.8</c:v>
                </c:pt>
                <c:pt idx="937">
                  <c:v>22.7</c:v>
                </c:pt>
                <c:pt idx="938">
                  <c:v>22.5</c:v>
                </c:pt>
                <c:pt idx="939">
                  <c:v>22.4</c:v>
                </c:pt>
                <c:pt idx="940">
                  <c:v>22.2</c:v>
                </c:pt>
                <c:pt idx="941">
                  <c:v>22</c:v>
                </c:pt>
                <c:pt idx="942">
                  <c:v>21.8</c:v>
                </c:pt>
                <c:pt idx="943">
                  <c:v>21.7</c:v>
                </c:pt>
                <c:pt idx="944">
                  <c:v>21.6</c:v>
                </c:pt>
                <c:pt idx="945">
                  <c:v>21.6</c:v>
                </c:pt>
                <c:pt idx="946">
                  <c:v>21.5</c:v>
                </c:pt>
                <c:pt idx="947">
                  <c:v>21.4</c:v>
                </c:pt>
                <c:pt idx="948">
                  <c:v>21.4</c:v>
                </c:pt>
                <c:pt idx="949">
                  <c:v>21.4</c:v>
                </c:pt>
                <c:pt idx="950">
                  <c:v>21.3</c:v>
                </c:pt>
                <c:pt idx="951">
                  <c:v>21.3</c:v>
                </c:pt>
                <c:pt idx="952">
                  <c:v>21.3</c:v>
                </c:pt>
                <c:pt idx="953">
                  <c:v>21.2</c:v>
                </c:pt>
                <c:pt idx="954">
                  <c:v>22.1</c:v>
                </c:pt>
                <c:pt idx="955">
                  <c:v>22.8</c:v>
                </c:pt>
                <c:pt idx="956">
                  <c:v>23.1</c:v>
                </c:pt>
                <c:pt idx="957">
                  <c:v>23.2</c:v>
                </c:pt>
                <c:pt idx="958">
                  <c:v>23.3</c:v>
                </c:pt>
                <c:pt idx="959">
                  <c:v>23.4</c:v>
                </c:pt>
                <c:pt idx="960">
                  <c:v>23.5</c:v>
                </c:pt>
                <c:pt idx="961">
                  <c:v>23.6</c:v>
                </c:pt>
                <c:pt idx="962">
                  <c:v>23.6</c:v>
                </c:pt>
                <c:pt idx="963">
                  <c:v>23.6</c:v>
                </c:pt>
                <c:pt idx="964">
                  <c:v>23.6</c:v>
                </c:pt>
                <c:pt idx="965">
                  <c:v>23.5</c:v>
                </c:pt>
                <c:pt idx="966">
                  <c:v>23.3</c:v>
                </c:pt>
                <c:pt idx="967">
                  <c:v>22.8</c:v>
                </c:pt>
                <c:pt idx="968">
                  <c:v>22.2</c:v>
                </c:pt>
                <c:pt idx="969">
                  <c:v>21.9</c:v>
                </c:pt>
                <c:pt idx="970">
                  <c:v>21.7</c:v>
                </c:pt>
                <c:pt idx="971">
                  <c:v>21.5</c:v>
                </c:pt>
                <c:pt idx="972">
                  <c:v>21.4</c:v>
                </c:pt>
                <c:pt idx="973">
                  <c:v>21.3</c:v>
                </c:pt>
                <c:pt idx="974">
                  <c:v>21.3</c:v>
                </c:pt>
                <c:pt idx="975">
                  <c:v>21.3</c:v>
                </c:pt>
                <c:pt idx="976">
                  <c:v>21.3</c:v>
                </c:pt>
                <c:pt idx="977">
                  <c:v>21.3</c:v>
                </c:pt>
                <c:pt idx="978">
                  <c:v>21.4</c:v>
                </c:pt>
                <c:pt idx="979">
                  <c:v>21.7</c:v>
                </c:pt>
                <c:pt idx="980">
                  <c:v>22.3</c:v>
                </c:pt>
                <c:pt idx="981">
                  <c:v>22.8</c:v>
                </c:pt>
                <c:pt idx="982">
                  <c:v>22.9</c:v>
                </c:pt>
                <c:pt idx="983">
                  <c:v>22.9</c:v>
                </c:pt>
                <c:pt idx="984">
                  <c:v>23.1</c:v>
                </c:pt>
                <c:pt idx="985">
                  <c:v>23.1</c:v>
                </c:pt>
                <c:pt idx="986">
                  <c:v>23</c:v>
                </c:pt>
                <c:pt idx="987">
                  <c:v>22.8</c:v>
                </c:pt>
                <c:pt idx="988">
                  <c:v>22.5</c:v>
                </c:pt>
                <c:pt idx="989">
                  <c:v>22.2</c:v>
                </c:pt>
                <c:pt idx="990">
                  <c:v>21.9</c:v>
                </c:pt>
                <c:pt idx="991">
                  <c:v>21.7</c:v>
                </c:pt>
                <c:pt idx="992">
                  <c:v>21.5</c:v>
                </c:pt>
                <c:pt idx="993">
                  <c:v>21.3</c:v>
                </c:pt>
                <c:pt idx="994">
                  <c:v>21.2</c:v>
                </c:pt>
                <c:pt idx="995">
                  <c:v>21.1</c:v>
                </c:pt>
                <c:pt idx="996">
                  <c:v>20.9</c:v>
                </c:pt>
                <c:pt idx="997">
                  <c:v>20.8</c:v>
                </c:pt>
                <c:pt idx="998">
                  <c:v>20.7</c:v>
                </c:pt>
                <c:pt idx="999">
                  <c:v>20.6</c:v>
                </c:pt>
                <c:pt idx="1000">
                  <c:v>21.1</c:v>
                </c:pt>
                <c:pt idx="1001">
                  <c:v>23.2</c:v>
                </c:pt>
                <c:pt idx="1002">
                  <c:v>24.7</c:v>
                </c:pt>
                <c:pt idx="1003">
                  <c:v>25.3</c:v>
                </c:pt>
                <c:pt idx="1004">
                  <c:v>25.3</c:v>
                </c:pt>
                <c:pt idx="1005">
                  <c:v>25.2</c:v>
                </c:pt>
                <c:pt idx="1006">
                  <c:v>24.8</c:v>
                </c:pt>
                <c:pt idx="1007">
                  <c:v>24.4</c:v>
                </c:pt>
                <c:pt idx="1008">
                  <c:v>24.2</c:v>
                </c:pt>
                <c:pt idx="1009">
                  <c:v>24</c:v>
                </c:pt>
                <c:pt idx="1010">
                  <c:v>23.8</c:v>
                </c:pt>
                <c:pt idx="1011">
                  <c:v>23.6</c:v>
                </c:pt>
                <c:pt idx="1012">
                  <c:v>23.3</c:v>
                </c:pt>
                <c:pt idx="1013">
                  <c:v>22.9</c:v>
                </c:pt>
                <c:pt idx="1014">
                  <c:v>22.5</c:v>
                </c:pt>
                <c:pt idx="1015">
                  <c:v>22.2</c:v>
                </c:pt>
                <c:pt idx="1016">
                  <c:v>22.1</c:v>
                </c:pt>
                <c:pt idx="1017">
                  <c:v>21.9</c:v>
                </c:pt>
                <c:pt idx="1018">
                  <c:v>21.8</c:v>
                </c:pt>
                <c:pt idx="1019">
                  <c:v>21.6</c:v>
                </c:pt>
                <c:pt idx="1020">
                  <c:v>21.4</c:v>
                </c:pt>
                <c:pt idx="1021">
                  <c:v>21.3</c:v>
                </c:pt>
                <c:pt idx="1022">
                  <c:v>21.2</c:v>
                </c:pt>
                <c:pt idx="1023">
                  <c:v>21.2</c:v>
                </c:pt>
                <c:pt idx="1024">
                  <c:v>21.8</c:v>
                </c:pt>
                <c:pt idx="1025">
                  <c:v>23</c:v>
                </c:pt>
                <c:pt idx="1026">
                  <c:v>24.4</c:v>
                </c:pt>
                <c:pt idx="1027">
                  <c:v>24.8</c:v>
                </c:pt>
                <c:pt idx="1028">
                  <c:v>24.7</c:v>
                </c:pt>
                <c:pt idx="1029">
                  <c:v>24.4</c:v>
                </c:pt>
                <c:pt idx="1030">
                  <c:v>24.1</c:v>
                </c:pt>
                <c:pt idx="1031">
                  <c:v>23.9</c:v>
                </c:pt>
                <c:pt idx="1032">
                  <c:v>23.7</c:v>
                </c:pt>
                <c:pt idx="1033">
                  <c:v>23.6</c:v>
                </c:pt>
                <c:pt idx="1034">
                  <c:v>23.4</c:v>
                </c:pt>
                <c:pt idx="1035">
                  <c:v>23.3</c:v>
                </c:pt>
                <c:pt idx="1036">
                  <c:v>23.1</c:v>
                </c:pt>
                <c:pt idx="1037">
                  <c:v>22.6</c:v>
                </c:pt>
                <c:pt idx="1038">
                  <c:v>22.2</c:v>
                </c:pt>
                <c:pt idx="1039">
                  <c:v>22</c:v>
                </c:pt>
                <c:pt idx="1040">
                  <c:v>21.8</c:v>
                </c:pt>
                <c:pt idx="1041">
                  <c:v>21.7</c:v>
                </c:pt>
                <c:pt idx="1042">
                  <c:v>21.6</c:v>
                </c:pt>
                <c:pt idx="1043">
                  <c:v>21.4</c:v>
                </c:pt>
                <c:pt idx="1044">
                  <c:v>21.4</c:v>
                </c:pt>
                <c:pt idx="1045">
                  <c:v>21.3</c:v>
                </c:pt>
                <c:pt idx="1046">
                  <c:v>21.3</c:v>
                </c:pt>
                <c:pt idx="1047">
                  <c:v>21.3</c:v>
                </c:pt>
                <c:pt idx="1048">
                  <c:v>21.4</c:v>
                </c:pt>
                <c:pt idx="1049">
                  <c:v>21.6</c:v>
                </c:pt>
                <c:pt idx="1050">
                  <c:v>22</c:v>
                </c:pt>
                <c:pt idx="1051">
                  <c:v>22.9</c:v>
                </c:pt>
                <c:pt idx="1052">
                  <c:v>23.3</c:v>
                </c:pt>
                <c:pt idx="1053">
                  <c:v>23.3</c:v>
                </c:pt>
                <c:pt idx="1054">
                  <c:v>23.3</c:v>
                </c:pt>
                <c:pt idx="1055">
                  <c:v>23.2</c:v>
                </c:pt>
                <c:pt idx="1056">
                  <c:v>23.1</c:v>
                </c:pt>
                <c:pt idx="1057">
                  <c:v>22.9</c:v>
                </c:pt>
                <c:pt idx="1058">
                  <c:v>22.6</c:v>
                </c:pt>
                <c:pt idx="1059">
                  <c:v>22.3</c:v>
                </c:pt>
                <c:pt idx="1060">
                  <c:v>22.2</c:v>
                </c:pt>
                <c:pt idx="1061">
                  <c:v>21.9</c:v>
                </c:pt>
                <c:pt idx="1062">
                  <c:v>21.8</c:v>
                </c:pt>
                <c:pt idx="1063">
                  <c:v>21.7</c:v>
                </c:pt>
                <c:pt idx="1064">
                  <c:v>21.6</c:v>
                </c:pt>
                <c:pt idx="1065">
                  <c:v>21.6</c:v>
                </c:pt>
                <c:pt idx="1066">
                  <c:v>21.6</c:v>
                </c:pt>
                <c:pt idx="1067">
                  <c:v>21.5</c:v>
                </c:pt>
                <c:pt idx="1068">
                  <c:v>21.5</c:v>
                </c:pt>
                <c:pt idx="1069">
                  <c:v>21.4</c:v>
                </c:pt>
                <c:pt idx="1070">
                  <c:v>21.4</c:v>
                </c:pt>
                <c:pt idx="1071">
                  <c:v>21.4</c:v>
                </c:pt>
                <c:pt idx="1072">
                  <c:v>21.4</c:v>
                </c:pt>
                <c:pt idx="1073">
                  <c:v>21.8</c:v>
                </c:pt>
                <c:pt idx="1074">
                  <c:v>22.9</c:v>
                </c:pt>
                <c:pt idx="1075">
                  <c:v>23.7</c:v>
                </c:pt>
                <c:pt idx="1076">
                  <c:v>23.9</c:v>
                </c:pt>
                <c:pt idx="1077">
                  <c:v>24.1</c:v>
                </c:pt>
                <c:pt idx="1078">
                  <c:v>24</c:v>
                </c:pt>
                <c:pt idx="1079">
                  <c:v>23.9</c:v>
                </c:pt>
                <c:pt idx="1080">
                  <c:v>23.9</c:v>
                </c:pt>
                <c:pt idx="1081">
                  <c:v>24</c:v>
                </c:pt>
                <c:pt idx="1082">
                  <c:v>23.9</c:v>
                </c:pt>
                <c:pt idx="1083">
                  <c:v>23.8</c:v>
                </c:pt>
                <c:pt idx="1084">
                  <c:v>23.4</c:v>
                </c:pt>
                <c:pt idx="1085">
                  <c:v>22.9</c:v>
                </c:pt>
                <c:pt idx="1086">
                  <c:v>22.4</c:v>
                </c:pt>
                <c:pt idx="1087">
                  <c:v>22.2</c:v>
                </c:pt>
                <c:pt idx="1088">
                  <c:v>21.9</c:v>
                </c:pt>
                <c:pt idx="1089">
                  <c:v>21.8</c:v>
                </c:pt>
                <c:pt idx="1090">
                  <c:v>21.7</c:v>
                </c:pt>
                <c:pt idx="1091">
                  <c:v>21.7</c:v>
                </c:pt>
                <c:pt idx="1092">
                  <c:v>21.7</c:v>
                </c:pt>
                <c:pt idx="1093">
                  <c:v>21.7</c:v>
                </c:pt>
                <c:pt idx="1094">
                  <c:v>21.6</c:v>
                </c:pt>
                <c:pt idx="1095">
                  <c:v>21.6</c:v>
                </c:pt>
                <c:pt idx="1096">
                  <c:v>21.7</c:v>
                </c:pt>
                <c:pt idx="1097">
                  <c:v>21.7</c:v>
                </c:pt>
                <c:pt idx="1098">
                  <c:v>21.8</c:v>
                </c:pt>
                <c:pt idx="1099">
                  <c:v>21.9</c:v>
                </c:pt>
                <c:pt idx="1100">
                  <c:v>22.4</c:v>
                </c:pt>
                <c:pt idx="1101">
                  <c:v>23</c:v>
                </c:pt>
                <c:pt idx="1102">
                  <c:v>23.3</c:v>
                </c:pt>
                <c:pt idx="1103">
                  <c:v>23.3</c:v>
                </c:pt>
                <c:pt idx="1104">
                  <c:v>23.3</c:v>
                </c:pt>
                <c:pt idx="1105">
                  <c:v>23.3</c:v>
                </c:pt>
                <c:pt idx="1106">
                  <c:v>23.3</c:v>
                </c:pt>
                <c:pt idx="1107">
                  <c:v>23.3</c:v>
                </c:pt>
                <c:pt idx="1108">
                  <c:v>23.2</c:v>
                </c:pt>
                <c:pt idx="1109">
                  <c:v>23</c:v>
                </c:pt>
                <c:pt idx="1110">
                  <c:v>22.8</c:v>
                </c:pt>
                <c:pt idx="1111">
                  <c:v>22.7</c:v>
                </c:pt>
                <c:pt idx="1112">
                  <c:v>22.4</c:v>
                </c:pt>
                <c:pt idx="1113">
                  <c:v>22.1</c:v>
                </c:pt>
                <c:pt idx="1114">
                  <c:v>21.8</c:v>
                </c:pt>
                <c:pt idx="1115">
                  <c:v>21.7</c:v>
                </c:pt>
                <c:pt idx="1116">
                  <c:v>21.6</c:v>
                </c:pt>
                <c:pt idx="1117">
                  <c:v>21.5</c:v>
                </c:pt>
                <c:pt idx="1118">
                  <c:v>21.5</c:v>
                </c:pt>
                <c:pt idx="1119">
                  <c:v>21.5</c:v>
                </c:pt>
                <c:pt idx="1120">
                  <c:v>21.5</c:v>
                </c:pt>
                <c:pt idx="1121">
                  <c:v>21.6</c:v>
                </c:pt>
                <c:pt idx="1122">
                  <c:v>21.6</c:v>
                </c:pt>
                <c:pt idx="1123">
                  <c:v>21.7</c:v>
                </c:pt>
                <c:pt idx="1124">
                  <c:v>21.7</c:v>
                </c:pt>
                <c:pt idx="1125">
                  <c:v>22.2</c:v>
                </c:pt>
                <c:pt idx="1126">
                  <c:v>22.9</c:v>
                </c:pt>
                <c:pt idx="1127">
                  <c:v>23.1</c:v>
                </c:pt>
                <c:pt idx="1128">
                  <c:v>23.1</c:v>
                </c:pt>
                <c:pt idx="1129">
                  <c:v>23.1</c:v>
                </c:pt>
                <c:pt idx="1130">
                  <c:v>23.1</c:v>
                </c:pt>
                <c:pt idx="1131">
                  <c:v>22.9</c:v>
                </c:pt>
                <c:pt idx="1132">
                  <c:v>22.6</c:v>
                </c:pt>
                <c:pt idx="1133">
                  <c:v>22.2</c:v>
                </c:pt>
                <c:pt idx="1134">
                  <c:v>22</c:v>
                </c:pt>
                <c:pt idx="1135">
                  <c:v>21.8</c:v>
                </c:pt>
                <c:pt idx="1136">
                  <c:v>21.7</c:v>
                </c:pt>
                <c:pt idx="1137">
                  <c:v>21.5</c:v>
                </c:pt>
                <c:pt idx="1138">
                  <c:v>21.4</c:v>
                </c:pt>
                <c:pt idx="1139">
                  <c:v>21.3</c:v>
                </c:pt>
                <c:pt idx="1140">
                  <c:v>21.3</c:v>
                </c:pt>
                <c:pt idx="1141">
                  <c:v>21.3</c:v>
                </c:pt>
                <c:pt idx="1142">
                  <c:v>21.2</c:v>
                </c:pt>
                <c:pt idx="1143">
                  <c:v>21.2</c:v>
                </c:pt>
                <c:pt idx="1144">
                  <c:v>21.3</c:v>
                </c:pt>
                <c:pt idx="1145">
                  <c:v>21.6</c:v>
                </c:pt>
                <c:pt idx="1146">
                  <c:v>21.9</c:v>
                </c:pt>
                <c:pt idx="1147">
                  <c:v>22.3</c:v>
                </c:pt>
                <c:pt idx="1148">
                  <c:v>22.6</c:v>
                </c:pt>
                <c:pt idx="1149">
                  <c:v>22.7</c:v>
                </c:pt>
                <c:pt idx="1150">
                  <c:v>22.6</c:v>
                </c:pt>
                <c:pt idx="1151">
                  <c:v>22.9</c:v>
                </c:pt>
                <c:pt idx="1152">
                  <c:v>23.1</c:v>
                </c:pt>
                <c:pt idx="1153">
                  <c:v>23.2</c:v>
                </c:pt>
                <c:pt idx="1154">
                  <c:v>23.2</c:v>
                </c:pt>
                <c:pt idx="1155">
                  <c:v>23.2</c:v>
                </c:pt>
                <c:pt idx="1156">
                  <c:v>23.2</c:v>
                </c:pt>
                <c:pt idx="1157">
                  <c:v>23</c:v>
                </c:pt>
                <c:pt idx="1158">
                  <c:v>22.7</c:v>
                </c:pt>
                <c:pt idx="1159">
                  <c:v>22.4</c:v>
                </c:pt>
                <c:pt idx="1160">
                  <c:v>22.2</c:v>
                </c:pt>
                <c:pt idx="1161">
                  <c:v>22.1</c:v>
                </c:pt>
                <c:pt idx="1162">
                  <c:v>21.8</c:v>
                </c:pt>
                <c:pt idx="1163">
                  <c:v>21.7</c:v>
                </c:pt>
                <c:pt idx="1164">
                  <c:v>21.5</c:v>
                </c:pt>
                <c:pt idx="1165">
                  <c:v>21.4</c:v>
                </c:pt>
                <c:pt idx="1166">
                  <c:v>21.3</c:v>
                </c:pt>
                <c:pt idx="1167">
                  <c:v>21.3</c:v>
                </c:pt>
                <c:pt idx="1168">
                  <c:v>22.4</c:v>
                </c:pt>
                <c:pt idx="1169">
                  <c:v>23.9</c:v>
                </c:pt>
                <c:pt idx="1170">
                  <c:v>25.1</c:v>
                </c:pt>
                <c:pt idx="1171">
                  <c:v>25.6</c:v>
                </c:pt>
                <c:pt idx="1172">
                  <c:v>25.7</c:v>
                </c:pt>
                <c:pt idx="1173">
                  <c:v>25.3</c:v>
                </c:pt>
                <c:pt idx="1174">
                  <c:v>25</c:v>
                </c:pt>
                <c:pt idx="1175">
                  <c:v>24.7</c:v>
                </c:pt>
                <c:pt idx="1176">
                  <c:v>24.6</c:v>
                </c:pt>
                <c:pt idx="1177">
                  <c:v>24.6</c:v>
                </c:pt>
                <c:pt idx="1178">
                  <c:v>24.3</c:v>
                </c:pt>
                <c:pt idx="1179">
                  <c:v>24.1</c:v>
                </c:pt>
                <c:pt idx="1180">
                  <c:v>23.8</c:v>
                </c:pt>
                <c:pt idx="1181">
                  <c:v>23.7</c:v>
                </c:pt>
                <c:pt idx="1182">
                  <c:v>23.4</c:v>
                </c:pt>
                <c:pt idx="1183">
                  <c:v>23.1</c:v>
                </c:pt>
                <c:pt idx="1184">
                  <c:v>22.8</c:v>
                </c:pt>
                <c:pt idx="1185">
                  <c:v>22.5</c:v>
                </c:pt>
                <c:pt idx="1186">
                  <c:v>22.3</c:v>
                </c:pt>
                <c:pt idx="1187">
                  <c:v>22.1</c:v>
                </c:pt>
                <c:pt idx="1188">
                  <c:v>21.9</c:v>
                </c:pt>
                <c:pt idx="1189">
                  <c:v>21.8</c:v>
                </c:pt>
                <c:pt idx="1190">
                  <c:v>21.7</c:v>
                </c:pt>
                <c:pt idx="1191">
                  <c:v>21.7</c:v>
                </c:pt>
                <c:pt idx="1192">
                  <c:v>23</c:v>
                </c:pt>
                <c:pt idx="1193">
                  <c:v>24.6</c:v>
                </c:pt>
                <c:pt idx="1194">
                  <c:v>25.2</c:v>
                </c:pt>
                <c:pt idx="1195">
                  <c:v>24.7</c:v>
                </c:pt>
                <c:pt idx="1196">
                  <c:v>24.7</c:v>
                </c:pt>
                <c:pt idx="1197">
                  <c:v>24.8</c:v>
                </c:pt>
                <c:pt idx="1198">
                  <c:v>24.8</c:v>
                </c:pt>
                <c:pt idx="1199">
                  <c:v>24.8</c:v>
                </c:pt>
                <c:pt idx="1200">
                  <c:v>24.8</c:v>
                </c:pt>
                <c:pt idx="1201">
                  <c:v>24.8</c:v>
                </c:pt>
                <c:pt idx="1202">
                  <c:v>24.7</c:v>
                </c:pt>
                <c:pt idx="1203">
                  <c:v>24.5</c:v>
                </c:pt>
                <c:pt idx="1204">
                  <c:v>24.3</c:v>
                </c:pt>
                <c:pt idx="1205">
                  <c:v>24</c:v>
                </c:pt>
                <c:pt idx="1206">
                  <c:v>23.6</c:v>
                </c:pt>
                <c:pt idx="1207">
                  <c:v>23.1</c:v>
                </c:pt>
                <c:pt idx="1208">
                  <c:v>22.7</c:v>
                </c:pt>
                <c:pt idx="1209">
                  <c:v>22.4</c:v>
                </c:pt>
                <c:pt idx="1210">
                  <c:v>22.2</c:v>
                </c:pt>
                <c:pt idx="1211">
                  <c:v>22</c:v>
                </c:pt>
                <c:pt idx="1212">
                  <c:v>21.9</c:v>
                </c:pt>
                <c:pt idx="1213">
                  <c:v>21.9</c:v>
                </c:pt>
                <c:pt idx="1214">
                  <c:v>21.8</c:v>
                </c:pt>
                <c:pt idx="1215">
                  <c:v>21.8</c:v>
                </c:pt>
                <c:pt idx="1216">
                  <c:v>21.8</c:v>
                </c:pt>
                <c:pt idx="1217">
                  <c:v>22</c:v>
                </c:pt>
                <c:pt idx="1218">
                  <c:v>22.3</c:v>
                </c:pt>
                <c:pt idx="1219">
                  <c:v>22.6</c:v>
                </c:pt>
                <c:pt idx="1220">
                  <c:v>23</c:v>
                </c:pt>
                <c:pt idx="1221">
                  <c:v>23.3</c:v>
                </c:pt>
                <c:pt idx="1222">
                  <c:v>23.3</c:v>
                </c:pt>
                <c:pt idx="1223">
                  <c:v>23.4</c:v>
                </c:pt>
                <c:pt idx="1224">
                  <c:v>23.6</c:v>
                </c:pt>
                <c:pt idx="1225">
                  <c:v>23.6</c:v>
                </c:pt>
                <c:pt idx="1226">
                  <c:v>23.4</c:v>
                </c:pt>
                <c:pt idx="1227">
                  <c:v>23.2</c:v>
                </c:pt>
                <c:pt idx="1228">
                  <c:v>22.9</c:v>
                </c:pt>
                <c:pt idx="1229">
                  <c:v>22.7</c:v>
                </c:pt>
                <c:pt idx="1230">
                  <c:v>22.4</c:v>
                </c:pt>
                <c:pt idx="1231">
                  <c:v>22.2</c:v>
                </c:pt>
                <c:pt idx="1232">
                  <c:v>22</c:v>
                </c:pt>
                <c:pt idx="1233">
                  <c:v>21.9</c:v>
                </c:pt>
                <c:pt idx="1234">
                  <c:v>21.8</c:v>
                </c:pt>
                <c:pt idx="1235">
                  <c:v>21.8</c:v>
                </c:pt>
                <c:pt idx="1236">
                  <c:v>21.7</c:v>
                </c:pt>
                <c:pt idx="1237">
                  <c:v>21.7</c:v>
                </c:pt>
                <c:pt idx="1238">
                  <c:v>21.7</c:v>
                </c:pt>
                <c:pt idx="1239">
                  <c:v>21.6</c:v>
                </c:pt>
                <c:pt idx="1240">
                  <c:v>21.6</c:v>
                </c:pt>
                <c:pt idx="1241">
                  <c:v>21.7</c:v>
                </c:pt>
                <c:pt idx="1242">
                  <c:v>21.8</c:v>
                </c:pt>
                <c:pt idx="1243">
                  <c:v>21.9</c:v>
                </c:pt>
                <c:pt idx="1244">
                  <c:v>22.3</c:v>
                </c:pt>
                <c:pt idx="1245">
                  <c:v>22.6</c:v>
                </c:pt>
                <c:pt idx="1246">
                  <c:v>22.7</c:v>
                </c:pt>
                <c:pt idx="1247">
                  <c:v>22.8</c:v>
                </c:pt>
                <c:pt idx="1248">
                  <c:v>23.1</c:v>
                </c:pt>
                <c:pt idx="1249">
                  <c:v>23.1</c:v>
                </c:pt>
                <c:pt idx="1250">
                  <c:v>23.1</c:v>
                </c:pt>
                <c:pt idx="1251">
                  <c:v>23</c:v>
                </c:pt>
                <c:pt idx="1252">
                  <c:v>22.9</c:v>
                </c:pt>
                <c:pt idx="1253">
                  <c:v>22.7</c:v>
                </c:pt>
                <c:pt idx="1254">
                  <c:v>22.3</c:v>
                </c:pt>
                <c:pt idx="1255">
                  <c:v>22.1</c:v>
                </c:pt>
                <c:pt idx="1256">
                  <c:v>21.9</c:v>
                </c:pt>
                <c:pt idx="1257">
                  <c:v>21.8</c:v>
                </c:pt>
                <c:pt idx="1258">
                  <c:v>21.7</c:v>
                </c:pt>
                <c:pt idx="1259">
                  <c:v>21.6</c:v>
                </c:pt>
                <c:pt idx="1260">
                  <c:v>21.5</c:v>
                </c:pt>
                <c:pt idx="1261">
                  <c:v>21.5</c:v>
                </c:pt>
                <c:pt idx="1262">
                  <c:v>21.5</c:v>
                </c:pt>
                <c:pt idx="1263">
                  <c:v>21.5</c:v>
                </c:pt>
                <c:pt idx="1264">
                  <c:v>21.8</c:v>
                </c:pt>
                <c:pt idx="1265">
                  <c:v>22.6</c:v>
                </c:pt>
                <c:pt idx="1266">
                  <c:v>23.1</c:v>
                </c:pt>
                <c:pt idx="1267">
                  <c:v>23.3</c:v>
                </c:pt>
                <c:pt idx="1268">
                  <c:v>23.4</c:v>
                </c:pt>
                <c:pt idx="1269">
                  <c:v>23.3</c:v>
                </c:pt>
                <c:pt idx="1270">
                  <c:v>23.1</c:v>
                </c:pt>
                <c:pt idx="1271">
                  <c:v>23</c:v>
                </c:pt>
                <c:pt idx="1272">
                  <c:v>22.9</c:v>
                </c:pt>
                <c:pt idx="1273">
                  <c:v>22.9</c:v>
                </c:pt>
                <c:pt idx="1274">
                  <c:v>22.8</c:v>
                </c:pt>
                <c:pt idx="1275">
                  <c:v>22.8</c:v>
                </c:pt>
                <c:pt idx="1276">
                  <c:v>22.7</c:v>
                </c:pt>
                <c:pt idx="1277">
                  <c:v>22.5</c:v>
                </c:pt>
                <c:pt idx="1278">
                  <c:v>22.3</c:v>
                </c:pt>
                <c:pt idx="1279">
                  <c:v>22.2</c:v>
                </c:pt>
                <c:pt idx="1280">
                  <c:v>22.1</c:v>
                </c:pt>
                <c:pt idx="1281">
                  <c:v>21.9</c:v>
                </c:pt>
                <c:pt idx="1282">
                  <c:v>21.7</c:v>
                </c:pt>
                <c:pt idx="1283">
                  <c:v>21.5</c:v>
                </c:pt>
                <c:pt idx="1284">
                  <c:v>21.4</c:v>
                </c:pt>
                <c:pt idx="1285">
                  <c:v>21.4</c:v>
                </c:pt>
                <c:pt idx="1286">
                  <c:v>21.4</c:v>
                </c:pt>
                <c:pt idx="1287">
                  <c:v>21.3</c:v>
                </c:pt>
                <c:pt idx="1288">
                  <c:v>21.3</c:v>
                </c:pt>
                <c:pt idx="1289">
                  <c:v>21.4</c:v>
                </c:pt>
                <c:pt idx="1290">
                  <c:v>21.7</c:v>
                </c:pt>
                <c:pt idx="1291">
                  <c:v>21.9</c:v>
                </c:pt>
                <c:pt idx="1292">
                  <c:v>22.2</c:v>
                </c:pt>
                <c:pt idx="1293">
                  <c:v>22.6</c:v>
                </c:pt>
                <c:pt idx="1294">
                  <c:v>22.5</c:v>
                </c:pt>
                <c:pt idx="1295">
                  <c:v>22.5</c:v>
                </c:pt>
                <c:pt idx="1296">
                  <c:v>22.4</c:v>
                </c:pt>
                <c:pt idx="1297">
                  <c:v>22.4</c:v>
                </c:pt>
                <c:pt idx="1298">
                  <c:v>22.3</c:v>
                </c:pt>
                <c:pt idx="1299">
                  <c:v>22.3</c:v>
                </c:pt>
                <c:pt idx="1300">
                  <c:v>22.2</c:v>
                </c:pt>
                <c:pt idx="1301">
                  <c:v>21.9</c:v>
                </c:pt>
                <c:pt idx="1302">
                  <c:v>21.8</c:v>
                </c:pt>
                <c:pt idx="1303">
                  <c:v>21.6</c:v>
                </c:pt>
                <c:pt idx="1304">
                  <c:v>21.4</c:v>
                </c:pt>
                <c:pt idx="1305">
                  <c:v>21.3</c:v>
                </c:pt>
                <c:pt idx="1306">
                  <c:v>21.3</c:v>
                </c:pt>
                <c:pt idx="1307">
                  <c:v>21.2</c:v>
                </c:pt>
                <c:pt idx="1308">
                  <c:v>21.1</c:v>
                </c:pt>
                <c:pt idx="1309">
                  <c:v>21</c:v>
                </c:pt>
                <c:pt idx="1310">
                  <c:v>20.9</c:v>
                </c:pt>
                <c:pt idx="1311">
                  <c:v>21</c:v>
                </c:pt>
                <c:pt idx="1312">
                  <c:v>21.8</c:v>
                </c:pt>
                <c:pt idx="1313">
                  <c:v>22.6</c:v>
                </c:pt>
                <c:pt idx="1314">
                  <c:v>23.1</c:v>
                </c:pt>
                <c:pt idx="1315">
                  <c:v>23.3</c:v>
                </c:pt>
                <c:pt idx="1316">
                  <c:v>23.3</c:v>
                </c:pt>
                <c:pt idx="1317">
                  <c:v>23.2</c:v>
                </c:pt>
                <c:pt idx="1318">
                  <c:v>23.2</c:v>
                </c:pt>
                <c:pt idx="1319">
                  <c:v>23.2</c:v>
                </c:pt>
                <c:pt idx="1320">
                  <c:v>23</c:v>
                </c:pt>
                <c:pt idx="1321">
                  <c:v>22.9</c:v>
                </c:pt>
                <c:pt idx="1322">
                  <c:v>22.8</c:v>
                </c:pt>
                <c:pt idx="1323">
                  <c:v>22.6</c:v>
                </c:pt>
                <c:pt idx="1324">
                  <c:v>22.4</c:v>
                </c:pt>
                <c:pt idx="1325">
                  <c:v>22.2</c:v>
                </c:pt>
                <c:pt idx="1326">
                  <c:v>22</c:v>
                </c:pt>
                <c:pt idx="1327">
                  <c:v>21.8</c:v>
                </c:pt>
                <c:pt idx="1328">
                  <c:v>21.6</c:v>
                </c:pt>
                <c:pt idx="1329">
                  <c:v>21.5</c:v>
                </c:pt>
                <c:pt idx="1330">
                  <c:v>21.3</c:v>
                </c:pt>
                <c:pt idx="1331">
                  <c:v>21.3</c:v>
                </c:pt>
                <c:pt idx="1332">
                  <c:v>21.2</c:v>
                </c:pt>
                <c:pt idx="1333">
                  <c:v>21.1</c:v>
                </c:pt>
                <c:pt idx="1334">
                  <c:v>20.9</c:v>
                </c:pt>
                <c:pt idx="1335">
                  <c:v>21</c:v>
                </c:pt>
                <c:pt idx="1336">
                  <c:v>21.7</c:v>
                </c:pt>
                <c:pt idx="1337">
                  <c:v>22.4</c:v>
                </c:pt>
                <c:pt idx="1338">
                  <c:v>2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705-484E-8188-E1A810FB68A4}"/>
            </c:ext>
          </c:extLst>
        </c:ser>
        <c:ser>
          <c:idx val="0"/>
          <c:order val="1"/>
          <c:tx>
            <c:strRef>
              <c:f>Tabelle1!$F$10</c:f>
              <c:strCache>
                <c:ptCount val="1"/>
                <c:pt idx="0">
                  <c:v>Relative Humidity [%]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2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</c:spPr>
          </c:marker>
          <c:xVal>
            <c:numRef>
              <c:f>Tabelle1!$C$13:$C$1351</c:f>
              <c:numCache>
                <c:formatCode>0.00000000000000000</c:formatCode>
                <c:ptCount val="1339"/>
                <c:pt idx="0">
                  <c:v>5.9523809523809521E-3</c:v>
                </c:pt>
                <c:pt idx="1">
                  <c:v>1.1904761904761904E-2</c:v>
                </c:pt>
                <c:pt idx="2">
                  <c:v>1.7857142857142856E-2</c:v>
                </c:pt>
                <c:pt idx="3">
                  <c:v>2.3809523809523808E-2</c:v>
                </c:pt>
                <c:pt idx="4">
                  <c:v>2.976190476190476E-2</c:v>
                </c:pt>
                <c:pt idx="5">
                  <c:v>3.5714285714285712E-2</c:v>
                </c:pt>
                <c:pt idx="6">
                  <c:v>4.1666666666666664E-2</c:v>
                </c:pt>
                <c:pt idx="7">
                  <c:v>4.7619047619047616E-2</c:v>
                </c:pt>
                <c:pt idx="8">
                  <c:v>5.3571428571428568E-2</c:v>
                </c:pt>
                <c:pt idx="9">
                  <c:v>5.9523809523809521E-2</c:v>
                </c:pt>
                <c:pt idx="10">
                  <c:v>6.5476190476190479E-2</c:v>
                </c:pt>
                <c:pt idx="11">
                  <c:v>7.1428571428571425E-2</c:v>
                </c:pt>
                <c:pt idx="12">
                  <c:v>7.7380952380952384E-2</c:v>
                </c:pt>
                <c:pt idx="13">
                  <c:v>8.3333333333333329E-2</c:v>
                </c:pt>
                <c:pt idx="14">
                  <c:v>8.9285714285714288E-2</c:v>
                </c:pt>
                <c:pt idx="15">
                  <c:v>9.5238095238095233E-2</c:v>
                </c:pt>
                <c:pt idx="16">
                  <c:v>0.10119047619047619</c:v>
                </c:pt>
                <c:pt idx="17">
                  <c:v>0.10714285714285714</c:v>
                </c:pt>
                <c:pt idx="18">
                  <c:v>0.1130952380952381</c:v>
                </c:pt>
                <c:pt idx="19">
                  <c:v>0.11904761904761904</c:v>
                </c:pt>
                <c:pt idx="20">
                  <c:v>0.125</c:v>
                </c:pt>
                <c:pt idx="21">
                  <c:v>0.13095238095238096</c:v>
                </c:pt>
                <c:pt idx="22">
                  <c:v>0.13690476190476192</c:v>
                </c:pt>
                <c:pt idx="23">
                  <c:v>0.14285714285714285</c:v>
                </c:pt>
                <c:pt idx="24">
                  <c:v>0.14880952380952381</c:v>
                </c:pt>
                <c:pt idx="25">
                  <c:v>0.15476190476190477</c:v>
                </c:pt>
                <c:pt idx="26">
                  <c:v>0.16071428571428573</c:v>
                </c:pt>
                <c:pt idx="27">
                  <c:v>0.16666666666666666</c:v>
                </c:pt>
                <c:pt idx="28">
                  <c:v>0.17261904761904762</c:v>
                </c:pt>
                <c:pt idx="29">
                  <c:v>0.17857142857142858</c:v>
                </c:pt>
                <c:pt idx="30">
                  <c:v>0.18452380952380953</c:v>
                </c:pt>
                <c:pt idx="31">
                  <c:v>0.19047619047619047</c:v>
                </c:pt>
                <c:pt idx="32">
                  <c:v>0.19642857142857142</c:v>
                </c:pt>
                <c:pt idx="33">
                  <c:v>0.20238095238095238</c:v>
                </c:pt>
                <c:pt idx="34">
                  <c:v>0.20833333333333334</c:v>
                </c:pt>
                <c:pt idx="35">
                  <c:v>0.21428571428571427</c:v>
                </c:pt>
                <c:pt idx="36">
                  <c:v>0.22023809523809523</c:v>
                </c:pt>
                <c:pt idx="37">
                  <c:v>0.22619047619047619</c:v>
                </c:pt>
                <c:pt idx="38">
                  <c:v>0.23214285714285715</c:v>
                </c:pt>
                <c:pt idx="39">
                  <c:v>0.23809523809523808</c:v>
                </c:pt>
                <c:pt idx="40">
                  <c:v>0.24404761904761904</c:v>
                </c:pt>
                <c:pt idx="41">
                  <c:v>0.25</c:v>
                </c:pt>
                <c:pt idx="42">
                  <c:v>0.25595238095238093</c:v>
                </c:pt>
                <c:pt idx="43">
                  <c:v>0.26190476190476192</c:v>
                </c:pt>
                <c:pt idx="44">
                  <c:v>0.26785714285714285</c:v>
                </c:pt>
                <c:pt idx="45">
                  <c:v>0.27380952380952384</c:v>
                </c:pt>
                <c:pt idx="46">
                  <c:v>0.27976190476190477</c:v>
                </c:pt>
                <c:pt idx="47">
                  <c:v>0.2857142857142857</c:v>
                </c:pt>
                <c:pt idx="48">
                  <c:v>0.29166666666666669</c:v>
                </c:pt>
                <c:pt idx="49">
                  <c:v>0.29761904761904762</c:v>
                </c:pt>
                <c:pt idx="50">
                  <c:v>0.30357142857142855</c:v>
                </c:pt>
                <c:pt idx="51">
                  <c:v>0.30952380952380953</c:v>
                </c:pt>
                <c:pt idx="52">
                  <c:v>0.31547619047619047</c:v>
                </c:pt>
                <c:pt idx="53">
                  <c:v>0.32142857142857145</c:v>
                </c:pt>
                <c:pt idx="54">
                  <c:v>0.32738095238095238</c:v>
                </c:pt>
                <c:pt idx="55">
                  <c:v>0.33333333333333331</c:v>
                </c:pt>
                <c:pt idx="56">
                  <c:v>0.3392857142857143</c:v>
                </c:pt>
                <c:pt idx="57">
                  <c:v>0.34523809523809523</c:v>
                </c:pt>
                <c:pt idx="58">
                  <c:v>0.35119047619047616</c:v>
                </c:pt>
                <c:pt idx="59">
                  <c:v>0.35714285714285715</c:v>
                </c:pt>
                <c:pt idx="60">
                  <c:v>0.36309523809523808</c:v>
                </c:pt>
                <c:pt idx="61">
                  <c:v>0.36904761904761907</c:v>
                </c:pt>
                <c:pt idx="62">
                  <c:v>0.375</c:v>
                </c:pt>
                <c:pt idx="63">
                  <c:v>0.38095238095238093</c:v>
                </c:pt>
                <c:pt idx="64">
                  <c:v>0.38690476190476192</c:v>
                </c:pt>
                <c:pt idx="65">
                  <c:v>0.39285714285714285</c:v>
                </c:pt>
                <c:pt idx="66">
                  <c:v>0.39880952380952384</c:v>
                </c:pt>
                <c:pt idx="67">
                  <c:v>0.40476190476190477</c:v>
                </c:pt>
                <c:pt idx="68">
                  <c:v>0.4107142857142857</c:v>
                </c:pt>
                <c:pt idx="69">
                  <c:v>0.41666666666666669</c:v>
                </c:pt>
                <c:pt idx="70">
                  <c:v>0.42261904761904762</c:v>
                </c:pt>
                <c:pt idx="71">
                  <c:v>0.42857142857142855</c:v>
                </c:pt>
                <c:pt idx="72">
                  <c:v>0.43452380952380953</c:v>
                </c:pt>
                <c:pt idx="73">
                  <c:v>0.44047619047619047</c:v>
                </c:pt>
                <c:pt idx="74">
                  <c:v>0.44642857142857145</c:v>
                </c:pt>
                <c:pt idx="75">
                  <c:v>0.45238095238095238</c:v>
                </c:pt>
                <c:pt idx="76">
                  <c:v>0.45833333333333331</c:v>
                </c:pt>
                <c:pt idx="77">
                  <c:v>0.4642857142857143</c:v>
                </c:pt>
                <c:pt idx="78">
                  <c:v>0.47023809523809523</c:v>
                </c:pt>
                <c:pt idx="79">
                  <c:v>0.47619047619047616</c:v>
                </c:pt>
                <c:pt idx="80">
                  <c:v>0.48214285714285715</c:v>
                </c:pt>
                <c:pt idx="81">
                  <c:v>0.48809523809523808</c:v>
                </c:pt>
                <c:pt idx="82">
                  <c:v>0.49404761904761907</c:v>
                </c:pt>
                <c:pt idx="83">
                  <c:v>0.5</c:v>
                </c:pt>
                <c:pt idx="84">
                  <c:v>0.50595238095238093</c:v>
                </c:pt>
                <c:pt idx="85">
                  <c:v>0.51190476190476186</c:v>
                </c:pt>
                <c:pt idx="86">
                  <c:v>0.5178571428571429</c:v>
                </c:pt>
                <c:pt idx="87">
                  <c:v>0.52380952380952384</c:v>
                </c:pt>
                <c:pt idx="88">
                  <c:v>0.52976190476190477</c:v>
                </c:pt>
                <c:pt idx="89">
                  <c:v>0.5357142857142857</c:v>
                </c:pt>
                <c:pt idx="90">
                  <c:v>0.54166666666666663</c:v>
                </c:pt>
                <c:pt idx="91">
                  <c:v>0.54761904761904767</c:v>
                </c:pt>
                <c:pt idx="92">
                  <c:v>0.5535714285714286</c:v>
                </c:pt>
                <c:pt idx="93">
                  <c:v>0.55952380952380953</c:v>
                </c:pt>
                <c:pt idx="94">
                  <c:v>0.56547619047619047</c:v>
                </c:pt>
                <c:pt idx="95">
                  <c:v>0.5714285714285714</c:v>
                </c:pt>
                <c:pt idx="96">
                  <c:v>0.57738095238095233</c:v>
                </c:pt>
                <c:pt idx="97">
                  <c:v>0.58333333333333337</c:v>
                </c:pt>
                <c:pt idx="98">
                  <c:v>0.5892857142857143</c:v>
                </c:pt>
                <c:pt idx="99">
                  <c:v>0.59523809523809523</c:v>
                </c:pt>
                <c:pt idx="100">
                  <c:v>0.60119047619047616</c:v>
                </c:pt>
                <c:pt idx="101">
                  <c:v>0.6071428571428571</c:v>
                </c:pt>
                <c:pt idx="102">
                  <c:v>0.61309523809523814</c:v>
                </c:pt>
                <c:pt idx="103">
                  <c:v>0.61904761904761907</c:v>
                </c:pt>
                <c:pt idx="104">
                  <c:v>0.625</c:v>
                </c:pt>
                <c:pt idx="105">
                  <c:v>0.63095238095238093</c:v>
                </c:pt>
                <c:pt idx="106">
                  <c:v>0.63690476190476186</c:v>
                </c:pt>
                <c:pt idx="107">
                  <c:v>0.6428571428571429</c:v>
                </c:pt>
                <c:pt idx="108">
                  <c:v>0.64880952380952384</c:v>
                </c:pt>
                <c:pt idx="109">
                  <c:v>0.65476190476190477</c:v>
                </c:pt>
                <c:pt idx="110">
                  <c:v>0.6607142857142857</c:v>
                </c:pt>
                <c:pt idx="111">
                  <c:v>0.66666666666666663</c:v>
                </c:pt>
                <c:pt idx="112">
                  <c:v>0.67261904761904767</c:v>
                </c:pt>
                <c:pt idx="113">
                  <c:v>0.6785714285714286</c:v>
                </c:pt>
                <c:pt idx="114">
                  <c:v>0.68452380952380953</c:v>
                </c:pt>
                <c:pt idx="115">
                  <c:v>0.69047619047619047</c:v>
                </c:pt>
                <c:pt idx="116">
                  <c:v>0.6964285714285714</c:v>
                </c:pt>
                <c:pt idx="117">
                  <c:v>0.70238095238095233</c:v>
                </c:pt>
                <c:pt idx="118">
                  <c:v>0.70833333333333337</c:v>
                </c:pt>
                <c:pt idx="119">
                  <c:v>0.7142857142857143</c:v>
                </c:pt>
                <c:pt idx="120">
                  <c:v>0.72023809523809523</c:v>
                </c:pt>
                <c:pt idx="121">
                  <c:v>0.72619047619047616</c:v>
                </c:pt>
                <c:pt idx="122">
                  <c:v>0.7321428571428571</c:v>
                </c:pt>
                <c:pt idx="123">
                  <c:v>0.73809523809523814</c:v>
                </c:pt>
                <c:pt idx="124">
                  <c:v>0.74404761904761907</c:v>
                </c:pt>
                <c:pt idx="125">
                  <c:v>0.75</c:v>
                </c:pt>
                <c:pt idx="126">
                  <c:v>0.75595238095238093</c:v>
                </c:pt>
                <c:pt idx="127">
                  <c:v>0.76190476190476186</c:v>
                </c:pt>
                <c:pt idx="128">
                  <c:v>0.7678571428571429</c:v>
                </c:pt>
                <c:pt idx="129">
                  <c:v>0.77380952380952384</c:v>
                </c:pt>
                <c:pt idx="130">
                  <c:v>0.77976190476190477</c:v>
                </c:pt>
                <c:pt idx="131">
                  <c:v>0.7857142857142857</c:v>
                </c:pt>
                <c:pt idx="132">
                  <c:v>0.79166666666666663</c:v>
                </c:pt>
                <c:pt idx="133">
                  <c:v>0.79761904761904767</c:v>
                </c:pt>
                <c:pt idx="134">
                  <c:v>0.8035714285714286</c:v>
                </c:pt>
                <c:pt idx="135">
                  <c:v>0.80952380952380953</c:v>
                </c:pt>
                <c:pt idx="136">
                  <c:v>0.81547619047619047</c:v>
                </c:pt>
                <c:pt idx="137">
                  <c:v>0.8214285714285714</c:v>
                </c:pt>
                <c:pt idx="138">
                  <c:v>0.82738095238095233</c:v>
                </c:pt>
                <c:pt idx="139">
                  <c:v>0.83333333333333337</c:v>
                </c:pt>
                <c:pt idx="140">
                  <c:v>0.8392857142857143</c:v>
                </c:pt>
                <c:pt idx="141">
                  <c:v>0.84523809523809523</c:v>
                </c:pt>
                <c:pt idx="142">
                  <c:v>0.85119047619047616</c:v>
                </c:pt>
                <c:pt idx="143">
                  <c:v>0.8571428571428571</c:v>
                </c:pt>
                <c:pt idx="144">
                  <c:v>0.86309523809523814</c:v>
                </c:pt>
                <c:pt idx="145">
                  <c:v>0.86904761904761907</c:v>
                </c:pt>
                <c:pt idx="146">
                  <c:v>0.875</c:v>
                </c:pt>
                <c:pt idx="147">
                  <c:v>0.88095238095238093</c:v>
                </c:pt>
                <c:pt idx="148">
                  <c:v>0.88690476190476186</c:v>
                </c:pt>
                <c:pt idx="149">
                  <c:v>0.8928571428571429</c:v>
                </c:pt>
                <c:pt idx="150">
                  <c:v>0.89880952380952384</c:v>
                </c:pt>
                <c:pt idx="151">
                  <c:v>0.90476190476190477</c:v>
                </c:pt>
                <c:pt idx="152">
                  <c:v>0.9107142857142857</c:v>
                </c:pt>
                <c:pt idx="153">
                  <c:v>0.91666666666666663</c:v>
                </c:pt>
                <c:pt idx="154">
                  <c:v>0.92261904761904767</c:v>
                </c:pt>
                <c:pt idx="155">
                  <c:v>0.9285714285714286</c:v>
                </c:pt>
                <c:pt idx="156">
                  <c:v>0.93452380952380953</c:v>
                </c:pt>
                <c:pt idx="157">
                  <c:v>0.94047619047619047</c:v>
                </c:pt>
                <c:pt idx="158">
                  <c:v>0.9464285714285714</c:v>
                </c:pt>
                <c:pt idx="159">
                  <c:v>0.95238095238095233</c:v>
                </c:pt>
                <c:pt idx="160">
                  <c:v>0.95833333333333337</c:v>
                </c:pt>
                <c:pt idx="161">
                  <c:v>0.9642857142857143</c:v>
                </c:pt>
                <c:pt idx="162">
                  <c:v>0.97023809523809523</c:v>
                </c:pt>
                <c:pt idx="163">
                  <c:v>0.97619047619047616</c:v>
                </c:pt>
                <c:pt idx="164">
                  <c:v>0.9821428571428571</c:v>
                </c:pt>
                <c:pt idx="165">
                  <c:v>0.98809523809523814</c:v>
                </c:pt>
                <c:pt idx="166">
                  <c:v>0.99404761904761907</c:v>
                </c:pt>
                <c:pt idx="167">
                  <c:v>1</c:v>
                </c:pt>
                <c:pt idx="168">
                  <c:v>1.0059523809523809</c:v>
                </c:pt>
                <c:pt idx="169">
                  <c:v>1.0119047619047619</c:v>
                </c:pt>
                <c:pt idx="170">
                  <c:v>1.0178571428571428</c:v>
                </c:pt>
                <c:pt idx="171">
                  <c:v>1.0238095238095237</c:v>
                </c:pt>
                <c:pt idx="172">
                  <c:v>1.0297619047619047</c:v>
                </c:pt>
                <c:pt idx="173">
                  <c:v>1.0357142857142858</c:v>
                </c:pt>
                <c:pt idx="174">
                  <c:v>1.0416666666666667</c:v>
                </c:pt>
                <c:pt idx="175">
                  <c:v>1.0476190476190477</c:v>
                </c:pt>
                <c:pt idx="176">
                  <c:v>1.0535714285714286</c:v>
                </c:pt>
                <c:pt idx="177">
                  <c:v>1.0595238095238095</c:v>
                </c:pt>
                <c:pt idx="178">
                  <c:v>1.0654761904761905</c:v>
                </c:pt>
                <c:pt idx="179">
                  <c:v>1.0714285714285714</c:v>
                </c:pt>
                <c:pt idx="180">
                  <c:v>1.0773809523809523</c:v>
                </c:pt>
                <c:pt idx="181">
                  <c:v>1.0833333333333333</c:v>
                </c:pt>
                <c:pt idx="182">
                  <c:v>1.0892857142857142</c:v>
                </c:pt>
                <c:pt idx="183">
                  <c:v>1.0952380952380953</c:v>
                </c:pt>
                <c:pt idx="184">
                  <c:v>1.1011904761904763</c:v>
                </c:pt>
                <c:pt idx="185">
                  <c:v>1.1071428571428572</c:v>
                </c:pt>
                <c:pt idx="186">
                  <c:v>1.1130952380952381</c:v>
                </c:pt>
                <c:pt idx="187">
                  <c:v>1.1190476190476191</c:v>
                </c:pt>
                <c:pt idx="188">
                  <c:v>1.125</c:v>
                </c:pt>
                <c:pt idx="189">
                  <c:v>1.1309523809523809</c:v>
                </c:pt>
                <c:pt idx="190">
                  <c:v>1.1369047619047619</c:v>
                </c:pt>
                <c:pt idx="191">
                  <c:v>1.1428571428571428</c:v>
                </c:pt>
                <c:pt idx="192">
                  <c:v>1.1488095238095237</c:v>
                </c:pt>
                <c:pt idx="193">
                  <c:v>1.1547619047619047</c:v>
                </c:pt>
                <c:pt idx="194">
                  <c:v>1.1607142857142858</c:v>
                </c:pt>
                <c:pt idx="195">
                  <c:v>1.1666666666666667</c:v>
                </c:pt>
                <c:pt idx="196">
                  <c:v>1.1726190476190477</c:v>
                </c:pt>
                <c:pt idx="197">
                  <c:v>1.1785714285714286</c:v>
                </c:pt>
                <c:pt idx="198">
                  <c:v>1.1845238095238095</c:v>
                </c:pt>
                <c:pt idx="199">
                  <c:v>1.1904761904761905</c:v>
                </c:pt>
                <c:pt idx="200">
                  <c:v>1.1964285714285714</c:v>
                </c:pt>
                <c:pt idx="201">
                  <c:v>1.2023809523809523</c:v>
                </c:pt>
                <c:pt idx="202">
                  <c:v>1.2083333333333333</c:v>
                </c:pt>
                <c:pt idx="203">
                  <c:v>1.2142857142857142</c:v>
                </c:pt>
                <c:pt idx="204">
                  <c:v>1.2202380952380953</c:v>
                </c:pt>
                <c:pt idx="205">
                  <c:v>1.2261904761904763</c:v>
                </c:pt>
                <c:pt idx="206">
                  <c:v>1.2321428571428572</c:v>
                </c:pt>
                <c:pt idx="207">
                  <c:v>1.2380952380952381</c:v>
                </c:pt>
                <c:pt idx="208">
                  <c:v>1.2440476190476191</c:v>
                </c:pt>
                <c:pt idx="209">
                  <c:v>1.25</c:v>
                </c:pt>
                <c:pt idx="210">
                  <c:v>1.2559523809523809</c:v>
                </c:pt>
                <c:pt idx="211">
                  <c:v>1.2619047619047619</c:v>
                </c:pt>
                <c:pt idx="212">
                  <c:v>1.2678571428571428</c:v>
                </c:pt>
                <c:pt idx="213">
                  <c:v>1.2738095238095237</c:v>
                </c:pt>
                <c:pt idx="214">
                  <c:v>1.2797619047619047</c:v>
                </c:pt>
                <c:pt idx="215">
                  <c:v>1.2857142857142858</c:v>
                </c:pt>
                <c:pt idx="216">
                  <c:v>1.2916666666666667</c:v>
                </c:pt>
                <c:pt idx="217">
                  <c:v>1.2976190476190477</c:v>
                </c:pt>
                <c:pt idx="218">
                  <c:v>1.3035714285714286</c:v>
                </c:pt>
                <c:pt idx="219">
                  <c:v>1.3095238095238095</c:v>
                </c:pt>
                <c:pt idx="220">
                  <c:v>1.3154761904761905</c:v>
                </c:pt>
                <c:pt idx="221">
                  <c:v>1.3214285714285714</c:v>
                </c:pt>
                <c:pt idx="222">
                  <c:v>1.3273809523809523</c:v>
                </c:pt>
                <c:pt idx="223">
                  <c:v>1.3333333333333333</c:v>
                </c:pt>
                <c:pt idx="224">
                  <c:v>1.3392857142857142</c:v>
                </c:pt>
                <c:pt idx="225">
                  <c:v>1.3452380952380953</c:v>
                </c:pt>
                <c:pt idx="226">
                  <c:v>1.3511904761904763</c:v>
                </c:pt>
                <c:pt idx="227">
                  <c:v>1.3571428571428572</c:v>
                </c:pt>
                <c:pt idx="228">
                  <c:v>1.3630952380952381</c:v>
                </c:pt>
                <c:pt idx="229">
                  <c:v>1.3690476190476191</c:v>
                </c:pt>
                <c:pt idx="230">
                  <c:v>1.375</c:v>
                </c:pt>
                <c:pt idx="231">
                  <c:v>1.3809523809523809</c:v>
                </c:pt>
                <c:pt idx="232">
                  <c:v>1.3869047619047619</c:v>
                </c:pt>
                <c:pt idx="233">
                  <c:v>1.3928571428571428</c:v>
                </c:pt>
                <c:pt idx="234">
                  <c:v>1.3988095238095237</c:v>
                </c:pt>
                <c:pt idx="235">
                  <c:v>1.4047619047619047</c:v>
                </c:pt>
                <c:pt idx="236">
                  <c:v>1.4107142857142858</c:v>
                </c:pt>
                <c:pt idx="237">
                  <c:v>1.4166666666666667</c:v>
                </c:pt>
                <c:pt idx="238">
                  <c:v>1.4226190476190477</c:v>
                </c:pt>
                <c:pt idx="239">
                  <c:v>1.4285714285714286</c:v>
                </c:pt>
                <c:pt idx="240">
                  <c:v>1.4345238095238095</c:v>
                </c:pt>
                <c:pt idx="241">
                  <c:v>1.4404761904761905</c:v>
                </c:pt>
                <c:pt idx="242">
                  <c:v>1.4464285714285714</c:v>
                </c:pt>
                <c:pt idx="243">
                  <c:v>1.4523809523809523</c:v>
                </c:pt>
                <c:pt idx="244">
                  <c:v>1.4583333333333333</c:v>
                </c:pt>
                <c:pt idx="245">
                  <c:v>1.4642857142857142</c:v>
                </c:pt>
                <c:pt idx="246">
                  <c:v>1.4702380952380953</c:v>
                </c:pt>
                <c:pt idx="247">
                  <c:v>1.4761904761904763</c:v>
                </c:pt>
                <c:pt idx="248">
                  <c:v>1.4821428571428572</c:v>
                </c:pt>
                <c:pt idx="249">
                  <c:v>1.4880952380952381</c:v>
                </c:pt>
                <c:pt idx="250">
                  <c:v>1.4940476190476191</c:v>
                </c:pt>
                <c:pt idx="251">
                  <c:v>1.5</c:v>
                </c:pt>
                <c:pt idx="252">
                  <c:v>1.5059523809523809</c:v>
                </c:pt>
                <c:pt idx="253">
                  <c:v>1.5119047619047619</c:v>
                </c:pt>
                <c:pt idx="254">
                  <c:v>1.5178571428571428</c:v>
                </c:pt>
                <c:pt idx="255">
                  <c:v>1.5238095238095237</c:v>
                </c:pt>
                <c:pt idx="256">
                  <c:v>1.5297619047619047</c:v>
                </c:pt>
                <c:pt idx="257">
                  <c:v>1.5357142857142858</c:v>
                </c:pt>
                <c:pt idx="258">
                  <c:v>1.5416666666666667</c:v>
                </c:pt>
                <c:pt idx="259">
                  <c:v>1.5476190476190477</c:v>
                </c:pt>
                <c:pt idx="260">
                  <c:v>1.5535714285714286</c:v>
                </c:pt>
                <c:pt idx="261">
                  <c:v>1.5595238095238095</c:v>
                </c:pt>
                <c:pt idx="262">
                  <c:v>1.5654761904761905</c:v>
                </c:pt>
                <c:pt idx="263">
                  <c:v>1.5714285714285714</c:v>
                </c:pt>
                <c:pt idx="264">
                  <c:v>1.5773809523809523</c:v>
                </c:pt>
                <c:pt idx="265">
                  <c:v>1.5833333333333333</c:v>
                </c:pt>
                <c:pt idx="266">
                  <c:v>1.5892857142857142</c:v>
                </c:pt>
                <c:pt idx="267">
                  <c:v>1.5952380952380953</c:v>
                </c:pt>
                <c:pt idx="268">
                  <c:v>1.6011904761904763</c:v>
                </c:pt>
                <c:pt idx="269">
                  <c:v>1.6071428571428572</c:v>
                </c:pt>
                <c:pt idx="270">
                  <c:v>1.6130952380952381</c:v>
                </c:pt>
                <c:pt idx="271">
                  <c:v>1.6190476190476191</c:v>
                </c:pt>
                <c:pt idx="272">
                  <c:v>1.625</c:v>
                </c:pt>
                <c:pt idx="273">
                  <c:v>1.6309523809523809</c:v>
                </c:pt>
                <c:pt idx="274">
                  <c:v>1.6369047619047619</c:v>
                </c:pt>
                <c:pt idx="275">
                  <c:v>1.6428571428571428</c:v>
                </c:pt>
                <c:pt idx="276">
                  <c:v>1.6488095238095237</c:v>
                </c:pt>
                <c:pt idx="277">
                  <c:v>1.6547619047619047</c:v>
                </c:pt>
                <c:pt idx="278">
                  <c:v>1.6607142857142858</c:v>
                </c:pt>
                <c:pt idx="279">
                  <c:v>1.6666666666666667</c:v>
                </c:pt>
                <c:pt idx="280">
                  <c:v>1.6726190476190477</c:v>
                </c:pt>
                <c:pt idx="281">
                  <c:v>1.6785714285714286</c:v>
                </c:pt>
                <c:pt idx="282">
                  <c:v>1.6845238095238095</c:v>
                </c:pt>
                <c:pt idx="283">
                  <c:v>1.6904761904761905</c:v>
                </c:pt>
                <c:pt idx="284">
                  <c:v>1.6964285714285714</c:v>
                </c:pt>
                <c:pt idx="285">
                  <c:v>1.7023809523809523</c:v>
                </c:pt>
                <c:pt idx="286">
                  <c:v>1.7083333333333333</c:v>
                </c:pt>
                <c:pt idx="287">
                  <c:v>1.7142857142857142</c:v>
                </c:pt>
                <c:pt idx="288">
                  <c:v>1.7202380952380953</c:v>
                </c:pt>
                <c:pt idx="289">
                  <c:v>1.7261904761904763</c:v>
                </c:pt>
                <c:pt idx="290">
                  <c:v>1.7321428571428572</c:v>
                </c:pt>
                <c:pt idx="291">
                  <c:v>1.7380952380952381</c:v>
                </c:pt>
                <c:pt idx="292">
                  <c:v>1.7440476190476191</c:v>
                </c:pt>
                <c:pt idx="293">
                  <c:v>1.75</c:v>
                </c:pt>
                <c:pt idx="294">
                  <c:v>1.7559523809523809</c:v>
                </c:pt>
                <c:pt idx="295">
                  <c:v>1.7619047619047619</c:v>
                </c:pt>
                <c:pt idx="296">
                  <c:v>1.7678571428571428</c:v>
                </c:pt>
                <c:pt idx="297">
                  <c:v>1.7738095238095237</c:v>
                </c:pt>
                <c:pt idx="298">
                  <c:v>1.7797619047619047</c:v>
                </c:pt>
                <c:pt idx="299">
                  <c:v>1.7857142857142858</c:v>
                </c:pt>
                <c:pt idx="300">
                  <c:v>1.7916666666666667</c:v>
                </c:pt>
                <c:pt idx="301">
                  <c:v>1.7976190476190477</c:v>
                </c:pt>
                <c:pt idx="302">
                  <c:v>1.8035714285714286</c:v>
                </c:pt>
                <c:pt idx="303">
                  <c:v>1.8095238095238095</c:v>
                </c:pt>
                <c:pt idx="304">
                  <c:v>1.8154761904761905</c:v>
                </c:pt>
                <c:pt idx="305">
                  <c:v>1.8214285714285714</c:v>
                </c:pt>
                <c:pt idx="306">
                  <c:v>1.8273809523809523</c:v>
                </c:pt>
                <c:pt idx="307">
                  <c:v>1.8333333333333333</c:v>
                </c:pt>
                <c:pt idx="308">
                  <c:v>1.8392857142857142</c:v>
                </c:pt>
                <c:pt idx="309">
                  <c:v>1.8452380952380953</c:v>
                </c:pt>
                <c:pt idx="310">
                  <c:v>1.8511904761904763</c:v>
                </c:pt>
                <c:pt idx="311">
                  <c:v>1.8571428571428572</c:v>
                </c:pt>
                <c:pt idx="312">
                  <c:v>1.8630952380952381</c:v>
                </c:pt>
                <c:pt idx="313">
                  <c:v>1.8690476190476191</c:v>
                </c:pt>
                <c:pt idx="314">
                  <c:v>1.875</c:v>
                </c:pt>
                <c:pt idx="315">
                  <c:v>1.8809523809523809</c:v>
                </c:pt>
                <c:pt idx="316">
                  <c:v>1.8869047619047619</c:v>
                </c:pt>
                <c:pt idx="317">
                  <c:v>1.8928571428571428</c:v>
                </c:pt>
                <c:pt idx="318">
                  <c:v>1.8988095238095237</c:v>
                </c:pt>
                <c:pt idx="319">
                  <c:v>1.9047619047619047</c:v>
                </c:pt>
                <c:pt idx="320">
                  <c:v>1.9107142857142858</c:v>
                </c:pt>
                <c:pt idx="321">
                  <c:v>1.9166666666666667</c:v>
                </c:pt>
                <c:pt idx="322">
                  <c:v>1.9226190476190477</c:v>
                </c:pt>
                <c:pt idx="323">
                  <c:v>1.9285714285714286</c:v>
                </c:pt>
                <c:pt idx="324">
                  <c:v>1.9345238095238095</c:v>
                </c:pt>
                <c:pt idx="325">
                  <c:v>1.9404761904761905</c:v>
                </c:pt>
                <c:pt idx="326">
                  <c:v>1.9464285714285714</c:v>
                </c:pt>
                <c:pt idx="327">
                  <c:v>1.9523809523809523</c:v>
                </c:pt>
                <c:pt idx="328">
                  <c:v>1.9583333333333333</c:v>
                </c:pt>
                <c:pt idx="329">
                  <c:v>1.9642857142857142</c:v>
                </c:pt>
                <c:pt idx="330">
                  <c:v>1.9702380952380953</c:v>
                </c:pt>
                <c:pt idx="331">
                  <c:v>1.9761904761904763</c:v>
                </c:pt>
                <c:pt idx="332">
                  <c:v>1.9821428571428572</c:v>
                </c:pt>
                <c:pt idx="333">
                  <c:v>1.9880952380952381</c:v>
                </c:pt>
                <c:pt idx="334">
                  <c:v>1.9940476190476191</c:v>
                </c:pt>
                <c:pt idx="335">
                  <c:v>2</c:v>
                </c:pt>
                <c:pt idx="336">
                  <c:v>2.0059523809523809</c:v>
                </c:pt>
                <c:pt idx="337">
                  <c:v>2.0119047619047619</c:v>
                </c:pt>
                <c:pt idx="338">
                  <c:v>2.0178571428571428</c:v>
                </c:pt>
                <c:pt idx="339">
                  <c:v>2.0238095238095237</c:v>
                </c:pt>
                <c:pt idx="340">
                  <c:v>2.0297619047619047</c:v>
                </c:pt>
                <c:pt idx="341">
                  <c:v>2.0357142857142856</c:v>
                </c:pt>
                <c:pt idx="342">
                  <c:v>2.0416666666666665</c:v>
                </c:pt>
                <c:pt idx="343">
                  <c:v>2.0476190476190474</c:v>
                </c:pt>
                <c:pt idx="344">
                  <c:v>2.0535714285714284</c:v>
                </c:pt>
                <c:pt idx="345">
                  <c:v>2.0595238095238093</c:v>
                </c:pt>
                <c:pt idx="346">
                  <c:v>2.0654761904761907</c:v>
                </c:pt>
                <c:pt idx="347">
                  <c:v>2.0714285714285716</c:v>
                </c:pt>
                <c:pt idx="348">
                  <c:v>2.0773809523809526</c:v>
                </c:pt>
                <c:pt idx="349">
                  <c:v>2.0833333333333335</c:v>
                </c:pt>
                <c:pt idx="350">
                  <c:v>2.0892857142857144</c:v>
                </c:pt>
                <c:pt idx="351">
                  <c:v>2.0952380952380953</c:v>
                </c:pt>
                <c:pt idx="352">
                  <c:v>2.1011904761904763</c:v>
                </c:pt>
                <c:pt idx="353">
                  <c:v>2.1071428571428572</c:v>
                </c:pt>
                <c:pt idx="354">
                  <c:v>2.1130952380952381</c:v>
                </c:pt>
                <c:pt idx="355">
                  <c:v>2.1190476190476191</c:v>
                </c:pt>
                <c:pt idx="356">
                  <c:v>2.125</c:v>
                </c:pt>
                <c:pt idx="357">
                  <c:v>2.1309523809523809</c:v>
                </c:pt>
                <c:pt idx="358">
                  <c:v>2.1369047619047619</c:v>
                </c:pt>
                <c:pt idx="359">
                  <c:v>2.1428571428571428</c:v>
                </c:pt>
                <c:pt idx="360">
                  <c:v>2.1488095238095237</c:v>
                </c:pt>
                <c:pt idx="361">
                  <c:v>2.1547619047619047</c:v>
                </c:pt>
                <c:pt idx="362">
                  <c:v>2.1607142857142856</c:v>
                </c:pt>
                <c:pt idx="363">
                  <c:v>2.1666666666666665</c:v>
                </c:pt>
                <c:pt idx="364">
                  <c:v>2.1726190476190474</c:v>
                </c:pt>
                <c:pt idx="365">
                  <c:v>2.1785714285714284</c:v>
                </c:pt>
                <c:pt idx="366">
                  <c:v>2.1845238095238093</c:v>
                </c:pt>
                <c:pt idx="367">
                  <c:v>2.1904761904761907</c:v>
                </c:pt>
                <c:pt idx="368">
                  <c:v>2.1964285714285716</c:v>
                </c:pt>
                <c:pt idx="369">
                  <c:v>2.2023809523809526</c:v>
                </c:pt>
                <c:pt idx="370">
                  <c:v>2.2083333333333335</c:v>
                </c:pt>
                <c:pt idx="371">
                  <c:v>2.2142857142857144</c:v>
                </c:pt>
                <c:pt idx="372">
                  <c:v>2.2202380952380953</c:v>
                </c:pt>
                <c:pt idx="373">
                  <c:v>2.2261904761904763</c:v>
                </c:pt>
                <c:pt idx="374">
                  <c:v>2.2321428571428572</c:v>
                </c:pt>
                <c:pt idx="375">
                  <c:v>2.2380952380952381</c:v>
                </c:pt>
                <c:pt idx="376">
                  <c:v>2.2440476190476191</c:v>
                </c:pt>
                <c:pt idx="377">
                  <c:v>2.25</c:v>
                </c:pt>
                <c:pt idx="378">
                  <c:v>2.2559523809523809</c:v>
                </c:pt>
                <c:pt idx="379">
                  <c:v>2.2619047619047619</c:v>
                </c:pt>
                <c:pt idx="380">
                  <c:v>2.2678571428571428</c:v>
                </c:pt>
                <c:pt idx="381">
                  <c:v>2.2738095238095237</c:v>
                </c:pt>
                <c:pt idx="382">
                  <c:v>2.2797619047619047</c:v>
                </c:pt>
                <c:pt idx="383">
                  <c:v>2.2857142857142856</c:v>
                </c:pt>
                <c:pt idx="384">
                  <c:v>2.2916666666666665</c:v>
                </c:pt>
                <c:pt idx="385">
                  <c:v>2.2976190476190474</c:v>
                </c:pt>
                <c:pt idx="386">
                  <c:v>2.3035714285714284</c:v>
                </c:pt>
                <c:pt idx="387">
                  <c:v>2.3095238095238093</c:v>
                </c:pt>
                <c:pt idx="388">
                  <c:v>2.3154761904761907</c:v>
                </c:pt>
                <c:pt idx="389">
                  <c:v>2.3214285714285716</c:v>
                </c:pt>
                <c:pt idx="390">
                  <c:v>2.3273809523809526</c:v>
                </c:pt>
                <c:pt idx="391">
                  <c:v>2.3333333333333335</c:v>
                </c:pt>
                <c:pt idx="392">
                  <c:v>2.3392857142857144</c:v>
                </c:pt>
                <c:pt idx="393">
                  <c:v>2.3452380952380953</c:v>
                </c:pt>
                <c:pt idx="394">
                  <c:v>2.3511904761904763</c:v>
                </c:pt>
                <c:pt idx="395">
                  <c:v>2.3571428571428572</c:v>
                </c:pt>
                <c:pt idx="396">
                  <c:v>2.3630952380952381</c:v>
                </c:pt>
                <c:pt idx="397">
                  <c:v>2.3690476190476191</c:v>
                </c:pt>
                <c:pt idx="398">
                  <c:v>2.375</c:v>
                </c:pt>
                <c:pt idx="399">
                  <c:v>2.3809523809523809</c:v>
                </c:pt>
                <c:pt idx="400">
                  <c:v>2.3869047619047619</c:v>
                </c:pt>
                <c:pt idx="401">
                  <c:v>2.3928571428571428</c:v>
                </c:pt>
                <c:pt idx="402">
                  <c:v>2.3988095238095237</c:v>
                </c:pt>
                <c:pt idx="403">
                  <c:v>2.4047619047619047</c:v>
                </c:pt>
                <c:pt idx="404">
                  <c:v>2.4107142857142856</c:v>
                </c:pt>
                <c:pt idx="405">
                  <c:v>2.4166666666666665</c:v>
                </c:pt>
                <c:pt idx="406">
                  <c:v>2.4226190476190474</c:v>
                </c:pt>
                <c:pt idx="407">
                  <c:v>2.4285714285714284</c:v>
                </c:pt>
                <c:pt idx="408">
                  <c:v>2.4345238095238093</c:v>
                </c:pt>
                <c:pt idx="409">
                  <c:v>2.4404761904761907</c:v>
                </c:pt>
                <c:pt idx="410">
                  <c:v>2.4464285714285716</c:v>
                </c:pt>
                <c:pt idx="411">
                  <c:v>2.4523809523809526</c:v>
                </c:pt>
                <c:pt idx="412">
                  <c:v>2.4583333333333335</c:v>
                </c:pt>
                <c:pt idx="413">
                  <c:v>2.4642857142857144</c:v>
                </c:pt>
                <c:pt idx="414">
                  <c:v>2.4702380952380953</c:v>
                </c:pt>
                <c:pt idx="415">
                  <c:v>2.4761904761904763</c:v>
                </c:pt>
                <c:pt idx="416">
                  <c:v>2.4821428571428572</c:v>
                </c:pt>
                <c:pt idx="417">
                  <c:v>2.4880952380952381</c:v>
                </c:pt>
                <c:pt idx="418">
                  <c:v>2.4940476190476191</c:v>
                </c:pt>
                <c:pt idx="419">
                  <c:v>2.5</c:v>
                </c:pt>
                <c:pt idx="420">
                  <c:v>2.5059523809523809</c:v>
                </c:pt>
                <c:pt idx="421">
                  <c:v>2.5119047619047619</c:v>
                </c:pt>
                <c:pt idx="422">
                  <c:v>2.5178571428571428</c:v>
                </c:pt>
                <c:pt idx="423">
                  <c:v>2.5238095238095237</c:v>
                </c:pt>
                <c:pt idx="424">
                  <c:v>2.5297619047619047</c:v>
                </c:pt>
                <c:pt idx="425">
                  <c:v>2.5357142857142856</c:v>
                </c:pt>
                <c:pt idx="426">
                  <c:v>2.5416666666666665</c:v>
                </c:pt>
                <c:pt idx="427">
                  <c:v>2.5476190476190474</c:v>
                </c:pt>
                <c:pt idx="428">
                  <c:v>2.5535714285714284</c:v>
                </c:pt>
                <c:pt idx="429">
                  <c:v>2.5595238095238093</c:v>
                </c:pt>
                <c:pt idx="430">
                  <c:v>2.5654761904761907</c:v>
                </c:pt>
                <c:pt idx="431">
                  <c:v>2.5714285714285716</c:v>
                </c:pt>
                <c:pt idx="432">
                  <c:v>2.5773809523809526</c:v>
                </c:pt>
                <c:pt idx="433">
                  <c:v>2.5833333333333335</c:v>
                </c:pt>
                <c:pt idx="434">
                  <c:v>2.5892857142857144</c:v>
                </c:pt>
                <c:pt idx="435">
                  <c:v>2.5952380952380953</c:v>
                </c:pt>
                <c:pt idx="436">
                  <c:v>2.6011904761904763</c:v>
                </c:pt>
                <c:pt idx="437">
                  <c:v>2.6071428571428572</c:v>
                </c:pt>
                <c:pt idx="438">
                  <c:v>2.6130952380952381</c:v>
                </c:pt>
                <c:pt idx="439">
                  <c:v>2.6190476190476191</c:v>
                </c:pt>
                <c:pt idx="440">
                  <c:v>2.625</c:v>
                </c:pt>
                <c:pt idx="441">
                  <c:v>2.6309523809523809</c:v>
                </c:pt>
                <c:pt idx="442">
                  <c:v>2.6369047619047619</c:v>
                </c:pt>
                <c:pt idx="443">
                  <c:v>2.6428571428571428</c:v>
                </c:pt>
                <c:pt idx="444">
                  <c:v>2.6488095238095237</c:v>
                </c:pt>
                <c:pt idx="445">
                  <c:v>2.6547619047619047</c:v>
                </c:pt>
                <c:pt idx="446">
                  <c:v>2.6607142857142856</c:v>
                </c:pt>
                <c:pt idx="447">
                  <c:v>2.6666666666666665</c:v>
                </c:pt>
                <c:pt idx="448">
                  <c:v>2.6726190476190474</c:v>
                </c:pt>
                <c:pt idx="449">
                  <c:v>2.6785714285714284</c:v>
                </c:pt>
                <c:pt idx="450">
                  <c:v>2.6845238095238093</c:v>
                </c:pt>
                <c:pt idx="451">
                  <c:v>2.6904761904761907</c:v>
                </c:pt>
                <c:pt idx="452">
                  <c:v>2.6964285714285716</c:v>
                </c:pt>
                <c:pt idx="453">
                  <c:v>2.7023809523809526</c:v>
                </c:pt>
                <c:pt idx="454">
                  <c:v>2.7083333333333335</c:v>
                </c:pt>
                <c:pt idx="455">
                  <c:v>2.7142857142857144</c:v>
                </c:pt>
                <c:pt idx="456">
                  <c:v>2.7202380952380953</c:v>
                </c:pt>
                <c:pt idx="457">
                  <c:v>2.7261904761904763</c:v>
                </c:pt>
                <c:pt idx="458">
                  <c:v>2.7321428571428572</c:v>
                </c:pt>
                <c:pt idx="459">
                  <c:v>2.7380952380952381</c:v>
                </c:pt>
                <c:pt idx="460">
                  <c:v>2.7440476190476191</c:v>
                </c:pt>
                <c:pt idx="461">
                  <c:v>2.75</c:v>
                </c:pt>
                <c:pt idx="462">
                  <c:v>2.7559523809523809</c:v>
                </c:pt>
                <c:pt idx="463">
                  <c:v>2.7619047619047619</c:v>
                </c:pt>
                <c:pt idx="464">
                  <c:v>2.7678571428571428</c:v>
                </c:pt>
                <c:pt idx="465">
                  <c:v>2.7738095238095237</c:v>
                </c:pt>
                <c:pt idx="466">
                  <c:v>2.7797619047619047</c:v>
                </c:pt>
                <c:pt idx="467">
                  <c:v>2.7857142857142856</c:v>
                </c:pt>
                <c:pt idx="468">
                  <c:v>2.7916666666666665</c:v>
                </c:pt>
                <c:pt idx="469">
                  <c:v>2.7976190476190474</c:v>
                </c:pt>
                <c:pt idx="470">
                  <c:v>2.8035714285714284</c:v>
                </c:pt>
                <c:pt idx="471">
                  <c:v>2.8095238095238093</c:v>
                </c:pt>
                <c:pt idx="472">
                  <c:v>2.8154761904761907</c:v>
                </c:pt>
                <c:pt idx="473">
                  <c:v>2.8214285714285716</c:v>
                </c:pt>
                <c:pt idx="474">
                  <c:v>2.8273809523809526</c:v>
                </c:pt>
                <c:pt idx="475">
                  <c:v>2.8333333333333335</c:v>
                </c:pt>
                <c:pt idx="476">
                  <c:v>2.8392857142857144</c:v>
                </c:pt>
                <c:pt idx="477">
                  <c:v>2.8452380952380953</c:v>
                </c:pt>
                <c:pt idx="478">
                  <c:v>2.8511904761904763</c:v>
                </c:pt>
                <c:pt idx="479">
                  <c:v>2.8571428571428572</c:v>
                </c:pt>
                <c:pt idx="480">
                  <c:v>2.8630952380952381</c:v>
                </c:pt>
                <c:pt idx="481">
                  <c:v>2.8690476190476191</c:v>
                </c:pt>
                <c:pt idx="482">
                  <c:v>2.875</c:v>
                </c:pt>
                <c:pt idx="483">
                  <c:v>2.8809523809523809</c:v>
                </c:pt>
                <c:pt idx="484">
                  <c:v>2.8869047619047619</c:v>
                </c:pt>
                <c:pt idx="485">
                  <c:v>2.8928571428571428</c:v>
                </c:pt>
                <c:pt idx="486">
                  <c:v>2.8988095238095237</c:v>
                </c:pt>
                <c:pt idx="487">
                  <c:v>2.9047619047619047</c:v>
                </c:pt>
                <c:pt idx="488">
                  <c:v>2.9107142857142856</c:v>
                </c:pt>
                <c:pt idx="489">
                  <c:v>2.9166666666666665</c:v>
                </c:pt>
                <c:pt idx="490">
                  <c:v>2.9226190476190474</c:v>
                </c:pt>
                <c:pt idx="491">
                  <c:v>2.9285714285714284</c:v>
                </c:pt>
                <c:pt idx="492">
                  <c:v>2.9345238095238093</c:v>
                </c:pt>
                <c:pt idx="493">
                  <c:v>2.9404761904761907</c:v>
                </c:pt>
                <c:pt idx="494">
                  <c:v>2.9464285714285716</c:v>
                </c:pt>
                <c:pt idx="495">
                  <c:v>2.9523809523809526</c:v>
                </c:pt>
                <c:pt idx="496">
                  <c:v>2.9583333333333335</c:v>
                </c:pt>
                <c:pt idx="497">
                  <c:v>2.9642857142857144</c:v>
                </c:pt>
                <c:pt idx="498">
                  <c:v>2.9702380952380953</c:v>
                </c:pt>
                <c:pt idx="499">
                  <c:v>2.9761904761904763</c:v>
                </c:pt>
                <c:pt idx="500">
                  <c:v>2.9821428571428572</c:v>
                </c:pt>
                <c:pt idx="501">
                  <c:v>2.9880952380952381</c:v>
                </c:pt>
                <c:pt idx="502">
                  <c:v>2.9940476190476191</c:v>
                </c:pt>
                <c:pt idx="503">
                  <c:v>3</c:v>
                </c:pt>
                <c:pt idx="504">
                  <c:v>3.0059523809523809</c:v>
                </c:pt>
                <c:pt idx="505">
                  <c:v>3.0119047619047619</c:v>
                </c:pt>
                <c:pt idx="506">
                  <c:v>3.0178571428571428</c:v>
                </c:pt>
                <c:pt idx="507">
                  <c:v>3.0238095238095237</c:v>
                </c:pt>
                <c:pt idx="508">
                  <c:v>3.0297619047619047</c:v>
                </c:pt>
                <c:pt idx="509">
                  <c:v>3.0357142857142856</c:v>
                </c:pt>
                <c:pt idx="510">
                  <c:v>3.0416666666666665</c:v>
                </c:pt>
                <c:pt idx="511">
                  <c:v>3.0476190476190474</c:v>
                </c:pt>
                <c:pt idx="512">
                  <c:v>3.0535714285714284</c:v>
                </c:pt>
                <c:pt idx="513">
                  <c:v>3.0595238095238093</c:v>
                </c:pt>
                <c:pt idx="514">
                  <c:v>3.0654761904761907</c:v>
                </c:pt>
                <c:pt idx="515">
                  <c:v>3.0714285714285716</c:v>
                </c:pt>
                <c:pt idx="516">
                  <c:v>3.0773809523809526</c:v>
                </c:pt>
                <c:pt idx="517">
                  <c:v>3.0833333333333335</c:v>
                </c:pt>
                <c:pt idx="518">
                  <c:v>3.0892857142857144</c:v>
                </c:pt>
                <c:pt idx="519">
                  <c:v>3.0952380952380953</c:v>
                </c:pt>
                <c:pt idx="520">
                  <c:v>3.1011904761904763</c:v>
                </c:pt>
                <c:pt idx="521">
                  <c:v>3.1071428571428572</c:v>
                </c:pt>
                <c:pt idx="522">
                  <c:v>3.1130952380952381</c:v>
                </c:pt>
                <c:pt idx="523">
                  <c:v>3.1190476190476191</c:v>
                </c:pt>
                <c:pt idx="524">
                  <c:v>3.125</c:v>
                </c:pt>
                <c:pt idx="525">
                  <c:v>3.1309523809523809</c:v>
                </c:pt>
                <c:pt idx="526">
                  <c:v>3.1369047619047619</c:v>
                </c:pt>
                <c:pt idx="527">
                  <c:v>3.1428571428571428</c:v>
                </c:pt>
                <c:pt idx="528">
                  <c:v>3.1488095238095237</c:v>
                </c:pt>
                <c:pt idx="529">
                  <c:v>3.1547619047619047</c:v>
                </c:pt>
                <c:pt idx="530">
                  <c:v>3.1607142857142856</c:v>
                </c:pt>
                <c:pt idx="531">
                  <c:v>3.1666666666666665</c:v>
                </c:pt>
                <c:pt idx="532">
                  <c:v>3.1726190476190474</c:v>
                </c:pt>
                <c:pt idx="533">
                  <c:v>3.1785714285714284</c:v>
                </c:pt>
                <c:pt idx="534">
                  <c:v>3.1845238095238093</c:v>
                </c:pt>
                <c:pt idx="535">
                  <c:v>3.1904761904761907</c:v>
                </c:pt>
                <c:pt idx="536">
                  <c:v>3.1964285714285716</c:v>
                </c:pt>
                <c:pt idx="537">
                  <c:v>3.2023809523809526</c:v>
                </c:pt>
                <c:pt idx="538">
                  <c:v>3.2083333333333335</c:v>
                </c:pt>
                <c:pt idx="539">
                  <c:v>3.2142857142857144</c:v>
                </c:pt>
                <c:pt idx="540">
                  <c:v>3.2202380952380953</c:v>
                </c:pt>
                <c:pt idx="541">
                  <c:v>3.2261904761904763</c:v>
                </c:pt>
                <c:pt idx="542">
                  <c:v>3.2321428571428572</c:v>
                </c:pt>
                <c:pt idx="543">
                  <c:v>3.2380952380952381</c:v>
                </c:pt>
                <c:pt idx="544">
                  <c:v>3.2440476190476191</c:v>
                </c:pt>
                <c:pt idx="545">
                  <c:v>3.25</c:v>
                </c:pt>
                <c:pt idx="546">
                  <c:v>3.2559523809523809</c:v>
                </c:pt>
                <c:pt idx="547">
                  <c:v>3.2619047619047619</c:v>
                </c:pt>
                <c:pt idx="548">
                  <c:v>3.2678571428571428</c:v>
                </c:pt>
                <c:pt idx="549">
                  <c:v>3.2738095238095237</c:v>
                </c:pt>
                <c:pt idx="550">
                  <c:v>3.2797619047619047</c:v>
                </c:pt>
                <c:pt idx="551">
                  <c:v>3.2857142857142856</c:v>
                </c:pt>
                <c:pt idx="552">
                  <c:v>3.2916666666666665</c:v>
                </c:pt>
                <c:pt idx="553">
                  <c:v>3.2976190476190474</c:v>
                </c:pt>
                <c:pt idx="554">
                  <c:v>3.3035714285714284</c:v>
                </c:pt>
                <c:pt idx="555">
                  <c:v>3.3095238095238093</c:v>
                </c:pt>
                <c:pt idx="556">
                  <c:v>3.3154761904761907</c:v>
                </c:pt>
                <c:pt idx="557">
                  <c:v>3.3214285714285716</c:v>
                </c:pt>
                <c:pt idx="558">
                  <c:v>3.3273809523809526</c:v>
                </c:pt>
                <c:pt idx="559">
                  <c:v>3.3333333333333335</c:v>
                </c:pt>
                <c:pt idx="560">
                  <c:v>3.3392857142857144</c:v>
                </c:pt>
                <c:pt idx="561">
                  <c:v>3.3452380952380953</c:v>
                </c:pt>
                <c:pt idx="562">
                  <c:v>3.3511904761904763</c:v>
                </c:pt>
                <c:pt idx="563">
                  <c:v>3.3571428571428572</c:v>
                </c:pt>
                <c:pt idx="564">
                  <c:v>3.3630952380952381</c:v>
                </c:pt>
                <c:pt idx="565">
                  <c:v>3.3690476190476191</c:v>
                </c:pt>
                <c:pt idx="566">
                  <c:v>3.375</c:v>
                </c:pt>
                <c:pt idx="567">
                  <c:v>3.3809523809523809</c:v>
                </c:pt>
                <c:pt idx="568">
                  <c:v>3.3869047619047619</c:v>
                </c:pt>
                <c:pt idx="569">
                  <c:v>3.3928571428571428</c:v>
                </c:pt>
                <c:pt idx="570">
                  <c:v>3.3988095238095237</c:v>
                </c:pt>
                <c:pt idx="571">
                  <c:v>3.4047619047619047</c:v>
                </c:pt>
                <c:pt idx="572">
                  <c:v>3.4107142857142856</c:v>
                </c:pt>
                <c:pt idx="573">
                  <c:v>3.4166666666666665</c:v>
                </c:pt>
                <c:pt idx="574">
                  <c:v>3.4226190476190474</c:v>
                </c:pt>
                <c:pt idx="575">
                  <c:v>3.4285714285714284</c:v>
                </c:pt>
                <c:pt idx="576">
                  <c:v>3.4345238095238093</c:v>
                </c:pt>
                <c:pt idx="577">
                  <c:v>3.4404761904761907</c:v>
                </c:pt>
                <c:pt idx="578">
                  <c:v>3.4464285714285716</c:v>
                </c:pt>
                <c:pt idx="579">
                  <c:v>3.4523809523809526</c:v>
                </c:pt>
                <c:pt idx="580">
                  <c:v>3.4583333333333335</c:v>
                </c:pt>
                <c:pt idx="581">
                  <c:v>3.4642857142857144</c:v>
                </c:pt>
                <c:pt idx="582">
                  <c:v>3.4702380952380953</c:v>
                </c:pt>
                <c:pt idx="583">
                  <c:v>3.4761904761904763</c:v>
                </c:pt>
                <c:pt idx="584">
                  <c:v>3.4821428571428572</c:v>
                </c:pt>
                <c:pt idx="585">
                  <c:v>3.4880952380952381</c:v>
                </c:pt>
                <c:pt idx="586">
                  <c:v>3.4940476190476191</c:v>
                </c:pt>
                <c:pt idx="587">
                  <c:v>3.5</c:v>
                </c:pt>
                <c:pt idx="588">
                  <c:v>3.5059523809523809</c:v>
                </c:pt>
                <c:pt idx="589">
                  <c:v>3.5119047619047619</c:v>
                </c:pt>
                <c:pt idx="590">
                  <c:v>3.5178571428571428</c:v>
                </c:pt>
                <c:pt idx="591">
                  <c:v>3.5238095238095237</c:v>
                </c:pt>
                <c:pt idx="592">
                  <c:v>3.5297619047619047</c:v>
                </c:pt>
                <c:pt idx="593">
                  <c:v>3.5357142857142856</c:v>
                </c:pt>
                <c:pt idx="594">
                  <c:v>3.5416666666666665</c:v>
                </c:pt>
                <c:pt idx="595">
                  <c:v>3.5476190476190474</c:v>
                </c:pt>
                <c:pt idx="596">
                  <c:v>3.5535714285714284</c:v>
                </c:pt>
                <c:pt idx="597">
                  <c:v>3.5595238095238093</c:v>
                </c:pt>
                <c:pt idx="598">
                  <c:v>3.5654761904761907</c:v>
                </c:pt>
                <c:pt idx="599">
                  <c:v>3.5714285714285716</c:v>
                </c:pt>
                <c:pt idx="600">
                  <c:v>3.5773809523809526</c:v>
                </c:pt>
                <c:pt idx="601">
                  <c:v>3.5833333333333335</c:v>
                </c:pt>
                <c:pt idx="602">
                  <c:v>3.5892857142857144</c:v>
                </c:pt>
                <c:pt idx="603">
                  <c:v>3.5952380952380953</c:v>
                </c:pt>
                <c:pt idx="604">
                  <c:v>3.6011904761904763</c:v>
                </c:pt>
                <c:pt idx="605">
                  <c:v>3.6071428571428572</c:v>
                </c:pt>
                <c:pt idx="606">
                  <c:v>3.6130952380952381</c:v>
                </c:pt>
                <c:pt idx="607">
                  <c:v>3.6190476190476191</c:v>
                </c:pt>
                <c:pt idx="608">
                  <c:v>3.625</c:v>
                </c:pt>
                <c:pt idx="609">
                  <c:v>3.6309523809523809</c:v>
                </c:pt>
                <c:pt idx="610">
                  <c:v>3.6369047619047619</c:v>
                </c:pt>
                <c:pt idx="611">
                  <c:v>3.6428571428571428</c:v>
                </c:pt>
                <c:pt idx="612">
                  <c:v>3.6488095238095237</c:v>
                </c:pt>
                <c:pt idx="613">
                  <c:v>3.6547619047619047</c:v>
                </c:pt>
                <c:pt idx="614">
                  <c:v>3.6607142857142856</c:v>
                </c:pt>
                <c:pt idx="615">
                  <c:v>3.6666666666666665</c:v>
                </c:pt>
                <c:pt idx="616">
                  <c:v>3.6726190476190474</c:v>
                </c:pt>
                <c:pt idx="617">
                  <c:v>3.6785714285714284</c:v>
                </c:pt>
                <c:pt idx="618">
                  <c:v>3.6845238095238093</c:v>
                </c:pt>
                <c:pt idx="619">
                  <c:v>3.6904761904761907</c:v>
                </c:pt>
                <c:pt idx="620">
                  <c:v>3.6964285714285716</c:v>
                </c:pt>
                <c:pt idx="621">
                  <c:v>3.7023809523809526</c:v>
                </c:pt>
                <c:pt idx="622">
                  <c:v>3.7083333333333335</c:v>
                </c:pt>
                <c:pt idx="623">
                  <c:v>3.7142857142857144</c:v>
                </c:pt>
                <c:pt idx="624">
                  <c:v>3.7202380952380953</c:v>
                </c:pt>
                <c:pt idx="625">
                  <c:v>3.7261904761904763</c:v>
                </c:pt>
                <c:pt idx="626">
                  <c:v>3.7321428571428572</c:v>
                </c:pt>
                <c:pt idx="627">
                  <c:v>3.7380952380952381</c:v>
                </c:pt>
                <c:pt idx="628">
                  <c:v>3.7440476190476191</c:v>
                </c:pt>
                <c:pt idx="629">
                  <c:v>3.75</c:v>
                </c:pt>
                <c:pt idx="630">
                  <c:v>3.7559523809523809</c:v>
                </c:pt>
                <c:pt idx="631">
                  <c:v>3.7619047619047619</c:v>
                </c:pt>
                <c:pt idx="632">
                  <c:v>3.7678571428571428</c:v>
                </c:pt>
                <c:pt idx="633">
                  <c:v>3.7738095238095237</c:v>
                </c:pt>
                <c:pt idx="634">
                  <c:v>3.7797619047619047</c:v>
                </c:pt>
                <c:pt idx="635">
                  <c:v>3.7857142857142856</c:v>
                </c:pt>
                <c:pt idx="636">
                  <c:v>3.7916666666666665</c:v>
                </c:pt>
                <c:pt idx="637">
                  <c:v>3.7976190476190474</c:v>
                </c:pt>
                <c:pt idx="638">
                  <c:v>3.8035714285714284</c:v>
                </c:pt>
                <c:pt idx="639">
                  <c:v>3.8095238095238093</c:v>
                </c:pt>
                <c:pt idx="640">
                  <c:v>3.8154761904761907</c:v>
                </c:pt>
                <c:pt idx="641">
                  <c:v>3.8214285714285716</c:v>
                </c:pt>
                <c:pt idx="642">
                  <c:v>3.8273809523809526</c:v>
                </c:pt>
                <c:pt idx="643">
                  <c:v>3.8333333333333335</c:v>
                </c:pt>
                <c:pt idx="644">
                  <c:v>3.8392857142857144</c:v>
                </c:pt>
                <c:pt idx="645">
                  <c:v>3.8452380952380953</c:v>
                </c:pt>
                <c:pt idx="646">
                  <c:v>3.8511904761904763</c:v>
                </c:pt>
                <c:pt idx="647">
                  <c:v>3.8571428571428572</c:v>
                </c:pt>
                <c:pt idx="648">
                  <c:v>3.8630952380952381</c:v>
                </c:pt>
                <c:pt idx="649">
                  <c:v>3.8690476190476191</c:v>
                </c:pt>
                <c:pt idx="650">
                  <c:v>3.875</c:v>
                </c:pt>
                <c:pt idx="651">
                  <c:v>3.8809523809523809</c:v>
                </c:pt>
                <c:pt idx="652">
                  <c:v>3.8869047619047619</c:v>
                </c:pt>
                <c:pt idx="653">
                  <c:v>3.8928571428571428</c:v>
                </c:pt>
                <c:pt idx="654">
                  <c:v>3.8988095238095237</c:v>
                </c:pt>
                <c:pt idx="655">
                  <c:v>3.9047619047619047</c:v>
                </c:pt>
                <c:pt idx="656">
                  <c:v>3.9107142857142856</c:v>
                </c:pt>
                <c:pt idx="657">
                  <c:v>3.9166666666666665</c:v>
                </c:pt>
                <c:pt idx="658">
                  <c:v>3.9226190476190474</c:v>
                </c:pt>
                <c:pt idx="659">
                  <c:v>3.9285714285714284</c:v>
                </c:pt>
                <c:pt idx="660">
                  <c:v>3.9345238095238093</c:v>
                </c:pt>
                <c:pt idx="661">
                  <c:v>3.9404761904761907</c:v>
                </c:pt>
                <c:pt idx="662">
                  <c:v>3.9464285714285716</c:v>
                </c:pt>
                <c:pt idx="663">
                  <c:v>3.9523809523809526</c:v>
                </c:pt>
                <c:pt idx="664">
                  <c:v>3.9583333333333335</c:v>
                </c:pt>
                <c:pt idx="665">
                  <c:v>3.9642857142857144</c:v>
                </c:pt>
                <c:pt idx="666">
                  <c:v>3.9702380952380953</c:v>
                </c:pt>
                <c:pt idx="667">
                  <c:v>3.9761904761904763</c:v>
                </c:pt>
                <c:pt idx="668">
                  <c:v>3.9821428571428572</c:v>
                </c:pt>
                <c:pt idx="669">
                  <c:v>3.9880952380952381</c:v>
                </c:pt>
                <c:pt idx="670">
                  <c:v>3.9940476190476191</c:v>
                </c:pt>
                <c:pt idx="671">
                  <c:v>4</c:v>
                </c:pt>
                <c:pt idx="672">
                  <c:v>4.0059523809523814</c:v>
                </c:pt>
                <c:pt idx="673">
                  <c:v>4.0119047619047619</c:v>
                </c:pt>
                <c:pt idx="674">
                  <c:v>4.0178571428571432</c:v>
                </c:pt>
                <c:pt idx="675">
                  <c:v>4.0238095238095237</c:v>
                </c:pt>
                <c:pt idx="676">
                  <c:v>4.0297619047619051</c:v>
                </c:pt>
                <c:pt idx="677">
                  <c:v>4.0357142857142856</c:v>
                </c:pt>
                <c:pt idx="678">
                  <c:v>4.041666666666667</c:v>
                </c:pt>
                <c:pt idx="679">
                  <c:v>4.0476190476190474</c:v>
                </c:pt>
                <c:pt idx="680">
                  <c:v>4.0535714285714288</c:v>
                </c:pt>
                <c:pt idx="681">
                  <c:v>4.0595238095238093</c:v>
                </c:pt>
                <c:pt idx="682">
                  <c:v>4.0654761904761907</c:v>
                </c:pt>
                <c:pt idx="683">
                  <c:v>4.0714285714285712</c:v>
                </c:pt>
                <c:pt idx="684">
                  <c:v>4.0773809523809526</c:v>
                </c:pt>
                <c:pt idx="685">
                  <c:v>4.083333333333333</c:v>
                </c:pt>
                <c:pt idx="686">
                  <c:v>4.0892857142857144</c:v>
                </c:pt>
                <c:pt idx="687">
                  <c:v>4.0952380952380949</c:v>
                </c:pt>
                <c:pt idx="688">
                  <c:v>4.1011904761904763</c:v>
                </c:pt>
                <c:pt idx="689">
                  <c:v>4.1071428571428568</c:v>
                </c:pt>
                <c:pt idx="690">
                  <c:v>4.1130952380952381</c:v>
                </c:pt>
                <c:pt idx="691">
                  <c:v>4.1190476190476186</c:v>
                </c:pt>
                <c:pt idx="692">
                  <c:v>4.125</c:v>
                </c:pt>
                <c:pt idx="693">
                  <c:v>4.1309523809523814</c:v>
                </c:pt>
                <c:pt idx="694">
                  <c:v>4.1369047619047619</c:v>
                </c:pt>
                <c:pt idx="695">
                  <c:v>4.1428571428571432</c:v>
                </c:pt>
                <c:pt idx="696">
                  <c:v>4.1488095238095237</c:v>
                </c:pt>
                <c:pt idx="697">
                  <c:v>4.1547619047619051</c:v>
                </c:pt>
                <c:pt idx="698">
                  <c:v>4.1607142857142856</c:v>
                </c:pt>
                <c:pt idx="699">
                  <c:v>4.166666666666667</c:v>
                </c:pt>
                <c:pt idx="700">
                  <c:v>4.1726190476190474</c:v>
                </c:pt>
                <c:pt idx="701">
                  <c:v>4.1785714285714288</c:v>
                </c:pt>
                <c:pt idx="702">
                  <c:v>4.1845238095238093</c:v>
                </c:pt>
                <c:pt idx="703">
                  <c:v>4.1904761904761907</c:v>
                </c:pt>
                <c:pt idx="704">
                  <c:v>4.1964285714285712</c:v>
                </c:pt>
                <c:pt idx="705">
                  <c:v>4.2023809523809526</c:v>
                </c:pt>
                <c:pt idx="706">
                  <c:v>4.208333333333333</c:v>
                </c:pt>
                <c:pt idx="707">
                  <c:v>4.2142857142857144</c:v>
                </c:pt>
                <c:pt idx="708">
                  <c:v>4.2202380952380949</c:v>
                </c:pt>
                <c:pt idx="709">
                  <c:v>4.2261904761904763</c:v>
                </c:pt>
                <c:pt idx="710">
                  <c:v>4.2321428571428568</c:v>
                </c:pt>
                <c:pt idx="711">
                  <c:v>4.2380952380952381</c:v>
                </c:pt>
                <c:pt idx="712">
                  <c:v>4.2440476190476186</c:v>
                </c:pt>
                <c:pt idx="713">
                  <c:v>4.25</c:v>
                </c:pt>
                <c:pt idx="714">
                  <c:v>4.2559523809523814</c:v>
                </c:pt>
                <c:pt idx="715">
                  <c:v>4.2619047619047619</c:v>
                </c:pt>
                <c:pt idx="716">
                  <c:v>4.2678571428571432</c:v>
                </c:pt>
                <c:pt idx="717">
                  <c:v>4.2738095238095237</c:v>
                </c:pt>
                <c:pt idx="718">
                  <c:v>4.2797619047619051</c:v>
                </c:pt>
                <c:pt idx="719">
                  <c:v>4.2857142857142856</c:v>
                </c:pt>
                <c:pt idx="720">
                  <c:v>4.291666666666667</c:v>
                </c:pt>
                <c:pt idx="721">
                  <c:v>4.2976190476190474</c:v>
                </c:pt>
                <c:pt idx="722">
                  <c:v>4.3035714285714288</c:v>
                </c:pt>
                <c:pt idx="723">
                  <c:v>4.3095238095238093</c:v>
                </c:pt>
                <c:pt idx="724">
                  <c:v>4.3154761904761907</c:v>
                </c:pt>
                <c:pt idx="725">
                  <c:v>4.3214285714285712</c:v>
                </c:pt>
                <c:pt idx="726">
                  <c:v>4.3273809523809526</c:v>
                </c:pt>
                <c:pt idx="727">
                  <c:v>4.333333333333333</c:v>
                </c:pt>
                <c:pt idx="728">
                  <c:v>4.3392857142857144</c:v>
                </c:pt>
                <c:pt idx="729">
                  <c:v>4.3452380952380949</c:v>
                </c:pt>
                <c:pt idx="730">
                  <c:v>4.3511904761904763</c:v>
                </c:pt>
                <c:pt idx="731">
                  <c:v>4.3571428571428568</c:v>
                </c:pt>
                <c:pt idx="732">
                  <c:v>4.3630952380952381</c:v>
                </c:pt>
                <c:pt idx="733">
                  <c:v>4.3690476190476186</c:v>
                </c:pt>
                <c:pt idx="734">
                  <c:v>4.375</c:v>
                </c:pt>
                <c:pt idx="735">
                  <c:v>4.3809523809523814</c:v>
                </c:pt>
                <c:pt idx="736">
                  <c:v>4.3869047619047619</c:v>
                </c:pt>
                <c:pt idx="737">
                  <c:v>4.3928571428571432</c:v>
                </c:pt>
                <c:pt idx="738">
                  <c:v>4.3988095238095237</c:v>
                </c:pt>
                <c:pt idx="739">
                  <c:v>4.4047619047619051</c:v>
                </c:pt>
                <c:pt idx="740">
                  <c:v>4.4107142857142856</c:v>
                </c:pt>
                <c:pt idx="741">
                  <c:v>4.416666666666667</c:v>
                </c:pt>
                <c:pt idx="742">
                  <c:v>4.4226190476190474</c:v>
                </c:pt>
                <c:pt idx="743">
                  <c:v>4.4285714285714288</c:v>
                </c:pt>
                <c:pt idx="744">
                  <c:v>4.4345238095238093</c:v>
                </c:pt>
                <c:pt idx="745">
                  <c:v>4.4404761904761907</c:v>
                </c:pt>
                <c:pt idx="746">
                  <c:v>4.4464285714285712</c:v>
                </c:pt>
                <c:pt idx="747">
                  <c:v>4.4523809523809526</c:v>
                </c:pt>
                <c:pt idx="748">
                  <c:v>4.458333333333333</c:v>
                </c:pt>
                <c:pt idx="749">
                  <c:v>4.4642857142857144</c:v>
                </c:pt>
                <c:pt idx="750">
                  <c:v>4.4702380952380949</c:v>
                </c:pt>
                <c:pt idx="751">
                  <c:v>4.4761904761904763</c:v>
                </c:pt>
                <c:pt idx="752">
                  <c:v>4.4821428571428568</c:v>
                </c:pt>
                <c:pt idx="753">
                  <c:v>4.4880952380952381</c:v>
                </c:pt>
                <c:pt idx="754">
                  <c:v>4.4940476190476186</c:v>
                </c:pt>
                <c:pt idx="755">
                  <c:v>4.5</c:v>
                </c:pt>
                <c:pt idx="756">
                  <c:v>4.5059523809523814</c:v>
                </c:pt>
                <c:pt idx="757">
                  <c:v>4.5119047619047619</c:v>
                </c:pt>
                <c:pt idx="758">
                  <c:v>4.5178571428571432</c:v>
                </c:pt>
                <c:pt idx="759">
                  <c:v>4.5238095238095237</c:v>
                </c:pt>
                <c:pt idx="760">
                  <c:v>4.5297619047619051</c:v>
                </c:pt>
                <c:pt idx="761">
                  <c:v>4.5357142857142856</c:v>
                </c:pt>
                <c:pt idx="762">
                  <c:v>4.541666666666667</c:v>
                </c:pt>
                <c:pt idx="763">
                  <c:v>4.5476190476190474</c:v>
                </c:pt>
                <c:pt idx="764">
                  <c:v>4.5535714285714288</c:v>
                </c:pt>
                <c:pt idx="765">
                  <c:v>4.5595238095238093</c:v>
                </c:pt>
                <c:pt idx="766">
                  <c:v>4.5654761904761907</c:v>
                </c:pt>
                <c:pt idx="767">
                  <c:v>4.5714285714285712</c:v>
                </c:pt>
                <c:pt idx="768">
                  <c:v>4.5773809523809526</c:v>
                </c:pt>
                <c:pt idx="769">
                  <c:v>4.583333333333333</c:v>
                </c:pt>
                <c:pt idx="770">
                  <c:v>4.5892857142857144</c:v>
                </c:pt>
                <c:pt idx="771">
                  <c:v>4.5952380952380949</c:v>
                </c:pt>
                <c:pt idx="772">
                  <c:v>4.6011904761904763</c:v>
                </c:pt>
                <c:pt idx="773">
                  <c:v>4.6071428571428568</c:v>
                </c:pt>
                <c:pt idx="774">
                  <c:v>4.6130952380952381</c:v>
                </c:pt>
                <c:pt idx="775">
                  <c:v>4.6190476190476186</c:v>
                </c:pt>
                <c:pt idx="776">
                  <c:v>4.625</c:v>
                </c:pt>
                <c:pt idx="777">
                  <c:v>4.6309523809523814</c:v>
                </c:pt>
                <c:pt idx="778">
                  <c:v>4.6369047619047619</c:v>
                </c:pt>
                <c:pt idx="779">
                  <c:v>4.6428571428571432</c:v>
                </c:pt>
                <c:pt idx="780">
                  <c:v>4.6488095238095237</c:v>
                </c:pt>
                <c:pt idx="781">
                  <c:v>4.6547619047619051</c:v>
                </c:pt>
                <c:pt idx="782">
                  <c:v>4.6607142857142856</c:v>
                </c:pt>
                <c:pt idx="783">
                  <c:v>4.666666666666667</c:v>
                </c:pt>
                <c:pt idx="784">
                  <c:v>4.6726190476190474</c:v>
                </c:pt>
                <c:pt idx="785">
                  <c:v>4.6785714285714288</c:v>
                </c:pt>
                <c:pt idx="786">
                  <c:v>4.6845238095238093</c:v>
                </c:pt>
                <c:pt idx="787">
                  <c:v>4.6904761904761907</c:v>
                </c:pt>
                <c:pt idx="788">
                  <c:v>4.6964285714285712</c:v>
                </c:pt>
                <c:pt idx="789">
                  <c:v>4.7023809523809526</c:v>
                </c:pt>
                <c:pt idx="790">
                  <c:v>4.708333333333333</c:v>
                </c:pt>
                <c:pt idx="791">
                  <c:v>4.7142857142857144</c:v>
                </c:pt>
                <c:pt idx="792">
                  <c:v>4.7202380952380949</c:v>
                </c:pt>
                <c:pt idx="793">
                  <c:v>4.7261904761904763</c:v>
                </c:pt>
                <c:pt idx="794">
                  <c:v>4.7321428571428568</c:v>
                </c:pt>
                <c:pt idx="795">
                  <c:v>4.7380952380952381</c:v>
                </c:pt>
                <c:pt idx="796">
                  <c:v>4.7440476190476186</c:v>
                </c:pt>
                <c:pt idx="797">
                  <c:v>4.75</c:v>
                </c:pt>
                <c:pt idx="798">
                  <c:v>4.7559523809523814</c:v>
                </c:pt>
                <c:pt idx="799">
                  <c:v>4.7619047619047619</c:v>
                </c:pt>
                <c:pt idx="800">
                  <c:v>4.7678571428571432</c:v>
                </c:pt>
                <c:pt idx="801">
                  <c:v>4.7738095238095237</c:v>
                </c:pt>
                <c:pt idx="802">
                  <c:v>4.7797619047619051</c:v>
                </c:pt>
                <c:pt idx="803">
                  <c:v>4.7857142857142856</c:v>
                </c:pt>
                <c:pt idx="804">
                  <c:v>4.791666666666667</c:v>
                </c:pt>
                <c:pt idx="805">
                  <c:v>4.7976190476190474</c:v>
                </c:pt>
                <c:pt idx="806">
                  <c:v>4.8035714285714288</c:v>
                </c:pt>
                <c:pt idx="807">
                  <c:v>4.8095238095238093</c:v>
                </c:pt>
                <c:pt idx="808">
                  <c:v>4.8154761904761907</c:v>
                </c:pt>
                <c:pt idx="809">
                  <c:v>4.8214285714285712</c:v>
                </c:pt>
                <c:pt idx="810">
                  <c:v>4.8273809523809526</c:v>
                </c:pt>
                <c:pt idx="811">
                  <c:v>4.833333333333333</c:v>
                </c:pt>
                <c:pt idx="812">
                  <c:v>4.8392857142857144</c:v>
                </c:pt>
                <c:pt idx="813">
                  <c:v>4.8452380952380949</c:v>
                </c:pt>
                <c:pt idx="814">
                  <c:v>4.8511904761904763</c:v>
                </c:pt>
                <c:pt idx="815">
                  <c:v>4.8571428571428568</c:v>
                </c:pt>
                <c:pt idx="816">
                  <c:v>4.8630952380952381</c:v>
                </c:pt>
                <c:pt idx="817">
                  <c:v>4.8690476190476186</c:v>
                </c:pt>
                <c:pt idx="818">
                  <c:v>4.875</c:v>
                </c:pt>
                <c:pt idx="819">
                  <c:v>4.8809523809523814</c:v>
                </c:pt>
                <c:pt idx="820">
                  <c:v>4.8869047619047619</c:v>
                </c:pt>
                <c:pt idx="821">
                  <c:v>4.8928571428571432</c:v>
                </c:pt>
                <c:pt idx="822">
                  <c:v>4.8988095238095237</c:v>
                </c:pt>
                <c:pt idx="823">
                  <c:v>4.9047619047619051</c:v>
                </c:pt>
                <c:pt idx="824">
                  <c:v>4.9107142857142856</c:v>
                </c:pt>
                <c:pt idx="825">
                  <c:v>4.916666666666667</c:v>
                </c:pt>
                <c:pt idx="826">
                  <c:v>4.9226190476190474</c:v>
                </c:pt>
                <c:pt idx="827">
                  <c:v>4.9285714285714288</c:v>
                </c:pt>
                <c:pt idx="828">
                  <c:v>4.9345238095238093</c:v>
                </c:pt>
                <c:pt idx="829">
                  <c:v>4.9404761904761907</c:v>
                </c:pt>
                <c:pt idx="830">
                  <c:v>4.9464285714285712</c:v>
                </c:pt>
                <c:pt idx="831">
                  <c:v>4.9523809523809526</c:v>
                </c:pt>
                <c:pt idx="832">
                  <c:v>4.958333333333333</c:v>
                </c:pt>
                <c:pt idx="833">
                  <c:v>4.9642857142857144</c:v>
                </c:pt>
                <c:pt idx="834">
                  <c:v>4.9702380952380949</c:v>
                </c:pt>
                <c:pt idx="835">
                  <c:v>4.9761904761904763</c:v>
                </c:pt>
                <c:pt idx="836">
                  <c:v>4.9821428571428568</c:v>
                </c:pt>
                <c:pt idx="837">
                  <c:v>4.9880952380952381</c:v>
                </c:pt>
                <c:pt idx="838">
                  <c:v>4.9940476190476186</c:v>
                </c:pt>
                <c:pt idx="839">
                  <c:v>5</c:v>
                </c:pt>
                <c:pt idx="840">
                  <c:v>5.0059523809523814</c:v>
                </c:pt>
                <c:pt idx="841">
                  <c:v>5.0119047619047619</c:v>
                </c:pt>
                <c:pt idx="842">
                  <c:v>5.0178571428571432</c:v>
                </c:pt>
                <c:pt idx="843">
                  <c:v>5.0238095238095237</c:v>
                </c:pt>
                <c:pt idx="844">
                  <c:v>5.0297619047619051</c:v>
                </c:pt>
                <c:pt idx="845">
                  <c:v>5.0357142857142856</c:v>
                </c:pt>
                <c:pt idx="846">
                  <c:v>5.041666666666667</c:v>
                </c:pt>
                <c:pt idx="847">
                  <c:v>5.0476190476190474</c:v>
                </c:pt>
                <c:pt idx="848">
                  <c:v>5.0535714285714288</c:v>
                </c:pt>
                <c:pt idx="849">
                  <c:v>5.0595238095238093</c:v>
                </c:pt>
                <c:pt idx="850">
                  <c:v>5.0654761904761907</c:v>
                </c:pt>
                <c:pt idx="851">
                  <c:v>5.0714285714285712</c:v>
                </c:pt>
                <c:pt idx="852">
                  <c:v>5.0773809523809526</c:v>
                </c:pt>
                <c:pt idx="853">
                  <c:v>5.083333333333333</c:v>
                </c:pt>
                <c:pt idx="854">
                  <c:v>5.0892857142857144</c:v>
                </c:pt>
                <c:pt idx="855">
                  <c:v>5.0952380952380949</c:v>
                </c:pt>
                <c:pt idx="856">
                  <c:v>5.1011904761904763</c:v>
                </c:pt>
                <c:pt idx="857">
                  <c:v>5.1071428571428568</c:v>
                </c:pt>
                <c:pt idx="858">
                  <c:v>5.1130952380952381</c:v>
                </c:pt>
                <c:pt idx="859">
                  <c:v>5.1190476190476186</c:v>
                </c:pt>
                <c:pt idx="860">
                  <c:v>5.125</c:v>
                </c:pt>
                <c:pt idx="861">
                  <c:v>5.1309523809523814</c:v>
                </c:pt>
                <c:pt idx="862">
                  <c:v>5.1369047619047619</c:v>
                </c:pt>
                <c:pt idx="863">
                  <c:v>5.1428571428571432</c:v>
                </c:pt>
                <c:pt idx="864">
                  <c:v>5.1488095238095237</c:v>
                </c:pt>
                <c:pt idx="865">
                  <c:v>5.1547619047619051</c:v>
                </c:pt>
                <c:pt idx="866">
                  <c:v>5.1607142857142856</c:v>
                </c:pt>
                <c:pt idx="867">
                  <c:v>5.166666666666667</c:v>
                </c:pt>
                <c:pt idx="868">
                  <c:v>5.1726190476190474</c:v>
                </c:pt>
                <c:pt idx="869">
                  <c:v>5.1785714285714288</c:v>
                </c:pt>
                <c:pt idx="870">
                  <c:v>5.1845238095238093</c:v>
                </c:pt>
                <c:pt idx="871">
                  <c:v>5.1904761904761907</c:v>
                </c:pt>
                <c:pt idx="872">
                  <c:v>5.1964285714285712</c:v>
                </c:pt>
                <c:pt idx="873">
                  <c:v>5.2023809523809526</c:v>
                </c:pt>
                <c:pt idx="874">
                  <c:v>5.208333333333333</c:v>
                </c:pt>
                <c:pt idx="875">
                  <c:v>5.2142857142857144</c:v>
                </c:pt>
                <c:pt idx="876">
                  <c:v>5.2202380952380949</c:v>
                </c:pt>
                <c:pt idx="877">
                  <c:v>5.2261904761904763</c:v>
                </c:pt>
                <c:pt idx="878">
                  <c:v>5.2321428571428568</c:v>
                </c:pt>
                <c:pt idx="879">
                  <c:v>5.2380952380952381</c:v>
                </c:pt>
                <c:pt idx="880">
                  <c:v>5.2440476190476186</c:v>
                </c:pt>
                <c:pt idx="881">
                  <c:v>5.25</c:v>
                </c:pt>
                <c:pt idx="882">
                  <c:v>5.2559523809523814</c:v>
                </c:pt>
                <c:pt idx="883">
                  <c:v>5.2619047619047619</c:v>
                </c:pt>
                <c:pt idx="884">
                  <c:v>5.2678571428571432</c:v>
                </c:pt>
                <c:pt idx="885">
                  <c:v>5.2738095238095237</c:v>
                </c:pt>
                <c:pt idx="886">
                  <c:v>5.2797619047619051</c:v>
                </c:pt>
                <c:pt idx="887">
                  <c:v>5.2857142857142856</c:v>
                </c:pt>
                <c:pt idx="888">
                  <c:v>5.291666666666667</c:v>
                </c:pt>
                <c:pt idx="889">
                  <c:v>5.2976190476190474</c:v>
                </c:pt>
                <c:pt idx="890">
                  <c:v>5.3035714285714288</c:v>
                </c:pt>
                <c:pt idx="891">
                  <c:v>5.3095238095238093</c:v>
                </c:pt>
                <c:pt idx="892">
                  <c:v>5.3154761904761907</c:v>
                </c:pt>
                <c:pt idx="893">
                  <c:v>5.3214285714285712</c:v>
                </c:pt>
                <c:pt idx="894">
                  <c:v>5.3273809523809526</c:v>
                </c:pt>
                <c:pt idx="895">
                  <c:v>5.333333333333333</c:v>
                </c:pt>
                <c:pt idx="896">
                  <c:v>5.3392857142857144</c:v>
                </c:pt>
                <c:pt idx="897">
                  <c:v>5.3452380952380949</c:v>
                </c:pt>
                <c:pt idx="898">
                  <c:v>5.3511904761904763</c:v>
                </c:pt>
                <c:pt idx="899">
                  <c:v>5.3571428571428568</c:v>
                </c:pt>
                <c:pt idx="900">
                  <c:v>5.3630952380952381</c:v>
                </c:pt>
                <c:pt idx="901">
                  <c:v>5.3690476190476186</c:v>
                </c:pt>
                <c:pt idx="902">
                  <c:v>5.375</c:v>
                </c:pt>
                <c:pt idx="903">
                  <c:v>5.3809523809523814</c:v>
                </c:pt>
                <c:pt idx="904">
                  <c:v>5.3869047619047619</c:v>
                </c:pt>
                <c:pt idx="905">
                  <c:v>5.3928571428571432</c:v>
                </c:pt>
                <c:pt idx="906">
                  <c:v>5.3988095238095237</c:v>
                </c:pt>
                <c:pt idx="907">
                  <c:v>5.4047619047619051</c:v>
                </c:pt>
                <c:pt idx="908">
                  <c:v>5.4107142857142856</c:v>
                </c:pt>
                <c:pt idx="909">
                  <c:v>5.416666666666667</c:v>
                </c:pt>
                <c:pt idx="910">
                  <c:v>5.4226190476190474</c:v>
                </c:pt>
                <c:pt idx="911">
                  <c:v>5.4285714285714288</c:v>
                </c:pt>
                <c:pt idx="912">
                  <c:v>5.4345238095238093</c:v>
                </c:pt>
                <c:pt idx="913">
                  <c:v>5.4404761904761907</c:v>
                </c:pt>
                <c:pt idx="914">
                  <c:v>5.4464285714285712</c:v>
                </c:pt>
                <c:pt idx="915">
                  <c:v>5.4523809523809526</c:v>
                </c:pt>
                <c:pt idx="916">
                  <c:v>5.458333333333333</c:v>
                </c:pt>
                <c:pt idx="917">
                  <c:v>5.4642857142857144</c:v>
                </c:pt>
                <c:pt idx="918">
                  <c:v>5.4702380952380949</c:v>
                </c:pt>
                <c:pt idx="919">
                  <c:v>5.4761904761904763</c:v>
                </c:pt>
                <c:pt idx="920">
                  <c:v>5.4821428571428568</c:v>
                </c:pt>
                <c:pt idx="921">
                  <c:v>5.4880952380952381</c:v>
                </c:pt>
                <c:pt idx="922">
                  <c:v>5.4940476190476186</c:v>
                </c:pt>
                <c:pt idx="923">
                  <c:v>5.5</c:v>
                </c:pt>
                <c:pt idx="924">
                  <c:v>5.5059523809523814</c:v>
                </c:pt>
                <c:pt idx="925">
                  <c:v>5.5119047619047619</c:v>
                </c:pt>
                <c:pt idx="926">
                  <c:v>5.5178571428571432</c:v>
                </c:pt>
                <c:pt idx="927">
                  <c:v>5.5238095238095237</c:v>
                </c:pt>
                <c:pt idx="928">
                  <c:v>5.5297619047619051</c:v>
                </c:pt>
                <c:pt idx="929">
                  <c:v>5.5357142857142856</c:v>
                </c:pt>
                <c:pt idx="930">
                  <c:v>5.541666666666667</c:v>
                </c:pt>
                <c:pt idx="931">
                  <c:v>5.5476190476190474</c:v>
                </c:pt>
                <c:pt idx="932">
                  <c:v>5.5535714285714288</c:v>
                </c:pt>
                <c:pt idx="933">
                  <c:v>5.5595238095238093</c:v>
                </c:pt>
                <c:pt idx="934">
                  <c:v>5.5654761904761907</c:v>
                </c:pt>
                <c:pt idx="935">
                  <c:v>5.5714285714285712</c:v>
                </c:pt>
                <c:pt idx="936">
                  <c:v>5.5773809523809526</c:v>
                </c:pt>
                <c:pt idx="937">
                  <c:v>5.583333333333333</c:v>
                </c:pt>
                <c:pt idx="938">
                  <c:v>5.5892857142857144</c:v>
                </c:pt>
                <c:pt idx="939">
                  <c:v>5.5952380952380949</c:v>
                </c:pt>
                <c:pt idx="940">
                  <c:v>5.6011904761904763</c:v>
                </c:pt>
                <c:pt idx="941">
                  <c:v>5.6071428571428568</c:v>
                </c:pt>
                <c:pt idx="942">
                  <c:v>5.6130952380952381</c:v>
                </c:pt>
                <c:pt idx="943">
                  <c:v>5.6190476190476186</c:v>
                </c:pt>
                <c:pt idx="944">
                  <c:v>5.625</c:v>
                </c:pt>
                <c:pt idx="945">
                  <c:v>5.6309523809523814</c:v>
                </c:pt>
                <c:pt idx="946">
                  <c:v>5.6369047619047619</c:v>
                </c:pt>
                <c:pt idx="947">
                  <c:v>5.6428571428571432</c:v>
                </c:pt>
                <c:pt idx="948">
                  <c:v>5.6488095238095237</c:v>
                </c:pt>
                <c:pt idx="949">
                  <c:v>5.6547619047619051</c:v>
                </c:pt>
                <c:pt idx="950">
                  <c:v>5.6607142857142856</c:v>
                </c:pt>
                <c:pt idx="951">
                  <c:v>5.666666666666667</c:v>
                </c:pt>
                <c:pt idx="952">
                  <c:v>5.6726190476190474</c:v>
                </c:pt>
                <c:pt idx="953">
                  <c:v>5.6785714285714288</c:v>
                </c:pt>
                <c:pt idx="954">
                  <c:v>5.6845238095238093</c:v>
                </c:pt>
                <c:pt idx="955">
                  <c:v>5.6904761904761907</c:v>
                </c:pt>
                <c:pt idx="956">
                  <c:v>5.6964285714285712</c:v>
                </c:pt>
                <c:pt idx="957">
                  <c:v>5.7023809523809526</c:v>
                </c:pt>
                <c:pt idx="958">
                  <c:v>5.708333333333333</c:v>
                </c:pt>
                <c:pt idx="959">
                  <c:v>5.7142857142857144</c:v>
                </c:pt>
                <c:pt idx="960">
                  <c:v>5.7202380952380949</c:v>
                </c:pt>
                <c:pt idx="961">
                  <c:v>5.7261904761904763</c:v>
                </c:pt>
                <c:pt idx="962">
                  <c:v>5.7321428571428568</c:v>
                </c:pt>
                <c:pt idx="963">
                  <c:v>5.7380952380952381</c:v>
                </c:pt>
                <c:pt idx="964">
                  <c:v>5.7440476190476186</c:v>
                </c:pt>
                <c:pt idx="965">
                  <c:v>5.75</c:v>
                </c:pt>
                <c:pt idx="966">
                  <c:v>5.7559523809523814</c:v>
                </c:pt>
                <c:pt idx="967">
                  <c:v>5.7619047619047619</c:v>
                </c:pt>
                <c:pt idx="968">
                  <c:v>5.7678571428571432</c:v>
                </c:pt>
                <c:pt idx="969">
                  <c:v>5.7738095238095237</c:v>
                </c:pt>
                <c:pt idx="970">
                  <c:v>5.7797619047619051</c:v>
                </c:pt>
                <c:pt idx="971">
                  <c:v>5.7857142857142856</c:v>
                </c:pt>
                <c:pt idx="972">
                  <c:v>5.791666666666667</c:v>
                </c:pt>
                <c:pt idx="973">
                  <c:v>5.7976190476190474</c:v>
                </c:pt>
                <c:pt idx="974">
                  <c:v>5.8035714285714288</c:v>
                </c:pt>
                <c:pt idx="975">
                  <c:v>5.8095238095238093</c:v>
                </c:pt>
                <c:pt idx="976">
                  <c:v>5.8154761904761907</c:v>
                </c:pt>
                <c:pt idx="977">
                  <c:v>5.8214285714285712</c:v>
                </c:pt>
                <c:pt idx="978">
                  <c:v>5.8273809523809526</c:v>
                </c:pt>
                <c:pt idx="979">
                  <c:v>5.833333333333333</c:v>
                </c:pt>
                <c:pt idx="980">
                  <c:v>5.8392857142857144</c:v>
                </c:pt>
                <c:pt idx="981">
                  <c:v>5.8452380952380949</c:v>
                </c:pt>
                <c:pt idx="982">
                  <c:v>5.8511904761904763</c:v>
                </c:pt>
                <c:pt idx="983">
                  <c:v>5.8571428571428568</c:v>
                </c:pt>
                <c:pt idx="984">
                  <c:v>5.8630952380952381</c:v>
                </c:pt>
                <c:pt idx="985">
                  <c:v>5.8690476190476186</c:v>
                </c:pt>
                <c:pt idx="986">
                  <c:v>5.875</c:v>
                </c:pt>
                <c:pt idx="987">
                  <c:v>5.8809523809523814</c:v>
                </c:pt>
                <c:pt idx="988">
                  <c:v>5.8869047619047619</c:v>
                </c:pt>
                <c:pt idx="989">
                  <c:v>5.8928571428571432</c:v>
                </c:pt>
                <c:pt idx="990">
                  <c:v>5.8988095238095237</c:v>
                </c:pt>
                <c:pt idx="991">
                  <c:v>5.9047619047619051</c:v>
                </c:pt>
                <c:pt idx="992">
                  <c:v>5.9107142857142856</c:v>
                </c:pt>
                <c:pt idx="993">
                  <c:v>5.916666666666667</c:v>
                </c:pt>
                <c:pt idx="994">
                  <c:v>5.9226190476190474</c:v>
                </c:pt>
                <c:pt idx="995">
                  <c:v>5.9285714285714288</c:v>
                </c:pt>
                <c:pt idx="996">
                  <c:v>5.9345238095238093</c:v>
                </c:pt>
                <c:pt idx="997">
                  <c:v>5.9404761904761907</c:v>
                </c:pt>
                <c:pt idx="998">
                  <c:v>5.9464285714285712</c:v>
                </c:pt>
                <c:pt idx="999">
                  <c:v>5.9523809523809526</c:v>
                </c:pt>
                <c:pt idx="1000">
                  <c:v>5.958333333333333</c:v>
                </c:pt>
                <c:pt idx="1001">
                  <c:v>5.9642857142857144</c:v>
                </c:pt>
                <c:pt idx="1002">
                  <c:v>5.9702380952380949</c:v>
                </c:pt>
                <c:pt idx="1003">
                  <c:v>5.9761904761904763</c:v>
                </c:pt>
                <c:pt idx="1004">
                  <c:v>5.9821428571428568</c:v>
                </c:pt>
                <c:pt idx="1005">
                  <c:v>5.9880952380952381</c:v>
                </c:pt>
                <c:pt idx="1006">
                  <c:v>5.9940476190476186</c:v>
                </c:pt>
                <c:pt idx="1007">
                  <c:v>6</c:v>
                </c:pt>
                <c:pt idx="1008">
                  <c:v>6.0059523809523814</c:v>
                </c:pt>
                <c:pt idx="1009">
                  <c:v>6.0119047619047619</c:v>
                </c:pt>
                <c:pt idx="1010">
                  <c:v>6.0178571428571432</c:v>
                </c:pt>
                <c:pt idx="1011">
                  <c:v>6.0238095238095237</c:v>
                </c:pt>
                <c:pt idx="1012">
                  <c:v>6.0297619047619051</c:v>
                </c:pt>
                <c:pt idx="1013">
                  <c:v>6.0357142857142856</c:v>
                </c:pt>
                <c:pt idx="1014">
                  <c:v>6.041666666666667</c:v>
                </c:pt>
                <c:pt idx="1015">
                  <c:v>6.0476190476190474</c:v>
                </c:pt>
                <c:pt idx="1016">
                  <c:v>6.0535714285714288</c:v>
                </c:pt>
                <c:pt idx="1017">
                  <c:v>6.0595238095238093</c:v>
                </c:pt>
                <c:pt idx="1018">
                  <c:v>6.0654761904761907</c:v>
                </c:pt>
                <c:pt idx="1019">
                  <c:v>6.0714285714285712</c:v>
                </c:pt>
                <c:pt idx="1020">
                  <c:v>6.0773809523809526</c:v>
                </c:pt>
                <c:pt idx="1021">
                  <c:v>6.083333333333333</c:v>
                </c:pt>
                <c:pt idx="1022">
                  <c:v>6.0892857142857144</c:v>
                </c:pt>
                <c:pt idx="1023">
                  <c:v>6.0952380952380949</c:v>
                </c:pt>
                <c:pt idx="1024">
                  <c:v>6.1011904761904763</c:v>
                </c:pt>
                <c:pt idx="1025">
                  <c:v>6.1071428571428568</c:v>
                </c:pt>
                <c:pt idx="1026">
                  <c:v>6.1130952380952381</c:v>
                </c:pt>
                <c:pt idx="1027">
                  <c:v>6.1190476190476186</c:v>
                </c:pt>
                <c:pt idx="1028">
                  <c:v>6.125</c:v>
                </c:pt>
                <c:pt idx="1029">
                  <c:v>6.1309523809523814</c:v>
                </c:pt>
                <c:pt idx="1030">
                  <c:v>6.1369047619047619</c:v>
                </c:pt>
                <c:pt idx="1031">
                  <c:v>6.1428571428571432</c:v>
                </c:pt>
                <c:pt idx="1032">
                  <c:v>6.1488095238095237</c:v>
                </c:pt>
                <c:pt idx="1033">
                  <c:v>6.1547619047619051</c:v>
                </c:pt>
                <c:pt idx="1034">
                  <c:v>6.1607142857142856</c:v>
                </c:pt>
                <c:pt idx="1035">
                  <c:v>6.166666666666667</c:v>
                </c:pt>
                <c:pt idx="1036">
                  <c:v>6.1726190476190474</c:v>
                </c:pt>
                <c:pt idx="1037">
                  <c:v>6.1785714285714288</c:v>
                </c:pt>
                <c:pt idx="1038">
                  <c:v>6.1845238095238093</c:v>
                </c:pt>
                <c:pt idx="1039">
                  <c:v>6.1904761904761907</c:v>
                </c:pt>
                <c:pt idx="1040">
                  <c:v>6.1964285714285712</c:v>
                </c:pt>
                <c:pt idx="1041">
                  <c:v>6.2023809523809526</c:v>
                </c:pt>
                <c:pt idx="1042">
                  <c:v>6.208333333333333</c:v>
                </c:pt>
                <c:pt idx="1043">
                  <c:v>6.2142857142857144</c:v>
                </c:pt>
                <c:pt idx="1044">
                  <c:v>6.2202380952380949</c:v>
                </c:pt>
                <c:pt idx="1045">
                  <c:v>6.2261904761904763</c:v>
                </c:pt>
                <c:pt idx="1046">
                  <c:v>6.2321428571428568</c:v>
                </c:pt>
                <c:pt idx="1047">
                  <c:v>6.2380952380952381</c:v>
                </c:pt>
                <c:pt idx="1048">
                  <c:v>6.2440476190476186</c:v>
                </c:pt>
                <c:pt idx="1049">
                  <c:v>6.25</c:v>
                </c:pt>
                <c:pt idx="1050">
                  <c:v>6.2559523809523814</c:v>
                </c:pt>
                <c:pt idx="1051">
                  <c:v>6.2619047619047619</c:v>
                </c:pt>
                <c:pt idx="1052">
                  <c:v>6.2678571428571432</c:v>
                </c:pt>
                <c:pt idx="1053">
                  <c:v>6.2738095238095237</c:v>
                </c:pt>
                <c:pt idx="1054">
                  <c:v>6.2797619047619051</c:v>
                </c:pt>
                <c:pt idx="1055">
                  <c:v>6.2857142857142856</c:v>
                </c:pt>
                <c:pt idx="1056">
                  <c:v>6.291666666666667</c:v>
                </c:pt>
                <c:pt idx="1057">
                  <c:v>6.2976190476190474</c:v>
                </c:pt>
                <c:pt idx="1058">
                  <c:v>6.3035714285714288</c:v>
                </c:pt>
                <c:pt idx="1059">
                  <c:v>6.3095238095238093</c:v>
                </c:pt>
                <c:pt idx="1060">
                  <c:v>6.3154761904761907</c:v>
                </c:pt>
                <c:pt idx="1061">
                  <c:v>6.3214285714285712</c:v>
                </c:pt>
                <c:pt idx="1062">
                  <c:v>6.3273809523809526</c:v>
                </c:pt>
                <c:pt idx="1063">
                  <c:v>6.333333333333333</c:v>
                </c:pt>
                <c:pt idx="1064">
                  <c:v>6.3392857142857144</c:v>
                </c:pt>
                <c:pt idx="1065">
                  <c:v>6.3452380952380949</c:v>
                </c:pt>
                <c:pt idx="1066">
                  <c:v>6.3511904761904763</c:v>
                </c:pt>
                <c:pt idx="1067">
                  <c:v>6.3571428571428568</c:v>
                </c:pt>
                <c:pt idx="1068">
                  <c:v>6.3630952380952381</c:v>
                </c:pt>
                <c:pt idx="1069">
                  <c:v>6.3690476190476186</c:v>
                </c:pt>
                <c:pt idx="1070">
                  <c:v>6.375</c:v>
                </c:pt>
                <c:pt idx="1071">
                  <c:v>6.3809523809523814</c:v>
                </c:pt>
                <c:pt idx="1072">
                  <c:v>6.3869047619047619</c:v>
                </c:pt>
                <c:pt idx="1073">
                  <c:v>6.3928571428571432</c:v>
                </c:pt>
                <c:pt idx="1074">
                  <c:v>6.3988095238095237</c:v>
                </c:pt>
                <c:pt idx="1075">
                  <c:v>6.4047619047619051</c:v>
                </c:pt>
                <c:pt idx="1076">
                  <c:v>6.4107142857142856</c:v>
                </c:pt>
                <c:pt idx="1077">
                  <c:v>6.416666666666667</c:v>
                </c:pt>
                <c:pt idx="1078">
                  <c:v>6.4226190476190474</c:v>
                </c:pt>
                <c:pt idx="1079">
                  <c:v>6.4285714285714288</c:v>
                </c:pt>
                <c:pt idx="1080">
                  <c:v>6.4345238095238093</c:v>
                </c:pt>
                <c:pt idx="1081">
                  <c:v>6.4404761904761907</c:v>
                </c:pt>
                <c:pt idx="1082">
                  <c:v>6.4464285714285712</c:v>
                </c:pt>
                <c:pt idx="1083">
                  <c:v>6.4523809523809526</c:v>
                </c:pt>
                <c:pt idx="1084">
                  <c:v>6.458333333333333</c:v>
                </c:pt>
                <c:pt idx="1085">
                  <c:v>6.4642857142857144</c:v>
                </c:pt>
                <c:pt idx="1086">
                  <c:v>6.4702380952380949</c:v>
                </c:pt>
                <c:pt idx="1087">
                  <c:v>6.4761904761904763</c:v>
                </c:pt>
                <c:pt idx="1088">
                  <c:v>6.4821428571428568</c:v>
                </c:pt>
                <c:pt idx="1089">
                  <c:v>6.4880952380952381</c:v>
                </c:pt>
                <c:pt idx="1090">
                  <c:v>6.4940476190476186</c:v>
                </c:pt>
                <c:pt idx="1091">
                  <c:v>6.5</c:v>
                </c:pt>
                <c:pt idx="1092">
                  <c:v>6.5059523809523814</c:v>
                </c:pt>
                <c:pt idx="1093">
                  <c:v>6.5119047619047619</c:v>
                </c:pt>
                <c:pt idx="1094">
                  <c:v>6.5178571428571432</c:v>
                </c:pt>
                <c:pt idx="1095">
                  <c:v>6.5238095238095237</c:v>
                </c:pt>
                <c:pt idx="1096">
                  <c:v>6.5297619047619051</c:v>
                </c:pt>
                <c:pt idx="1097">
                  <c:v>6.5357142857142856</c:v>
                </c:pt>
                <c:pt idx="1098">
                  <c:v>6.541666666666667</c:v>
                </c:pt>
                <c:pt idx="1099">
                  <c:v>6.5476190476190474</c:v>
                </c:pt>
                <c:pt idx="1100">
                  <c:v>6.5535714285714288</c:v>
                </c:pt>
                <c:pt idx="1101">
                  <c:v>6.5595238095238093</c:v>
                </c:pt>
                <c:pt idx="1102">
                  <c:v>6.5654761904761907</c:v>
                </c:pt>
                <c:pt idx="1103">
                  <c:v>6.5714285714285712</c:v>
                </c:pt>
                <c:pt idx="1104">
                  <c:v>6.5773809523809526</c:v>
                </c:pt>
                <c:pt idx="1105">
                  <c:v>6.583333333333333</c:v>
                </c:pt>
                <c:pt idx="1106">
                  <c:v>6.5892857142857144</c:v>
                </c:pt>
                <c:pt idx="1107">
                  <c:v>6.5952380952380949</c:v>
                </c:pt>
                <c:pt idx="1108">
                  <c:v>6.6011904761904763</c:v>
                </c:pt>
                <c:pt idx="1109">
                  <c:v>6.6071428571428568</c:v>
                </c:pt>
                <c:pt idx="1110">
                  <c:v>6.6130952380952381</c:v>
                </c:pt>
                <c:pt idx="1111">
                  <c:v>6.6190476190476186</c:v>
                </c:pt>
                <c:pt idx="1112">
                  <c:v>6.625</c:v>
                </c:pt>
                <c:pt idx="1113">
                  <c:v>6.6309523809523814</c:v>
                </c:pt>
                <c:pt idx="1114">
                  <c:v>6.6369047619047619</c:v>
                </c:pt>
                <c:pt idx="1115">
                  <c:v>6.6428571428571432</c:v>
                </c:pt>
                <c:pt idx="1116">
                  <c:v>6.6488095238095237</c:v>
                </c:pt>
                <c:pt idx="1117">
                  <c:v>6.6547619047619051</c:v>
                </c:pt>
                <c:pt idx="1118">
                  <c:v>6.6607142857142856</c:v>
                </c:pt>
                <c:pt idx="1119">
                  <c:v>6.666666666666667</c:v>
                </c:pt>
                <c:pt idx="1120">
                  <c:v>6.6726190476190474</c:v>
                </c:pt>
                <c:pt idx="1121">
                  <c:v>6.6785714285714288</c:v>
                </c:pt>
                <c:pt idx="1122">
                  <c:v>6.6845238095238093</c:v>
                </c:pt>
                <c:pt idx="1123">
                  <c:v>6.6904761904761907</c:v>
                </c:pt>
                <c:pt idx="1124">
                  <c:v>6.6964285714285712</c:v>
                </c:pt>
                <c:pt idx="1125">
                  <c:v>6.7023809523809526</c:v>
                </c:pt>
                <c:pt idx="1126">
                  <c:v>6.708333333333333</c:v>
                </c:pt>
                <c:pt idx="1127">
                  <c:v>6.7142857142857144</c:v>
                </c:pt>
                <c:pt idx="1128">
                  <c:v>6.7202380952380949</c:v>
                </c:pt>
                <c:pt idx="1129">
                  <c:v>6.7261904761904763</c:v>
                </c:pt>
                <c:pt idx="1130">
                  <c:v>6.7321428571428568</c:v>
                </c:pt>
                <c:pt idx="1131">
                  <c:v>6.7380952380952381</c:v>
                </c:pt>
                <c:pt idx="1132">
                  <c:v>6.7440476190476186</c:v>
                </c:pt>
                <c:pt idx="1133">
                  <c:v>6.75</c:v>
                </c:pt>
                <c:pt idx="1134">
                  <c:v>6.7559523809523814</c:v>
                </c:pt>
                <c:pt idx="1135">
                  <c:v>6.7619047619047619</c:v>
                </c:pt>
                <c:pt idx="1136">
                  <c:v>6.7678571428571432</c:v>
                </c:pt>
                <c:pt idx="1137">
                  <c:v>6.7738095238095237</c:v>
                </c:pt>
                <c:pt idx="1138">
                  <c:v>6.7797619047619051</c:v>
                </c:pt>
                <c:pt idx="1139">
                  <c:v>6.7857142857142856</c:v>
                </c:pt>
                <c:pt idx="1140">
                  <c:v>6.791666666666667</c:v>
                </c:pt>
                <c:pt idx="1141">
                  <c:v>6.7976190476190474</c:v>
                </c:pt>
                <c:pt idx="1142">
                  <c:v>6.8035714285714288</c:v>
                </c:pt>
                <c:pt idx="1143">
                  <c:v>6.8095238095238093</c:v>
                </c:pt>
                <c:pt idx="1144">
                  <c:v>6.8154761904761907</c:v>
                </c:pt>
                <c:pt idx="1145">
                  <c:v>6.8214285714285712</c:v>
                </c:pt>
                <c:pt idx="1146">
                  <c:v>6.8273809523809526</c:v>
                </c:pt>
                <c:pt idx="1147">
                  <c:v>6.833333333333333</c:v>
                </c:pt>
                <c:pt idx="1148">
                  <c:v>6.8392857142857144</c:v>
                </c:pt>
                <c:pt idx="1149">
                  <c:v>6.8452380952380949</c:v>
                </c:pt>
                <c:pt idx="1150">
                  <c:v>6.8511904761904763</c:v>
                </c:pt>
                <c:pt idx="1151">
                  <c:v>6.8571428571428568</c:v>
                </c:pt>
                <c:pt idx="1152">
                  <c:v>6.8630952380952381</c:v>
                </c:pt>
                <c:pt idx="1153">
                  <c:v>6.8690476190476186</c:v>
                </c:pt>
                <c:pt idx="1154">
                  <c:v>6.875</c:v>
                </c:pt>
                <c:pt idx="1155">
                  <c:v>6.8809523809523814</c:v>
                </c:pt>
                <c:pt idx="1156">
                  <c:v>6.8869047619047619</c:v>
                </c:pt>
                <c:pt idx="1157">
                  <c:v>6.8928571428571432</c:v>
                </c:pt>
                <c:pt idx="1158">
                  <c:v>6.8988095238095237</c:v>
                </c:pt>
                <c:pt idx="1159">
                  <c:v>6.9047619047619051</c:v>
                </c:pt>
                <c:pt idx="1160">
                  <c:v>6.9107142857142856</c:v>
                </c:pt>
                <c:pt idx="1161">
                  <c:v>6.916666666666667</c:v>
                </c:pt>
                <c:pt idx="1162">
                  <c:v>6.9226190476190474</c:v>
                </c:pt>
                <c:pt idx="1163">
                  <c:v>6.9285714285714288</c:v>
                </c:pt>
                <c:pt idx="1164">
                  <c:v>6.9345238095238093</c:v>
                </c:pt>
                <c:pt idx="1165">
                  <c:v>6.9404761904761907</c:v>
                </c:pt>
                <c:pt idx="1166">
                  <c:v>6.9464285714285712</c:v>
                </c:pt>
                <c:pt idx="1167">
                  <c:v>6.9523809523809526</c:v>
                </c:pt>
                <c:pt idx="1168">
                  <c:v>6.958333333333333</c:v>
                </c:pt>
                <c:pt idx="1169">
                  <c:v>6.9642857142857144</c:v>
                </c:pt>
                <c:pt idx="1170">
                  <c:v>6.9702380952380949</c:v>
                </c:pt>
                <c:pt idx="1171">
                  <c:v>6.9761904761904763</c:v>
                </c:pt>
                <c:pt idx="1172">
                  <c:v>6.9821428571428568</c:v>
                </c:pt>
                <c:pt idx="1173">
                  <c:v>6.9880952380952381</c:v>
                </c:pt>
                <c:pt idx="1174">
                  <c:v>6.9940476190476186</c:v>
                </c:pt>
                <c:pt idx="1175">
                  <c:v>7</c:v>
                </c:pt>
                <c:pt idx="1176">
                  <c:v>7.0059523809523814</c:v>
                </c:pt>
                <c:pt idx="1177">
                  <c:v>7.0119047619047619</c:v>
                </c:pt>
                <c:pt idx="1178">
                  <c:v>7.0178571428571432</c:v>
                </c:pt>
                <c:pt idx="1179">
                  <c:v>7.0238095238095237</c:v>
                </c:pt>
                <c:pt idx="1180">
                  <c:v>7.0297619047619051</c:v>
                </c:pt>
                <c:pt idx="1181">
                  <c:v>7.0357142857142856</c:v>
                </c:pt>
                <c:pt idx="1182">
                  <c:v>7.041666666666667</c:v>
                </c:pt>
                <c:pt idx="1183">
                  <c:v>7.0476190476190474</c:v>
                </c:pt>
                <c:pt idx="1184">
                  <c:v>7.0535714285714288</c:v>
                </c:pt>
                <c:pt idx="1185">
                  <c:v>7.0595238095238093</c:v>
                </c:pt>
                <c:pt idx="1186">
                  <c:v>7.0654761904761907</c:v>
                </c:pt>
                <c:pt idx="1187">
                  <c:v>7.0714285714285712</c:v>
                </c:pt>
                <c:pt idx="1188">
                  <c:v>7.0773809523809526</c:v>
                </c:pt>
                <c:pt idx="1189">
                  <c:v>7.083333333333333</c:v>
                </c:pt>
                <c:pt idx="1190">
                  <c:v>7.0892857142857144</c:v>
                </c:pt>
                <c:pt idx="1191">
                  <c:v>7.0952380952380949</c:v>
                </c:pt>
                <c:pt idx="1192">
                  <c:v>7.1011904761904763</c:v>
                </c:pt>
                <c:pt idx="1193">
                  <c:v>7.1071428571428568</c:v>
                </c:pt>
                <c:pt idx="1194">
                  <c:v>7.1130952380952381</c:v>
                </c:pt>
                <c:pt idx="1195">
                  <c:v>7.1190476190476186</c:v>
                </c:pt>
                <c:pt idx="1196">
                  <c:v>7.125</c:v>
                </c:pt>
                <c:pt idx="1197">
                  <c:v>7.1309523809523814</c:v>
                </c:pt>
                <c:pt idx="1198">
                  <c:v>7.1369047619047619</c:v>
                </c:pt>
                <c:pt idx="1199">
                  <c:v>7.1428571428571432</c:v>
                </c:pt>
                <c:pt idx="1200">
                  <c:v>7.1488095238095237</c:v>
                </c:pt>
                <c:pt idx="1201">
                  <c:v>7.1547619047619051</c:v>
                </c:pt>
                <c:pt idx="1202">
                  <c:v>7.1607142857142856</c:v>
                </c:pt>
                <c:pt idx="1203">
                  <c:v>7.166666666666667</c:v>
                </c:pt>
                <c:pt idx="1204">
                  <c:v>7.1726190476190474</c:v>
                </c:pt>
                <c:pt idx="1205">
                  <c:v>7.1785714285714288</c:v>
                </c:pt>
                <c:pt idx="1206">
                  <c:v>7.1845238095238093</c:v>
                </c:pt>
                <c:pt idx="1207">
                  <c:v>7.1904761904761907</c:v>
                </c:pt>
                <c:pt idx="1208">
                  <c:v>7.1964285714285712</c:v>
                </c:pt>
                <c:pt idx="1209">
                  <c:v>7.2023809523809526</c:v>
                </c:pt>
                <c:pt idx="1210">
                  <c:v>7.208333333333333</c:v>
                </c:pt>
                <c:pt idx="1211">
                  <c:v>7.2142857142857144</c:v>
                </c:pt>
                <c:pt idx="1212">
                  <c:v>7.2202380952380949</c:v>
                </c:pt>
                <c:pt idx="1213">
                  <c:v>7.2261904761904763</c:v>
                </c:pt>
                <c:pt idx="1214">
                  <c:v>7.2321428571428568</c:v>
                </c:pt>
                <c:pt idx="1215">
                  <c:v>7.2380952380952381</c:v>
                </c:pt>
                <c:pt idx="1216">
                  <c:v>7.2440476190476186</c:v>
                </c:pt>
                <c:pt idx="1217">
                  <c:v>7.25</c:v>
                </c:pt>
                <c:pt idx="1218">
                  <c:v>7.2559523809523814</c:v>
                </c:pt>
                <c:pt idx="1219">
                  <c:v>7.2619047619047619</c:v>
                </c:pt>
                <c:pt idx="1220">
                  <c:v>7.2678571428571432</c:v>
                </c:pt>
                <c:pt idx="1221">
                  <c:v>7.2738095238095237</c:v>
                </c:pt>
                <c:pt idx="1222">
                  <c:v>7.2797619047619051</c:v>
                </c:pt>
                <c:pt idx="1223">
                  <c:v>7.2857142857142856</c:v>
                </c:pt>
                <c:pt idx="1224">
                  <c:v>7.291666666666667</c:v>
                </c:pt>
                <c:pt idx="1225">
                  <c:v>7.2976190476190474</c:v>
                </c:pt>
                <c:pt idx="1226">
                  <c:v>7.3035714285714288</c:v>
                </c:pt>
                <c:pt idx="1227">
                  <c:v>7.3095238095238093</c:v>
                </c:pt>
                <c:pt idx="1228">
                  <c:v>7.3154761904761907</c:v>
                </c:pt>
                <c:pt idx="1229">
                  <c:v>7.3214285714285712</c:v>
                </c:pt>
                <c:pt idx="1230">
                  <c:v>7.3273809523809526</c:v>
                </c:pt>
                <c:pt idx="1231">
                  <c:v>7.333333333333333</c:v>
                </c:pt>
                <c:pt idx="1232">
                  <c:v>7.3392857142857144</c:v>
                </c:pt>
                <c:pt idx="1233">
                  <c:v>7.3452380952380949</c:v>
                </c:pt>
                <c:pt idx="1234">
                  <c:v>7.3511904761904763</c:v>
                </c:pt>
                <c:pt idx="1235">
                  <c:v>7.3571428571428568</c:v>
                </c:pt>
                <c:pt idx="1236">
                  <c:v>7.3630952380952381</c:v>
                </c:pt>
                <c:pt idx="1237">
                  <c:v>7.3690476190476186</c:v>
                </c:pt>
                <c:pt idx="1238">
                  <c:v>7.375</c:v>
                </c:pt>
                <c:pt idx="1239">
                  <c:v>7.3809523809523814</c:v>
                </c:pt>
                <c:pt idx="1240">
                  <c:v>7.3869047619047619</c:v>
                </c:pt>
                <c:pt idx="1241">
                  <c:v>7.3928571428571432</c:v>
                </c:pt>
                <c:pt idx="1242">
                  <c:v>7.3988095238095237</c:v>
                </c:pt>
                <c:pt idx="1243">
                  <c:v>7.4047619047619051</c:v>
                </c:pt>
                <c:pt idx="1244">
                  <c:v>7.4107142857142856</c:v>
                </c:pt>
                <c:pt idx="1245">
                  <c:v>7.416666666666667</c:v>
                </c:pt>
                <c:pt idx="1246">
                  <c:v>7.4226190476190474</c:v>
                </c:pt>
                <c:pt idx="1247">
                  <c:v>7.4285714285714288</c:v>
                </c:pt>
                <c:pt idx="1248">
                  <c:v>7.4345238095238093</c:v>
                </c:pt>
                <c:pt idx="1249">
                  <c:v>7.4404761904761907</c:v>
                </c:pt>
                <c:pt idx="1250">
                  <c:v>7.4464285714285712</c:v>
                </c:pt>
                <c:pt idx="1251">
                  <c:v>7.4523809523809526</c:v>
                </c:pt>
                <c:pt idx="1252">
                  <c:v>7.458333333333333</c:v>
                </c:pt>
                <c:pt idx="1253">
                  <c:v>7.4642857142857144</c:v>
                </c:pt>
                <c:pt idx="1254">
                  <c:v>7.4702380952380949</c:v>
                </c:pt>
                <c:pt idx="1255">
                  <c:v>7.4761904761904763</c:v>
                </c:pt>
                <c:pt idx="1256">
                  <c:v>7.4821428571428568</c:v>
                </c:pt>
                <c:pt idx="1257">
                  <c:v>7.4880952380952381</c:v>
                </c:pt>
                <c:pt idx="1258">
                  <c:v>7.4940476190476186</c:v>
                </c:pt>
                <c:pt idx="1259">
                  <c:v>7.5</c:v>
                </c:pt>
                <c:pt idx="1260">
                  <c:v>7.5059523809523814</c:v>
                </c:pt>
                <c:pt idx="1261">
                  <c:v>7.5119047619047619</c:v>
                </c:pt>
                <c:pt idx="1262">
                  <c:v>7.5178571428571432</c:v>
                </c:pt>
                <c:pt idx="1263">
                  <c:v>7.5238095238095237</c:v>
                </c:pt>
                <c:pt idx="1264">
                  <c:v>7.5297619047619051</c:v>
                </c:pt>
                <c:pt idx="1265">
                  <c:v>7.5357142857142856</c:v>
                </c:pt>
                <c:pt idx="1266">
                  <c:v>7.541666666666667</c:v>
                </c:pt>
                <c:pt idx="1267">
                  <c:v>7.5476190476190474</c:v>
                </c:pt>
                <c:pt idx="1268">
                  <c:v>7.5535714285714288</c:v>
                </c:pt>
                <c:pt idx="1269">
                  <c:v>7.5595238095238093</c:v>
                </c:pt>
                <c:pt idx="1270">
                  <c:v>7.5654761904761907</c:v>
                </c:pt>
                <c:pt idx="1271">
                  <c:v>7.5714285714285712</c:v>
                </c:pt>
                <c:pt idx="1272">
                  <c:v>7.5773809523809526</c:v>
                </c:pt>
                <c:pt idx="1273">
                  <c:v>7.583333333333333</c:v>
                </c:pt>
                <c:pt idx="1274">
                  <c:v>7.5892857142857144</c:v>
                </c:pt>
                <c:pt idx="1275">
                  <c:v>7.5952380952380949</c:v>
                </c:pt>
                <c:pt idx="1276">
                  <c:v>7.6011904761904763</c:v>
                </c:pt>
                <c:pt idx="1277">
                  <c:v>7.6071428571428568</c:v>
                </c:pt>
                <c:pt idx="1278">
                  <c:v>7.6130952380952381</c:v>
                </c:pt>
                <c:pt idx="1279">
                  <c:v>7.6190476190476186</c:v>
                </c:pt>
                <c:pt idx="1280">
                  <c:v>7.625</c:v>
                </c:pt>
                <c:pt idx="1281">
                  <c:v>7.6309523809523814</c:v>
                </c:pt>
                <c:pt idx="1282">
                  <c:v>7.6369047619047619</c:v>
                </c:pt>
                <c:pt idx="1283">
                  <c:v>7.6428571428571432</c:v>
                </c:pt>
                <c:pt idx="1284">
                  <c:v>7.6488095238095237</c:v>
                </c:pt>
                <c:pt idx="1285">
                  <c:v>7.6547619047619051</c:v>
                </c:pt>
                <c:pt idx="1286">
                  <c:v>7.6607142857142856</c:v>
                </c:pt>
                <c:pt idx="1287">
                  <c:v>7.666666666666667</c:v>
                </c:pt>
                <c:pt idx="1288">
                  <c:v>7.6726190476190474</c:v>
                </c:pt>
                <c:pt idx="1289">
                  <c:v>7.6785714285714288</c:v>
                </c:pt>
                <c:pt idx="1290">
                  <c:v>7.6845238095238093</c:v>
                </c:pt>
                <c:pt idx="1291">
                  <c:v>7.6904761904761907</c:v>
                </c:pt>
                <c:pt idx="1292">
                  <c:v>7.6964285714285712</c:v>
                </c:pt>
                <c:pt idx="1293">
                  <c:v>7.7023809523809526</c:v>
                </c:pt>
                <c:pt idx="1294">
                  <c:v>7.708333333333333</c:v>
                </c:pt>
                <c:pt idx="1295">
                  <c:v>7.7142857142857144</c:v>
                </c:pt>
                <c:pt idx="1296">
                  <c:v>7.7202380952380949</c:v>
                </c:pt>
                <c:pt idx="1297">
                  <c:v>7.7261904761904763</c:v>
                </c:pt>
                <c:pt idx="1298">
                  <c:v>7.7321428571428568</c:v>
                </c:pt>
                <c:pt idx="1299">
                  <c:v>7.7380952380952381</c:v>
                </c:pt>
                <c:pt idx="1300">
                  <c:v>7.7440476190476186</c:v>
                </c:pt>
                <c:pt idx="1301">
                  <c:v>7.75</c:v>
                </c:pt>
                <c:pt idx="1302">
                  <c:v>7.7559523809523814</c:v>
                </c:pt>
                <c:pt idx="1303">
                  <c:v>7.7619047619047619</c:v>
                </c:pt>
                <c:pt idx="1304">
                  <c:v>7.7678571428571432</c:v>
                </c:pt>
                <c:pt idx="1305">
                  <c:v>7.7738095238095237</c:v>
                </c:pt>
                <c:pt idx="1306">
                  <c:v>7.7797619047619051</c:v>
                </c:pt>
                <c:pt idx="1307">
                  <c:v>7.7857142857142856</c:v>
                </c:pt>
                <c:pt idx="1308">
                  <c:v>7.791666666666667</c:v>
                </c:pt>
                <c:pt idx="1309">
                  <c:v>7.7976190476190474</c:v>
                </c:pt>
                <c:pt idx="1310">
                  <c:v>7.8035714285714288</c:v>
                </c:pt>
                <c:pt idx="1311">
                  <c:v>7.8095238095238093</c:v>
                </c:pt>
                <c:pt idx="1312">
                  <c:v>7.8154761904761907</c:v>
                </c:pt>
                <c:pt idx="1313">
                  <c:v>7.8214285714285712</c:v>
                </c:pt>
                <c:pt idx="1314">
                  <c:v>7.8273809523809526</c:v>
                </c:pt>
                <c:pt idx="1315">
                  <c:v>7.833333333333333</c:v>
                </c:pt>
                <c:pt idx="1316">
                  <c:v>7.8392857142857144</c:v>
                </c:pt>
                <c:pt idx="1317">
                  <c:v>7.8452380952380949</c:v>
                </c:pt>
                <c:pt idx="1318">
                  <c:v>7.8511904761904763</c:v>
                </c:pt>
                <c:pt idx="1319">
                  <c:v>7.8571428571428568</c:v>
                </c:pt>
                <c:pt idx="1320">
                  <c:v>7.8630952380952381</c:v>
                </c:pt>
                <c:pt idx="1321">
                  <c:v>7.8690476190476186</c:v>
                </c:pt>
                <c:pt idx="1322">
                  <c:v>7.875</c:v>
                </c:pt>
                <c:pt idx="1323">
                  <c:v>7.8809523809523814</c:v>
                </c:pt>
                <c:pt idx="1324">
                  <c:v>7.8869047619047619</c:v>
                </c:pt>
                <c:pt idx="1325">
                  <c:v>7.8928571428571432</c:v>
                </c:pt>
                <c:pt idx="1326">
                  <c:v>7.8988095238095237</c:v>
                </c:pt>
                <c:pt idx="1327">
                  <c:v>7.9047619047619051</c:v>
                </c:pt>
                <c:pt idx="1328">
                  <c:v>7.9107142857142856</c:v>
                </c:pt>
                <c:pt idx="1329">
                  <c:v>7.916666666666667</c:v>
                </c:pt>
                <c:pt idx="1330">
                  <c:v>7.9226190476190474</c:v>
                </c:pt>
                <c:pt idx="1331">
                  <c:v>7.9285714285714288</c:v>
                </c:pt>
                <c:pt idx="1332">
                  <c:v>7.9345238095238093</c:v>
                </c:pt>
                <c:pt idx="1333">
                  <c:v>7.9404761904761907</c:v>
                </c:pt>
                <c:pt idx="1334">
                  <c:v>7.9464285714285712</c:v>
                </c:pt>
                <c:pt idx="1335">
                  <c:v>7.9523809523809526</c:v>
                </c:pt>
                <c:pt idx="1336">
                  <c:v>7.958333333333333</c:v>
                </c:pt>
                <c:pt idx="1337">
                  <c:v>7.9642857142857144</c:v>
                </c:pt>
                <c:pt idx="1338">
                  <c:v>7.9702380952380949</c:v>
                </c:pt>
              </c:numCache>
            </c:numRef>
          </c:xVal>
          <c:yVal>
            <c:numRef>
              <c:f>Tabelle1!$F$13:$F$1351</c:f>
              <c:numCache>
                <c:formatCode>0</c:formatCode>
                <c:ptCount val="1339"/>
                <c:pt idx="0">
                  <c:v>35.5</c:v>
                </c:pt>
                <c:pt idx="1">
                  <c:v>28.3</c:v>
                </c:pt>
                <c:pt idx="2">
                  <c:v>28.9</c:v>
                </c:pt>
                <c:pt idx="3">
                  <c:v>29.4</c:v>
                </c:pt>
                <c:pt idx="4">
                  <c:v>29.6</c:v>
                </c:pt>
                <c:pt idx="5">
                  <c:v>29.7</c:v>
                </c:pt>
                <c:pt idx="6">
                  <c:v>29.8</c:v>
                </c:pt>
                <c:pt idx="7">
                  <c:v>29.8</c:v>
                </c:pt>
                <c:pt idx="8">
                  <c:v>29.7</c:v>
                </c:pt>
                <c:pt idx="9">
                  <c:v>29.6</c:v>
                </c:pt>
                <c:pt idx="10">
                  <c:v>29.5</c:v>
                </c:pt>
                <c:pt idx="11">
                  <c:v>29.5</c:v>
                </c:pt>
                <c:pt idx="12">
                  <c:v>29.4</c:v>
                </c:pt>
                <c:pt idx="13">
                  <c:v>29.4</c:v>
                </c:pt>
                <c:pt idx="14">
                  <c:v>29.4</c:v>
                </c:pt>
                <c:pt idx="15">
                  <c:v>29.4</c:v>
                </c:pt>
                <c:pt idx="16">
                  <c:v>29.3</c:v>
                </c:pt>
                <c:pt idx="17">
                  <c:v>29.1</c:v>
                </c:pt>
                <c:pt idx="18">
                  <c:v>28.1</c:v>
                </c:pt>
                <c:pt idx="19">
                  <c:v>28.4</c:v>
                </c:pt>
                <c:pt idx="20">
                  <c:v>28.1</c:v>
                </c:pt>
                <c:pt idx="21">
                  <c:v>28.5</c:v>
                </c:pt>
                <c:pt idx="22">
                  <c:v>29.1</c:v>
                </c:pt>
                <c:pt idx="23">
                  <c:v>29.7</c:v>
                </c:pt>
                <c:pt idx="24">
                  <c:v>29</c:v>
                </c:pt>
                <c:pt idx="25">
                  <c:v>29.5</c:v>
                </c:pt>
                <c:pt idx="26">
                  <c:v>30</c:v>
                </c:pt>
                <c:pt idx="27">
                  <c:v>30.5</c:v>
                </c:pt>
                <c:pt idx="28">
                  <c:v>30.8</c:v>
                </c:pt>
                <c:pt idx="29">
                  <c:v>31</c:v>
                </c:pt>
                <c:pt idx="30">
                  <c:v>31.1</c:v>
                </c:pt>
                <c:pt idx="31">
                  <c:v>31.1</c:v>
                </c:pt>
                <c:pt idx="32">
                  <c:v>31.2</c:v>
                </c:pt>
                <c:pt idx="33">
                  <c:v>31.1</c:v>
                </c:pt>
                <c:pt idx="34">
                  <c:v>31.1</c:v>
                </c:pt>
                <c:pt idx="35">
                  <c:v>31.1</c:v>
                </c:pt>
                <c:pt idx="36">
                  <c:v>31.1</c:v>
                </c:pt>
                <c:pt idx="37">
                  <c:v>31</c:v>
                </c:pt>
                <c:pt idx="38">
                  <c:v>30.9</c:v>
                </c:pt>
                <c:pt idx="39">
                  <c:v>30.9</c:v>
                </c:pt>
                <c:pt idx="40">
                  <c:v>30.8</c:v>
                </c:pt>
                <c:pt idx="41">
                  <c:v>30.7</c:v>
                </c:pt>
                <c:pt idx="42">
                  <c:v>30.6</c:v>
                </c:pt>
                <c:pt idx="43">
                  <c:v>30.3</c:v>
                </c:pt>
                <c:pt idx="44">
                  <c:v>30.1</c:v>
                </c:pt>
                <c:pt idx="45">
                  <c:v>30.1</c:v>
                </c:pt>
                <c:pt idx="46">
                  <c:v>30</c:v>
                </c:pt>
                <c:pt idx="47">
                  <c:v>30</c:v>
                </c:pt>
                <c:pt idx="48">
                  <c:v>30.1</c:v>
                </c:pt>
                <c:pt idx="49">
                  <c:v>30</c:v>
                </c:pt>
                <c:pt idx="50">
                  <c:v>30.1</c:v>
                </c:pt>
                <c:pt idx="51">
                  <c:v>30</c:v>
                </c:pt>
                <c:pt idx="52">
                  <c:v>30</c:v>
                </c:pt>
                <c:pt idx="53">
                  <c:v>30.1</c:v>
                </c:pt>
                <c:pt idx="54">
                  <c:v>30.1</c:v>
                </c:pt>
                <c:pt idx="55">
                  <c:v>30.1</c:v>
                </c:pt>
                <c:pt idx="56">
                  <c:v>30.1</c:v>
                </c:pt>
                <c:pt idx="57">
                  <c:v>30.1</c:v>
                </c:pt>
                <c:pt idx="58">
                  <c:v>30.1</c:v>
                </c:pt>
                <c:pt idx="59">
                  <c:v>30.1</c:v>
                </c:pt>
                <c:pt idx="60">
                  <c:v>30.1</c:v>
                </c:pt>
                <c:pt idx="61">
                  <c:v>30</c:v>
                </c:pt>
                <c:pt idx="62">
                  <c:v>30</c:v>
                </c:pt>
                <c:pt idx="63">
                  <c:v>30</c:v>
                </c:pt>
                <c:pt idx="64">
                  <c:v>29.8</c:v>
                </c:pt>
                <c:pt idx="65">
                  <c:v>29.4</c:v>
                </c:pt>
                <c:pt idx="66">
                  <c:v>28.3</c:v>
                </c:pt>
                <c:pt idx="67">
                  <c:v>27.5</c:v>
                </c:pt>
                <c:pt idx="68">
                  <c:v>28.2</c:v>
                </c:pt>
                <c:pt idx="69">
                  <c:v>29.4</c:v>
                </c:pt>
                <c:pt idx="70">
                  <c:v>30.3</c:v>
                </c:pt>
                <c:pt idx="71">
                  <c:v>30.3</c:v>
                </c:pt>
                <c:pt idx="72">
                  <c:v>30.2</c:v>
                </c:pt>
                <c:pt idx="73">
                  <c:v>30.1</c:v>
                </c:pt>
                <c:pt idx="74">
                  <c:v>30.1</c:v>
                </c:pt>
                <c:pt idx="75">
                  <c:v>30.1</c:v>
                </c:pt>
                <c:pt idx="76">
                  <c:v>29.9</c:v>
                </c:pt>
                <c:pt idx="77">
                  <c:v>29.6</c:v>
                </c:pt>
                <c:pt idx="78">
                  <c:v>29.2</c:v>
                </c:pt>
                <c:pt idx="79">
                  <c:v>28.9</c:v>
                </c:pt>
                <c:pt idx="80">
                  <c:v>28.8</c:v>
                </c:pt>
                <c:pt idx="81">
                  <c:v>28.6</c:v>
                </c:pt>
                <c:pt idx="82">
                  <c:v>28.5</c:v>
                </c:pt>
                <c:pt idx="83">
                  <c:v>28.4</c:v>
                </c:pt>
                <c:pt idx="84">
                  <c:v>28.3</c:v>
                </c:pt>
                <c:pt idx="85">
                  <c:v>28.2</c:v>
                </c:pt>
                <c:pt idx="86">
                  <c:v>28.1</c:v>
                </c:pt>
                <c:pt idx="87">
                  <c:v>28.1</c:v>
                </c:pt>
                <c:pt idx="88">
                  <c:v>28</c:v>
                </c:pt>
                <c:pt idx="89">
                  <c:v>27.8</c:v>
                </c:pt>
                <c:pt idx="90">
                  <c:v>26.8</c:v>
                </c:pt>
                <c:pt idx="91">
                  <c:v>25.9</c:v>
                </c:pt>
                <c:pt idx="92">
                  <c:v>26.4</c:v>
                </c:pt>
                <c:pt idx="93">
                  <c:v>27.9</c:v>
                </c:pt>
                <c:pt idx="94">
                  <c:v>28.8</c:v>
                </c:pt>
                <c:pt idx="95">
                  <c:v>29.5</c:v>
                </c:pt>
                <c:pt idx="96">
                  <c:v>29.5</c:v>
                </c:pt>
                <c:pt idx="97">
                  <c:v>29.4</c:v>
                </c:pt>
                <c:pt idx="98">
                  <c:v>29.3</c:v>
                </c:pt>
                <c:pt idx="99">
                  <c:v>29.1</c:v>
                </c:pt>
                <c:pt idx="100">
                  <c:v>28.9</c:v>
                </c:pt>
                <c:pt idx="101">
                  <c:v>28.8</c:v>
                </c:pt>
                <c:pt idx="102">
                  <c:v>28.8</c:v>
                </c:pt>
                <c:pt idx="103">
                  <c:v>28.7</c:v>
                </c:pt>
                <c:pt idx="104">
                  <c:v>28.7</c:v>
                </c:pt>
                <c:pt idx="105">
                  <c:v>28.7</c:v>
                </c:pt>
                <c:pt idx="106">
                  <c:v>28.7</c:v>
                </c:pt>
                <c:pt idx="107">
                  <c:v>28.7</c:v>
                </c:pt>
                <c:pt idx="108">
                  <c:v>28.7</c:v>
                </c:pt>
                <c:pt idx="109">
                  <c:v>28.7</c:v>
                </c:pt>
                <c:pt idx="110">
                  <c:v>28.8</c:v>
                </c:pt>
                <c:pt idx="111">
                  <c:v>28.7</c:v>
                </c:pt>
                <c:pt idx="112">
                  <c:v>28.7</c:v>
                </c:pt>
                <c:pt idx="113">
                  <c:v>28.7</c:v>
                </c:pt>
                <c:pt idx="114">
                  <c:v>28.6</c:v>
                </c:pt>
                <c:pt idx="115">
                  <c:v>28.4</c:v>
                </c:pt>
                <c:pt idx="116">
                  <c:v>28.2</c:v>
                </c:pt>
                <c:pt idx="117">
                  <c:v>28.2</c:v>
                </c:pt>
                <c:pt idx="118">
                  <c:v>28.3</c:v>
                </c:pt>
                <c:pt idx="119">
                  <c:v>28.3</c:v>
                </c:pt>
                <c:pt idx="120">
                  <c:v>28.4</c:v>
                </c:pt>
                <c:pt idx="121">
                  <c:v>28.3</c:v>
                </c:pt>
                <c:pt idx="122">
                  <c:v>28.3</c:v>
                </c:pt>
                <c:pt idx="123">
                  <c:v>28.4</c:v>
                </c:pt>
                <c:pt idx="124">
                  <c:v>28.4</c:v>
                </c:pt>
                <c:pt idx="125">
                  <c:v>28.4</c:v>
                </c:pt>
                <c:pt idx="126">
                  <c:v>28.4</c:v>
                </c:pt>
                <c:pt idx="127">
                  <c:v>28.3</c:v>
                </c:pt>
                <c:pt idx="128">
                  <c:v>28.2</c:v>
                </c:pt>
                <c:pt idx="129">
                  <c:v>28.3</c:v>
                </c:pt>
                <c:pt idx="130">
                  <c:v>28.3</c:v>
                </c:pt>
                <c:pt idx="131">
                  <c:v>28.5</c:v>
                </c:pt>
                <c:pt idx="132">
                  <c:v>28.5</c:v>
                </c:pt>
                <c:pt idx="133">
                  <c:v>28.7</c:v>
                </c:pt>
                <c:pt idx="134">
                  <c:v>28.7</c:v>
                </c:pt>
                <c:pt idx="135">
                  <c:v>28.8</c:v>
                </c:pt>
                <c:pt idx="136">
                  <c:v>28.7</c:v>
                </c:pt>
                <c:pt idx="137">
                  <c:v>28.3</c:v>
                </c:pt>
                <c:pt idx="138">
                  <c:v>27.1</c:v>
                </c:pt>
                <c:pt idx="139">
                  <c:v>26.6</c:v>
                </c:pt>
                <c:pt idx="140">
                  <c:v>27.3</c:v>
                </c:pt>
                <c:pt idx="141">
                  <c:v>28.4</c:v>
                </c:pt>
                <c:pt idx="142">
                  <c:v>29.3</c:v>
                </c:pt>
                <c:pt idx="143">
                  <c:v>29.5</c:v>
                </c:pt>
                <c:pt idx="144">
                  <c:v>29.4</c:v>
                </c:pt>
                <c:pt idx="145">
                  <c:v>29.1</c:v>
                </c:pt>
                <c:pt idx="146">
                  <c:v>28.9</c:v>
                </c:pt>
                <c:pt idx="147">
                  <c:v>28.7</c:v>
                </c:pt>
                <c:pt idx="148">
                  <c:v>28.5</c:v>
                </c:pt>
                <c:pt idx="149">
                  <c:v>28.2</c:v>
                </c:pt>
                <c:pt idx="150">
                  <c:v>27.9</c:v>
                </c:pt>
                <c:pt idx="151">
                  <c:v>27.6</c:v>
                </c:pt>
                <c:pt idx="152">
                  <c:v>27.5</c:v>
                </c:pt>
                <c:pt idx="153">
                  <c:v>27.3</c:v>
                </c:pt>
                <c:pt idx="154">
                  <c:v>27.2</c:v>
                </c:pt>
                <c:pt idx="155">
                  <c:v>27.1</c:v>
                </c:pt>
                <c:pt idx="156">
                  <c:v>27.1</c:v>
                </c:pt>
                <c:pt idx="157">
                  <c:v>27</c:v>
                </c:pt>
                <c:pt idx="158">
                  <c:v>26.8</c:v>
                </c:pt>
                <c:pt idx="159">
                  <c:v>26.8</c:v>
                </c:pt>
                <c:pt idx="160">
                  <c:v>26.8</c:v>
                </c:pt>
                <c:pt idx="161">
                  <c:v>26.6</c:v>
                </c:pt>
                <c:pt idx="162">
                  <c:v>25.5</c:v>
                </c:pt>
                <c:pt idx="163">
                  <c:v>25.7</c:v>
                </c:pt>
                <c:pt idx="164">
                  <c:v>25.6</c:v>
                </c:pt>
                <c:pt idx="165">
                  <c:v>16.5</c:v>
                </c:pt>
                <c:pt idx="166">
                  <c:v>17</c:v>
                </c:pt>
                <c:pt idx="167">
                  <c:v>20.100000000000001</c:v>
                </c:pt>
                <c:pt idx="168">
                  <c:v>22.5</c:v>
                </c:pt>
                <c:pt idx="169">
                  <c:v>23.8</c:v>
                </c:pt>
                <c:pt idx="170">
                  <c:v>24.6</c:v>
                </c:pt>
                <c:pt idx="171">
                  <c:v>25</c:v>
                </c:pt>
                <c:pt idx="172">
                  <c:v>25.2</c:v>
                </c:pt>
                <c:pt idx="173">
                  <c:v>25.2</c:v>
                </c:pt>
                <c:pt idx="174">
                  <c:v>25.1</c:v>
                </c:pt>
                <c:pt idx="175">
                  <c:v>25</c:v>
                </c:pt>
                <c:pt idx="176">
                  <c:v>24.9</c:v>
                </c:pt>
                <c:pt idx="177">
                  <c:v>24.8</c:v>
                </c:pt>
                <c:pt idx="178">
                  <c:v>24.7</c:v>
                </c:pt>
                <c:pt idx="179">
                  <c:v>24.6</c:v>
                </c:pt>
                <c:pt idx="180">
                  <c:v>24.5</c:v>
                </c:pt>
                <c:pt idx="181">
                  <c:v>24.5</c:v>
                </c:pt>
                <c:pt idx="182">
                  <c:v>24.4</c:v>
                </c:pt>
                <c:pt idx="183">
                  <c:v>24.4</c:v>
                </c:pt>
                <c:pt idx="184">
                  <c:v>24.4</c:v>
                </c:pt>
                <c:pt idx="185">
                  <c:v>24</c:v>
                </c:pt>
                <c:pt idx="186">
                  <c:v>22.5</c:v>
                </c:pt>
                <c:pt idx="187">
                  <c:v>22</c:v>
                </c:pt>
                <c:pt idx="188">
                  <c:v>22.8</c:v>
                </c:pt>
                <c:pt idx="189">
                  <c:v>23.8</c:v>
                </c:pt>
                <c:pt idx="190">
                  <c:v>24.5</c:v>
                </c:pt>
                <c:pt idx="191">
                  <c:v>25.1</c:v>
                </c:pt>
                <c:pt idx="192">
                  <c:v>25.5</c:v>
                </c:pt>
                <c:pt idx="193">
                  <c:v>25.7</c:v>
                </c:pt>
                <c:pt idx="194">
                  <c:v>25.7</c:v>
                </c:pt>
                <c:pt idx="195">
                  <c:v>25.6</c:v>
                </c:pt>
                <c:pt idx="196">
                  <c:v>25.4</c:v>
                </c:pt>
                <c:pt idx="197">
                  <c:v>25.4</c:v>
                </c:pt>
                <c:pt idx="198">
                  <c:v>25.3</c:v>
                </c:pt>
                <c:pt idx="199">
                  <c:v>25.2</c:v>
                </c:pt>
                <c:pt idx="200">
                  <c:v>25</c:v>
                </c:pt>
                <c:pt idx="201">
                  <c:v>24.8</c:v>
                </c:pt>
                <c:pt idx="202">
                  <c:v>24.7</c:v>
                </c:pt>
                <c:pt idx="203">
                  <c:v>24.8</c:v>
                </c:pt>
                <c:pt idx="204">
                  <c:v>24.8</c:v>
                </c:pt>
                <c:pt idx="205">
                  <c:v>24.8</c:v>
                </c:pt>
                <c:pt idx="206">
                  <c:v>24.8</c:v>
                </c:pt>
                <c:pt idx="207">
                  <c:v>24.8</c:v>
                </c:pt>
                <c:pt idx="208">
                  <c:v>25</c:v>
                </c:pt>
                <c:pt idx="209">
                  <c:v>25.2</c:v>
                </c:pt>
                <c:pt idx="210">
                  <c:v>25.2</c:v>
                </c:pt>
                <c:pt idx="211">
                  <c:v>25.5</c:v>
                </c:pt>
                <c:pt idx="212">
                  <c:v>25.7</c:v>
                </c:pt>
                <c:pt idx="213">
                  <c:v>25.9</c:v>
                </c:pt>
                <c:pt idx="214">
                  <c:v>25.9</c:v>
                </c:pt>
                <c:pt idx="215">
                  <c:v>26</c:v>
                </c:pt>
                <c:pt idx="216">
                  <c:v>26.6</c:v>
                </c:pt>
                <c:pt idx="217">
                  <c:v>27.2</c:v>
                </c:pt>
                <c:pt idx="218">
                  <c:v>27.5</c:v>
                </c:pt>
                <c:pt idx="219">
                  <c:v>27.9</c:v>
                </c:pt>
                <c:pt idx="220">
                  <c:v>28.2</c:v>
                </c:pt>
                <c:pt idx="221">
                  <c:v>28.5</c:v>
                </c:pt>
                <c:pt idx="222">
                  <c:v>28.6</c:v>
                </c:pt>
                <c:pt idx="223">
                  <c:v>28.6</c:v>
                </c:pt>
                <c:pt idx="224">
                  <c:v>28.6</c:v>
                </c:pt>
                <c:pt idx="225">
                  <c:v>28.6</c:v>
                </c:pt>
                <c:pt idx="226">
                  <c:v>28.6</c:v>
                </c:pt>
                <c:pt idx="227">
                  <c:v>28.5</c:v>
                </c:pt>
                <c:pt idx="228">
                  <c:v>28.5</c:v>
                </c:pt>
                <c:pt idx="229">
                  <c:v>28.4</c:v>
                </c:pt>
                <c:pt idx="230">
                  <c:v>28.5</c:v>
                </c:pt>
                <c:pt idx="231">
                  <c:v>28.6</c:v>
                </c:pt>
                <c:pt idx="232">
                  <c:v>28.6</c:v>
                </c:pt>
                <c:pt idx="233">
                  <c:v>28.5</c:v>
                </c:pt>
                <c:pt idx="234">
                  <c:v>28.2</c:v>
                </c:pt>
                <c:pt idx="235">
                  <c:v>27.9</c:v>
                </c:pt>
                <c:pt idx="236">
                  <c:v>28</c:v>
                </c:pt>
                <c:pt idx="237">
                  <c:v>27.7</c:v>
                </c:pt>
                <c:pt idx="238">
                  <c:v>28</c:v>
                </c:pt>
                <c:pt idx="239">
                  <c:v>28.3</c:v>
                </c:pt>
                <c:pt idx="240">
                  <c:v>28.4</c:v>
                </c:pt>
                <c:pt idx="241">
                  <c:v>28.4</c:v>
                </c:pt>
                <c:pt idx="242">
                  <c:v>28.3</c:v>
                </c:pt>
                <c:pt idx="243">
                  <c:v>28.2</c:v>
                </c:pt>
                <c:pt idx="244">
                  <c:v>28.1</c:v>
                </c:pt>
                <c:pt idx="245">
                  <c:v>28</c:v>
                </c:pt>
                <c:pt idx="246">
                  <c:v>27.8</c:v>
                </c:pt>
                <c:pt idx="247">
                  <c:v>27.6</c:v>
                </c:pt>
                <c:pt idx="248">
                  <c:v>27.4</c:v>
                </c:pt>
                <c:pt idx="249">
                  <c:v>27.3</c:v>
                </c:pt>
                <c:pt idx="250">
                  <c:v>27.3</c:v>
                </c:pt>
                <c:pt idx="251">
                  <c:v>27.5</c:v>
                </c:pt>
                <c:pt idx="252">
                  <c:v>27.7</c:v>
                </c:pt>
                <c:pt idx="253">
                  <c:v>27.7</c:v>
                </c:pt>
                <c:pt idx="254">
                  <c:v>27.7</c:v>
                </c:pt>
                <c:pt idx="255">
                  <c:v>27.8</c:v>
                </c:pt>
                <c:pt idx="256">
                  <c:v>27.8</c:v>
                </c:pt>
                <c:pt idx="257">
                  <c:v>27.7</c:v>
                </c:pt>
                <c:pt idx="258">
                  <c:v>27.5</c:v>
                </c:pt>
                <c:pt idx="259">
                  <c:v>27.5</c:v>
                </c:pt>
                <c:pt idx="260">
                  <c:v>27.6</c:v>
                </c:pt>
                <c:pt idx="261">
                  <c:v>27.8</c:v>
                </c:pt>
                <c:pt idx="262">
                  <c:v>27.9</c:v>
                </c:pt>
                <c:pt idx="263">
                  <c:v>27.9</c:v>
                </c:pt>
                <c:pt idx="264">
                  <c:v>28.2</c:v>
                </c:pt>
                <c:pt idx="265">
                  <c:v>28.6</c:v>
                </c:pt>
                <c:pt idx="266">
                  <c:v>28.7</c:v>
                </c:pt>
                <c:pt idx="267">
                  <c:v>28.8</c:v>
                </c:pt>
                <c:pt idx="268">
                  <c:v>28.9</c:v>
                </c:pt>
                <c:pt idx="269">
                  <c:v>29</c:v>
                </c:pt>
                <c:pt idx="270">
                  <c:v>28.9</c:v>
                </c:pt>
                <c:pt idx="271">
                  <c:v>28.8</c:v>
                </c:pt>
                <c:pt idx="272">
                  <c:v>28.7</c:v>
                </c:pt>
                <c:pt idx="273">
                  <c:v>28.6</c:v>
                </c:pt>
                <c:pt idx="274">
                  <c:v>28.5</c:v>
                </c:pt>
                <c:pt idx="275">
                  <c:v>28.4</c:v>
                </c:pt>
                <c:pt idx="276">
                  <c:v>28.2</c:v>
                </c:pt>
                <c:pt idx="277">
                  <c:v>28.1</c:v>
                </c:pt>
                <c:pt idx="278">
                  <c:v>28</c:v>
                </c:pt>
                <c:pt idx="279">
                  <c:v>27.9</c:v>
                </c:pt>
                <c:pt idx="280">
                  <c:v>28</c:v>
                </c:pt>
                <c:pt idx="281">
                  <c:v>28.1</c:v>
                </c:pt>
                <c:pt idx="282">
                  <c:v>28.1</c:v>
                </c:pt>
                <c:pt idx="283">
                  <c:v>28.1</c:v>
                </c:pt>
                <c:pt idx="284">
                  <c:v>28.1</c:v>
                </c:pt>
                <c:pt idx="285">
                  <c:v>28.1</c:v>
                </c:pt>
                <c:pt idx="286">
                  <c:v>27.8</c:v>
                </c:pt>
                <c:pt idx="287">
                  <c:v>27.9</c:v>
                </c:pt>
                <c:pt idx="288">
                  <c:v>28.1</c:v>
                </c:pt>
                <c:pt idx="289">
                  <c:v>28.5</c:v>
                </c:pt>
                <c:pt idx="290">
                  <c:v>28.8</c:v>
                </c:pt>
                <c:pt idx="291">
                  <c:v>29</c:v>
                </c:pt>
                <c:pt idx="292">
                  <c:v>29.2</c:v>
                </c:pt>
                <c:pt idx="293">
                  <c:v>29.1</c:v>
                </c:pt>
                <c:pt idx="294">
                  <c:v>29.1</c:v>
                </c:pt>
                <c:pt idx="295">
                  <c:v>29</c:v>
                </c:pt>
                <c:pt idx="296">
                  <c:v>29.1</c:v>
                </c:pt>
                <c:pt idx="297">
                  <c:v>29.1</c:v>
                </c:pt>
                <c:pt idx="298">
                  <c:v>29</c:v>
                </c:pt>
                <c:pt idx="299">
                  <c:v>28.9</c:v>
                </c:pt>
                <c:pt idx="300">
                  <c:v>28.8</c:v>
                </c:pt>
                <c:pt idx="301">
                  <c:v>28.8</c:v>
                </c:pt>
                <c:pt idx="302">
                  <c:v>28.7</c:v>
                </c:pt>
                <c:pt idx="303">
                  <c:v>28.7</c:v>
                </c:pt>
                <c:pt idx="304">
                  <c:v>28.7</c:v>
                </c:pt>
                <c:pt idx="305">
                  <c:v>28.6</c:v>
                </c:pt>
                <c:pt idx="306">
                  <c:v>28.4</c:v>
                </c:pt>
                <c:pt idx="307">
                  <c:v>28.2</c:v>
                </c:pt>
                <c:pt idx="308">
                  <c:v>28</c:v>
                </c:pt>
                <c:pt idx="309">
                  <c:v>27.9</c:v>
                </c:pt>
                <c:pt idx="310">
                  <c:v>27.8</c:v>
                </c:pt>
                <c:pt idx="311">
                  <c:v>27.8</c:v>
                </c:pt>
                <c:pt idx="312">
                  <c:v>28.4</c:v>
                </c:pt>
                <c:pt idx="313">
                  <c:v>28.7</c:v>
                </c:pt>
                <c:pt idx="314">
                  <c:v>29</c:v>
                </c:pt>
                <c:pt idx="315">
                  <c:v>29.3</c:v>
                </c:pt>
                <c:pt idx="316">
                  <c:v>29.3</c:v>
                </c:pt>
                <c:pt idx="317">
                  <c:v>29.3</c:v>
                </c:pt>
                <c:pt idx="318">
                  <c:v>29.2</c:v>
                </c:pt>
                <c:pt idx="319">
                  <c:v>29.2</c:v>
                </c:pt>
                <c:pt idx="320">
                  <c:v>29.2</c:v>
                </c:pt>
                <c:pt idx="321">
                  <c:v>29.2</c:v>
                </c:pt>
                <c:pt idx="322">
                  <c:v>29.2</c:v>
                </c:pt>
                <c:pt idx="323">
                  <c:v>29.2</c:v>
                </c:pt>
                <c:pt idx="324">
                  <c:v>29.2</c:v>
                </c:pt>
                <c:pt idx="325">
                  <c:v>29.1</c:v>
                </c:pt>
                <c:pt idx="326">
                  <c:v>29.1</c:v>
                </c:pt>
                <c:pt idx="327">
                  <c:v>29.1</c:v>
                </c:pt>
                <c:pt idx="328">
                  <c:v>29</c:v>
                </c:pt>
                <c:pt idx="329">
                  <c:v>28.9</c:v>
                </c:pt>
                <c:pt idx="330">
                  <c:v>28.7</c:v>
                </c:pt>
                <c:pt idx="331">
                  <c:v>28.4</c:v>
                </c:pt>
                <c:pt idx="332">
                  <c:v>28</c:v>
                </c:pt>
                <c:pt idx="333">
                  <c:v>27.6</c:v>
                </c:pt>
                <c:pt idx="334">
                  <c:v>27.8</c:v>
                </c:pt>
                <c:pt idx="335">
                  <c:v>28.3</c:v>
                </c:pt>
                <c:pt idx="336">
                  <c:v>28.5</c:v>
                </c:pt>
                <c:pt idx="337">
                  <c:v>28.5</c:v>
                </c:pt>
                <c:pt idx="338">
                  <c:v>28.5</c:v>
                </c:pt>
                <c:pt idx="339">
                  <c:v>28.5</c:v>
                </c:pt>
                <c:pt idx="340">
                  <c:v>28.4</c:v>
                </c:pt>
                <c:pt idx="341">
                  <c:v>28.4</c:v>
                </c:pt>
                <c:pt idx="342">
                  <c:v>28.2</c:v>
                </c:pt>
                <c:pt idx="343">
                  <c:v>28.1</c:v>
                </c:pt>
                <c:pt idx="344">
                  <c:v>27.9</c:v>
                </c:pt>
                <c:pt idx="345">
                  <c:v>27.8</c:v>
                </c:pt>
                <c:pt idx="346">
                  <c:v>27.7</c:v>
                </c:pt>
                <c:pt idx="347">
                  <c:v>27.6</c:v>
                </c:pt>
                <c:pt idx="348">
                  <c:v>27.5</c:v>
                </c:pt>
                <c:pt idx="349">
                  <c:v>27.4</c:v>
                </c:pt>
                <c:pt idx="350">
                  <c:v>27.3</c:v>
                </c:pt>
                <c:pt idx="351">
                  <c:v>27.3</c:v>
                </c:pt>
                <c:pt idx="352">
                  <c:v>27.4</c:v>
                </c:pt>
                <c:pt idx="353">
                  <c:v>27.3</c:v>
                </c:pt>
                <c:pt idx="354">
                  <c:v>27.2</c:v>
                </c:pt>
                <c:pt idx="355">
                  <c:v>27.1</c:v>
                </c:pt>
                <c:pt idx="356">
                  <c:v>27.1</c:v>
                </c:pt>
                <c:pt idx="357">
                  <c:v>27.2</c:v>
                </c:pt>
                <c:pt idx="358">
                  <c:v>27.2</c:v>
                </c:pt>
                <c:pt idx="359">
                  <c:v>27.7</c:v>
                </c:pt>
                <c:pt idx="360">
                  <c:v>27.7</c:v>
                </c:pt>
                <c:pt idx="361">
                  <c:v>27.9</c:v>
                </c:pt>
                <c:pt idx="362">
                  <c:v>27.9</c:v>
                </c:pt>
                <c:pt idx="363">
                  <c:v>28</c:v>
                </c:pt>
                <c:pt idx="364">
                  <c:v>28.2</c:v>
                </c:pt>
                <c:pt idx="365">
                  <c:v>28.3</c:v>
                </c:pt>
                <c:pt idx="366">
                  <c:v>28.3</c:v>
                </c:pt>
                <c:pt idx="367">
                  <c:v>28.2</c:v>
                </c:pt>
                <c:pt idx="368">
                  <c:v>28.1</c:v>
                </c:pt>
                <c:pt idx="369">
                  <c:v>28</c:v>
                </c:pt>
                <c:pt idx="370">
                  <c:v>27.8</c:v>
                </c:pt>
                <c:pt idx="371">
                  <c:v>27.8</c:v>
                </c:pt>
                <c:pt idx="372">
                  <c:v>27.7</c:v>
                </c:pt>
                <c:pt idx="373">
                  <c:v>27.6</c:v>
                </c:pt>
                <c:pt idx="374">
                  <c:v>27.5</c:v>
                </c:pt>
                <c:pt idx="375">
                  <c:v>27.3</c:v>
                </c:pt>
                <c:pt idx="376">
                  <c:v>27.2</c:v>
                </c:pt>
                <c:pt idx="377">
                  <c:v>27.1</c:v>
                </c:pt>
                <c:pt idx="378">
                  <c:v>26.8</c:v>
                </c:pt>
                <c:pt idx="379">
                  <c:v>25.5</c:v>
                </c:pt>
                <c:pt idx="380">
                  <c:v>25.6</c:v>
                </c:pt>
                <c:pt idx="381">
                  <c:v>26.8</c:v>
                </c:pt>
                <c:pt idx="382">
                  <c:v>27.1</c:v>
                </c:pt>
                <c:pt idx="383">
                  <c:v>27.4</c:v>
                </c:pt>
                <c:pt idx="384">
                  <c:v>28</c:v>
                </c:pt>
                <c:pt idx="385">
                  <c:v>28.3</c:v>
                </c:pt>
                <c:pt idx="386">
                  <c:v>28.4</c:v>
                </c:pt>
                <c:pt idx="387">
                  <c:v>28.3</c:v>
                </c:pt>
                <c:pt idx="388">
                  <c:v>28.2</c:v>
                </c:pt>
                <c:pt idx="389">
                  <c:v>28.1</c:v>
                </c:pt>
                <c:pt idx="390">
                  <c:v>27.8</c:v>
                </c:pt>
                <c:pt idx="391">
                  <c:v>27.6</c:v>
                </c:pt>
                <c:pt idx="392">
                  <c:v>27.6</c:v>
                </c:pt>
                <c:pt idx="393">
                  <c:v>27.5</c:v>
                </c:pt>
                <c:pt idx="394">
                  <c:v>27.5</c:v>
                </c:pt>
                <c:pt idx="395">
                  <c:v>27.4</c:v>
                </c:pt>
                <c:pt idx="396">
                  <c:v>27.4</c:v>
                </c:pt>
                <c:pt idx="397">
                  <c:v>27.3</c:v>
                </c:pt>
                <c:pt idx="398">
                  <c:v>27.3</c:v>
                </c:pt>
                <c:pt idx="399">
                  <c:v>27.3</c:v>
                </c:pt>
                <c:pt idx="400">
                  <c:v>27.3</c:v>
                </c:pt>
                <c:pt idx="401">
                  <c:v>26.5</c:v>
                </c:pt>
                <c:pt idx="402">
                  <c:v>25.8</c:v>
                </c:pt>
                <c:pt idx="403">
                  <c:v>26.7</c:v>
                </c:pt>
                <c:pt idx="404">
                  <c:v>27</c:v>
                </c:pt>
                <c:pt idx="405">
                  <c:v>27.5</c:v>
                </c:pt>
                <c:pt idx="406">
                  <c:v>27.6</c:v>
                </c:pt>
                <c:pt idx="407">
                  <c:v>27.6</c:v>
                </c:pt>
                <c:pt idx="408">
                  <c:v>27.6</c:v>
                </c:pt>
                <c:pt idx="409">
                  <c:v>27.5</c:v>
                </c:pt>
                <c:pt idx="410">
                  <c:v>27.4</c:v>
                </c:pt>
                <c:pt idx="411">
                  <c:v>27.3</c:v>
                </c:pt>
                <c:pt idx="412">
                  <c:v>27.3</c:v>
                </c:pt>
                <c:pt idx="413">
                  <c:v>27.1</c:v>
                </c:pt>
                <c:pt idx="414">
                  <c:v>26.8</c:v>
                </c:pt>
                <c:pt idx="415">
                  <c:v>26.4</c:v>
                </c:pt>
                <c:pt idx="416">
                  <c:v>26.2</c:v>
                </c:pt>
                <c:pt idx="417">
                  <c:v>26</c:v>
                </c:pt>
                <c:pt idx="418">
                  <c:v>25.8</c:v>
                </c:pt>
                <c:pt idx="419">
                  <c:v>25.6</c:v>
                </c:pt>
                <c:pt idx="420">
                  <c:v>25.4</c:v>
                </c:pt>
                <c:pt idx="421">
                  <c:v>25.3</c:v>
                </c:pt>
                <c:pt idx="422">
                  <c:v>25.2</c:v>
                </c:pt>
                <c:pt idx="423">
                  <c:v>25.1</c:v>
                </c:pt>
                <c:pt idx="424">
                  <c:v>25</c:v>
                </c:pt>
                <c:pt idx="425">
                  <c:v>24.7</c:v>
                </c:pt>
                <c:pt idx="426">
                  <c:v>23.8</c:v>
                </c:pt>
                <c:pt idx="427">
                  <c:v>23.7</c:v>
                </c:pt>
                <c:pt idx="428">
                  <c:v>24.1</c:v>
                </c:pt>
                <c:pt idx="429">
                  <c:v>24.9</c:v>
                </c:pt>
                <c:pt idx="430">
                  <c:v>25.5</c:v>
                </c:pt>
                <c:pt idx="431">
                  <c:v>25.9</c:v>
                </c:pt>
                <c:pt idx="432">
                  <c:v>26</c:v>
                </c:pt>
                <c:pt idx="433">
                  <c:v>26</c:v>
                </c:pt>
                <c:pt idx="434">
                  <c:v>25.8</c:v>
                </c:pt>
                <c:pt idx="435">
                  <c:v>25.7</c:v>
                </c:pt>
                <c:pt idx="436">
                  <c:v>25.6</c:v>
                </c:pt>
                <c:pt idx="437">
                  <c:v>25.3</c:v>
                </c:pt>
                <c:pt idx="438">
                  <c:v>25</c:v>
                </c:pt>
                <c:pt idx="439">
                  <c:v>24.8</c:v>
                </c:pt>
                <c:pt idx="440">
                  <c:v>24.6</c:v>
                </c:pt>
                <c:pt idx="441">
                  <c:v>24.5</c:v>
                </c:pt>
                <c:pt idx="442">
                  <c:v>24.5</c:v>
                </c:pt>
                <c:pt idx="443">
                  <c:v>24.5</c:v>
                </c:pt>
                <c:pt idx="444">
                  <c:v>24.5</c:v>
                </c:pt>
                <c:pt idx="445">
                  <c:v>24.5</c:v>
                </c:pt>
                <c:pt idx="446">
                  <c:v>24.6</c:v>
                </c:pt>
                <c:pt idx="447">
                  <c:v>24.8</c:v>
                </c:pt>
                <c:pt idx="448">
                  <c:v>25</c:v>
                </c:pt>
                <c:pt idx="449">
                  <c:v>25.2</c:v>
                </c:pt>
                <c:pt idx="450">
                  <c:v>25.4</c:v>
                </c:pt>
                <c:pt idx="451">
                  <c:v>25.5</c:v>
                </c:pt>
                <c:pt idx="452">
                  <c:v>25.7</c:v>
                </c:pt>
                <c:pt idx="453">
                  <c:v>26</c:v>
                </c:pt>
                <c:pt idx="454">
                  <c:v>26.4</c:v>
                </c:pt>
                <c:pt idx="455">
                  <c:v>26.7</c:v>
                </c:pt>
                <c:pt idx="456">
                  <c:v>26.8</c:v>
                </c:pt>
                <c:pt idx="457">
                  <c:v>27.1</c:v>
                </c:pt>
                <c:pt idx="458">
                  <c:v>27.3</c:v>
                </c:pt>
                <c:pt idx="459">
                  <c:v>27.3</c:v>
                </c:pt>
                <c:pt idx="460">
                  <c:v>27.2</c:v>
                </c:pt>
                <c:pt idx="461">
                  <c:v>26.9</c:v>
                </c:pt>
                <c:pt idx="462">
                  <c:v>26.5</c:v>
                </c:pt>
                <c:pt idx="463">
                  <c:v>26.2</c:v>
                </c:pt>
                <c:pt idx="464">
                  <c:v>25.9</c:v>
                </c:pt>
                <c:pt idx="465">
                  <c:v>25.8</c:v>
                </c:pt>
                <c:pt idx="466">
                  <c:v>25.8</c:v>
                </c:pt>
                <c:pt idx="467">
                  <c:v>25.6</c:v>
                </c:pt>
                <c:pt idx="468">
                  <c:v>25.5</c:v>
                </c:pt>
                <c:pt idx="469">
                  <c:v>25.3</c:v>
                </c:pt>
                <c:pt idx="470">
                  <c:v>25.1</c:v>
                </c:pt>
                <c:pt idx="471">
                  <c:v>25.1</c:v>
                </c:pt>
                <c:pt idx="472">
                  <c:v>25.1</c:v>
                </c:pt>
                <c:pt idx="473">
                  <c:v>24.1</c:v>
                </c:pt>
                <c:pt idx="474">
                  <c:v>23.4</c:v>
                </c:pt>
                <c:pt idx="475">
                  <c:v>23.7</c:v>
                </c:pt>
                <c:pt idx="476">
                  <c:v>24.2</c:v>
                </c:pt>
                <c:pt idx="477">
                  <c:v>25.1</c:v>
                </c:pt>
                <c:pt idx="478">
                  <c:v>25.8</c:v>
                </c:pt>
                <c:pt idx="479">
                  <c:v>25.8</c:v>
                </c:pt>
                <c:pt idx="480">
                  <c:v>25.9</c:v>
                </c:pt>
                <c:pt idx="481">
                  <c:v>25.8</c:v>
                </c:pt>
                <c:pt idx="482">
                  <c:v>25.8</c:v>
                </c:pt>
                <c:pt idx="483">
                  <c:v>25.9</c:v>
                </c:pt>
                <c:pt idx="484">
                  <c:v>25.8</c:v>
                </c:pt>
                <c:pt idx="485">
                  <c:v>25.7</c:v>
                </c:pt>
                <c:pt idx="486">
                  <c:v>25.6</c:v>
                </c:pt>
                <c:pt idx="487">
                  <c:v>25.4</c:v>
                </c:pt>
                <c:pt idx="488">
                  <c:v>25.2</c:v>
                </c:pt>
                <c:pt idx="489">
                  <c:v>25</c:v>
                </c:pt>
                <c:pt idx="490">
                  <c:v>24.9</c:v>
                </c:pt>
                <c:pt idx="491">
                  <c:v>24.9</c:v>
                </c:pt>
                <c:pt idx="492">
                  <c:v>25.1</c:v>
                </c:pt>
                <c:pt idx="493">
                  <c:v>25.3</c:v>
                </c:pt>
                <c:pt idx="494">
                  <c:v>25.6</c:v>
                </c:pt>
                <c:pt idx="495">
                  <c:v>25.8</c:v>
                </c:pt>
                <c:pt idx="496">
                  <c:v>26</c:v>
                </c:pt>
                <c:pt idx="497">
                  <c:v>26.1</c:v>
                </c:pt>
                <c:pt idx="498">
                  <c:v>26.2</c:v>
                </c:pt>
                <c:pt idx="499">
                  <c:v>26</c:v>
                </c:pt>
                <c:pt idx="500">
                  <c:v>26</c:v>
                </c:pt>
                <c:pt idx="501">
                  <c:v>26.2</c:v>
                </c:pt>
                <c:pt idx="502">
                  <c:v>26.4</c:v>
                </c:pt>
                <c:pt idx="503">
                  <c:v>26.6</c:v>
                </c:pt>
                <c:pt idx="504">
                  <c:v>26.9</c:v>
                </c:pt>
                <c:pt idx="505">
                  <c:v>26.7</c:v>
                </c:pt>
                <c:pt idx="506">
                  <c:v>26.5</c:v>
                </c:pt>
                <c:pt idx="507">
                  <c:v>26.6</c:v>
                </c:pt>
                <c:pt idx="508">
                  <c:v>26.7</c:v>
                </c:pt>
                <c:pt idx="509">
                  <c:v>26.8</c:v>
                </c:pt>
                <c:pt idx="510">
                  <c:v>26.9</c:v>
                </c:pt>
                <c:pt idx="511">
                  <c:v>26.9</c:v>
                </c:pt>
                <c:pt idx="512">
                  <c:v>26.9</c:v>
                </c:pt>
                <c:pt idx="513">
                  <c:v>26.9</c:v>
                </c:pt>
                <c:pt idx="514">
                  <c:v>27</c:v>
                </c:pt>
                <c:pt idx="515">
                  <c:v>27</c:v>
                </c:pt>
                <c:pt idx="516">
                  <c:v>27</c:v>
                </c:pt>
                <c:pt idx="517">
                  <c:v>27</c:v>
                </c:pt>
                <c:pt idx="518">
                  <c:v>27</c:v>
                </c:pt>
                <c:pt idx="519">
                  <c:v>27</c:v>
                </c:pt>
                <c:pt idx="520">
                  <c:v>27</c:v>
                </c:pt>
                <c:pt idx="521">
                  <c:v>26.9</c:v>
                </c:pt>
                <c:pt idx="522">
                  <c:v>26.9</c:v>
                </c:pt>
                <c:pt idx="523">
                  <c:v>26.7</c:v>
                </c:pt>
                <c:pt idx="524">
                  <c:v>26.5</c:v>
                </c:pt>
                <c:pt idx="525">
                  <c:v>26.5</c:v>
                </c:pt>
                <c:pt idx="526">
                  <c:v>26.7</c:v>
                </c:pt>
                <c:pt idx="527">
                  <c:v>26.9</c:v>
                </c:pt>
                <c:pt idx="528">
                  <c:v>27.2</c:v>
                </c:pt>
                <c:pt idx="529">
                  <c:v>27.4</c:v>
                </c:pt>
                <c:pt idx="530">
                  <c:v>27.5</c:v>
                </c:pt>
                <c:pt idx="531">
                  <c:v>27.6</c:v>
                </c:pt>
                <c:pt idx="532">
                  <c:v>27.7</c:v>
                </c:pt>
                <c:pt idx="533">
                  <c:v>27.7</c:v>
                </c:pt>
                <c:pt idx="534">
                  <c:v>27.7</c:v>
                </c:pt>
                <c:pt idx="535">
                  <c:v>27.6</c:v>
                </c:pt>
                <c:pt idx="536">
                  <c:v>27.6</c:v>
                </c:pt>
                <c:pt idx="537">
                  <c:v>27.5</c:v>
                </c:pt>
                <c:pt idx="538">
                  <c:v>27.4</c:v>
                </c:pt>
                <c:pt idx="539">
                  <c:v>27.4</c:v>
                </c:pt>
                <c:pt idx="540">
                  <c:v>27.3</c:v>
                </c:pt>
                <c:pt idx="541">
                  <c:v>27.3</c:v>
                </c:pt>
                <c:pt idx="542">
                  <c:v>27.2</c:v>
                </c:pt>
                <c:pt idx="543">
                  <c:v>27.2</c:v>
                </c:pt>
                <c:pt idx="544">
                  <c:v>27.1</c:v>
                </c:pt>
                <c:pt idx="545">
                  <c:v>26.5</c:v>
                </c:pt>
                <c:pt idx="546">
                  <c:v>25.4</c:v>
                </c:pt>
                <c:pt idx="547">
                  <c:v>25</c:v>
                </c:pt>
                <c:pt idx="548">
                  <c:v>25.6</c:v>
                </c:pt>
                <c:pt idx="549">
                  <c:v>26.6</c:v>
                </c:pt>
                <c:pt idx="550">
                  <c:v>27.2</c:v>
                </c:pt>
                <c:pt idx="551">
                  <c:v>27.5</c:v>
                </c:pt>
                <c:pt idx="552">
                  <c:v>27.7</c:v>
                </c:pt>
                <c:pt idx="553">
                  <c:v>27.8</c:v>
                </c:pt>
                <c:pt idx="554">
                  <c:v>27.9</c:v>
                </c:pt>
                <c:pt idx="555">
                  <c:v>28</c:v>
                </c:pt>
                <c:pt idx="556">
                  <c:v>28</c:v>
                </c:pt>
                <c:pt idx="557">
                  <c:v>28</c:v>
                </c:pt>
                <c:pt idx="558">
                  <c:v>28.1</c:v>
                </c:pt>
                <c:pt idx="559">
                  <c:v>28</c:v>
                </c:pt>
                <c:pt idx="560">
                  <c:v>28</c:v>
                </c:pt>
                <c:pt idx="561">
                  <c:v>27.9</c:v>
                </c:pt>
                <c:pt idx="562">
                  <c:v>27.8</c:v>
                </c:pt>
                <c:pt idx="563">
                  <c:v>27.8</c:v>
                </c:pt>
                <c:pt idx="564">
                  <c:v>27.8</c:v>
                </c:pt>
                <c:pt idx="565">
                  <c:v>27.8</c:v>
                </c:pt>
                <c:pt idx="566">
                  <c:v>27.8</c:v>
                </c:pt>
                <c:pt idx="567">
                  <c:v>27.8</c:v>
                </c:pt>
                <c:pt idx="568">
                  <c:v>27.8</c:v>
                </c:pt>
                <c:pt idx="569">
                  <c:v>27.8</c:v>
                </c:pt>
                <c:pt idx="570">
                  <c:v>27.7</c:v>
                </c:pt>
                <c:pt idx="571">
                  <c:v>27</c:v>
                </c:pt>
                <c:pt idx="572">
                  <c:v>26.9</c:v>
                </c:pt>
                <c:pt idx="573">
                  <c:v>27.4</c:v>
                </c:pt>
                <c:pt idx="574">
                  <c:v>27.8</c:v>
                </c:pt>
                <c:pt idx="575">
                  <c:v>28.1</c:v>
                </c:pt>
                <c:pt idx="576">
                  <c:v>28.5</c:v>
                </c:pt>
                <c:pt idx="577">
                  <c:v>28.6</c:v>
                </c:pt>
                <c:pt idx="578">
                  <c:v>28.7</c:v>
                </c:pt>
                <c:pt idx="579">
                  <c:v>28.8</c:v>
                </c:pt>
                <c:pt idx="580">
                  <c:v>28.9</c:v>
                </c:pt>
                <c:pt idx="581">
                  <c:v>29</c:v>
                </c:pt>
                <c:pt idx="582">
                  <c:v>29.1</c:v>
                </c:pt>
                <c:pt idx="583">
                  <c:v>29</c:v>
                </c:pt>
                <c:pt idx="584">
                  <c:v>28.9</c:v>
                </c:pt>
                <c:pt idx="585">
                  <c:v>28.8</c:v>
                </c:pt>
                <c:pt idx="586">
                  <c:v>28.7</c:v>
                </c:pt>
                <c:pt idx="587">
                  <c:v>28.6</c:v>
                </c:pt>
                <c:pt idx="588">
                  <c:v>28.5</c:v>
                </c:pt>
                <c:pt idx="589">
                  <c:v>28.5</c:v>
                </c:pt>
                <c:pt idx="590">
                  <c:v>28.3</c:v>
                </c:pt>
                <c:pt idx="591">
                  <c:v>28.3</c:v>
                </c:pt>
                <c:pt idx="592">
                  <c:v>28.2</c:v>
                </c:pt>
                <c:pt idx="593">
                  <c:v>28</c:v>
                </c:pt>
                <c:pt idx="594">
                  <c:v>27.7</c:v>
                </c:pt>
                <c:pt idx="595">
                  <c:v>28.2</c:v>
                </c:pt>
                <c:pt idx="596">
                  <c:v>28.7</c:v>
                </c:pt>
                <c:pt idx="597">
                  <c:v>28.6</c:v>
                </c:pt>
                <c:pt idx="598">
                  <c:v>28.4</c:v>
                </c:pt>
                <c:pt idx="599">
                  <c:v>28.4</c:v>
                </c:pt>
                <c:pt idx="600">
                  <c:v>28.4</c:v>
                </c:pt>
                <c:pt idx="601">
                  <c:v>28.5</c:v>
                </c:pt>
                <c:pt idx="602">
                  <c:v>28.4</c:v>
                </c:pt>
                <c:pt idx="603">
                  <c:v>28.3</c:v>
                </c:pt>
                <c:pt idx="604">
                  <c:v>28.2</c:v>
                </c:pt>
                <c:pt idx="605">
                  <c:v>28</c:v>
                </c:pt>
                <c:pt idx="606">
                  <c:v>27.9</c:v>
                </c:pt>
                <c:pt idx="607">
                  <c:v>27.8</c:v>
                </c:pt>
                <c:pt idx="608">
                  <c:v>27.7</c:v>
                </c:pt>
                <c:pt idx="609">
                  <c:v>27.6</c:v>
                </c:pt>
                <c:pt idx="610">
                  <c:v>27.5</c:v>
                </c:pt>
                <c:pt idx="611">
                  <c:v>27.4</c:v>
                </c:pt>
                <c:pt idx="612">
                  <c:v>27.4</c:v>
                </c:pt>
                <c:pt idx="613">
                  <c:v>27.3</c:v>
                </c:pt>
                <c:pt idx="614">
                  <c:v>27.2</c:v>
                </c:pt>
                <c:pt idx="615">
                  <c:v>27.2</c:v>
                </c:pt>
                <c:pt idx="616">
                  <c:v>27.1</c:v>
                </c:pt>
                <c:pt idx="617">
                  <c:v>26.3</c:v>
                </c:pt>
                <c:pt idx="618">
                  <c:v>25.6</c:v>
                </c:pt>
                <c:pt idx="619">
                  <c:v>25.7</c:v>
                </c:pt>
                <c:pt idx="620">
                  <c:v>26.2</c:v>
                </c:pt>
                <c:pt idx="621">
                  <c:v>26.6</c:v>
                </c:pt>
                <c:pt idx="622">
                  <c:v>27</c:v>
                </c:pt>
                <c:pt idx="623">
                  <c:v>27.2</c:v>
                </c:pt>
                <c:pt idx="624">
                  <c:v>27.3</c:v>
                </c:pt>
                <c:pt idx="625">
                  <c:v>27.4</c:v>
                </c:pt>
                <c:pt idx="626">
                  <c:v>27.6</c:v>
                </c:pt>
                <c:pt idx="627">
                  <c:v>27.5</c:v>
                </c:pt>
                <c:pt idx="628">
                  <c:v>27.6</c:v>
                </c:pt>
                <c:pt idx="629">
                  <c:v>27.6</c:v>
                </c:pt>
                <c:pt idx="630">
                  <c:v>27.5</c:v>
                </c:pt>
                <c:pt idx="631">
                  <c:v>27.5</c:v>
                </c:pt>
                <c:pt idx="632">
                  <c:v>27.5</c:v>
                </c:pt>
                <c:pt idx="633">
                  <c:v>27.5</c:v>
                </c:pt>
                <c:pt idx="634">
                  <c:v>27.6</c:v>
                </c:pt>
                <c:pt idx="635">
                  <c:v>27.6</c:v>
                </c:pt>
                <c:pt idx="636">
                  <c:v>27.6</c:v>
                </c:pt>
                <c:pt idx="637">
                  <c:v>27.6</c:v>
                </c:pt>
                <c:pt idx="638">
                  <c:v>27.6</c:v>
                </c:pt>
                <c:pt idx="639">
                  <c:v>27.6</c:v>
                </c:pt>
                <c:pt idx="640">
                  <c:v>27.7</c:v>
                </c:pt>
                <c:pt idx="641">
                  <c:v>27.7</c:v>
                </c:pt>
                <c:pt idx="642">
                  <c:v>27.6</c:v>
                </c:pt>
                <c:pt idx="643">
                  <c:v>27.5</c:v>
                </c:pt>
                <c:pt idx="644">
                  <c:v>27.5</c:v>
                </c:pt>
                <c:pt idx="645">
                  <c:v>27.4</c:v>
                </c:pt>
                <c:pt idx="646">
                  <c:v>27.7</c:v>
                </c:pt>
                <c:pt idx="647">
                  <c:v>27.9</c:v>
                </c:pt>
                <c:pt idx="648">
                  <c:v>27.9</c:v>
                </c:pt>
                <c:pt idx="649">
                  <c:v>28.2</c:v>
                </c:pt>
                <c:pt idx="650">
                  <c:v>28.4</c:v>
                </c:pt>
                <c:pt idx="651">
                  <c:v>28.6</c:v>
                </c:pt>
                <c:pt idx="652">
                  <c:v>28.7</c:v>
                </c:pt>
                <c:pt idx="653">
                  <c:v>28.8</c:v>
                </c:pt>
                <c:pt idx="654">
                  <c:v>28.7</c:v>
                </c:pt>
                <c:pt idx="655">
                  <c:v>28.7</c:v>
                </c:pt>
                <c:pt idx="656">
                  <c:v>28.8</c:v>
                </c:pt>
                <c:pt idx="657">
                  <c:v>28.8</c:v>
                </c:pt>
                <c:pt idx="658">
                  <c:v>28.7</c:v>
                </c:pt>
                <c:pt idx="659">
                  <c:v>28.6</c:v>
                </c:pt>
                <c:pt idx="660">
                  <c:v>28.5</c:v>
                </c:pt>
                <c:pt idx="661">
                  <c:v>28.4</c:v>
                </c:pt>
                <c:pt idx="662">
                  <c:v>28.3</c:v>
                </c:pt>
                <c:pt idx="663">
                  <c:v>28.2</c:v>
                </c:pt>
                <c:pt idx="664">
                  <c:v>28.1</c:v>
                </c:pt>
                <c:pt idx="665">
                  <c:v>26.8</c:v>
                </c:pt>
                <c:pt idx="666">
                  <c:v>26.3</c:v>
                </c:pt>
                <c:pt idx="667">
                  <c:v>24.1</c:v>
                </c:pt>
                <c:pt idx="668">
                  <c:v>23.9</c:v>
                </c:pt>
                <c:pt idx="669">
                  <c:v>24.8</c:v>
                </c:pt>
                <c:pt idx="670">
                  <c:v>25.7</c:v>
                </c:pt>
                <c:pt idx="671">
                  <c:v>26.6</c:v>
                </c:pt>
                <c:pt idx="672">
                  <c:v>27.2</c:v>
                </c:pt>
                <c:pt idx="673">
                  <c:v>27.5</c:v>
                </c:pt>
                <c:pt idx="674">
                  <c:v>27.7</c:v>
                </c:pt>
                <c:pt idx="675">
                  <c:v>27.9</c:v>
                </c:pt>
                <c:pt idx="676">
                  <c:v>28.2</c:v>
                </c:pt>
                <c:pt idx="677">
                  <c:v>28.4</c:v>
                </c:pt>
                <c:pt idx="678">
                  <c:v>28.7</c:v>
                </c:pt>
                <c:pt idx="679">
                  <c:v>29</c:v>
                </c:pt>
                <c:pt idx="680">
                  <c:v>29.2</c:v>
                </c:pt>
                <c:pt idx="681">
                  <c:v>29.4</c:v>
                </c:pt>
                <c:pt idx="682">
                  <c:v>29.6</c:v>
                </c:pt>
                <c:pt idx="683">
                  <c:v>29.7</c:v>
                </c:pt>
                <c:pt idx="684">
                  <c:v>29.8</c:v>
                </c:pt>
                <c:pt idx="685">
                  <c:v>29.8</c:v>
                </c:pt>
                <c:pt idx="686">
                  <c:v>29.8</c:v>
                </c:pt>
                <c:pt idx="687">
                  <c:v>29.8</c:v>
                </c:pt>
                <c:pt idx="688">
                  <c:v>29.6</c:v>
                </c:pt>
                <c:pt idx="689">
                  <c:v>28.3</c:v>
                </c:pt>
                <c:pt idx="690">
                  <c:v>27.8</c:v>
                </c:pt>
                <c:pt idx="691">
                  <c:v>27.6</c:v>
                </c:pt>
                <c:pt idx="692">
                  <c:v>27.9</c:v>
                </c:pt>
                <c:pt idx="693">
                  <c:v>28.2</c:v>
                </c:pt>
                <c:pt idx="694">
                  <c:v>28.6</c:v>
                </c:pt>
                <c:pt idx="695">
                  <c:v>29</c:v>
                </c:pt>
                <c:pt idx="696">
                  <c:v>29.1</c:v>
                </c:pt>
                <c:pt idx="697">
                  <c:v>28.9</c:v>
                </c:pt>
                <c:pt idx="698">
                  <c:v>28.7</c:v>
                </c:pt>
                <c:pt idx="699">
                  <c:v>28.6</c:v>
                </c:pt>
                <c:pt idx="700">
                  <c:v>28.4</c:v>
                </c:pt>
                <c:pt idx="701">
                  <c:v>28.2</c:v>
                </c:pt>
                <c:pt idx="702">
                  <c:v>27.8</c:v>
                </c:pt>
                <c:pt idx="703">
                  <c:v>27.6</c:v>
                </c:pt>
                <c:pt idx="704">
                  <c:v>27.5</c:v>
                </c:pt>
                <c:pt idx="705">
                  <c:v>27.6</c:v>
                </c:pt>
                <c:pt idx="706">
                  <c:v>27.6</c:v>
                </c:pt>
                <c:pt idx="707">
                  <c:v>27.6</c:v>
                </c:pt>
                <c:pt idx="708">
                  <c:v>27.6</c:v>
                </c:pt>
                <c:pt idx="709">
                  <c:v>27.5</c:v>
                </c:pt>
                <c:pt idx="710">
                  <c:v>27.6</c:v>
                </c:pt>
                <c:pt idx="711">
                  <c:v>27.6</c:v>
                </c:pt>
                <c:pt idx="712">
                  <c:v>27.5</c:v>
                </c:pt>
                <c:pt idx="713">
                  <c:v>27.4</c:v>
                </c:pt>
                <c:pt idx="714">
                  <c:v>26.8</c:v>
                </c:pt>
                <c:pt idx="715">
                  <c:v>26.5</c:v>
                </c:pt>
                <c:pt idx="716">
                  <c:v>26.5</c:v>
                </c:pt>
                <c:pt idx="717">
                  <c:v>26.8</c:v>
                </c:pt>
                <c:pt idx="718">
                  <c:v>27.2</c:v>
                </c:pt>
                <c:pt idx="719">
                  <c:v>27.6</c:v>
                </c:pt>
                <c:pt idx="720">
                  <c:v>27.9</c:v>
                </c:pt>
                <c:pt idx="721">
                  <c:v>28.2</c:v>
                </c:pt>
                <c:pt idx="722">
                  <c:v>28.4</c:v>
                </c:pt>
                <c:pt idx="723">
                  <c:v>28.7</c:v>
                </c:pt>
                <c:pt idx="724">
                  <c:v>29</c:v>
                </c:pt>
                <c:pt idx="725">
                  <c:v>29.3</c:v>
                </c:pt>
                <c:pt idx="726">
                  <c:v>29.4</c:v>
                </c:pt>
                <c:pt idx="727">
                  <c:v>29.4</c:v>
                </c:pt>
                <c:pt idx="728">
                  <c:v>29.5</c:v>
                </c:pt>
                <c:pt idx="729">
                  <c:v>29.3</c:v>
                </c:pt>
                <c:pt idx="730">
                  <c:v>29.3</c:v>
                </c:pt>
                <c:pt idx="731">
                  <c:v>29.1</c:v>
                </c:pt>
                <c:pt idx="732">
                  <c:v>28.9</c:v>
                </c:pt>
                <c:pt idx="733">
                  <c:v>28.7</c:v>
                </c:pt>
                <c:pt idx="734">
                  <c:v>28.5</c:v>
                </c:pt>
                <c:pt idx="735">
                  <c:v>28.3</c:v>
                </c:pt>
                <c:pt idx="736">
                  <c:v>27.8</c:v>
                </c:pt>
                <c:pt idx="737">
                  <c:v>26</c:v>
                </c:pt>
                <c:pt idx="738">
                  <c:v>25.5</c:v>
                </c:pt>
                <c:pt idx="739">
                  <c:v>25.5</c:v>
                </c:pt>
                <c:pt idx="740">
                  <c:v>25.9</c:v>
                </c:pt>
                <c:pt idx="741">
                  <c:v>26.6</c:v>
                </c:pt>
                <c:pt idx="742">
                  <c:v>27.3</c:v>
                </c:pt>
                <c:pt idx="743">
                  <c:v>27.4</c:v>
                </c:pt>
                <c:pt idx="744">
                  <c:v>27.3</c:v>
                </c:pt>
                <c:pt idx="745">
                  <c:v>27.1</c:v>
                </c:pt>
                <c:pt idx="746">
                  <c:v>26.9</c:v>
                </c:pt>
                <c:pt idx="747">
                  <c:v>27</c:v>
                </c:pt>
                <c:pt idx="748">
                  <c:v>27</c:v>
                </c:pt>
                <c:pt idx="749">
                  <c:v>26.9</c:v>
                </c:pt>
                <c:pt idx="750">
                  <c:v>26.8</c:v>
                </c:pt>
                <c:pt idx="751">
                  <c:v>26.7</c:v>
                </c:pt>
                <c:pt idx="752">
                  <c:v>26.6</c:v>
                </c:pt>
                <c:pt idx="753">
                  <c:v>26.6</c:v>
                </c:pt>
                <c:pt idx="754">
                  <c:v>26.6</c:v>
                </c:pt>
                <c:pt idx="755">
                  <c:v>26.7</c:v>
                </c:pt>
                <c:pt idx="756">
                  <c:v>26.8</c:v>
                </c:pt>
                <c:pt idx="757">
                  <c:v>27</c:v>
                </c:pt>
                <c:pt idx="758">
                  <c:v>27.1</c:v>
                </c:pt>
                <c:pt idx="759">
                  <c:v>27.1</c:v>
                </c:pt>
                <c:pt idx="760">
                  <c:v>26.7</c:v>
                </c:pt>
                <c:pt idx="761">
                  <c:v>25.3</c:v>
                </c:pt>
                <c:pt idx="762">
                  <c:v>24.8</c:v>
                </c:pt>
                <c:pt idx="763">
                  <c:v>24.9</c:v>
                </c:pt>
                <c:pt idx="764">
                  <c:v>25.5</c:v>
                </c:pt>
                <c:pt idx="765">
                  <c:v>26.1</c:v>
                </c:pt>
                <c:pt idx="766">
                  <c:v>26.2</c:v>
                </c:pt>
                <c:pt idx="767">
                  <c:v>26.1</c:v>
                </c:pt>
                <c:pt idx="768">
                  <c:v>26</c:v>
                </c:pt>
                <c:pt idx="769">
                  <c:v>25.8</c:v>
                </c:pt>
                <c:pt idx="770">
                  <c:v>25.6</c:v>
                </c:pt>
                <c:pt idx="771">
                  <c:v>25.4</c:v>
                </c:pt>
                <c:pt idx="772">
                  <c:v>25.2</c:v>
                </c:pt>
                <c:pt idx="773">
                  <c:v>25</c:v>
                </c:pt>
                <c:pt idx="774">
                  <c:v>24.8</c:v>
                </c:pt>
                <c:pt idx="775">
                  <c:v>24.5</c:v>
                </c:pt>
                <c:pt idx="776">
                  <c:v>24.2</c:v>
                </c:pt>
                <c:pt idx="777">
                  <c:v>24</c:v>
                </c:pt>
                <c:pt idx="778">
                  <c:v>23.9</c:v>
                </c:pt>
                <c:pt idx="779">
                  <c:v>23.8</c:v>
                </c:pt>
                <c:pt idx="780">
                  <c:v>23.7</c:v>
                </c:pt>
                <c:pt idx="781">
                  <c:v>23.6</c:v>
                </c:pt>
                <c:pt idx="782">
                  <c:v>23.6</c:v>
                </c:pt>
                <c:pt idx="783">
                  <c:v>23.5</c:v>
                </c:pt>
                <c:pt idx="784">
                  <c:v>23</c:v>
                </c:pt>
                <c:pt idx="785">
                  <c:v>21.5</c:v>
                </c:pt>
                <c:pt idx="786">
                  <c:v>21.2</c:v>
                </c:pt>
                <c:pt idx="787">
                  <c:v>21.4</c:v>
                </c:pt>
                <c:pt idx="788">
                  <c:v>21.9</c:v>
                </c:pt>
                <c:pt idx="789">
                  <c:v>22.6</c:v>
                </c:pt>
                <c:pt idx="790">
                  <c:v>23.3</c:v>
                </c:pt>
                <c:pt idx="791">
                  <c:v>23.7</c:v>
                </c:pt>
                <c:pt idx="792">
                  <c:v>24</c:v>
                </c:pt>
                <c:pt idx="793">
                  <c:v>24.1</c:v>
                </c:pt>
                <c:pt idx="794">
                  <c:v>24.2</c:v>
                </c:pt>
                <c:pt idx="795">
                  <c:v>24.3</c:v>
                </c:pt>
                <c:pt idx="796">
                  <c:v>24.4</c:v>
                </c:pt>
                <c:pt idx="797">
                  <c:v>24.4</c:v>
                </c:pt>
                <c:pt idx="798">
                  <c:v>24.4</c:v>
                </c:pt>
                <c:pt idx="799">
                  <c:v>24.4</c:v>
                </c:pt>
                <c:pt idx="800">
                  <c:v>24.3</c:v>
                </c:pt>
                <c:pt idx="801">
                  <c:v>24.4</c:v>
                </c:pt>
                <c:pt idx="802">
                  <c:v>24.4</c:v>
                </c:pt>
                <c:pt idx="803">
                  <c:v>24.5</c:v>
                </c:pt>
                <c:pt idx="804">
                  <c:v>24.5</c:v>
                </c:pt>
                <c:pt idx="805">
                  <c:v>24.5</c:v>
                </c:pt>
                <c:pt idx="806">
                  <c:v>24.5</c:v>
                </c:pt>
                <c:pt idx="807">
                  <c:v>24.5</c:v>
                </c:pt>
                <c:pt idx="808">
                  <c:v>24.5</c:v>
                </c:pt>
                <c:pt idx="809">
                  <c:v>24.5</c:v>
                </c:pt>
                <c:pt idx="810">
                  <c:v>24.4</c:v>
                </c:pt>
                <c:pt idx="811">
                  <c:v>24.4</c:v>
                </c:pt>
                <c:pt idx="812">
                  <c:v>24.5</c:v>
                </c:pt>
                <c:pt idx="813">
                  <c:v>24.7</c:v>
                </c:pt>
                <c:pt idx="814">
                  <c:v>24.9</c:v>
                </c:pt>
                <c:pt idx="815">
                  <c:v>25</c:v>
                </c:pt>
                <c:pt idx="816">
                  <c:v>25</c:v>
                </c:pt>
                <c:pt idx="817">
                  <c:v>24.9</c:v>
                </c:pt>
                <c:pt idx="818">
                  <c:v>24.9</c:v>
                </c:pt>
                <c:pt idx="819">
                  <c:v>24.9</c:v>
                </c:pt>
                <c:pt idx="820">
                  <c:v>24.8</c:v>
                </c:pt>
                <c:pt idx="821">
                  <c:v>24.6</c:v>
                </c:pt>
                <c:pt idx="822">
                  <c:v>24.5</c:v>
                </c:pt>
                <c:pt idx="823">
                  <c:v>24.3</c:v>
                </c:pt>
                <c:pt idx="824">
                  <c:v>24.1</c:v>
                </c:pt>
                <c:pt idx="825">
                  <c:v>23.9</c:v>
                </c:pt>
                <c:pt idx="826">
                  <c:v>23.8</c:v>
                </c:pt>
                <c:pt idx="827">
                  <c:v>23.6</c:v>
                </c:pt>
                <c:pt idx="828">
                  <c:v>23.6</c:v>
                </c:pt>
                <c:pt idx="829">
                  <c:v>23.5</c:v>
                </c:pt>
                <c:pt idx="830">
                  <c:v>23.4</c:v>
                </c:pt>
                <c:pt idx="831">
                  <c:v>23.4</c:v>
                </c:pt>
                <c:pt idx="832">
                  <c:v>23.1</c:v>
                </c:pt>
                <c:pt idx="833">
                  <c:v>21.6</c:v>
                </c:pt>
                <c:pt idx="834">
                  <c:v>21.2</c:v>
                </c:pt>
                <c:pt idx="835">
                  <c:v>21.6</c:v>
                </c:pt>
                <c:pt idx="836">
                  <c:v>22.2</c:v>
                </c:pt>
                <c:pt idx="837">
                  <c:v>22.6</c:v>
                </c:pt>
                <c:pt idx="838">
                  <c:v>23.1</c:v>
                </c:pt>
                <c:pt idx="839">
                  <c:v>23.5</c:v>
                </c:pt>
                <c:pt idx="840">
                  <c:v>23.7</c:v>
                </c:pt>
                <c:pt idx="841">
                  <c:v>23.6</c:v>
                </c:pt>
                <c:pt idx="842">
                  <c:v>23.5</c:v>
                </c:pt>
                <c:pt idx="843">
                  <c:v>23.5</c:v>
                </c:pt>
                <c:pt idx="844">
                  <c:v>23.6</c:v>
                </c:pt>
                <c:pt idx="845">
                  <c:v>23.7</c:v>
                </c:pt>
                <c:pt idx="846">
                  <c:v>23.7</c:v>
                </c:pt>
                <c:pt idx="847">
                  <c:v>23.7</c:v>
                </c:pt>
                <c:pt idx="848">
                  <c:v>23.6</c:v>
                </c:pt>
                <c:pt idx="849">
                  <c:v>23.6</c:v>
                </c:pt>
                <c:pt idx="850">
                  <c:v>23.5</c:v>
                </c:pt>
                <c:pt idx="851">
                  <c:v>23.5</c:v>
                </c:pt>
                <c:pt idx="852">
                  <c:v>23.5</c:v>
                </c:pt>
                <c:pt idx="853">
                  <c:v>23.4</c:v>
                </c:pt>
                <c:pt idx="854">
                  <c:v>23.4</c:v>
                </c:pt>
                <c:pt idx="855">
                  <c:v>23.4</c:v>
                </c:pt>
                <c:pt idx="856">
                  <c:v>23.4</c:v>
                </c:pt>
                <c:pt idx="857">
                  <c:v>23.3</c:v>
                </c:pt>
                <c:pt idx="858">
                  <c:v>23.2</c:v>
                </c:pt>
                <c:pt idx="859">
                  <c:v>23</c:v>
                </c:pt>
                <c:pt idx="860">
                  <c:v>22.7</c:v>
                </c:pt>
                <c:pt idx="861">
                  <c:v>22.8</c:v>
                </c:pt>
                <c:pt idx="862">
                  <c:v>23.1</c:v>
                </c:pt>
                <c:pt idx="863">
                  <c:v>23.2</c:v>
                </c:pt>
                <c:pt idx="864">
                  <c:v>23.3</c:v>
                </c:pt>
                <c:pt idx="865">
                  <c:v>23.2</c:v>
                </c:pt>
                <c:pt idx="866">
                  <c:v>23.2</c:v>
                </c:pt>
                <c:pt idx="867">
                  <c:v>23.2</c:v>
                </c:pt>
                <c:pt idx="868">
                  <c:v>23.2</c:v>
                </c:pt>
                <c:pt idx="869">
                  <c:v>23.2</c:v>
                </c:pt>
                <c:pt idx="870">
                  <c:v>23.2</c:v>
                </c:pt>
                <c:pt idx="871">
                  <c:v>23.4</c:v>
                </c:pt>
                <c:pt idx="872">
                  <c:v>23.5</c:v>
                </c:pt>
                <c:pt idx="873">
                  <c:v>23.6</c:v>
                </c:pt>
                <c:pt idx="874">
                  <c:v>23.8</c:v>
                </c:pt>
                <c:pt idx="875">
                  <c:v>23.9</c:v>
                </c:pt>
                <c:pt idx="876">
                  <c:v>23.9</c:v>
                </c:pt>
                <c:pt idx="877">
                  <c:v>23.8</c:v>
                </c:pt>
                <c:pt idx="878">
                  <c:v>23.8</c:v>
                </c:pt>
                <c:pt idx="879">
                  <c:v>23.8</c:v>
                </c:pt>
                <c:pt idx="880">
                  <c:v>23.8</c:v>
                </c:pt>
                <c:pt idx="881">
                  <c:v>23.7</c:v>
                </c:pt>
                <c:pt idx="882">
                  <c:v>23.1</c:v>
                </c:pt>
                <c:pt idx="883">
                  <c:v>22.9</c:v>
                </c:pt>
                <c:pt idx="884">
                  <c:v>22.5</c:v>
                </c:pt>
                <c:pt idx="885">
                  <c:v>22.6</c:v>
                </c:pt>
                <c:pt idx="886">
                  <c:v>23.1</c:v>
                </c:pt>
                <c:pt idx="887">
                  <c:v>23.4</c:v>
                </c:pt>
                <c:pt idx="888">
                  <c:v>23.6</c:v>
                </c:pt>
                <c:pt idx="889">
                  <c:v>23.6</c:v>
                </c:pt>
                <c:pt idx="890">
                  <c:v>23.6</c:v>
                </c:pt>
                <c:pt idx="891">
                  <c:v>23.7</c:v>
                </c:pt>
                <c:pt idx="892">
                  <c:v>23.6</c:v>
                </c:pt>
                <c:pt idx="893">
                  <c:v>23.6</c:v>
                </c:pt>
                <c:pt idx="894">
                  <c:v>23.5</c:v>
                </c:pt>
                <c:pt idx="895">
                  <c:v>23.3</c:v>
                </c:pt>
                <c:pt idx="896">
                  <c:v>23.2</c:v>
                </c:pt>
                <c:pt idx="897">
                  <c:v>23.1</c:v>
                </c:pt>
                <c:pt idx="898">
                  <c:v>23</c:v>
                </c:pt>
                <c:pt idx="899">
                  <c:v>23</c:v>
                </c:pt>
                <c:pt idx="900">
                  <c:v>23</c:v>
                </c:pt>
                <c:pt idx="901">
                  <c:v>22.9</c:v>
                </c:pt>
                <c:pt idx="902">
                  <c:v>22.9</c:v>
                </c:pt>
                <c:pt idx="903">
                  <c:v>22.8</c:v>
                </c:pt>
                <c:pt idx="904">
                  <c:v>22.3</c:v>
                </c:pt>
                <c:pt idx="905">
                  <c:v>21.1</c:v>
                </c:pt>
                <c:pt idx="906">
                  <c:v>21.2</c:v>
                </c:pt>
                <c:pt idx="907">
                  <c:v>21</c:v>
                </c:pt>
                <c:pt idx="908">
                  <c:v>21.3</c:v>
                </c:pt>
                <c:pt idx="909">
                  <c:v>21.8</c:v>
                </c:pt>
                <c:pt idx="910">
                  <c:v>22.2</c:v>
                </c:pt>
                <c:pt idx="911">
                  <c:v>22.5</c:v>
                </c:pt>
                <c:pt idx="912">
                  <c:v>22.7</c:v>
                </c:pt>
                <c:pt idx="913">
                  <c:v>22.8</c:v>
                </c:pt>
                <c:pt idx="914">
                  <c:v>23</c:v>
                </c:pt>
                <c:pt idx="915">
                  <c:v>23</c:v>
                </c:pt>
                <c:pt idx="916">
                  <c:v>23.1</c:v>
                </c:pt>
                <c:pt idx="917">
                  <c:v>23.1</c:v>
                </c:pt>
                <c:pt idx="918">
                  <c:v>23.2</c:v>
                </c:pt>
                <c:pt idx="919">
                  <c:v>23.2</c:v>
                </c:pt>
                <c:pt idx="920">
                  <c:v>23.2</c:v>
                </c:pt>
                <c:pt idx="921">
                  <c:v>23.2</c:v>
                </c:pt>
                <c:pt idx="922">
                  <c:v>23.3</c:v>
                </c:pt>
                <c:pt idx="923">
                  <c:v>23.3</c:v>
                </c:pt>
                <c:pt idx="924">
                  <c:v>23.4</c:v>
                </c:pt>
                <c:pt idx="925">
                  <c:v>23.5</c:v>
                </c:pt>
                <c:pt idx="926">
                  <c:v>23.5</c:v>
                </c:pt>
                <c:pt idx="927">
                  <c:v>23.5</c:v>
                </c:pt>
                <c:pt idx="928">
                  <c:v>23.6</c:v>
                </c:pt>
                <c:pt idx="929">
                  <c:v>23.8</c:v>
                </c:pt>
                <c:pt idx="930">
                  <c:v>24.1</c:v>
                </c:pt>
                <c:pt idx="931">
                  <c:v>24.4</c:v>
                </c:pt>
                <c:pt idx="932">
                  <c:v>24.5</c:v>
                </c:pt>
                <c:pt idx="933">
                  <c:v>24.5</c:v>
                </c:pt>
                <c:pt idx="934">
                  <c:v>24.7</c:v>
                </c:pt>
                <c:pt idx="935">
                  <c:v>24.9</c:v>
                </c:pt>
                <c:pt idx="936">
                  <c:v>25.1</c:v>
                </c:pt>
                <c:pt idx="937">
                  <c:v>25.3</c:v>
                </c:pt>
                <c:pt idx="938">
                  <c:v>25.4</c:v>
                </c:pt>
                <c:pt idx="939">
                  <c:v>25.4</c:v>
                </c:pt>
                <c:pt idx="940">
                  <c:v>25.4</c:v>
                </c:pt>
                <c:pt idx="941">
                  <c:v>25.6</c:v>
                </c:pt>
                <c:pt idx="942">
                  <c:v>25.7</c:v>
                </c:pt>
                <c:pt idx="943">
                  <c:v>25.8</c:v>
                </c:pt>
                <c:pt idx="944">
                  <c:v>26</c:v>
                </c:pt>
                <c:pt idx="945">
                  <c:v>26.1</c:v>
                </c:pt>
                <c:pt idx="946">
                  <c:v>26.2</c:v>
                </c:pt>
                <c:pt idx="947">
                  <c:v>26.4</c:v>
                </c:pt>
                <c:pt idx="948">
                  <c:v>26.5</c:v>
                </c:pt>
                <c:pt idx="949">
                  <c:v>26.6</c:v>
                </c:pt>
                <c:pt idx="950">
                  <c:v>26.8</c:v>
                </c:pt>
                <c:pt idx="951">
                  <c:v>27</c:v>
                </c:pt>
                <c:pt idx="952">
                  <c:v>27.2</c:v>
                </c:pt>
                <c:pt idx="953">
                  <c:v>27.4</c:v>
                </c:pt>
                <c:pt idx="954">
                  <c:v>26.8</c:v>
                </c:pt>
                <c:pt idx="955">
                  <c:v>26.6</c:v>
                </c:pt>
                <c:pt idx="956">
                  <c:v>26.9</c:v>
                </c:pt>
                <c:pt idx="957">
                  <c:v>27.3</c:v>
                </c:pt>
                <c:pt idx="958">
                  <c:v>27.5</c:v>
                </c:pt>
                <c:pt idx="959">
                  <c:v>27.8</c:v>
                </c:pt>
                <c:pt idx="960">
                  <c:v>27.8</c:v>
                </c:pt>
                <c:pt idx="961">
                  <c:v>27.8</c:v>
                </c:pt>
                <c:pt idx="962">
                  <c:v>27.9</c:v>
                </c:pt>
                <c:pt idx="963">
                  <c:v>28</c:v>
                </c:pt>
                <c:pt idx="964">
                  <c:v>28.1</c:v>
                </c:pt>
                <c:pt idx="965">
                  <c:v>28.3</c:v>
                </c:pt>
                <c:pt idx="966">
                  <c:v>28.8</c:v>
                </c:pt>
                <c:pt idx="967">
                  <c:v>29.3</c:v>
                </c:pt>
                <c:pt idx="968">
                  <c:v>29.5</c:v>
                </c:pt>
                <c:pt idx="969">
                  <c:v>29.5</c:v>
                </c:pt>
                <c:pt idx="970">
                  <c:v>29.3</c:v>
                </c:pt>
                <c:pt idx="971">
                  <c:v>29</c:v>
                </c:pt>
                <c:pt idx="972">
                  <c:v>28.7</c:v>
                </c:pt>
                <c:pt idx="973">
                  <c:v>28.4</c:v>
                </c:pt>
                <c:pt idx="974">
                  <c:v>28.1</c:v>
                </c:pt>
                <c:pt idx="975">
                  <c:v>28</c:v>
                </c:pt>
                <c:pt idx="976">
                  <c:v>27.8</c:v>
                </c:pt>
                <c:pt idx="977">
                  <c:v>27.6</c:v>
                </c:pt>
                <c:pt idx="978">
                  <c:v>27.4</c:v>
                </c:pt>
                <c:pt idx="979">
                  <c:v>27.1</c:v>
                </c:pt>
                <c:pt idx="980">
                  <c:v>26.6</c:v>
                </c:pt>
                <c:pt idx="981">
                  <c:v>26.4</c:v>
                </c:pt>
                <c:pt idx="982">
                  <c:v>26.4</c:v>
                </c:pt>
                <c:pt idx="983">
                  <c:v>26.5</c:v>
                </c:pt>
                <c:pt idx="984">
                  <c:v>26.4</c:v>
                </c:pt>
                <c:pt idx="985">
                  <c:v>26.2</c:v>
                </c:pt>
                <c:pt idx="986">
                  <c:v>26.1</c:v>
                </c:pt>
                <c:pt idx="987">
                  <c:v>26</c:v>
                </c:pt>
                <c:pt idx="988">
                  <c:v>25.9</c:v>
                </c:pt>
                <c:pt idx="989">
                  <c:v>25.8</c:v>
                </c:pt>
                <c:pt idx="990">
                  <c:v>25.6</c:v>
                </c:pt>
                <c:pt idx="991">
                  <c:v>25.5</c:v>
                </c:pt>
                <c:pt idx="992">
                  <c:v>25.3</c:v>
                </c:pt>
                <c:pt idx="993">
                  <c:v>25.2</c:v>
                </c:pt>
                <c:pt idx="994">
                  <c:v>25.1</c:v>
                </c:pt>
                <c:pt idx="995">
                  <c:v>25.1</c:v>
                </c:pt>
                <c:pt idx="996">
                  <c:v>25</c:v>
                </c:pt>
                <c:pt idx="997">
                  <c:v>25</c:v>
                </c:pt>
                <c:pt idx="998">
                  <c:v>25</c:v>
                </c:pt>
                <c:pt idx="999">
                  <c:v>24.9</c:v>
                </c:pt>
                <c:pt idx="1000">
                  <c:v>24.5</c:v>
                </c:pt>
                <c:pt idx="1001">
                  <c:v>23</c:v>
                </c:pt>
                <c:pt idx="1002">
                  <c:v>22.5</c:v>
                </c:pt>
                <c:pt idx="1003">
                  <c:v>22.8</c:v>
                </c:pt>
                <c:pt idx="1004">
                  <c:v>23.3</c:v>
                </c:pt>
                <c:pt idx="1005">
                  <c:v>23.9</c:v>
                </c:pt>
                <c:pt idx="1006">
                  <c:v>24.5</c:v>
                </c:pt>
                <c:pt idx="1007">
                  <c:v>24.8</c:v>
                </c:pt>
                <c:pt idx="1008">
                  <c:v>24.9</c:v>
                </c:pt>
                <c:pt idx="1009">
                  <c:v>24.8</c:v>
                </c:pt>
                <c:pt idx="1010">
                  <c:v>24.7</c:v>
                </c:pt>
                <c:pt idx="1011">
                  <c:v>24.7</c:v>
                </c:pt>
                <c:pt idx="1012">
                  <c:v>24.6</c:v>
                </c:pt>
                <c:pt idx="1013">
                  <c:v>24.6</c:v>
                </c:pt>
                <c:pt idx="1014">
                  <c:v>24.6</c:v>
                </c:pt>
                <c:pt idx="1015">
                  <c:v>24.6</c:v>
                </c:pt>
                <c:pt idx="1016">
                  <c:v>24.4</c:v>
                </c:pt>
                <c:pt idx="1017">
                  <c:v>24.4</c:v>
                </c:pt>
                <c:pt idx="1018">
                  <c:v>24.4</c:v>
                </c:pt>
                <c:pt idx="1019">
                  <c:v>24.4</c:v>
                </c:pt>
                <c:pt idx="1020">
                  <c:v>24.3</c:v>
                </c:pt>
                <c:pt idx="1021">
                  <c:v>24.3</c:v>
                </c:pt>
                <c:pt idx="1022">
                  <c:v>24.2</c:v>
                </c:pt>
                <c:pt idx="1023">
                  <c:v>24.1</c:v>
                </c:pt>
                <c:pt idx="1024">
                  <c:v>23.7</c:v>
                </c:pt>
                <c:pt idx="1025">
                  <c:v>23</c:v>
                </c:pt>
                <c:pt idx="1026">
                  <c:v>22.5</c:v>
                </c:pt>
                <c:pt idx="1027">
                  <c:v>22.7</c:v>
                </c:pt>
                <c:pt idx="1028">
                  <c:v>23.2</c:v>
                </c:pt>
                <c:pt idx="1029">
                  <c:v>23.8</c:v>
                </c:pt>
                <c:pt idx="1030">
                  <c:v>24.1</c:v>
                </c:pt>
                <c:pt idx="1031">
                  <c:v>24.1</c:v>
                </c:pt>
                <c:pt idx="1032">
                  <c:v>24.1</c:v>
                </c:pt>
                <c:pt idx="1033">
                  <c:v>24</c:v>
                </c:pt>
                <c:pt idx="1034">
                  <c:v>23.8</c:v>
                </c:pt>
                <c:pt idx="1035">
                  <c:v>23.7</c:v>
                </c:pt>
                <c:pt idx="1036">
                  <c:v>23.7</c:v>
                </c:pt>
                <c:pt idx="1037">
                  <c:v>23.6</c:v>
                </c:pt>
                <c:pt idx="1038">
                  <c:v>23.5</c:v>
                </c:pt>
                <c:pt idx="1039">
                  <c:v>23.3</c:v>
                </c:pt>
                <c:pt idx="1040">
                  <c:v>23.2</c:v>
                </c:pt>
                <c:pt idx="1041">
                  <c:v>23.1</c:v>
                </c:pt>
                <c:pt idx="1042">
                  <c:v>23</c:v>
                </c:pt>
                <c:pt idx="1043">
                  <c:v>22.9</c:v>
                </c:pt>
                <c:pt idx="1044">
                  <c:v>22.8</c:v>
                </c:pt>
                <c:pt idx="1045">
                  <c:v>22.7</c:v>
                </c:pt>
                <c:pt idx="1046">
                  <c:v>22.7</c:v>
                </c:pt>
                <c:pt idx="1047">
                  <c:v>22.7</c:v>
                </c:pt>
                <c:pt idx="1048">
                  <c:v>22.6</c:v>
                </c:pt>
                <c:pt idx="1049">
                  <c:v>22.5</c:v>
                </c:pt>
                <c:pt idx="1050">
                  <c:v>22.4</c:v>
                </c:pt>
                <c:pt idx="1051">
                  <c:v>22.1</c:v>
                </c:pt>
                <c:pt idx="1052">
                  <c:v>22.2</c:v>
                </c:pt>
                <c:pt idx="1053">
                  <c:v>22.4</c:v>
                </c:pt>
                <c:pt idx="1054">
                  <c:v>22.7</c:v>
                </c:pt>
                <c:pt idx="1055">
                  <c:v>22.8</c:v>
                </c:pt>
                <c:pt idx="1056">
                  <c:v>22.8</c:v>
                </c:pt>
                <c:pt idx="1057">
                  <c:v>22.8</c:v>
                </c:pt>
                <c:pt idx="1058">
                  <c:v>22.7</c:v>
                </c:pt>
                <c:pt idx="1059">
                  <c:v>22.5</c:v>
                </c:pt>
                <c:pt idx="1060">
                  <c:v>22.4</c:v>
                </c:pt>
                <c:pt idx="1061">
                  <c:v>22.3</c:v>
                </c:pt>
                <c:pt idx="1062">
                  <c:v>22.2</c:v>
                </c:pt>
                <c:pt idx="1063">
                  <c:v>22.3</c:v>
                </c:pt>
                <c:pt idx="1064">
                  <c:v>22.4</c:v>
                </c:pt>
                <c:pt idx="1065">
                  <c:v>22.5</c:v>
                </c:pt>
                <c:pt idx="1066">
                  <c:v>22.6</c:v>
                </c:pt>
                <c:pt idx="1067">
                  <c:v>22.8</c:v>
                </c:pt>
                <c:pt idx="1068">
                  <c:v>22.9</c:v>
                </c:pt>
                <c:pt idx="1069">
                  <c:v>23</c:v>
                </c:pt>
                <c:pt idx="1070">
                  <c:v>23.1</c:v>
                </c:pt>
                <c:pt idx="1071">
                  <c:v>23.1</c:v>
                </c:pt>
                <c:pt idx="1072">
                  <c:v>23.1</c:v>
                </c:pt>
                <c:pt idx="1073">
                  <c:v>22.9</c:v>
                </c:pt>
                <c:pt idx="1074">
                  <c:v>22.3</c:v>
                </c:pt>
                <c:pt idx="1075">
                  <c:v>22.1</c:v>
                </c:pt>
                <c:pt idx="1076">
                  <c:v>22.5</c:v>
                </c:pt>
                <c:pt idx="1077">
                  <c:v>22.8</c:v>
                </c:pt>
                <c:pt idx="1078">
                  <c:v>23.1</c:v>
                </c:pt>
                <c:pt idx="1079">
                  <c:v>23.3</c:v>
                </c:pt>
                <c:pt idx="1080">
                  <c:v>23.4</c:v>
                </c:pt>
                <c:pt idx="1081">
                  <c:v>23.2</c:v>
                </c:pt>
                <c:pt idx="1082">
                  <c:v>23.2</c:v>
                </c:pt>
                <c:pt idx="1083">
                  <c:v>23.3</c:v>
                </c:pt>
                <c:pt idx="1084">
                  <c:v>23.4</c:v>
                </c:pt>
                <c:pt idx="1085">
                  <c:v>23.4</c:v>
                </c:pt>
                <c:pt idx="1086">
                  <c:v>23.4</c:v>
                </c:pt>
                <c:pt idx="1087">
                  <c:v>23.2</c:v>
                </c:pt>
                <c:pt idx="1088">
                  <c:v>23</c:v>
                </c:pt>
                <c:pt idx="1089">
                  <c:v>22.8</c:v>
                </c:pt>
                <c:pt idx="1090">
                  <c:v>22.7</c:v>
                </c:pt>
                <c:pt idx="1091">
                  <c:v>22.7</c:v>
                </c:pt>
                <c:pt idx="1092">
                  <c:v>22.7</c:v>
                </c:pt>
                <c:pt idx="1093">
                  <c:v>22.7</c:v>
                </c:pt>
                <c:pt idx="1094">
                  <c:v>22.7</c:v>
                </c:pt>
                <c:pt idx="1095">
                  <c:v>22.7</c:v>
                </c:pt>
                <c:pt idx="1096">
                  <c:v>22.7</c:v>
                </c:pt>
                <c:pt idx="1097">
                  <c:v>22.8</c:v>
                </c:pt>
                <c:pt idx="1098">
                  <c:v>22.8</c:v>
                </c:pt>
                <c:pt idx="1099">
                  <c:v>22.8</c:v>
                </c:pt>
                <c:pt idx="1100">
                  <c:v>22.7</c:v>
                </c:pt>
                <c:pt idx="1101">
                  <c:v>22.7</c:v>
                </c:pt>
                <c:pt idx="1102">
                  <c:v>22.9</c:v>
                </c:pt>
                <c:pt idx="1103">
                  <c:v>23.3</c:v>
                </c:pt>
                <c:pt idx="1104">
                  <c:v>23.6</c:v>
                </c:pt>
                <c:pt idx="1105">
                  <c:v>23.8</c:v>
                </c:pt>
                <c:pt idx="1106">
                  <c:v>24</c:v>
                </c:pt>
                <c:pt idx="1107">
                  <c:v>24.2</c:v>
                </c:pt>
                <c:pt idx="1108">
                  <c:v>24.4</c:v>
                </c:pt>
                <c:pt idx="1109">
                  <c:v>24.7</c:v>
                </c:pt>
                <c:pt idx="1110">
                  <c:v>24.9</c:v>
                </c:pt>
                <c:pt idx="1111">
                  <c:v>25.1</c:v>
                </c:pt>
                <c:pt idx="1112">
                  <c:v>25.4</c:v>
                </c:pt>
                <c:pt idx="1113">
                  <c:v>25.8</c:v>
                </c:pt>
                <c:pt idx="1114">
                  <c:v>26.1</c:v>
                </c:pt>
                <c:pt idx="1115">
                  <c:v>26.3</c:v>
                </c:pt>
                <c:pt idx="1116">
                  <c:v>26.4</c:v>
                </c:pt>
                <c:pt idx="1117">
                  <c:v>26.5</c:v>
                </c:pt>
                <c:pt idx="1118">
                  <c:v>26.5</c:v>
                </c:pt>
                <c:pt idx="1119">
                  <c:v>26.6</c:v>
                </c:pt>
                <c:pt idx="1120">
                  <c:v>26.7</c:v>
                </c:pt>
                <c:pt idx="1121">
                  <c:v>26.8</c:v>
                </c:pt>
                <c:pt idx="1122">
                  <c:v>26.8</c:v>
                </c:pt>
                <c:pt idx="1123">
                  <c:v>26.9</c:v>
                </c:pt>
                <c:pt idx="1124">
                  <c:v>27</c:v>
                </c:pt>
                <c:pt idx="1125">
                  <c:v>26.8</c:v>
                </c:pt>
                <c:pt idx="1126">
                  <c:v>26.7</c:v>
                </c:pt>
                <c:pt idx="1127">
                  <c:v>27.1</c:v>
                </c:pt>
                <c:pt idx="1128">
                  <c:v>27.5</c:v>
                </c:pt>
                <c:pt idx="1129">
                  <c:v>27.8</c:v>
                </c:pt>
                <c:pt idx="1130">
                  <c:v>28</c:v>
                </c:pt>
                <c:pt idx="1131">
                  <c:v>28.3</c:v>
                </c:pt>
                <c:pt idx="1132">
                  <c:v>28.7</c:v>
                </c:pt>
                <c:pt idx="1133">
                  <c:v>28.9</c:v>
                </c:pt>
                <c:pt idx="1134">
                  <c:v>29.1</c:v>
                </c:pt>
                <c:pt idx="1135">
                  <c:v>29.1</c:v>
                </c:pt>
                <c:pt idx="1136">
                  <c:v>29.1</c:v>
                </c:pt>
                <c:pt idx="1137">
                  <c:v>29.1</c:v>
                </c:pt>
                <c:pt idx="1138">
                  <c:v>29.1</c:v>
                </c:pt>
                <c:pt idx="1139">
                  <c:v>29.1</c:v>
                </c:pt>
                <c:pt idx="1140">
                  <c:v>29</c:v>
                </c:pt>
                <c:pt idx="1141">
                  <c:v>29</c:v>
                </c:pt>
                <c:pt idx="1142">
                  <c:v>29</c:v>
                </c:pt>
                <c:pt idx="1143">
                  <c:v>28.9</c:v>
                </c:pt>
                <c:pt idx="1144">
                  <c:v>28.8</c:v>
                </c:pt>
                <c:pt idx="1145">
                  <c:v>28.6</c:v>
                </c:pt>
                <c:pt idx="1146">
                  <c:v>28.5</c:v>
                </c:pt>
                <c:pt idx="1147">
                  <c:v>28.3</c:v>
                </c:pt>
                <c:pt idx="1148">
                  <c:v>28.6</c:v>
                </c:pt>
                <c:pt idx="1149">
                  <c:v>28.8</c:v>
                </c:pt>
                <c:pt idx="1150">
                  <c:v>29.1</c:v>
                </c:pt>
                <c:pt idx="1151">
                  <c:v>29.2</c:v>
                </c:pt>
                <c:pt idx="1152">
                  <c:v>29.4</c:v>
                </c:pt>
                <c:pt idx="1153">
                  <c:v>29.6</c:v>
                </c:pt>
                <c:pt idx="1154">
                  <c:v>29.8</c:v>
                </c:pt>
                <c:pt idx="1155">
                  <c:v>30.1</c:v>
                </c:pt>
                <c:pt idx="1156">
                  <c:v>30.4</c:v>
                </c:pt>
                <c:pt idx="1157">
                  <c:v>30.8</c:v>
                </c:pt>
                <c:pt idx="1158">
                  <c:v>31.2</c:v>
                </c:pt>
                <c:pt idx="1159">
                  <c:v>31.2</c:v>
                </c:pt>
                <c:pt idx="1160">
                  <c:v>31.2</c:v>
                </c:pt>
                <c:pt idx="1161">
                  <c:v>31.2</c:v>
                </c:pt>
                <c:pt idx="1162">
                  <c:v>31.2</c:v>
                </c:pt>
                <c:pt idx="1163">
                  <c:v>31.1</c:v>
                </c:pt>
                <c:pt idx="1164">
                  <c:v>30.8</c:v>
                </c:pt>
                <c:pt idx="1165">
                  <c:v>30.6</c:v>
                </c:pt>
                <c:pt idx="1166">
                  <c:v>30.4</c:v>
                </c:pt>
                <c:pt idx="1167">
                  <c:v>30.2</c:v>
                </c:pt>
                <c:pt idx="1168">
                  <c:v>29.1</c:v>
                </c:pt>
                <c:pt idx="1169">
                  <c:v>28</c:v>
                </c:pt>
                <c:pt idx="1170">
                  <c:v>27.5</c:v>
                </c:pt>
                <c:pt idx="1171">
                  <c:v>27.7</c:v>
                </c:pt>
                <c:pt idx="1172">
                  <c:v>28</c:v>
                </c:pt>
                <c:pt idx="1173">
                  <c:v>28.7</c:v>
                </c:pt>
                <c:pt idx="1174">
                  <c:v>29.1</c:v>
                </c:pt>
                <c:pt idx="1175">
                  <c:v>29.3</c:v>
                </c:pt>
                <c:pt idx="1176">
                  <c:v>29.2</c:v>
                </c:pt>
                <c:pt idx="1177">
                  <c:v>29.1</c:v>
                </c:pt>
                <c:pt idx="1178">
                  <c:v>29.1</c:v>
                </c:pt>
                <c:pt idx="1179">
                  <c:v>29</c:v>
                </c:pt>
                <c:pt idx="1180">
                  <c:v>28.8</c:v>
                </c:pt>
                <c:pt idx="1181">
                  <c:v>28.5</c:v>
                </c:pt>
                <c:pt idx="1182">
                  <c:v>28.3</c:v>
                </c:pt>
                <c:pt idx="1183">
                  <c:v>28.1</c:v>
                </c:pt>
                <c:pt idx="1184">
                  <c:v>27.9</c:v>
                </c:pt>
                <c:pt idx="1185">
                  <c:v>27.8</c:v>
                </c:pt>
                <c:pt idx="1186">
                  <c:v>27.7</c:v>
                </c:pt>
                <c:pt idx="1187">
                  <c:v>27.6</c:v>
                </c:pt>
                <c:pt idx="1188">
                  <c:v>27.6</c:v>
                </c:pt>
                <c:pt idx="1189">
                  <c:v>27.7</c:v>
                </c:pt>
                <c:pt idx="1190">
                  <c:v>27.6</c:v>
                </c:pt>
                <c:pt idx="1191">
                  <c:v>27.5</c:v>
                </c:pt>
                <c:pt idx="1192">
                  <c:v>26.4</c:v>
                </c:pt>
                <c:pt idx="1193">
                  <c:v>25.4</c:v>
                </c:pt>
                <c:pt idx="1194">
                  <c:v>25.4</c:v>
                </c:pt>
                <c:pt idx="1195">
                  <c:v>26.4</c:v>
                </c:pt>
                <c:pt idx="1196">
                  <c:v>26.4</c:v>
                </c:pt>
                <c:pt idx="1197">
                  <c:v>26.1</c:v>
                </c:pt>
                <c:pt idx="1198">
                  <c:v>26</c:v>
                </c:pt>
                <c:pt idx="1199">
                  <c:v>25.9</c:v>
                </c:pt>
                <c:pt idx="1200">
                  <c:v>25.8</c:v>
                </c:pt>
                <c:pt idx="1201">
                  <c:v>25.7</c:v>
                </c:pt>
                <c:pt idx="1202">
                  <c:v>25.7</c:v>
                </c:pt>
                <c:pt idx="1203">
                  <c:v>25.9</c:v>
                </c:pt>
                <c:pt idx="1204">
                  <c:v>25.9</c:v>
                </c:pt>
                <c:pt idx="1205">
                  <c:v>26</c:v>
                </c:pt>
                <c:pt idx="1206">
                  <c:v>26.2</c:v>
                </c:pt>
                <c:pt idx="1207">
                  <c:v>26.3</c:v>
                </c:pt>
                <c:pt idx="1208">
                  <c:v>26.2</c:v>
                </c:pt>
                <c:pt idx="1209">
                  <c:v>26.1</c:v>
                </c:pt>
                <c:pt idx="1210">
                  <c:v>25.9</c:v>
                </c:pt>
                <c:pt idx="1211">
                  <c:v>25.6</c:v>
                </c:pt>
                <c:pt idx="1212">
                  <c:v>25.4</c:v>
                </c:pt>
                <c:pt idx="1213">
                  <c:v>25.1</c:v>
                </c:pt>
                <c:pt idx="1214">
                  <c:v>24.9</c:v>
                </c:pt>
                <c:pt idx="1215">
                  <c:v>24.7</c:v>
                </c:pt>
                <c:pt idx="1216">
                  <c:v>24.6</c:v>
                </c:pt>
                <c:pt idx="1217">
                  <c:v>24.4</c:v>
                </c:pt>
                <c:pt idx="1218">
                  <c:v>24.3</c:v>
                </c:pt>
                <c:pt idx="1219">
                  <c:v>24.2</c:v>
                </c:pt>
                <c:pt idx="1220">
                  <c:v>24.2</c:v>
                </c:pt>
                <c:pt idx="1221">
                  <c:v>24.3</c:v>
                </c:pt>
                <c:pt idx="1222">
                  <c:v>24.4</c:v>
                </c:pt>
                <c:pt idx="1223">
                  <c:v>24.4</c:v>
                </c:pt>
                <c:pt idx="1224">
                  <c:v>24.4</c:v>
                </c:pt>
                <c:pt idx="1225">
                  <c:v>24.3</c:v>
                </c:pt>
                <c:pt idx="1226">
                  <c:v>24.5</c:v>
                </c:pt>
                <c:pt idx="1227">
                  <c:v>24.6</c:v>
                </c:pt>
                <c:pt idx="1228">
                  <c:v>24.6</c:v>
                </c:pt>
                <c:pt idx="1229">
                  <c:v>24.6</c:v>
                </c:pt>
                <c:pt idx="1230">
                  <c:v>24.7</c:v>
                </c:pt>
                <c:pt idx="1231">
                  <c:v>24.7</c:v>
                </c:pt>
                <c:pt idx="1232">
                  <c:v>24.7</c:v>
                </c:pt>
                <c:pt idx="1233">
                  <c:v>24.6</c:v>
                </c:pt>
                <c:pt idx="1234">
                  <c:v>24.6</c:v>
                </c:pt>
                <c:pt idx="1235">
                  <c:v>24.6</c:v>
                </c:pt>
                <c:pt idx="1236">
                  <c:v>24.6</c:v>
                </c:pt>
                <c:pt idx="1237">
                  <c:v>24.7</c:v>
                </c:pt>
                <c:pt idx="1238">
                  <c:v>24.7</c:v>
                </c:pt>
                <c:pt idx="1239">
                  <c:v>24.8</c:v>
                </c:pt>
                <c:pt idx="1240">
                  <c:v>24.9</c:v>
                </c:pt>
                <c:pt idx="1241">
                  <c:v>24.9</c:v>
                </c:pt>
                <c:pt idx="1242">
                  <c:v>25</c:v>
                </c:pt>
                <c:pt idx="1243">
                  <c:v>25</c:v>
                </c:pt>
                <c:pt idx="1244">
                  <c:v>24.9</c:v>
                </c:pt>
                <c:pt idx="1245">
                  <c:v>24.9</c:v>
                </c:pt>
                <c:pt idx="1246">
                  <c:v>25</c:v>
                </c:pt>
                <c:pt idx="1247">
                  <c:v>25</c:v>
                </c:pt>
                <c:pt idx="1248">
                  <c:v>24.8</c:v>
                </c:pt>
                <c:pt idx="1249">
                  <c:v>24.7</c:v>
                </c:pt>
                <c:pt idx="1250">
                  <c:v>24.7</c:v>
                </c:pt>
                <c:pt idx="1251">
                  <c:v>24.6</c:v>
                </c:pt>
                <c:pt idx="1252">
                  <c:v>24.6</c:v>
                </c:pt>
                <c:pt idx="1253">
                  <c:v>24.5</c:v>
                </c:pt>
                <c:pt idx="1254">
                  <c:v>24.3</c:v>
                </c:pt>
                <c:pt idx="1255">
                  <c:v>24.1</c:v>
                </c:pt>
                <c:pt idx="1256">
                  <c:v>23.9</c:v>
                </c:pt>
                <c:pt idx="1257">
                  <c:v>23.7</c:v>
                </c:pt>
                <c:pt idx="1258">
                  <c:v>23.5</c:v>
                </c:pt>
                <c:pt idx="1259">
                  <c:v>23.4</c:v>
                </c:pt>
                <c:pt idx="1260">
                  <c:v>23.2</c:v>
                </c:pt>
                <c:pt idx="1261">
                  <c:v>23.2</c:v>
                </c:pt>
                <c:pt idx="1262">
                  <c:v>23.2</c:v>
                </c:pt>
                <c:pt idx="1263">
                  <c:v>23.3</c:v>
                </c:pt>
                <c:pt idx="1264">
                  <c:v>23.3</c:v>
                </c:pt>
                <c:pt idx="1265">
                  <c:v>23.2</c:v>
                </c:pt>
                <c:pt idx="1266">
                  <c:v>23.2</c:v>
                </c:pt>
                <c:pt idx="1267">
                  <c:v>23.6</c:v>
                </c:pt>
                <c:pt idx="1268">
                  <c:v>23.9</c:v>
                </c:pt>
                <c:pt idx="1269">
                  <c:v>24.3</c:v>
                </c:pt>
                <c:pt idx="1270">
                  <c:v>24.5</c:v>
                </c:pt>
                <c:pt idx="1271">
                  <c:v>24.5</c:v>
                </c:pt>
                <c:pt idx="1272">
                  <c:v>24.4</c:v>
                </c:pt>
                <c:pt idx="1273">
                  <c:v>24.4</c:v>
                </c:pt>
                <c:pt idx="1274">
                  <c:v>24.3</c:v>
                </c:pt>
                <c:pt idx="1275">
                  <c:v>24.2</c:v>
                </c:pt>
                <c:pt idx="1276">
                  <c:v>24.1</c:v>
                </c:pt>
                <c:pt idx="1277">
                  <c:v>24</c:v>
                </c:pt>
                <c:pt idx="1278">
                  <c:v>24</c:v>
                </c:pt>
                <c:pt idx="1279">
                  <c:v>23.9</c:v>
                </c:pt>
                <c:pt idx="1280">
                  <c:v>23.8</c:v>
                </c:pt>
                <c:pt idx="1281">
                  <c:v>23.8</c:v>
                </c:pt>
                <c:pt idx="1282">
                  <c:v>23.8</c:v>
                </c:pt>
                <c:pt idx="1283">
                  <c:v>23.7</c:v>
                </c:pt>
                <c:pt idx="1284">
                  <c:v>23.6</c:v>
                </c:pt>
                <c:pt idx="1285">
                  <c:v>23.5</c:v>
                </c:pt>
                <c:pt idx="1286">
                  <c:v>23.5</c:v>
                </c:pt>
                <c:pt idx="1287">
                  <c:v>23.4</c:v>
                </c:pt>
                <c:pt idx="1288">
                  <c:v>23.4</c:v>
                </c:pt>
                <c:pt idx="1289">
                  <c:v>23.4</c:v>
                </c:pt>
                <c:pt idx="1290">
                  <c:v>23.3</c:v>
                </c:pt>
                <c:pt idx="1291">
                  <c:v>23.3</c:v>
                </c:pt>
                <c:pt idx="1292">
                  <c:v>23.1</c:v>
                </c:pt>
                <c:pt idx="1293">
                  <c:v>23.1</c:v>
                </c:pt>
                <c:pt idx="1294">
                  <c:v>23.3</c:v>
                </c:pt>
                <c:pt idx="1295">
                  <c:v>23.3</c:v>
                </c:pt>
                <c:pt idx="1296">
                  <c:v>23.3</c:v>
                </c:pt>
                <c:pt idx="1297">
                  <c:v>23.2</c:v>
                </c:pt>
                <c:pt idx="1298">
                  <c:v>23.1</c:v>
                </c:pt>
                <c:pt idx="1299">
                  <c:v>22.9</c:v>
                </c:pt>
                <c:pt idx="1300">
                  <c:v>22.7</c:v>
                </c:pt>
                <c:pt idx="1301">
                  <c:v>22.6</c:v>
                </c:pt>
                <c:pt idx="1302">
                  <c:v>22.4</c:v>
                </c:pt>
                <c:pt idx="1303">
                  <c:v>22.2</c:v>
                </c:pt>
                <c:pt idx="1304">
                  <c:v>22</c:v>
                </c:pt>
                <c:pt idx="1305">
                  <c:v>21.9</c:v>
                </c:pt>
                <c:pt idx="1306">
                  <c:v>21.7</c:v>
                </c:pt>
                <c:pt idx="1307">
                  <c:v>21.7</c:v>
                </c:pt>
                <c:pt idx="1308">
                  <c:v>21.6</c:v>
                </c:pt>
                <c:pt idx="1309">
                  <c:v>21.4</c:v>
                </c:pt>
                <c:pt idx="1310">
                  <c:v>21.4</c:v>
                </c:pt>
                <c:pt idx="1311">
                  <c:v>21.3</c:v>
                </c:pt>
                <c:pt idx="1312">
                  <c:v>20.8</c:v>
                </c:pt>
                <c:pt idx="1313">
                  <c:v>20.6</c:v>
                </c:pt>
                <c:pt idx="1314">
                  <c:v>20.7</c:v>
                </c:pt>
                <c:pt idx="1315">
                  <c:v>20.9</c:v>
                </c:pt>
                <c:pt idx="1316">
                  <c:v>21.2</c:v>
                </c:pt>
                <c:pt idx="1317">
                  <c:v>21.4</c:v>
                </c:pt>
                <c:pt idx="1318">
                  <c:v>21.2</c:v>
                </c:pt>
                <c:pt idx="1319">
                  <c:v>21.3</c:v>
                </c:pt>
                <c:pt idx="1320">
                  <c:v>21.3</c:v>
                </c:pt>
                <c:pt idx="1321">
                  <c:v>21.2</c:v>
                </c:pt>
                <c:pt idx="1322">
                  <c:v>21.2</c:v>
                </c:pt>
                <c:pt idx="1323">
                  <c:v>21.2</c:v>
                </c:pt>
                <c:pt idx="1324">
                  <c:v>21.1</c:v>
                </c:pt>
                <c:pt idx="1325">
                  <c:v>21</c:v>
                </c:pt>
                <c:pt idx="1326">
                  <c:v>21</c:v>
                </c:pt>
                <c:pt idx="1327">
                  <c:v>20.8</c:v>
                </c:pt>
                <c:pt idx="1328">
                  <c:v>20.8</c:v>
                </c:pt>
                <c:pt idx="1329">
                  <c:v>20.8</c:v>
                </c:pt>
                <c:pt idx="1330">
                  <c:v>20.8</c:v>
                </c:pt>
                <c:pt idx="1331">
                  <c:v>20.8</c:v>
                </c:pt>
                <c:pt idx="1332">
                  <c:v>20.8</c:v>
                </c:pt>
                <c:pt idx="1333">
                  <c:v>20.9</c:v>
                </c:pt>
                <c:pt idx="1334">
                  <c:v>20.9</c:v>
                </c:pt>
                <c:pt idx="1335">
                  <c:v>20.9</c:v>
                </c:pt>
                <c:pt idx="1336">
                  <c:v>20.399999999999999</c:v>
                </c:pt>
                <c:pt idx="1337">
                  <c:v>20.3</c:v>
                </c:pt>
                <c:pt idx="1338">
                  <c:v>20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705-484E-8188-E1A810FB68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6368088"/>
        <c:axId val="1"/>
      </c:scatterChart>
      <c:valAx>
        <c:axId val="186368088"/>
        <c:scaling>
          <c:orientation val="minMax"/>
          <c:max val="8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de-DE" sz="1300" b="0" baseline="0" dirty="0" smtClean="0">
                    <a:latin typeface="Calibri" panose="020F0502020204030204" pitchFamily="34" charset="0"/>
                    <a:cs typeface="Calibri" panose="020F0502020204030204" pitchFamily="34" charset="0"/>
                  </a:rPr>
                  <a:t>Storage time [</a:t>
                </a:r>
                <a:r>
                  <a:rPr lang="de-DE" sz="1300" b="0" baseline="0" dirty="0" err="1" smtClean="0">
                    <a:latin typeface="Calibri" panose="020F0502020204030204" pitchFamily="34" charset="0"/>
                    <a:cs typeface="Calibri" panose="020F0502020204030204" pitchFamily="34" charset="0"/>
                  </a:rPr>
                  <a:t>weeks</a:t>
                </a:r>
                <a:r>
                  <a:rPr lang="de-DE" sz="1300" b="0" baseline="0" dirty="0" smtClean="0">
                    <a:latin typeface="Calibri" panose="020F0502020204030204" pitchFamily="34" charset="0"/>
                    <a:cs typeface="Calibri" panose="020F0502020204030204" pitchFamily="34" charset="0"/>
                  </a:rPr>
                  <a:t>]</a:t>
                </a:r>
                <a:endParaRPr lang="de-DE" sz="1300" b="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de-DE"/>
          </a:p>
        </c:txPr>
        <c:crossAx val="1"/>
        <c:crosses val="autoZero"/>
        <c:crossBetween val="midCat"/>
        <c:majorUnit val="2"/>
      </c:valAx>
      <c:valAx>
        <c:axId val="1"/>
        <c:scaling>
          <c:orientation val="minMax"/>
          <c:max val="100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de-DE" sz="1300" b="0" dirty="0" err="1">
                    <a:latin typeface="Calibri" panose="020F0502020204030204" pitchFamily="34" charset="0"/>
                    <a:cs typeface="Calibri" panose="020F0502020204030204" pitchFamily="34" charset="0"/>
                  </a:rPr>
                  <a:t>Temperature</a:t>
                </a:r>
                <a:r>
                  <a:rPr lang="de-DE" sz="1300" b="0" dirty="0">
                    <a:latin typeface="Calibri" panose="020F0502020204030204" pitchFamily="34" charset="0"/>
                    <a:cs typeface="Calibri" panose="020F0502020204030204" pitchFamily="34" charset="0"/>
                  </a:rPr>
                  <a:t> [°C] / Relative </a:t>
                </a:r>
                <a:r>
                  <a:rPr lang="de-DE" sz="1300" b="0" dirty="0" err="1">
                    <a:latin typeface="Calibri" panose="020F0502020204030204" pitchFamily="34" charset="0"/>
                    <a:cs typeface="Calibri" panose="020F0502020204030204" pitchFamily="34" charset="0"/>
                  </a:rPr>
                  <a:t>Humidity</a:t>
                </a:r>
                <a:r>
                  <a:rPr lang="de-DE" sz="1300" b="0" dirty="0">
                    <a:latin typeface="Calibri" panose="020F0502020204030204" pitchFamily="34" charset="0"/>
                    <a:cs typeface="Calibri" panose="020F0502020204030204" pitchFamily="34" charset="0"/>
                  </a:rPr>
                  <a:t> [%]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186368088"/>
        <c:crosses val="autoZero"/>
        <c:crossBetween val="midCat"/>
      </c:valAx>
    </c:plotArea>
    <c:legend>
      <c:legendPos val="t"/>
      <c:layout>
        <c:manualLayout>
          <c:xMode val="edge"/>
          <c:yMode val="edge"/>
          <c:x val="0.65423232054077329"/>
          <c:y val="0.28779150059473774"/>
          <c:w val="0.18068456803410732"/>
          <c:h val="0.23100131432338855"/>
        </c:manualLayout>
      </c:layout>
      <c:overlay val="0"/>
      <c:spPr>
        <a:solidFill>
          <a:sysClr val="window" lastClr="FFFFFF"/>
        </a:solidFill>
        <a:ln>
          <a:solidFill>
            <a:sysClr val="windowText" lastClr="000000"/>
          </a:solidFill>
        </a:ln>
      </c:spPr>
      <c:txPr>
        <a:bodyPr/>
        <a:lstStyle/>
        <a:p>
          <a:pPr>
            <a:defRPr>
              <a:latin typeface="Calibri" panose="020F0502020204030204" pitchFamily="34" charset="0"/>
              <a:cs typeface="Calibri" panose="020F0502020204030204" pitchFamily="34" charset="0"/>
            </a:defRPr>
          </a:pPr>
          <a:endParaRPr lang="de-DE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2"/>
          <c:order val="0"/>
          <c:tx>
            <c:strRef>
              <c:f>Tabelle1!$H$10</c:f>
              <c:strCache>
                <c:ptCount val="1"/>
                <c:pt idx="0">
                  <c:v>Temperature [°C]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2"/>
            <c:spPr>
              <a:solidFill>
                <a:schemeClr val="accent5"/>
              </a:solidFill>
              <a:ln>
                <a:solidFill>
                  <a:schemeClr val="accent5"/>
                </a:solidFill>
              </a:ln>
            </c:spPr>
          </c:marker>
          <c:xVal>
            <c:numRef>
              <c:f>Tabelle1!$C$13:$C$1350</c:f>
              <c:numCache>
                <c:formatCode>0.00000000000000000</c:formatCode>
                <c:ptCount val="1338"/>
                <c:pt idx="0">
                  <c:v>5.9523809523809521E-3</c:v>
                </c:pt>
                <c:pt idx="1">
                  <c:v>1.1904761904761904E-2</c:v>
                </c:pt>
                <c:pt idx="2">
                  <c:v>1.7857142857142856E-2</c:v>
                </c:pt>
                <c:pt idx="3">
                  <c:v>2.3809523809523808E-2</c:v>
                </c:pt>
                <c:pt idx="4">
                  <c:v>2.976190476190476E-2</c:v>
                </c:pt>
                <c:pt idx="5">
                  <c:v>3.5714285714285712E-2</c:v>
                </c:pt>
                <c:pt idx="6">
                  <c:v>4.1666666666666664E-2</c:v>
                </c:pt>
                <c:pt idx="7">
                  <c:v>4.7619047619047616E-2</c:v>
                </c:pt>
                <c:pt idx="8">
                  <c:v>5.3571428571428568E-2</c:v>
                </c:pt>
                <c:pt idx="9">
                  <c:v>5.9523809523809521E-2</c:v>
                </c:pt>
                <c:pt idx="10">
                  <c:v>6.5476190476190479E-2</c:v>
                </c:pt>
                <c:pt idx="11">
                  <c:v>7.1428571428571425E-2</c:v>
                </c:pt>
                <c:pt idx="12">
                  <c:v>7.7380952380952384E-2</c:v>
                </c:pt>
                <c:pt idx="13">
                  <c:v>8.3333333333333329E-2</c:v>
                </c:pt>
                <c:pt idx="14">
                  <c:v>8.9285714285714288E-2</c:v>
                </c:pt>
                <c:pt idx="15">
                  <c:v>9.5238095238095233E-2</c:v>
                </c:pt>
                <c:pt idx="16">
                  <c:v>0.10119047619047619</c:v>
                </c:pt>
                <c:pt idx="17">
                  <c:v>0.10714285714285714</c:v>
                </c:pt>
                <c:pt idx="18">
                  <c:v>0.1130952380952381</c:v>
                </c:pt>
                <c:pt idx="19">
                  <c:v>0.11904761904761904</c:v>
                </c:pt>
                <c:pt idx="20">
                  <c:v>0.125</c:v>
                </c:pt>
                <c:pt idx="21">
                  <c:v>0.13095238095238096</c:v>
                </c:pt>
                <c:pt idx="22">
                  <c:v>0.13690476190476192</c:v>
                </c:pt>
                <c:pt idx="23">
                  <c:v>0.14285714285714285</c:v>
                </c:pt>
                <c:pt idx="24">
                  <c:v>0.14880952380952381</c:v>
                </c:pt>
                <c:pt idx="25">
                  <c:v>0.15476190476190477</c:v>
                </c:pt>
                <c:pt idx="26">
                  <c:v>0.16071428571428573</c:v>
                </c:pt>
                <c:pt idx="27">
                  <c:v>0.16666666666666666</c:v>
                </c:pt>
                <c:pt idx="28">
                  <c:v>0.17261904761904762</c:v>
                </c:pt>
                <c:pt idx="29">
                  <c:v>0.17857142857142858</c:v>
                </c:pt>
                <c:pt idx="30">
                  <c:v>0.18452380952380953</c:v>
                </c:pt>
                <c:pt idx="31">
                  <c:v>0.19047619047619047</c:v>
                </c:pt>
                <c:pt idx="32">
                  <c:v>0.19642857142857142</c:v>
                </c:pt>
                <c:pt idx="33">
                  <c:v>0.20238095238095238</c:v>
                </c:pt>
                <c:pt idx="34">
                  <c:v>0.20833333333333334</c:v>
                </c:pt>
                <c:pt idx="35">
                  <c:v>0.21428571428571427</c:v>
                </c:pt>
                <c:pt idx="36">
                  <c:v>0.22023809523809523</c:v>
                </c:pt>
                <c:pt idx="37">
                  <c:v>0.22619047619047619</c:v>
                </c:pt>
                <c:pt idx="38">
                  <c:v>0.23214285714285715</c:v>
                </c:pt>
                <c:pt idx="39">
                  <c:v>0.23809523809523808</c:v>
                </c:pt>
                <c:pt idx="40">
                  <c:v>0.24404761904761904</c:v>
                </c:pt>
                <c:pt idx="41">
                  <c:v>0.25</c:v>
                </c:pt>
                <c:pt idx="42">
                  <c:v>0.25595238095238093</c:v>
                </c:pt>
                <c:pt idx="43">
                  <c:v>0.26190476190476192</c:v>
                </c:pt>
                <c:pt idx="44">
                  <c:v>0.26785714285714285</c:v>
                </c:pt>
                <c:pt idx="45">
                  <c:v>0.27380952380952384</c:v>
                </c:pt>
                <c:pt idx="46">
                  <c:v>0.27976190476190477</c:v>
                </c:pt>
                <c:pt idx="47">
                  <c:v>0.2857142857142857</c:v>
                </c:pt>
                <c:pt idx="48">
                  <c:v>0.29166666666666669</c:v>
                </c:pt>
                <c:pt idx="49">
                  <c:v>0.29761904761904762</c:v>
                </c:pt>
                <c:pt idx="50">
                  <c:v>0.30357142857142855</c:v>
                </c:pt>
                <c:pt idx="51">
                  <c:v>0.30952380952380953</c:v>
                </c:pt>
                <c:pt idx="52">
                  <c:v>0.31547619047619047</c:v>
                </c:pt>
                <c:pt idx="53">
                  <c:v>0.32142857142857145</c:v>
                </c:pt>
                <c:pt idx="54">
                  <c:v>0.32738095238095238</c:v>
                </c:pt>
                <c:pt idx="55">
                  <c:v>0.33333333333333331</c:v>
                </c:pt>
                <c:pt idx="56">
                  <c:v>0.3392857142857143</c:v>
                </c:pt>
                <c:pt idx="57">
                  <c:v>0.34523809523809523</c:v>
                </c:pt>
                <c:pt idx="58">
                  <c:v>0.35119047619047616</c:v>
                </c:pt>
                <c:pt idx="59">
                  <c:v>0.35714285714285715</c:v>
                </c:pt>
                <c:pt idx="60">
                  <c:v>0.36309523809523808</c:v>
                </c:pt>
                <c:pt idx="61">
                  <c:v>0.36904761904761907</c:v>
                </c:pt>
                <c:pt idx="62">
                  <c:v>0.375</c:v>
                </c:pt>
                <c:pt idx="63">
                  <c:v>0.38095238095238093</c:v>
                </c:pt>
                <c:pt idx="64">
                  <c:v>0.38690476190476192</c:v>
                </c:pt>
                <c:pt idx="65">
                  <c:v>0.39285714285714285</c:v>
                </c:pt>
                <c:pt idx="66">
                  <c:v>0.39880952380952384</c:v>
                </c:pt>
                <c:pt idx="67">
                  <c:v>0.40476190476190477</c:v>
                </c:pt>
                <c:pt idx="68">
                  <c:v>0.4107142857142857</c:v>
                </c:pt>
                <c:pt idx="69">
                  <c:v>0.41666666666666669</c:v>
                </c:pt>
                <c:pt idx="70">
                  <c:v>0.42261904761904762</c:v>
                </c:pt>
                <c:pt idx="71">
                  <c:v>0.42857142857142855</c:v>
                </c:pt>
                <c:pt idx="72">
                  <c:v>0.43452380952380953</c:v>
                </c:pt>
                <c:pt idx="73">
                  <c:v>0.44047619047619047</c:v>
                </c:pt>
                <c:pt idx="74">
                  <c:v>0.44642857142857145</c:v>
                </c:pt>
                <c:pt idx="75">
                  <c:v>0.45238095238095238</c:v>
                </c:pt>
                <c:pt idx="76">
                  <c:v>0.45833333333333331</c:v>
                </c:pt>
                <c:pt idx="77">
                  <c:v>0.4642857142857143</c:v>
                </c:pt>
                <c:pt idx="78">
                  <c:v>0.47023809523809523</c:v>
                </c:pt>
                <c:pt idx="79">
                  <c:v>0.47619047619047616</c:v>
                </c:pt>
                <c:pt idx="80">
                  <c:v>0.48214285714285715</c:v>
                </c:pt>
                <c:pt idx="81">
                  <c:v>0.48809523809523808</c:v>
                </c:pt>
                <c:pt idx="82">
                  <c:v>0.49404761904761907</c:v>
                </c:pt>
                <c:pt idx="83">
                  <c:v>0.5</c:v>
                </c:pt>
                <c:pt idx="84">
                  <c:v>0.50595238095238093</c:v>
                </c:pt>
                <c:pt idx="85">
                  <c:v>0.51190476190476186</c:v>
                </c:pt>
                <c:pt idx="86">
                  <c:v>0.5178571428571429</c:v>
                </c:pt>
                <c:pt idx="87">
                  <c:v>0.52380952380952384</c:v>
                </c:pt>
                <c:pt idx="88">
                  <c:v>0.52976190476190477</c:v>
                </c:pt>
                <c:pt idx="89">
                  <c:v>0.5357142857142857</c:v>
                </c:pt>
                <c:pt idx="90">
                  <c:v>0.54166666666666663</c:v>
                </c:pt>
                <c:pt idx="91">
                  <c:v>0.54761904761904767</c:v>
                </c:pt>
                <c:pt idx="92">
                  <c:v>0.5535714285714286</c:v>
                </c:pt>
                <c:pt idx="93">
                  <c:v>0.55952380952380953</c:v>
                </c:pt>
                <c:pt idx="94">
                  <c:v>0.56547619047619047</c:v>
                </c:pt>
                <c:pt idx="95">
                  <c:v>0.5714285714285714</c:v>
                </c:pt>
                <c:pt idx="96">
                  <c:v>0.57738095238095233</c:v>
                </c:pt>
                <c:pt idx="97">
                  <c:v>0.58333333333333337</c:v>
                </c:pt>
                <c:pt idx="98">
                  <c:v>0.5892857142857143</c:v>
                </c:pt>
                <c:pt idx="99">
                  <c:v>0.59523809523809523</c:v>
                </c:pt>
                <c:pt idx="100">
                  <c:v>0.60119047619047616</c:v>
                </c:pt>
                <c:pt idx="101">
                  <c:v>0.6071428571428571</c:v>
                </c:pt>
                <c:pt idx="102">
                  <c:v>0.61309523809523814</c:v>
                </c:pt>
                <c:pt idx="103">
                  <c:v>0.61904761904761907</c:v>
                </c:pt>
                <c:pt idx="104">
                  <c:v>0.625</c:v>
                </c:pt>
                <c:pt idx="105">
                  <c:v>0.63095238095238093</c:v>
                </c:pt>
                <c:pt idx="106">
                  <c:v>0.63690476190476186</c:v>
                </c:pt>
                <c:pt idx="107">
                  <c:v>0.6428571428571429</c:v>
                </c:pt>
                <c:pt idx="108">
                  <c:v>0.64880952380952384</c:v>
                </c:pt>
                <c:pt idx="109">
                  <c:v>0.65476190476190477</c:v>
                </c:pt>
                <c:pt idx="110">
                  <c:v>0.6607142857142857</c:v>
                </c:pt>
                <c:pt idx="111">
                  <c:v>0.66666666666666663</c:v>
                </c:pt>
                <c:pt idx="112">
                  <c:v>0.67261904761904767</c:v>
                </c:pt>
                <c:pt idx="113">
                  <c:v>0.6785714285714286</c:v>
                </c:pt>
                <c:pt idx="114">
                  <c:v>0.68452380952380953</c:v>
                </c:pt>
                <c:pt idx="115">
                  <c:v>0.69047619047619047</c:v>
                </c:pt>
                <c:pt idx="116">
                  <c:v>0.6964285714285714</c:v>
                </c:pt>
                <c:pt idx="117">
                  <c:v>0.70238095238095233</c:v>
                </c:pt>
                <c:pt idx="118">
                  <c:v>0.70833333333333337</c:v>
                </c:pt>
                <c:pt idx="119">
                  <c:v>0.7142857142857143</c:v>
                </c:pt>
                <c:pt idx="120">
                  <c:v>0.72023809523809523</c:v>
                </c:pt>
                <c:pt idx="121">
                  <c:v>0.72619047619047616</c:v>
                </c:pt>
                <c:pt idx="122">
                  <c:v>0.7321428571428571</c:v>
                </c:pt>
                <c:pt idx="123">
                  <c:v>0.73809523809523814</c:v>
                </c:pt>
                <c:pt idx="124">
                  <c:v>0.74404761904761907</c:v>
                </c:pt>
                <c:pt idx="125">
                  <c:v>0.75</c:v>
                </c:pt>
                <c:pt idx="126">
                  <c:v>0.75595238095238093</c:v>
                </c:pt>
                <c:pt idx="127">
                  <c:v>0.76190476190476186</c:v>
                </c:pt>
                <c:pt idx="128">
                  <c:v>0.7678571428571429</c:v>
                </c:pt>
                <c:pt idx="129">
                  <c:v>0.77380952380952384</c:v>
                </c:pt>
                <c:pt idx="130">
                  <c:v>0.77976190476190477</c:v>
                </c:pt>
                <c:pt idx="131">
                  <c:v>0.7857142857142857</c:v>
                </c:pt>
                <c:pt idx="132">
                  <c:v>0.79166666666666663</c:v>
                </c:pt>
                <c:pt idx="133">
                  <c:v>0.79761904761904767</c:v>
                </c:pt>
                <c:pt idx="134">
                  <c:v>0.8035714285714286</c:v>
                </c:pt>
                <c:pt idx="135">
                  <c:v>0.80952380952380953</c:v>
                </c:pt>
                <c:pt idx="136">
                  <c:v>0.81547619047619047</c:v>
                </c:pt>
                <c:pt idx="137">
                  <c:v>0.8214285714285714</c:v>
                </c:pt>
                <c:pt idx="138">
                  <c:v>0.82738095238095233</c:v>
                </c:pt>
                <c:pt idx="139">
                  <c:v>0.83333333333333337</c:v>
                </c:pt>
                <c:pt idx="140">
                  <c:v>0.8392857142857143</c:v>
                </c:pt>
                <c:pt idx="141">
                  <c:v>0.84523809523809523</c:v>
                </c:pt>
                <c:pt idx="142">
                  <c:v>0.85119047619047616</c:v>
                </c:pt>
                <c:pt idx="143">
                  <c:v>0.8571428571428571</c:v>
                </c:pt>
                <c:pt idx="144">
                  <c:v>0.86309523809523814</c:v>
                </c:pt>
                <c:pt idx="145">
                  <c:v>0.86904761904761907</c:v>
                </c:pt>
                <c:pt idx="146">
                  <c:v>0.875</c:v>
                </c:pt>
                <c:pt idx="147">
                  <c:v>0.88095238095238093</c:v>
                </c:pt>
                <c:pt idx="148">
                  <c:v>0.88690476190476186</c:v>
                </c:pt>
                <c:pt idx="149">
                  <c:v>0.8928571428571429</c:v>
                </c:pt>
                <c:pt idx="150">
                  <c:v>0.89880952380952384</c:v>
                </c:pt>
                <c:pt idx="151">
                  <c:v>0.90476190476190477</c:v>
                </c:pt>
                <c:pt idx="152">
                  <c:v>0.9107142857142857</c:v>
                </c:pt>
                <c:pt idx="153">
                  <c:v>0.91666666666666663</c:v>
                </c:pt>
                <c:pt idx="154">
                  <c:v>0.92261904761904767</c:v>
                </c:pt>
                <c:pt idx="155">
                  <c:v>0.9285714285714286</c:v>
                </c:pt>
                <c:pt idx="156">
                  <c:v>0.93452380952380953</c:v>
                </c:pt>
                <c:pt idx="157">
                  <c:v>0.94047619047619047</c:v>
                </c:pt>
                <c:pt idx="158">
                  <c:v>0.9464285714285714</c:v>
                </c:pt>
                <c:pt idx="159">
                  <c:v>0.95238095238095233</c:v>
                </c:pt>
                <c:pt idx="160">
                  <c:v>0.95833333333333337</c:v>
                </c:pt>
                <c:pt idx="161">
                  <c:v>0.9642857142857143</c:v>
                </c:pt>
                <c:pt idx="162">
                  <c:v>0.97023809523809523</c:v>
                </c:pt>
                <c:pt idx="163">
                  <c:v>0.97619047619047616</c:v>
                </c:pt>
                <c:pt idx="164">
                  <c:v>0.9821428571428571</c:v>
                </c:pt>
                <c:pt idx="165">
                  <c:v>0.98809523809523814</c:v>
                </c:pt>
                <c:pt idx="166">
                  <c:v>0.99404761904761907</c:v>
                </c:pt>
                <c:pt idx="167">
                  <c:v>1</c:v>
                </c:pt>
                <c:pt idx="168">
                  <c:v>1.0059523809523809</c:v>
                </c:pt>
                <c:pt idx="169">
                  <c:v>1.0119047619047619</c:v>
                </c:pt>
                <c:pt idx="170">
                  <c:v>1.0178571428571428</c:v>
                </c:pt>
                <c:pt idx="171">
                  <c:v>1.0238095238095237</c:v>
                </c:pt>
                <c:pt idx="172">
                  <c:v>1.0297619047619047</c:v>
                </c:pt>
                <c:pt idx="173">
                  <c:v>1.0357142857142858</c:v>
                </c:pt>
                <c:pt idx="174">
                  <c:v>1.0416666666666667</c:v>
                </c:pt>
                <c:pt idx="175">
                  <c:v>1.0476190476190477</c:v>
                </c:pt>
                <c:pt idx="176">
                  <c:v>1.0535714285714286</c:v>
                </c:pt>
                <c:pt idx="177">
                  <c:v>1.0595238095238095</c:v>
                </c:pt>
                <c:pt idx="178">
                  <c:v>1.0654761904761905</c:v>
                </c:pt>
                <c:pt idx="179">
                  <c:v>1.0714285714285714</c:v>
                </c:pt>
                <c:pt idx="180">
                  <c:v>1.0773809523809523</c:v>
                </c:pt>
                <c:pt idx="181">
                  <c:v>1.0833333333333333</c:v>
                </c:pt>
                <c:pt idx="182">
                  <c:v>1.0892857142857142</c:v>
                </c:pt>
                <c:pt idx="183">
                  <c:v>1.0952380952380953</c:v>
                </c:pt>
                <c:pt idx="184">
                  <c:v>1.1011904761904763</c:v>
                </c:pt>
                <c:pt idx="185">
                  <c:v>1.1071428571428572</c:v>
                </c:pt>
                <c:pt idx="186">
                  <c:v>1.1130952380952381</c:v>
                </c:pt>
                <c:pt idx="187">
                  <c:v>1.1190476190476191</c:v>
                </c:pt>
                <c:pt idx="188">
                  <c:v>1.125</c:v>
                </c:pt>
                <c:pt idx="189">
                  <c:v>1.1309523809523809</c:v>
                </c:pt>
                <c:pt idx="190">
                  <c:v>1.1369047619047619</c:v>
                </c:pt>
                <c:pt idx="191">
                  <c:v>1.1428571428571428</c:v>
                </c:pt>
                <c:pt idx="192">
                  <c:v>1.1488095238095237</c:v>
                </c:pt>
                <c:pt idx="193">
                  <c:v>1.1547619047619047</c:v>
                </c:pt>
                <c:pt idx="194">
                  <c:v>1.1607142857142858</c:v>
                </c:pt>
                <c:pt idx="195">
                  <c:v>1.1666666666666667</c:v>
                </c:pt>
                <c:pt idx="196">
                  <c:v>1.1726190476190477</c:v>
                </c:pt>
                <c:pt idx="197">
                  <c:v>1.1785714285714286</c:v>
                </c:pt>
                <c:pt idx="198">
                  <c:v>1.1845238095238095</c:v>
                </c:pt>
                <c:pt idx="199">
                  <c:v>1.1904761904761905</c:v>
                </c:pt>
                <c:pt idx="200">
                  <c:v>1.1964285714285714</c:v>
                </c:pt>
                <c:pt idx="201">
                  <c:v>1.2023809523809523</c:v>
                </c:pt>
                <c:pt idx="202">
                  <c:v>1.2083333333333333</c:v>
                </c:pt>
                <c:pt idx="203">
                  <c:v>1.2142857142857142</c:v>
                </c:pt>
                <c:pt idx="204">
                  <c:v>1.2202380952380953</c:v>
                </c:pt>
                <c:pt idx="205">
                  <c:v>1.2261904761904763</c:v>
                </c:pt>
                <c:pt idx="206">
                  <c:v>1.2321428571428572</c:v>
                </c:pt>
                <c:pt idx="207">
                  <c:v>1.2380952380952381</c:v>
                </c:pt>
                <c:pt idx="208">
                  <c:v>1.2440476190476191</c:v>
                </c:pt>
                <c:pt idx="209">
                  <c:v>1.25</c:v>
                </c:pt>
                <c:pt idx="210">
                  <c:v>1.2559523809523809</c:v>
                </c:pt>
                <c:pt idx="211">
                  <c:v>1.2619047619047619</c:v>
                </c:pt>
                <c:pt idx="212">
                  <c:v>1.2678571428571428</c:v>
                </c:pt>
                <c:pt idx="213">
                  <c:v>1.2738095238095237</c:v>
                </c:pt>
                <c:pt idx="214">
                  <c:v>1.2797619047619047</c:v>
                </c:pt>
                <c:pt idx="215">
                  <c:v>1.2857142857142858</c:v>
                </c:pt>
                <c:pt idx="216">
                  <c:v>1.2916666666666667</c:v>
                </c:pt>
                <c:pt idx="217">
                  <c:v>1.2976190476190477</c:v>
                </c:pt>
                <c:pt idx="218">
                  <c:v>1.3035714285714286</c:v>
                </c:pt>
                <c:pt idx="219">
                  <c:v>1.3095238095238095</c:v>
                </c:pt>
                <c:pt idx="220">
                  <c:v>1.3154761904761905</c:v>
                </c:pt>
                <c:pt idx="221">
                  <c:v>1.3214285714285714</c:v>
                </c:pt>
                <c:pt idx="222">
                  <c:v>1.3273809523809523</c:v>
                </c:pt>
                <c:pt idx="223">
                  <c:v>1.3333333333333333</c:v>
                </c:pt>
                <c:pt idx="224">
                  <c:v>1.3392857142857142</c:v>
                </c:pt>
                <c:pt idx="225">
                  <c:v>1.3452380952380953</c:v>
                </c:pt>
                <c:pt idx="226">
                  <c:v>1.3511904761904763</c:v>
                </c:pt>
                <c:pt idx="227">
                  <c:v>1.3571428571428572</c:v>
                </c:pt>
                <c:pt idx="228">
                  <c:v>1.3630952380952381</c:v>
                </c:pt>
                <c:pt idx="229">
                  <c:v>1.3690476190476191</c:v>
                </c:pt>
                <c:pt idx="230">
                  <c:v>1.375</c:v>
                </c:pt>
                <c:pt idx="231">
                  <c:v>1.3809523809523809</c:v>
                </c:pt>
                <c:pt idx="232">
                  <c:v>1.3869047619047619</c:v>
                </c:pt>
                <c:pt idx="233">
                  <c:v>1.3928571428571428</c:v>
                </c:pt>
                <c:pt idx="234">
                  <c:v>1.3988095238095237</c:v>
                </c:pt>
                <c:pt idx="235">
                  <c:v>1.4047619047619047</c:v>
                </c:pt>
                <c:pt idx="236">
                  <c:v>1.4107142857142858</c:v>
                </c:pt>
                <c:pt idx="237">
                  <c:v>1.4166666666666667</c:v>
                </c:pt>
                <c:pt idx="238">
                  <c:v>1.4226190476190477</c:v>
                </c:pt>
                <c:pt idx="239">
                  <c:v>1.4285714285714286</c:v>
                </c:pt>
                <c:pt idx="240">
                  <c:v>1.4345238095238095</c:v>
                </c:pt>
                <c:pt idx="241">
                  <c:v>1.4404761904761905</c:v>
                </c:pt>
                <c:pt idx="242">
                  <c:v>1.4464285714285714</c:v>
                </c:pt>
                <c:pt idx="243">
                  <c:v>1.4523809523809523</c:v>
                </c:pt>
                <c:pt idx="244">
                  <c:v>1.4583333333333333</c:v>
                </c:pt>
                <c:pt idx="245">
                  <c:v>1.4642857142857142</c:v>
                </c:pt>
                <c:pt idx="246">
                  <c:v>1.4702380952380953</c:v>
                </c:pt>
                <c:pt idx="247">
                  <c:v>1.4761904761904763</c:v>
                </c:pt>
                <c:pt idx="248">
                  <c:v>1.4821428571428572</c:v>
                </c:pt>
                <c:pt idx="249">
                  <c:v>1.4880952380952381</c:v>
                </c:pt>
                <c:pt idx="250">
                  <c:v>1.4940476190476191</c:v>
                </c:pt>
                <c:pt idx="251">
                  <c:v>1.5</c:v>
                </c:pt>
                <c:pt idx="252">
                  <c:v>1.5059523809523809</c:v>
                </c:pt>
                <c:pt idx="253">
                  <c:v>1.5119047619047619</c:v>
                </c:pt>
                <c:pt idx="254">
                  <c:v>1.5178571428571428</c:v>
                </c:pt>
                <c:pt idx="255">
                  <c:v>1.5238095238095237</c:v>
                </c:pt>
                <c:pt idx="256">
                  <c:v>1.5297619047619047</c:v>
                </c:pt>
                <c:pt idx="257">
                  <c:v>1.5357142857142858</c:v>
                </c:pt>
                <c:pt idx="258">
                  <c:v>1.5416666666666667</c:v>
                </c:pt>
                <c:pt idx="259">
                  <c:v>1.5476190476190477</c:v>
                </c:pt>
                <c:pt idx="260">
                  <c:v>1.5535714285714286</c:v>
                </c:pt>
                <c:pt idx="261">
                  <c:v>1.5595238095238095</c:v>
                </c:pt>
                <c:pt idx="262">
                  <c:v>1.5654761904761905</c:v>
                </c:pt>
                <c:pt idx="263">
                  <c:v>1.5714285714285714</c:v>
                </c:pt>
                <c:pt idx="264">
                  <c:v>1.5773809523809523</c:v>
                </c:pt>
                <c:pt idx="265">
                  <c:v>1.5833333333333333</c:v>
                </c:pt>
                <c:pt idx="266">
                  <c:v>1.5892857142857142</c:v>
                </c:pt>
                <c:pt idx="267">
                  <c:v>1.5952380952380953</c:v>
                </c:pt>
                <c:pt idx="268">
                  <c:v>1.6011904761904763</c:v>
                </c:pt>
                <c:pt idx="269">
                  <c:v>1.6071428571428572</c:v>
                </c:pt>
                <c:pt idx="270">
                  <c:v>1.6130952380952381</c:v>
                </c:pt>
                <c:pt idx="271">
                  <c:v>1.6190476190476191</c:v>
                </c:pt>
                <c:pt idx="272">
                  <c:v>1.625</c:v>
                </c:pt>
                <c:pt idx="273">
                  <c:v>1.6309523809523809</c:v>
                </c:pt>
                <c:pt idx="274">
                  <c:v>1.6369047619047619</c:v>
                </c:pt>
                <c:pt idx="275">
                  <c:v>1.6428571428571428</c:v>
                </c:pt>
                <c:pt idx="276">
                  <c:v>1.6488095238095237</c:v>
                </c:pt>
                <c:pt idx="277">
                  <c:v>1.6547619047619047</c:v>
                </c:pt>
                <c:pt idx="278">
                  <c:v>1.6607142857142858</c:v>
                </c:pt>
                <c:pt idx="279">
                  <c:v>1.6666666666666667</c:v>
                </c:pt>
                <c:pt idx="280">
                  <c:v>1.6726190476190477</c:v>
                </c:pt>
                <c:pt idx="281">
                  <c:v>1.6785714285714286</c:v>
                </c:pt>
                <c:pt idx="282">
                  <c:v>1.6845238095238095</c:v>
                </c:pt>
                <c:pt idx="283">
                  <c:v>1.6904761904761905</c:v>
                </c:pt>
                <c:pt idx="284">
                  <c:v>1.6964285714285714</c:v>
                </c:pt>
                <c:pt idx="285">
                  <c:v>1.7023809523809523</c:v>
                </c:pt>
                <c:pt idx="286">
                  <c:v>1.7083333333333333</c:v>
                </c:pt>
                <c:pt idx="287">
                  <c:v>1.7142857142857142</c:v>
                </c:pt>
                <c:pt idx="288">
                  <c:v>1.7202380952380953</c:v>
                </c:pt>
                <c:pt idx="289">
                  <c:v>1.7261904761904763</c:v>
                </c:pt>
                <c:pt idx="290">
                  <c:v>1.7321428571428572</c:v>
                </c:pt>
                <c:pt idx="291">
                  <c:v>1.7380952380952381</c:v>
                </c:pt>
                <c:pt idx="292">
                  <c:v>1.7440476190476191</c:v>
                </c:pt>
                <c:pt idx="293">
                  <c:v>1.75</c:v>
                </c:pt>
                <c:pt idx="294">
                  <c:v>1.7559523809523809</c:v>
                </c:pt>
                <c:pt idx="295">
                  <c:v>1.7619047619047619</c:v>
                </c:pt>
                <c:pt idx="296">
                  <c:v>1.7678571428571428</c:v>
                </c:pt>
                <c:pt idx="297">
                  <c:v>1.7738095238095237</c:v>
                </c:pt>
                <c:pt idx="298">
                  <c:v>1.7797619047619047</c:v>
                </c:pt>
                <c:pt idx="299">
                  <c:v>1.7857142857142858</c:v>
                </c:pt>
                <c:pt idx="300">
                  <c:v>1.7916666666666667</c:v>
                </c:pt>
                <c:pt idx="301">
                  <c:v>1.7976190476190477</c:v>
                </c:pt>
                <c:pt idx="302">
                  <c:v>1.8035714285714286</c:v>
                </c:pt>
                <c:pt idx="303">
                  <c:v>1.8095238095238095</c:v>
                </c:pt>
                <c:pt idx="304">
                  <c:v>1.8154761904761905</c:v>
                </c:pt>
                <c:pt idx="305">
                  <c:v>1.8214285714285714</c:v>
                </c:pt>
                <c:pt idx="306">
                  <c:v>1.8273809523809523</c:v>
                </c:pt>
                <c:pt idx="307">
                  <c:v>1.8333333333333333</c:v>
                </c:pt>
                <c:pt idx="308">
                  <c:v>1.8392857142857142</c:v>
                </c:pt>
                <c:pt idx="309">
                  <c:v>1.8452380952380953</c:v>
                </c:pt>
                <c:pt idx="310">
                  <c:v>1.8511904761904763</c:v>
                </c:pt>
                <c:pt idx="311">
                  <c:v>1.8571428571428572</c:v>
                </c:pt>
                <c:pt idx="312">
                  <c:v>1.8630952380952381</c:v>
                </c:pt>
                <c:pt idx="313">
                  <c:v>1.8690476190476191</c:v>
                </c:pt>
                <c:pt idx="314">
                  <c:v>1.875</c:v>
                </c:pt>
                <c:pt idx="315">
                  <c:v>1.8809523809523809</c:v>
                </c:pt>
                <c:pt idx="316">
                  <c:v>1.8869047619047619</c:v>
                </c:pt>
                <c:pt idx="317">
                  <c:v>1.8928571428571428</c:v>
                </c:pt>
                <c:pt idx="318">
                  <c:v>1.8988095238095237</c:v>
                </c:pt>
                <c:pt idx="319">
                  <c:v>1.9047619047619047</c:v>
                </c:pt>
                <c:pt idx="320">
                  <c:v>1.9107142857142858</c:v>
                </c:pt>
                <c:pt idx="321">
                  <c:v>1.9166666666666667</c:v>
                </c:pt>
                <c:pt idx="322">
                  <c:v>1.9226190476190477</c:v>
                </c:pt>
                <c:pt idx="323">
                  <c:v>1.9285714285714286</c:v>
                </c:pt>
                <c:pt idx="324">
                  <c:v>1.9345238095238095</c:v>
                </c:pt>
                <c:pt idx="325">
                  <c:v>1.9404761904761905</c:v>
                </c:pt>
                <c:pt idx="326">
                  <c:v>1.9464285714285714</c:v>
                </c:pt>
                <c:pt idx="327">
                  <c:v>1.9523809523809523</c:v>
                </c:pt>
                <c:pt idx="328">
                  <c:v>1.9583333333333333</c:v>
                </c:pt>
                <c:pt idx="329">
                  <c:v>1.9642857142857142</c:v>
                </c:pt>
                <c:pt idx="330">
                  <c:v>1.9702380952380953</c:v>
                </c:pt>
                <c:pt idx="331">
                  <c:v>1.9761904761904763</c:v>
                </c:pt>
                <c:pt idx="332">
                  <c:v>1.9821428571428572</c:v>
                </c:pt>
                <c:pt idx="333">
                  <c:v>1.9880952380952381</c:v>
                </c:pt>
                <c:pt idx="334">
                  <c:v>1.9940476190476191</c:v>
                </c:pt>
                <c:pt idx="335">
                  <c:v>2</c:v>
                </c:pt>
                <c:pt idx="336">
                  <c:v>2.0059523809523809</c:v>
                </c:pt>
                <c:pt idx="337">
                  <c:v>2.0119047619047619</c:v>
                </c:pt>
                <c:pt idx="338">
                  <c:v>2.0178571428571428</c:v>
                </c:pt>
                <c:pt idx="339">
                  <c:v>2.0238095238095237</c:v>
                </c:pt>
                <c:pt idx="340">
                  <c:v>2.0297619047619047</c:v>
                </c:pt>
                <c:pt idx="341">
                  <c:v>2.0357142857142856</c:v>
                </c:pt>
                <c:pt idx="342">
                  <c:v>2.0416666666666665</c:v>
                </c:pt>
                <c:pt idx="343">
                  <c:v>2.0476190476190474</c:v>
                </c:pt>
                <c:pt idx="344">
                  <c:v>2.0535714285714284</c:v>
                </c:pt>
                <c:pt idx="345">
                  <c:v>2.0595238095238093</c:v>
                </c:pt>
                <c:pt idx="346">
                  <c:v>2.0654761904761907</c:v>
                </c:pt>
                <c:pt idx="347">
                  <c:v>2.0714285714285716</c:v>
                </c:pt>
                <c:pt idx="348">
                  <c:v>2.0773809523809526</c:v>
                </c:pt>
                <c:pt idx="349">
                  <c:v>2.0833333333333335</c:v>
                </c:pt>
                <c:pt idx="350">
                  <c:v>2.0892857142857144</c:v>
                </c:pt>
                <c:pt idx="351">
                  <c:v>2.0952380952380953</c:v>
                </c:pt>
                <c:pt idx="352">
                  <c:v>2.1011904761904763</c:v>
                </c:pt>
                <c:pt idx="353">
                  <c:v>2.1071428571428572</c:v>
                </c:pt>
                <c:pt idx="354">
                  <c:v>2.1130952380952381</c:v>
                </c:pt>
                <c:pt idx="355">
                  <c:v>2.1190476190476191</c:v>
                </c:pt>
                <c:pt idx="356">
                  <c:v>2.125</c:v>
                </c:pt>
                <c:pt idx="357">
                  <c:v>2.1309523809523809</c:v>
                </c:pt>
                <c:pt idx="358">
                  <c:v>2.1369047619047619</c:v>
                </c:pt>
                <c:pt idx="359">
                  <c:v>2.1428571428571428</c:v>
                </c:pt>
                <c:pt idx="360">
                  <c:v>2.1488095238095237</c:v>
                </c:pt>
                <c:pt idx="361">
                  <c:v>2.1547619047619047</c:v>
                </c:pt>
                <c:pt idx="362">
                  <c:v>2.1607142857142856</c:v>
                </c:pt>
                <c:pt idx="363">
                  <c:v>2.1666666666666665</c:v>
                </c:pt>
                <c:pt idx="364">
                  <c:v>2.1726190476190474</c:v>
                </c:pt>
                <c:pt idx="365">
                  <c:v>2.1785714285714284</c:v>
                </c:pt>
                <c:pt idx="366">
                  <c:v>2.1845238095238093</c:v>
                </c:pt>
                <c:pt idx="367">
                  <c:v>2.1904761904761907</c:v>
                </c:pt>
                <c:pt idx="368">
                  <c:v>2.1964285714285716</c:v>
                </c:pt>
                <c:pt idx="369">
                  <c:v>2.2023809523809526</c:v>
                </c:pt>
                <c:pt idx="370">
                  <c:v>2.2083333333333335</c:v>
                </c:pt>
                <c:pt idx="371">
                  <c:v>2.2142857142857144</c:v>
                </c:pt>
                <c:pt idx="372">
                  <c:v>2.2202380952380953</c:v>
                </c:pt>
                <c:pt idx="373">
                  <c:v>2.2261904761904763</c:v>
                </c:pt>
                <c:pt idx="374">
                  <c:v>2.2321428571428572</c:v>
                </c:pt>
                <c:pt idx="375">
                  <c:v>2.2380952380952381</c:v>
                </c:pt>
                <c:pt idx="376">
                  <c:v>2.2440476190476191</c:v>
                </c:pt>
                <c:pt idx="377">
                  <c:v>2.25</c:v>
                </c:pt>
                <c:pt idx="378">
                  <c:v>2.2559523809523809</c:v>
                </c:pt>
                <c:pt idx="379">
                  <c:v>2.2619047619047619</c:v>
                </c:pt>
                <c:pt idx="380">
                  <c:v>2.2678571428571428</c:v>
                </c:pt>
                <c:pt idx="381">
                  <c:v>2.2738095238095237</c:v>
                </c:pt>
                <c:pt idx="382">
                  <c:v>2.2797619047619047</c:v>
                </c:pt>
                <c:pt idx="383">
                  <c:v>2.2857142857142856</c:v>
                </c:pt>
                <c:pt idx="384">
                  <c:v>2.2916666666666665</c:v>
                </c:pt>
                <c:pt idx="385">
                  <c:v>2.2976190476190474</c:v>
                </c:pt>
                <c:pt idx="386">
                  <c:v>2.3035714285714284</c:v>
                </c:pt>
                <c:pt idx="387">
                  <c:v>2.3095238095238093</c:v>
                </c:pt>
                <c:pt idx="388">
                  <c:v>2.3154761904761907</c:v>
                </c:pt>
                <c:pt idx="389">
                  <c:v>2.3214285714285716</c:v>
                </c:pt>
                <c:pt idx="390">
                  <c:v>2.3273809523809526</c:v>
                </c:pt>
                <c:pt idx="391">
                  <c:v>2.3333333333333335</c:v>
                </c:pt>
                <c:pt idx="392">
                  <c:v>2.3392857142857144</c:v>
                </c:pt>
                <c:pt idx="393">
                  <c:v>2.3452380952380953</c:v>
                </c:pt>
                <c:pt idx="394">
                  <c:v>2.3511904761904763</c:v>
                </c:pt>
                <c:pt idx="395">
                  <c:v>2.3571428571428572</c:v>
                </c:pt>
                <c:pt idx="396">
                  <c:v>2.3630952380952381</c:v>
                </c:pt>
                <c:pt idx="397">
                  <c:v>2.3690476190476191</c:v>
                </c:pt>
                <c:pt idx="398">
                  <c:v>2.375</c:v>
                </c:pt>
                <c:pt idx="399">
                  <c:v>2.3809523809523809</c:v>
                </c:pt>
                <c:pt idx="400">
                  <c:v>2.3869047619047619</c:v>
                </c:pt>
                <c:pt idx="401">
                  <c:v>2.3928571428571428</c:v>
                </c:pt>
                <c:pt idx="402">
                  <c:v>2.3988095238095237</c:v>
                </c:pt>
                <c:pt idx="403">
                  <c:v>2.4047619047619047</c:v>
                </c:pt>
                <c:pt idx="404">
                  <c:v>2.4107142857142856</c:v>
                </c:pt>
                <c:pt idx="405">
                  <c:v>2.4166666666666665</c:v>
                </c:pt>
                <c:pt idx="406">
                  <c:v>2.4226190476190474</c:v>
                </c:pt>
                <c:pt idx="407">
                  <c:v>2.4285714285714284</c:v>
                </c:pt>
                <c:pt idx="408">
                  <c:v>2.4345238095238093</c:v>
                </c:pt>
                <c:pt idx="409">
                  <c:v>2.4404761904761907</c:v>
                </c:pt>
                <c:pt idx="410">
                  <c:v>2.4464285714285716</c:v>
                </c:pt>
                <c:pt idx="411">
                  <c:v>2.4523809523809526</c:v>
                </c:pt>
                <c:pt idx="412">
                  <c:v>2.4583333333333335</c:v>
                </c:pt>
                <c:pt idx="413">
                  <c:v>2.4642857142857144</c:v>
                </c:pt>
                <c:pt idx="414">
                  <c:v>2.4702380952380953</c:v>
                </c:pt>
                <c:pt idx="415">
                  <c:v>2.4761904761904763</c:v>
                </c:pt>
                <c:pt idx="416">
                  <c:v>2.4821428571428572</c:v>
                </c:pt>
                <c:pt idx="417">
                  <c:v>2.4880952380952381</c:v>
                </c:pt>
                <c:pt idx="418">
                  <c:v>2.4940476190476191</c:v>
                </c:pt>
                <c:pt idx="419">
                  <c:v>2.5</c:v>
                </c:pt>
                <c:pt idx="420">
                  <c:v>2.5059523809523809</c:v>
                </c:pt>
                <c:pt idx="421">
                  <c:v>2.5119047619047619</c:v>
                </c:pt>
                <c:pt idx="422">
                  <c:v>2.5178571428571428</c:v>
                </c:pt>
                <c:pt idx="423">
                  <c:v>2.5238095238095237</c:v>
                </c:pt>
                <c:pt idx="424">
                  <c:v>2.5297619047619047</c:v>
                </c:pt>
                <c:pt idx="425">
                  <c:v>2.5357142857142856</c:v>
                </c:pt>
                <c:pt idx="426">
                  <c:v>2.5416666666666665</c:v>
                </c:pt>
                <c:pt idx="427">
                  <c:v>2.5476190476190474</c:v>
                </c:pt>
                <c:pt idx="428">
                  <c:v>2.5535714285714284</c:v>
                </c:pt>
                <c:pt idx="429">
                  <c:v>2.5595238095238093</c:v>
                </c:pt>
                <c:pt idx="430">
                  <c:v>2.5654761904761907</c:v>
                </c:pt>
                <c:pt idx="431">
                  <c:v>2.5714285714285716</c:v>
                </c:pt>
                <c:pt idx="432">
                  <c:v>2.5773809523809526</c:v>
                </c:pt>
                <c:pt idx="433">
                  <c:v>2.5833333333333335</c:v>
                </c:pt>
                <c:pt idx="434">
                  <c:v>2.5892857142857144</c:v>
                </c:pt>
                <c:pt idx="435">
                  <c:v>2.5952380952380953</c:v>
                </c:pt>
                <c:pt idx="436">
                  <c:v>2.6011904761904763</c:v>
                </c:pt>
                <c:pt idx="437">
                  <c:v>2.6071428571428572</c:v>
                </c:pt>
                <c:pt idx="438">
                  <c:v>2.6130952380952381</c:v>
                </c:pt>
                <c:pt idx="439">
                  <c:v>2.6190476190476191</c:v>
                </c:pt>
                <c:pt idx="440">
                  <c:v>2.625</c:v>
                </c:pt>
                <c:pt idx="441">
                  <c:v>2.6309523809523809</c:v>
                </c:pt>
                <c:pt idx="442">
                  <c:v>2.6369047619047619</c:v>
                </c:pt>
                <c:pt idx="443">
                  <c:v>2.6428571428571428</c:v>
                </c:pt>
                <c:pt idx="444">
                  <c:v>2.6488095238095237</c:v>
                </c:pt>
                <c:pt idx="445">
                  <c:v>2.6547619047619047</c:v>
                </c:pt>
                <c:pt idx="446">
                  <c:v>2.6607142857142856</c:v>
                </c:pt>
                <c:pt idx="447">
                  <c:v>2.6666666666666665</c:v>
                </c:pt>
                <c:pt idx="448">
                  <c:v>2.6726190476190474</c:v>
                </c:pt>
                <c:pt idx="449">
                  <c:v>2.6785714285714284</c:v>
                </c:pt>
                <c:pt idx="450">
                  <c:v>2.6845238095238093</c:v>
                </c:pt>
                <c:pt idx="451">
                  <c:v>2.6904761904761907</c:v>
                </c:pt>
                <c:pt idx="452">
                  <c:v>2.6964285714285716</c:v>
                </c:pt>
                <c:pt idx="453">
                  <c:v>2.7023809523809526</c:v>
                </c:pt>
                <c:pt idx="454">
                  <c:v>2.7083333333333335</c:v>
                </c:pt>
                <c:pt idx="455">
                  <c:v>2.7142857142857144</c:v>
                </c:pt>
                <c:pt idx="456">
                  <c:v>2.7202380952380953</c:v>
                </c:pt>
                <c:pt idx="457">
                  <c:v>2.7261904761904763</c:v>
                </c:pt>
                <c:pt idx="458">
                  <c:v>2.7321428571428572</c:v>
                </c:pt>
                <c:pt idx="459">
                  <c:v>2.7380952380952381</c:v>
                </c:pt>
                <c:pt idx="460">
                  <c:v>2.7440476190476191</c:v>
                </c:pt>
                <c:pt idx="461">
                  <c:v>2.75</c:v>
                </c:pt>
                <c:pt idx="462">
                  <c:v>2.7559523809523809</c:v>
                </c:pt>
                <c:pt idx="463">
                  <c:v>2.7619047619047619</c:v>
                </c:pt>
                <c:pt idx="464">
                  <c:v>2.7678571428571428</c:v>
                </c:pt>
                <c:pt idx="465">
                  <c:v>2.7738095238095237</c:v>
                </c:pt>
                <c:pt idx="466">
                  <c:v>2.7797619047619047</c:v>
                </c:pt>
                <c:pt idx="467">
                  <c:v>2.7857142857142856</c:v>
                </c:pt>
                <c:pt idx="468">
                  <c:v>2.7916666666666665</c:v>
                </c:pt>
                <c:pt idx="469">
                  <c:v>2.7976190476190474</c:v>
                </c:pt>
                <c:pt idx="470">
                  <c:v>2.8035714285714284</c:v>
                </c:pt>
                <c:pt idx="471">
                  <c:v>2.8095238095238093</c:v>
                </c:pt>
                <c:pt idx="472">
                  <c:v>2.8154761904761907</c:v>
                </c:pt>
                <c:pt idx="473">
                  <c:v>2.8214285714285716</c:v>
                </c:pt>
                <c:pt idx="474">
                  <c:v>2.8273809523809526</c:v>
                </c:pt>
                <c:pt idx="475">
                  <c:v>2.8333333333333335</c:v>
                </c:pt>
                <c:pt idx="476">
                  <c:v>2.8392857142857144</c:v>
                </c:pt>
                <c:pt idx="477">
                  <c:v>2.8452380952380953</c:v>
                </c:pt>
                <c:pt idx="478">
                  <c:v>2.8511904761904763</c:v>
                </c:pt>
                <c:pt idx="479">
                  <c:v>2.8571428571428572</c:v>
                </c:pt>
                <c:pt idx="480">
                  <c:v>2.8630952380952381</c:v>
                </c:pt>
                <c:pt idx="481">
                  <c:v>2.8690476190476191</c:v>
                </c:pt>
                <c:pt idx="482">
                  <c:v>2.875</c:v>
                </c:pt>
                <c:pt idx="483">
                  <c:v>2.8809523809523809</c:v>
                </c:pt>
                <c:pt idx="484">
                  <c:v>2.8869047619047619</c:v>
                </c:pt>
                <c:pt idx="485">
                  <c:v>2.8928571428571428</c:v>
                </c:pt>
                <c:pt idx="486">
                  <c:v>2.8988095238095237</c:v>
                </c:pt>
                <c:pt idx="487">
                  <c:v>2.9047619047619047</c:v>
                </c:pt>
                <c:pt idx="488">
                  <c:v>2.9107142857142856</c:v>
                </c:pt>
                <c:pt idx="489">
                  <c:v>2.9166666666666665</c:v>
                </c:pt>
                <c:pt idx="490">
                  <c:v>2.9226190476190474</c:v>
                </c:pt>
                <c:pt idx="491">
                  <c:v>2.9285714285714284</c:v>
                </c:pt>
                <c:pt idx="492">
                  <c:v>2.9345238095238093</c:v>
                </c:pt>
                <c:pt idx="493">
                  <c:v>2.9404761904761907</c:v>
                </c:pt>
                <c:pt idx="494">
                  <c:v>2.9464285714285716</c:v>
                </c:pt>
                <c:pt idx="495">
                  <c:v>2.9523809523809526</c:v>
                </c:pt>
                <c:pt idx="496">
                  <c:v>2.9583333333333335</c:v>
                </c:pt>
                <c:pt idx="497">
                  <c:v>2.9642857142857144</c:v>
                </c:pt>
                <c:pt idx="498">
                  <c:v>2.9702380952380953</c:v>
                </c:pt>
                <c:pt idx="499">
                  <c:v>2.9761904761904763</c:v>
                </c:pt>
                <c:pt idx="500">
                  <c:v>2.9821428571428572</c:v>
                </c:pt>
                <c:pt idx="501">
                  <c:v>2.9880952380952381</c:v>
                </c:pt>
                <c:pt idx="502">
                  <c:v>2.9940476190476191</c:v>
                </c:pt>
                <c:pt idx="503">
                  <c:v>3</c:v>
                </c:pt>
                <c:pt idx="504">
                  <c:v>3.0059523809523809</c:v>
                </c:pt>
                <c:pt idx="505">
                  <c:v>3.0119047619047619</c:v>
                </c:pt>
                <c:pt idx="506">
                  <c:v>3.0178571428571428</c:v>
                </c:pt>
                <c:pt idx="507">
                  <c:v>3.0238095238095237</c:v>
                </c:pt>
                <c:pt idx="508">
                  <c:v>3.0297619047619047</c:v>
                </c:pt>
                <c:pt idx="509">
                  <c:v>3.0357142857142856</c:v>
                </c:pt>
                <c:pt idx="510">
                  <c:v>3.0416666666666665</c:v>
                </c:pt>
                <c:pt idx="511">
                  <c:v>3.0476190476190474</c:v>
                </c:pt>
                <c:pt idx="512">
                  <c:v>3.0535714285714284</c:v>
                </c:pt>
                <c:pt idx="513">
                  <c:v>3.0595238095238093</c:v>
                </c:pt>
                <c:pt idx="514">
                  <c:v>3.0654761904761907</c:v>
                </c:pt>
                <c:pt idx="515">
                  <c:v>3.0714285714285716</c:v>
                </c:pt>
                <c:pt idx="516">
                  <c:v>3.0773809523809526</c:v>
                </c:pt>
                <c:pt idx="517">
                  <c:v>3.0833333333333335</c:v>
                </c:pt>
                <c:pt idx="518">
                  <c:v>3.0892857142857144</c:v>
                </c:pt>
                <c:pt idx="519">
                  <c:v>3.0952380952380953</c:v>
                </c:pt>
                <c:pt idx="520">
                  <c:v>3.1011904761904763</c:v>
                </c:pt>
                <c:pt idx="521">
                  <c:v>3.1071428571428572</c:v>
                </c:pt>
                <c:pt idx="522">
                  <c:v>3.1130952380952381</c:v>
                </c:pt>
                <c:pt idx="523">
                  <c:v>3.1190476190476191</c:v>
                </c:pt>
                <c:pt idx="524">
                  <c:v>3.125</c:v>
                </c:pt>
                <c:pt idx="525">
                  <c:v>3.1309523809523809</c:v>
                </c:pt>
                <c:pt idx="526">
                  <c:v>3.1369047619047619</c:v>
                </c:pt>
                <c:pt idx="527">
                  <c:v>3.1428571428571428</c:v>
                </c:pt>
                <c:pt idx="528">
                  <c:v>3.1488095238095237</c:v>
                </c:pt>
                <c:pt idx="529">
                  <c:v>3.1547619047619047</c:v>
                </c:pt>
                <c:pt idx="530">
                  <c:v>3.1607142857142856</c:v>
                </c:pt>
                <c:pt idx="531">
                  <c:v>3.1666666666666665</c:v>
                </c:pt>
                <c:pt idx="532">
                  <c:v>3.1726190476190474</c:v>
                </c:pt>
                <c:pt idx="533">
                  <c:v>3.1785714285714284</c:v>
                </c:pt>
                <c:pt idx="534">
                  <c:v>3.1845238095238093</c:v>
                </c:pt>
                <c:pt idx="535">
                  <c:v>3.1904761904761907</c:v>
                </c:pt>
                <c:pt idx="536">
                  <c:v>3.1964285714285716</c:v>
                </c:pt>
                <c:pt idx="537">
                  <c:v>3.2023809523809526</c:v>
                </c:pt>
                <c:pt idx="538">
                  <c:v>3.2083333333333335</c:v>
                </c:pt>
                <c:pt idx="539">
                  <c:v>3.2142857142857144</c:v>
                </c:pt>
                <c:pt idx="540">
                  <c:v>3.2202380952380953</c:v>
                </c:pt>
                <c:pt idx="541">
                  <c:v>3.2261904761904763</c:v>
                </c:pt>
                <c:pt idx="542">
                  <c:v>3.2321428571428572</c:v>
                </c:pt>
                <c:pt idx="543">
                  <c:v>3.2380952380952381</c:v>
                </c:pt>
                <c:pt idx="544">
                  <c:v>3.2440476190476191</c:v>
                </c:pt>
                <c:pt idx="545">
                  <c:v>3.25</c:v>
                </c:pt>
                <c:pt idx="546">
                  <c:v>3.2559523809523809</c:v>
                </c:pt>
                <c:pt idx="547">
                  <c:v>3.2619047619047619</c:v>
                </c:pt>
                <c:pt idx="548">
                  <c:v>3.2678571428571428</c:v>
                </c:pt>
                <c:pt idx="549">
                  <c:v>3.2738095238095237</c:v>
                </c:pt>
                <c:pt idx="550">
                  <c:v>3.2797619047619047</c:v>
                </c:pt>
                <c:pt idx="551">
                  <c:v>3.2857142857142856</c:v>
                </c:pt>
                <c:pt idx="552">
                  <c:v>3.2916666666666665</c:v>
                </c:pt>
                <c:pt idx="553">
                  <c:v>3.2976190476190474</c:v>
                </c:pt>
                <c:pt idx="554">
                  <c:v>3.3035714285714284</c:v>
                </c:pt>
                <c:pt idx="555">
                  <c:v>3.3095238095238093</c:v>
                </c:pt>
                <c:pt idx="556">
                  <c:v>3.3154761904761907</c:v>
                </c:pt>
                <c:pt idx="557">
                  <c:v>3.3214285714285716</c:v>
                </c:pt>
                <c:pt idx="558">
                  <c:v>3.3273809523809526</c:v>
                </c:pt>
                <c:pt idx="559">
                  <c:v>3.3333333333333335</c:v>
                </c:pt>
                <c:pt idx="560">
                  <c:v>3.3392857142857144</c:v>
                </c:pt>
                <c:pt idx="561">
                  <c:v>3.3452380952380953</c:v>
                </c:pt>
                <c:pt idx="562">
                  <c:v>3.3511904761904763</c:v>
                </c:pt>
                <c:pt idx="563">
                  <c:v>3.3571428571428572</c:v>
                </c:pt>
                <c:pt idx="564">
                  <c:v>3.3630952380952381</c:v>
                </c:pt>
                <c:pt idx="565">
                  <c:v>3.3690476190476191</c:v>
                </c:pt>
                <c:pt idx="566">
                  <c:v>3.375</c:v>
                </c:pt>
                <c:pt idx="567">
                  <c:v>3.3809523809523809</c:v>
                </c:pt>
                <c:pt idx="568">
                  <c:v>3.3869047619047619</c:v>
                </c:pt>
                <c:pt idx="569">
                  <c:v>3.3928571428571428</c:v>
                </c:pt>
                <c:pt idx="570">
                  <c:v>3.3988095238095237</c:v>
                </c:pt>
                <c:pt idx="571">
                  <c:v>3.4047619047619047</c:v>
                </c:pt>
                <c:pt idx="572">
                  <c:v>3.4107142857142856</c:v>
                </c:pt>
                <c:pt idx="573">
                  <c:v>3.4166666666666665</c:v>
                </c:pt>
                <c:pt idx="574">
                  <c:v>3.4226190476190474</c:v>
                </c:pt>
                <c:pt idx="575">
                  <c:v>3.4285714285714284</c:v>
                </c:pt>
                <c:pt idx="576">
                  <c:v>3.4345238095238093</c:v>
                </c:pt>
                <c:pt idx="577">
                  <c:v>3.4404761904761907</c:v>
                </c:pt>
                <c:pt idx="578">
                  <c:v>3.4464285714285716</c:v>
                </c:pt>
                <c:pt idx="579">
                  <c:v>3.4523809523809526</c:v>
                </c:pt>
                <c:pt idx="580">
                  <c:v>3.4583333333333335</c:v>
                </c:pt>
                <c:pt idx="581">
                  <c:v>3.4642857142857144</c:v>
                </c:pt>
                <c:pt idx="582">
                  <c:v>3.4702380952380953</c:v>
                </c:pt>
                <c:pt idx="583">
                  <c:v>3.4761904761904763</c:v>
                </c:pt>
                <c:pt idx="584">
                  <c:v>3.4821428571428572</c:v>
                </c:pt>
                <c:pt idx="585">
                  <c:v>3.4880952380952381</c:v>
                </c:pt>
                <c:pt idx="586">
                  <c:v>3.4940476190476191</c:v>
                </c:pt>
                <c:pt idx="587">
                  <c:v>3.5</c:v>
                </c:pt>
                <c:pt idx="588">
                  <c:v>3.5059523809523809</c:v>
                </c:pt>
                <c:pt idx="589">
                  <c:v>3.5119047619047619</c:v>
                </c:pt>
                <c:pt idx="590">
                  <c:v>3.5178571428571428</c:v>
                </c:pt>
                <c:pt idx="591">
                  <c:v>3.5238095238095237</c:v>
                </c:pt>
                <c:pt idx="592">
                  <c:v>3.5297619047619047</c:v>
                </c:pt>
                <c:pt idx="593">
                  <c:v>3.5357142857142856</c:v>
                </c:pt>
                <c:pt idx="594">
                  <c:v>3.5416666666666665</c:v>
                </c:pt>
                <c:pt idx="595">
                  <c:v>3.5476190476190474</c:v>
                </c:pt>
                <c:pt idx="596">
                  <c:v>3.5535714285714284</c:v>
                </c:pt>
                <c:pt idx="597">
                  <c:v>3.5595238095238093</c:v>
                </c:pt>
                <c:pt idx="598">
                  <c:v>3.5654761904761907</c:v>
                </c:pt>
                <c:pt idx="599">
                  <c:v>3.5714285714285716</c:v>
                </c:pt>
                <c:pt idx="600">
                  <c:v>3.5773809523809526</c:v>
                </c:pt>
                <c:pt idx="601">
                  <c:v>3.5833333333333335</c:v>
                </c:pt>
                <c:pt idx="602">
                  <c:v>3.5892857142857144</c:v>
                </c:pt>
                <c:pt idx="603">
                  <c:v>3.5952380952380953</c:v>
                </c:pt>
                <c:pt idx="604">
                  <c:v>3.6011904761904763</c:v>
                </c:pt>
                <c:pt idx="605">
                  <c:v>3.6071428571428572</c:v>
                </c:pt>
                <c:pt idx="606">
                  <c:v>3.6130952380952381</c:v>
                </c:pt>
                <c:pt idx="607">
                  <c:v>3.6190476190476191</c:v>
                </c:pt>
                <c:pt idx="608">
                  <c:v>3.625</c:v>
                </c:pt>
                <c:pt idx="609">
                  <c:v>3.6309523809523809</c:v>
                </c:pt>
                <c:pt idx="610">
                  <c:v>3.6369047619047619</c:v>
                </c:pt>
                <c:pt idx="611">
                  <c:v>3.6428571428571428</c:v>
                </c:pt>
                <c:pt idx="612">
                  <c:v>3.6488095238095237</c:v>
                </c:pt>
                <c:pt idx="613">
                  <c:v>3.6547619047619047</c:v>
                </c:pt>
                <c:pt idx="614">
                  <c:v>3.6607142857142856</c:v>
                </c:pt>
                <c:pt idx="615">
                  <c:v>3.6666666666666665</c:v>
                </c:pt>
                <c:pt idx="616">
                  <c:v>3.6726190476190474</c:v>
                </c:pt>
                <c:pt idx="617">
                  <c:v>3.6785714285714284</c:v>
                </c:pt>
                <c:pt idx="618">
                  <c:v>3.6845238095238093</c:v>
                </c:pt>
                <c:pt idx="619">
                  <c:v>3.6904761904761907</c:v>
                </c:pt>
                <c:pt idx="620">
                  <c:v>3.6964285714285716</c:v>
                </c:pt>
                <c:pt idx="621">
                  <c:v>3.7023809523809526</c:v>
                </c:pt>
                <c:pt idx="622">
                  <c:v>3.7083333333333335</c:v>
                </c:pt>
                <c:pt idx="623">
                  <c:v>3.7142857142857144</c:v>
                </c:pt>
                <c:pt idx="624">
                  <c:v>3.7202380952380953</c:v>
                </c:pt>
                <c:pt idx="625">
                  <c:v>3.7261904761904763</c:v>
                </c:pt>
                <c:pt idx="626">
                  <c:v>3.7321428571428572</c:v>
                </c:pt>
                <c:pt idx="627">
                  <c:v>3.7380952380952381</c:v>
                </c:pt>
                <c:pt idx="628">
                  <c:v>3.7440476190476191</c:v>
                </c:pt>
                <c:pt idx="629">
                  <c:v>3.75</c:v>
                </c:pt>
                <c:pt idx="630">
                  <c:v>3.7559523809523809</c:v>
                </c:pt>
                <c:pt idx="631">
                  <c:v>3.7619047619047619</c:v>
                </c:pt>
                <c:pt idx="632">
                  <c:v>3.7678571428571428</c:v>
                </c:pt>
                <c:pt idx="633">
                  <c:v>3.7738095238095237</c:v>
                </c:pt>
                <c:pt idx="634">
                  <c:v>3.7797619047619047</c:v>
                </c:pt>
                <c:pt idx="635">
                  <c:v>3.7857142857142856</c:v>
                </c:pt>
                <c:pt idx="636">
                  <c:v>3.7916666666666665</c:v>
                </c:pt>
                <c:pt idx="637">
                  <c:v>3.7976190476190474</c:v>
                </c:pt>
                <c:pt idx="638">
                  <c:v>3.8035714285714284</c:v>
                </c:pt>
                <c:pt idx="639">
                  <c:v>3.8095238095238093</c:v>
                </c:pt>
                <c:pt idx="640">
                  <c:v>3.8154761904761907</c:v>
                </c:pt>
                <c:pt idx="641">
                  <c:v>3.8214285714285716</c:v>
                </c:pt>
                <c:pt idx="642">
                  <c:v>3.8273809523809526</c:v>
                </c:pt>
                <c:pt idx="643">
                  <c:v>3.8333333333333335</c:v>
                </c:pt>
                <c:pt idx="644">
                  <c:v>3.8392857142857144</c:v>
                </c:pt>
                <c:pt idx="645">
                  <c:v>3.8452380952380953</c:v>
                </c:pt>
                <c:pt idx="646">
                  <c:v>3.8511904761904763</c:v>
                </c:pt>
                <c:pt idx="647">
                  <c:v>3.8571428571428572</c:v>
                </c:pt>
                <c:pt idx="648">
                  <c:v>3.8630952380952381</c:v>
                </c:pt>
                <c:pt idx="649">
                  <c:v>3.8690476190476191</c:v>
                </c:pt>
                <c:pt idx="650">
                  <c:v>3.875</c:v>
                </c:pt>
                <c:pt idx="651">
                  <c:v>3.8809523809523809</c:v>
                </c:pt>
                <c:pt idx="652">
                  <c:v>3.8869047619047619</c:v>
                </c:pt>
                <c:pt idx="653">
                  <c:v>3.8928571428571428</c:v>
                </c:pt>
                <c:pt idx="654">
                  <c:v>3.8988095238095237</c:v>
                </c:pt>
                <c:pt idx="655">
                  <c:v>3.9047619047619047</c:v>
                </c:pt>
                <c:pt idx="656">
                  <c:v>3.9107142857142856</c:v>
                </c:pt>
                <c:pt idx="657">
                  <c:v>3.9166666666666665</c:v>
                </c:pt>
                <c:pt idx="658">
                  <c:v>3.9226190476190474</c:v>
                </c:pt>
                <c:pt idx="659">
                  <c:v>3.9285714285714284</c:v>
                </c:pt>
                <c:pt idx="660">
                  <c:v>3.9345238095238093</c:v>
                </c:pt>
                <c:pt idx="661">
                  <c:v>3.9404761904761907</c:v>
                </c:pt>
                <c:pt idx="662">
                  <c:v>3.9464285714285716</c:v>
                </c:pt>
                <c:pt idx="663">
                  <c:v>3.9523809523809526</c:v>
                </c:pt>
                <c:pt idx="664">
                  <c:v>3.9583333333333335</c:v>
                </c:pt>
                <c:pt idx="665">
                  <c:v>3.9642857142857144</c:v>
                </c:pt>
                <c:pt idx="666">
                  <c:v>3.9702380952380953</c:v>
                </c:pt>
                <c:pt idx="667">
                  <c:v>3.9761904761904763</c:v>
                </c:pt>
                <c:pt idx="668">
                  <c:v>3.9821428571428572</c:v>
                </c:pt>
                <c:pt idx="669">
                  <c:v>3.9880952380952381</c:v>
                </c:pt>
                <c:pt idx="670">
                  <c:v>3.9940476190476191</c:v>
                </c:pt>
                <c:pt idx="671">
                  <c:v>4</c:v>
                </c:pt>
                <c:pt idx="672">
                  <c:v>4.0059523809523814</c:v>
                </c:pt>
                <c:pt idx="673">
                  <c:v>4.0119047619047619</c:v>
                </c:pt>
                <c:pt idx="674">
                  <c:v>4.0178571428571432</c:v>
                </c:pt>
                <c:pt idx="675">
                  <c:v>4.0238095238095237</c:v>
                </c:pt>
                <c:pt idx="676">
                  <c:v>4.0297619047619051</c:v>
                </c:pt>
                <c:pt idx="677">
                  <c:v>4.0357142857142856</c:v>
                </c:pt>
                <c:pt idx="678">
                  <c:v>4.041666666666667</c:v>
                </c:pt>
                <c:pt idx="679">
                  <c:v>4.0476190476190474</c:v>
                </c:pt>
                <c:pt idx="680">
                  <c:v>4.0535714285714288</c:v>
                </c:pt>
                <c:pt idx="681">
                  <c:v>4.0595238095238093</c:v>
                </c:pt>
                <c:pt idx="682">
                  <c:v>4.0654761904761907</c:v>
                </c:pt>
                <c:pt idx="683">
                  <c:v>4.0714285714285712</c:v>
                </c:pt>
                <c:pt idx="684">
                  <c:v>4.0773809523809526</c:v>
                </c:pt>
                <c:pt idx="685">
                  <c:v>4.083333333333333</c:v>
                </c:pt>
                <c:pt idx="686">
                  <c:v>4.0892857142857144</c:v>
                </c:pt>
                <c:pt idx="687">
                  <c:v>4.0952380952380949</c:v>
                </c:pt>
                <c:pt idx="688">
                  <c:v>4.1011904761904763</c:v>
                </c:pt>
                <c:pt idx="689">
                  <c:v>4.1071428571428568</c:v>
                </c:pt>
                <c:pt idx="690">
                  <c:v>4.1130952380952381</c:v>
                </c:pt>
                <c:pt idx="691">
                  <c:v>4.1190476190476186</c:v>
                </c:pt>
                <c:pt idx="692">
                  <c:v>4.125</c:v>
                </c:pt>
                <c:pt idx="693">
                  <c:v>4.1309523809523814</c:v>
                </c:pt>
                <c:pt idx="694">
                  <c:v>4.1369047619047619</c:v>
                </c:pt>
                <c:pt idx="695">
                  <c:v>4.1428571428571432</c:v>
                </c:pt>
                <c:pt idx="696">
                  <c:v>4.1488095238095237</c:v>
                </c:pt>
                <c:pt idx="697">
                  <c:v>4.1547619047619051</c:v>
                </c:pt>
                <c:pt idx="698">
                  <c:v>4.1607142857142856</c:v>
                </c:pt>
                <c:pt idx="699">
                  <c:v>4.166666666666667</c:v>
                </c:pt>
                <c:pt idx="700">
                  <c:v>4.1726190476190474</c:v>
                </c:pt>
                <c:pt idx="701">
                  <c:v>4.1785714285714288</c:v>
                </c:pt>
                <c:pt idx="702">
                  <c:v>4.1845238095238093</c:v>
                </c:pt>
                <c:pt idx="703">
                  <c:v>4.1904761904761907</c:v>
                </c:pt>
                <c:pt idx="704">
                  <c:v>4.1964285714285712</c:v>
                </c:pt>
                <c:pt idx="705">
                  <c:v>4.2023809523809526</c:v>
                </c:pt>
                <c:pt idx="706">
                  <c:v>4.208333333333333</c:v>
                </c:pt>
                <c:pt idx="707">
                  <c:v>4.2142857142857144</c:v>
                </c:pt>
                <c:pt idx="708">
                  <c:v>4.2202380952380949</c:v>
                </c:pt>
                <c:pt idx="709">
                  <c:v>4.2261904761904763</c:v>
                </c:pt>
                <c:pt idx="710">
                  <c:v>4.2321428571428568</c:v>
                </c:pt>
                <c:pt idx="711">
                  <c:v>4.2380952380952381</c:v>
                </c:pt>
                <c:pt idx="712">
                  <c:v>4.2440476190476186</c:v>
                </c:pt>
                <c:pt idx="713">
                  <c:v>4.25</c:v>
                </c:pt>
                <c:pt idx="714">
                  <c:v>4.2559523809523814</c:v>
                </c:pt>
                <c:pt idx="715">
                  <c:v>4.2619047619047619</c:v>
                </c:pt>
                <c:pt idx="716">
                  <c:v>4.2678571428571432</c:v>
                </c:pt>
                <c:pt idx="717">
                  <c:v>4.2738095238095237</c:v>
                </c:pt>
                <c:pt idx="718">
                  <c:v>4.2797619047619051</c:v>
                </c:pt>
                <c:pt idx="719">
                  <c:v>4.2857142857142856</c:v>
                </c:pt>
                <c:pt idx="720">
                  <c:v>4.291666666666667</c:v>
                </c:pt>
                <c:pt idx="721">
                  <c:v>4.2976190476190474</c:v>
                </c:pt>
                <c:pt idx="722">
                  <c:v>4.3035714285714288</c:v>
                </c:pt>
                <c:pt idx="723">
                  <c:v>4.3095238095238093</c:v>
                </c:pt>
                <c:pt idx="724">
                  <c:v>4.3154761904761907</c:v>
                </c:pt>
                <c:pt idx="725">
                  <c:v>4.3214285714285712</c:v>
                </c:pt>
                <c:pt idx="726">
                  <c:v>4.3273809523809526</c:v>
                </c:pt>
                <c:pt idx="727">
                  <c:v>4.333333333333333</c:v>
                </c:pt>
                <c:pt idx="728">
                  <c:v>4.3392857142857144</c:v>
                </c:pt>
                <c:pt idx="729">
                  <c:v>4.3452380952380949</c:v>
                </c:pt>
                <c:pt idx="730">
                  <c:v>4.3511904761904763</c:v>
                </c:pt>
                <c:pt idx="731">
                  <c:v>4.3571428571428568</c:v>
                </c:pt>
                <c:pt idx="732">
                  <c:v>4.3630952380952381</c:v>
                </c:pt>
                <c:pt idx="733">
                  <c:v>4.3690476190476186</c:v>
                </c:pt>
                <c:pt idx="734">
                  <c:v>4.375</c:v>
                </c:pt>
                <c:pt idx="735">
                  <c:v>4.3809523809523814</c:v>
                </c:pt>
                <c:pt idx="736">
                  <c:v>4.3869047619047619</c:v>
                </c:pt>
                <c:pt idx="737">
                  <c:v>4.3928571428571432</c:v>
                </c:pt>
                <c:pt idx="738">
                  <c:v>4.3988095238095237</c:v>
                </c:pt>
                <c:pt idx="739">
                  <c:v>4.4047619047619051</c:v>
                </c:pt>
                <c:pt idx="740">
                  <c:v>4.4107142857142856</c:v>
                </c:pt>
                <c:pt idx="741">
                  <c:v>4.416666666666667</c:v>
                </c:pt>
                <c:pt idx="742">
                  <c:v>4.4226190476190474</c:v>
                </c:pt>
                <c:pt idx="743">
                  <c:v>4.4285714285714288</c:v>
                </c:pt>
                <c:pt idx="744">
                  <c:v>4.4345238095238093</c:v>
                </c:pt>
                <c:pt idx="745">
                  <c:v>4.4404761904761907</c:v>
                </c:pt>
                <c:pt idx="746">
                  <c:v>4.4464285714285712</c:v>
                </c:pt>
                <c:pt idx="747">
                  <c:v>4.4523809523809526</c:v>
                </c:pt>
                <c:pt idx="748">
                  <c:v>4.458333333333333</c:v>
                </c:pt>
                <c:pt idx="749">
                  <c:v>4.4642857142857144</c:v>
                </c:pt>
                <c:pt idx="750">
                  <c:v>4.4702380952380949</c:v>
                </c:pt>
                <c:pt idx="751">
                  <c:v>4.4761904761904763</c:v>
                </c:pt>
                <c:pt idx="752">
                  <c:v>4.4821428571428568</c:v>
                </c:pt>
                <c:pt idx="753">
                  <c:v>4.4880952380952381</c:v>
                </c:pt>
                <c:pt idx="754">
                  <c:v>4.4940476190476186</c:v>
                </c:pt>
                <c:pt idx="755">
                  <c:v>4.5</c:v>
                </c:pt>
                <c:pt idx="756">
                  <c:v>4.5059523809523814</c:v>
                </c:pt>
                <c:pt idx="757">
                  <c:v>4.5119047619047619</c:v>
                </c:pt>
                <c:pt idx="758">
                  <c:v>4.5178571428571432</c:v>
                </c:pt>
                <c:pt idx="759">
                  <c:v>4.5238095238095237</c:v>
                </c:pt>
                <c:pt idx="760">
                  <c:v>4.5297619047619051</c:v>
                </c:pt>
                <c:pt idx="761">
                  <c:v>4.5357142857142856</c:v>
                </c:pt>
                <c:pt idx="762">
                  <c:v>4.541666666666667</c:v>
                </c:pt>
                <c:pt idx="763">
                  <c:v>4.5476190476190474</c:v>
                </c:pt>
                <c:pt idx="764">
                  <c:v>4.5535714285714288</c:v>
                </c:pt>
                <c:pt idx="765">
                  <c:v>4.5595238095238093</c:v>
                </c:pt>
                <c:pt idx="766">
                  <c:v>4.5654761904761907</c:v>
                </c:pt>
                <c:pt idx="767">
                  <c:v>4.5714285714285712</c:v>
                </c:pt>
                <c:pt idx="768">
                  <c:v>4.5773809523809526</c:v>
                </c:pt>
                <c:pt idx="769">
                  <c:v>4.583333333333333</c:v>
                </c:pt>
                <c:pt idx="770">
                  <c:v>4.5892857142857144</c:v>
                </c:pt>
                <c:pt idx="771">
                  <c:v>4.5952380952380949</c:v>
                </c:pt>
                <c:pt idx="772">
                  <c:v>4.6011904761904763</c:v>
                </c:pt>
                <c:pt idx="773">
                  <c:v>4.6071428571428568</c:v>
                </c:pt>
                <c:pt idx="774">
                  <c:v>4.6130952380952381</c:v>
                </c:pt>
                <c:pt idx="775">
                  <c:v>4.6190476190476186</c:v>
                </c:pt>
                <c:pt idx="776">
                  <c:v>4.625</c:v>
                </c:pt>
                <c:pt idx="777">
                  <c:v>4.6309523809523814</c:v>
                </c:pt>
                <c:pt idx="778">
                  <c:v>4.6369047619047619</c:v>
                </c:pt>
                <c:pt idx="779">
                  <c:v>4.6428571428571432</c:v>
                </c:pt>
                <c:pt idx="780">
                  <c:v>4.6488095238095237</c:v>
                </c:pt>
                <c:pt idx="781">
                  <c:v>4.6547619047619051</c:v>
                </c:pt>
                <c:pt idx="782">
                  <c:v>4.6607142857142856</c:v>
                </c:pt>
                <c:pt idx="783">
                  <c:v>4.666666666666667</c:v>
                </c:pt>
                <c:pt idx="784">
                  <c:v>4.6726190476190474</c:v>
                </c:pt>
                <c:pt idx="785">
                  <c:v>4.6785714285714288</c:v>
                </c:pt>
                <c:pt idx="786">
                  <c:v>4.6845238095238093</c:v>
                </c:pt>
                <c:pt idx="787">
                  <c:v>4.6904761904761907</c:v>
                </c:pt>
                <c:pt idx="788">
                  <c:v>4.6964285714285712</c:v>
                </c:pt>
                <c:pt idx="789">
                  <c:v>4.7023809523809526</c:v>
                </c:pt>
                <c:pt idx="790">
                  <c:v>4.708333333333333</c:v>
                </c:pt>
                <c:pt idx="791">
                  <c:v>4.7142857142857144</c:v>
                </c:pt>
                <c:pt idx="792">
                  <c:v>4.7202380952380949</c:v>
                </c:pt>
                <c:pt idx="793">
                  <c:v>4.7261904761904763</c:v>
                </c:pt>
                <c:pt idx="794">
                  <c:v>4.7321428571428568</c:v>
                </c:pt>
                <c:pt idx="795">
                  <c:v>4.7380952380952381</c:v>
                </c:pt>
                <c:pt idx="796">
                  <c:v>4.7440476190476186</c:v>
                </c:pt>
                <c:pt idx="797">
                  <c:v>4.75</c:v>
                </c:pt>
                <c:pt idx="798">
                  <c:v>4.7559523809523814</c:v>
                </c:pt>
                <c:pt idx="799">
                  <c:v>4.7619047619047619</c:v>
                </c:pt>
                <c:pt idx="800">
                  <c:v>4.7678571428571432</c:v>
                </c:pt>
                <c:pt idx="801">
                  <c:v>4.7738095238095237</c:v>
                </c:pt>
                <c:pt idx="802">
                  <c:v>4.7797619047619051</c:v>
                </c:pt>
                <c:pt idx="803">
                  <c:v>4.7857142857142856</c:v>
                </c:pt>
                <c:pt idx="804">
                  <c:v>4.791666666666667</c:v>
                </c:pt>
                <c:pt idx="805">
                  <c:v>4.7976190476190474</c:v>
                </c:pt>
                <c:pt idx="806">
                  <c:v>4.8035714285714288</c:v>
                </c:pt>
                <c:pt idx="807">
                  <c:v>4.8095238095238093</c:v>
                </c:pt>
                <c:pt idx="808">
                  <c:v>4.8154761904761907</c:v>
                </c:pt>
                <c:pt idx="809">
                  <c:v>4.8214285714285712</c:v>
                </c:pt>
                <c:pt idx="810">
                  <c:v>4.8273809523809526</c:v>
                </c:pt>
                <c:pt idx="811">
                  <c:v>4.833333333333333</c:v>
                </c:pt>
                <c:pt idx="812">
                  <c:v>4.8392857142857144</c:v>
                </c:pt>
                <c:pt idx="813">
                  <c:v>4.8452380952380949</c:v>
                </c:pt>
                <c:pt idx="814">
                  <c:v>4.8511904761904763</c:v>
                </c:pt>
                <c:pt idx="815">
                  <c:v>4.8571428571428568</c:v>
                </c:pt>
                <c:pt idx="816">
                  <c:v>4.8630952380952381</c:v>
                </c:pt>
                <c:pt idx="817">
                  <c:v>4.8690476190476186</c:v>
                </c:pt>
                <c:pt idx="818">
                  <c:v>4.875</c:v>
                </c:pt>
                <c:pt idx="819">
                  <c:v>4.8809523809523814</c:v>
                </c:pt>
                <c:pt idx="820">
                  <c:v>4.8869047619047619</c:v>
                </c:pt>
                <c:pt idx="821">
                  <c:v>4.8928571428571432</c:v>
                </c:pt>
                <c:pt idx="822">
                  <c:v>4.8988095238095237</c:v>
                </c:pt>
                <c:pt idx="823">
                  <c:v>4.9047619047619051</c:v>
                </c:pt>
                <c:pt idx="824">
                  <c:v>4.9107142857142856</c:v>
                </c:pt>
                <c:pt idx="825">
                  <c:v>4.916666666666667</c:v>
                </c:pt>
                <c:pt idx="826">
                  <c:v>4.9226190476190474</c:v>
                </c:pt>
                <c:pt idx="827">
                  <c:v>4.9285714285714288</c:v>
                </c:pt>
                <c:pt idx="828">
                  <c:v>4.9345238095238093</c:v>
                </c:pt>
                <c:pt idx="829">
                  <c:v>4.9404761904761907</c:v>
                </c:pt>
                <c:pt idx="830">
                  <c:v>4.9464285714285712</c:v>
                </c:pt>
                <c:pt idx="831">
                  <c:v>4.9523809523809526</c:v>
                </c:pt>
                <c:pt idx="832">
                  <c:v>4.958333333333333</c:v>
                </c:pt>
                <c:pt idx="833">
                  <c:v>4.9642857142857144</c:v>
                </c:pt>
                <c:pt idx="834">
                  <c:v>4.9702380952380949</c:v>
                </c:pt>
                <c:pt idx="835">
                  <c:v>4.9761904761904763</c:v>
                </c:pt>
                <c:pt idx="836">
                  <c:v>4.9821428571428568</c:v>
                </c:pt>
                <c:pt idx="837">
                  <c:v>4.9880952380952381</c:v>
                </c:pt>
                <c:pt idx="838">
                  <c:v>4.9940476190476186</c:v>
                </c:pt>
                <c:pt idx="839">
                  <c:v>5</c:v>
                </c:pt>
                <c:pt idx="840">
                  <c:v>5.0059523809523814</c:v>
                </c:pt>
                <c:pt idx="841">
                  <c:v>5.0119047619047619</c:v>
                </c:pt>
                <c:pt idx="842">
                  <c:v>5.0178571428571432</c:v>
                </c:pt>
                <c:pt idx="843">
                  <c:v>5.0238095238095237</c:v>
                </c:pt>
                <c:pt idx="844">
                  <c:v>5.0297619047619051</c:v>
                </c:pt>
                <c:pt idx="845">
                  <c:v>5.0357142857142856</c:v>
                </c:pt>
                <c:pt idx="846">
                  <c:v>5.041666666666667</c:v>
                </c:pt>
                <c:pt idx="847">
                  <c:v>5.0476190476190474</c:v>
                </c:pt>
                <c:pt idx="848">
                  <c:v>5.0535714285714288</c:v>
                </c:pt>
                <c:pt idx="849">
                  <c:v>5.0595238095238093</c:v>
                </c:pt>
                <c:pt idx="850">
                  <c:v>5.0654761904761907</c:v>
                </c:pt>
                <c:pt idx="851">
                  <c:v>5.0714285714285712</c:v>
                </c:pt>
                <c:pt idx="852">
                  <c:v>5.0773809523809526</c:v>
                </c:pt>
                <c:pt idx="853">
                  <c:v>5.083333333333333</c:v>
                </c:pt>
                <c:pt idx="854">
                  <c:v>5.0892857142857144</c:v>
                </c:pt>
                <c:pt idx="855">
                  <c:v>5.0952380952380949</c:v>
                </c:pt>
                <c:pt idx="856">
                  <c:v>5.1011904761904763</c:v>
                </c:pt>
                <c:pt idx="857">
                  <c:v>5.1071428571428568</c:v>
                </c:pt>
                <c:pt idx="858">
                  <c:v>5.1130952380952381</c:v>
                </c:pt>
                <c:pt idx="859">
                  <c:v>5.1190476190476186</c:v>
                </c:pt>
                <c:pt idx="860">
                  <c:v>5.125</c:v>
                </c:pt>
                <c:pt idx="861">
                  <c:v>5.1309523809523814</c:v>
                </c:pt>
                <c:pt idx="862">
                  <c:v>5.1369047619047619</c:v>
                </c:pt>
                <c:pt idx="863">
                  <c:v>5.1428571428571432</c:v>
                </c:pt>
                <c:pt idx="864">
                  <c:v>5.1488095238095237</c:v>
                </c:pt>
                <c:pt idx="865">
                  <c:v>5.1547619047619051</c:v>
                </c:pt>
                <c:pt idx="866">
                  <c:v>5.1607142857142856</c:v>
                </c:pt>
                <c:pt idx="867">
                  <c:v>5.166666666666667</c:v>
                </c:pt>
                <c:pt idx="868">
                  <c:v>5.1726190476190474</c:v>
                </c:pt>
                <c:pt idx="869">
                  <c:v>5.1785714285714288</c:v>
                </c:pt>
                <c:pt idx="870">
                  <c:v>5.1845238095238093</c:v>
                </c:pt>
                <c:pt idx="871">
                  <c:v>5.1904761904761907</c:v>
                </c:pt>
                <c:pt idx="872">
                  <c:v>5.1964285714285712</c:v>
                </c:pt>
                <c:pt idx="873">
                  <c:v>5.2023809523809526</c:v>
                </c:pt>
                <c:pt idx="874">
                  <c:v>5.208333333333333</c:v>
                </c:pt>
                <c:pt idx="875">
                  <c:v>5.2142857142857144</c:v>
                </c:pt>
                <c:pt idx="876">
                  <c:v>5.2202380952380949</c:v>
                </c:pt>
                <c:pt idx="877">
                  <c:v>5.2261904761904763</c:v>
                </c:pt>
                <c:pt idx="878">
                  <c:v>5.2321428571428568</c:v>
                </c:pt>
                <c:pt idx="879">
                  <c:v>5.2380952380952381</c:v>
                </c:pt>
                <c:pt idx="880">
                  <c:v>5.2440476190476186</c:v>
                </c:pt>
                <c:pt idx="881">
                  <c:v>5.25</c:v>
                </c:pt>
                <c:pt idx="882">
                  <c:v>5.2559523809523814</c:v>
                </c:pt>
                <c:pt idx="883">
                  <c:v>5.2619047619047619</c:v>
                </c:pt>
                <c:pt idx="884">
                  <c:v>5.2678571428571432</c:v>
                </c:pt>
                <c:pt idx="885">
                  <c:v>5.2738095238095237</c:v>
                </c:pt>
                <c:pt idx="886">
                  <c:v>5.2797619047619051</c:v>
                </c:pt>
                <c:pt idx="887">
                  <c:v>5.2857142857142856</c:v>
                </c:pt>
                <c:pt idx="888">
                  <c:v>5.291666666666667</c:v>
                </c:pt>
                <c:pt idx="889">
                  <c:v>5.2976190476190474</c:v>
                </c:pt>
                <c:pt idx="890">
                  <c:v>5.3035714285714288</c:v>
                </c:pt>
                <c:pt idx="891">
                  <c:v>5.3095238095238093</c:v>
                </c:pt>
                <c:pt idx="892">
                  <c:v>5.3154761904761907</c:v>
                </c:pt>
                <c:pt idx="893">
                  <c:v>5.3214285714285712</c:v>
                </c:pt>
                <c:pt idx="894">
                  <c:v>5.3273809523809526</c:v>
                </c:pt>
                <c:pt idx="895">
                  <c:v>5.333333333333333</c:v>
                </c:pt>
                <c:pt idx="896">
                  <c:v>5.3392857142857144</c:v>
                </c:pt>
                <c:pt idx="897">
                  <c:v>5.3452380952380949</c:v>
                </c:pt>
                <c:pt idx="898">
                  <c:v>5.3511904761904763</c:v>
                </c:pt>
                <c:pt idx="899">
                  <c:v>5.3571428571428568</c:v>
                </c:pt>
                <c:pt idx="900">
                  <c:v>5.3630952380952381</c:v>
                </c:pt>
                <c:pt idx="901">
                  <c:v>5.3690476190476186</c:v>
                </c:pt>
                <c:pt idx="902">
                  <c:v>5.375</c:v>
                </c:pt>
                <c:pt idx="903">
                  <c:v>5.3809523809523814</c:v>
                </c:pt>
                <c:pt idx="904">
                  <c:v>5.3869047619047619</c:v>
                </c:pt>
                <c:pt idx="905">
                  <c:v>5.3928571428571432</c:v>
                </c:pt>
                <c:pt idx="906">
                  <c:v>5.3988095238095237</c:v>
                </c:pt>
                <c:pt idx="907">
                  <c:v>5.4047619047619051</c:v>
                </c:pt>
                <c:pt idx="908">
                  <c:v>5.4107142857142856</c:v>
                </c:pt>
                <c:pt idx="909">
                  <c:v>5.416666666666667</c:v>
                </c:pt>
                <c:pt idx="910">
                  <c:v>5.4226190476190474</c:v>
                </c:pt>
                <c:pt idx="911">
                  <c:v>5.4285714285714288</c:v>
                </c:pt>
                <c:pt idx="912">
                  <c:v>5.4345238095238093</c:v>
                </c:pt>
                <c:pt idx="913">
                  <c:v>5.4404761904761907</c:v>
                </c:pt>
                <c:pt idx="914">
                  <c:v>5.4464285714285712</c:v>
                </c:pt>
                <c:pt idx="915">
                  <c:v>5.4523809523809526</c:v>
                </c:pt>
                <c:pt idx="916">
                  <c:v>5.458333333333333</c:v>
                </c:pt>
                <c:pt idx="917">
                  <c:v>5.4642857142857144</c:v>
                </c:pt>
                <c:pt idx="918">
                  <c:v>5.4702380952380949</c:v>
                </c:pt>
                <c:pt idx="919">
                  <c:v>5.4761904761904763</c:v>
                </c:pt>
                <c:pt idx="920">
                  <c:v>5.4821428571428568</c:v>
                </c:pt>
                <c:pt idx="921">
                  <c:v>5.4880952380952381</c:v>
                </c:pt>
                <c:pt idx="922">
                  <c:v>5.4940476190476186</c:v>
                </c:pt>
                <c:pt idx="923">
                  <c:v>5.5</c:v>
                </c:pt>
                <c:pt idx="924">
                  <c:v>5.5059523809523814</c:v>
                </c:pt>
                <c:pt idx="925">
                  <c:v>5.5119047619047619</c:v>
                </c:pt>
                <c:pt idx="926">
                  <c:v>5.5178571428571432</c:v>
                </c:pt>
                <c:pt idx="927">
                  <c:v>5.5238095238095237</c:v>
                </c:pt>
                <c:pt idx="928">
                  <c:v>5.5297619047619051</c:v>
                </c:pt>
                <c:pt idx="929">
                  <c:v>5.5357142857142856</c:v>
                </c:pt>
                <c:pt idx="930">
                  <c:v>5.541666666666667</c:v>
                </c:pt>
                <c:pt idx="931">
                  <c:v>5.5476190476190474</c:v>
                </c:pt>
                <c:pt idx="932">
                  <c:v>5.5535714285714288</c:v>
                </c:pt>
                <c:pt idx="933">
                  <c:v>5.5595238095238093</c:v>
                </c:pt>
                <c:pt idx="934">
                  <c:v>5.5654761904761907</c:v>
                </c:pt>
                <c:pt idx="935">
                  <c:v>5.5714285714285712</c:v>
                </c:pt>
                <c:pt idx="936">
                  <c:v>5.5773809523809526</c:v>
                </c:pt>
                <c:pt idx="937">
                  <c:v>5.583333333333333</c:v>
                </c:pt>
                <c:pt idx="938">
                  <c:v>5.5892857142857144</c:v>
                </c:pt>
                <c:pt idx="939">
                  <c:v>5.5952380952380949</c:v>
                </c:pt>
                <c:pt idx="940">
                  <c:v>5.6011904761904763</c:v>
                </c:pt>
                <c:pt idx="941">
                  <c:v>5.6071428571428568</c:v>
                </c:pt>
                <c:pt idx="942">
                  <c:v>5.6130952380952381</c:v>
                </c:pt>
                <c:pt idx="943">
                  <c:v>5.6190476190476186</c:v>
                </c:pt>
                <c:pt idx="944">
                  <c:v>5.625</c:v>
                </c:pt>
                <c:pt idx="945">
                  <c:v>5.6309523809523814</c:v>
                </c:pt>
                <c:pt idx="946">
                  <c:v>5.6369047619047619</c:v>
                </c:pt>
                <c:pt idx="947">
                  <c:v>5.6428571428571432</c:v>
                </c:pt>
                <c:pt idx="948">
                  <c:v>5.6488095238095237</c:v>
                </c:pt>
                <c:pt idx="949">
                  <c:v>5.6547619047619051</c:v>
                </c:pt>
                <c:pt idx="950">
                  <c:v>5.6607142857142856</c:v>
                </c:pt>
                <c:pt idx="951">
                  <c:v>5.666666666666667</c:v>
                </c:pt>
                <c:pt idx="952">
                  <c:v>5.6726190476190474</c:v>
                </c:pt>
                <c:pt idx="953">
                  <c:v>5.6785714285714288</c:v>
                </c:pt>
                <c:pt idx="954">
                  <c:v>5.6845238095238093</c:v>
                </c:pt>
                <c:pt idx="955">
                  <c:v>5.6904761904761907</c:v>
                </c:pt>
                <c:pt idx="956">
                  <c:v>5.6964285714285712</c:v>
                </c:pt>
                <c:pt idx="957">
                  <c:v>5.7023809523809526</c:v>
                </c:pt>
                <c:pt idx="958">
                  <c:v>5.708333333333333</c:v>
                </c:pt>
                <c:pt idx="959">
                  <c:v>5.7142857142857144</c:v>
                </c:pt>
                <c:pt idx="960">
                  <c:v>5.7202380952380949</c:v>
                </c:pt>
                <c:pt idx="961">
                  <c:v>5.7261904761904763</c:v>
                </c:pt>
                <c:pt idx="962">
                  <c:v>5.7321428571428568</c:v>
                </c:pt>
                <c:pt idx="963">
                  <c:v>5.7380952380952381</c:v>
                </c:pt>
                <c:pt idx="964">
                  <c:v>5.7440476190476186</c:v>
                </c:pt>
                <c:pt idx="965">
                  <c:v>5.75</c:v>
                </c:pt>
                <c:pt idx="966">
                  <c:v>5.7559523809523814</c:v>
                </c:pt>
                <c:pt idx="967">
                  <c:v>5.7619047619047619</c:v>
                </c:pt>
                <c:pt idx="968">
                  <c:v>5.7678571428571432</c:v>
                </c:pt>
                <c:pt idx="969">
                  <c:v>5.7738095238095237</c:v>
                </c:pt>
                <c:pt idx="970">
                  <c:v>5.7797619047619051</c:v>
                </c:pt>
                <c:pt idx="971">
                  <c:v>5.7857142857142856</c:v>
                </c:pt>
                <c:pt idx="972">
                  <c:v>5.791666666666667</c:v>
                </c:pt>
                <c:pt idx="973">
                  <c:v>5.7976190476190474</c:v>
                </c:pt>
                <c:pt idx="974">
                  <c:v>5.8035714285714288</c:v>
                </c:pt>
                <c:pt idx="975">
                  <c:v>5.8095238095238093</c:v>
                </c:pt>
                <c:pt idx="976">
                  <c:v>5.8154761904761907</c:v>
                </c:pt>
                <c:pt idx="977">
                  <c:v>5.8214285714285712</c:v>
                </c:pt>
                <c:pt idx="978">
                  <c:v>5.8273809523809526</c:v>
                </c:pt>
                <c:pt idx="979">
                  <c:v>5.833333333333333</c:v>
                </c:pt>
                <c:pt idx="980">
                  <c:v>5.8392857142857144</c:v>
                </c:pt>
                <c:pt idx="981">
                  <c:v>5.8452380952380949</c:v>
                </c:pt>
                <c:pt idx="982">
                  <c:v>5.8511904761904763</c:v>
                </c:pt>
                <c:pt idx="983">
                  <c:v>5.8571428571428568</c:v>
                </c:pt>
                <c:pt idx="984">
                  <c:v>5.8630952380952381</c:v>
                </c:pt>
                <c:pt idx="985">
                  <c:v>5.8690476190476186</c:v>
                </c:pt>
                <c:pt idx="986">
                  <c:v>5.875</c:v>
                </c:pt>
                <c:pt idx="987">
                  <c:v>5.8809523809523814</c:v>
                </c:pt>
                <c:pt idx="988">
                  <c:v>5.8869047619047619</c:v>
                </c:pt>
                <c:pt idx="989">
                  <c:v>5.8928571428571432</c:v>
                </c:pt>
                <c:pt idx="990">
                  <c:v>5.8988095238095237</c:v>
                </c:pt>
                <c:pt idx="991">
                  <c:v>5.9047619047619051</c:v>
                </c:pt>
                <c:pt idx="992">
                  <c:v>5.9107142857142856</c:v>
                </c:pt>
                <c:pt idx="993">
                  <c:v>5.916666666666667</c:v>
                </c:pt>
                <c:pt idx="994">
                  <c:v>5.9226190476190474</c:v>
                </c:pt>
                <c:pt idx="995">
                  <c:v>5.9285714285714288</c:v>
                </c:pt>
                <c:pt idx="996">
                  <c:v>5.9345238095238093</c:v>
                </c:pt>
                <c:pt idx="997">
                  <c:v>5.9404761904761907</c:v>
                </c:pt>
                <c:pt idx="998">
                  <c:v>5.9464285714285712</c:v>
                </c:pt>
                <c:pt idx="999">
                  <c:v>5.9523809523809526</c:v>
                </c:pt>
                <c:pt idx="1000">
                  <c:v>5.958333333333333</c:v>
                </c:pt>
                <c:pt idx="1001">
                  <c:v>5.9642857142857144</c:v>
                </c:pt>
                <c:pt idx="1002">
                  <c:v>5.9702380952380949</c:v>
                </c:pt>
                <c:pt idx="1003">
                  <c:v>5.9761904761904763</c:v>
                </c:pt>
                <c:pt idx="1004">
                  <c:v>5.9821428571428568</c:v>
                </c:pt>
                <c:pt idx="1005">
                  <c:v>5.9880952380952381</c:v>
                </c:pt>
                <c:pt idx="1006">
                  <c:v>5.9940476190476186</c:v>
                </c:pt>
                <c:pt idx="1007">
                  <c:v>6</c:v>
                </c:pt>
                <c:pt idx="1008">
                  <c:v>6.0059523809523814</c:v>
                </c:pt>
                <c:pt idx="1009">
                  <c:v>6.0119047619047619</c:v>
                </c:pt>
                <c:pt idx="1010">
                  <c:v>6.0178571428571432</c:v>
                </c:pt>
                <c:pt idx="1011">
                  <c:v>6.0238095238095237</c:v>
                </c:pt>
                <c:pt idx="1012">
                  <c:v>6.0297619047619051</c:v>
                </c:pt>
                <c:pt idx="1013">
                  <c:v>6.0357142857142856</c:v>
                </c:pt>
                <c:pt idx="1014">
                  <c:v>6.041666666666667</c:v>
                </c:pt>
                <c:pt idx="1015">
                  <c:v>6.0476190476190474</c:v>
                </c:pt>
                <c:pt idx="1016">
                  <c:v>6.0535714285714288</c:v>
                </c:pt>
                <c:pt idx="1017">
                  <c:v>6.0595238095238093</c:v>
                </c:pt>
                <c:pt idx="1018">
                  <c:v>6.0654761904761907</c:v>
                </c:pt>
                <c:pt idx="1019">
                  <c:v>6.0714285714285712</c:v>
                </c:pt>
                <c:pt idx="1020">
                  <c:v>6.0773809523809526</c:v>
                </c:pt>
                <c:pt idx="1021">
                  <c:v>6.083333333333333</c:v>
                </c:pt>
                <c:pt idx="1022">
                  <c:v>6.0892857142857144</c:v>
                </c:pt>
                <c:pt idx="1023">
                  <c:v>6.0952380952380949</c:v>
                </c:pt>
                <c:pt idx="1024">
                  <c:v>6.1011904761904763</c:v>
                </c:pt>
                <c:pt idx="1025">
                  <c:v>6.1071428571428568</c:v>
                </c:pt>
                <c:pt idx="1026">
                  <c:v>6.1130952380952381</c:v>
                </c:pt>
                <c:pt idx="1027">
                  <c:v>6.1190476190476186</c:v>
                </c:pt>
                <c:pt idx="1028">
                  <c:v>6.125</c:v>
                </c:pt>
                <c:pt idx="1029">
                  <c:v>6.1309523809523814</c:v>
                </c:pt>
                <c:pt idx="1030">
                  <c:v>6.1369047619047619</c:v>
                </c:pt>
                <c:pt idx="1031">
                  <c:v>6.1428571428571432</c:v>
                </c:pt>
                <c:pt idx="1032">
                  <c:v>6.1488095238095237</c:v>
                </c:pt>
                <c:pt idx="1033">
                  <c:v>6.1547619047619051</c:v>
                </c:pt>
                <c:pt idx="1034">
                  <c:v>6.1607142857142856</c:v>
                </c:pt>
                <c:pt idx="1035">
                  <c:v>6.166666666666667</c:v>
                </c:pt>
                <c:pt idx="1036">
                  <c:v>6.1726190476190474</c:v>
                </c:pt>
                <c:pt idx="1037">
                  <c:v>6.1785714285714288</c:v>
                </c:pt>
                <c:pt idx="1038">
                  <c:v>6.1845238095238093</c:v>
                </c:pt>
                <c:pt idx="1039">
                  <c:v>6.1904761904761907</c:v>
                </c:pt>
                <c:pt idx="1040">
                  <c:v>6.1964285714285712</c:v>
                </c:pt>
                <c:pt idx="1041">
                  <c:v>6.2023809523809526</c:v>
                </c:pt>
                <c:pt idx="1042">
                  <c:v>6.208333333333333</c:v>
                </c:pt>
                <c:pt idx="1043">
                  <c:v>6.2142857142857144</c:v>
                </c:pt>
                <c:pt idx="1044">
                  <c:v>6.2202380952380949</c:v>
                </c:pt>
                <c:pt idx="1045">
                  <c:v>6.2261904761904763</c:v>
                </c:pt>
                <c:pt idx="1046">
                  <c:v>6.2321428571428568</c:v>
                </c:pt>
                <c:pt idx="1047">
                  <c:v>6.2380952380952381</c:v>
                </c:pt>
                <c:pt idx="1048">
                  <c:v>6.2440476190476186</c:v>
                </c:pt>
                <c:pt idx="1049">
                  <c:v>6.25</c:v>
                </c:pt>
                <c:pt idx="1050">
                  <c:v>6.2559523809523814</c:v>
                </c:pt>
                <c:pt idx="1051">
                  <c:v>6.2619047619047619</c:v>
                </c:pt>
                <c:pt idx="1052">
                  <c:v>6.2678571428571432</c:v>
                </c:pt>
                <c:pt idx="1053">
                  <c:v>6.2738095238095237</c:v>
                </c:pt>
                <c:pt idx="1054">
                  <c:v>6.2797619047619051</c:v>
                </c:pt>
                <c:pt idx="1055">
                  <c:v>6.2857142857142856</c:v>
                </c:pt>
                <c:pt idx="1056">
                  <c:v>6.291666666666667</c:v>
                </c:pt>
                <c:pt idx="1057">
                  <c:v>6.2976190476190474</c:v>
                </c:pt>
                <c:pt idx="1058">
                  <c:v>6.3035714285714288</c:v>
                </c:pt>
                <c:pt idx="1059">
                  <c:v>6.3095238095238093</c:v>
                </c:pt>
                <c:pt idx="1060">
                  <c:v>6.3154761904761907</c:v>
                </c:pt>
                <c:pt idx="1061">
                  <c:v>6.3214285714285712</c:v>
                </c:pt>
                <c:pt idx="1062">
                  <c:v>6.3273809523809526</c:v>
                </c:pt>
                <c:pt idx="1063">
                  <c:v>6.333333333333333</c:v>
                </c:pt>
                <c:pt idx="1064">
                  <c:v>6.3392857142857144</c:v>
                </c:pt>
                <c:pt idx="1065">
                  <c:v>6.3452380952380949</c:v>
                </c:pt>
                <c:pt idx="1066">
                  <c:v>6.3511904761904763</c:v>
                </c:pt>
                <c:pt idx="1067">
                  <c:v>6.3571428571428568</c:v>
                </c:pt>
                <c:pt idx="1068">
                  <c:v>6.3630952380952381</c:v>
                </c:pt>
                <c:pt idx="1069">
                  <c:v>6.3690476190476186</c:v>
                </c:pt>
                <c:pt idx="1070">
                  <c:v>6.375</c:v>
                </c:pt>
                <c:pt idx="1071">
                  <c:v>6.3809523809523814</c:v>
                </c:pt>
                <c:pt idx="1072">
                  <c:v>6.3869047619047619</c:v>
                </c:pt>
                <c:pt idx="1073">
                  <c:v>6.3928571428571432</c:v>
                </c:pt>
                <c:pt idx="1074">
                  <c:v>6.3988095238095237</c:v>
                </c:pt>
                <c:pt idx="1075">
                  <c:v>6.4047619047619051</c:v>
                </c:pt>
                <c:pt idx="1076">
                  <c:v>6.4107142857142856</c:v>
                </c:pt>
                <c:pt idx="1077">
                  <c:v>6.416666666666667</c:v>
                </c:pt>
                <c:pt idx="1078">
                  <c:v>6.4226190476190474</c:v>
                </c:pt>
                <c:pt idx="1079">
                  <c:v>6.4285714285714288</c:v>
                </c:pt>
                <c:pt idx="1080">
                  <c:v>6.4345238095238093</c:v>
                </c:pt>
                <c:pt idx="1081">
                  <c:v>6.4404761904761907</c:v>
                </c:pt>
                <c:pt idx="1082">
                  <c:v>6.4464285714285712</c:v>
                </c:pt>
                <c:pt idx="1083">
                  <c:v>6.4523809523809526</c:v>
                </c:pt>
                <c:pt idx="1084">
                  <c:v>6.458333333333333</c:v>
                </c:pt>
                <c:pt idx="1085">
                  <c:v>6.4642857142857144</c:v>
                </c:pt>
                <c:pt idx="1086">
                  <c:v>6.4702380952380949</c:v>
                </c:pt>
                <c:pt idx="1087">
                  <c:v>6.4761904761904763</c:v>
                </c:pt>
                <c:pt idx="1088">
                  <c:v>6.4821428571428568</c:v>
                </c:pt>
                <c:pt idx="1089">
                  <c:v>6.4880952380952381</c:v>
                </c:pt>
                <c:pt idx="1090">
                  <c:v>6.4940476190476186</c:v>
                </c:pt>
                <c:pt idx="1091">
                  <c:v>6.5</c:v>
                </c:pt>
                <c:pt idx="1092">
                  <c:v>6.5059523809523814</c:v>
                </c:pt>
                <c:pt idx="1093">
                  <c:v>6.5119047619047619</c:v>
                </c:pt>
                <c:pt idx="1094">
                  <c:v>6.5178571428571432</c:v>
                </c:pt>
                <c:pt idx="1095">
                  <c:v>6.5238095238095237</c:v>
                </c:pt>
                <c:pt idx="1096">
                  <c:v>6.5297619047619051</c:v>
                </c:pt>
                <c:pt idx="1097">
                  <c:v>6.5357142857142856</c:v>
                </c:pt>
                <c:pt idx="1098">
                  <c:v>6.541666666666667</c:v>
                </c:pt>
                <c:pt idx="1099">
                  <c:v>6.5476190476190474</c:v>
                </c:pt>
                <c:pt idx="1100">
                  <c:v>6.5535714285714288</c:v>
                </c:pt>
                <c:pt idx="1101">
                  <c:v>6.5595238095238093</c:v>
                </c:pt>
                <c:pt idx="1102">
                  <c:v>6.5654761904761907</c:v>
                </c:pt>
                <c:pt idx="1103">
                  <c:v>6.5714285714285712</c:v>
                </c:pt>
                <c:pt idx="1104">
                  <c:v>6.5773809523809526</c:v>
                </c:pt>
                <c:pt idx="1105">
                  <c:v>6.583333333333333</c:v>
                </c:pt>
                <c:pt idx="1106">
                  <c:v>6.5892857142857144</c:v>
                </c:pt>
                <c:pt idx="1107">
                  <c:v>6.5952380952380949</c:v>
                </c:pt>
                <c:pt idx="1108">
                  <c:v>6.6011904761904763</c:v>
                </c:pt>
                <c:pt idx="1109">
                  <c:v>6.6071428571428568</c:v>
                </c:pt>
                <c:pt idx="1110">
                  <c:v>6.6130952380952381</c:v>
                </c:pt>
                <c:pt idx="1111">
                  <c:v>6.6190476190476186</c:v>
                </c:pt>
                <c:pt idx="1112">
                  <c:v>6.625</c:v>
                </c:pt>
                <c:pt idx="1113">
                  <c:v>6.6309523809523814</c:v>
                </c:pt>
                <c:pt idx="1114">
                  <c:v>6.6369047619047619</c:v>
                </c:pt>
                <c:pt idx="1115">
                  <c:v>6.6428571428571432</c:v>
                </c:pt>
                <c:pt idx="1116">
                  <c:v>6.6488095238095237</c:v>
                </c:pt>
                <c:pt idx="1117">
                  <c:v>6.6547619047619051</c:v>
                </c:pt>
                <c:pt idx="1118">
                  <c:v>6.6607142857142856</c:v>
                </c:pt>
                <c:pt idx="1119">
                  <c:v>6.666666666666667</c:v>
                </c:pt>
                <c:pt idx="1120">
                  <c:v>6.6726190476190474</c:v>
                </c:pt>
                <c:pt idx="1121">
                  <c:v>6.6785714285714288</c:v>
                </c:pt>
                <c:pt idx="1122">
                  <c:v>6.6845238095238093</c:v>
                </c:pt>
                <c:pt idx="1123">
                  <c:v>6.6904761904761907</c:v>
                </c:pt>
                <c:pt idx="1124">
                  <c:v>6.6964285714285712</c:v>
                </c:pt>
                <c:pt idx="1125">
                  <c:v>6.7023809523809526</c:v>
                </c:pt>
                <c:pt idx="1126">
                  <c:v>6.708333333333333</c:v>
                </c:pt>
                <c:pt idx="1127">
                  <c:v>6.7142857142857144</c:v>
                </c:pt>
                <c:pt idx="1128">
                  <c:v>6.7202380952380949</c:v>
                </c:pt>
                <c:pt idx="1129">
                  <c:v>6.7261904761904763</c:v>
                </c:pt>
                <c:pt idx="1130">
                  <c:v>6.7321428571428568</c:v>
                </c:pt>
                <c:pt idx="1131">
                  <c:v>6.7380952380952381</c:v>
                </c:pt>
                <c:pt idx="1132">
                  <c:v>6.7440476190476186</c:v>
                </c:pt>
                <c:pt idx="1133">
                  <c:v>6.75</c:v>
                </c:pt>
                <c:pt idx="1134">
                  <c:v>6.7559523809523814</c:v>
                </c:pt>
                <c:pt idx="1135">
                  <c:v>6.7619047619047619</c:v>
                </c:pt>
                <c:pt idx="1136">
                  <c:v>6.7678571428571432</c:v>
                </c:pt>
                <c:pt idx="1137">
                  <c:v>6.7738095238095237</c:v>
                </c:pt>
                <c:pt idx="1138">
                  <c:v>6.7797619047619051</c:v>
                </c:pt>
                <c:pt idx="1139">
                  <c:v>6.7857142857142856</c:v>
                </c:pt>
                <c:pt idx="1140">
                  <c:v>6.791666666666667</c:v>
                </c:pt>
                <c:pt idx="1141">
                  <c:v>6.7976190476190474</c:v>
                </c:pt>
                <c:pt idx="1142">
                  <c:v>6.8035714285714288</c:v>
                </c:pt>
                <c:pt idx="1143">
                  <c:v>6.8095238095238093</c:v>
                </c:pt>
                <c:pt idx="1144">
                  <c:v>6.8154761904761907</c:v>
                </c:pt>
                <c:pt idx="1145">
                  <c:v>6.8214285714285712</c:v>
                </c:pt>
                <c:pt idx="1146">
                  <c:v>6.8273809523809526</c:v>
                </c:pt>
                <c:pt idx="1147">
                  <c:v>6.833333333333333</c:v>
                </c:pt>
                <c:pt idx="1148">
                  <c:v>6.8392857142857144</c:v>
                </c:pt>
                <c:pt idx="1149">
                  <c:v>6.8452380952380949</c:v>
                </c:pt>
                <c:pt idx="1150">
                  <c:v>6.8511904761904763</c:v>
                </c:pt>
                <c:pt idx="1151">
                  <c:v>6.8571428571428568</c:v>
                </c:pt>
                <c:pt idx="1152">
                  <c:v>6.8630952380952381</c:v>
                </c:pt>
                <c:pt idx="1153">
                  <c:v>6.8690476190476186</c:v>
                </c:pt>
                <c:pt idx="1154">
                  <c:v>6.875</c:v>
                </c:pt>
                <c:pt idx="1155">
                  <c:v>6.8809523809523814</c:v>
                </c:pt>
                <c:pt idx="1156">
                  <c:v>6.8869047619047619</c:v>
                </c:pt>
                <c:pt idx="1157">
                  <c:v>6.8928571428571432</c:v>
                </c:pt>
                <c:pt idx="1158">
                  <c:v>6.8988095238095237</c:v>
                </c:pt>
                <c:pt idx="1159">
                  <c:v>6.9047619047619051</c:v>
                </c:pt>
                <c:pt idx="1160">
                  <c:v>6.9107142857142856</c:v>
                </c:pt>
                <c:pt idx="1161">
                  <c:v>6.916666666666667</c:v>
                </c:pt>
                <c:pt idx="1162">
                  <c:v>6.9226190476190474</c:v>
                </c:pt>
                <c:pt idx="1163">
                  <c:v>6.9285714285714288</c:v>
                </c:pt>
                <c:pt idx="1164">
                  <c:v>6.9345238095238093</c:v>
                </c:pt>
                <c:pt idx="1165">
                  <c:v>6.9404761904761907</c:v>
                </c:pt>
                <c:pt idx="1166">
                  <c:v>6.9464285714285712</c:v>
                </c:pt>
                <c:pt idx="1167">
                  <c:v>6.9523809523809526</c:v>
                </c:pt>
                <c:pt idx="1168">
                  <c:v>6.958333333333333</c:v>
                </c:pt>
                <c:pt idx="1169">
                  <c:v>6.9642857142857144</c:v>
                </c:pt>
                <c:pt idx="1170">
                  <c:v>6.9702380952380949</c:v>
                </c:pt>
                <c:pt idx="1171">
                  <c:v>6.9761904761904763</c:v>
                </c:pt>
                <c:pt idx="1172">
                  <c:v>6.9821428571428568</c:v>
                </c:pt>
                <c:pt idx="1173">
                  <c:v>6.9880952380952381</c:v>
                </c:pt>
                <c:pt idx="1174">
                  <c:v>6.9940476190476186</c:v>
                </c:pt>
                <c:pt idx="1175">
                  <c:v>7</c:v>
                </c:pt>
                <c:pt idx="1176">
                  <c:v>7.0059523809523814</c:v>
                </c:pt>
                <c:pt idx="1177">
                  <c:v>7.0119047619047619</c:v>
                </c:pt>
                <c:pt idx="1178">
                  <c:v>7.0178571428571432</c:v>
                </c:pt>
                <c:pt idx="1179">
                  <c:v>7.0238095238095237</c:v>
                </c:pt>
                <c:pt idx="1180">
                  <c:v>7.0297619047619051</c:v>
                </c:pt>
                <c:pt idx="1181">
                  <c:v>7.0357142857142856</c:v>
                </c:pt>
                <c:pt idx="1182">
                  <c:v>7.041666666666667</c:v>
                </c:pt>
                <c:pt idx="1183">
                  <c:v>7.0476190476190474</c:v>
                </c:pt>
                <c:pt idx="1184">
                  <c:v>7.0535714285714288</c:v>
                </c:pt>
                <c:pt idx="1185">
                  <c:v>7.0595238095238093</c:v>
                </c:pt>
                <c:pt idx="1186">
                  <c:v>7.0654761904761907</c:v>
                </c:pt>
                <c:pt idx="1187">
                  <c:v>7.0714285714285712</c:v>
                </c:pt>
                <c:pt idx="1188">
                  <c:v>7.0773809523809526</c:v>
                </c:pt>
                <c:pt idx="1189">
                  <c:v>7.083333333333333</c:v>
                </c:pt>
                <c:pt idx="1190">
                  <c:v>7.0892857142857144</c:v>
                </c:pt>
                <c:pt idx="1191">
                  <c:v>7.0952380952380949</c:v>
                </c:pt>
                <c:pt idx="1192">
                  <c:v>7.1011904761904763</c:v>
                </c:pt>
                <c:pt idx="1193">
                  <c:v>7.1071428571428568</c:v>
                </c:pt>
                <c:pt idx="1194">
                  <c:v>7.1130952380952381</c:v>
                </c:pt>
                <c:pt idx="1195">
                  <c:v>7.1190476190476186</c:v>
                </c:pt>
                <c:pt idx="1196">
                  <c:v>7.125</c:v>
                </c:pt>
                <c:pt idx="1197">
                  <c:v>7.1309523809523814</c:v>
                </c:pt>
                <c:pt idx="1198">
                  <c:v>7.1369047619047619</c:v>
                </c:pt>
                <c:pt idx="1199">
                  <c:v>7.1428571428571432</c:v>
                </c:pt>
                <c:pt idx="1200">
                  <c:v>7.1488095238095237</c:v>
                </c:pt>
                <c:pt idx="1201">
                  <c:v>7.1547619047619051</c:v>
                </c:pt>
                <c:pt idx="1202">
                  <c:v>7.1607142857142856</c:v>
                </c:pt>
                <c:pt idx="1203">
                  <c:v>7.166666666666667</c:v>
                </c:pt>
                <c:pt idx="1204">
                  <c:v>7.1726190476190474</c:v>
                </c:pt>
                <c:pt idx="1205">
                  <c:v>7.1785714285714288</c:v>
                </c:pt>
                <c:pt idx="1206">
                  <c:v>7.1845238095238093</c:v>
                </c:pt>
                <c:pt idx="1207">
                  <c:v>7.1904761904761907</c:v>
                </c:pt>
                <c:pt idx="1208">
                  <c:v>7.1964285714285712</c:v>
                </c:pt>
                <c:pt idx="1209">
                  <c:v>7.2023809523809526</c:v>
                </c:pt>
                <c:pt idx="1210">
                  <c:v>7.208333333333333</c:v>
                </c:pt>
                <c:pt idx="1211">
                  <c:v>7.2142857142857144</c:v>
                </c:pt>
                <c:pt idx="1212">
                  <c:v>7.2202380952380949</c:v>
                </c:pt>
                <c:pt idx="1213">
                  <c:v>7.2261904761904763</c:v>
                </c:pt>
                <c:pt idx="1214">
                  <c:v>7.2321428571428568</c:v>
                </c:pt>
                <c:pt idx="1215">
                  <c:v>7.2380952380952381</c:v>
                </c:pt>
                <c:pt idx="1216">
                  <c:v>7.2440476190476186</c:v>
                </c:pt>
                <c:pt idx="1217">
                  <c:v>7.25</c:v>
                </c:pt>
                <c:pt idx="1218">
                  <c:v>7.2559523809523814</c:v>
                </c:pt>
                <c:pt idx="1219">
                  <c:v>7.2619047619047619</c:v>
                </c:pt>
                <c:pt idx="1220">
                  <c:v>7.2678571428571432</c:v>
                </c:pt>
                <c:pt idx="1221">
                  <c:v>7.2738095238095237</c:v>
                </c:pt>
                <c:pt idx="1222">
                  <c:v>7.2797619047619051</c:v>
                </c:pt>
                <c:pt idx="1223">
                  <c:v>7.2857142857142856</c:v>
                </c:pt>
                <c:pt idx="1224">
                  <c:v>7.291666666666667</c:v>
                </c:pt>
                <c:pt idx="1225">
                  <c:v>7.2976190476190474</c:v>
                </c:pt>
                <c:pt idx="1226">
                  <c:v>7.3035714285714288</c:v>
                </c:pt>
                <c:pt idx="1227">
                  <c:v>7.3095238095238093</c:v>
                </c:pt>
                <c:pt idx="1228">
                  <c:v>7.3154761904761907</c:v>
                </c:pt>
                <c:pt idx="1229">
                  <c:v>7.3214285714285712</c:v>
                </c:pt>
                <c:pt idx="1230">
                  <c:v>7.3273809523809526</c:v>
                </c:pt>
                <c:pt idx="1231">
                  <c:v>7.333333333333333</c:v>
                </c:pt>
                <c:pt idx="1232">
                  <c:v>7.3392857142857144</c:v>
                </c:pt>
                <c:pt idx="1233">
                  <c:v>7.3452380952380949</c:v>
                </c:pt>
                <c:pt idx="1234">
                  <c:v>7.3511904761904763</c:v>
                </c:pt>
                <c:pt idx="1235">
                  <c:v>7.3571428571428568</c:v>
                </c:pt>
                <c:pt idx="1236">
                  <c:v>7.3630952380952381</c:v>
                </c:pt>
                <c:pt idx="1237">
                  <c:v>7.3690476190476186</c:v>
                </c:pt>
                <c:pt idx="1238">
                  <c:v>7.375</c:v>
                </c:pt>
                <c:pt idx="1239">
                  <c:v>7.3809523809523814</c:v>
                </c:pt>
                <c:pt idx="1240">
                  <c:v>7.3869047619047619</c:v>
                </c:pt>
                <c:pt idx="1241">
                  <c:v>7.3928571428571432</c:v>
                </c:pt>
                <c:pt idx="1242">
                  <c:v>7.3988095238095237</c:v>
                </c:pt>
                <c:pt idx="1243">
                  <c:v>7.4047619047619051</c:v>
                </c:pt>
                <c:pt idx="1244">
                  <c:v>7.4107142857142856</c:v>
                </c:pt>
                <c:pt idx="1245">
                  <c:v>7.416666666666667</c:v>
                </c:pt>
                <c:pt idx="1246">
                  <c:v>7.4226190476190474</c:v>
                </c:pt>
                <c:pt idx="1247">
                  <c:v>7.4285714285714288</c:v>
                </c:pt>
                <c:pt idx="1248">
                  <c:v>7.4345238095238093</c:v>
                </c:pt>
                <c:pt idx="1249">
                  <c:v>7.4404761904761907</c:v>
                </c:pt>
                <c:pt idx="1250">
                  <c:v>7.4464285714285712</c:v>
                </c:pt>
                <c:pt idx="1251">
                  <c:v>7.4523809523809526</c:v>
                </c:pt>
                <c:pt idx="1252">
                  <c:v>7.458333333333333</c:v>
                </c:pt>
                <c:pt idx="1253">
                  <c:v>7.4642857142857144</c:v>
                </c:pt>
                <c:pt idx="1254">
                  <c:v>7.4702380952380949</c:v>
                </c:pt>
                <c:pt idx="1255">
                  <c:v>7.4761904761904763</c:v>
                </c:pt>
                <c:pt idx="1256">
                  <c:v>7.4821428571428568</c:v>
                </c:pt>
                <c:pt idx="1257">
                  <c:v>7.4880952380952381</c:v>
                </c:pt>
                <c:pt idx="1258">
                  <c:v>7.4940476190476186</c:v>
                </c:pt>
                <c:pt idx="1259">
                  <c:v>7.5</c:v>
                </c:pt>
                <c:pt idx="1260">
                  <c:v>7.5059523809523814</c:v>
                </c:pt>
                <c:pt idx="1261">
                  <c:v>7.5119047619047619</c:v>
                </c:pt>
                <c:pt idx="1262">
                  <c:v>7.5178571428571432</c:v>
                </c:pt>
                <c:pt idx="1263">
                  <c:v>7.5238095238095237</c:v>
                </c:pt>
                <c:pt idx="1264">
                  <c:v>7.5297619047619051</c:v>
                </c:pt>
                <c:pt idx="1265">
                  <c:v>7.5357142857142856</c:v>
                </c:pt>
                <c:pt idx="1266">
                  <c:v>7.541666666666667</c:v>
                </c:pt>
                <c:pt idx="1267">
                  <c:v>7.5476190476190474</c:v>
                </c:pt>
                <c:pt idx="1268">
                  <c:v>7.5535714285714288</c:v>
                </c:pt>
                <c:pt idx="1269">
                  <c:v>7.5595238095238093</c:v>
                </c:pt>
                <c:pt idx="1270">
                  <c:v>7.5654761904761907</c:v>
                </c:pt>
                <c:pt idx="1271">
                  <c:v>7.5714285714285712</c:v>
                </c:pt>
                <c:pt idx="1272">
                  <c:v>7.5773809523809526</c:v>
                </c:pt>
                <c:pt idx="1273">
                  <c:v>7.583333333333333</c:v>
                </c:pt>
                <c:pt idx="1274">
                  <c:v>7.5892857142857144</c:v>
                </c:pt>
                <c:pt idx="1275">
                  <c:v>7.5952380952380949</c:v>
                </c:pt>
                <c:pt idx="1276">
                  <c:v>7.6011904761904763</c:v>
                </c:pt>
                <c:pt idx="1277">
                  <c:v>7.6071428571428568</c:v>
                </c:pt>
                <c:pt idx="1278">
                  <c:v>7.6130952380952381</c:v>
                </c:pt>
                <c:pt idx="1279">
                  <c:v>7.6190476190476186</c:v>
                </c:pt>
                <c:pt idx="1280">
                  <c:v>7.625</c:v>
                </c:pt>
                <c:pt idx="1281">
                  <c:v>7.6309523809523814</c:v>
                </c:pt>
                <c:pt idx="1282">
                  <c:v>7.6369047619047619</c:v>
                </c:pt>
                <c:pt idx="1283">
                  <c:v>7.6428571428571432</c:v>
                </c:pt>
                <c:pt idx="1284">
                  <c:v>7.6488095238095237</c:v>
                </c:pt>
                <c:pt idx="1285">
                  <c:v>7.6547619047619051</c:v>
                </c:pt>
                <c:pt idx="1286">
                  <c:v>7.6607142857142856</c:v>
                </c:pt>
                <c:pt idx="1287">
                  <c:v>7.666666666666667</c:v>
                </c:pt>
                <c:pt idx="1288">
                  <c:v>7.6726190476190474</c:v>
                </c:pt>
                <c:pt idx="1289">
                  <c:v>7.6785714285714288</c:v>
                </c:pt>
                <c:pt idx="1290">
                  <c:v>7.6845238095238093</c:v>
                </c:pt>
                <c:pt idx="1291">
                  <c:v>7.6904761904761907</c:v>
                </c:pt>
                <c:pt idx="1292">
                  <c:v>7.6964285714285712</c:v>
                </c:pt>
                <c:pt idx="1293">
                  <c:v>7.7023809523809526</c:v>
                </c:pt>
                <c:pt idx="1294">
                  <c:v>7.708333333333333</c:v>
                </c:pt>
                <c:pt idx="1295">
                  <c:v>7.7142857142857144</c:v>
                </c:pt>
                <c:pt idx="1296">
                  <c:v>7.7202380952380949</c:v>
                </c:pt>
                <c:pt idx="1297">
                  <c:v>7.7261904761904763</c:v>
                </c:pt>
                <c:pt idx="1298">
                  <c:v>7.7321428571428568</c:v>
                </c:pt>
                <c:pt idx="1299">
                  <c:v>7.7380952380952381</c:v>
                </c:pt>
                <c:pt idx="1300">
                  <c:v>7.7440476190476186</c:v>
                </c:pt>
                <c:pt idx="1301">
                  <c:v>7.75</c:v>
                </c:pt>
                <c:pt idx="1302">
                  <c:v>7.7559523809523814</c:v>
                </c:pt>
                <c:pt idx="1303">
                  <c:v>7.7619047619047619</c:v>
                </c:pt>
                <c:pt idx="1304">
                  <c:v>7.7678571428571432</c:v>
                </c:pt>
                <c:pt idx="1305">
                  <c:v>7.7738095238095237</c:v>
                </c:pt>
                <c:pt idx="1306">
                  <c:v>7.7797619047619051</c:v>
                </c:pt>
                <c:pt idx="1307">
                  <c:v>7.7857142857142856</c:v>
                </c:pt>
                <c:pt idx="1308">
                  <c:v>7.791666666666667</c:v>
                </c:pt>
                <c:pt idx="1309">
                  <c:v>7.7976190476190474</c:v>
                </c:pt>
                <c:pt idx="1310">
                  <c:v>7.8035714285714288</c:v>
                </c:pt>
                <c:pt idx="1311">
                  <c:v>7.8095238095238093</c:v>
                </c:pt>
                <c:pt idx="1312">
                  <c:v>7.8154761904761907</c:v>
                </c:pt>
                <c:pt idx="1313">
                  <c:v>7.8214285714285712</c:v>
                </c:pt>
                <c:pt idx="1314">
                  <c:v>7.8273809523809526</c:v>
                </c:pt>
                <c:pt idx="1315">
                  <c:v>7.833333333333333</c:v>
                </c:pt>
                <c:pt idx="1316">
                  <c:v>7.8392857142857144</c:v>
                </c:pt>
                <c:pt idx="1317">
                  <c:v>7.8452380952380949</c:v>
                </c:pt>
                <c:pt idx="1318">
                  <c:v>7.8511904761904763</c:v>
                </c:pt>
                <c:pt idx="1319">
                  <c:v>7.8571428571428568</c:v>
                </c:pt>
                <c:pt idx="1320">
                  <c:v>7.8630952380952381</c:v>
                </c:pt>
                <c:pt idx="1321">
                  <c:v>7.8690476190476186</c:v>
                </c:pt>
                <c:pt idx="1322">
                  <c:v>7.875</c:v>
                </c:pt>
                <c:pt idx="1323">
                  <c:v>7.8809523809523814</c:v>
                </c:pt>
                <c:pt idx="1324">
                  <c:v>7.8869047619047619</c:v>
                </c:pt>
                <c:pt idx="1325">
                  <c:v>7.8928571428571432</c:v>
                </c:pt>
                <c:pt idx="1326">
                  <c:v>7.8988095238095237</c:v>
                </c:pt>
                <c:pt idx="1327">
                  <c:v>7.9047619047619051</c:v>
                </c:pt>
                <c:pt idx="1328">
                  <c:v>7.9107142857142856</c:v>
                </c:pt>
                <c:pt idx="1329">
                  <c:v>7.916666666666667</c:v>
                </c:pt>
                <c:pt idx="1330">
                  <c:v>7.9226190476190474</c:v>
                </c:pt>
                <c:pt idx="1331">
                  <c:v>7.9285714285714288</c:v>
                </c:pt>
                <c:pt idx="1332">
                  <c:v>7.9345238095238093</c:v>
                </c:pt>
                <c:pt idx="1333">
                  <c:v>7.9404761904761907</c:v>
                </c:pt>
                <c:pt idx="1334">
                  <c:v>7.9464285714285712</c:v>
                </c:pt>
                <c:pt idx="1335">
                  <c:v>7.9523809523809526</c:v>
                </c:pt>
                <c:pt idx="1336">
                  <c:v>7.958333333333333</c:v>
                </c:pt>
                <c:pt idx="1337">
                  <c:v>7.9642857142857144</c:v>
                </c:pt>
              </c:numCache>
            </c:numRef>
          </c:xVal>
          <c:yVal>
            <c:numRef>
              <c:f>Tabelle1!$H$13:$H$1350</c:f>
              <c:numCache>
                <c:formatCode>0.0</c:formatCode>
                <c:ptCount val="1338"/>
                <c:pt idx="0">
                  <c:v>27.2</c:v>
                </c:pt>
                <c:pt idx="1">
                  <c:v>6.7</c:v>
                </c:pt>
                <c:pt idx="2">
                  <c:v>4.2</c:v>
                </c:pt>
                <c:pt idx="3">
                  <c:v>3.7</c:v>
                </c:pt>
                <c:pt idx="4">
                  <c:v>2.2000000000000002</c:v>
                </c:pt>
                <c:pt idx="5">
                  <c:v>2.2999999999999998</c:v>
                </c:pt>
                <c:pt idx="6">
                  <c:v>2.6</c:v>
                </c:pt>
                <c:pt idx="7">
                  <c:v>1.9</c:v>
                </c:pt>
                <c:pt idx="8">
                  <c:v>2.2999999999999998</c:v>
                </c:pt>
                <c:pt idx="9">
                  <c:v>2.6</c:v>
                </c:pt>
                <c:pt idx="10">
                  <c:v>1.6</c:v>
                </c:pt>
                <c:pt idx="11">
                  <c:v>1.8</c:v>
                </c:pt>
                <c:pt idx="12">
                  <c:v>2.2000000000000002</c:v>
                </c:pt>
                <c:pt idx="13">
                  <c:v>2.5</c:v>
                </c:pt>
                <c:pt idx="14">
                  <c:v>2.1</c:v>
                </c:pt>
                <c:pt idx="15">
                  <c:v>1.8</c:v>
                </c:pt>
                <c:pt idx="16">
                  <c:v>2.2999999999999998</c:v>
                </c:pt>
                <c:pt idx="17">
                  <c:v>2.6</c:v>
                </c:pt>
                <c:pt idx="18">
                  <c:v>1.9</c:v>
                </c:pt>
                <c:pt idx="19">
                  <c:v>2.6</c:v>
                </c:pt>
                <c:pt idx="20">
                  <c:v>9.1999999999999993</c:v>
                </c:pt>
                <c:pt idx="21">
                  <c:v>18.2</c:v>
                </c:pt>
                <c:pt idx="22">
                  <c:v>5.3</c:v>
                </c:pt>
                <c:pt idx="23">
                  <c:v>3.4</c:v>
                </c:pt>
                <c:pt idx="24">
                  <c:v>2.6</c:v>
                </c:pt>
                <c:pt idx="25">
                  <c:v>2.8</c:v>
                </c:pt>
                <c:pt idx="26">
                  <c:v>1.9</c:v>
                </c:pt>
                <c:pt idx="27">
                  <c:v>2.4</c:v>
                </c:pt>
                <c:pt idx="28">
                  <c:v>2.2999999999999998</c:v>
                </c:pt>
                <c:pt idx="29">
                  <c:v>2.1</c:v>
                </c:pt>
                <c:pt idx="30">
                  <c:v>2.4</c:v>
                </c:pt>
                <c:pt idx="31">
                  <c:v>1.8</c:v>
                </c:pt>
                <c:pt idx="32">
                  <c:v>2.2000000000000002</c:v>
                </c:pt>
                <c:pt idx="33">
                  <c:v>2.6</c:v>
                </c:pt>
                <c:pt idx="34">
                  <c:v>2.2000000000000002</c:v>
                </c:pt>
                <c:pt idx="35">
                  <c:v>1.8</c:v>
                </c:pt>
                <c:pt idx="36">
                  <c:v>2.2000000000000002</c:v>
                </c:pt>
                <c:pt idx="37">
                  <c:v>2.5</c:v>
                </c:pt>
                <c:pt idx="38">
                  <c:v>2.8</c:v>
                </c:pt>
                <c:pt idx="39">
                  <c:v>2.1</c:v>
                </c:pt>
                <c:pt idx="40">
                  <c:v>2.2000000000000002</c:v>
                </c:pt>
                <c:pt idx="41">
                  <c:v>2.4</c:v>
                </c:pt>
                <c:pt idx="42">
                  <c:v>2.6</c:v>
                </c:pt>
                <c:pt idx="43">
                  <c:v>1.9</c:v>
                </c:pt>
                <c:pt idx="44">
                  <c:v>2.2999999999999998</c:v>
                </c:pt>
                <c:pt idx="45">
                  <c:v>2.8</c:v>
                </c:pt>
                <c:pt idx="46">
                  <c:v>1.9</c:v>
                </c:pt>
                <c:pt idx="47">
                  <c:v>2.2999999999999998</c:v>
                </c:pt>
                <c:pt idx="48">
                  <c:v>1.7</c:v>
                </c:pt>
                <c:pt idx="49">
                  <c:v>2.2000000000000002</c:v>
                </c:pt>
                <c:pt idx="50">
                  <c:v>2.7</c:v>
                </c:pt>
                <c:pt idx="51">
                  <c:v>1.7</c:v>
                </c:pt>
                <c:pt idx="52">
                  <c:v>1.9</c:v>
                </c:pt>
                <c:pt idx="53">
                  <c:v>2.2999999999999998</c:v>
                </c:pt>
                <c:pt idx="54">
                  <c:v>2.4</c:v>
                </c:pt>
                <c:pt idx="55">
                  <c:v>1.9</c:v>
                </c:pt>
                <c:pt idx="56">
                  <c:v>2.2000000000000002</c:v>
                </c:pt>
                <c:pt idx="57">
                  <c:v>2.5</c:v>
                </c:pt>
                <c:pt idx="58">
                  <c:v>2.8</c:v>
                </c:pt>
                <c:pt idx="59">
                  <c:v>1.8</c:v>
                </c:pt>
                <c:pt idx="60">
                  <c:v>2.1</c:v>
                </c:pt>
                <c:pt idx="61">
                  <c:v>2.4</c:v>
                </c:pt>
                <c:pt idx="62">
                  <c:v>2.7</c:v>
                </c:pt>
                <c:pt idx="63">
                  <c:v>2.1</c:v>
                </c:pt>
                <c:pt idx="64">
                  <c:v>1.9</c:v>
                </c:pt>
                <c:pt idx="65">
                  <c:v>2.1</c:v>
                </c:pt>
                <c:pt idx="66">
                  <c:v>2.4</c:v>
                </c:pt>
                <c:pt idx="67">
                  <c:v>1.7</c:v>
                </c:pt>
                <c:pt idx="68">
                  <c:v>2.1</c:v>
                </c:pt>
                <c:pt idx="69">
                  <c:v>2.4</c:v>
                </c:pt>
                <c:pt idx="70">
                  <c:v>2.2999999999999998</c:v>
                </c:pt>
                <c:pt idx="71">
                  <c:v>1.9</c:v>
                </c:pt>
                <c:pt idx="72">
                  <c:v>2.4</c:v>
                </c:pt>
                <c:pt idx="73">
                  <c:v>1.8</c:v>
                </c:pt>
                <c:pt idx="74">
                  <c:v>1.9</c:v>
                </c:pt>
                <c:pt idx="75">
                  <c:v>2.5</c:v>
                </c:pt>
                <c:pt idx="76">
                  <c:v>1.7</c:v>
                </c:pt>
                <c:pt idx="77">
                  <c:v>2.1</c:v>
                </c:pt>
                <c:pt idx="78">
                  <c:v>2.6</c:v>
                </c:pt>
                <c:pt idx="79">
                  <c:v>1.7</c:v>
                </c:pt>
                <c:pt idx="80">
                  <c:v>2</c:v>
                </c:pt>
                <c:pt idx="81">
                  <c:v>2.2999999999999998</c:v>
                </c:pt>
                <c:pt idx="82">
                  <c:v>2.6</c:v>
                </c:pt>
                <c:pt idx="83">
                  <c:v>1.9</c:v>
                </c:pt>
                <c:pt idx="84">
                  <c:v>1.8</c:v>
                </c:pt>
                <c:pt idx="85">
                  <c:v>2.1</c:v>
                </c:pt>
                <c:pt idx="86">
                  <c:v>2.4</c:v>
                </c:pt>
                <c:pt idx="87">
                  <c:v>2.7</c:v>
                </c:pt>
                <c:pt idx="88">
                  <c:v>2</c:v>
                </c:pt>
                <c:pt idx="89">
                  <c:v>1.8</c:v>
                </c:pt>
                <c:pt idx="90">
                  <c:v>2.2000000000000002</c:v>
                </c:pt>
                <c:pt idx="91">
                  <c:v>2.4</c:v>
                </c:pt>
                <c:pt idx="92">
                  <c:v>2.7</c:v>
                </c:pt>
                <c:pt idx="93">
                  <c:v>1.8</c:v>
                </c:pt>
                <c:pt idx="94">
                  <c:v>2.1</c:v>
                </c:pt>
                <c:pt idx="95">
                  <c:v>2.4</c:v>
                </c:pt>
                <c:pt idx="96">
                  <c:v>1.7</c:v>
                </c:pt>
                <c:pt idx="97">
                  <c:v>2.2000000000000002</c:v>
                </c:pt>
                <c:pt idx="98">
                  <c:v>2.4</c:v>
                </c:pt>
                <c:pt idx="99">
                  <c:v>2.6</c:v>
                </c:pt>
                <c:pt idx="100">
                  <c:v>1.9</c:v>
                </c:pt>
                <c:pt idx="101">
                  <c:v>2.2999999999999998</c:v>
                </c:pt>
                <c:pt idx="102">
                  <c:v>2.1</c:v>
                </c:pt>
                <c:pt idx="103">
                  <c:v>2.1</c:v>
                </c:pt>
                <c:pt idx="104">
                  <c:v>2.2999999999999998</c:v>
                </c:pt>
                <c:pt idx="105">
                  <c:v>2.7</c:v>
                </c:pt>
                <c:pt idx="106">
                  <c:v>1.8</c:v>
                </c:pt>
                <c:pt idx="107">
                  <c:v>1.8</c:v>
                </c:pt>
                <c:pt idx="108">
                  <c:v>2.2000000000000002</c:v>
                </c:pt>
                <c:pt idx="109">
                  <c:v>2.4</c:v>
                </c:pt>
                <c:pt idx="110">
                  <c:v>2.7</c:v>
                </c:pt>
                <c:pt idx="111">
                  <c:v>1.9</c:v>
                </c:pt>
                <c:pt idx="112">
                  <c:v>2.6</c:v>
                </c:pt>
                <c:pt idx="113">
                  <c:v>1.8</c:v>
                </c:pt>
                <c:pt idx="114">
                  <c:v>2.2000000000000002</c:v>
                </c:pt>
                <c:pt idx="115">
                  <c:v>1.6</c:v>
                </c:pt>
                <c:pt idx="116">
                  <c:v>2.2000000000000002</c:v>
                </c:pt>
                <c:pt idx="117">
                  <c:v>1.7</c:v>
                </c:pt>
                <c:pt idx="118">
                  <c:v>2.2000000000000002</c:v>
                </c:pt>
                <c:pt idx="119">
                  <c:v>2.4</c:v>
                </c:pt>
                <c:pt idx="120">
                  <c:v>1.9</c:v>
                </c:pt>
                <c:pt idx="121">
                  <c:v>2.6</c:v>
                </c:pt>
                <c:pt idx="122">
                  <c:v>1.7</c:v>
                </c:pt>
                <c:pt idx="123">
                  <c:v>2.2999999999999998</c:v>
                </c:pt>
                <c:pt idx="124">
                  <c:v>2.7</c:v>
                </c:pt>
                <c:pt idx="125">
                  <c:v>1.8</c:v>
                </c:pt>
                <c:pt idx="126">
                  <c:v>2</c:v>
                </c:pt>
                <c:pt idx="127">
                  <c:v>2.2999999999999998</c:v>
                </c:pt>
                <c:pt idx="128">
                  <c:v>2.1</c:v>
                </c:pt>
                <c:pt idx="129">
                  <c:v>1.8</c:v>
                </c:pt>
                <c:pt idx="130">
                  <c:v>2.2000000000000002</c:v>
                </c:pt>
                <c:pt idx="131">
                  <c:v>2.4</c:v>
                </c:pt>
                <c:pt idx="132">
                  <c:v>2.2000000000000002</c:v>
                </c:pt>
                <c:pt idx="133">
                  <c:v>1.8</c:v>
                </c:pt>
                <c:pt idx="134">
                  <c:v>2</c:v>
                </c:pt>
                <c:pt idx="135">
                  <c:v>2.2000000000000002</c:v>
                </c:pt>
                <c:pt idx="136">
                  <c:v>2.4</c:v>
                </c:pt>
                <c:pt idx="137">
                  <c:v>1.9</c:v>
                </c:pt>
                <c:pt idx="138">
                  <c:v>2.4</c:v>
                </c:pt>
                <c:pt idx="139">
                  <c:v>2.2999999999999998</c:v>
                </c:pt>
                <c:pt idx="140">
                  <c:v>1.9</c:v>
                </c:pt>
                <c:pt idx="141">
                  <c:v>1.8</c:v>
                </c:pt>
                <c:pt idx="142">
                  <c:v>2.4</c:v>
                </c:pt>
                <c:pt idx="143">
                  <c:v>1.7</c:v>
                </c:pt>
                <c:pt idx="144">
                  <c:v>2.4</c:v>
                </c:pt>
                <c:pt idx="145">
                  <c:v>2.4</c:v>
                </c:pt>
                <c:pt idx="146">
                  <c:v>1.8</c:v>
                </c:pt>
                <c:pt idx="147">
                  <c:v>2.2000000000000002</c:v>
                </c:pt>
                <c:pt idx="148">
                  <c:v>2.6</c:v>
                </c:pt>
                <c:pt idx="149">
                  <c:v>1.8</c:v>
                </c:pt>
                <c:pt idx="150">
                  <c:v>1.9</c:v>
                </c:pt>
                <c:pt idx="151">
                  <c:v>2.2999999999999998</c:v>
                </c:pt>
                <c:pt idx="152">
                  <c:v>1.7</c:v>
                </c:pt>
                <c:pt idx="153">
                  <c:v>2.1</c:v>
                </c:pt>
                <c:pt idx="154">
                  <c:v>2.4</c:v>
                </c:pt>
                <c:pt idx="155">
                  <c:v>1.6</c:v>
                </c:pt>
                <c:pt idx="156">
                  <c:v>1.9</c:v>
                </c:pt>
                <c:pt idx="157">
                  <c:v>2.2999999999999998</c:v>
                </c:pt>
                <c:pt idx="158">
                  <c:v>2.2999999999999998</c:v>
                </c:pt>
                <c:pt idx="159">
                  <c:v>1.5</c:v>
                </c:pt>
                <c:pt idx="160">
                  <c:v>1.8</c:v>
                </c:pt>
                <c:pt idx="161">
                  <c:v>2.2999999999999998</c:v>
                </c:pt>
                <c:pt idx="162">
                  <c:v>2.2000000000000002</c:v>
                </c:pt>
                <c:pt idx="163">
                  <c:v>18.899999999999999</c:v>
                </c:pt>
                <c:pt idx="164">
                  <c:v>9.6</c:v>
                </c:pt>
                <c:pt idx="165">
                  <c:v>4.3</c:v>
                </c:pt>
                <c:pt idx="166">
                  <c:v>2.1</c:v>
                </c:pt>
                <c:pt idx="167">
                  <c:v>2.1</c:v>
                </c:pt>
                <c:pt idx="168">
                  <c:v>2.2000000000000002</c:v>
                </c:pt>
                <c:pt idx="169">
                  <c:v>1.2</c:v>
                </c:pt>
                <c:pt idx="170">
                  <c:v>1.8</c:v>
                </c:pt>
                <c:pt idx="171">
                  <c:v>2</c:v>
                </c:pt>
                <c:pt idx="172">
                  <c:v>1.3</c:v>
                </c:pt>
                <c:pt idx="173">
                  <c:v>1.8</c:v>
                </c:pt>
                <c:pt idx="174">
                  <c:v>2</c:v>
                </c:pt>
                <c:pt idx="175">
                  <c:v>1.7</c:v>
                </c:pt>
                <c:pt idx="176">
                  <c:v>2.2999999999999998</c:v>
                </c:pt>
                <c:pt idx="177">
                  <c:v>1.4</c:v>
                </c:pt>
                <c:pt idx="178">
                  <c:v>1.8</c:v>
                </c:pt>
                <c:pt idx="179">
                  <c:v>2.2000000000000002</c:v>
                </c:pt>
                <c:pt idx="180">
                  <c:v>1.4</c:v>
                </c:pt>
                <c:pt idx="181">
                  <c:v>1.6</c:v>
                </c:pt>
                <c:pt idx="182">
                  <c:v>2.1</c:v>
                </c:pt>
                <c:pt idx="183">
                  <c:v>1.9</c:v>
                </c:pt>
                <c:pt idx="184">
                  <c:v>1.5</c:v>
                </c:pt>
                <c:pt idx="185">
                  <c:v>1.4</c:v>
                </c:pt>
                <c:pt idx="186">
                  <c:v>2.1</c:v>
                </c:pt>
                <c:pt idx="187">
                  <c:v>1.7</c:v>
                </c:pt>
                <c:pt idx="188">
                  <c:v>2.2999999999999998</c:v>
                </c:pt>
                <c:pt idx="189">
                  <c:v>1.7</c:v>
                </c:pt>
                <c:pt idx="190">
                  <c:v>2.2999999999999998</c:v>
                </c:pt>
                <c:pt idx="191">
                  <c:v>1.6</c:v>
                </c:pt>
                <c:pt idx="192">
                  <c:v>2.1</c:v>
                </c:pt>
                <c:pt idx="193">
                  <c:v>2.2999999999999998</c:v>
                </c:pt>
                <c:pt idx="194">
                  <c:v>1.7</c:v>
                </c:pt>
                <c:pt idx="195">
                  <c:v>2.2999999999999998</c:v>
                </c:pt>
                <c:pt idx="196">
                  <c:v>2.2999999999999998</c:v>
                </c:pt>
                <c:pt idx="197">
                  <c:v>1.7</c:v>
                </c:pt>
                <c:pt idx="198">
                  <c:v>2.2000000000000002</c:v>
                </c:pt>
                <c:pt idx="199">
                  <c:v>1.7</c:v>
                </c:pt>
                <c:pt idx="200">
                  <c:v>2.2000000000000002</c:v>
                </c:pt>
                <c:pt idx="201">
                  <c:v>1.4</c:v>
                </c:pt>
                <c:pt idx="202">
                  <c:v>2</c:v>
                </c:pt>
                <c:pt idx="203">
                  <c:v>2.2999999999999998</c:v>
                </c:pt>
                <c:pt idx="204">
                  <c:v>1.6</c:v>
                </c:pt>
                <c:pt idx="205">
                  <c:v>1.8</c:v>
                </c:pt>
                <c:pt idx="206">
                  <c:v>2.2999999999999998</c:v>
                </c:pt>
                <c:pt idx="207">
                  <c:v>1.4</c:v>
                </c:pt>
                <c:pt idx="208">
                  <c:v>1.8</c:v>
                </c:pt>
                <c:pt idx="209">
                  <c:v>2.1</c:v>
                </c:pt>
                <c:pt idx="210">
                  <c:v>1.5</c:v>
                </c:pt>
                <c:pt idx="211">
                  <c:v>1.8</c:v>
                </c:pt>
                <c:pt idx="212">
                  <c:v>2.2000000000000002</c:v>
                </c:pt>
                <c:pt idx="213">
                  <c:v>1.6</c:v>
                </c:pt>
                <c:pt idx="214">
                  <c:v>1.9</c:v>
                </c:pt>
                <c:pt idx="215">
                  <c:v>1.9</c:v>
                </c:pt>
                <c:pt idx="216">
                  <c:v>1.7</c:v>
                </c:pt>
                <c:pt idx="217">
                  <c:v>2.2000000000000002</c:v>
                </c:pt>
                <c:pt idx="218">
                  <c:v>1.3</c:v>
                </c:pt>
                <c:pt idx="219">
                  <c:v>1.8</c:v>
                </c:pt>
                <c:pt idx="220">
                  <c:v>2.1</c:v>
                </c:pt>
                <c:pt idx="221">
                  <c:v>1.7</c:v>
                </c:pt>
                <c:pt idx="222">
                  <c:v>1.6</c:v>
                </c:pt>
                <c:pt idx="223">
                  <c:v>2.1</c:v>
                </c:pt>
                <c:pt idx="224">
                  <c:v>1.4</c:v>
                </c:pt>
                <c:pt idx="225">
                  <c:v>1.8</c:v>
                </c:pt>
                <c:pt idx="226">
                  <c:v>1.8</c:v>
                </c:pt>
                <c:pt idx="227">
                  <c:v>1.4</c:v>
                </c:pt>
                <c:pt idx="228">
                  <c:v>1.9</c:v>
                </c:pt>
                <c:pt idx="229">
                  <c:v>1.9</c:v>
                </c:pt>
                <c:pt idx="230">
                  <c:v>1.4</c:v>
                </c:pt>
                <c:pt idx="231">
                  <c:v>1.9</c:v>
                </c:pt>
                <c:pt idx="232">
                  <c:v>2.2999999999999998</c:v>
                </c:pt>
                <c:pt idx="233">
                  <c:v>1.4</c:v>
                </c:pt>
                <c:pt idx="234">
                  <c:v>1.7</c:v>
                </c:pt>
                <c:pt idx="235">
                  <c:v>2.2000000000000002</c:v>
                </c:pt>
                <c:pt idx="236">
                  <c:v>1.6</c:v>
                </c:pt>
                <c:pt idx="237">
                  <c:v>1.7</c:v>
                </c:pt>
                <c:pt idx="238">
                  <c:v>2.1</c:v>
                </c:pt>
                <c:pt idx="239">
                  <c:v>2.4</c:v>
                </c:pt>
                <c:pt idx="240">
                  <c:v>1.7</c:v>
                </c:pt>
                <c:pt idx="241">
                  <c:v>2.2000000000000002</c:v>
                </c:pt>
                <c:pt idx="242">
                  <c:v>1.7</c:v>
                </c:pt>
                <c:pt idx="243">
                  <c:v>1.6</c:v>
                </c:pt>
                <c:pt idx="244">
                  <c:v>1.9</c:v>
                </c:pt>
                <c:pt idx="245">
                  <c:v>2.2000000000000002</c:v>
                </c:pt>
                <c:pt idx="246">
                  <c:v>1.7</c:v>
                </c:pt>
                <c:pt idx="247">
                  <c:v>1.9</c:v>
                </c:pt>
                <c:pt idx="248">
                  <c:v>2.4</c:v>
                </c:pt>
                <c:pt idx="249">
                  <c:v>1.6</c:v>
                </c:pt>
                <c:pt idx="250">
                  <c:v>1.7</c:v>
                </c:pt>
                <c:pt idx="251">
                  <c:v>2.1</c:v>
                </c:pt>
                <c:pt idx="252">
                  <c:v>2.4</c:v>
                </c:pt>
                <c:pt idx="253">
                  <c:v>1.7</c:v>
                </c:pt>
                <c:pt idx="254">
                  <c:v>1.6</c:v>
                </c:pt>
                <c:pt idx="255">
                  <c:v>1.8</c:v>
                </c:pt>
                <c:pt idx="256">
                  <c:v>2</c:v>
                </c:pt>
                <c:pt idx="257">
                  <c:v>2.2999999999999998</c:v>
                </c:pt>
                <c:pt idx="258">
                  <c:v>1.7</c:v>
                </c:pt>
                <c:pt idx="259">
                  <c:v>1.8</c:v>
                </c:pt>
                <c:pt idx="260">
                  <c:v>1.8</c:v>
                </c:pt>
                <c:pt idx="261">
                  <c:v>1.9</c:v>
                </c:pt>
                <c:pt idx="262">
                  <c:v>2.2000000000000002</c:v>
                </c:pt>
                <c:pt idx="263">
                  <c:v>1.6</c:v>
                </c:pt>
                <c:pt idx="264">
                  <c:v>1.7</c:v>
                </c:pt>
                <c:pt idx="265">
                  <c:v>2.2999999999999998</c:v>
                </c:pt>
                <c:pt idx="266">
                  <c:v>1.4</c:v>
                </c:pt>
                <c:pt idx="267">
                  <c:v>1.8</c:v>
                </c:pt>
                <c:pt idx="268">
                  <c:v>2.1</c:v>
                </c:pt>
                <c:pt idx="269">
                  <c:v>2.5</c:v>
                </c:pt>
                <c:pt idx="270">
                  <c:v>1.6</c:v>
                </c:pt>
                <c:pt idx="271">
                  <c:v>2</c:v>
                </c:pt>
                <c:pt idx="272">
                  <c:v>2.4</c:v>
                </c:pt>
                <c:pt idx="273">
                  <c:v>1.7</c:v>
                </c:pt>
                <c:pt idx="274">
                  <c:v>2.1</c:v>
                </c:pt>
                <c:pt idx="275">
                  <c:v>2.4</c:v>
                </c:pt>
                <c:pt idx="276">
                  <c:v>1.8</c:v>
                </c:pt>
                <c:pt idx="277">
                  <c:v>1.8</c:v>
                </c:pt>
                <c:pt idx="278">
                  <c:v>2.2000000000000002</c:v>
                </c:pt>
                <c:pt idx="279">
                  <c:v>2.4</c:v>
                </c:pt>
                <c:pt idx="280">
                  <c:v>2.6</c:v>
                </c:pt>
                <c:pt idx="281">
                  <c:v>1.8</c:v>
                </c:pt>
                <c:pt idx="282">
                  <c:v>1.9</c:v>
                </c:pt>
                <c:pt idx="283">
                  <c:v>2</c:v>
                </c:pt>
                <c:pt idx="284">
                  <c:v>2.5</c:v>
                </c:pt>
                <c:pt idx="285">
                  <c:v>1.8</c:v>
                </c:pt>
                <c:pt idx="286">
                  <c:v>2.5</c:v>
                </c:pt>
                <c:pt idx="287">
                  <c:v>2</c:v>
                </c:pt>
                <c:pt idx="288">
                  <c:v>2.1</c:v>
                </c:pt>
                <c:pt idx="289">
                  <c:v>2.4</c:v>
                </c:pt>
                <c:pt idx="290">
                  <c:v>1.7</c:v>
                </c:pt>
                <c:pt idx="291">
                  <c:v>2.1</c:v>
                </c:pt>
                <c:pt idx="292">
                  <c:v>2.4</c:v>
                </c:pt>
                <c:pt idx="293">
                  <c:v>2.7</c:v>
                </c:pt>
                <c:pt idx="294">
                  <c:v>2.1</c:v>
                </c:pt>
                <c:pt idx="295">
                  <c:v>2.1</c:v>
                </c:pt>
                <c:pt idx="296">
                  <c:v>2.4</c:v>
                </c:pt>
                <c:pt idx="297">
                  <c:v>2</c:v>
                </c:pt>
                <c:pt idx="298">
                  <c:v>1.8</c:v>
                </c:pt>
                <c:pt idx="299">
                  <c:v>2.1</c:v>
                </c:pt>
                <c:pt idx="300">
                  <c:v>2.4</c:v>
                </c:pt>
                <c:pt idx="301">
                  <c:v>2.7</c:v>
                </c:pt>
                <c:pt idx="302">
                  <c:v>2.1</c:v>
                </c:pt>
                <c:pt idx="303">
                  <c:v>1.9</c:v>
                </c:pt>
                <c:pt idx="304">
                  <c:v>2.1</c:v>
                </c:pt>
                <c:pt idx="305">
                  <c:v>2.6</c:v>
                </c:pt>
                <c:pt idx="306">
                  <c:v>1.9</c:v>
                </c:pt>
                <c:pt idx="307">
                  <c:v>1.7</c:v>
                </c:pt>
                <c:pt idx="308">
                  <c:v>2.1</c:v>
                </c:pt>
                <c:pt idx="309">
                  <c:v>1.8</c:v>
                </c:pt>
                <c:pt idx="310">
                  <c:v>2.5</c:v>
                </c:pt>
                <c:pt idx="311">
                  <c:v>1.6</c:v>
                </c:pt>
                <c:pt idx="312">
                  <c:v>2.2000000000000002</c:v>
                </c:pt>
                <c:pt idx="313">
                  <c:v>1.9</c:v>
                </c:pt>
                <c:pt idx="314">
                  <c:v>2.4</c:v>
                </c:pt>
                <c:pt idx="315">
                  <c:v>2.6</c:v>
                </c:pt>
                <c:pt idx="316">
                  <c:v>1.9</c:v>
                </c:pt>
                <c:pt idx="317">
                  <c:v>2.2999999999999998</c:v>
                </c:pt>
                <c:pt idx="318">
                  <c:v>2.1</c:v>
                </c:pt>
                <c:pt idx="319">
                  <c:v>2.2000000000000002</c:v>
                </c:pt>
                <c:pt idx="320">
                  <c:v>2.6</c:v>
                </c:pt>
                <c:pt idx="321">
                  <c:v>2</c:v>
                </c:pt>
                <c:pt idx="322">
                  <c:v>2.2000000000000002</c:v>
                </c:pt>
                <c:pt idx="323">
                  <c:v>2.6</c:v>
                </c:pt>
                <c:pt idx="324">
                  <c:v>2.7</c:v>
                </c:pt>
                <c:pt idx="325">
                  <c:v>1.9</c:v>
                </c:pt>
                <c:pt idx="326">
                  <c:v>2.2999999999999998</c:v>
                </c:pt>
                <c:pt idx="327">
                  <c:v>2.6</c:v>
                </c:pt>
                <c:pt idx="328">
                  <c:v>2.1</c:v>
                </c:pt>
                <c:pt idx="329">
                  <c:v>1.9</c:v>
                </c:pt>
                <c:pt idx="330">
                  <c:v>1.7</c:v>
                </c:pt>
                <c:pt idx="331">
                  <c:v>2.4</c:v>
                </c:pt>
                <c:pt idx="332">
                  <c:v>2.2000000000000002</c:v>
                </c:pt>
                <c:pt idx="333">
                  <c:v>2.6</c:v>
                </c:pt>
                <c:pt idx="334">
                  <c:v>2.1</c:v>
                </c:pt>
                <c:pt idx="335">
                  <c:v>2.1</c:v>
                </c:pt>
                <c:pt idx="336">
                  <c:v>1.8</c:v>
                </c:pt>
                <c:pt idx="337">
                  <c:v>1.7</c:v>
                </c:pt>
                <c:pt idx="338">
                  <c:v>2.2999999999999998</c:v>
                </c:pt>
                <c:pt idx="339">
                  <c:v>2.2000000000000002</c:v>
                </c:pt>
                <c:pt idx="340">
                  <c:v>1.8</c:v>
                </c:pt>
                <c:pt idx="341">
                  <c:v>2.1</c:v>
                </c:pt>
                <c:pt idx="342">
                  <c:v>2.4</c:v>
                </c:pt>
                <c:pt idx="343">
                  <c:v>1.7</c:v>
                </c:pt>
                <c:pt idx="344">
                  <c:v>2.1</c:v>
                </c:pt>
                <c:pt idx="345">
                  <c:v>2.6</c:v>
                </c:pt>
                <c:pt idx="346">
                  <c:v>1.7</c:v>
                </c:pt>
                <c:pt idx="347">
                  <c:v>2.1</c:v>
                </c:pt>
                <c:pt idx="348">
                  <c:v>2.4</c:v>
                </c:pt>
                <c:pt idx="349">
                  <c:v>2</c:v>
                </c:pt>
                <c:pt idx="350">
                  <c:v>1.9</c:v>
                </c:pt>
                <c:pt idx="351">
                  <c:v>2.1</c:v>
                </c:pt>
                <c:pt idx="352">
                  <c:v>2.2999999999999998</c:v>
                </c:pt>
                <c:pt idx="353">
                  <c:v>2.2999999999999998</c:v>
                </c:pt>
                <c:pt idx="354">
                  <c:v>2.2000000000000002</c:v>
                </c:pt>
                <c:pt idx="355">
                  <c:v>2.5</c:v>
                </c:pt>
                <c:pt idx="356">
                  <c:v>2.2000000000000002</c:v>
                </c:pt>
                <c:pt idx="357">
                  <c:v>2.1</c:v>
                </c:pt>
                <c:pt idx="358">
                  <c:v>1.7</c:v>
                </c:pt>
                <c:pt idx="359">
                  <c:v>1.7</c:v>
                </c:pt>
                <c:pt idx="360">
                  <c:v>2.4</c:v>
                </c:pt>
                <c:pt idx="361">
                  <c:v>1.7</c:v>
                </c:pt>
                <c:pt idx="362">
                  <c:v>2</c:v>
                </c:pt>
                <c:pt idx="363">
                  <c:v>2.4</c:v>
                </c:pt>
                <c:pt idx="364">
                  <c:v>2.8</c:v>
                </c:pt>
                <c:pt idx="365">
                  <c:v>1.9</c:v>
                </c:pt>
                <c:pt idx="366">
                  <c:v>2.2000000000000002</c:v>
                </c:pt>
                <c:pt idx="367">
                  <c:v>2.4</c:v>
                </c:pt>
                <c:pt idx="368">
                  <c:v>2.7</c:v>
                </c:pt>
                <c:pt idx="369">
                  <c:v>1.7</c:v>
                </c:pt>
                <c:pt idx="370">
                  <c:v>2.2000000000000002</c:v>
                </c:pt>
                <c:pt idx="371">
                  <c:v>2.6</c:v>
                </c:pt>
                <c:pt idx="372">
                  <c:v>2.7</c:v>
                </c:pt>
                <c:pt idx="373">
                  <c:v>1.7</c:v>
                </c:pt>
                <c:pt idx="374">
                  <c:v>2</c:v>
                </c:pt>
                <c:pt idx="375">
                  <c:v>2.1</c:v>
                </c:pt>
                <c:pt idx="376">
                  <c:v>2.2999999999999998</c:v>
                </c:pt>
                <c:pt idx="377">
                  <c:v>2.6</c:v>
                </c:pt>
                <c:pt idx="378">
                  <c:v>2.1</c:v>
                </c:pt>
                <c:pt idx="379">
                  <c:v>2.2000000000000002</c:v>
                </c:pt>
                <c:pt idx="380">
                  <c:v>2.8</c:v>
                </c:pt>
                <c:pt idx="381">
                  <c:v>2</c:v>
                </c:pt>
                <c:pt idx="382">
                  <c:v>2.4</c:v>
                </c:pt>
                <c:pt idx="383">
                  <c:v>1.8</c:v>
                </c:pt>
                <c:pt idx="384">
                  <c:v>2.2000000000000002</c:v>
                </c:pt>
                <c:pt idx="385">
                  <c:v>2.6</c:v>
                </c:pt>
                <c:pt idx="386">
                  <c:v>1.8</c:v>
                </c:pt>
                <c:pt idx="387">
                  <c:v>2.2999999999999998</c:v>
                </c:pt>
                <c:pt idx="388">
                  <c:v>2.4</c:v>
                </c:pt>
                <c:pt idx="389">
                  <c:v>2.1</c:v>
                </c:pt>
                <c:pt idx="390">
                  <c:v>2.6</c:v>
                </c:pt>
                <c:pt idx="391">
                  <c:v>1.8</c:v>
                </c:pt>
                <c:pt idx="392">
                  <c:v>2.2000000000000002</c:v>
                </c:pt>
                <c:pt idx="393">
                  <c:v>2.4</c:v>
                </c:pt>
                <c:pt idx="394">
                  <c:v>1.9</c:v>
                </c:pt>
                <c:pt idx="395">
                  <c:v>2.2999999999999998</c:v>
                </c:pt>
                <c:pt idx="396">
                  <c:v>2.4</c:v>
                </c:pt>
                <c:pt idx="397">
                  <c:v>1.7</c:v>
                </c:pt>
                <c:pt idx="398">
                  <c:v>2.1</c:v>
                </c:pt>
                <c:pt idx="399">
                  <c:v>2.6</c:v>
                </c:pt>
                <c:pt idx="400">
                  <c:v>1.6</c:v>
                </c:pt>
                <c:pt idx="401">
                  <c:v>1.8</c:v>
                </c:pt>
                <c:pt idx="402">
                  <c:v>2</c:v>
                </c:pt>
                <c:pt idx="403">
                  <c:v>1.7</c:v>
                </c:pt>
                <c:pt idx="404">
                  <c:v>2.2000000000000002</c:v>
                </c:pt>
                <c:pt idx="405">
                  <c:v>1.6</c:v>
                </c:pt>
                <c:pt idx="406">
                  <c:v>2.2000000000000002</c:v>
                </c:pt>
                <c:pt idx="407">
                  <c:v>2.4</c:v>
                </c:pt>
                <c:pt idx="408">
                  <c:v>2.2999999999999998</c:v>
                </c:pt>
                <c:pt idx="409">
                  <c:v>1.7</c:v>
                </c:pt>
                <c:pt idx="410">
                  <c:v>2.1</c:v>
                </c:pt>
                <c:pt idx="411">
                  <c:v>2.6</c:v>
                </c:pt>
                <c:pt idx="412">
                  <c:v>1.7</c:v>
                </c:pt>
                <c:pt idx="413">
                  <c:v>2.1</c:v>
                </c:pt>
                <c:pt idx="414">
                  <c:v>2.2000000000000002</c:v>
                </c:pt>
                <c:pt idx="415">
                  <c:v>1.9</c:v>
                </c:pt>
                <c:pt idx="416">
                  <c:v>2.2000000000000002</c:v>
                </c:pt>
                <c:pt idx="417">
                  <c:v>2.6</c:v>
                </c:pt>
                <c:pt idx="418">
                  <c:v>1.9</c:v>
                </c:pt>
                <c:pt idx="419">
                  <c:v>1.8</c:v>
                </c:pt>
                <c:pt idx="420">
                  <c:v>2.2999999999999998</c:v>
                </c:pt>
                <c:pt idx="421">
                  <c:v>2.6</c:v>
                </c:pt>
                <c:pt idx="422">
                  <c:v>1.9</c:v>
                </c:pt>
                <c:pt idx="423">
                  <c:v>2.2000000000000002</c:v>
                </c:pt>
                <c:pt idx="424">
                  <c:v>2.6</c:v>
                </c:pt>
                <c:pt idx="425">
                  <c:v>1.8</c:v>
                </c:pt>
                <c:pt idx="426">
                  <c:v>1.7</c:v>
                </c:pt>
                <c:pt idx="427">
                  <c:v>2.2999999999999998</c:v>
                </c:pt>
                <c:pt idx="428">
                  <c:v>2.1</c:v>
                </c:pt>
                <c:pt idx="429">
                  <c:v>2.6</c:v>
                </c:pt>
                <c:pt idx="430">
                  <c:v>1.9</c:v>
                </c:pt>
                <c:pt idx="431">
                  <c:v>2.5</c:v>
                </c:pt>
                <c:pt idx="432">
                  <c:v>1.8</c:v>
                </c:pt>
                <c:pt idx="433">
                  <c:v>2.1</c:v>
                </c:pt>
                <c:pt idx="434">
                  <c:v>2.2999999999999998</c:v>
                </c:pt>
                <c:pt idx="435">
                  <c:v>1.7</c:v>
                </c:pt>
                <c:pt idx="436">
                  <c:v>2</c:v>
                </c:pt>
                <c:pt idx="437">
                  <c:v>2.4</c:v>
                </c:pt>
                <c:pt idx="438">
                  <c:v>1.9</c:v>
                </c:pt>
                <c:pt idx="439">
                  <c:v>2.2000000000000002</c:v>
                </c:pt>
                <c:pt idx="440">
                  <c:v>2.5</c:v>
                </c:pt>
                <c:pt idx="441">
                  <c:v>2</c:v>
                </c:pt>
                <c:pt idx="442">
                  <c:v>1.9</c:v>
                </c:pt>
                <c:pt idx="443">
                  <c:v>2.2999999999999998</c:v>
                </c:pt>
                <c:pt idx="444">
                  <c:v>2.7</c:v>
                </c:pt>
                <c:pt idx="445">
                  <c:v>2</c:v>
                </c:pt>
                <c:pt idx="446">
                  <c:v>2.1</c:v>
                </c:pt>
                <c:pt idx="447">
                  <c:v>2.2999999999999998</c:v>
                </c:pt>
                <c:pt idx="448">
                  <c:v>2.6</c:v>
                </c:pt>
                <c:pt idx="449">
                  <c:v>2.8</c:v>
                </c:pt>
                <c:pt idx="450">
                  <c:v>1.8</c:v>
                </c:pt>
                <c:pt idx="451">
                  <c:v>2.5</c:v>
                </c:pt>
                <c:pt idx="452">
                  <c:v>1.7</c:v>
                </c:pt>
                <c:pt idx="453">
                  <c:v>2.6</c:v>
                </c:pt>
                <c:pt idx="454">
                  <c:v>2</c:v>
                </c:pt>
                <c:pt idx="455">
                  <c:v>1.8</c:v>
                </c:pt>
                <c:pt idx="456">
                  <c:v>2.2999999999999998</c:v>
                </c:pt>
                <c:pt idx="457">
                  <c:v>2.7</c:v>
                </c:pt>
                <c:pt idx="458">
                  <c:v>2</c:v>
                </c:pt>
                <c:pt idx="459">
                  <c:v>2.4</c:v>
                </c:pt>
                <c:pt idx="460">
                  <c:v>2.8</c:v>
                </c:pt>
                <c:pt idx="461">
                  <c:v>2.1</c:v>
                </c:pt>
                <c:pt idx="462">
                  <c:v>2.6</c:v>
                </c:pt>
                <c:pt idx="463">
                  <c:v>2</c:v>
                </c:pt>
                <c:pt idx="464">
                  <c:v>2.6</c:v>
                </c:pt>
                <c:pt idx="465">
                  <c:v>2.2999999999999998</c:v>
                </c:pt>
                <c:pt idx="466">
                  <c:v>2.1</c:v>
                </c:pt>
                <c:pt idx="467">
                  <c:v>2.5</c:v>
                </c:pt>
                <c:pt idx="468">
                  <c:v>2.2000000000000002</c:v>
                </c:pt>
                <c:pt idx="469">
                  <c:v>2.2000000000000002</c:v>
                </c:pt>
                <c:pt idx="470">
                  <c:v>2.6</c:v>
                </c:pt>
                <c:pt idx="471">
                  <c:v>1.8</c:v>
                </c:pt>
                <c:pt idx="472">
                  <c:v>1.9</c:v>
                </c:pt>
                <c:pt idx="473">
                  <c:v>2.4</c:v>
                </c:pt>
                <c:pt idx="474">
                  <c:v>1.9</c:v>
                </c:pt>
                <c:pt idx="475">
                  <c:v>2.6</c:v>
                </c:pt>
                <c:pt idx="476">
                  <c:v>2</c:v>
                </c:pt>
                <c:pt idx="477">
                  <c:v>2.2000000000000002</c:v>
                </c:pt>
                <c:pt idx="478">
                  <c:v>1.8</c:v>
                </c:pt>
                <c:pt idx="479">
                  <c:v>2.2999999999999998</c:v>
                </c:pt>
                <c:pt idx="480">
                  <c:v>1.8</c:v>
                </c:pt>
                <c:pt idx="481">
                  <c:v>2.2999999999999998</c:v>
                </c:pt>
                <c:pt idx="482">
                  <c:v>2.2999999999999998</c:v>
                </c:pt>
                <c:pt idx="483">
                  <c:v>1.9</c:v>
                </c:pt>
                <c:pt idx="484">
                  <c:v>1.8</c:v>
                </c:pt>
                <c:pt idx="485">
                  <c:v>2.2000000000000002</c:v>
                </c:pt>
                <c:pt idx="486">
                  <c:v>2.2000000000000002</c:v>
                </c:pt>
                <c:pt idx="487">
                  <c:v>2</c:v>
                </c:pt>
                <c:pt idx="488">
                  <c:v>2.5</c:v>
                </c:pt>
                <c:pt idx="489">
                  <c:v>1.8</c:v>
                </c:pt>
                <c:pt idx="490">
                  <c:v>1.9</c:v>
                </c:pt>
                <c:pt idx="491">
                  <c:v>2.4</c:v>
                </c:pt>
                <c:pt idx="492">
                  <c:v>2.4</c:v>
                </c:pt>
                <c:pt idx="493">
                  <c:v>1.8</c:v>
                </c:pt>
                <c:pt idx="494">
                  <c:v>2.6</c:v>
                </c:pt>
                <c:pt idx="495">
                  <c:v>1.8</c:v>
                </c:pt>
                <c:pt idx="496">
                  <c:v>1.9</c:v>
                </c:pt>
                <c:pt idx="497">
                  <c:v>1.8</c:v>
                </c:pt>
                <c:pt idx="498">
                  <c:v>1.6</c:v>
                </c:pt>
                <c:pt idx="499">
                  <c:v>1.8</c:v>
                </c:pt>
                <c:pt idx="500">
                  <c:v>1.8</c:v>
                </c:pt>
                <c:pt idx="501">
                  <c:v>1.5</c:v>
                </c:pt>
                <c:pt idx="502">
                  <c:v>2.1</c:v>
                </c:pt>
                <c:pt idx="503">
                  <c:v>2.4</c:v>
                </c:pt>
                <c:pt idx="504">
                  <c:v>1.9</c:v>
                </c:pt>
                <c:pt idx="505">
                  <c:v>2.4</c:v>
                </c:pt>
                <c:pt idx="506">
                  <c:v>1.6</c:v>
                </c:pt>
                <c:pt idx="507">
                  <c:v>1.8</c:v>
                </c:pt>
                <c:pt idx="508">
                  <c:v>2.2000000000000002</c:v>
                </c:pt>
                <c:pt idx="509">
                  <c:v>2.6</c:v>
                </c:pt>
                <c:pt idx="510">
                  <c:v>1.9</c:v>
                </c:pt>
                <c:pt idx="511">
                  <c:v>1.9</c:v>
                </c:pt>
                <c:pt idx="512">
                  <c:v>2.2000000000000002</c:v>
                </c:pt>
                <c:pt idx="513">
                  <c:v>2.6</c:v>
                </c:pt>
                <c:pt idx="514">
                  <c:v>1.9</c:v>
                </c:pt>
                <c:pt idx="515">
                  <c:v>1.8</c:v>
                </c:pt>
                <c:pt idx="516">
                  <c:v>2.2000000000000002</c:v>
                </c:pt>
                <c:pt idx="517">
                  <c:v>2.5</c:v>
                </c:pt>
                <c:pt idx="518">
                  <c:v>2.7</c:v>
                </c:pt>
                <c:pt idx="519">
                  <c:v>1.7</c:v>
                </c:pt>
                <c:pt idx="520">
                  <c:v>1.7</c:v>
                </c:pt>
                <c:pt idx="521">
                  <c:v>1.8</c:v>
                </c:pt>
                <c:pt idx="522">
                  <c:v>1.7</c:v>
                </c:pt>
                <c:pt idx="523">
                  <c:v>1.8</c:v>
                </c:pt>
                <c:pt idx="524">
                  <c:v>2.2000000000000002</c:v>
                </c:pt>
                <c:pt idx="525">
                  <c:v>1.7</c:v>
                </c:pt>
                <c:pt idx="526">
                  <c:v>1.8</c:v>
                </c:pt>
                <c:pt idx="527">
                  <c:v>2.4</c:v>
                </c:pt>
                <c:pt idx="528">
                  <c:v>2</c:v>
                </c:pt>
                <c:pt idx="529">
                  <c:v>1.6</c:v>
                </c:pt>
                <c:pt idx="530">
                  <c:v>2.2000000000000002</c:v>
                </c:pt>
                <c:pt idx="531">
                  <c:v>2.2999999999999998</c:v>
                </c:pt>
                <c:pt idx="532">
                  <c:v>1.7</c:v>
                </c:pt>
                <c:pt idx="533">
                  <c:v>2</c:v>
                </c:pt>
                <c:pt idx="534">
                  <c:v>2.1</c:v>
                </c:pt>
                <c:pt idx="535">
                  <c:v>1.7</c:v>
                </c:pt>
                <c:pt idx="536">
                  <c:v>2.1</c:v>
                </c:pt>
                <c:pt idx="537">
                  <c:v>2.5</c:v>
                </c:pt>
                <c:pt idx="538">
                  <c:v>1.6</c:v>
                </c:pt>
                <c:pt idx="539">
                  <c:v>1.9</c:v>
                </c:pt>
                <c:pt idx="540">
                  <c:v>2.2000000000000002</c:v>
                </c:pt>
                <c:pt idx="541">
                  <c:v>2.4</c:v>
                </c:pt>
                <c:pt idx="542">
                  <c:v>1.6</c:v>
                </c:pt>
                <c:pt idx="543">
                  <c:v>1.7</c:v>
                </c:pt>
                <c:pt idx="544">
                  <c:v>2.1</c:v>
                </c:pt>
                <c:pt idx="545">
                  <c:v>2.4</c:v>
                </c:pt>
                <c:pt idx="546">
                  <c:v>1.8</c:v>
                </c:pt>
                <c:pt idx="547">
                  <c:v>2.1</c:v>
                </c:pt>
                <c:pt idx="548">
                  <c:v>2.2000000000000002</c:v>
                </c:pt>
                <c:pt idx="549">
                  <c:v>2.1</c:v>
                </c:pt>
                <c:pt idx="550">
                  <c:v>2.6</c:v>
                </c:pt>
                <c:pt idx="551">
                  <c:v>1.6</c:v>
                </c:pt>
                <c:pt idx="552">
                  <c:v>2.1</c:v>
                </c:pt>
                <c:pt idx="553">
                  <c:v>2.6</c:v>
                </c:pt>
                <c:pt idx="554">
                  <c:v>1.8</c:v>
                </c:pt>
                <c:pt idx="555">
                  <c:v>1.9</c:v>
                </c:pt>
                <c:pt idx="556">
                  <c:v>1.6</c:v>
                </c:pt>
                <c:pt idx="557">
                  <c:v>1.8</c:v>
                </c:pt>
                <c:pt idx="558">
                  <c:v>2.2999999999999998</c:v>
                </c:pt>
                <c:pt idx="559">
                  <c:v>1.7</c:v>
                </c:pt>
                <c:pt idx="560">
                  <c:v>2.1</c:v>
                </c:pt>
                <c:pt idx="561">
                  <c:v>2.6</c:v>
                </c:pt>
                <c:pt idx="562">
                  <c:v>2.2000000000000002</c:v>
                </c:pt>
                <c:pt idx="563">
                  <c:v>1.8</c:v>
                </c:pt>
                <c:pt idx="564">
                  <c:v>2</c:v>
                </c:pt>
                <c:pt idx="565">
                  <c:v>2.4</c:v>
                </c:pt>
                <c:pt idx="566">
                  <c:v>2.8</c:v>
                </c:pt>
                <c:pt idx="567">
                  <c:v>1.8</c:v>
                </c:pt>
                <c:pt idx="568">
                  <c:v>1.8</c:v>
                </c:pt>
                <c:pt idx="569">
                  <c:v>2.1</c:v>
                </c:pt>
                <c:pt idx="570">
                  <c:v>2.1</c:v>
                </c:pt>
                <c:pt idx="571">
                  <c:v>1.9</c:v>
                </c:pt>
                <c:pt idx="572">
                  <c:v>2.4</c:v>
                </c:pt>
                <c:pt idx="573">
                  <c:v>1.7</c:v>
                </c:pt>
                <c:pt idx="574">
                  <c:v>2.5</c:v>
                </c:pt>
                <c:pt idx="575">
                  <c:v>2</c:v>
                </c:pt>
                <c:pt idx="576">
                  <c:v>1.6</c:v>
                </c:pt>
                <c:pt idx="577">
                  <c:v>2.1</c:v>
                </c:pt>
                <c:pt idx="578">
                  <c:v>1.9</c:v>
                </c:pt>
                <c:pt idx="579">
                  <c:v>2.2000000000000002</c:v>
                </c:pt>
                <c:pt idx="580">
                  <c:v>2.6</c:v>
                </c:pt>
                <c:pt idx="581">
                  <c:v>1.9</c:v>
                </c:pt>
                <c:pt idx="582">
                  <c:v>1.9</c:v>
                </c:pt>
                <c:pt idx="583">
                  <c:v>2.2000000000000002</c:v>
                </c:pt>
                <c:pt idx="584">
                  <c:v>2.5</c:v>
                </c:pt>
                <c:pt idx="585">
                  <c:v>2.8</c:v>
                </c:pt>
                <c:pt idx="586">
                  <c:v>1.9</c:v>
                </c:pt>
                <c:pt idx="587">
                  <c:v>2.1</c:v>
                </c:pt>
                <c:pt idx="588">
                  <c:v>2.4</c:v>
                </c:pt>
                <c:pt idx="589">
                  <c:v>2.6</c:v>
                </c:pt>
                <c:pt idx="590">
                  <c:v>2.8</c:v>
                </c:pt>
                <c:pt idx="591">
                  <c:v>2.4</c:v>
                </c:pt>
                <c:pt idx="592">
                  <c:v>1.8</c:v>
                </c:pt>
                <c:pt idx="593">
                  <c:v>1.7</c:v>
                </c:pt>
                <c:pt idx="594">
                  <c:v>1.7</c:v>
                </c:pt>
                <c:pt idx="595">
                  <c:v>2.1</c:v>
                </c:pt>
                <c:pt idx="596">
                  <c:v>1.8</c:v>
                </c:pt>
                <c:pt idx="597">
                  <c:v>1.8</c:v>
                </c:pt>
                <c:pt idx="598">
                  <c:v>2.6</c:v>
                </c:pt>
                <c:pt idx="599">
                  <c:v>1.7</c:v>
                </c:pt>
                <c:pt idx="600">
                  <c:v>2.2000000000000002</c:v>
                </c:pt>
                <c:pt idx="601">
                  <c:v>1.4</c:v>
                </c:pt>
                <c:pt idx="602">
                  <c:v>2.4</c:v>
                </c:pt>
                <c:pt idx="603">
                  <c:v>1.8</c:v>
                </c:pt>
                <c:pt idx="604">
                  <c:v>1.9</c:v>
                </c:pt>
                <c:pt idx="605">
                  <c:v>2.4</c:v>
                </c:pt>
                <c:pt idx="606">
                  <c:v>1.7</c:v>
                </c:pt>
                <c:pt idx="607">
                  <c:v>1.7</c:v>
                </c:pt>
                <c:pt idx="608">
                  <c:v>1.9</c:v>
                </c:pt>
                <c:pt idx="609">
                  <c:v>2.2000000000000002</c:v>
                </c:pt>
                <c:pt idx="610">
                  <c:v>2.4</c:v>
                </c:pt>
                <c:pt idx="611">
                  <c:v>2.7</c:v>
                </c:pt>
                <c:pt idx="612">
                  <c:v>2.4</c:v>
                </c:pt>
                <c:pt idx="613">
                  <c:v>1.7</c:v>
                </c:pt>
                <c:pt idx="614">
                  <c:v>1.8</c:v>
                </c:pt>
                <c:pt idx="615">
                  <c:v>2.2999999999999998</c:v>
                </c:pt>
                <c:pt idx="616">
                  <c:v>2.7</c:v>
                </c:pt>
                <c:pt idx="617">
                  <c:v>1.7</c:v>
                </c:pt>
                <c:pt idx="618">
                  <c:v>2.2999999999999998</c:v>
                </c:pt>
                <c:pt idx="619">
                  <c:v>1.8</c:v>
                </c:pt>
                <c:pt idx="620">
                  <c:v>1.9</c:v>
                </c:pt>
                <c:pt idx="621">
                  <c:v>2.2000000000000002</c:v>
                </c:pt>
                <c:pt idx="622">
                  <c:v>1.7</c:v>
                </c:pt>
                <c:pt idx="623">
                  <c:v>2</c:v>
                </c:pt>
                <c:pt idx="624">
                  <c:v>1.4</c:v>
                </c:pt>
                <c:pt idx="625">
                  <c:v>2.1</c:v>
                </c:pt>
                <c:pt idx="626">
                  <c:v>2.4</c:v>
                </c:pt>
                <c:pt idx="627">
                  <c:v>2.7</c:v>
                </c:pt>
                <c:pt idx="628">
                  <c:v>1.9</c:v>
                </c:pt>
                <c:pt idx="629">
                  <c:v>2.4</c:v>
                </c:pt>
                <c:pt idx="630">
                  <c:v>1.6</c:v>
                </c:pt>
                <c:pt idx="631">
                  <c:v>2</c:v>
                </c:pt>
                <c:pt idx="632">
                  <c:v>2.2999999999999998</c:v>
                </c:pt>
                <c:pt idx="633">
                  <c:v>2.6</c:v>
                </c:pt>
                <c:pt idx="634">
                  <c:v>2.1</c:v>
                </c:pt>
                <c:pt idx="635">
                  <c:v>1.9</c:v>
                </c:pt>
                <c:pt idx="636">
                  <c:v>2.2000000000000002</c:v>
                </c:pt>
                <c:pt idx="637">
                  <c:v>2.2999999999999998</c:v>
                </c:pt>
                <c:pt idx="638">
                  <c:v>2.6</c:v>
                </c:pt>
                <c:pt idx="639">
                  <c:v>1.9</c:v>
                </c:pt>
                <c:pt idx="640">
                  <c:v>1.6</c:v>
                </c:pt>
                <c:pt idx="641">
                  <c:v>1.7</c:v>
                </c:pt>
                <c:pt idx="642">
                  <c:v>2.4</c:v>
                </c:pt>
                <c:pt idx="643">
                  <c:v>1.7</c:v>
                </c:pt>
                <c:pt idx="644">
                  <c:v>1.6</c:v>
                </c:pt>
                <c:pt idx="645">
                  <c:v>2.2000000000000002</c:v>
                </c:pt>
                <c:pt idx="646">
                  <c:v>1.4</c:v>
                </c:pt>
                <c:pt idx="647">
                  <c:v>2.2000000000000002</c:v>
                </c:pt>
                <c:pt idx="648">
                  <c:v>1.4</c:v>
                </c:pt>
                <c:pt idx="649">
                  <c:v>1.9</c:v>
                </c:pt>
                <c:pt idx="650">
                  <c:v>2.5</c:v>
                </c:pt>
                <c:pt idx="651">
                  <c:v>1.8</c:v>
                </c:pt>
                <c:pt idx="652">
                  <c:v>1.9</c:v>
                </c:pt>
                <c:pt idx="653">
                  <c:v>1.6</c:v>
                </c:pt>
                <c:pt idx="654">
                  <c:v>2.4</c:v>
                </c:pt>
                <c:pt idx="655">
                  <c:v>1.8</c:v>
                </c:pt>
                <c:pt idx="656">
                  <c:v>2.1</c:v>
                </c:pt>
                <c:pt idx="657">
                  <c:v>2.1</c:v>
                </c:pt>
                <c:pt idx="658">
                  <c:v>1.6</c:v>
                </c:pt>
                <c:pt idx="659">
                  <c:v>2.5</c:v>
                </c:pt>
                <c:pt idx="660">
                  <c:v>1.9</c:v>
                </c:pt>
                <c:pt idx="661">
                  <c:v>1.8</c:v>
                </c:pt>
                <c:pt idx="662">
                  <c:v>2.1</c:v>
                </c:pt>
                <c:pt idx="663">
                  <c:v>1.6</c:v>
                </c:pt>
                <c:pt idx="664">
                  <c:v>1.9</c:v>
                </c:pt>
                <c:pt idx="665">
                  <c:v>1.7</c:v>
                </c:pt>
                <c:pt idx="666">
                  <c:v>11.1</c:v>
                </c:pt>
                <c:pt idx="667">
                  <c:v>3.5</c:v>
                </c:pt>
                <c:pt idx="668">
                  <c:v>3</c:v>
                </c:pt>
                <c:pt idx="669">
                  <c:v>2.6</c:v>
                </c:pt>
                <c:pt idx="670">
                  <c:v>1.7</c:v>
                </c:pt>
                <c:pt idx="671">
                  <c:v>2.4</c:v>
                </c:pt>
                <c:pt idx="672">
                  <c:v>1.8</c:v>
                </c:pt>
                <c:pt idx="673">
                  <c:v>2.4</c:v>
                </c:pt>
                <c:pt idx="674">
                  <c:v>1.6</c:v>
                </c:pt>
                <c:pt idx="675">
                  <c:v>1.7</c:v>
                </c:pt>
                <c:pt idx="676">
                  <c:v>2</c:v>
                </c:pt>
                <c:pt idx="677">
                  <c:v>2.4</c:v>
                </c:pt>
                <c:pt idx="678">
                  <c:v>1.7</c:v>
                </c:pt>
                <c:pt idx="679">
                  <c:v>2.2000000000000002</c:v>
                </c:pt>
                <c:pt idx="680">
                  <c:v>2.5</c:v>
                </c:pt>
                <c:pt idx="681">
                  <c:v>1.5</c:v>
                </c:pt>
                <c:pt idx="682">
                  <c:v>2</c:v>
                </c:pt>
                <c:pt idx="683">
                  <c:v>2.4</c:v>
                </c:pt>
                <c:pt idx="684">
                  <c:v>2.7</c:v>
                </c:pt>
                <c:pt idx="685">
                  <c:v>1.6</c:v>
                </c:pt>
                <c:pt idx="686">
                  <c:v>1.9</c:v>
                </c:pt>
                <c:pt idx="687">
                  <c:v>2.2000000000000002</c:v>
                </c:pt>
                <c:pt idx="688">
                  <c:v>2.5</c:v>
                </c:pt>
                <c:pt idx="689">
                  <c:v>1.9</c:v>
                </c:pt>
                <c:pt idx="690">
                  <c:v>2.2000000000000002</c:v>
                </c:pt>
                <c:pt idx="691">
                  <c:v>2.6</c:v>
                </c:pt>
                <c:pt idx="692">
                  <c:v>1.7</c:v>
                </c:pt>
                <c:pt idx="693">
                  <c:v>2.1</c:v>
                </c:pt>
                <c:pt idx="694">
                  <c:v>2.2999999999999998</c:v>
                </c:pt>
                <c:pt idx="695">
                  <c:v>1.9</c:v>
                </c:pt>
                <c:pt idx="696">
                  <c:v>2.5</c:v>
                </c:pt>
                <c:pt idx="697">
                  <c:v>1.6</c:v>
                </c:pt>
                <c:pt idx="698">
                  <c:v>2</c:v>
                </c:pt>
                <c:pt idx="699">
                  <c:v>2.5</c:v>
                </c:pt>
                <c:pt idx="700">
                  <c:v>1.8</c:v>
                </c:pt>
                <c:pt idx="701">
                  <c:v>2.2000000000000002</c:v>
                </c:pt>
                <c:pt idx="702">
                  <c:v>1.5</c:v>
                </c:pt>
                <c:pt idx="703">
                  <c:v>2.1</c:v>
                </c:pt>
                <c:pt idx="704">
                  <c:v>2.4</c:v>
                </c:pt>
                <c:pt idx="705">
                  <c:v>1.9</c:v>
                </c:pt>
                <c:pt idx="706">
                  <c:v>1.7</c:v>
                </c:pt>
                <c:pt idx="707">
                  <c:v>2.1</c:v>
                </c:pt>
                <c:pt idx="708">
                  <c:v>2.4</c:v>
                </c:pt>
                <c:pt idx="709">
                  <c:v>1.7</c:v>
                </c:pt>
                <c:pt idx="710">
                  <c:v>1.9</c:v>
                </c:pt>
                <c:pt idx="711">
                  <c:v>2.2000000000000002</c:v>
                </c:pt>
                <c:pt idx="712">
                  <c:v>2.5</c:v>
                </c:pt>
                <c:pt idx="713">
                  <c:v>1.9</c:v>
                </c:pt>
                <c:pt idx="714">
                  <c:v>1.8</c:v>
                </c:pt>
                <c:pt idx="715">
                  <c:v>2.2999999999999998</c:v>
                </c:pt>
                <c:pt idx="716">
                  <c:v>2.7</c:v>
                </c:pt>
                <c:pt idx="717">
                  <c:v>2</c:v>
                </c:pt>
                <c:pt idx="718">
                  <c:v>2.6</c:v>
                </c:pt>
                <c:pt idx="719">
                  <c:v>1.8</c:v>
                </c:pt>
                <c:pt idx="720">
                  <c:v>2.1</c:v>
                </c:pt>
                <c:pt idx="721">
                  <c:v>1.7</c:v>
                </c:pt>
                <c:pt idx="722">
                  <c:v>2.1</c:v>
                </c:pt>
                <c:pt idx="723">
                  <c:v>2.6</c:v>
                </c:pt>
                <c:pt idx="724">
                  <c:v>1.9</c:v>
                </c:pt>
                <c:pt idx="725">
                  <c:v>2.4</c:v>
                </c:pt>
                <c:pt idx="726">
                  <c:v>1.6</c:v>
                </c:pt>
                <c:pt idx="727">
                  <c:v>1.9</c:v>
                </c:pt>
                <c:pt idx="728">
                  <c:v>2.2000000000000002</c:v>
                </c:pt>
                <c:pt idx="729">
                  <c:v>2.8</c:v>
                </c:pt>
                <c:pt idx="730">
                  <c:v>1.6</c:v>
                </c:pt>
                <c:pt idx="731">
                  <c:v>2</c:v>
                </c:pt>
                <c:pt idx="732">
                  <c:v>2.2999999999999998</c:v>
                </c:pt>
                <c:pt idx="733">
                  <c:v>2.8</c:v>
                </c:pt>
                <c:pt idx="734">
                  <c:v>1.8</c:v>
                </c:pt>
                <c:pt idx="735">
                  <c:v>2.1</c:v>
                </c:pt>
                <c:pt idx="736">
                  <c:v>2.4</c:v>
                </c:pt>
                <c:pt idx="737">
                  <c:v>1.8</c:v>
                </c:pt>
                <c:pt idx="738">
                  <c:v>1.9</c:v>
                </c:pt>
                <c:pt idx="739">
                  <c:v>2.2999999999999998</c:v>
                </c:pt>
                <c:pt idx="740">
                  <c:v>2.7</c:v>
                </c:pt>
                <c:pt idx="741">
                  <c:v>1.7</c:v>
                </c:pt>
                <c:pt idx="742">
                  <c:v>1.9</c:v>
                </c:pt>
                <c:pt idx="743">
                  <c:v>2.2999999999999998</c:v>
                </c:pt>
                <c:pt idx="744">
                  <c:v>1.8</c:v>
                </c:pt>
                <c:pt idx="745">
                  <c:v>1.9</c:v>
                </c:pt>
                <c:pt idx="746">
                  <c:v>2.4</c:v>
                </c:pt>
                <c:pt idx="747">
                  <c:v>1.7</c:v>
                </c:pt>
                <c:pt idx="748">
                  <c:v>2</c:v>
                </c:pt>
                <c:pt idx="749">
                  <c:v>2.1</c:v>
                </c:pt>
                <c:pt idx="750">
                  <c:v>1.7</c:v>
                </c:pt>
                <c:pt idx="751">
                  <c:v>2.2999999999999998</c:v>
                </c:pt>
                <c:pt idx="752">
                  <c:v>1.7</c:v>
                </c:pt>
                <c:pt idx="753">
                  <c:v>1.8</c:v>
                </c:pt>
                <c:pt idx="754">
                  <c:v>2.1</c:v>
                </c:pt>
                <c:pt idx="755">
                  <c:v>2.4</c:v>
                </c:pt>
                <c:pt idx="756">
                  <c:v>1.3</c:v>
                </c:pt>
                <c:pt idx="757">
                  <c:v>1.6</c:v>
                </c:pt>
                <c:pt idx="758">
                  <c:v>2</c:v>
                </c:pt>
                <c:pt idx="759">
                  <c:v>2.2999999999999998</c:v>
                </c:pt>
                <c:pt idx="760">
                  <c:v>1.6</c:v>
                </c:pt>
                <c:pt idx="761">
                  <c:v>1.7</c:v>
                </c:pt>
                <c:pt idx="762">
                  <c:v>2.2000000000000002</c:v>
                </c:pt>
                <c:pt idx="763">
                  <c:v>1.3</c:v>
                </c:pt>
                <c:pt idx="764">
                  <c:v>1.6</c:v>
                </c:pt>
                <c:pt idx="765">
                  <c:v>1.9</c:v>
                </c:pt>
                <c:pt idx="766">
                  <c:v>2.2999999999999998</c:v>
                </c:pt>
                <c:pt idx="767">
                  <c:v>1.4</c:v>
                </c:pt>
                <c:pt idx="768">
                  <c:v>1.6</c:v>
                </c:pt>
                <c:pt idx="769">
                  <c:v>2.1</c:v>
                </c:pt>
                <c:pt idx="770">
                  <c:v>1.6</c:v>
                </c:pt>
                <c:pt idx="771">
                  <c:v>2.1</c:v>
                </c:pt>
                <c:pt idx="772">
                  <c:v>2.4</c:v>
                </c:pt>
                <c:pt idx="773">
                  <c:v>1.9</c:v>
                </c:pt>
                <c:pt idx="774">
                  <c:v>2.6</c:v>
                </c:pt>
                <c:pt idx="775">
                  <c:v>1.8</c:v>
                </c:pt>
                <c:pt idx="776">
                  <c:v>2.2999999999999998</c:v>
                </c:pt>
                <c:pt idx="777">
                  <c:v>1.6</c:v>
                </c:pt>
                <c:pt idx="778">
                  <c:v>2.2000000000000002</c:v>
                </c:pt>
                <c:pt idx="779">
                  <c:v>1.8</c:v>
                </c:pt>
                <c:pt idx="780">
                  <c:v>2.2999999999999998</c:v>
                </c:pt>
                <c:pt idx="781">
                  <c:v>1.7</c:v>
                </c:pt>
                <c:pt idx="782">
                  <c:v>2.1</c:v>
                </c:pt>
                <c:pt idx="783">
                  <c:v>1.9</c:v>
                </c:pt>
                <c:pt idx="784">
                  <c:v>2.2000000000000002</c:v>
                </c:pt>
                <c:pt idx="785">
                  <c:v>2.2000000000000002</c:v>
                </c:pt>
                <c:pt idx="786">
                  <c:v>2</c:v>
                </c:pt>
                <c:pt idx="787">
                  <c:v>1.8</c:v>
                </c:pt>
                <c:pt idx="788">
                  <c:v>2.2000000000000002</c:v>
                </c:pt>
                <c:pt idx="789">
                  <c:v>1.8</c:v>
                </c:pt>
                <c:pt idx="790">
                  <c:v>2.2999999999999998</c:v>
                </c:pt>
                <c:pt idx="791">
                  <c:v>1.7</c:v>
                </c:pt>
                <c:pt idx="792">
                  <c:v>2</c:v>
                </c:pt>
                <c:pt idx="793">
                  <c:v>2.2000000000000002</c:v>
                </c:pt>
                <c:pt idx="794">
                  <c:v>2.1</c:v>
                </c:pt>
                <c:pt idx="795">
                  <c:v>1.8</c:v>
                </c:pt>
                <c:pt idx="796">
                  <c:v>1.6</c:v>
                </c:pt>
                <c:pt idx="797">
                  <c:v>2.2000000000000002</c:v>
                </c:pt>
                <c:pt idx="798">
                  <c:v>1.8</c:v>
                </c:pt>
                <c:pt idx="799">
                  <c:v>2.4</c:v>
                </c:pt>
                <c:pt idx="800">
                  <c:v>1.4</c:v>
                </c:pt>
                <c:pt idx="801">
                  <c:v>2.1</c:v>
                </c:pt>
                <c:pt idx="802">
                  <c:v>2.5</c:v>
                </c:pt>
                <c:pt idx="803">
                  <c:v>1.7</c:v>
                </c:pt>
                <c:pt idx="804">
                  <c:v>2.2000000000000002</c:v>
                </c:pt>
                <c:pt idx="805">
                  <c:v>2.2999999999999998</c:v>
                </c:pt>
                <c:pt idx="806">
                  <c:v>1.8</c:v>
                </c:pt>
                <c:pt idx="807">
                  <c:v>2.4</c:v>
                </c:pt>
                <c:pt idx="808">
                  <c:v>2.1</c:v>
                </c:pt>
                <c:pt idx="809">
                  <c:v>1.4</c:v>
                </c:pt>
                <c:pt idx="810">
                  <c:v>2</c:v>
                </c:pt>
                <c:pt idx="811">
                  <c:v>1.7</c:v>
                </c:pt>
                <c:pt idx="812">
                  <c:v>1.4</c:v>
                </c:pt>
                <c:pt idx="813">
                  <c:v>2.1</c:v>
                </c:pt>
                <c:pt idx="814">
                  <c:v>1.7</c:v>
                </c:pt>
                <c:pt idx="815">
                  <c:v>2.4</c:v>
                </c:pt>
                <c:pt idx="816">
                  <c:v>1.9</c:v>
                </c:pt>
                <c:pt idx="817">
                  <c:v>2.4</c:v>
                </c:pt>
                <c:pt idx="818">
                  <c:v>1.9</c:v>
                </c:pt>
                <c:pt idx="819">
                  <c:v>2.6</c:v>
                </c:pt>
                <c:pt idx="820">
                  <c:v>1.7</c:v>
                </c:pt>
                <c:pt idx="821">
                  <c:v>2.2999999999999998</c:v>
                </c:pt>
                <c:pt idx="822">
                  <c:v>1.7</c:v>
                </c:pt>
                <c:pt idx="823">
                  <c:v>2.2999999999999998</c:v>
                </c:pt>
                <c:pt idx="824">
                  <c:v>1.7</c:v>
                </c:pt>
                <c:pt idx="825">
                  <c:v>2.1</c:v>
                </c:pt>
                <c:pt idx="826">
                  <c:v>2.7</c:v>
                </c:pt>
                <c:pt idx="827">
                  <c:v>2</c:v>
                </c:pt>
                <c:pt idx="828">
                  <c:v>2.6</c:v>
                </c:pt>
                <c:pt idx="829">
                  <c:v>2.1</c:v>
                </c:pt>
                <c:pt idx="830">
                  <c:v>2.7</c:v>
                </c:pt>
                <c:pt idx="831">
                  <c:v>2.1</c:v>
                </c:pt>
                <c:pt idx="832">
                  <c:v>1.9</c:v>
                </c:pt>
                <c:pt idx="833">
                  <c:v>2.4</c:v>
                </c:pt>
                <c:pt idx="834">
                  <c:v>1.9</c:v>
                </c:pt>
                <c:pt idx="835">
                  <c:v>1.7</c:v>
                </c:pt>
                <c:pt idx="836">
                  <c:v>2.4</c:v>
                </c:pt>
                <c:pt idx="837">
                  <c:v>2.2000000000000002</c:v>
                </c:pt>
                <c:pt idx="838">
                  <c:v>2.1</c:v>
                </c:pt>
                <c:pt idx="839">
                  <c:v>2.5</c:v>
                </c:pt>
                <c:pt idx="840">
                  <c:v>2.8</c:v>
                </c:pt>
                <c:pt idx="841">
                  <c:v>2</c:v>
                </c:pt>
                <c:pt idx="842">
                  <c:v>2.4</c:v>
                </c:pt>
                <c:pt idx="843">
                  <c:v>2.4</c:v>
                </c:pt>
                <c:pt idx="844">
                  <c:v>2.1</c:v>
                </c:pt>
                <c:pt idx="845">
                  <c:v>2.7</c:v>
                </c:pt>
                <c:pt idx="846">
                  <c:v>1.8</c:v>
                </c:pt>
                <c:pt idx="847">
                  <c:v>2.2000000000000002</c:v>
                </c:pt>
                <c:pt idx="848">
                  <c:v>2.6</c:v>
                </c:pt>
                <c:pt idx="849">
                  <c:v>2.2000000000000002</c:v>
                </c:pt>
                <c:pt idx="850">
                  <c:v>1.9</c:v>
                </c:pt>
                <c:pt idx="851">
                  <c:v>2.2999999999999998</c:v>
                </c:pt>
                <c:pt idx="852">
                  <c:v>2.7</c:v>
                </c:pt>
                <c:pt idx="853">
                  <c:v>1.8</c:v>
                </c:pt>
                <c:pt idx="854">
                  <c:v>2.4</c:v>
                </c:pt>
                <c:pt idx="855">
                  <c:v>2.6</c:v>
                </c:pt>
                <c:pt idx="856">
                  <c:v>2.1</c:v>
                </c:pt>
                <c:pt idx="857">
                  <c:v>1.8</c:v>
                </c:pt>
                <c:pt idx="858">
                  <c:v>2.2000000000000002</c:v>
                </c:pt>
                <c:pt idx="859">
                  <c:v>1.7</c:v>
                </c:pt>
                <c:pt idx="860">
                  <c:v>2.2000000000000002</c:v>
                </c:pt>
                <c:pt idx="861">
                  <c:v>2.6</c:v>
                </c:pt>
                <c:pt idx="862">
                  <c:v>1.8</c:v>
                </c:pt>
                <c:pt idx="863">
                  <c:v>2.4</c:v>
                </c:pt>
                <c:pt idx="864">
                  <c:v>1.8</c:v>
                </c:pt>
                <c:pt idx="865">
                  <c:v>2.1</c:v>
                </c:pt>
                <c:pt idx="866">
                  <c:v>2.5</c:v>
                </c:pt>
                <c:pt idx="867">
                  <c:v>2.2000000000000002</c:v>
                </c:pt>
                <c:pt idx="868">
                  <c:v>2.6</c:v>
                </c:pt>
                <c:pt idx="869">
                  <c:v>1.6</c:v>
                </c:pt>
                <c:pt idx="870">
                  <c:v>1.9</c:v>
                </c:pt>
                <c:pt idx="871">
                  <c:v>2.2999999999999998</c:v>
                </c:pt>
                <c:pt idx="872">
                  <c:v>2.4</c:v>
                </c:pt>
                <c:pt idx="873">
                  <c:v>1.7</c:v>
                </c:pt>
                <c:pt idx="874">
                  <c:v>2.2000000000000002</c:v>
                </c:pt>
                <c:pt idx="875">
                  <c:v>2.7</c:v>
                </c:pt>
                <c:pt idx="876">
                  <c:v>1.7</c:v>
                </c:pt>
                <c:pt idx="877">
                  <c:v>2.2000000000000002</c:v>
                </c:pt>
                <c:pt idx="878">
                  <c:v>2.6</c:v>
                </c:pt>
                <c:pt idx="879">
                  <c:v>2.2000000000000002</c:v>
                </c:pt>
                <c:pt idx="880">
                  <c:v>1.9</c:v>
                </c:pt>
                <c:pt idx="881">
                  <c:v>2.4</c:v>
                </c:pt>
                <c:pt idx="882">
                  <c:v>1.7</c:v>
                </c:pt>
                <c:pt idx="883">
                  <c:v>1.9</c:v>
                </c:pt>
                <c:pt idx="884">
                  <c:v>2.2000000000000002</c:v>
                </c:pt>
                <c:pt idx="885">
                  <c:v>2.1</c:v>
                </c:pt>
                <c:pt idx="886">
                  <c:v>1.9</c:v>
                </c:pt>
                <c:pt idx="887">
                  <c:v>2.4</c:v>
                </c:pt>
                <c:pt idx="888">
                  <c:v>1.7</c:v>
                </c:pt>
                <c:pt idx="889">
                  <c:v>2.7</c:v>
                </c:pt>
                <c:pt idx="890">
                  <c:v>2.2999999999999998</c:v>
                </c:pt>
                <c:pt idx="891">
                  <c:v>1.8</c:v>
                </c:pt>
                <c:pt idx="892">
                  <c:v>2.7</c:v>
                </c:pt>
                <c:pt idx="893">
                  <c:v>1.8</c:v>
                </c:pt>
                <c:pt idx="894">
                  <c:v>2.2999999999999998</c:v>
                </c:pt>
                <c:pt idx="895">
                  <c:v>2.5</c:v>
                </c:pt>
                <c:pt idx="896">
                  <c:v>2</c:v>
                </c:pt>
                <c:pt idx="897">
                  <c:v>1.9</c:v>
                </c:pt>
                <c:pt idx="898">
                  <c:v>2.6</c:v>
                </c:pt>
                <c:pt idx="899">
                  <c:v>2.4</c:v>
                </c:pt>
                <c:pt idx="900">
                  <c:v>1.9</c:v>
                </c:pt>
                <c:pt idx="901">
                  <c:v>2.1</c:v>
                </c:pt>
                <c:pt idx="902">
                  <c:v>2.5</c:v>
                </c:pt>
                <c:pt idx="903">
                  <c:v>2.1</c:v>
                </c:pt>
                <c:pt idx="904">
                  <c:v>1.9</c:v>
                </c:pt>
                <c:pt idx="905">
                  <c:v>1.9</c:v>
                </c:pt>
                <c:pt idx="906">
                  <c:v>2.4</c:v>
                </c:pt>
                <c:pt idx="907">
                  <c:v>1.8</c:v>
                </c:pt>
                <c:pt idx="908">
                  <c:v>1.9</c:v>
                </c:pt>
                <c:pt idx="909">
                  <c:v>2.2000000000000002</c:v>
                </c:pt>
                <c:pt idx="910">
                  <c:v>1.6</c:v>
                </c:pt>
                <c:pt idx="911">
                  <c:v>2.1</c:v>
                </c:pt>
                <c:pt idx="912">
                  <c:v>2.5</c:v>
                </c:pt>
                <c:pt idx="913">
                  <c:v>1.6</c:v>
                </c:pt>
                <c:pt idx="914">
                  <c:v>2.1</c:v>
                </c:pt>
                <c:pt idx="915">
                  <c:v>2.6</c:v>
                </c:pt>
                <c:pt idx="916">
                  <c:v>1.9</c:v>
                </c:pt>
                <c:pt idx="917">
                  <c:v>2.2999999999999998</c:v>
                </c:pt>
                <c:pt idx="918">
                  <c:v>1.8</c:v>
                </c:pt>
                <c:pt idx="919">
                  <c:v>2.4</c:v>
                </c:pt>
                <c:pt idx="920">
                  <c:v>2.4</c:v>
                </c:pt>
                <c:pt idx="921">
                  <c:v>2</c:v>
                </c:pt>
                <c:pt idx="922">
                  <c:v>2.4</c:v>
                </c:pt>
                <c:pt idx="923">
                  <c:v>2.2000000000000002</c:v>
                </c:pt>
                <c:pt idx="924">
                  <c:v>1.9</c:v>
                </c:pt>
                <c:pt idx="925">
                  <c:v>2.6</c:v>
                </c:pt>
                <c:pt idx="926">
                  <c:v>1.9</c:v>
                </c:pt>
                <c:pt idx="927">
                  <c:v>2.2999999999999998</c:v>
                </c:pt>
                <c:pt idx="928">
                  <c:v>2.8</c:v>
                </c:pt>
                <c:pt idx="929">
                  <c:v>2.2000000000000002</c:v>
                </c:pt>
                <c:pt idx="930">
                  <c:v>2.2000000000000002</c:v>
                </c:pt>
                <c:pt idx="931">
                  <c:v>2.2999999999999998</c:v>
                </c:pt>
                <c:pt idx="932">
                  <c:v>1.9</c:v>
                </c:pt>
                <c:pt idx="933">
                  <c:v>2.2999999999999998</c:v>
                </c:pt>
                <c:pt idx="934">
                  <c:v>2.6</c:v>
                </c:pt>
                <c:pt idx="935">
                  <c:v>2.2000000000000002</c:v>
                </c:pt>
                <c:pt idx="936">
                  <c:v>2.7</c:v>
                </c:pt>
                <c:pt idx="937">
                  <c:v>1.8</c:v>
                </c:pt>
                <c:pt idx="938">
                  <c:v>2.2000000000000002</c:v>
                </c:pt>
                <c:pt idx="939">
                  <c:v>2.7</c:v>
                </c:pt>
                <c:pt idx="940">
                  <c:v>2.1</c:v>
                </c:pt>
                <c:pt idx="941">
                  <c:v>1.9</c:v>
                </c:pt>
                <c:pt idx="942">
                  <c:v>2.4</c:v>
                </c:pt>
                <c:pt idx="943">
                  <c:v>2.8</c:v>
                </c:pt>
                <c:pt idx="944">
                  <c:v>2.1</c:v>
                </c:pt>
                <c:pt idx="945">
                  <c:v>2.7</c:v>
                </c:pt>
                <c:pt idx="946">
                  <c:v>2.2999999999999998</c:v>
                </c:pt>
                <c:pt idx="947">
                  <c:v>2.2000000000000002</c:v>
                </c:pt>
                <c:pt idx="948">
                  <c:v>2.7</c:v>
                </c:pt>
                <c:pt idx="949">
                  <c:v>2.2000000000000002</c:v>
                </c:pt>
                <c:pt idx="950">
                  <c:v>2.1</c:v>
                </c:pt>
                <c:pt idx="951">
                  <c:v>2.4</c:v>
                </c:pt>
                <c:pt idx="952">
                  <c:v>2.6</c:v>
                </c:pt>
                <c:pt idx="953">
                  <c:v>10.4</c:v>
                </c:pt>
                <c:pt idx="954">
                  <c:v>5.9</c:v>
                </c:pt>
                <c:pt idx="955">
                  <c:v>5.4</c:v>
                </c:pt>
                <c:pt idx="956">
                  <c:v>5.3</c:v>
                </c:pt>
                <c:pt idx="957">
                  <c:v>5.3</c:v>
                </c:pt>
                <c:pt idx="958">
                  <c:v>5.3</c:v>
                </c:pt>
                <c:pt idx="959">
                  <c:v>5.3</c:v>
                </c:pt>
                <c:pt idx="960">
                  <c:v>5.3</c:v>
                </c:pt>
                <c:pt idx="961">
                  <c:v>5.3</c:v>
                </c:pt>
                <c:pt idx="962">
                  <c:v>5.3</c:v>
                </c:pt>
                <c:pt idx="963">
                  <c:v>5.3</c:v>
                </c:pt>
                <c:pt idx="964">
                  <c:v>5.3</c:v>
                </c:pt>
                <c:pt idx="965">
                  <c:v>5.3</c:v>
                </c:pt>
                <c:pt idx="966">
                  <c:v>5.3</c:v>
                </c:pt>
                <c:pt idx="967">
                  <c:v>5.3</c:v>
                </c:pt>
                <c:pt idx="968">
                  <c:v>5.2</c:v>
                </c:pt>
                <c:pt idx="969">
                  <c:v>5.2</c:v>
                </c:pt>
                <c:pt idx="970">
                  <c:v>5.2</c:v>
                </c:pt>
                <c:pt idx="971">
                  <c:v>5.2</c:v>
                </c:pt>
                <c:pt idx="972">
                  <c:v>5.2</c:v>
                </c:pt>
                <c:pt idx="973">
                  <c:v>5.2</c:v>
                </c:pt>
                <c:pt idx="974">
                  <c:v>5.3</c:v>
                </c:pt>
                <c:pt idx="975">
                  <c:v>5.3</c:v>
                </c:pt>
                <c:pt idx="976">
                  <c:v>5.3</c:v>
                </c:pt>
                <c:pt idx="977">
                  <c:v>5.3</c:v>
                </c:pt>
                <c:pt idx="978">
                  <c:v>5.3</c:v>
                </c:pt>
                <c:pt idx="979">
                  <c:v>5.3</c:v>
                </c:pt>
                <c:pt idx="980">
                  <c:v>5.2</c:v>
                </c:pt>
                <c:pt idx="981">
                  <c:v>5.3</c:v>
                </c:pt>
                <c:pt idx="982">
                  <c:v>5.2</c:v>
                </c:pt>
                <c:pt idx="983">
                  <c:v>5.2</c:v>
                </c:pt>
                <c:pt idx="984">
                  <c:v>5.3</c:v>
                </c:pt>
                <c:pt idx="985">
                  <c:v>5.3</c:v>
                </c:pt>
                <c:pt idx="986">
                  <c:v>5.3</c:v>
                </c:pt>
                <c:pt idx="987">
                  <c:v>5.3</c:v>
                </c:pt>
                <c:pt idx="988">
                  <c:v>5.3</c:v>
                </c:pt>
                <c:pt idx="989">
                  <c:v>5.2</c:v>
                </c:pt>
                <c:pt idx="990">
                  <c:v>5.2</c:v>
                </c:pt>
                <c:pt idx="991">
                  <c:v>5.2</c:v>
                </c:pt>
                <c:pt idx="992">
                  <c:v>5.3</c:v>
                </c:pt>
                <c:pt idx="993">
                  <c:v>5.2</c:v>
                </c:pt>
                <c:pt idx="994">
                  <c:v>5.2</c:v>
                </c:pt>
                <c:pt idx="995">
                  <c:v>5.2</c:v>
                </c:pt>
                <c:pt idx="996">
                  <c:v>5.2</c:v>
                </c:pt>
                <c:pt idx="997">
                  <c:v>5.2</c:v>
                </c:pt>
                <c:pt idx="998">
                  <c:v>5.3</c:v>
                </c:pt>
                <c:pt idx="999">
                  <c:v>5.3</c:v>
                </c:pt>
                <c:pt idx="1000">
                  <c:v>5.3</c:v>
                </c:pt>
                <c:pt idx="1001">
                  <c:v>5.3</c:v>
                </c:pt>
                <c:pt idx="1002">
                  <c:v>5.3</c:v>
                </c:pt>
                <c:pt idx="1003">
                  <c:v>5.3</c:v>
                </c:pt>
                <c:pt idx="1004">
                  <c:v>5.3</c:v>
                </c:pt>
                <c:pt idx="1005">
                  <c:v>5.3</c:v>
                </c:pt>
                <c:pt idx="1006">
                  <c:v>5.3</c:v>
                </c:pt>
                <c:pt idx="1007">
                  <c:v>5.3</c:v>
                </c:pt>
                <c:pt idx="1008">
                  <c:v>5.3</c:v>
                </c:pt>
                <c:pt idx="1009">
                  <c:v>5.3</c:v>
                </c:pt>
                <c:pt idx="1010">
                  <c:v>5.3</c:v>
                </c:pt>
                <c:pt idx="1011">
                  <c:v>5.2</c:v>
                </c:pt>
                <c:pt idx="1012">
                  <c:v>5.2</c:v>
                </c:pt>
                <c:pt idx="1013">
                  <c:v>5.2</c:v>
                </c:pt>
                <c:pt idx="1014">
                  <c:v>5.3</c:v>
                </c:pt>
                <c:pt idx="1015">
                  <c:v>5.2</c:v>
                </c:pt>
                <c:pt idx="1016">
                  <c:v>5.2</c:v>
                </c:pt>
                <c:pt idx="1017">
                  <c:v>5.2</c:v>
                </c:pt>
                <c:pt idx="1018">
                  <c:v>5.2</c:v>
                </c:pt>
                <c:pt idx="1019">
                  <c:v>5.2</c:v>
                </c:pt>
                <c:pt idx="1020">
                  <c:v>5.2</c:v>
                </c:pt>
                <c:pt idx="1021">
                  <c:v>5.2</c:v>
                </c:pt>
                <c:pt idx="1022">
                  <c:v>5.3</c:v>
                </c:pt>
                <c:pt idx="1023">
                  <c:v>5.3</c:v>
                </c:pt>
                <c:pt idx="1024">
                  <c:v>5.3</c:v>
                </c:pt>
                <c:pt idx="1025">
                  <c:v>5.2</c:v>
                </c:pt>
                <c:pt idx="1026">
                  <c:v>5.2</c:v>
                </c:pt>
                <c:pt idx="1027">
                  <c:v>5.2</c:v>
                </c:pt>
                <c:pt idx="1028">
                  <c:v>5.2</c:v>
                </c:pt>
                <c:pt idx="1029">
                  <c:v>5.2</c:v>
                </c:pt>
                <c:pt idx="1030">
                  <c:v>5.2</c:v>
                </c:pt>
                <c:pt idx="1031">
                  <c:v>5.2</c:v>
                </c:pt>
                <c:pt idx="1032">
                  <c:v>5.2</c:v>
                </c:pt>
                <c:pt idx="1033">
                  <c:v>5.3</c:v>
                </c:pt>
                <c:pt idx="1034">
                  <c:v>5.2</c:v>
                </c:pt>
                <c:pt idx="1035">
                  <c:v>5.2</c:v>
                </c:pt>
                <c:pt idx="1036">
                  <c:v>5.2</c:v>
                </c:pt>
                <c:pt idx="1037">
                  <c:v>5.2</c:v>
                </c:pt>
                <c:pt idx="1038">
                  <c:v>5.2</c:v>
                </c:pt>
                <c:pt idx="1039">
                  <c:v>5.2</c:v>
                </c:pt>
                <c:pt idx="1040">
                  <c:v>5.2</c:v>
                </c:pt>
                <c:pt idx="1041">
                  <c:v>5.2</c:v>
                </c:pt>
                <c:pt idx="1042">
                  <c:v>5.2</c:v>
                </c:pt>
                <c:pt idx="1043">
                  <c:v>5.2</c:v>
                </c:pt>
                <c:pt idx="1044">
                  <c:v>5.2</c:v>
                </c:pt>
                <c:pt idx="1045">
                  <c:v>5.2</c:v>
                </c:pt>
                <c:pt idx="1046">
                  <c:v>5.2</c:v>
                </c:pt>
                <c:pt idx="1047">
                  <c:v>5.2</c:v>
                </c:pt>
                <c:pt idx="1048">
                  <c:v>5.2</c:v>
                </c:pt>
                <c:pt idx="1049">
                  <c:v>5.3</c:v>
                </c:pt>
                <c:pt idx="1050">
                  <c:v>5.3</c:v>
                </c:pt>
                <c:pt idx="1051">
                  <c:v>5.2</c:v>
                </c:pt>
                <c:pt idx="1052">
                  <c:v>5.2</c:v>
                </c:pt>
                <c:pt idx="1053">
                  <c:v>5.3</c:v>
                </c:pt>
                <c:pt idx="1054">
                  <c:v>5.2</c:v>
                </c:pt>
                <c:pt idx="1055">
                  <c:v>5.2</c:v>
                </c:pt>
                <c:pt idx="1056">
                  <c:v>5.2</c:v>
                </c:pt>
                <c:pt idx="1057">
                  <c:v>5.3</c:v>
                </c:pt>
                <c:pt idx="1058">
                  <c:v>5.3</c:v>
                </c:pt>
                <c:pt idx="1059">
                  <c:v>5.2</c:v>
                </c:pt>
                <c:pt idx="1060">
                  <c:v>5.2</c:v>
                </c:pt>
                <c:pt idx="1061">
                  <c:v>5.2</c:v>
                </c:pt>
                <c:pt idx="1062">
                  <c:v>5.2</c:v>
                </c:pt>
                <c:pt idx="1063">
                  <c:v>5.2</c:v>
                </c:pt>
                <c:pt idx="1064">
                  <c:v>5.2</c:v>
                </c:pt>
                <c:pt idx="1065">
                  <c:v>5.2</c:v>
                </c:pt>
                <c:pt idx="1066">
                  <c:v>5.2</c:v>
                </c:pt>
                <c:pt idx="1067">
                  <c:v>5.2</c:v>
                </c:pt>
                <c:pt idx="1068">
                  <c:v>5.2</c:v>
                </c:pt>
                <c:pt idx="1069">
                  <c:v>5.2</c:v>
                </c:pt>
                <c:pt idx="1070">
                  <c:v>5.2</c:v>
                </c:pt>
                <c:pt idx="1071">
                  <c:v>5.2</c:v>
                </c:pt>
                <c:pt idx="1072">
                  <c:v>5.2</c:v>
                </c:pt>
                <c:pt idx="1073">
                  <c:v>5.2</c:v>
                </c:pt>
                <c:pt idx="1074">
                  <c:v>5.2</c:v>
                </c:pt>
                <c:pt idx="1075">
                  <c:v>5.2</c:v>
                </c:pt>
                <c:pt idx="1076">
                  <c:v>5.2</c:v>
                </c:pt>
                <c:pt idx="1077">
                  <c:v>5.2</c:v>
                </c:pt>
                <c:pt idx="1078">
                  <c:v>5.2</c:v>
                </c:pt>
                <c:pt idx="1079">
                  <c:v>5.2</c:v>
                </c:pt>
                <c:pt idx="1080">
                  <c:v>5.2</c:v>
                </c:pt>
                <c:pt idx="1081">
                  <c:v>5.3</c:v>
                </c:pt>
                <c:pt idx="1082">
                  <c:v>5.2</c:v>
                </c:pt>
                <c:pt idx="1083">
                  <c:v>5.2</c:v>
                </c:pt>
                <c:pt idx="1084">
                  <c:v>5.2</c:v>
                </c:pt>
                <c:pt idx="1085">
                  <c:v>5.2</c:v>
                </c:pt>
                <c:pt idx="1086">
                  <c:v>5.2</c:v>
                </c:pt>
                <c:pt idx="1087">
                  <c:v>5.2</c:v>
                </c:pt>
                <c:pt idx="1088">
                  <c:v>5.2</c:v>
                </c:pt>
                <c:pt idx="1089">
                  <c:v>5.2</c:v>
                </c:pt>
                <c:pt idx="1090">
                  <c:v>5.2</c:v>
                </c:pt>
                <c:pt idx="1091">
                  <c:v>5.2</c:v>
                </c:pt>
                <c:pt idx="1092">
                  <c:v>5.2</c:v>
                </c:pt>
                <c:pt idx="1093">
                  <c:v>5.2</c:v>
                </c:pt>
                <c:pt idx="1094">
                  <c:v>5.3</c:v>
                </c:pt>
                <c:pt idx="1095">
                  <c:v>5.3</c:v>
                </c:pt>
                <c:pt idx="1096">
                  <c:v>5.2</c:v>
                </c:pt>
                <c:pt idx="1097">
                  <c:v>5.3</c:v>
                </c:pt>
                <c:pt idx="1098">
                  <c:v>5.2</c:v>
                </c:pt>
                <c:pt idx="1099">
                  <c:v>5.2</c:v>
                </c:pt>
                <c:pt idx="1100">
                  <c:v>5.2</c:v>
                </c:pt>
                <c:pt idx="1101">
                  <c:v>5.2</c:v>
                </c:pt>
                <c:pt idx="1102">
                  <c:v>5.2</c:v>
                </c:pt>
                <c:pt idx="1103">
                  <c:v>5.2</c:v>
                </c:pt>
                <c:pt idx="1104">
                  <c:v>5.2</c:v>
                </c:pt>
                <c:pt idx="1105">
                  <c:v>5.3</c:v>
                </c:pt>
                <c:pt idx="1106">
                  <c:v>5.2</c:v>
                </c:pt>
                <c:pt idx="1107">
                  <c:v>5.2</c:v>
                </c:pt>
                <c:pt idx="1108">
                  <c:v>5.2</c:v>
                </c:pt>
                <c:pt idx="1109">
                  <c:v>5.2</c:v>
                </c:pt>
                <c:pt idx="1110">
                  <c:v>5.2</c:v>
                </c:pt>
                <c:pt idx="1111">
                  <c:v>5.2</c:v>
                </c:pt>
                <c:pt idx="1112">
                  <c:v>5.2</c:v>
                </c:pt>
                <c:pt idx="1113">
                  <c:v>5.2</c:v>
                </c:pt>
                <c:pt idx="1114">
                  <c:v>5.2</c:v>
                </c:pt>
                <c:pt idx="1115">
                  <c:v>5.2</c:v>
                </c:pt>
                <c:pt idx="1116">
                  <c:v>5.3</c:v>
                </c:pt>
                <c:pt idx="1117">
                  <c:v>5.2</c:v>
                </c:pt>
                <c:pt idx="1118">
                  <c:v>5.3</c:v>
                </c:pt>
                <c:pt idx="1119">
                  <c:v>5.3</c:v>
                </c:pt>
                <c:pt idx="1120">
                  <c:v>5.3</c:v>
                </c:pt>
                <c:pt idx="1121">
                  <c:v>5.2</c:v>
                </c:pt>
                <c:pt idx="1122">
                  <c:v>5.7</c:v>
                </c:pt>
                <c:pt idx="1123">
                  <c:v>5.3</c:v>
                </c:pt>
                <c:pt idx="1124">
                  <c:v>5.2</c:v>
                </c:pt>
                <c:pt idx="1125">
                  <c:v>5.2</c:v>
                </c:pt>
                <c:pt idx="1126">
                  <c:v>5.2</c:v>
                </c:pt>
                <c:pt idx="1127">
                  <c:v>5.2</c:v>
                </c:pt>
                <c:pt idx="1128">
                  <c:v>5.2</c:v>
                </c:pt>
                <c:pt idx="1129">
                  <c:v>5.3</c:v>
                </c:pt>
                <c:pt idx="1130">
                  <c:v>5.3</c:v>
                </c:pt>
                <c:pt idx="1131">
                  <c:v>5.2</c:v>
                </c:pt>
                <c:pt idx="1132">
                  <c:v>5.2</c:v>
                </c:pt>
                <c:pt idx="1133">
                  <c:v>5.2</c:v>
                </c:pt>
                <c:pt idx="1134">
                  <c:v>5.2</c:v>
                </c:pt>
                <c:pt idx="1135">
                  <c:v>5.2</c:v>
                </c:pt>
                <c:pt idx="1136">
                  <c:v>5.2</c:v>
                </c:pt>
                <c:pt idx="1137">
                  <c:v>5.2</c:v>
                </c:pt>
                <c:pt idx="1138">
                  <c:v>5.2</c:v>
                </c:pt>
                <c:pt idx="1139">
                  <c:v>5.2</c:v>
                </c:pt>
                <c:pt idx="1140">
                  <c:v>5.2</c:v>
                </c:pt>
                <c:pt idx="1141">
                  <c:v>5.2</c:v>
                </c:pt>
                <c:pt idx="1142">
                  <c:v>5.3</c:v>
                </c:pt>
                <c:pt idx="1143">
                  <c:v>5.2</c:v>
                </c:pt>
                <c:pt idx="1144">
                  <c:v>5.2</c:v>
                </c:pt>
                <c:pt idx="1145">
                  <c:v>5.2</c:v>
                </c:pt>
                <c:pt idx="1146">
                  <c:v>5.2</c:v>
                </c:pt>
                <c:pt idx="1147">
                  <c:v>5.3</c:v>
                </c:pt>
                <c:pt idx="1148">
                  <c:v>5.3</c:v>
                </c:pt>
                <c:pt idx="1149">
                  <c:v>5.3</c:v>
                </c:pt>
                <c:pt idx="1150">
                  <c:v>5.3</c:v>
                </c:pt>
                <c:pt idx="1151">
                  <c:v>5.3</c:v>
                </c:pt>
                <c:pt idx="1152">
                  <c:v>5.2</c:v>
                </c:pt>
                <c:pt idx="1153">
                  <c:v>5.3</c:v>
                </c:pt>
                <c:pt idx="1154">
                  <c:v>5.2</c:v>
                </c:pt>
                <c:pt idx="1155">
                  <c:v>5.2</c:v>
                </c:pt>
                <c:pt idx="1156">
                  <c:v>5.2</c:v>
                </c:pt>
                <c:pt idx="1157">
                  <c:v>5.2</c:v>
                </c:pt>
                <c:pt idx="1158">
                  <c:v>5.2</c:v>
                </c:pt>
                <c:pt idx="1159">
                  <c:v>5.2</c:v>
                </c:pt>
                <c:pt idx="1160">
                  <c:v>5.2</c:v>
                </c:pt>
                <c:pt idx="1161">
                  <c:v>5.2</c:v>
                </c:pt>
                <c:pt idx="1162">
                  <c:v>5.2</c:v>
                </c:pt>
                <c:pt idx="1163">
                  <c:v>5.2</c:v>
                </c:pt>
                <c:pt idx="1164">
                  <c:v>5.2</c:v>
                </c:pt>
                <c:pt idx="1165">
                  <c:v>5.2</c:v>
                </c:pt>
                <c:pt idx="1166">
                  <c:v>5.3</c:v>
                </c:pt>
                <c:pt idx="1167">
                  <c:v>5.2</c:v>
                </c:pt>
                <c:pt idx="1168">
                  <c:v>5.2</c:v>
                </c:pt>
                <c:pt idx="1169">
                  <c:v>5.2</c:v>
                </c:pt>
                <c:pt idx="1170">
                  <c:v>5.2</c:v>
                </c:pt>
                <c:pt idx="1171">
                  <c:v>5.2</c:v>
                </c:pt>
                <c:pt idx="1172">
                  <c:v>5.2</c:v>
                </c:pt>
                <c:pt idx="1173">
                  <c:v>5.2</c:v>
                </c:pt>
                <c:pt idx="1174">
                  <c:v>5.2</c:v>
                </c:pt>
                <c:pt idx="1175">
                  <c:v>5.2</c:v>
                </c:pt>
                <c:pt idx="1176">
                  <c:v>5.2</c:v>
                </c:pt>
                <c:pt idx="1177">
                  <c:v>5.3</c:v>
                </c:pt>
                <c:pt idx="1178">
                  <c:v>5.2</c:v>
                </c:pt>
                <c:pt idx="1179">
                  <c:v>5.2</c:v>
                </c:pt>
                <c:pt idx="1180">
                  <c:v>5.2</c:v>
                </c:pt>
                <c:pt idx="1181">
                  <c:v>5.2</c:v>
                </c:pt>
                <c:pt idx="1182">
                  <c:v>5.2</c:v>
                </c:pt>
                <c:pt idx="1183">
                  <c:v>5.2</c:v>
                </c:pt>
                <c:pt idx="1184">
                  <c:v>5.2</c:v>
                </c:pt>
                <c:pt idx="1185">
                  <c:v>5.2</c:v>
                </c:pt>
                <c:pt idx="1186">
                  <c:v>5.2</c:v>
                </c:pt>
                <c:pt idx="1187">
                  <c:v>5.2</c:v>
                </c:pt>
                <c:pt idx="1188">
                  <c:v>5.2</c:v>
                </c:pt>
                <c:pt idx="1189">
                  <c:v>5.2</c:v>
                </c:pt>
                <c:pt idx="1190">
                  <c:v>5.3</c:v>
                </c:pt>
                <c:pt idx="1191">
                  <c:v>5.2</c:v>
                </c:pt>
                <c:pt idx="1192">
                  <c:v>5.2</c:v>
                </c:pt>
                <c:pt idx="1193">
                  <c:v>5.2</c:v>
                </c:pt>
                <c:pt idx="1194">
                  <c:v>5.2</c:v>
                </c:pt>
                <c:pt idx="1195">
                  <c:v>5.2</c:v>
                </c:pt>
                <c:pt idx="1196">
                  <c:v>5.2</c:v>
                </c:pt>
                <c:pt idx="1197">
                  <c:v>5.2</c:v>
                </c:pt>
                <c:pt idx="1198">
                  <c:v>5.2</c:v>
                </c:pt>
                <c:pt idx="1199">
                  <c:v>5.2</c:v>
                </c:pt>
                <c:pt idx="1200">
                  <c:v>5.2</c:v>
                </c:pt>
                <c:pt idx="1201">
                  <c:v>5.3</c:v>
                </c:pt>
                <c:pt idx="1202">
                  <c:v>5.3</c:v>
                </c:pt>
                <c:pt idx="1203">
                  <c:v>5.2</c:v>
                </c:pt>
                <c:pt idx="1204">
                  <c:v>5.2</c:v>
                </c:pt>
                <c:pt idx="1205">
                  <c:v>5.2</c:v>
                </c:pt>
                <c:pt idx="1206">
                  <c:v>5.2</c:v>
                </c:pt>
                <c:pt idx="1207">
                  <c:v>5.2</c:v>
                </c:pt>
                <c:pt idx="1208">
                  <c:v>5.2</c:v>
                </c:pt>
                <c:pt idx="1209">
                  <c:v>5.2</c:v>
                </c:pt>
                <c:pt idx="1210">
                  <c:v>5.2</c:v>
                </c:pt>
                <c:pt idx="1211">
                  <c:v>5.2</c:v>
                </c:pt>
                <c:pt idx="1212">
                  <c:v>5.2</c:v>
                </c:pt>
                <c:pt idx="1213">
                  <c:v>5.2</c:v>
                </c:pt>
                <c:pt idx="1214">
                  <c:v>5.3</c:v>
                </c:pt>
                <c:pt idx="1215">
                  <c:v>5.2</c:v>
                </c:pt>
                <c:pt idx="1216">
                  <c:v>5.2</c:v>
                </c:pt>
                <c:pt idx="1217">
                  <c:v>5.2</c:v>
                </c:pt>
                <c:pt idx="1218">
                  <c:v>5.2</c:v>
                </c:pt>
                <c:pt idx="1219">
                  <c:v>5.2</c:v>
                </c:pt>
                <c:pt idx="1220">
                  <c:v>5.2</c:v>
                </c:pt>
                <c:pt idx="1221">
                  <c:v>5.2</c:v>
                </c:pt>
                <c:pt idx="1222">
                  <c:v>5.2</c:v>
                </c:pt>
                <c:pt idx="1223">
                  <c:v>5.2</c:v>
                </c:pt>
                <c:pt idx="1224">
                  <c:v>5.2</c:v>
                </c:pt>
                <c:pt idx="1225">
                  <c:v>5.3</c:v>
                </c:pt>
                <c:pt idx="1226">
                  <c:v>5.2</c:v>
                </c:pt>
                <c:pt idx="1227">
                  <c:v>5.2</c:v>
                </c:pt>
                <c:pt idx="1228">
                  <c:v>5.2</c:v>
                </c:pt>
                <c:pt idx="1229">
                  <c:v>5.2</c:v>
                </c:pt>
                <c:pt idx="1230">
                  <c:v>5.2</c:v>
                </c:pt>
                <c:pt idx="1231">
                  <c:v>5.2</c:v>
                </c:pt>
                <c:pt idx="1232">
                  <c:v>5.2</c:v>
                </c:pt>
                <c:pt idx="1233">
                  <c:v>5.2</c:v>
                </c:pt>
                <c:pt idx="1234">
                  <c:v>5.2</c:v>
                </c:pt>
                <c:pt idx="1235">
                  <c:v>5.2</c:v>
                </c:pt>
                <c:pt idx="1236">
                  <c:v>5.2</c:v>
                </c:pt>
                <c:pt idx="1237">
                  <c:v>5.2</c:v>
                </c:pt>
                <c:pt idx="1238">
                  <c:v>5.3</c:v>
                </c:pt>
                <c:pt idx="1239">
                  <c:v>5.2</c:v>
                </c:pt>
                <c:pt idx="1240">
                  <c:v>5.2</c:v>
                </c:pt>
                <c:pt idx="1241">
                  <c:v>5.2</c:v>
                </c:pt>
                <c:pt idx="1242">
                  <c:v>5.2</c:v>
                </c:pt>
                <c:pt idx="1243">
                  <c:v>5.2</c:v>
                </c:pt>
                <c:pt idx="1244">
                  <c:v>5.2</c:v>
                </c:pt>
                <c:pt idx="1245">
                  <c:v>5.2</c:v>
                </c:pt>
                <c:pt idx="1246">
                  <c:v>5.2</c:v>
                </c:pt>
                <c:pt idx="1247">
                  <c:v>5.2</c:v>
                </c:pt>
                <c:pt idx="1248">
                  <c:v>5.2</c:v>
                </c:pt>
                <c:pt idx="1249">
                  <c:v>5.3</c:v>
                </c:pt>
                <c:pt idx="1250">
                  <c:v>5.2</c:v>
                </c:pt>
                <c:pt idx="1251">
                  <c:v>5.2</c:v>
                </c:pt>
                <c:pt idx="1252">
                  <c:v>5.2</c:v>
                </c:pt>
                <c:pt idx="1253">
                  <c:v>5.2</c:v>
                </c:pt>
                <c:pt idx="1254">
                  <c:v>5.2</c:v>
                </c:pt>
                <c:pt idx="1255">
                  <c:v>5.2</c:v>
                </c:pt>
                <c:pt idx="1256">
                  <c:v>5.2</c:v>
                </c:pt>
                <c:pt idx="1257">
                  <c:v>5.2</c:v>
                </c:pt>
                <c:pt idx="1258">
                  <c:v>5.2</c:v>
                </c:pt>
                <c:pt idx="1259">
                  <c:v>5.2</c:v>
                </c:pt>
                <c:pt idx="1260">
                  <c:v>5.2</c:v>
                </c:pt>
                <c:pt idx="1261">
                  <c:v>5.2</c:v>
                </c:pt>
                <c:pt idx="1262">
                  <c:v>5.3</c:v>
                </c:pt>
                <c:pt idx="1263">
                  <c:v>5.2</c:v>
                </c:pt>
                <c:pt idx="1264">
                  <c:v>5.2</c:v>
                </c:pt>
                <c:pt idx="1265">
                  <c:v>5.2</c:v>
                </c:pt>
                <c:pt idx="1266">
                  <c:v>5.2</c:v>
                </c:pt>
                <c:pt idx="1267">
                  <c:v>5.2</c:v>
                </c:pt>
                <c:pt idx="1268">
                  <c:v>5.2</c:v>
                </c:pt>
                <c:pt idx="1269">
                  <c:v>5.2</c:v>
                </c:pt>
                <c:pt idx="1270">
                  <c:v>5.2</c:v>
                </c:pt>
                <c:pt idx="1271">
                  <c:v>5.2</c:v>
                </c:pt>
                <c:pt idx="1272">
                  <c:v>5.2</c:v>
                </c:pt>
                <c:pt idx="1273">
                  <c:v>5.3</c:v>
                </c:pt>
                <c:pt idx="1274">
                  <c:v>5.2</c:v>
                </c:pt>
                <c:pt idx="1275">
                  <c:v>5.2</c:v>
                </c:pt>
                <c:pt idx="1276">
                  <c:v>5.2</c:v>
                </c:pt>
                <c:pt idx="1277">
                  <c:v>5.2</c:v>
                </c:pt>
                <c:pt idx="1278">
                  <c:v>5.2</c:v>
                </c:pt>
                <c:pt idx="1279">
                  <c:v>5.2</c:v>
                </c:pt>
                <c:pt idx="1280">
                  <c:v>5.2</c:v>
                </c:pt>
                <c:pt idx="1281">
                  <c:v>5.2</c:v>
                </c:pt>
                <c:pt idx="1282">
                  <c:v>5.2</c:v>
                </c:pt>
                <c:pt idx="1283">
                  <c:v>5.2</c:v>
                </c:pt>
                <c:pt idx="1284">
                  <c:v>5.2</c:v>
                </c:pt>
                <c:pt idx="1285">
                  <c:v>5.2</c:v>
                </c:pt>
                <c:pt idx="1286">
                  <c:v>5.3</c:v>
                </c:pt>
                <c:pt idx="1287">
                  <c:v>5.3</c:v>
                </c:pt>
                <c:pt idx="1288">
                  <c:v>5.2</c:v>
                </c:pt>
                <c:pt idx="1289">
                  <c:v>5.2</c:v>
                </c:pt>
                <c:pt idx="1290">
                  <c:v>5.2</c:v>
                </c:pt>
                <c:pt idx="1291">
                  <c:v>5.2</c:v>
                </c:pt>
                <c:pt idx="1292">
                  <c:v>5.2</c:v>
                </c:pt>
                <c:pt idx="1293">
                  <c:v>5.2</c:v>
                </c:pt>
                <c:pt idx="1294">
                  <c:v>5.2</c:v>
                </c:pt>
                <c:pt idx="1295">
                  <c:v>5.2</c:v>
                </c:pt>
                <c:pt idx="1296">
                  <c:v>5.2</c:v>
                </c:pt>
                <c:pt idx="1297">
                  <c:v>5.3</c:v>
                </c:pt>
                <c:pt idx="1298">
                  <c:v>5.2</c:v>
                </c:pt>
                <c:pt idx="1299">
                  <c:v>5.2</c:v>
                </c:pt>
                <c:pt idx="1300">
                  <c:v>5.2</c:v>
                </c:pt>
                <c:pt idx="1301">
                  <c:v>5.2</c:v>
                </c:pt>
                <c:pt idx="1302">
                  <c:v>5.2</c:v>
                </c:pt>
                <c:pt idx="1303">
                  <c:v>5.2</c:v>
                </c:pt>
                <c:pt idx="1304">
                  <c:v>5.2</c:v>
                </c:pt>
                <c:pt idx="1305">
                  <c:v>5.2</c:v>
                </c:pt>
                <c:pt idx="1306">
                  <c:v>5.2</c:v>
                </c:pt>
                <c:pt idx="1307">
                  <c:v>5.2</c:v>
                </c:pt>
                <c:pt idx="1308">
                  <c:v>5.2</c:v>
                </c:pt>
                <c:pt idx="1309">
                  <c:v>5.3</c:v>
                </c:pt>
                <c:pt idx="1310">
                  <c:v>5.3</c:v>
                </c:pt>
                <c:pt idx="1311">
                  <c:v>5.3</c:v>
                </c:pt>
                <c:pt idx="1312">
                  <c:v>5.3</c:v>
                </c:pt>
                <c:pt idx="1313">
                  <c:v>5.3</c:v>
                </c:pt>
                <c:pt idx="1314">
                  <c:v>5.3</c:v>
                </c:pt>
                <c:pt idx="1315">
                  <c:v>5.3</c:v>
                </c:pt>
                <c:pt idx="1316">
                  <c:v>5.3</c:v>
                </c:pt>
                <c:pt idx="1317">
                  <c:v>5.2</c:v>
                </c:pt>
                <c:pt idx="1318">
                  <c:v>5.3</c:v>
                </c:pt>
                <c:pt idx="1319">
                  <c:v>5.2</c:v>
                </c:pt>
                <c:pt idx="1320">
                  <c:v>5.2</c:v>
                </c:pt>
                <c:pt idx="1321">
                  <c:v>5.3</c:v>
                </c:pt>
                <c:pt idx="1322">
                  <c:v>5.2</c:v>
                </c:pt>
                <c:pt idx="1323">
                  <c:v>5.2</c:v>
                </c:pt>
                <c:pt idx="1324">
                  <c:v>5.2</c:v>
                </c:pt>
                <c:pt idx="1325">
                  <c:v>5.2</c:v>
                </c:pt>
                <c:pt idx="1326">
                  <c:v>5.2</c:v>
                </c:pt>
                <c:pt idx="1327">
                  <c:v>5.2</c:v>
                </c:pt>
                <c:pt idx="1328">
                  <c:v>5.2</c:v>
                </c:pt>
                <c:pt idx="1329">
                  <c:v>5.2</c:v>
                </c:pt>
                <c:pt idx="1330">
                  <c:v>5.2</c:v>
                </c:pt>
                <c:pt idx="1331">
                  <c:v>5.2</c:v>
                </c:pt>
                <c:pt idx="1332">
                  <c:v>5.2</c:v>
                </c:pt>
                <c:pt idx="1333">
                  <c:v>5.3</c:v>
                </c:pt>
                <c:pt idx="1334">
                  <c:v>5.4</c:v>
                </c:pt>
                <c:pt idx="1335">
                  <c:v>5.4</c:v>
                </c:pt>
                <c:pt idx="1336">
                  <c:v>5.4</c:v>
                </c:pt>
                <c:pt idx="1337">
                  <c:v>9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AB2-40A4-919E-6D451ADE32B5}"/>
            </c:ext>
          </c:extLst>
        </c:ser>
        <c:ser>
          <c:idx val="3"/>
          <c:order val="1"/>
          <c:tx>
            <c:strRef>
              <c:f>Tabelle1!$I$10</c:f>
              <c:strCache>
                <c:ptCount val="1"/>
                <c:pt idx="0">
                  <c:v>Relative Humidity [%]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2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</c:spPr>
          </c:marker>
          <c:xVal>
            <c:numRef>
              <c:f>Tabelle1!$C$13:$C$1350</c:f>
              <c:numCache>
                <c:formatCode>0.00000000000000000</c:formatCode>
                <c:ptCount val="1338"/>
                <c:pt idx="0">
                  <c:v>5.9523809523809521E-3</c:v>
                </c:pt>
                <c:pt idx="1">
                  <c:v>1.1904761904761904E-2</c:v>
                </c:pt>
                <c:pt idx="2">
                  <c:v>1.7857142857142856E-2</c:v>
                </c:pt>
                <c:pt idx="3">
                  <c:v>2.3809523809523808E-2</c:v>
                </c:pt>
                <c:pt idx="4">
                  <c:v>2.976190476190476E-2</c:v>
                </c:pt>
                <c:pt idx="5">
                  <c:v>3.5714285714285712E-2</c:v>
                </c:pt>
                <c:pt idx="6">
                  <c:v>4.1666666666666664E-2</c:v>
                </c:pt>
                <c:pt idx="7">
                  <c:v>4.7619047619047616E-2</c:v>
                </c:pt>
                <c:pt idx="8">
                  <c:v>5.3571428571428568E-2</c:v>
                </c:pt>
                <c:pt idx="9">
                  <c:v>5.9523809523809521E-2</c:v>
                </c:pt>
                <c:pt idx="10">
                  <c:v>6.5476190476190479E-2</c:v>
                </c:pt>
                <c:pt idx="11">
                  <c:v>7.1428571428571425E-2</c:v>
                </c:pt>
                <c:pt idx="12">
                  <c:v>7.7380952380952384E-2</c:v>
                </c:pt>
                <c:pt idx="13">
                  <c:v>8.3333333333333329E-2</c:v>
                </c:pt>
                <c:pt idx="14">
                  <c:v>8.9285714285714288E-2</c:v>
                </c:pt>
                <c:pt idx="15">
                  <c:v>9.5238095238095233E-2</c:v>
                </c:pt>
                <c:pt idx="16">
                  <c:v>0.10119047619047619</c:v>
                </c:pt>
                <c:pt idx="17">
                  <c:v>0.10714285714285714</c:v>
                </c:pt>
                <c:pt idx="18">
                  <c:v>0.1130952380952381</c:v>
                </c:pt>
                <c:pt idx="19">
                  <c:v>0.11904761904761904</c:v>
                </c:pt>
                <c:pt idx="20">
                  <c:v>0.125</c:v>
                </c:pt>
                <c:pt idx="21">
                  <c:v>0.13095238095238096</c:v>
                </c:pt>
                <c:pt idx="22">
                  <c:v>0.13690476190476192</c:v>
                </c:pt>
                <c:pt idx="23">
                  <c:v>0.14285714285714285</c:v>
                </c:pt>
                <c:pt idx="24">
                  <c:v>0.14880952380952381</c:v>
                </c:pt>
                <c:pt idx="25">
                  <c:v>0.15476190476190477</c:v>
                </c:pt>
                <c:pt idx="26">
                  <c:v>0.16071428571428573</c:v>
                </c:pt>
                <c:pt idx="27">
                  <c:v>0.16666666666666666</c:v>
                </c:pt>
                <c:pt idx="28">
                  <c:v>0.17261904761904762</c:v>
                </c:pt>
                <c:pt idx="29">
                  <c:v>0.17857142857142858</c:v>
                </c:pt>
                <c:pt idx="30">
                  <c:v>0.18452380952380953</c:v>
                </c:pt>
                <c:pt idx="31">
                  <c:v>0.19047619047619047</c:v>
                </c:pt>
                <c:pt idx="32">
                  <c:v>0.19642857142857142</c:v>
                </c:pt>
                <c:pt idx="33">
                  <c:v>0.20238095238095238</c:v>
                </c:pt>
                <c:pt idx="34">
                  <c:v>0.20833333333333334</c:v>
                </c:pt>
                <c:pt idx="35">
                  <c:v>0.21428571428571427</c:v>
                </c:pt>
                <c:pt idx="36">
                  <c:v>0.22023809523809523</c:v>
                </c:pt>
                <c:pt idx="37">
                  <c:v>0.22619047619047619</c:v>
                </c:pt>
                <c:pt idx="38">
                  <c:v>0.23214285714285715</c:v>
                </c:pt>
                <c:pt idx="39">
                  <c:v>0.23809523809523808</c:v>
                </c:pt>
                <c:pt idx="40">
                  <c:v>0.24404761904761904</c:v>
                </c:pt>
                <c:pt idx="41">
                  <c:v>0.25</c:v>
                </c:pt>
                <c:pt idx="42">
                  <c:v>0.25595238095238093</c:v>
                </c:pt>
                <c:pt idx="43">
                  <c:v>0.26190476190476192</c:v>
                </c:pt>
                <c:pt idx="44">
                  <c:v>0.26785714285714285</c:v>
                </c:pt>
                <c:pt idx="45">
                  <c:v>0.27380952380952384</c:v>
                </c:pt>
                <c:pt idx="46">
                  <c:v>0.27976190476190477</c:v>
                </c:pt>
                <c:pt idx="47">
                  <c:v>0.2857142857142857</c:v>
                </c:pt>
                <c:pt idx="48">
                  <c:v>0.29166666666666669</c:v>
                </c:pt>
                <c:pt idx="49">
                  <c:v>0.29761904761904762</c:v>
                </c:pt>
                <c:pt idx="50">
                  <c:v>0.30357142857142855</c:v>
                </c:pt>
                <c:pt idx="51">
                  <c:v>0.30952380952380953</c:v>
                </c:pt>
                <c:pt idx="52">
                  <c:v>0.31547619047619047</c:v>
                </c:pt>
                <c:pt idx="53">
                  <c:v>0.32142857142857145</c:v>
                </c:pt>
                <c:pt idx="54">
                  <c:v>0.32738095238095238</c:v>
                </c:pt>
                <c:pt idx="55">
                  <c:v>0.33333333333333331</c:v>
                </c:pt>
                <c:pt idx="56">
                  <c:v>0.3392857142857143</c:v>
                </c:pt>
                <c:pt idx="57">
                  <c:v>0.34523809523809523</c:v>
                </c:pt>
                <c:pt idx="58">
                  <c:v>0.35119047619047616</c:v>
                </c:pt>
                <c:pt idx="59">
                  <c:v>0.35714285714285715</c:v>
                </c:pt>
                <c:pt idx="60">
                  <c:v>0.36309523809523808</c:v>
                </c:pt>
                <c:pt idx="61">
                  <c:v>0.36904761904761907</c:v>
                </c:pt>
                <c:pt idx="62">
                  <c:v>0.375</c:v>
                </c:pt>
                <c:pt idx="63">
                  <c:v>0.38095238095238093</c:v>
                </c:pt>
                <c:pt idx="64">
                  <c:v>0.38690476190476192</c:v>
                </c:pt>
                <c:pt idx="65">
                  <c:v>0.39285714285714285</c:v>
                </c:pt>
                <c:pt idx="66">
                  <c:v>0.39880952380952384</c:v>
                </c:pt>
                <c:pt idx="67">
                  <c:v>0.40476190476190477</c:v>
                </c:pt>
                <c:pt idx="68">
                  <c:v>0.4107142857142857</c:v>
                </c:pt>
                <c:pt idx="69">
                  <c:v>0.41666666666666669</c:v>
                </c:pt>
                <c:pt idx="70">
                  <c:v>0.42261904761904762</c:v>
                </c:pt>
                <c:pt idx="71">
                  <c:v>0.42857142857142855</c:v>
                </c:pt>
                <c:pt idx="72">
                  <c:v>0.43452380952380953</c:v>
                </c:pt>
                <c:pt idx="73">
                  <c:v>0.44047619047619047</c:v>
                </c:pt>
                <c:pt idx="74">
                  <c:v>0.44642857142857145</c:v>
                </c:pt>
                <c:pt idx="75">
                  <c:v>0.45238095238095238</c:v>
                </c:pt>
                <c:pt idx="76">
                  <c:v>0.45833333333333331</c:v>
                </c:pt>
                <c:pt idx="77">
                  <c:v>0.4642857142857143</c:v>
                </c:pt>
                <c:pt idx="78">
                  <c:v>0.47023809523809523</c:v>
                </c:pt>
                <c:pt idx="79">
                  <c:v>0.47619047619047616</c:v>
                </c:pt>
                <c:pt idx="80">
                  <c:v>0.48214285714285715</c:v>
                </c:pt>
                <c:pt idx="81">
                  <c:v>0.48809523809523808</c:v>
                </c:pt>
                <c:pt idx="82">
                  <c:v>0.49404761904761907</c:v>
                </c:pt>
                <c:pt idx="83">
                  <c:v>0.5</c:v>
                </c:pt>
                <c:pt idx="84">
                  <c:v>0.50595238095238093</c:v>
                </c:pt>
                <c:pt idx="85">
                  <c:v>0.51190476190476186</c:v>
                </c:pt>
                <c:pt idx="86">
                  <c:v>0.5178571428571429</c:v>
                </c:pt>
                <c:pt idx="87">
                  <c:v>0.52380952380952384</c:v>
                </c:pt>
                <c:pt idx="88">
                  <c:v>0.52976190476190477</c:v>
                </c:pt>
                <c:pt idx="89">
                  <c:v>0.5357142857142857</c:v>
                </c:pt>
                <c:pt idx="90">
                  <c:v>0.54166666666666663</c:v>
                </c:pt>
                <c:pt idx="91">
                  <c:v>0.54761904761904767</c:v>
                </c:pt>
                <c:pt idx="92">
                  <c:v>0.5535714285714286</c:v>
                </c:pt>
                <c:pt idx="93">
                  <c:v>0.55952380952380953</c:v>
                </c:pt>
                <c:pt idx="94">
                  <c:v>0.56547619047619047</c:v>
                </c:pt>
                <c:pt idx="95">
                  <c:v>0.5714285714285714</c:v>
                </c:pt>
                <c:pt idx="96">
                  <c:v>0.57738095238095233</c:v>
                </c:pt>
                <c:pt idx="97">
                  <c:v>0.58333333333333337</c:v>
                </c:pt>
                <c:pt idx="98">
                  <c:v>0.5892857142857143</c:v>
                </c:pt>
                <c:pt idx="99">
                  <c:v>0.59523809523809523</c:v>
                </c:pt>
                <c:pt idx="100">
                  <c:v>0.60119047619047616</c:v>
                </c:pt>
                <c:pt idx="101">
                  <c:v>0.6071428571428571</c:v>
                </c:pt>
                <c:pt idx="102">
                  <c:v>0.61309523809523814</c:v>
                </c:pt>
                <c:pt idx="103">
                  <c:v>0.61904761904761907</c:v>
                </c:pt>
                <c:pt idx="104">
                  <c:v>0.625</c:v>
                </c:pt>
                <c:pt idx="105">
                  <c:v>0.63095238095238093</c:v>
                </c:pt>
                <c:pt idx="106">
                  <c:v>0.63690476190476186</c:v>
                </c:pt>
                <c:pt idx="107">
                  <c:v>0.6428571428571429</c:v>
                </c:pt>
                <c:pt idx="108">
                  <c:v>0.64880952380952384</c:v>
                </c:pt>
                <c:pt idx="109">
                  <c:v>0.65476190476190477</c:v>
                </c:pt>
                <c:pt idx="110">
                  <c:v>0.6607142857142857</c:v>
                </c:pt>
                <c:pt idx="111">
                  <c:v>0.66666666666666663</c:v>
                </c:pt>
                <c:pt idx="112">
                  <c:v>0.67261904761904767</c:v>
                </c:pt>
                <c:pt idx="113">
                  <c:v>0.6785714285714286</c:v>
                </c:pt>
                <c:pt idx="114">
                  <c:v>0.68452380952380953</c:v>
                </c:pt>
                <c:pt idx="115">
                  <c:v>0.69047619047619047</c:v>
                </c:pt>
                <c:pt idx="116">
                  <c:v>0.6964285714285714</c:v>
                </c:pt>
                <c:pt idx="117">
                  <c:v>0.70238095238095233</c:v>
                </c:pt>
                <c:pt idx="118">
                  <c:v>0.70833333333333337</c:v>
                </c:pt>
                <c:pt idx="119">
                  <c:v>0.7142857142857143</c:v>
                </c:pt>
                <c:pt idx="120">
                  <c:v>0.72023809523809523</c:v>
                </c:pt>
                <c:pt idx="121">
                  <c:v>0.72619047619047616</c:v>
                </c:pt>
                <c:pt idx="122">
                  <c:v>0.7321428571428571</c:v>
                </c:pt>
                <c:pt idx="123">
                  <c:v>0.73809523809523814</c:v>
                </c:pt>
                <c:pt idx="124">
                  <c:v>0.74404761904761907</c:v>
                </c:pt>
                <c:pt idx="125">
                  <c:v>0.75</c:v>
                </c:pt>
                <c:pt idx="126">
                  <c:v>0.75595238095238093</c:v>
                </c:pt>
                <c:pt idx="127">
                  <c:v>0.76190476190476186</c:v>
                </c:pt>
                <c:pt idx="128">
                  <c:v>0.7678571428571429</c:v>
                </c:pt>
                <c:pt idx="129">
                  <c:v>0.77380952380952384</c:v>
                </c:pt>
                <c:pt idx="130">
                  <c:v>0.77976190476190477</c:v>
                </c:pt>
                <c:pt idx="131">
                  <c:v>0.7857142857142857</c:v>
                </c:pt>
                <c:pt idx="132">
                  <c:v>0.79166666666666663</c:v>
                </c:pt>
                <c:pt idx="133">
                  <c:v>0.79761904761904767</c:v>
                </c:pt>
                <c:pt idx="134">
                  <c:v>0.8035714285714286</c:v>
                </c:pt>
                <c:pt idx="135">
                  <c:v>0.80952380952380953</c:v>
                </c:pt>
                <c:pt idx="136">
                  <c:v>0.81547619047619047</c:v>
                </c:pt>
                <c:pt idx="137">
                  <c:v>0.8214285714285714</c:v>
                </c:pt>
                <c:pt idx="138">
                  <c:v>0.82738095238095233</c:v>
                </c:pt>
                <c:pt idx="139">
                  <c:v>0.83333333333333337</c:v>
                </c:pt>
                <c:pt idx="140">
                  <c:v>0.8392857142857143</c:v>
                </c:pt>
                <c:pt idx="141">
                  <c:v>0.84523809523809523</c:v>
                </c:pt>
                <c:pt idx="142">
                  <c:v>0.85119047619047616</c:v>
                </c:pt>
                <c:pt idx="143">
                  <c:v>0.8571428571428571</c:v>
                </c:pt>
                <c:pt idx="144">
                  <c:v>0.86309523809523814</c:v>
                </c:pt>
                <c:pt idx="145">
                  <c:v>0.86904761904761907</c:v>
                </c:pt>
                <c:pt idx="146">
                  <c:v>0.875</c:v>
                </c:pt>
                <c:pt idx="147">
                  <c:v>0.88095238095238093</c:v>
                </c:pt>
                <c:pt idx="148">
                  <c:v>0.88690476190476186</c:v>
                </c:pt>
                <c:pt idx="149">
                  <c:v>0.8928571428571429</c:v>
                </c:pt>
                <c:pt idx="150">
                  <c:v>0.89880952380952384</c:v>
                </c:pt>
                <c:pt idx="151">
                  <c:v>0.90476190476190477</c:v>
                </c:pt>
                <c:pt idx="152">
                  <c:v>0.9107142857142857</c:v>
                </c:pt>
                <c:pt idx="153">
                  <c:v>0.91666666666666663</c:v>
                </c:pt>
                <c:pt idx="154">
                  <c:v>0.92261904761904767</c:v>
                </c:pt>
                <c:pt idx="155">
                  <c:v>0.9285714285714286</c:v>
                </c:pt>
                <c:pt idx="156">
                  <c:v>0.93452380952380953</c:v>
                </c:pt>
                <c:pt idx="157">
                  <c:v>0.94047619047619047</c:v>
                </c:pt>
                <c:pt idx="158">
                  <c:v>0.9464285714285714</c:v>
                </c:pt>
                <c:pt idx="159">
                  <c:v>0.95238095238095233</c:v>
                </c:pt>
                <c:pt idx="160">
                  <c:v>0.95833333333333337</c:v>
                </c:pt>
                <c:pt idx="161">
                  <c:v>0.9642857142857143</c:v>
                </c:pt>
                <c:pt idx="162">
                  <c:v>0.97023809523809523</c:v>
                </c:pt>
                <c:pt idx="163">
                  <c:v>0.97619047619047616</c:v>
                </c:pt>
                <c:pt idx="164">
                  <c:v>0.9821428571428571</c:v>
                </c:pt>
                <c:pt idx="165">
                  <c:v>0.98809523809523814</c:v>
                </c:pt>
                <c:pt idx="166">
                  <c:v>0.99404761904761907</c:v>
                </c:pt>
                <c:pt idx="167">
                  <c:v>1</c:v>
                </c:pt>
                <c:pt idx="168">
                  <c:v>1.0059523809523809</c:v>
                </c:pt>
                <c:pt idx="169">
                  <c:v>1.0119047619047619</c:v>
                </c:pt>
                <c:pt idx="170">
                  <c:v>1.0178571428571428</c:v>
                </c:pt>
                <c:pt idx="171">
                  <c:v>1.0238095238095237</c:v>
                </c:pt>
                <c:pt idx="172">
                  <c:v>1.0297619047619047</c:v>
                </c:pt>
                <c:pt idx="173">
                  <c:v>1.0357142857142858</c:v>
                </c:pt>
                <c:pt idx="174">
                  <c:v>1.0416666666666667</c:v>
                </c:pt>
                <c:pt idx="175">
                  <c:v>1.0476190476190477</c:v>
                </c:pt>
                <c:pt idx="176">
                  <c:v>1.0535714285714286</c:v>
                </c:pt>
                <c:pt idx="177">
                  <c:v>1.0595238095238095</c:v>
                </c:pt>
                <c:pt idx="178">
                  <c:v>1.0654761904761905</c:v>
                </c:pt>
                <c:pt idx="179">
                  <c:v>1.0714285714285714</c:v>
                </c:pt>
                <c:pt idx="180">
                  <c:v>1.0773809523809523</c:v>
                </c:pt>
                <c:pt idx="181">
                  <c:v>1.0833333333333333</c:v>
                </c:pt>
                <c:pt idx="182">
                  <c:v>1.0892857142857142</c:v>
                </c:pt>
                <c:pt idx="183">
                  <c:v>1.0952380952380953</c:v>
                </c:pt>
                <c:pt idx="184">
                  <c:v>1.1011904761904763</c:v>
                </c:pt>
                <c:pt idx="185">
                  <c:v>1.1071428571428572</c:v>
                </c:pt>
                <c:pt idx="186">
                  <c:v>1.1130952380952381</c:v>
                </c:pt>
                <c:pt idx="187">
                  <c:v>1.1190476190476191</c:v>
                </c:pt>
                <c:pt idx="188">
                  <c:v>1.125</c:v>
                </c:pt>
                <c:pt idx="189">
                  <c:v>1.1309523809523809</c:v>
                </c:pt>
                <c:pt idx="190">
                  <c:v>1.1369047619047619</c:v>
                </c:pt>
                <c:pt idx="191">
                  <c:v>1.1428571428571428</c:v>
                </c:pt>
                <c:pt idx="192">
                  <c:v>1.1488095238095237</c:v>
                </c:pt>
                <c:pt idx="193">
                  <c:v>1.1547619047619047</c:v>
                </c:pt>
                <c:pt idx="194">
                  <c:v>1.1607142857142858</c:v>
                </c:pt>
                <c:pt idx="195">
                  <c:v>1.1666666666666667</c:v>
                </c:pt>
                <c:pt idx="196">
                  <c:v>1.1726190476190477</c:v>
                </c:pt>
                <c:pt idx="197">
                  <c:v>1.1785714285714286</c:v>
                </c:pt>
                <c:pt idx="198">
                  <c:v>1.1845238095238095</c:v>
                </c:pt>
                <c:pt idx="199">
                  <c:v>1.1904761904761905</c:v>
                </c:pt>
                <c:pt idx="200">
                  <c:v>1.1964285714285714</c:v>
                </c:pt>
                <c:pt idx="201">
                  <c:v>1.2023809523809523</c:v>
                </c:pt>
                <c:pt idx="202">
                  <c:v>1.2083333333333333</c:v>
                </c:pt>
                <c:pt idx="203">
                  <c:v>1.2142857142857142</c:v>
                </c:pt>
                <c:pt idx="204">
                  <c:v>1.2202380952380953</c:v>
                </c:pt>
                <c:pt idx="205">
                  <c:v>1.2261904761904763</c:v>
                </c:pt>
                <c:pt idx="206">
                  <c:v>1.2321428571428572</c:v>
                </c:pt>
                <c:pt idx="207">
                  <c:v>1.2380952380952381</c:v>
                </c:pt>
                <c:pt idx="208">
                  <c:v>1.2440476190476191</c:v>
                </c:pt>
                <c:pt idx="209">
                  <c:v>1.25</c:v>
                </c:pt>
                <c:pt idx="210">
                  <c:v>1.2559523809523809</c:v>
                </c:pt>
                <c:pt idx="211">
                  <c:v>1.2619047619047619</c:v>
                </c:pt>
                <c:pt idx="212">
                  <c:v>1.2678571428571428</c:v>
                </c:pt>
                <c:pt idx="213">
                  <c:v>1.2738095238095237</c:v>
                </c:pt>
                <c:pt idx="214">
                  <c:v>1.2797619047619047</c:v>
                </c:pt>
                <c:pt idx="215">
                  <c:v>1.2857142857142858</c:v>
                </c:pt>
                <c:pt idx="216">
                  <c:v>1.2916666666666667</c:v>
                </c:pt>
                <c:pt idx="217">
                  <c:v>1.2976190476190477</c:v>
                </c:pt>
                <c:pt idx="218">
                  <c:v>1.3035714285714286</c:v>
                </c:pt>
                <c:pt idx="219">
                  <c:v>1.3095238095238095</c:v>
                </c:pt>
                <c:pt idx="220">
                  <c:v>1.3154761904761905</c:v>
                </c:pt>
                <c:pt idx="221">
                  <c:v>1.3214285714285714</c:v>
                </c:pt>
                <c:pt idx="222">
                  <c:v>1.3273809523809523</c:v>
                </c:pt>
                <c:pt idx="223">
                  <c:v>1.3333333333333333</c:v>
                </c:pt>
                <c:pt idx="224">
                  <c:v>1.3392857142857142</c:v>
                </c:pt>
                <c:pt idx="225">
                  <c:v>1.3452380952380953</c:v>
                </c:pt>
                <c:pt idx="226">
                  <c:v>1.3511904761904763</c:v>
                </c:pt>
                <c:pt idx="227">
                  <c:v>1.3571428571428572</c:v>
                </c:pt>
                <c:pt idx="228">
                  <c:v>1.3630952380952381</c:v>
                </c:pt>
                <c:pt idx="229">
                  <c:v>1.3690476190476191</c:v>
                </c:pt>
                <c:pt idx="230">
                  <c:v>1.375</c:v>
                </c:pt>
                <c:pt idx="231">
                  <c:v>1.3809523809523809</c:v>
                </c:pt>
                <c:pt idx="232">
                  <c:v>1.3869047619047619</c:v>
                </c:pt>
                <c:pt idx="233">
                  <c:v>1.3928571428571428</c:v>
                </c:pt>
                <c:pt idx="234">
                  <c:v>1.3988095238095237</c:v>
                </c:pt>
                <c:pt idx="235">
                  <c:v>1.4047619047619047</c:v>
                </c:pt>
                <c:pt idx="236">
                  <c:v>1.4107142857142858</c:v>
                </c:pt>
                <c:pt idx="237">
                  <c:v>1.4166666666666667</c:v>
                </c:pt>
                <c:pt idx="238">
                  <c:v>1.4226190476190477</c:v>
                </c:pt>
                <c:pt idx="239">
                  <c:v>1.4285714285714286</c:v>
                </c:pt>
                <c:pt idx="240">
                  <c:v>1.4345238095238095</c:v>
                </c:pt>
                <c:pt idx="241">
                  <c:v>1.4404761904761905</c:v>
                </c:pt>
                <c:pt idx="242">
                  <c:v>1.4464285714285714</c:v>
                </c:pt>
                <c:pt idx="243">
                  <c:v>1.4523809523809523</c:v>
                </c:pt>
                <c:pt idx="244">
                  <c:v>1.4583333333333333</c:v>
                </c:pt>
                <c:pt idx="245">
                  <c:v>1.4642857142857142</c:v>
                </c:pt>
                <c:pt idx="246">
                  <c:v>1.4702380952380953</c:v>
                </c:pt>
                <c:pt idx="247">
                  <c:v>1.4761904761904763</c:v>
                </c:pt>
                <c:pt idx="248">
                  <c:v>1.4821428571428572</c:v>
                </c:pt>
                <c:pt idx="249">
                  <c:v>1.4880952380952381</c:v>
                </c:pt>
                <c:pt idx="250">
                  <c:v>1.4940476190476191</c:v>
                </c:pt>
                <c:pt idx="251">
                  <c:v>1.5</c:v>
                </c:pt>
                <c:pt idx="252">
                  <c:v>1.5059523809523809</c:v>
                </c:pt>
                <c:pt idx="253">
                  <c:v>1.5119047619047619</c:v>
                </c:pt>
                <c:pt idx="254">
                  <c:v>1.5178571428571428</c:v>
                </c:pt>
                <c:pt idx="255">
                  <c:v>1.5238095238095237</c:v>
                </c:pt>
                <c:pt idx="256">
                  <c:v>1.5297619047619047</c:v>
                </c:pt>
                <c:pt idx="257">
                  <c:v>1.5357142857142858</c:v>
                </c:pt>
                <c:pt idx="258">
                  <c:v>1.5416666666666667</c:v>
                </c:pt>
                <c:pt idx="259">
                  <c:v>1.5476190476190477</c:v>
                </c:pt>
                <c:pt idx="260">
                  <c:v>1.5535714285714286</c:v>
                </c:pt>
                <c:pt idx="261">
                  <c:v>1.5595238095238095</c:v>
                </c:pt>
                <c:pt idx="262">
                  <c:v>1.5654761904761905</c:v>
                </c:pt>
                <c:pt idx="263">
                  <c:v>1.5714285714285714</c:v>
                </c:pt>
                <c:pt idx="264">
                  <c:v>1.5773809523809523</c:v>
                </c:pt>
                <c:pt idx="265">
                  <c:v>1.5833333333333333</c:v>
                </c:pt>
                <c:pt idx="266">
                  <c:v>1.5892857142857142</c:v>
                </c:pt>
                <c:pt idx="267">
                  <c:v>1.5952380952380953</c:v>
                </c:pt>
                <c:pt idx="268">
                  <c:v>1.6011904761904763</c:v>
                </c:pt>
                <c:pt idx="269">
                  <c:v>1.6071428571428572</c:v>
                </c:pt>
                <c:pt idx="270">
                  <c:v>1.6130952380952381</c:v>
                </c:pt>
                <c:pt idx="271">
                  <c:v>1.6190476190476191</c:v>
                </c:pt>
                <c:pt idx="272">
                  <c:v>1.625</c:v>
                </c:pt>
                <c:pt idx="273">
                  <c:v>1.6309523809523809</c:v>
                </c:pt>
                <c:pt idx="274">
                  <c:v>1.6369047619047619</c:v>
                </c:pt>
                <c:pt idx="275">
                  <c:v>1.6428571428571428</c:v>
                </c:pt>
                <c:pt idx="276">
                  <c:v>1.6488095238095237</c:v>
                </c:pt>
                <c:pt idx="277">
                  <c:v>1.6547619047619047</c:v>
                </c:pt>
                <c:pt idx="278">
                  <c:v>1.6607142857142858</c:v>
                </c:pt>
                <c:pt idx="279">
                  <c:v>1.6666666666666667</c:v>
                </c:pt>
                <c:pt idx="280">
                  <c:v>1.6726190476190477</c:v>
                </c:pt>
                <c:pt idx="281">
                  <c:v>1.6785714285714286</c:v>
                </c:pt>
                <c:pt idx="282">
                  <c:v>1.6845238095238095</c:v>
                </c:pt>
                <c:pt idx="283">
                  <c:v>1.6904761904761905</c:v>
                </c:pt>
                <c:pt idx="284">
                  <c:v>1.6964285714285714</c:v>
                </c:pt>
                <c:pt idx="285">
                  <c:v>1.7023809523809523</c:v>
                </c:pt>
                <c:pt idx="286">
                  <c:v>1.7083333333333333</c:v>
                </c:pt>
                <c:pt idx="287">
                  <c:v>1.7142857142857142</c:v>
                </c:pt>
                <c:pt idx="288">
                  <c:v>1.7202380952380953</c:v>
                </c:pt>
                <c:pt idx="289">
                  <c:v>1.7261904761904763</c:v>
                </c:pt>
                <c:pt idx="290">
                  <c:v>1.7321428571428572</c:v>
                </c:pt>
                <c:pt idx="291">
                  <c:v>1.7380952380952381</c:v>
                </c:pt>
                <c:pt idx="292">
                  <c:v>1.7440476190476191</c:v>
                </c:pt>
                <c:pt idx="293">
                  <c:v>1.75</c:v>
                </c:pt>
                <c:pt idx="294">
                  <c:v>1.7559523809523809</c:v>
                </c:pt>
                <c:pt idx="295">
                  <c:v>1.7619047619047619</c:v>
                </c:pt>
                <c:pt idx="296">
                  <c:v>1.7678571428571428</c:v>
                </c:pt>
                <c:pt idx="297">
                  <c:v>1.7738095238095237</c:v>
                </c:pt>
                <c:pt idx="298">
                  <c:v>1.7797619047619047</c:v>
                </c:pt>
                <c:pt idx="299">
                  <c:v>1.7857142857142858</c:v>
                </c:pt>
                <c:pt idx="300">
                  <c:v>1.7916666666666667</c:v>
                </c:pt>
                <c:pt idx="301">
                  <c:v>1.7976190476190477</c:v>
                </c:pt>
                <c:pt idx="302">
                  <c:v>1.8035714285714286</c:v>
                </c:pt>
                <c:pt idx="303">
                  <c:v>1.8095238095238095</c:v>
                </c:pt>
                <c:pt idx="304">
                  <c:v>1.8154761904761905</c:v>
                </c:pt>
                <c:pt idx="305">
                  <c:v>1.8214285714285714</c:v>
                </c:pt>
                <c:pt idx="306">
                  <c:v>1.8273809523809523</c:v>
                </c:pt>
                <c:pt idx="307">
                  <c:v>1.8333333333333333</c:v>
                </c:pt>
                <c:pt idx="308">
                  <c:v>1.8392857142857142</c:v>
                </c:pt>
                <c:pt idx="309">
                  <c:v>1.8452380952380953</c:v>
                </c:pt>
                <c:pt idx="310">
                  <c:v>1.8511904761904763</c:v>
                </c:pt>
                <c:pt idx="311">
                  <c:v>1.8571428571428572</c:v>
                </c:pt>
                <c:pt idx="312">
                  <c:v>1.8630952380952381</c:v>
                </c:pt>
                <c:pt idx="313">
                  <c:v>1.8690476190476191</c:v>
                </c:pt>
                <c:pt idx="314">
                  <c:v>1.875</c:v>
                </c:pt>
                <c:pt idx="315">
                  <c:v>1.8809523809523809</c:v>
                </c:pt>
                <c:pt idx="316">
                  <c:v>1.8869047619047619</c:v>
                </c:pt>
                <c:pt idx="317">
                  <c:v>1.8928571428571428</c:v>
                </c:pt>
                <c:pt idx="318">
                  <c:v>1.8988095238095237</c:v>
                </c:pt>
                <c:pt idx="319">
                  <c:v>1.9047619047619047</c:v>
                </c:pt>
                <c:pt idx="320">
                  <c:v>1.9107142857142858</c:v>
                </c:pt>
                <c:pt idx="321">
                  <c:v>1.9166666666666667</c:v>
                </c:pt>
                <c:pt idx="322">
                  <c:v>1.9226190476190477</c:v>
                </c:pt>
                <c:pt idx="323">
                  <c:v>1.9285714285714286</c:v>
                </c:pt>
                <c:pt idx="324">
                  <c:v>1.9345238095238095</c:v>
                </c:pt>
                <c:pt idx="325">
                  <c:v>1.9404761904761905</c:v>
                </c:pt>
                <c:pt idx="326">
                  <c:v>1.9464285714285714</c:v>
                </c:pt>
                <c:pt idx="327">
                  <c:v>1.9523809523809523</c:v>
                </c:pt>
                <c:pt idx="328">
                  <c:v>1.9583333333333333</c:v>
                </c:pt>
                <c:pt idx="329">
                  <c:v>1.9642857142857142</c:v>
                </c:pt>
                <c:pt idx="330">
                  <c:v>1.9702380952380953</c:v>
                </c:pt>
                <c:pt idx="331">
                  <c:v>1.9761904761904763</c:v>
                </c:pt>
                <c:pt idx="332">
                  <c:v>1.9821428571428572</c:v>
                </c:pt>
                <c:pt idx="333">
                  <c:v>1.9880952380952381</c:v>
                </c:pt>
                <c:pt idx="334">
                  <c:v>1.9940476190476191</c:v>
                </c:pt>
                <c:pt idx="335">
                  <c:v>2</c:v>
                </c:pt>
                <c:pt idx="336">
                  <c:v>2.0059523809523809</c:v>
                </c:pt>
                <c:pt idx="337">
                  <c:v>2.0119047619047619</c:v>
                </c:pt>
                <c:pt idx="338">
                  <c:v>2.0178571428571428</c:v>
                </c:pt>
                <c:pt idx="339">
                  <c:v>2.0238095238095237</c:v>
                </c:pt>
                <c:pt idx="340">
                  <c:v>2.0297619047619047</c:v>
                </c:pt>
                <c:pt idx="341">
                  <c:v>2.0357142857142856</c:v>
                </c:pt>
                <c:pt idx="342">
                  <c:v>2.0416666666666665</c:v>
                </c:pt>
                <c:pt idx="343">
                  <c:v>2.0476190476190474</c:v>
                </c:pt>
                <c:pt idx="344">
                  <c:v>2.0535714285714284</c:v>
                </c:pt>
                <c:pt idx="345">
                  <c:v>2.0595238095238093</c:v>
                </c:pt>
                <c:pt idx="346">
                  <c:v>2.0654761904761907</c:v>
                </c:pt>
                <c:pt idx="347">
                  <c:v>2.0714285714285716</c:v>
                </c:pt>
                <c:pt idx="348">
                  <c:v>2.0773809523809526</c:v>
                </c:pt>
                <c:pt idx="349">
                  <c:v>2.0833333333333335</c:v>
                </c:pt>
                <c:pt idx="350">
                  <c:v>2.0892857142857144</c:v>
                </c:pt>
                <c:pt idx="351">
                  <c:v>2.0952380952380953</c:v>
                </c:pt>
                <c:pt idx="352">
                  <c:v>2.1011904761904763</c:v>
                </c:pt>
                <c:pt idx="353">
                  <c:v>2.1071428571428572</c:v>
                </c:pt>
                <c:pt idx="354">
                  <c:v>2.1130952380952381</c:v>
                </c:pt>
                <c:pt idx="355">
                  <c:v>2.1190476190476191</c:v>
                </c:pt>
                <c:pt idx="356">
                  <c:v>2.125</c:v>
                </c:pt>
                <c:pt idx="357">
                  <c:v>2.1309523809523809</c:v>
                </c:pt>
                <c:pt idx="358">
                  <c:v>2.1369047619047619</c:v>
                </c:pt>
                <c:pt idx="359">
                  <c:v>2.1428571428571428</c:v>
                </c:pt>
                <c:pt idx="360">
                  <c:v>2.1488095238095237</c:v>
                </c:pt>
                <c:pt idx="361">
                  <c:v>2.1547619047619047</c:v>
                </c:pt>
                <c:pt idx="362">
                  <c:v>2.1607142857142856</c:v>
                </c:pt>
                <c:pt idx="363">
                  <c:v>2.1666666666666665</c:v>
                </c:pt>
                <c:pt idx="364">
                  <c:v>2.1726190476190474</c:v>
                </c:pt>
                <c:pt idx="365">
                  <c:v>2.1785714285714284</c:v>
                </c:pt>
                <c:pt idx="366">
                  <c:v>2.1845238095238093</c:v>
                </c:pt>
                <c:pt idx="367">
                  <c:v>2.1904761904761907</c:v>
                </c:pt>
                <c:pt idx="368">
                  <c:v>2.1964285714285716</c:v>
                </c:pt>
                <c:pt idx="369">
                  <c:v>2.2023809523809526</c:v>
                </c:pt>
                <c:pt idx="370">
                  <c:v>2.2083333333333335</c:v>
                </c:pt>
                <c:pt idx="371">
                  <c:v>2.2142857142857144</c:v>
                </c:pt>
                <c:pt idx="372">
                  <c:v>2.2202380952380953</c:v>
                </c:pt>
                <c:pt idx="373">
                  <c:v>2.2261904761904763</c:v>
                </c:pt>
                <c:pt idx="374">
                  <c:v>2.2321428571428572</c:v>
                </c:pt>
                <c:pt idx="375">
                  <c:v>2.2380952380952381</c:v>
                </c:pt>
                <c:pt idx="376">
                  <c:v>2.2440476190476191</c:v>
                </c:pt>
                <c:pt idx="377">
                  <c:v>2.25</c:v>
                </c:pt>
                <c:pt idx="378">
                  <c:v>2.2559523809523809</c:v>
                </c:pt>
                <c:pt idx="379">
                  <c:v>2.2619047619047619</c:v>
                </c:pt>
                <c:pt idx="380">
                  <c:v>2.2678571428571428</c:v>
                </c:pt>
                <c:pt idx="381">
                  <c:v>2.2738095238095237</c:v>
                </c:pt>
                <c:pt idx="382">
                  <c:v>2.2797619047619047</c:v>
                </c:pt>
                <c:pt idx="383">
                  <c:v>2.2857142857142856</c:v>
                </c:pt>
                <c:pt idx="384">
                  <c:v>2.2916666666666665</c:v>
                </c:pt>
                <c:pt idx="385">
                  <c:v>2.2976190476190474</c:v>
                </c:pt>
                <c:pt idx="386">
                  <c:v>2.3035714285714284</c:v>
                </c:pt>
                <c:pt idx="387">
                  <c:v>2.3095238095238093</c:v>
                </c:pt>
                <c:pt idx="388">
                  <c:v>2.3154761904761907</c:v>
                </c:pt>
                <c:pt idx="389">
                  <c:v>2.3214285714285716</c:v>
                </c:pt>
                <c:pt idx="390">
                  <c:v>2.3273809523809526</c:v>
                </c:pt>
                <c:pt idx="391">
                  <c:v>2.3333333333333335</c:v>
                </c:pt>
                <c:pt idx="392">
                  <c:v>2.3392857142857144</c:v>
                </c:pt>
                <c:pt idx="393">
                  <c:v>2.3452380952380953</c:v>
                </c:pt>
                <c:pt idx="394">
                  <c:v>2.3511904761904763</c:v>
                </c:pt>
                <c:pt idx="395">
                  <c:v>2.3571428571428572</c:v>
                </c:pt>
                <c:pt idx="396">
                  <c:v>2.3630952380952381</c:v>
                </c:pt>
                <c:pt idx="397">
                  <c:v>2.3690476190476191</c:v>
                </c:pt>
                <c:pt idx="398">
                  <c:v>2.375</c:v>
                </c:pt>
                <c:pt idx="399">
                  <c:v>2.3809523809523809</c:v>
                </c:pt>
                <c:pt idx="400">
                  <c:v>2.3869047619047619</c:v>
                </c:pt>
                <c:pt idx="401">
                  <c:v>2.3928571428571428</c:v>
                </c:pt>
                <c:pt idx="402">
                  <c:v>2.3988095238095237</c:v>
                </c:pt>
                <c:pt idx="403">
                  <c:v>2.4047619047619047</c:v>
                </c:pt>
                <c:pt idx="404">
                  <c:v>2.4107142857142856</c:v>
                </c:pt>
                <c:pt idx="405">
                  <c:v>2.4166666666666665</c:v>
                </c:pt>
                <c:pt idx="406">
                  <c:v>2.4226190476190474</c:v>
                </c:pt>
                <c:pt idx="407">
                  <c:v>2.4285714285714284</c:v>
                </c:pt>
                <c:pt idx="408">
                  <c:v>2.4345238095238093</c:v>
                </c:pt>
                <c:pt idx="409">
                  <c:v>2.4404761904761907</c:v>
                </c:pt>
                <c:pt idx="410">
                  <c:v>2.4464285714285716</c:v>
                </c:pt>
                <c:pt idx="411">
                  <c:v>2.4523809523809526</c:v>
                </c:pt>
                <c:pt idx="412">
                  <c:v>2.4583333333333335</c:v>
                </c:pt>
                <c:pt idx="413">
                  <c:v>2.4642857142857144</c:v>
                </c:pt>
                <c:pt idx="414">
                  <c:v>2.4702380952380953</c:v>
                </c:pt>
                <c:pt idx="415">
                  <c:v>2.4761904761904763</c:v>
                </c:pt>
                <c:pt idx="416">
                  <c:v>2.4821428571428572</c:v>
                </c:pt>
                <c:pt idx="417">
                  <c:v>2.4880952380952381</c:v>
                </c:pt>
                <c:pt idx="418">
                  <c:v>2.4940476190476191</c:v>
                </c:pt>
                <c:pt idx="419">
                  <c:v>2.5</c:v>
                </c:pt>
                <c:pt idx="420">
                  <c:v>2.5059523809523809</c:v>
                </c:pt>
                <c:pt idx="421">
                  <c:v>2.5119047619047619</c:v>
                </c:pt>
                <c:pt idx="422">
                  <c:v>2.5178571428571428</c:v>
                </c:pt>
                <c:pt idx="423">
                  <c:v>2.5238095238095237</c:v>
                </c:pt>
                <c:pt idx="424">
                  <c:v>2.5297619047619047</c:v>
                </c:pt>
                <c:pt idx="425">
                  <c:v>2.5357142857142856</c:v>
                </c:pt>
                <c:pt idx="426">
                  <c:v>2.5416666666666665</c:v>
                </c:pt>
                <c:pt idx="427">
                  <c:v>2.5476190476190474</c:v>
                </c:pt>
                <c:pt idx="428">
                  <c:v>2.5535714285714284</c:v>
                </c:pt>
                <c:pt idx="429">
                  <c:v>2.5595238095238093</c:v>
                </c:pt>
                <c:pt idx="430">
                  <c:v>2.5654761904761907</c:v>
                </c:pt>
                <c:pt idx="431">
                  <c:v>2.5714285714285716</c:v>
                </c:pt>
                <c:pt idx="432">
                  <c:v>2.5773809523809526</c:v>
                </c:pt>
                <c:pt idx="433">
                  <c:v>2.5833333333333335</c:v>
                </c:pt>
                <c:pt idx="434">
                  <c:v>2.5892857142857144</c:v>
                </c:pt>
                <c:pt idx="435">
                  <c:v>2.5952380952380953</c:v>
                </c:pt>
                <c:pt idx="436">
                  <c:v>2.6011904761904763</c:v>
                </c:pt>
                <c:pt idx="437">
                  <c:v>2.6071428571428572</c:v>
                </c:pt>
                <c:pt idx="438">
                  <c:v>2.6130952380952381</c:v>
                </c:pt>
                <c:pt idx="439">
                  <c:v>2.6190476190476191</c:v>
                </c:pt>
                <c:pt idx="440">
                  <c:v>2.625</c:v>
                </c:pt>
                <c:pt idx="441">
                  <c:v>2.6309523809523809</c:v>
                </c:pt>
                <c:pt idx="442">
                  <c:v>2.6369047619047619</c:v>
                </c:pt>
                <c:pt idx="443">
                  <c:v>2.6428571428571428</c:v>
                </c:pt>
                <c:pt idx="444">
                  <c:v>2.6488095238095237</c:v>
                </c:pt>
                <c:pt idx="445">
                  <c:v>2.6547619047619047</c:v>
                </c:pt>
                <c:pt idx="446">
                  <c:v>2.6607142857142856</c:v>
                </c:pt>
                <c:pt idx="447">
                  <c:v>2.6666666666666665</c:v>
                </c:pt>
                <c:pt idx="448">
                  <c:v>2.6726190476190474</c:v>
                </c:pt>
                <c:pt idx="449">
                  <c:v>2.6785714285714284</c:v>
                </c:pt>
                <c:pt idx="450">
                  <c:v>2.6845238095238093</c:v>
                </c:pt>
                <c:pt idx="451">
                  <c:v>2.6904761904761907</c:v>
                </c:pt>
                <c:pt idx="452">
                  <c:v>2.6964285714285716</c:v>
                </c:pt>
                <c:pt idx="453">
                  <c:v>2.7023809523809526</c:v>
                </c:pt>
                <c:pt idx="454">
                  <c:v>2.7083333333333335</c:v>
                </c:pt>
                <c:pt idx="455">
                  <c:v>2.7142857142857144</c:v>
                </c:pt>
                <c:pt idx="456">
                  <c:v>2.7202380952380953</c:v>
                </c:pt>
                <c:pt idx="457">
                  <c:v>2.7261904761904763</c:v>
                </c:pt>
                <c:pt idx="458">
                  <c:v>2.7321428571428572</c:v>
                </c:pt>
                <c:pt idx="459">
                  <c:v>2.7380952380952381</c:v>
                </c:pt>
                <c:pt idx="460">
                  <c:v>2.7440476190476191</c:v>
                </c:pt>
                <c:pt idx="461">
                  <c:v>2.75</c:v>
                </c:pt>
                <c:pt idx="462">
                  <c:v>2.7559523809523809</c:v>
                </c:pt>
                <c:pt idx="463">
                  <c:v>2.7619047619047619</c:v>
                </c:pt>
                <c:pt idx="464">
                  <c:v>2.7678571428571428</c:v>
                </c:pt>
                <c:pt idx="465">
                  <c:v>2.7738095238095237</c:v>
                </c:pt>
                <c:pt idx="466">
                  <c:v>2.7797619047619047</c:v>
                </c:pt>
                <c:pt idx="467">
                  <c:v>2.7857142857142856</c:v>
                </c:pt>
                <c:pt idx="468">
                  <c:v>2.7916666666666665</c:v>
                </c:pt>
                <c:pt idx="469">
                  <c:v>2.7976190476190474</c:v>
                </c:pt>
                <c:pt idx="470">
                  <c:v>2.8035714285714284</c:v>
                </c:pt>
                <c:pt idx="471">
                  <c:v>2.8095238095238093</c:v>
                </c:pt>
                <c:pt idx="472">
                  <c:v>2.8154761904761907</c:v>
                </c:pt>
                <c:pt idx="473">
                  <c:v>2.8214285714285716</c:v>
                </c:pt>
                <c:pt idx="474">
                  <c:v>2.8273809523809526</c:v>
                </c:pt>
                <c:pt idx="475">
                  <c:v>2.8333333333333335</c:v>
                </c:pt>
                <c:pt idx="476">
                  <c:v>2.8392857142857144</c:v>
                </c:pt>
                <c:pt idx="477">
                  <c:v>2.8452380952380953</c:v>
                </c:pt>
                <c:pt idx="478">
                  <c:v>2.8511904761904763</c:v>
                </c:pt>
                <c:pt idx="479">
                  <c:v>2.8571428571428572</c:v>
                </c:pt>
                <c:pt idx="480">
                  <c:v>2.8630952380952381</c:v>
                </c:pt>
                <c:pt idx="481">
                  <c:v>2.8690476190476191</c:v>
                </c:pt>
                <c:pt idx="482">
                  <c:v>2.875</c:v>
                </c:pt>
                <c:pt idx="483">
                  <c:v>2.8809523809523809</c:v>
                </c:pt>
                <c:pt idx="484">
                  <c:v>2.8869047619047619</c:v>
                </c:pt>
                <c:pt idx="485">
                  <c:v>2.8928571428571428</c:v>
                </c:pt>
                <c:pt idx="486">
                  <c:v>2.8988095238095237</c:v>
                </c:pt>
                <c:pt idx="487">
                  <c:v>2.9047619047619047</c:v>
                </c:pt>
                <c:pt idx="488">
                  <c:v>2.9107142857142856</c:v>
                </c:pt>
                <c:pt idx="489">
                  <c:v>2.9166666666666665</c:v>
                </c:pt>
                <c:pt idx="490">
                  <c:v>2.9226190476190474</c:v>
                </c:pt>
                <c:pt idx="491">
                  <c:v>2.9285714285714284</c:v>
                </c:pt>
                <c:pt idx="492">
                  <c:v>2.9345238095238093</c:v>
                </c:pt>
                <c:pt idx="493">
                  <c:v>2.9404761904761907</c:v>
                </c:pt>
                <c:pt idx="494">
                  <c:v>2.9464285714285716</c:v>
                </c:pt>
                <c:pt idx="495">
                  <c:v>2.9523809523809526</c:v>
                </c:pt>
                <c:pt idx="496">
                  <c:v>2.9583333333333335</c:v>
                </c:pt>
                <c:pt idx="497">
                  <c:v>2.9642857142857144</c:v>
                </c:pt>
                <c:pt idx="498">
                  <c:v>2.9702380952380953</c:v>
                </c:pt>
                <c:pt idx="499">
                  <c:v>2.9761904761904763</c:v>
                </c:pt>
                <c:pt idx="500">
                  <c:v>2.9821428571428572</c:v>
                </c:pt>
                <c:pt idx="501">
                  <c:v>2.9880952380952381</c:v>
                </c:pt>
                <c:pt idx="502">
                  <c:v>2.9940476190476191</c:v>
                </c:pt>
                <c:pt idx="503">
                  <c:v>3</c:v>
                </c:pt>
                <c:pt idx="504">
                  <c:v>3.0059523809523809</c:v>
                </c:pt>
                <c:pt idx="505">
                  <c:v>3.0119047619047619</c:v>
                </c:pt>
                <c:pt idx="506">
                  <c:v>3.0178571428571428</c:v>
                </c:pt>
                <c:pt idx="507">
                  <c:v>3.0238095238095237</c:v>
                </c:pt>
                <c:pt idx="508">
                  <c:v>3.0297619047619047</c:v>
                </c:pt>
                <c:pt idx="509">
                  <c:v>3.0357142857142856</c:v>
                </c:pt>
                <c:pt idx="510">
                  <c:v>3.0416666666666665</c:v>
                </c:pt>
                <c:pt idx="511">
                  <c:v>3.0476190476190474</c:v>
                </c:pt>
                <c:pt idx="512">
                  <c:v>3.0535714285714284</c:v>
                </c:pt>
                <c:pt idx="513">
                  <c:v>3.0595238095238093</c:v>
                </c:pt>
                <c:pt idx="514">
                  <c:v>3.0654761904761907</c:v>
                </c:pt>
                <c:pt idx="515">
                  <c:v>3.0714285714285716</c:v>
                </c:pt>
                <c:pt idx="516">
                  <c:v>3.0773809523809526</c:v>
                </c:pt>
                <c:pt idx="517">
                  <c:v>3.0833333333333335</c:v>
                </c:pt>
                <c:pt idx="518">
                  <c:v>3.0892857142857144</c:v>
                </c:pt>
                <c:pt idx="519">
                  <c:v>3.0952380952380953</c:v>
                </c:pt>
                <c:pt idx="520">
                  <c:v>3.1011904761904763</c:v>
                </c:pt>
                <c:pt idx="521">
                  <c:v>3.1071428571428572</c:v>
                </c:pt>
                <c:pt idx="522">
                  <c:v>3.1130952380952381</c:v>
                </c:pt>
                <c:pt idx="523">
                  <c:v>3.1190476190476191</c:v>
                </c:pt>
                <c:pt idx="524">
                  <c:v>3.125</c:v>
                </c:pt>
                <c:pt idx="525">
                  <c:v>3.1309523809523809</c:v>
                </c:pt>
                <c:pt idx="526">
                  <c:v>3.1369047619047619</c:v>
                </c:pt>
                <c:pt idx="527">
                  <c:v>3.1428571428571428</c:v>
                </c:pt>
                <c:pt idx="528">
                  <c:v>3.1488095238095237</c:v>
                </c:pt>
                <c:pt idx="529">
                  <c:v>3.1547619047619047</c:v>
                </c:pt>
                <c:pt idx="530">
                  <c:v>3.1607142857142856</c:v>
                </c:pt>
                <c:pt idx="531">
                  <c:v>3.1666666666666665</c:v>
                </c:pt>
                <c:pt idx="532">
                  <c:v>3.1726190476190474</c:v>
                </c:pt>
                <c:pt idx="533">
                  <c:v>3.1785714285714284</c:v>
                </c:pt>
                <c:pt idx="534">
                  <c:v>3.1845238095238093</c:v>
                </c:pt>
                <c:pt idx="535">
                  <c:v>3.1904761904761907</c:v>
                </c:pt>
                <c:pt idx="536">
                  <c:v>3.1964285714285716</c:v>
                </c:pt>
                <c:pt idx="537">
                  <c:v>3.2023809523809526</c:v>
                </c:pt>
                <c:pt idx="538">
                  <c:v>3.2083333333333335</c:v>
                </c:pt>
                <c:pt idx="539">
                  <c:v>3.2142857142857144</c:v>
                </c:pt>
                <c:pt idx="540">
                  <c:v>3.2202380952380953</c:v>
                </c:pt>
                <c:pt idx="541">
                  <c:v>3.2261904761904763</c:v>
                </c:pt>
                <c:pt idx="542">
                  <c:v>3.2321428571428572</c:v>
                </c:pt>
                <c:pt idx="543">
                  <c:v>3.2380952380952381</c:v>
                </c:pt>
                <c:pt idx="544">
                  <c:v>3.2440476190476191</c:v>
                </c:pt>
                <c:pt idx="545">
                  <c:v>3.25</c:v>
                </c:pt>
                <c:pt idx="546">
                  <c:v>3.2559523809523809</c:v>
                </c:pt>
                <c:pt idx="547">
                  <c:v>3.2619047619047619</c:v>
                </c:pt>
                <c:pt idx="548">
                  <c:v>3.2678571428571428</c:v>
                </c:pt>
                <c:pt idx="549">
                  <c:v>3.2738095238095237</c:v>
                </c:pt>
                <c:pt idx="550">
                  <c:v>3.2797619047619047</c:v>
                </c:pt>
                <c:pt idx="551">
                  <c:v>3.2857142857142856</c:v>
                </c:pt>
                <c:pt idx="552">
                  <c:v>3.2916666666666665</c:v>
                </c:pt>
                <c:pt idx="553">
                  <c:v>3.2976190476190474</c:v>
                </c:pt>
                <c:pt idx="554">
                  <c:v>3.3035714285714284</c:v>
                </c:pt>
                <c:pt idx="555">
                  <c:v>3.3095238095238093</c:v>
                </c:pt>
                <c:pt idx="556">
                  <c:v>3.3154761904761907</c:v>
                </c:pt>
                <c:pt idx="557">
                  <c:v>3.3214285714285716</c:v>
                </c:pt>
                <c:pt idx="558">
                  <c:v>3.3273809523809526</c:v>
                </c:pt>
                <c:pt idx="559">
                  <c:v>3.3333333333333335</c:v>
                </c:pt>
                <c:pt idx="560">
                  <c:v>3.3392857142857144</c:v>
                </c:pt>
                <c:pt idx="561">
                  <c:v>3.3452380952380953</c:v>
                </c:pt>
                <c:pt idx="562">
                  <c:v>3.3511904761904763</c:v>
                </c:pt>
                <c:pt idx="563">
                  <c:v>3.3571428571428572</c:v>
                </c:pt>
                <c:pt idx="564">
                  <c:v>3.3630952380952381</c:v>
                </c:pt>
                <c:pt idx="565">
                  <c:v>3.3690476190476191</c:v>
                </c:pt>
                <c:pt idx="566">
                  <c:v>3.375</c:v>
                </c:pt>
                <c:pt idx="567">
                  <c:v>3.3809523809523809</c:v>
                </c:pt>
                <c:pt idx="568">
                  <c:v>3.3869047619047619</c:v>
                </c:pt>
                <c:pt idx="569">
                  <c:v>3.3928571428571428</c:v>
                </c:pt>
                <c:pt idx="570">
                  <c:v>3.3988095238095237</c:v>
                </c:pt>
                <c:pt idx="571">
                  <c:v>3.4047619047619047</c:v>
                </c:pt>
                <c:pt idx="572">
                  <c:v>3.4107142857142856</c:v>
                </c:pt>
                <c:pt idx="573">
                  <c:v>3.4166666666666665</c:v>
                </c:pt>
                <c:pt idx="574">
                  <c:v>3.4226190476190474</c:v>
                </c:pt>
                <c:pt idx="575">
                  <c:v>3.4285714285714284</c:v>
                </c:pt>
                <c:pt idx="576">
                  <c:v>3.4345238095238093</c:v>
                </c:pt>
                <c:pt idx="577">
                  <c:v>3.4404761904761907</c:v>
                </c:pt>
                <c:pt idx="578">
                  <c:v>3.4464285714285716</c:v>
                </c:pt>
                <c:pt idx="579">
                  <c:v>3.4523809523809526</c:v>
                </c:pt>
                <c:pt idx="580">
                  <c:v>3.4583333333333335</c:v>
                </c:pt>
                <c:pt idx="581">
                  <c:v>3.4642857142857144</c:v>
                </c:pt>
                <c:pt idx="582">
                  <c:v>3.4702380952380953</c:v>
                </c:pt>
                <c:pt idx="583">
                  <c:v>3.4761904761904763</c:v>
                </c:pt>
                <c:pt idx="584">
                  <c:v>3.4821428571428572</c:v>
                </c:pt>
                <c:pt idx="585">
                  <c:v>3.4880952380952381</c:v>
                </c:pt>
                <c:pt idx="586">
                  <c:v>3.4940476190476191</c:v>
                </c:pt>
                <c:pt idx="587">
                  <c:v>3.5</c:v>
                </c:pt>
                <c:pt idx="588">
                  <c:v>3.5059523809523809</c:v>
                </c:pt>
                <c:pt idx="589">
                  <c:v>3.5119047619047619</c:v>
                </c:pt>
                <c:pt idx="590">
                  <c:v>3.5178571428571428</c:v>
                </c:pt>
                <c:pt idx="591">
                  <c:v>3.5238095238095237</c:v>
                </c:pt>
                <c:pt idx="592">
                  <c:v>3.5297619047619047</c:v>
                </c:pt>
                <c:pt idx="593">
                  <c:v>3.5357142857142856</c:v>
                </c:pt>
                <c:pt idx="594">
                  <c:v>3.5416666666666665</c:v>
                </c:pt>
                <c:pt idx="595">
                  <c:v>3.5476190476190474</c:v>
                </c:pt>
                <c:pt idx="596">
                  <c:v>3.5535714285714284</c:v>
                </c:pt>
                <c:pt idx="597">
                  <c:v>3.5595238095238093</c:v>
                </c:pt>
                <c:pt idx="598">
                  <c:v>3.5654761904761907</c:v>
                </c:pt>
                <c:pt idx="599">
                  <c:v>3.5714285714285716</c:v>
                </c:pt>
                <c:pt idx="600">
                  <c:v>3.5773809523809526</c:v>
                </c:pt>
                <c:pt idx="601">
                  <c:v>3.5833333333333335</c:v>
                </c:pt>
                <c:pt idx="602">
                  <c:v>3.5892857142857144</c:v>
                </c:pt>
                <c:pt idx="603">
                  <c:v>3.5952380952380953</c:v>
                </c:pt>
                <c:pt idx="604">
                  <c:v>3.6011904761904763</c:v>
                </c:pt>
                <c:pt idx="605">
                  <c:v>3.6071428571428572</c:v>
                </c:pt>
                <c:pt idx="606">
                  <c:v>3.6130952380952381</c:v>
                </c:pt>
                <c:pt idx="607">
                  <c:v>3.6190476190476191</c:v>
                </c:pt>
                <c:pt idx="608">
                  <c:v>3.625</c:v>
                </c:pt>
                <c:pt idx="609">
                  <c:v>3.6309523809523809</c:v>
                </c:pt>
                <c:pt idx="610">
                  <c:v>3.6369047619047619</c:v>
                </c:pt>
                <c:pt idx="611">
                  <c:v>3.6428571428571428</c:v>
                </c:pt>
                <c:pt idx="612">
                  <c:v>3.6488095238095237</c:v>
                </c:pt>
                <c:pt idx="613">
                  <c:v>3.6547619047619047</c:v>
                </c:pt>
                <c:pt idx="614">
                  <c:v>3.6607142857142856</c:v>
                </c:pt>
                <c:pt idx="615">
                  <c:v>3.6666666666666665</c:v>
                </c:pt>
                <c:pt idx="616">
                  <c:v>3.6726190476190474</c:v>
                </c:pt>
                <c:pt idx="617">
                  <c:v>3.6785714285714284</c:v>
                </c:pt>
                <c:pt idx="618">
                  <c:v>3.6845238095238093</c:v>
                </c:pt>
                <c:pt idx="619">
                  <c:v>3.6904761904761907</c:v>
                </c:pt>
                <c:pt idx="620">
                  <c:v>3.6964285714285716</c:v>
                </c:pt>
                <c:pt idx="621">
                  <c:v>3.7023809523809526</c:v>
                </c:pt>
                <c:pt idx="622">
                  <c:v>3.7083333333333335</c:v>
                </c:pt>
                <c:pt idx="623">
                  <c:v>3.7142857142857144</c:v>
                </c:pt>
                <c:pt idx="624">
                  <c:v>3.7202380952380953</c:v>
                </c:pt>
                <c:pt idx="625">
                  <c:v>3.7261904761904763</c:v>
                </c:pt>
                <c:pt idx="626">
                  <c:v>3.7321428571428572</c:v>
                </c:pt>
                <c:pt idx="627">
                  <c:v>3.7380952380952381</c:v>
                </c:pt>
                <c:pt idx="628">
                  <c:v>3.7440476190476191</c:v>
                </c:pt>
                <c:pt idx="629">
                  <c:v>3.75</c:v>
                </c:pt>
                <c:pt idx="630">
                  <c:v>3.7559523809523809</c:v>
                </c:pt>
                <c:pt idx="631">
                  <c:v>3.7619047619047619</c:v>
                </c:pt>
                <c:pt idx="632">
                  <c:v>3.7678571428571428</c:v>
                </c:pt>
                <c:pt idx="633">
                  <c:v>3.7738095238095237</c:v>
                </c:pt>
                <c:pt idx="634">
                  <c:v>3.7797619047619047</c:v>
                </c:pt>
                <c:pt idx="635">
                  <c:v>3.7857142857142856</c:v>
                </c:pt>
                <c:pt idx="636">
                  <c:v>3.7916666666666665</c:v>
                </c:pt>
                <c:pt idx="637">
                  <c:v>3.7976190476190474</c:v>
                </c:pt>
                <c:pt idx="638">
                  <c:v>3.8035714285714284</c:v>
                </c:pt>
                <c:pt idx="639">
                  <c:v>3.8095238095238093</c:v>
                </c:pt>
                <c:pt idx="640">
                  <c:v>3.8154761904761907</c:v>
                </c:pt>
                <c:pt idx="641">
                  <c:v>3.8214285714285716</c:v>
                </c:pt>
                <c:pt idx="642">
                  <c:v>3.8273809523809526</c:v>
                </c:pt>
                <c:pt idx="643">
                  <c:v>3.8333333333333335</c:v>
                </c:pt>
                <c:pt idx="644">
                  <c:v>3.8392857142857144</c:v>
                </c:pt>
                <c:pt idx="645">
                  <c:v>3.8452380952380953</c:v>
                </c:pt>
                <c:pt idx="646">
                  <c:v>3.8511904761904763</c:v>
                </c:pt>
                <c:pt idx="647">
                  <c:v>3.8571428571428572</c:v>
                </c:pt>
                <c:pt idx="648">
                  <c:v>3.8630952380952381</c:v>
                </c:pt>
                <c:pt idx="649">
                  <c:v>3.8690476190476191</c:v>
                </c:pt>
                <c:pt idx="650">
                  <c:v>3.875</c:v>
                </c:pt>
                <c:pt idx="651">
                  <c:v>3.8809523809523809</c:v>
                </c:pt>
                <c:pt idx="652">
                  <c:v>3.8869047619047619</c:v>
                </c:pt>
                <c:pt idx="653">
                  <c:v>3.8928571428571428</c:v>
                </c:pt>
                <c:pt idx="654">
                  <c:v>3.8988095238095237</c:v>
                </c:pt>
                <c:pt idx="655">
                  <c:v>3.9047619047619047</c:v>
                </c:pt>
                <c:pt idx="656">
                  <c:v>3.9107142857142856</c:v>
                </c:pt>
                <c:pt idx="657">
                  <c:v>3.9166666666666665</c:v>
                </c:pt>
                <c:pt idx="658">
                  <c:v>3.9226190476190474</c:v>
                </c:pt>
                <c:pt idx="659">
                  <c:v>3.9285714285714284</c:v>
                </c:pt>
                <c:pt idx="660">
                  <c:v>3.9345238095238093</c:v>
                </c:pt>
                <c:pt idx="661">
                  <c:v>3.9404761904761907</c:v>
                </c:pt>
                <c:pt idx="662">
                  <c:v>3.9464285714285716</c:v>
                </c:pt>
                <c:pt idx="663">
                  <c:v>3.9523809523809526</c:v>
                </c:pt>
                <c:pt idx="664">
                  <c:v>3.9583333333333335</c:v>
                </c:pt>
                <c:pt idx="665">
                  <c:v>3.9642857142857144</c:v>
                </c:pt>
                <c:pt idx="666">
                  <c:v>3.9702380952380953</c:v>
                </c:pt>
                <c:pt idx="667">
                  <c:v>3.9761904761904763</c:v>
                </c:pt>
                <c:pt idx="668">
                  <c:v>3.9821428571428572</c:v>
                </c:pt>
                <c:pt idx="669">
                  <c:v>3.9880952380952381</c:v>
                </c:pt>
                <c:pt idx="670">
                  <c:v>3.9940476190476191</c:v>
                </c:pt>
                <c:pt idx="671">
                  <c:v>4</c:v>
                </c:pt>
                <c:pt idx="672">
                  <c:v>4.0059523809523814</c:v>
                </c:pt>
                <c:pt idx="673">
                  <c:v>4.0119047619047619</c:v>
                </c:pt>
                <c:pt idx="674">
                  <c:v>4.0178571428571432</c:v>
                </c:pt>
                <c:pt idx="675">
                  <c:v>4.0238095238095237</c:v>
                </c:pt>
                <c:pt idx="676">
                  <c:v>4.0297619047619051</c:v>
                </c:pt>
                <c:pt idx="677">
                  <c:v>4.0357142857142856</c:v>
                </c:pt>
                <c:pt idx="678">
                  <c:v>4.041666666666667</c:v>
                </c:pt>
                <c:pt idx="679">
                  <c:v>4.0476190476190474</c:v>
                </c:pt>
                <c:pt idx="680">
                  <c:v>4.0535714285714288</c:v>
                </c:pt>
                <c:pt idx="681">
                  <c:v>4.0595238095238093</c:v>
                </c:pt>
                <c:pt idx="682">
                  <c:v>4.0654761904761907</c:v>
                </c:pt>
                <c:pt idx="683">
                  <c:v>4.0714285714285712</c:v>
                </c:pt>
                <c:pt idx="684">
                  <c:v>4.0773809523809526</c:v>
                </c:pt>
                <c:pt idx="685">
                  <c:v>4.083333333333333</c:v>
                </c:pt>
                <c:pt idx="686">
                  <c:v>4.0892857142857144</c:v>
                </c:pt>
                <c:pt idx="687">
                  <c:v>4.0952380952380949</c:v>
                </c:pt>
                <c:pt idx="688">
                  <c:v>4.1011904761904763</c:v>
                </c:pt>
                <c:pt idx="689">
                  <c:v>4.1071428571428568</c:v>
                </c:pt>
                <c:pt idx="690">
                  <c:v>4.1130952380952381</c:v>
                </c:pt>
                <c:pt idx="691">
                  <c:v>4.1190476190476186</c:v>
                </c:pt>
                <c:pt idx="692">
                  <c:v>4.125</c:v>
                </c:pt>
                <c:pt idx="693">
                  <c:v>4.1309523809523814</c:v>
                </c:pt>
                <c:pt idx="694">
                  <c:v>4.1369047619047619</c:v>
                </c:pt>
                <c:pt idx="695">
                  <c:v>4.1428571428571432</c:v>
                </c:pt>
                <c:pt idx="696">
                  <c:v>4.1488095238095237</c:v>
                </c:pt>
                <c:pt idx="697">
                  <c:v>4.1547619047619051</c:v>
                </c:pt>
                <c:pt idx="698">
                  <c:v>4.1607142857142856</c:v>
                </c:pt>
                <c:pt idx="699">
                  <c:v>4.166666666666667</c:v>
                </c:pt>
                <c:pt idx="700">
                  <c:v>4.1726190476190474</c:v>
                </c:pt>
                <c:pt idx="701">
                  <c:v>4.1785714285714288</c:v>
                </c:pt>
                <c:pt idx="702">
                  <c:v>4.1845238095238093</c:v>
                </c:pt>
                <c:pt idx="703">
                  <c:v>4.1904761904761907</c:v>
                </c:pt>
                <c:pt idx="704">
                  <c:v>4.1964285714285712</c:v>
                </c:pt>
                <c:pt idx="705">
                  <c:v>4.2023809523809526</c:v>
                </c:pt>
                <c:pt idx="706">
                  <c:v>4.208333333333333</c:v>
                </c:pt>
                <c:pt idx="707">
                  <c:v>4.2142857142857144</c:v>
                </c:pt>
                <c:pt idx="708">
                  <c:v>4.2202380952380949</c:v>
                </c:pt>
                <c:pt idx="709">
                  <c:v>4.2261904761904763</c:v>
                </c:pt>
                <c:pt idx="710">
                  <c:v>4.2321428571428568</c:v>
                </c:pt>
                <c:pt idx="711">
                  <c:v>4.2380952380952381</c:v>
                </c:pt>
                <c:pt idx="712">
                  <c:v>4.2440476190476186</c:v>
                </c:pt>
                <c:pt idx="713">
                  <c:v>4.25</c:v>
                </c:pt>
                <c:pt idx="714">
                  <c:v>4.2559523809523814</c:v>
                </c:pt>
                <c:pt idx="715">
                  <c:v>4.2619047619047619</c:v>
                </c:pt>
                <c:pt idx="716">
                  <c:v>4.2678571428571432</c:v>
                </c:pt>
                <c:pt idx="717">
                  <c:v>4.2738095238095237</c:v>
                </c:pt>
                <c:pt idx="718">
                  <c:v>4.2797619047619051</c:v>
                </c:pt>
                <c:pt idx="719">
                  <c:v>4.2857142857142856</c:v>
                </c:pt>
                <c:pt idx="720">
                  <c:v>4.291666666666667</c:v>
                </c:pt>
                <c:pt idx="721">
                  <c:v>4.2976190476190474</c:v>
                </c:pt>
                <c:pt idx="722">
                  <c:v>4.3035714285714288</c:v>
                </c:pt>
                <c:pt idx="723">
                  <c:v>4.3095238095238093</c:v>
                </c:pt>
                <c:pt idx="724">
                  <c:v>4.3154761904761907</c:v>
                </c:pt>
                <c:pt idx="725">
                  <c:v>4.3214285714285712</c:v>
                </c:pt>
                <c:pt idx="726">
                  <c:v>4.3273809523809526</c:v>
                </c:pt>
                <c:pt idx="727">
                  <c:v>4.333333333333333</c:v>
                </c:pt>
                <c:pt idx="728">
                  <c:v>4.3392857142857144</c:v>
                </c:pt>
                <c:pt idx="729">
                  <c:v>4.3452380952380949</c:v>
                </c:pt>
                <c:pt idx="730">
                  <c:v>4.3511904761904763</c:v>
                </c:pt>
                <c:pt idx="731">
                  <c:v>4.3571428571428568</c:v>
                </c:pt>
                <c:pt idx="732">
                  <c:v>4.3630952380952381</c:v>
                </c:pt>
                <c:pt idx="733">
                  <c:v>4.3690476190476186</c:v>
                </c:pt>
                <c:pt idx="734">
                  <c:v>4.375</c:v>
                </c:pt>
                <c:pt idx="735">
                  <c:v>4.3809523809523814</c:v>
                </c:pt>
                <c:pt idx="736">
                  <c:v>4.3869047619047619</c:v>
                </c:pt>
                <c:pt idx="737">
                  <c:v>4.3928571428571432</c:v>
                </c:pt>
                <c:pt idx="738">
                  <c:v>4.3988095238095237</c:v>
                </c:pt>
                <c:pt idx="739">
                  <c:v>4.4047619047619051</c:v>
                </c:pt>
                <c:pt idx="740">
                  <c:v>4.4107142857142856</c:v>
                </c:pt>
                <c:pt idx="741">
                  <c:v>4.416666666666667</c:v>
                </c:pt>
                <c:pt idx="742">
                  <c:v>4.4226190476190474</c:v>
                </c:pt>
                <c:pt idx="743">
                  <c:v>4.4285714285714288</c:v>
                </c:pt>
                <c:pt idx="744">
                  <c:v>4.4345238095238093</c:v>
                </c:pt>
                <c:pt idx="745">
                  <c:v>4.4404761904761907</c:v>
                </c:pt>
                <c:pt idx="746">
                  <c:v>4.4464285714285712</c:v>
                </c:pt>
                <c:pt idx="747">
                  <c:v>4.4523809523809526</c:v>
                </c:pt>
                <c:pt idx="748">
                  <c:v>4.458333333333333</c:v>
                </c:pt>
                <c:pt idx="749">
                  <c:v>4.4642857142857144</c:v>
                </c:pt>
                <c:pt idx="750">
                  <c:v>4.4702380952380949</c:v>
                </c:pt>
                <c:pt idx="751">
                  <c:v>4.4761904761904763</c:v>
                </c:pt>
                <c:pt idx="752">
                  <c:v>4.4821428571428568</c:v>
                </c:pt>
                <c:pt idx="753">
                  <c:v>4.4880952380952381</c:v>
                </c:pt>
                <c:pt idx="754">
                  <c:v>4.4940476190476186</c:v>
                </c:pt>
                <c:pt idx="755">
                  <c:v>4.5</c:v>
                </c:pt>
                <c:pt idx="756">
                  <c:v>4.5059523809523814</c:v>
                </c:pt>
                <c:pt idx="757">
                  <c:v>4.5119047619047619</c:v>
                </c:pt>
                <c:pt idx="758">
                  <c:v>4.5178571428571432</c:v>
                </c:pt>
                <c:pt idx="759">
                  <c:v>4.5238095238095237</c:v>
                </c:pt>
                <c:pt idx="760">
                  <c:v>4.5297619047619051</c:v>
                </c:pt>
                <c:pt idx="761">
                  <c:v>4.5357142857142856</c:v>
                </c:pt>
                <c:pt idx="762">
                  <c:v>4.541666666666667</c:v>
                </c:pt>
                <c:pt idx="763">
                  <c:v>4.5476190476190474</c:v>
                </c:pt>
                <c:pt idx="764">
                  <c:v>4.5535714285714288</c:v>
                </c:pt>
                <c:pt idx="765">
                  <c:v>4.5595238095238093</c:v>
                </c:pt>
                <c:pt idx="766">
                  <c:v>4.5654761904761907</c:v>
                </c:pt>
                <c:pt idx="767">
                  <c:v>4.5714285714285712</c:v>
                </c:pt>
                <c:pt idx="768">
                  <c:v>4.5773809523809526</c:v>
                </c:pt>
                <c:pt idx="769">
                  <c:v>4.583333333333333</c:v>
                </c:pt>
                <c:pt idx="770">
                  <c:v>4.5892857142857144</c:v>
                </c:pt>
                <c:pt idx="771">
                  <c:v>4.5952380952380949</c:v>
                </c:pt>
                <c:pt idx="772">
                  <c:v>4.6011904761904763</c:v>
                </c:pt>
                <c:pt idx="773">
                  <c:v>4.6071428571428568</c:v>
                </c:pt>
                <c:pt idx="774">
                  <c:v>4.6130952380952381</c:v>
                </c:pt>
                <c:pt idx="775">
                  <c:v>4.6190476190476186</c:v>
                </c:pt>
                <c:pt idx="776">
                  <c:v>4.625</c:v>
                </c:pt>
                <c:pt idx="777">
                  <c:v>4.6309523809523814</c:v>
                </c:pt>
                <c:pt idx="778">
                  <c:v>4.6369047619047619</c:v>
                </c:pt>
                <c:pt idx="779">
                  <c:v>4.6428571428571432</c:v>
                </c:pt>
                <c:pt idx="780">
                  <c:v>4.6488095238095237</c:v>
                </c:pt>
                <c:pt idx="781">
                  <c:v>4.6547619047619051</c:v>
                </c:pt>
                <c:pt idx="782">
                  <c:v>4.6607142857142856</c:v>
                </c:pt>
                <c:pt idx="783">
                  <c:v>4.666666666666667</c:v>
                </c:pt>
                <c:pt idx="784">
                  <c:v>4.6726190476190474</c:v>
                </c:pt>
                <c:pt idx="785">
                  <c:v>4.6785714285714288</c:v>
                </c:pt>
                <c:pt idx="786">
                  <c:v>4.6845238095238093</c:v>
                </c:pt>
                <c:pt idx="787">
                  <c:v>4.6904761904761907</c:v>
                </c:pt>
                <c:pt idx="788">
                  <c:v>4.6964285714285712</c:v>
                </c:pt>
                <c:pt idx="789">
                  <c:v>4.7023809523809526</c:v>
                </c:pt>
                <c:pt idx="790">
                  <c:v>4.708333333333333</c:v>
                </c:pt>
                <c:pt idx="791">
                  <c:v>4.7142857142857144</c:v>
                </c:pt>
                <c:pt idx="792">
                  <c:v>4.7202380952380949</c:v>
                </c:pt>
                <c:pt idx="793">
                  <c:v>4.7261904761904763</c:v>
                </c:pt>
                <c:pt idx="794">
                  <c:v>4.7321428571428568</c:v>
                </c:pt>
                <c:pt idx="795">
                  <c:v>4.7380952380952381</c:v>
                </c:pt>
                <c:pt idx="796">
                  <c:v>4.7440476190476186</c:v>
                </c:pt>
                <c:pt idx="797">
                  <c:v>4.75</c:v>
                </c:pt>
                <c:pt idx="798">
                  <c:v>4.7559523809523814</c:v>
                </c:pt>
                <c:pt idx="799">
                  <c:v>4.7619047619047619</c:v>
                </c:pt>
                <c:pt idx="800">
                  <c:v>4.7678571428571432</c:v>
                </c:pt>
                <c:pt idx="801">
                  <c:v>4.7738095238095237</c:v>
                </c:pt>
                <c:pt idx="802">
                  <c:v>4.7797619047619051</c:v>
                </c:pt>
                <c:pt idx="803">
                  <c:v>4.7857142857142856</c:v>
                </c:pt>
                <c:pt idx="804">
                  <c:v>4.791666666666667</c:v>
                </c:pt>
                <c:pt idx="805">
                  <c:v>4.7976190476190474</c:v>
                </c:pt>
                <c:pt idx="806">
                  <c:v>4.8035714285714288</c:v>
                </c:pt>
                <c:pt idx="807">
                  <c:v>4.8095238095238093</c:v>
                </c:pt>
                <c:pt idx="808">
                  <c:v>4.8154761904761907</c:v>
                </c:pt>
                <c:pt idx="809">
                  <c:v>4.8214285714285712</c:v>
                </c:pt>
                <c:pt idx="810">
                  <c:v>4.8273809523809526</c:v>
                </c:pt>
                <c:pt idx="811">
                  <c:v>4.833333333333333</c:v>
                </c:pt>
                <c:pt idx="812">
                  <c:v>4.8392857142857144</c:v>
                </c:pt>
                <c:pt idx="813">
                  <c:v>4.8452380952380949</c:v>
                </c:pt>
                <c:pt idx="814">
                  <c:v>4.8511904761904763</c:v>
                </c:pt>
                <c:pt idx="815">
                  <c:v>4.8571428571428568</c:v>
                </c:pt>
                <c:pt idx="816">
                  <c:v>4.8630952380952381</c:v>
                </c:pt>
                <c:pt idx="817">
                  <c:v>4.8690476190476186</c:v>
                </c:pt>
                <c:pt idx="818">
                  <c:v>4.875</c:v>
                </c:pt>
                <c:pt idx="819">
                  <c:v>4.8809523809523814</c:v>
                </c:pt>
                <c:pt idx="820">
                  <c:v>4.8869047619047619</c:v>
                </c:pt>
                <c:pt idx="821">
                  <c:v>4.8928571428571432</c:v>
                </c:pt>
                <c:pt idx="822">
                  <c:v>4.8988095238095237</c:v>
                </c:pt>
                <c:pt idx="823">
                  <c:v>4.9047619047619051</c:v>
                </c:pt>
                <c:pt idx="824">
                  <c:v>4.9107142857142856</c:v>
                </c:pt>
                <c:pt idx="825">
                  <c:v>4.916666666666667</c:v>
                </c:pt>
                <c:pt idx="826">
                  <c:v>4.9226190476190474</c:v>
                </c:pt>
                <c:pt idx="827">
                  <c:v>4.9285714285714288</c:v>
                </c:pt>
                <c:pt idx="828">
                  <c:v>4.9345238095238093</c:v>
                </c:pt>
                <c:pt idx="829">
                  <c:v>4.9404761904761907</c:v>
                </c:pt>
                <c:pt idx="830">
                  <c:v>4.9464285714285712</c:v>
                </c:pt>
                <c:pt idx="831">
                  <c:v>4.9523809523809526</c:v>
                </c:pt>
                <c:pt idx="832">
                  <c:v>4.958333333333333</c:v>
                </c:pt>
                <c:pt idx="833">
                  <c:v>4.9642857142857144</c:v>
                </c:pt>
                <c:pt idx="834">
                  <c:v>4.9702380952380949</c:v>
                </c:pt>
                <c:pt idx="835">
                  <c:v>4.9761904761904763</c:v>
                </c:pt>
                <c:pt idx="836">
                  <c:v>4.9821428571428568</c:v>
                </c:pt>
                <c:pt idx="837">
                  <c:v>4.9880952380952381</c:v>
                </c:pt>
                <c:pt idx="838">
                  <c:v>4.9940476190476186</c:v>
                </c:pt>
                <c:pt idx="839">
                  <c:v>5</c:v>
                </c:pt>
                <c:pt idx="840">
                  <c:v>5.0059523809523814</c:v>
                </c:pt>
                <c:pt idx="841">
                  <c:v>5.0119047619047619</c:v>
                </c:pt>
                <c:pt idx="842">
                  <c:v>5.0178571428571432</c:v>
                </c:pt>
                <c:pt idx="843">
                  <c:v>5.0238095238095237</c:v>
                </c:pt>
                <c:pt idx="844">
                  <c:v>5.0297619047619051</c:v>
                </c:pt>
                <c:pt idx="845">
                  <c:v>5.0357142857142856</c:v>
                </c:pt>
                <c:pt idx="846">
                  <c:v>5.041666666666667</c:v>
                </c:pt>
                <c:pt idx="847">
                  <c:v>5.0476190476190474</c:v>
                </c:pt>
                <c:pt idx="848">
                  <c:v>5.0535714285714288</c:v>
                </c:pt>
                <c:pt idx="849">
                  <c:v>5.0595238095238093</c:v>
                </c:pt>
                <c:pt idx="850">
                  <c:v>5.0654761904761907</c:v>
                </c:pt>
                <c:pt idx="851">
                  <c:v>5.0714285714285712</c:v>
                </c:pt>
                <c:pt idx="852">
                  <c:v>5.0773809523809526</c:v>
                </c:pt>
                <c:pt idx="853">
                  <c:v>5.083333333333333</c:v>
                </c:pt>
                <c:pt idx="854">
                  <c:v>5.0892857142857144</c:v>
                </c:pt>
                <c:pt idx="855">
                  <c:v>5.0952380952380949</c:v>
                </c:pt>
                <c:pt idx="856">
                  <c:v>5.1011904761904763</c:v>
                </c:pt>
                <c:pt idx="857">
                  <c:v>5.1071428571428568</c:v>
                </c:pt>
                <c:pt idx="858">
                  <c:v>5.1130952380952381</c:v>
                </c:pt>
                <c:pt idx="859">
                  <c:v>5.1190476190476186</c:v>
                </c:pt>
                <c:pt idx="860">
                  <c:v>5.125</c:v>
                </c:pt>
                <c:pt idx="861">
                  <c:v>5.1309523809523814</c:v>
                </c:pt>
                <c:pt idx="862">
                  <c:v>5.1369047619047619</c:v>
                </c:pt>
                <c:pt idx="863">
                  <c:v>5.1428571428571432</c:v>
                </c:pt>
                <c:pt idx="864">
                  <c:v>5.1488095238095237</c:v>
                </c:pt>
                <c:pt idx="865">
                  <c:v>5.1547619047619051</c:v>
                </c:pt>
                <c:pt idx="866">
                  <c:v>5.1607142857142856</c:v>
                </c:pt>
                <c:pt idx="867">
                  <c:v>5.166666666666667</c:v>
                </c:pt>
                <c:pt idx="868">
                  <c:v>5.1726190476190474</c:v>
                </c:pt>
                <c:pt idx="869">
                  <c:v>5.1785714285714288</c:v>
                </c:pt>
                <c:pt idx="870">
                  <c:v>5.1845238095238093</c:v>
                </c:pt>
                <c:pt idx="871">
                  <c:v>5.1904761904761907</c:v>
                </c:pt>
                <c:pt idx="872">
                  <c:v>5.1964285714285712</c:v>
                </c:pt>
                <c:pt idx="873">
                  <c:v>5.2023809523809526</c:v>
                </c:pt>
                <c:pt idx="874">
                  <c:v>5.208333333333333</c:v>
                </c:pt>
                <c:pt idx="875">
                  <c:v>5.2142857142857144</c:v>
                </c:pt>
                <c:pt idx="876">
                  <c:v>5.2202380952380949</c:v>
                </c:pt>
                <c:pt idx="877">
                  <c:v>5.2261904761904763</c:v>
                </c:pt>
                <c:pt idx="878">
                  <c:v>5.2321428571428568</c:v>
                </c:pt>
                <c:pt idx="879">
                  <c:v>5.2380952380952381</c:v>
                </c:pt>
                <c:pt idx="880">
                  <c:v>5.2440476190476186</c:v>
                </c:pt>
                <c:pt idx="881">
                  <c:v>5.25</c:v>
                </c:pt>
                <c:pt idx="882">
                  <c:v>5.2559523809523814</c:v>
                </c:pt>
                <c:pt idx="883">
                  <c:v>5.2619047619047619</c:v>
                </c:pt>
                <c:pt idx="884">
                  <c:v>5.2678571428571432</c:v>
                </c:pt>
                <c:pt idx="885">
                  <c:v>5.2738095238095237</c:v>
                </c:pt>
                <c:pt idx="886">
                  <c:v>5.2797619047619051</c:v>
                </c:pt>
                <c:pt idx="887">
                  <c:v>5.2857142857142856</c:v>
                </c:pt>
                <c:pt idx="888">
                  <c:v>5.291666666666667</c:v>
                </c:pt>
                <c:pt idx="889">
                  <c:v>5.2976190476190474</c:v>
                </c:pt>
                <c:pt idx="890">
                  <c:v>5.3035714285714288</c:v>
                </c:pt>
                <c:pt idx="891">
                  <c:v>5.3095238095238093</c:v>
                </c:pt>
                <c:pt idx="892">
                  <c:v>5.3154761904761907</c:v>
                </c:pt>
                <c:pt idx="893">
                  <c:v>5.3214285714285712</c:v>
                </c:pt>
                <c:pt idx="894">
                  <c:v>5.3273809523809526</c:v>
                </c:pt>
                <c:pt idx="895">
                  <c:v>5.333333333333333</c:v>
                </c:pt>
                <c:pt idx="896">
                  <c:v>5.3392857142857144</c:v>
                </c:pt>
                <c:pt idx="897">
                  <c:v>5.3452380952380949</c:v>
                </c:pt>
                <c:pt idx="898">
                  <c:v>5.3511904761904763</c:v>
                </c:pt>
                <c:pt idx="899">
                  <c:v>5.3571428571428568</c:v>
                </c:pt>
                <c:pt idx="900">
                  <c:v>5.3630952380952381</c:v>
                </c:pt>
                <c:pt idx="901">
                  <c:v>5.3690476190476186</c:v>
                </c:pt>
                <c:pt idx="902">
                  <c:v>5.375</c:v>
                </c:pt>
                <c:pt idx="903">
                  <c:v>5.3809523809523814</c:v>
                </c:pt>
                <c:pt idx="904">
                  <c:v>5.3869047619047619</c:v>
                </c:pt>
                <c:pt idx="905">
                  <c:v>5.3928571428571432</c:v>
                </c:pt>
                <c:pt idx="906">
                  <c:v>5.3988095238095237</c:v>
                </c:pt>
                <c:pt idx="907">
                  <c:v>5.4047619047619051</c:v>
                </c:pt>
                <c:pt idx="908">
                  <c:v>5.4107142857142856</c:v>
                </c:pt>
                <c:pt idx="909">
                  <c:v>5.416666666666667</c:v>
                </c:pt>
                <c:pt idx="910">
                  <c:v>5.4226190476190474</c:v>
                </c:pt>
                <c:pt idx="911">
                  <c:v>5.4285714285714288</c:v>
                </c:pt>
                <c:pt idx="912">
                  <c:v>5.4345238095238093</c:v>
                </c:pt>
                <c:pt idx="913">
                  <c:v>5.4404761904761907</c:v>
                </c:pt>
                <c:pt idx="914">
                  <c:v>5.4464285714285712</c:v>
                </c:pt>
                <c:pt idx="915">
                  <c:v>5.4523809523809526</c:v>
                </c:pt>
                <c:pt idx="916">
                  <c:v>5.458333333333333</c:v>
                </c:pt>
                <c:pt idx="917">
                  <c:v>5.4642857142857144</c:v>
                </c:pt>
                <c:pt idx="918">
                  <c:v>5.4702380952380949</c:v>
                </c:pt>
                <c:pt idx="919">
                  <c:v>5.4761904761904763</c:v>
                </c:pt>
                <c:pt idx="920">
                  <c:v>5.4821428571428568</c:v>
                </c:pt>
                <c:pt idx="921">
                  <c:v>5.4880952380952381</c:v>
                </c:pt>
                <c:pt idx="922">
                  <c:v>5.4940476190476186</c:v>
                </c:pt>
                <c:pt idx="923">
                  <c:v>5.5</c:v>
                </c:pt>
                <c:pt idx="924">
                  <c:v>5.5059523809523814</c:v>
                </c:pt>
                <c:pt idx="925">
                  <c:v>5.5119047619047619</c:v>
                </c:pt>
                <c:pt idx="926">
                  <c:v>5.5178571428571432</c:v>
                </c:pt>
                <c:pt idx="927">
                  <c:v>5.5238095238095237</c:v>
                </c:pt>
                <c:pt idx="928">
                  <c:v>5.5297619047619051</c:v>
                </c:pt>
                <c:pt idx="929">
                  <c:v>5.5357142857142856</c:v>
                </c:pt>
                <c:pt idx="930">
                  <c:v>5.541666666666667</c:v>
                </c:pt>
                <c:pt idx="931">
                  <c:v>5.5476190476190474</c:v>
                </c:pt>
                <c:pt idx="932">
                  <c:v>5.5535714285714288</c:v>
                </c:pt>
                <c:pt idx="933">
                  <c:v>5.5595238095238093</c:v>
                </c:pt>
                <c:pt idx="934">
                  <c:v>5.5654761904761907</c:v>
                </c:pt>
                <c:pt idx="935">
                  <c:v>5.5714285714285712</c:v>
                </c:pt>
                <c:pt idx="936">
                  <c:v>5.5773809523809526</c:v>
                </c:pt>
                <c:pt idx="937">
                  <c:v>5.583333333333333</c:v>
                </c:pt>
                <c:pt idx="938">
                  <c:v>5.5892857142857144</c:v>
                </c:pt>
                <c:pt idx="939">
                  <c:v>5.5952380952380949</c:v>
                </c:pt>
                <c:pt idx="940">
                  <c:v>5.6011904761904763</c:v>
                </c:pt>
                <c:pt idx="941">
                  <c:v>5.6071428571428568</c:v>
                </c:pt>
                <c:pt idx="942">
                  <c:v>5.6130952380952381</c:v>
                </c:pt>
                <c:pt idx="943">
                  <c:v>5.6190476190476186</c:v>
                </c:pt>
                <c:pt idx="944">
                  <c:v>5.625</c:v>
                </c:pt>
                <c:pt idx="945">
                  <c:v>5.6309523809523814</c:v>
                </c:pt>
                <c:pt idx="946">
                  <c:v>5.6369047619047619</c:v>
                </c:pt>
                <c:pt idx="947">
                  <c:v>5.6428571428571432</c:v>
                </c:pt>
                <c:pt idx="948">
                  <c:v>5.6488095238095237</c:v>
                </c:pt>
                <c:pt idx="949">
                  <c:v>5.6547619047619051</c:v>
                </c:pt>
                <c:pt idx="950">
                  <c:v>5.6607142857142856</c:v>
                </c:pt>
                <c:pt idx="951">
                  <c:v>5.666666666666667</c:v>
                </c:pt>
                <c:pt idx="952">
                  <c:v>5.6726190476190474</c:v>
                </c:pt>
                <c:pt idx="953">
                  <c:v>5.6785714285714288</c:v>
                </c:pt>
                <c:pt idx="954">
                  <c:v>5.6845238095238093</c:v>
                </c:pt>
                <c:pt idx="955">
                  <c:v>5.6904761904761907</c:v>
                </c:pt>
                <c:pt idx="956">
                  <c:v>5.6964285714285712</c:v>
                </c:pt>
                <c:pt idx="957">
                  <c:v>5.7023809523809526</c:v>
                </c:pt>
                <c:pt idx="958">
                  <c:v>5.708333333333333</c:v>
                </c:pt>
                <c:pt idx="959">
                  <c:v>5.7142857142857144</c:v>
                </c:pt>
                <c:pt idx="960">
                  <c:v>5.7202380952380949</c:v>
                </c:pt>
                <c:pt idx="961">
                  <c:v>5.7261904761904763</c:v>
                </c:pt>
                <c:pt idx="962">
                  <c:v>5.7321428571428568</c:v>
                </c:pt>
                <c:pt idx="963">
                  <c:v>5.7380952380952381</c:v>
                </c:pt>
                <c:pt idx="964">
                  <c:v>5.7440476190476186</c:v>
                </c:pt>
                <c:pt idx="965">
                  <c:v>5.75</c:v>
                </c:pt>
                <c:pt idx="966">
                  <c:v>5.7559523809523814</c:v>
                </c:pt>
                <c:pt idx="967">
                  <c:v>5.7619047619047619</c:v>
                </c:pt>
                <c:pt idx="968">
                  <c:v>5.7678571428571432</c:v>
                </c:pt>
                <c:pt idx="969">
                  <c:v>5.7738095238095237</c:v>
                </c:pt>
                <c:pt idx="970">
                  <c:v>5.7797619047619051</c:v>
                </c:pt>
                <c:pt idx="971">
                  <c:v>5.7857142857142856</c:v>
                </c:pt>
                <c:pt idx="972">
                  <c:v>5.791666666666667</c:v>
                </c:pt>
                <c:pt idx="973">
                  <c:v>5.7976190476190474</c:v>
                </c:pt>
                <c:pt idx="974">
                  <c:v>5.8035714285714288</c:v>
                </c:pt>
                <c:pt idx="975">
                  <c:v>5.8095238095238093</c:v>
                </c:pt>
                <c:pt idx="976">
                  <c:v>5.8154761904761907</c:v>
                </c:pt>
                <c:pt idx="977">
                  <c:v>5.8214285714285712</c:v>
                </c:pt>
                <c:pt idx="978">
                  <c:v>5.8273809523809526</c:v>
                </c:pt>
                <c:pt idx="979">
                  <c:v>5.833333333333333</c:v>
                </c:pt>
                <c:pt idx="980">
                  <c:v>5.8392857142857144</c:v>
                </c:pt>
                <c:pt idx="981">
                  <c:v>5.8452380952380949</c:v>
                </c:pt>
                <c:pt idx="982">
                  <c:v>5.8511904761904763</c:v>
                </c:pt>
                <c:pt idx="983">
                  <c:v>5.8571428571428568</c:v>
                </c:pt>
                <c:pt idx="984">
                  <c:v>5.8630952380952381</c:v>
                </c:pt>
                <c:pt idx="985">
                  <c:v>5.8690476190476186</c:v>
                </c:pt>
                <c:pt idx="986">
                  <c:v>5.875</c:v>
                </c:pt>
                <c:pt idx="987">
                  <c:v>5.8809523809523814</c:v>
                </c:pt>
                <c:pt idx="988">
                  <c:v>5.8869047619047619</c:v>
                </c:pt>
                <c:pt idx="989">
                  <c:v>5.8928571428571432</c:v>
                </c:pt>
                <c:pt idx="990">
                  <c:v>5.8988095238095237</c:v>
                </c:pt>
                <c:pt idx="991">
                  <c:v>5.9047619047619051</c:v>
                </c:pt>
                <c:pt idx="992">
                  <c:v>5.9107142857142856</c:v>
                </c:pt>
                <c:pt idx="993">
                  <c:v>5.916666666666667</c:v>
                </c:pt>
                <c:pt idx="994">
                  <c:v>5.9226190476190474</c:v>
                </c:pt>
                <c:pt idx="995">
                  <c:v>5.9285714285714288</c:v>
                </c:pt>
                <c:pt idx="996">
                  <c:v>5.9345238095238093</c:v>
                </c:pt>
                <c:pt idx="997">
                  <c:v>5.9404761904761907</c:v>
                </c:pt>
                <c:pt idx="998">
                  <c:v>5.9464285714285712</c:v>
                </c:pt>
                <c:pt idx="999">
                  <c:v>5.9523809523809526</c:v>
                </c:pt>
                <c:pt idx="1000">
                  <c:v>5.958333333333333</c:v>
                </c:pt>
                <c:pt idx="1001">
                  <c:v>5.9642857142857144</c:v>
                </c:pt>
                <c:pt idx="1002">
                  <c:v>5.9702380952380949</c:v>
                </c:pt>
                <c:pt idx="1003">
                  <c:v>5.9761904761904763</c:v>
                </c:pt>
                <c:pt idx="1004">
                  <c:v>5.9821428571428568</c:v>
                </c:pt>
                <c:pt idx="1005">
                  <c:v>5.9880952380952381</c:v>
                </c:pt>
                <c:pt idx="1006">
                  <c:v>5.9940476190476186</c:v>
                </c:pt>
                <c:pt idx="1007">
                  <c:v>6</c:v>
                </c:pt>
                <c:pt idx="1008">
                  <c:v>6.0059523809523814</c:v>
                </c:pt>
                <c:pt idx="1009">
                  <c:v>6.0119047619047619</c:v>
                </c:pt>
                <c:pt idx="1010">
                  <c:v>6.0178571428571432</c:v>
                </c:pt>
                <c:pt idx="1011">
                  <c:v>6.0238095238095237</c:v>
                </c:pt>
                <c:pt idx="1012">
                  <c:v>6.0297619047619051</c:v>
                </c:pt>
                <c:pt idx="1013">
                  <c:v>6.0357142857142856</c:v>
                </c:pt>
                <c:pt idx="1014">
                  <c:v>6.041666666666667</c:v>
                </c:pt>
                <c:pt idx="1015">
                  <c:v>6.0476190476190474</c:v>
                </c:pt>
                <c:pt idx="1016">
                  <c:v>6.0535714285714288</c:v>
                </c:pt>
                <c:pt idx="1017">
                  <c:v>6.0595238095238093</c:v>
                </c:pt>
                <c:pt idx="1018">
                  <c:v>6.0654761904761907</c:v>
                </c:pt>
                <c:pt idx="1019">
                  <c:v>6.0714285714285712</c:v>
                </c:pt>
                <c:pt idx="1020">
                  <c:v>6.0773809523809526</c:v>
                </c:pt>
                <c:pt idx="1021">
                  <c:v>6.083333333333333</c:v>
                </c:pt>
                <c:pt idx="1022">
                  <c:v>6.0892857142857144</c:v>
                </c:pt>
                <c:pt idx="1023">
                  <c:v>6.0952380952380949</c:v>
                </c:pt>
                <c:pt idx="1024">
                  <c:v>6.1011904761904763</c:v>
                </c:pt>
                <c:pt idx="1025">
                  <c:v>6.1071428571428568</c:v>
                </c:pt>
                <c:pt idx="1026">
                  <c:v>6.1130952380952381</c:v>
                </c:pt>
                <c:pt idx="1027">
                  <c:v>6.1190476190476186</c:v>
                </c:pt>
                <c:pt idx="1028">
                  <c:v>6.125</c:v>
                </c:pt>
                <c:pt idx="1029">
                  <c:v>6.1309523809523814</c:v>
                </c:pt>
                <c:pt idx="1030">
                  <c:v>6.1369047619047619</c:v>
                </c:pt>
                <c:pt idx="1031">
                  <c:v>6.1428571428571432</c:v>
                </c:pt>
                <c:pt idx="1032">
                  <c:v>6.1488095238095237</c:v>
                </c:pt>
                <c:pt idx="1033">
                  <c:v>6.1547619047619051</c:v>
                </c:pt>
                <c:pt idx="1034">
                  <c:v>6.1607142857142856</c:v>
                </c:pt>
                <c:pt idx="1035">
                  <c:v>6.166666666666667</c:v>
                </c:pt>
                <c:pt idx="1036">
                  <c:v>6.1726190476190474</c:v>
                </c:pt>
                <c:pt idx="1037">
                  <c:v>6.1785714285714288</c:v>
                </c:pt>
                <c:pt idx="1038">
                  <c:v>6.1845238095238093</c:v>
                </c:pt>
                <c:pt idx="1039">
                  <c:v>6.1904761904761907</c:v>
                </c:pt>
                <c:pt idx="1040">
                  <c:v>6.1964285714285712</c:v>
                </c:pt>
                <c:pt idx="1041">
                  <c:v>6.2023809523809526</c:v>
                </c:pt>
                <c:pt idx="1042">
                  <c:v>6.208333333333333</c:v>
                </c:pt>
                <c:pt idx="1043">
                  <c:v>6.2142857142857144</c:v>
                </c:pt>
                <c:pt idx="1044">
                  <c:v>6.2202380952380949</c:v>
                </c:pt>
                <c:pt idx="1045">
                  <c:v>6.2261904761904763</c:v>
                </c:pt>
                <c:pt idx="1046">
                  <c:v>6.2321428571428568</c:v>
                </c:pt>
                <c:pt idx="1047">
                  <c:v>6.2380952380952381</c:v>
                </c:pt>
                <c:pt idx="1048">
                  <c:v>6.2440476190476186</c:v>
                </c:pt>
                <c:pt idx="1049">
                  <c:v>6.25</c:v>
                </c:pt>
                <c:pt idx="1050">
                  <c:v>6.2559523809523814</c:v>
                </c:pt>
                <c:pt idx="1051">
                  <c:v>6.2619047619047619</c:v>
                </c:pt>
                <c:pt idx="1052">
                  <c:v>6.2678571428571432</c:v>
                </c:pt>
                <c:pt idx="1053">
                  <c:v>6.2738095238095237</c:v>
                </c:pt>
                <c:pt idx="1054">
                  <c:v>6.2797619047619051</c:v>
                </c:pt>
                <c:pt idx="1055">
                  <c:v>6.2857142857142856</c:v>
                </c:pt>
                <c:pt idx="1056">
                  <c:v>6.291666666666667</c:v>
                </c:pt>
                <c:pt idx="1057">
                  <c:v>6.2976190476190474</c:v>
                </c:pt>
                <c:pt idx="1058">
                  <c:v>6.3035714285714288</c:v>
                </c:pt>
                <c:pt idx="1059">
                  <c:v>6.3095238095238093</c:v>
                </c:pt>
                <c:pt idx="1060">
                  <c:v>6.3154761904761907</c:v>
                </c:pt>
                <c:pt idx="1061">
                  <c:v>6.3214285714285712</c:v>
                </c:pt>
                <c:pt idx="1062">
                  <c:v>6.3273809523809526</c:v>
                </c:pt>
                <c:pt idx="1063">
                  <c:v>6.333333333333333</c:v>
                </c:pt>
                <c:pt idx="1064">
                  <c:v>6.3392857142857144</c:v>
                </c:pt>
                <c:pt idx="1065">
                  <c:v>6.3452380952380949</c:v>
                </c:pt>
                <c:pt idx="1066">
                  <c:v>6.3511904761904763</c:v>
                </c:pt>
                <c:pt idx="1067">
                  <c:v>6.3571428571428568</c:v>
                </c:pt>
                <c:pt idx="1068">
                  <c:v>6.3630952380952381</c:v>
                </c:pt>
                <c:pt idx="1069">
                  <c:v>6.3690476190476186</c:v>
                </c:pt>
                <c:pt idx="1070">
                  <c:v>6.375</c:v>
                </c:pt>
                <c:pt idx="1071">
                  <c:v>6.3809523809523814</c:v>
                </c:pt>
                <c:pt idx="1072">
                  <c:v>6.3869047619047619</c:v>
                </c:pt>
                <c:pt idx="1073">
                  <c:v>6.3928571428571432</c:v>
                </c:pt>
                <c:pt idx="1074">
                  <c:v>6.3988095238095237</c:v>
                </c:pt>
                <c:pt idx="1075">
                  <c:v>6.4047619047619051</c:v>
                </c:pt>
                <c:pt idx="1076">
                  <c:v>6.4107142857142856</c:v>
                </c:pt>
                <c:pt idx="1077">
                  <c:v>6.416666666666667</c:v>
                </c:pt>
                <c:pt idx="1078">
                  <c:v>6.4226190476190474</c:v>
                </c:pt>
                <c:pt idx="1079">
                  <c:v>6.4285714285714288</c:v>
                </c:pt>
                <c:pt idx="1080">
                  <c:v>6.4345238095238093</c:v>
                </c:pt>
                <c:pt idx="1081">
                  <c:v>6.4404761904761907</c:v>
                </c:pt>
                <c:pt idx="1082">
                  <c:v>6.4464285714285712</c:v>
                </c:pt>
                <c:pt idx="1083">
                  <c:v>6.4523809523809526</c:v>
                </c:pt>
                <c:pt idx="1084">
                  <c:v>6.458333333333333</c:v>
                </c:pt>
                <c:pt idx="1085">
                  <c:v>6.4642857142857144</c:v>
                </c:pt>
                <c:pt idx="1086">
                  <c:v>6.4702380952380949</c:v>
                </c:pt>
                <c:pt idx="1087">
                  <c:v>6.4761904761904763</c:v>
                </c:pt>
                <c:pt idx="1088">
                  <c:v>6.4821428571428568</c:v>
                </c:pt>
                <c:pt idx="1089">
                  <c:v>6.4880952380952381</c:v>
                </c:pt>
                <c:pt idx="1090">
                  <c:v>6.4940476190476186</c:v>
                </c:pt>
                <c:pt idx="1091">
                  <c:v>6.5</c:v>
                </c:pt>
                <c:pt idx="1092">
                  <c:v>6.5059523809523814</c:v>
                </c:pt>
                <c:pt idx="1093">
                  <c:v>6.5119047619047619</c:v>
                </c:pt>
                <c:pt idx="1094">
                  <c:v>6.5178571428571432</c:v>
                </c:pt>
                <c:pt idx="1095">
                  <c:v>6.5238095238095237</c:v>
                </c:pt>
                <c:pt idx="1096">
                  <c:v>6.5297619047619051</c:v>
                </c:pt>
                <c:pt idx="1097">
                  <c:v>6.5357142857142856</c:v>
                </c:pt>
                <c:pt idx="1098">
                  <c:v>6.541666666666667</c:v>
                </c:pt>
                <c:pt idx="1099">
                  <c:v>6.5476190476190474</c:v>
                </c:pt>
                <c:pt idx="1100">
                  <c:v>6.5535714285714288</c:v>
                </c:pt>
                <c:pt idx="1101">
                  <c:v>6.5595238095238093</c:v>
                </c:pt>
                <c:pt idx="1102">
                  <c:v>6.5654761904761907</c:v>
                </c:pt>
                <c:pt idx="1103">
                  <c:v>6.5714285714285712</c:v>
                </c:pt>
                <c:pt idx="1104">
                  <c:v>6.5773809523809526</c:v>
                </c:pt>
                <c:pt idx="1105">
                  <c:v>6.583333333333333</c:v>
                </c:pt>
                <c:pt idx="1106">
                  <c:v>6.5892857142857144</c:v>
                </c:pt>
                <c:pt idx="1107">
                  <c:v>6.5952380952380949</c:v>
                </c:pt>
                <c:pt idx="1108">
                  <c:v>6.6011904761904763</c:v>
                </c:pt>
                <c:pt idx="1109">
                  <c:v>6.6071428571428568</c:v>
                </c:pt>
                <c:pt idx="1110">
                  <c:v>6.6130952380952381</c:v>
                </c:pt>
                <c:pt idx="1111">
                  <c:v>6.6190476190476186</c:v>
                </c:pt>
                <c:pt idx="1112">
                  <c:v>6.625</c:v>
                </c:pt>
                <c:pt idx="1113">
                  <c:v>6.6309523809523814</c:v>
                </c:pt>
                <c:pt idx="1114">
                  <c:v>6.6369047619047619</c:v>
                </c:pt>
                <c:pt idx="1115">
                  <c:v>6.6428571428571432</c:v>
                </c:pt>
                <c:pt idx="1116">
                  <c:v>6.6488095238095237</c:v>
                </c:pt>
                <c:pt idx="1117">
                  <c:v>6.6547619047619051</c:v>
                </c:pt>
                <c:pt idx="1118">
                  <c:v>6.6607142857142856</c:v>
                </c:pt>
                <c:pt idx="1119">
                  <c:v>6.666666666666667</c:v>
                </c:pt>
                <c:pt idx="1120">
                  <c:v>6.6726190476190474</c:v>
                </c:pt>
                <c:pt idx="1121">
                  <c:v>6.6785714285714288</c:v>
                </c:pt>
                <c:pt idx="1122">
                  <c:v>6.6845238095238093</c:v>
                </c:pt>
                <c:pt idx="1123">
                  <c:v>6.6904761904761907</c:v>
                </c:pt>
                <c:pt idx="1124">
                  <c:v>6.6964285714285712</c:v>
                </c:pt>
                <c:pt idx="1125">
                  <c:v>6.7023809523809526</c:v>
                </c:pt>
                <c:pt idx="1126">
                  <c:v>6.708333333333333</c:v>
                </c:pt>
                <c:pt idx="1127">
                  <c:v>6.7142857142857144</c:v>
                </c:pt>
                <c:pt idx="1128">
                  <c:v>6.7202380952380949</c:v>
                </c:pt>
                <c:pt idx="1129">
                  <c:v>6.7261904761904763</c:v>
                </c:pt>
                <c:pt idx="1130">
                  <c:v>6.7321428571428568</c:v>
                </c:pt>
                <c:pt idx="1131">
                  <c:v>6.7380952380952381</c:v>
                </c:pt>
                <c:pt idx="1132">
                  <c:v>6.7440476190476186</c:v>
                </c:pt>
                <c:pt idx="1133">
                  <c:v>6.75</c:v>
                </c:pt>
                <c:pt idx="1134">
                  <c:v>6.7559523809523814</c:v>
                </c:pt>
                <c:pt idx="1135">
                  <c:v>6.7619047619047619</c:v>
                </c:pt>
                <c:pt idx="1136">
                  <c:v>6.7678571428571432</c:v>
                </c:pt>
                <c:pt idx="1137">
                  <c:v>6.7738095238095237</c:v>
                </c:pt>
                <c:pt idx="1138">
                  <c:v>6.7797619047619051</c:v>
                </c:pt>
                <c:pt idx="1139">
                  <c:v>6.7857142857142856</c:v>
                </c:pt>
                <c:pt idx="1140">
                  <c:v>6.791666666666667</c:v>
                </c:pt>
                <c:pt idx="1141">
                  <c:v>6.7976190476190474</c:v>
                </c:pt>
                <c:pt idx="1142">
                  <c:v>6.8035714285714288</c:v>
                </c:pt>
                <c:pt idx="1143">
                  <c:v>6.8095238095238093</c:v>
                </c:pt>
                <c:pt idx="1144">
                  <c:v>6.8154761904761907</c:v>
                </c:pt>
                <c:pt idx="1145">
                  <c:v>6.8214285714285712</c:v>
                </c:pt>
                <c:pt idx="1146">
                  <c:v>6.8273809523809526</c:v>
                </c:pt>
                <c:pt idx="1147">
                  <c:v>6.833333333333333</c:v>
                </c:pt>
                <c:pt idx="1148">
                  <c:v>6.8392857142857144</c:v>
                </c:pt>
                <c:pt idx="1149">
                  <c:v>6.8452380952380949</c:v>
                </c:pt>
                <c:pt idx="1150">
                  <c:v>6.8511904761904763</c:v>
                </c:pt>
                <c:pt idx="1151">
                  <c:v>6.8571428571428568</c:v>
                </c:pt>
                <c:pt idx="1152">
                  <c:v>6.8630952380952381</c:v>
                </c:pt>
                <c:pt idx="1153">
                  <c:v>6.8690476190476186</c:v>
                </c:pt>
                <c:pt idx="1154">
                  <c:v>6.875</c:v>
                </c:pt>
                <c:pt idx="1155">
                  <c:v>6.8809523809523814</c:v>
                </c:pt>
                <c:pt idx="1156">
                  <c:v>6.8869047619047619</c:v>
                </c:pt>
                <c:pt idx="1157">
                  <c:v>6.8928571428571432</c:v>
                </c:pt>
                <c:pt idx="1158">
                  <c:v>6.8988095238095237</c:v>
                </c:pt>
                <c:pt idx="1159">
                  <c:v>6.9047619047619051</c:v>
                </c:pt>
                <c:pt idx="1160">
                  <c:v>6.9107142857142856</c:v>
                </c:pt>
                <c:pt idx="1161">
                  <c:v>6.916666666666667</c:v>
                </c:pt>
                <c:pt idx="1162">
                  <c:v>6.9226190476190474</c:v>
                </c:pt>
                <c:pt idx="1163">
                  <c:v>6.9285714285714288</c:v>
                </c:pt>
                <c:pt idx="1164">
                  <c:v>6.9345238095238093</c:v>
                </c:pt>
                <c:pt idx="1165">
                  <c:v>6.9404761904761907</c:v>
                </c:pt>
                <c:pt idx="1166">
                  <c:v>6.9464285714285712</c:v>
                </c:pt>
                <c:pt idx="1167">
                  <c:v>6.9523809523809526</c:v>
                </c:pt>
                <c:pt idx="1168">
                  <c:v>6.958333333333333</c:v>
                </c:pt>
                <c:pt idx="1169">
                  <c:v>6.9642857142857144</c:v>
                </c:pt>
                <c:pt idx="1170">
                  <c:v>6.9702380952380949</c:v>
                </c:pt>
                <c:pt idx="1171">
                  <c:v>6.9761904761904763</c:v>
                </c:pt>
                <c:pt idx="1172">
                  <c:v>6.9821428571428568</c:v>
                </c:pt>
                <c:pt idx="1173">
                  <c:v>6.9880952380952381</c:v>
                </c:pt>
                <c:pt idx="1174">
                  <c:v>6.9940476190476186</c:v>
                </c:pt>
                <c:pt idx="1175">
                  <c:v>7</c:v>
                </c:pt>
                <c:pt idx="1176">
                  <c:v>7.0059523809523814</c:v>
                </c:pt>
                <c:pt idx="1177">
                  <c:v>7.0119047619047619</c:v>
                </c:pt>
                <c:pt idx="1178">
                  <c:v>7.0178571428571432</c:v>
                </c:pt>
                <c:pt idx="1179">
                  <c:v>7.0238095238095237</c:v>
                </c:pt>
                <c:pt idx="1180">
                  <c:v>7.0297619047619051</c:v>
                </c:pt>
                <c:pt idx="1181">
                  <c:v>7.0357142857142856</c:v>
                </c:pt>
                <c:pt idx="1182">
                  <c:v>7.041666666666667</c:v>
                </c:pt>
                <c:pt idx="1183">
                  <c:v>7.0476190476190474</c:v>
                </c:pt>
                <c:pt idx="1184">
                  <c:v>7.0535714285714288</c:v>
                </c:pt>
                <c:pt idx="1185">
                  <c:v>7.0595238095238093</c:v>
                </c:pt>
                <c:pt idx="1186">
                  <c:v>7.0654761904761907</c:v>
                </c:pt>
                <c:pt idx="1187">
                  <c:v>7.0714285714285712</c:v>
                </c:pt>
                <c:pt idx="1188">
                  <c:v>7.0773809523809526</c:v>
                </c:pt>
                <c:pt idx="1189">
                  <c:v>7.083333333333333</c:v>
                </c:pt>
                <c:pt idx="1190">
                  <c:v>7.0892857142857144</c:v>
                </c:pt>
                <c:pt idx="1191">
                  <c:v>7.0952380952380949</c:v>
                </c:pt>
                <c:pt idx="1192">
                  <c:v>7.1011904761904763</c:v>
                </c:pt>
                <c:pt idx="1193">
                  <c:v>7.1071428571428568</c:v>
                </c:pt>
                <c:pt idx="1194">
                  <c:v>7.1130952380952381</c:v>
                </c:pt>
                <c:pt idx="1195">
                  <c:v>7.1190476190476186</c:v>
                </c:pt>
                <c:pt idx="1196">
                  <c:v>7.125</c:v>
                </c:pt>
                <c:pt idx="1197">
                  <c:v>7.1309523809523814</c:v>
                </c:pt>
                <c:pt idx="1198">
                  <c:v>7.1369047619047619</c:v>
                </c:pt>
                <c:pt idx="1199">
                  <c:v>7.1428571428571432</c:v>
                </c:pt>
                <c:pt idx="1200">
                  <c:v>7.1488095238095237</c:v>
                </c:pt>
                <c:pt idx="1201">
                  <c:v>7.1547619047619051</c:v>
                </c:pt>
                <c:pt idx="1202">
                  <c:v>7.1607142857142856</c:v>
                </c:pt>
                <c:pt idx="1203">
                  <c:v>7.166666666666667</c:v>
                </c:pt>
                <c:pt idx="1204">
                  <c:v>7.1726190476190474</c:v>
                </c:pt>
                <c:pt idx="1205">
                  <c:v>7.1785714285714288</c:v>
                </c:pt>
                <c:pt idx="1206">
                  <c:v>7.1845238095238093</c:v>
                </c:pt>
                <c:pt idx="1207">
                  <c:v>7.1904761904761907</c:v>
                </c:pt>
                <c:pt idx="1208">
                  <c:v>7.1964285714285712</c:v>
                </c:pt>
                <c:pt idx="1209">
                  <c:v>7.2023809523809526</c:v>
                </c:pt>
                <c:pt idx="1210">
                  <c:v>7.208333333333333</c:v>
                </c:pt>
                <c:pt idx="1211">
                  <c:v>7.2142857142857144</c:v>
                </c:pt>
                <c:pt idx="1212">
                  <c:v>7.2202380952380949</c:v>
                </c:pt>
                <c:pt idx="1213">
                  <c:v>7.2261904761904763</c:v>
                </c:pt>
                <c:pt idx="1214">
                  <c:v>7.2321428571428568</c:v>
                </c:pt>
                <c:pt idx="1215">
                  <c:v>7.2380952380952381</c:v>
                </c:pt>
                <c:pt idx="1216">
                  <c:v>7.2440476190476186</c:v>
                </c:pt>
                <c:pt idx="1217">
                  <c:v>7.25</c:v>
                </c:pt>
                <c:pt idx="1218">
                  <c:v>7.2559523809523814</c:v>
                </c:pt>
                <c:pt idx="1219">
                  <c:v>7.2619047619047619</c:v>
                </c:pt>
                <c:pt idx="1220">
                  <c:v>7.2678571428571432</c:v>
                </c:pt>
                <c:pt idx="1221">
                  <c:v>7.2738095238095237</c:v>
                </c:pt>
                <c:pt idx="1222">
                  <c:v>7.2797619047619051</c:v>
                </c:pt>
                <c:pt idx="1223">
                  <c:v>7.2857142857142856</c:v>
                </c:pt>
                <c:pt idx="1224">
                  <c:v>7.291666666666667</c:v>
                </c:pt>
                <c:pt idx="1225">
                  <c:v>7.2976190476190474</c:v>
                </c:pt>
                <c:pt idx="1226">
                  <c:v>7.3035714285714288</c:v>
                </c:pt>
                <c:pt idx="1227">
                  <c:v>7.3095238095238093</c:v>
                </c:pt>
                <c:pt idx="1228">
                  <c:v>7.3154761904761907</c:v>
                </c:pt>
                <c:pt idx="1229">
                  <c:v>7.3214285714285712</c:v>
                </c:pt>
                <c:pt idx="1230">
                  <c:v>7.3273809523809526</c:v>
                </c:pt>
                <c:pt idx="1231">
                  <c:v>7.333333333333333</c:v>
                </c:pt>
                <c:pt idx="1232">
                  <c:v>7.3392857142857144</c:v>
                </c:pt>
                <c:pt idx="1233">
                  <c:v>7.3452380952380949</c:v>
                </c:pt>
                <c:pt idx="1234">
                  <c:v>7.3511904761904763</c:v>
                </c:pt>
                <c:pt idx="1235">
                  <c:v>7.3571428571428568</c:v>
                </c:pt>
                <c:pt idx="1236">
                  <c:v>7.3630952380952381</c:v>
                </c:pt>
                <c:pt idx="1237">
                  <c:v>7.3690476190476186</c:v>
                </c:pt>
                <c:pt idx="1238">
                  <c:v>7.375</c:v>
                </c:pt>
                <c:pt idx="1239">
                  <c:v>7.3809523809523814</c:v>
                </c:pt>
                <c:pt idx="1240">
                  <c:v>7.3869047619047619</c:v>
                </c:pt>
                <c:pt idx="1241">
                  <c:v>7.3928571428571432</c:v>
                </c:pt>
                <c:pt idx="1242">
                  <c:v>7.3988095238095237</c:v>
                </c:pt>
                <c:pt idx="1243">
                  <c:v>7.4047619047619051</c:v>
                </c:pt>
                <c:pt idx="1244">
                  <c:v>7.4107142857142856</c:v>
                </c:pt>
                <c:pt idx="1245">
                  <c:v>7.416666666666667</c:v>
                </c:pt>
                <c:pt idx="1246">
                  <c:v>7.4226190476190474</c:v>
                </c:pt>
                <c:pt idx="1247">
                  <c:v>7.4285714285714288</c:v>
                </c:pt>
                <c:pt idx="1248">
                  <c:v>7.4345238095238093</c:v>
                </c:pt>
                <c:pt idx="1249">
                  <c:v>7.4404761904761907</c:v>
                </c:pt>
                <c:pt idx="1250">
                  <c:v>7.4464285714285712</c:v>
                </c:pt>
                <c:pt idx="1251">
                  <c:v>7.4523809523809526</c:v>
                </c:pt>
                <c:pt idx="1252">
                  <c:v>7.458333333333333</c:v>
                </c:pt>
                <c:pt idx="1253">
                  <c:v>7.4642857142857144</c:v>
                </c:pt>
                <c:pt idx="1254">
                  <c:v>7.4702380952380949</c:v>
                </c:pt>
                <c:pt idx="1255">
                  <c:v>7.4761904761904763</c:v>
                </c:pt>
                <c:pt idx="1256">
                  <c:v>7.4821428571428568</c:v>
                </c:pt>
                <c:pt idx="1257">
                  <c:v>7.4880952380952381</c:v>
                </c:pt>
                <c:pt idx="1258">
                  <c:v>7.4940476190476186</c:v>
                </c:pt>
                <c:pt idx="1259">
                  <c:v>7.5</c:v>
                </c:pt>
                <c:pt idx="1260">
                  <c:v>7.5059523809523814</c:v>
                </c:pt>
                <c:pt idx="1261">
                  <c:v>7.5119047619047619</c:v>
                </c:pt>
                <c:pt idx="1262">
                  <c:v>7.5178571428571432</c:v>
                </c:pt>
                <c:pt idx="1263">
                  <c:v>7.5238095238095237</c:v>
                </c:pt>
                <c:pt idx="1264">
                  <c:v>7.5297619047619051</c:v>
                </c:pt>
                <c:pt idx="1265">
                  <c:v>7.5357142857142856</c:v>
                </c:pt>
                <c:pt idx="1266">
                  <c:v>7.541666666666667</c:v>
                </c:pt>
                <c:pt idx="1267">
                  <c:v>7.5476190476190474</c:v>
                </c:pt>
                <c:pt idx="1268">
                  <c:v>7.5535714285714288</c:v>
                </c:pt>
                <c:pt idx="1269">
                  <c:v>7.5595238095238093</c:v>
                </c:pt>
                <c:pt idx="1270">
                  <c:v>7.5654761904761907</c:v>
                </c:pt>
                <c:pt idx="1271">
                  <c:v>7.5714285714285712</c:v>
                </c:pt>
                <c:pt idx="1272">
                  <c:v>7.5773809523809526</c:v>
                </c:pt>
                <c:pt idx="1273">
                  <c:v>7.583333333333333</c:v>
                </c:pt>
                <c:pt idx="1274">
                  <c:v>7.5892857142857144</c:v>
                </c:pt>
                <c:pt idx="1275">
                  <c:v>7.5952380952380949</c:v>
                </c:pt>
                <c:pt idx="1276">
                  <c:v>7.6011904761904763</c:v>
                </c:pt>
                <c:pt idx="1277">
                  <c:v>7.6071428571428568</c:v>
                </c:pt>
                <c:pt idx="1278">
                  <c:v>7.6130952380952381</c:v>
                </c:pt>
                <c:pt idx="1279">
                  <c:v>7.6190476190476186</c:v>
                </c:pt>
                <c:pt idx="1280">
                  <c:v>7.625</c:v>
                </c:pt>
                <c:pt idx="1281">
                  <c:v>7.6309523809523814</c:v>
                </c:pt>
                <c:pt idx="1282">
                  <c:v>7.6369047619047619</c:v>
                </c:pt>
                <c:pt idx="1283">
                  <c:v>7.6428571428571432</c:v>
                </c:pt>
                <c:pt idx="1284">
                  <c:v>7.6488095238095237</c:v>
                </c:pt>
                <c:pt idx="1285">
                  <c:v>7.6547619047619051</c:v>
                </c:pt>
                <c:pt idx="1286">
                  <c:v>7.6607142857142856</c:v>
                </c:pt>
                <c:pt idx="1287">
                  <c:v>7.666666666666667</c:v>
                </c:pt>
                <c:pt idx="1288">
                  <c:v>7.6726190476190474</c:v>
                </c:pt>
                <c:pt idx="1289">
                  <c:v>7.6785714285714288</c:v>
                </c:pt>
                <c:pt idx="1290">
                  <c:v>7.6845238095238093</c:v>
                </c:pt>
                <c:pt idx="1291">
                  <c:v>7.6904761904761907</c:v>
                </c:pt>
                <c:pt idx="1292">
                  <c:v>7.6964285714285712</c:v>
                </c:pt>
                <c:pt idx="1293">
                  <c:v>7.7023809523809526</c:v>
                </c:pt>
                <c:pt idx="1294">
                  <c:v>7.708333333333333</c:v>
                </c:pt>
                <c:pt idx="1295">
                  <c:v>7.7142857142857144</c:v>
                </c:pt>
                <c:pt idx="1296">
                  <c:v>7.7202380952380949</c:v>
                </c:pt>
                <c:pt idx="1297">
                  <c:v>7.7261904761904763</c:v>
                </c:pt>
                <c:pt idx="1298">
                  <c:v>7.7321428571428568</c:v>
                </c:pt>
                <c:pt idx="1299">
                  <c:v>7.7380952380952381</c:v>
                </c:pt>
                <c:pt idx="1300">
                  <c:v>7.7440476190476186</c:v>
                </c:pt>
                <c:pt idx="1301">
                  <c:v>7.75</c:v>
                </c:pt>
                <c:pt idx="1302">
                  <c:v>7.7559523809523814</c:v>
                </c:pt>
                <c:pt idx="1303">
                  <c:v>7.7619047619047619</c:v>
                </c:pt>
                <c:pt idx="1304">
                  <c:v>7.7678571428571432</c:v>
                </c:pt>
                <c:pt idx="1305">
                  <c:v>7.7738095238095237</c:v>
                </c:pt>
                <c:pt idx="1306">
                  <c:v>7.7797619047619051</c:v>
                </c:pt>
                <c:pt idx="1307">
                  <c:v>7.7857142857142856</c:v>
                </c:pt>
                <c:pt idx="1308">
                  <c:v>7.791666666666667</c:v>
                </c:pt>
                <c:pt idx="1309">
                  <c:v>7.7976190476190474</c:v>
                </c:pt>
                <c:pt idx="1310">
                  <c:v>7.8035714285714288</c:v>
                </c:pt>
                <c:pt idx="1311">
                  <c:v>7.8095238095238093</c:v>
                </c:pt>
                <c:pt idx="1312">
                  <c:v>7.8154761904761907</c:v>
                </c:pt>
                <c:pt idx="1313">
                  <c:v>7.8214285714285712</c:v>
                </c:pt>
                <c:pt idx="1314">
                  <c:v>7.8273809523809526</c:v>
                </c:pt>
                <c:pt idx="1315">
                  <c:v>7.833333333333333</c:v>
                </c:pt>
                <c:pt idx="1316">
                  <c:v>7.8392857142857144</c:v>
                </c:pt>
                <c:pt idx="1317">
                  <c:v>7.8452380952380949</c:v>
                </c:pt>
                <c:pt idx="1318">
                  <c:v>7.8511904761904763</c:v>
                </c:pt>
                <c:pt idx="1319">
                  <c:v>7.8571428571428568</c:v>
                </c:pt>
                <c:pt idx="1320">
                  <c:v>7.8630952380952381</c:v>
                </c:pt>
                <c:pt idx="1321">
                  <c:v>7.8690476190476186</c:v>
                </c:pt>
                <c:pt idx="1322">
                  <c:v>7.875</c:v>
                </c:pt>
                <c:pt idx="1323">
                  <c:v>7.8809523809523814</c:v>
                </c:pt>
                <c:pt idx="1324">
                  <c:v>7.8869047619047619</c:v>
                </c:pt>
                <c:pt idx="1325">
                  <c:v>7.8928571428571432</c:v>
                </c:pt>
                <c:pt idx="1326">
                  <c:v>7.8988095238095237</c:v>
                </c:pt>
                <c:pt idx="1327">
                  <c:v>7.9047619047619051</c:v>
                </c:pt>
                <c:pt idx="1328">
                  <c:v>7.9107142857142856</c:v>
                </c:pt>
                <c:pt idx="1329">
                  <c:v>7.916666666666667</c:v>
                </c:pt>
                <c:pt idx="1330">
                  <c:v>7.9226190476190474</c:v>
                </c:pt>
                <c:pt idx="1331">
                  <c:v>7.9285714285714288</c:v>
                </c:pt>
                <c:pt idx="1332">
                  <c:v>7.9345238095238093</c:v>
                </c:pt>
                <c:pt idx="1333">
                  <c:v>7.9404761904761907</c:v>
                </c:pt>
                <c:pt idx="1334">
                  <c:v>7.9464285714285712</c:v>
                </c:pt>
                <c:pt idx="1335">
                  <c:v>7.9523809523809526</c:v>
                </c:pt>
                <c:pt idx="1336">
                  <c:v>7.958333333333333</c:v>
                </c:pt>
                <c:pt idx="1337">
                  <c:v>7.9642857142857144</c:v>
                </c:pt>
              </c:numCache>
            </c:numRef>
          </c:xVal>
          <c:yVal>
            <c:numRef>
              <c:f>Tabelle1!$I$13:$I$1350</c:f>
              <c:numCache>
                <c:formatCode>0</c:formatCode>
                <c:ptCount val="1338"/>
                <c:pt idx="0">
                  <c:v>40</c:v>
                </c:pt>
                <c:pt idx="1">
                  <c:v>71.2</c:v>
                </c:pt>
                <c:pt idx="2">
                  <c:v>90</c:v>
                </c:pt>
                <c:pt idx="3">
                  <c:v>95.1</c:v>
                </c:pt>
                <c:pt idx="4">
                  <c:v>91.6</c:v>
                </c:pt>
                <c:pt idx="5">
                  <c:v>97.2</c:v>
                </c:pt>
                <c:pt idx="6">
                  <c:v>99.2</c:v>
                </c:pt>
                <c:pt idx="7">
                  <c:v>97.8</c:v>
                </c:pt>
                <c:pt idx="8">
                  <c:v>99.7</c:v>
                </c:pt>
                <c:pt idx="9">
                  <c:v>99.9</c:v>
                </c:pt>
                <c:pt idx="10">
                  <c:v>95.1</c:v>
                </c:pt>
                <c:pt idx="11">
                  <c:v>97.9</c:v>
                </c:pt>
                <c:pt idx="12">
                  <c:v>99.9</c:v>
                </c:pt>
                <c:pt idx="13">
                  <c:v>99.9</c:v>
                </c:pt>
                <c:pt idx="14">
                  <c:v>96.4</c:v>
                </c:pt>
                <c:pt idx="15">
                  <c:v>97.6</c:v>
                </c:pt>
                <c:pt idx="16">
                  <c:v>99.6</c:v>
                </c:pt>
                <c:pt idx="17">
                  <c:v>99.9</c:v>
                </c:pt>
                <c:pt idx="18">
                  <c:v>95.8</c:v>
                </c:pt>
                <c:pt idx="19">
                  <c:v>99.9</c:v>
                </c:pt>
                <c:pt idx="20">
                  <c:v>99.9</c:v>
                </c:pt>
                <c:pt idx="21">
                  <c:v>49.9</c:v>
                </c:pt>
                <c:pt idx="22">
                  <c:v>86.6</c:v>
                </c:pt>
                <c:pt idx="23">
                  <c:v>90.5</c:v>
                </c:pt>
                <c:pt idx="24">
                  <c:v>95.9</c:v>
                </c:pt>
                <c:pt idx="25">
                  <c:v>99.5</c:v>
                </c:pt>
                <c:pt idx="26">
                  <c:v>93.8</c:v>
                </c:pt>
                <c:pt idx="27">
                  <c:v>99.9</c:v>
                </c:pt>
                <c:pt idx="28">
                  <c:v>96</c:v>
                </c:pt>
                <c:pt idx="29">
                  <c:v>97.7</c:v>
                </c:pt>
                <c:pt idx="30">
                  <c:v>99.9</c:v>
                </c:pt>
                <c:pt idx="31">
                  <c:v>96.8</c:v>
                </c:pt>
                <c:pt idx="32">
                  <c:v>98.5</c:v>
                </c:pt>
                <c:pt idx="33">
                  <c:v>99.4</c:v>
                </c:pt>
                <c:pt idx="34">
                  <c:v>92.7</c:v>
                </c:pt>
                <c:pt idx="35">
                  <c:v>95.4</c:v>
                </c:pt>
                <c:pt idx="36">
                  <c:v>96.9</c:v>
                </c:pt>
                <c:pt idx="37">
                  <c:v>97.3</c:v>
                </c:pt>
                <c:pt idx="38">
                  <c:v>97.2</c:v>
                </c:pt>
                <c:pt idx="39">
                  <c:v>90.8</c:v>
                </c:pt>
                <c:pt idx="40">
                  <c:v>94.5</c:v>
                </c:pt>
                <c:pt idx="41">
                  <c:v>95.4</c:v>
                </c:pt>
                <c:pt idx="42">
                  <c:v>93.6</c:v>
                </c:pt>
                <c:pt idx="43">
                  <c:v>94.6</c:v>
                </c:pt>
                <c:pt idx="44">
                  <c:v>95.6</c:v>
                </c:pt>
                <c:pt idx="45">
                  <c:v>95.3</c:v>
                </c:pt>
                <c:pt idx="46">
                  <c:v>94.2</c:v>
                </c:pt>
                <c:pt idx="47">
                  <c:v>95.7</c:v>
                </c:pt>
                <c:pt idx="48">
                  <c:v>92.8</c:v>
                </c:pt>
                <c:pt idx="49">
                  <c:v>96.2</c:v>
                </c:pt>
                <c:pt idx="50">
                  <c:v>94</c:v>
                </c:pt>
                <c:pt idx="51">
                  <c:v>90.8</c:v>
                </c:pt>
                <c:pt idx="52">
                  <c:v>93.4</c:v>
                </c:pt>
                <c:pt idx="53">
                  <c:v>94.5</c:v>
                </c:pt>
                <c:pt idx="54">
                  <c:v>91.4</c:v>
                </c:pt>
                <c:pt idx="55">
                  <c:v>93.5</c:v>
                </c:pt>
                <c:pt idx="56">
                  <c:v>95</c:v>
                </c:pt>
                <c:pt idx="57">
                  <c:v>95.1</c:v>
                </c:pt>
                <c:pt idx="58">
                  <c:v>93.7</c:v>
                </c:pt>
                <c:pt idx="59">
                  <c:v>90.4</c:v>
                </c:pt>
                <c:pt idx="60">
                  <c:v>94.6</c:v>
                </c:pt>
                <c:pt idx="61">
                  <c:v>95.4</c:v>
                </c:pt>
                <c:pt idx="62">
                  <c:v>94.4</c:v>
                </c:pt>
                <c:pt idx="63">
                  <c:v>87.2</c:v>
                </c:pt>
                <c:pt idx="64">
                  <c:v>93.4</c:v>
                </c:pt>
                <c:pt idx="65">
                  <c:v>94.2</c:v>
                </c:pt>
                <c:pt idx="66">
                  <c:v>95.6</c:v>
                </c:pt>
                <c:pt idx="67">
                  <c:v>92.2</c:v>
                </c:pt>
                <c:pt idx="68">
                  <c:v>94.1</c:v>
                </c:pt>
                <c:pt idx="69">
                  <c:v>95</c:v>
                </c:pt>
                <c:pt idx="70">
                  <c:v>88.8</c:v>
                </c:pt>
                <c:pt idx="71">
                  <c:v>94</c:v>
                </c:pt>
                <c:pt idx="72">
                  <c:v>94</c:v>
                </c:pt>
                <c:pt idx="73">
                  <c:v>87.8</c:v>
                </c:pt>
                <c:pt idx="74">
                  <c:v>94.1</c:v>
                </c:pt>
                <c:pt idx="75">
                  <c:v>93</c:v>
                </c:pt>
                <c:pt idx="76">
                  <c:v>93.3</c:v>
                </c:pt>
                <c:pt idx="77">
                  <c:v>93.6</c:v>
                </c:pt>
                <c:pt idx="78">
                  <c:v>95.7</c:v>
                </c:pt>
                <c:pt idx="79">
                  <c:v>92.7</c:v>
                </c:pt>
                <c:pt idx="80">
                  <c:v>94.7</c:v>
                </c:pt>
                <c:pt idx="81">
                  <c:v>95.3</c:v>
                </c:pt>
                <c:pt idx="82">
                  <c:v>95</c:v>
                </c:pt>
                <c:pt idx="83">
                  <c:v>87.6</c:v>
                </c:pt>
                <c:pt idx="84">
                  <c:v>93.4</c:v>
                </c:pt>
                <c:pt idx="85">
                  <c:v>95.4</c:v>
                </c:pt>
                <c:pt idx="86">
                  <c:v>94.7</c:v>
                </c:pt>
                <c:pt idx="87">
                  <c:v>94</c:v>
                </c:pt>
                <c:pt idx="88">
                  <c:v>86.9</c:v>
                </c:pt>
                <c:pt idx="89">
                  <c:v>91.1</c:v>
                </c:pt>
                <c:pt idx="90">
                  <c:v>90.9</c:v>
                </c:pt>
                <c:pt idx="91">
                  <c:v>94.9</c:v>
                </c:pt>
                <c:pt idx="92">
                  <c:v>91.5</c:v>
                </c:pt>
                <c:pt idx="93">
                  <c:v>91.8</c:v>
                </c:pt>
                <c:pt idx="94">
                  <c:v>94.1</c:v>
                </c:pt>
                <c:pt idx="95">
                  <c:v>94.6</c:v>
                </c:pt>
                <c:pt idx="96">
                  <c:v>93.1</c:v>
                </c:pt>
                <c:pt idx="97">
                  <c:v>95.4</c:v>
                </c:pt>
                <c:pt idx="98">
                  <c:v>95.2</c:v>
                </c:pt>
                <c:pt idx="99">
                  <c:v>90.1</c:v>
                </c:pt>
                <c:pt idx="100">
                  <c:v>92.9</c:v>
                </c:pt>
                <c:pt idx="101">
                  <c:v>95.3</c:v>
                </c:pt>
                <c:pt idx="102">
                  <c:v>88.2</c:v>
                </c:pt>
                <c:pt idx="103">
                  <c:v>94.5</c:v>
                </c:pt>
                <c:pt idx="104">
                  <c:v>95.2</c:v>
                </c:pt>
                <c:pt idx="105">
                  <c:v>93.9</c:v>
                </c:pt>
                <c:pt idx="106">
                  <c:v>89.1</c:v>
                </c:pt>
                <c:pt idx="107">
                  <c:v>93.1</c:v>
                </c:pt>
                <c:pt idx="108">
                  <c:v>93.9</c:v>
                </c:pt>
                <c:pt idx="109">
                  <c:v>94.9</c:v>
                </c:pt>
                <c:pt idx="110">
                  <c:v>92</c:v>
                </c:pt>
                <c:pt idx="111">
                  <c:v>91.4</c:v>
                </c:pt>
                <c:pt idx="112">
                  <c:v>94.1</c:v>
                </c:pt>
                <c:pt idx="113">
                  <c:v>93.1</c:v>
                </c:pt>
                <c:pt idx="114">
                  <c:v>91.6</c:v>
                </c:pt>
                <c:pt idx="115">
                  <c:v>94.8</c:v>
                </c:pt>
                <c:pt idx="116">
                  <c:v>95.7</c:v>
                </c:pt>
                <c:pt idx="117">
                  <c:v>89.2</c:v>
                </c:pt>
                <c:pt idx="118">
                  <c:v>95.3</c:v>
                </c:pt>
                <c:pt idx="119">
                  <c:v>94.8</c:v>
                </c:pt>
                <c:pt idx="120">
                  <c:v>95</c:v>
                </c:pt>
                <c:pt idx="121">
                  <c:v>95.1</c:v>
                </c:pt>
                <c:pt idx="122">
                  <c:v>92.2</c:v>
                </c:pt>
                <c:pt idx="123">
                  <c:v>95.6</c:v>
                </c:pt>
                <c:pt idx="124">
                  <c:v>94.7</c:v>
                </c:pt>
                <c:pt idx="125">
                  <c:v>89.9</c:v>
                </c:pt>
                <c:pt idx="126">
                  <c:v>92.6</c:v>
                </c:pt>
                <c:pt idx="127">
                  <c:v>95.3</c:v>
                </c:pt>
                <c:pt idx="128">
                  <c:v>87.4</c:v>
                </c:pt>
                <c:pt idx="129">
                  <c:v>93.7</c:v>
                </c:pt>
                <c:pt idx="130">
                  <c:v>95.1</c:v>
                </c:pt>
                <c:pt idx="131">
                  <c:v>95.6</c:v>
                </c:pt>
                <c:pt idx="132">
                  <c:v>87.3</c:v>
                </c:pt>
                <c:pt idx="133">
                  <c:v>90.8</c:v>
                </c:pt>
                <c:pt idx="134">
                  <c:v>93.9</c:v>
                </c:pt>
                <c:pt idx="135">
                  <c:v>94.7</c:v>
                </c:pt>
                <c:pt idx="136">
                  <c:v>95.1</c:v>
                </c:pt>
                <c:pt idx="137">
                  <c:v>88.6</c:v>
                </c:pt>
                <c:pt idx="138">
                  <c:v>94.1</c:v>
                </c:pt>
                <c:pt idx="139">
                  <c:v>95.9</c:v>
                </c:pt>
                <c:pt idx="140">
                  <c:v>93.2</c:v>
                </c:pt>
                <c:pt idx="141">
                  <c:v>88.8</c:v>
                </c:pt>
                <c:pt idx="142">
                  <c:v>95.1</c:v>
                </c:pt>
                <c:pt idx="143">
                  <c:v>90.4</c:v>
                </c:pt>
                <c:pt idx="144">
                  <c:v>94.8</c:v>
                </c:pt>
                <c:pt idx="145">
                  <c:v>95.8</c:v>
                </c:pt>
                <c:pt idx="146">
                  <c:v>93.2</c:v>
                </c:pt>
                <c:pt idx="147">
                  <c:v>95.1</c:v>
                </c:pt>
                <c:pt idx="148">
                  <c:v>94.6</c:v>
                </c:pt>
                <c:pt idx="149">
                  <c:v>90.6</c:v>
                </c:pt>
                <c:pt idx="150">
                  <c:v>93.1</c:v>
                </c:pt>
                <c:pt idx="151">
                  <c:v>95.6</c:v>
                </c:pt>
                <c:pt idx="152">
                  <c:v>91.4</c:v>
                </c:pt>
                <c:pt idx="153">
                  <c:v>95.2</c:v>
                </c:pt>
                <c:pt idx="154">
                  <c:v>95.1</c:v>
                </c:pt>
                <c:pt idx="155">
                  <c:v>92.4</c:v>
                </c:pt>
                <c:pt idx="156">
                  <c:v>95.8</c:v>
                </c:pt>
                <c:pt idx="157">
                  <c:v>95.4</c:v>
                </c:pt>
                <c:pt idx="158">
                  <c:v>90.2</c:v>
                </c:pt>
                <c:pt idx="159">
                  <c:v>93.4</c:v>
                </c:pt>
                <c:pt idx="160">
                  <c:v>96</c:v>
                </c:pt>
                <c:pt idx="161">
                  <c:v>96</c:v>
                </c:pt>
                <c:pt idx="162">
                  <c:v>93.9</c:v>
                </c:pt>
                <c:pt idx="163">
                  <c:v>58.7</c:v>
                </c:pt>
                <c:pt idx="164">
                  <c:v>74.599999999999994</c:v>
                </c:pt>
                <c:pt idx="165">
                  <c:v>89.5</c:v>
                </c:pt>
                <c:pt idx="166">
                  <c:v>93</c:v>
                </c:pt>
                <c:pt idx="167">
                  <c:v>98.4</c:v>
                </c:pt>
                <c:pt idx="168">
                  <c:v>99.9</c:v>
                </c:pt>
                <c:pt idx="169">
                  <c:v>97.4</c:v>
                </c:pt>
                <c:pt idx="170">
                  <c:v>99.9</c:v>
                </c:pt>
                <c:pt idx="171">
                  <c:v>99.5</c:v>
                </c:pt>
                <c:pt idx="172">
                  <c:v>99.4</c:v>
                </c:pt>
                <c:pt idx="173">
                  <c:v>99.9</c:v>
                </c:pt>
                <c:pt idx="174">
                  <c:v>99.8</c:v>
                </c:pt>
                <c:pt idx="175">
                  <c:v>99.9</c:v>
                </c:pt>
                <c:pt idx="176">
                  <c:v>99.9</c:v>
                </c:pt>
                <c:pt idx="177">
                  <c:v>99.3</c:v>
                </c:pt>
                <c:pt idx="178">
                  <c:v>99.9</c:v>
                </c:pt>
                <c:pt idx="179">
                  <c:v>99.9</c:v>
                </c:pt>
                <c:pt idx="180">
                  <c:v>96.9</c:v>
                </c:pt>
                <c:pt idx="181">
                  <c:v>99.9</c:v>
                </c:pt>
                <c:pt idx="182">
                  <c:v>99.9</c:v>
                </c:pt>
                <c:pt idx="183">
                  <c:v>97</c:v>
                </c:pt>
                <c:pt idx="184">
                  <c:v>99.3</c:v>
                </c:pt>
                <c:pt idx="185">
                  <c:v>98.4</c:v>
                </c:pt>
                <c:pt idx="186">
                  <c:v>99.9</c:v>
                </c:pt>
                <c:pt idx="187">
                  <c:v>99.9</c:v>
                </c:pt>
                <c:pt idx="188">
                  <c:v>99.9</c:v>
                </c:pt>
                <c:pt idx="189">
                  <c:v>99.9</c:v>
                </c:pt>
                <c:pt idx="190">
                  <c:v>99.9</c:v>
                </c:pt>
                <c:pt idx="191">
                  <c:v>97.7</c:v>
                </c:pt>
                <c:pt idx="192">
                  <c:v>99.9</c:v>
                </c:pt>
                <c:pt idx="193">
                  <c:v>98.8</c:v>
                </c:pt>
                <c:pt idx="194">
                  <c:v>99.4</c:v>
                </c:pt>
                <c:pt idx="195">
                  <c:v>99.9</c:v>
                </c:pt>
                <c:pt idx="196">
                  <c:v>97.3</c:v>
                </c:pt>
                <c:pt idx="197">
                  <c:v>98.1</c:v>
                </c:pt>
                <c:pt idx="198">
                  <c:v>99.9</c:v>
                </c:pt>
                <c:pt idx="199">
                  <c:v>98.5</c:v>
                </c:pt>
                <c:pt idx="200">
                  <c:v>99.9</c:v>
                </c:pt>
                <c:pt idx="201">
                  <c:v>95.3</c:v>
                </c:pt>
                <c:pt idx="202">
                  <c:v>99.5</c:v>
                </c:pt>
                <c:pt idx="203">
                  <c:v>99.9</c:v>
                </c:pt>
                <c:pt idx="204">
                  <c:v>98</c:v>
                </c:pt>
                <c:pt idx="205">
                  <c:v>99.9</c:v>
                </c:pt>
                <c:pt idx="206">
                  <c:v>99.9</c:v>
                </c:pt>
                <c:pt idx="207">
                  <c:v>95.4</c:v>
                </c:pt>
                <c:pt idx="208">
                  <c:v>99.2</c:v>
                </c:pt>
                <c:pt idx="209">
                  <c:v>99.9</c:v>
                </c:pt>
                <c:pt idx="210">
                  <c:v>93.8</c:v>
                </c:pt>
                <c:pt idx="211">
                  <c:v>98.9</c:v>
                </c:pt>
                <c:pt idx="212">
                  <c:v>98.2</c:v>
                </c:pt>
                <c:pt idx="213">
                  <c:v>97</c:v>
                </c:pt>
                <c:pt idx="214">
                  <c:v>99.5</c:v>
                </c:pt>
                <c:pt idx="215">
                  <c:v>94.3</c:v>
                </c:pt>
                <c:pt idx="216">
                  <c:v>98.6</c:v>
                </c:pt>
                <c:pt idx="217">
                  <c:v>99.1</c:v>
                </c:pt>
                <c:pt idx="218">
                  <c:v>96.4</c:v>
                </c:pt>
                <c:pt idx="219">
                  <c:v>98.9</c:v>
                </c:pt>
                <c:pt idx="220">
                  <c:v>99.3</c:v>
                </c:pt>
                <c:pt idx="221">
                  <c:v>92.6</c:v>
                </c:pt>
                <c:pt idx="222">
                  <c:v>95.8</c:v>
                </c:pt>
                <c:pt idx="223">
                  <c:v>99.2</c:v>
                </c:pt>
                <c:pt idx="224">
                  <c:v>93.5</c:v>
                </c:pt>
                <c:pt idx="225">
                  <c:v>98.8</c:v>
                </c:pt>
                <c:pt idx="226">
                  <c:v>92.8</c:v>
                </c:pt>
                <c:pt idx="227">
                  <c:v>96.7</c:v>
                </c:pt>
                <c:pt idx="228">
                  <c:v>98.8</c:v>
                </c:pt>
                <c:pt idx="229">
                  <c:v>93.9</c:v>
                </c:pt>
                <c:pt idx="230">
                  <c:v>96.6</c:v>
                </c:pt>
                <c:pt idx="231">
                  <c:v>99.1</c:v>
                </c:pt>
                <c:pt idx="232">
                  <c:v>97</c:v>
                </c:pt>
                <c:pt idx="233">
                  <c:v>94.5</c:v>
                </c:pt>
                <c:pt idx="234">
                  <c:v>94.4</c:v>
                </c:pt>
                <c:pt idx="235">
                  <c:v>98.4</c:v>
                </c:pt>
                <c:pt idx="236">
                  <c:v>91.7</c:v>
                </c:pt>
                <c:pt idx="237">
                  <c:v>96.8</c:v>
                </c:pt>
                <c:pt idx="238">
                  <c:v>98.7</c:v>
                </c:pt>
                <c:pt idx="239">
                  <c:v>98.7</c:v>
                </c:pt>
                <c:pt idx="240">
                  <c:v>97.2</c:v>
                </c:pt>
                <c:pt idx="241">
                  <c:v>99</c:v>
                </c:pt>
                <c:pt idx="242">
                  <c:v>91.6</c:v>
                </c:pt>
                <c:pt idx="243">
                  <c:v>96.4</c:v>
                </c:pt>
                <c:pt idx="244">
                  <c:v>98.2</c:v>
                </c:pt>
                <c:pt idx="245">
                  <c:v>98.8</c:v>
                </c:pt>
                <c:pt idx="246">
                  <c:v>92.3</c:v>
                </c:pt>
                <c:pt idx="247">
                  <c:v>98.3</c:v>
                </c:pt>
                <c:pt idx="248">
                  <c:v>98.5</c:v>
                </c:pt>
                <c:pt idx="249">
                  <c:v>92.6</c:v>
                </c:pt>
                <c:pt idx="250">
                  <c:v>97.5</c:v>
                </c:pt>
                <c:pt idx="251">
                  <c:v>99</c:v>
                </c:pt>
                <c:pt idx="252">
                  <c:v>98.8</c:v>
                </c:pt>
                <c:pt idx="253">
                  <c:v>91.4</c:v>
                </c:pt>
                <c:pt idx="254">
                  <c:v>95.9</c:v>
                </c:pt>
                <c:pt idx="255">
                  <c:v>98.5</c:v>
                </c:pt>
                <c:pt idx="256">
                  <c:v>98.7</c:v>
                </c:pt>
                <c:pt idx="257">
                  <c:v>98.7</c:v>
                </c:pt>
                <c:pt idx="258">
                  <c:v>95.5</c:v>
                </c:pt>
                <c:pt idx="259">
                  <c:v>92.6</c:v>
                </c:pt>
                <c:pt idx="260">
                  <c:v>98.3</c:v>
                </c:pt>
                <c:pt idx="261">
                  <c:v>93.2</c:v>
                </c:pt>
                <c:pt idx="262">
                  <c:v>99.5</c:v>
                </c:pt>
                <c:pt idx="263">
                  <c:v>91.2</c:v>
                </c:pt>
                <c:pt idx="264">
                  <c:v>97.6</c:v>
                </c:pt>
                <c:pt idx="265">
                  <c:v>98.8</c:v>
                </c:pt>
                <c:pt idx="266">
                  <c:v>93.8</c:v>
                </c:pt>
                <c:pt idx="267">
                  <c:v>97</c:v>
                </c:pt>
                <c:pt idx="268">
                  <c:v>98.5</c:v>
                </c:pt>
                <c:pt idx="269">
                  <c:v>97.8</c:v>
                </c:pt>
                <c:pt idx="270">
                  <c:v>94</c:v>
                </c:pt>
                <c:pt idx="271">
                  <c:v>98.8</c:v>
                </c:pt>
                <c:pt idx="272">
                  <c:v>98.9</c:v>
                </c:pt>
                <c:pt idx="273">
                  <c:v>93.6</c:v>
                </c:pt>
                <c:pt idx="274">
                  <c:v>98.2</c:v>
                </c:pt>
                <c:pt idx="275">
                  <c:v>98.6</c:v>
                </c:pt>
                <c:pt idx="276">
                  <c:v>92.1</c:v>
                </c:pt>
                <c:pt idx="277">
                  <c:v>97.6</c:v>
                </c:pt>
                <c:pt idx="278">
                  <c:v>99.3</c:v>
                </c:pt>
                <c:pt idx="279">
                  <c:v>99.1</c:v>
                </c:pt>
                <c:pt idx="280">
                  <c:v>98.8</c:v>
                </c:pt>
                <c:pt idx="281">
                  <c:v>98</c:v>
                </c:pt>
                <c:pt idx="282">
                  <c:v>93.4</c:v>
                </c:pt>
                <c:pt idx="283">
                  <c:v>98.2</c:v>
                </c:pt>
                <c:pt idx="284">
                  <c:v>98.7</c:v>
                </c:pt>
                <c:pt idx="285">
                  <c:v>95.3</c:v>
                </c:pt>
                <c:pt idx="286">
                  <c:v>98.7</c:v>
                </c:pt>
                <c:pt idx="287">
                  <c:v>91.8</c:v>
                </c:pt>
                <c:pt idx="288">
                  <c:v>98.1</c:v>
                </c:pt>
                <c:pt idx="289">
                  <c:v>98.7</c:v>
                </c:pt>
                <c:pt idx="290">
                  <c:v>95.6</c:v>
                </c:pt>
                <c:pt idx="291">
                  <c:v>98.7</c:v>
                </c:pt>
                <c:pt idx="292">
                  <c:v>98.9</c:v>
                </c:pt>
                <c:pt idx="293">
                  <c:v>98.5</c:v>
                </c:pt>
                <c:pt idx="294">
                  <c:v>91.8</c:v>
                </c:pt>
                <c:pt idx="295">
                  <c:v>98.2</c:v>
                </c:pt>
                <c:pt idx="296">
                  <c:v>99</c:v>
                </c:pt>
                <c:pt idx="297">
                  <c:v>91.2</c:v>
                </c:pt>
                <c:pt idx="298">
                  <c:v>96.2</c:v>
                </c:pt>
                <c:pt idx="299">
                  <c:v>98.2</c:v>
                </c:pt>
                <c:pt idx="300">
                  <c:v>98.6</c:v>
                </c:pt>
                <c:pt idx="301">
                  <c:v>98.3</c:v>
                </c:pt>
                <c:pt idx="302">
                  <c:v>91.4</c:v>
                </c:pt>
                <c:pt idx="303">
                  <c:v>97.2</c:v>
                </c:pt>
                <c:pt idx="304">
                  <c:v>98.7</c:v>
                </c:pt>
                <c:pt idx="305">
                  <c:v>98.6</c:v>
                </c:pt>
                <c:pt idx="306">
                  <c:v>93.5</c:v>
                </c:pt>
                <c:pt idx="307">
                  <c:v>92.2</c:v>
                </c:pt>
                <c:pt idx="308">
                  <c:v>98.8</c:v>
                </c:pt>
                <c:pt idx="309">
                  <c:v>96.3</c:v>
                </c:pt>
                <c:pt idx="310">
                  <c:v>98.4</c:v>
                </c:pt>
                <c:pt idx="311">
                  <c:v>97.1</c:v>
                </c:pt>
                <c:pt idx="312">
                  <c:v>98.9</c:v>
                </c:pt>
                <c:pt idx="313">
                  <c:v>96.1</c:v>
                </c:pt>
                <c:pt idx="314">
                  <c:v>98.5</c:v>
                </c:pt>
                <c:pt idx="315">
                  <c:v>94.7</c:v>
                </c:pt>
                <c:pt idx="316">
                  <c:v>95.8</c:v>
                </c:pt>
                <c:pt idx="317">
                  <c:v>98.2</c:v>
                </c:pt>
                <c:pt idx="318">
                  <c:v>92.1</c:v>
                </c:pt>
                <c:pt idx="319">
                  <c:v>98.7</c:v>
                </c:pt>
                <c:pt idx="320">
                  <c:v>99</c:v>
                </c:pt>
                <c:pt idx="321">
                  <c:v>91.6</c:v>
                </c:pt>
                <c:pt idx="322">
                  <c:v>97.1</c:v>
                </c:pt>
                <c:pt idx="323">
                  <c:v>98.6</c:v>
                </c:pt>
                <c:pt idx="324">
                  <c:v>95.6</c:v>
                </c:pt>
                <c:pt idx="325">
                  <c:v>96.4</c:v>
                </c:pt>
                <c:pt idx="326">
                  <c:v>98.6</c:v>
                </c:pt>
                <c:pt idx="327">
                  <c:v>99.2</c:v>
                </c:pt>
                <c:pt idx="328">
                  <c:v>91</c:v>
                </c:pt>
                <c:pt idx="329">
                  <c:v>95.4</c:v>
                </c:pt>
                <c:pt idx="330">
                  <c:v>92.9</c:v>
                </c:pt>
                <c:pt idx="331">
                  <c:v>99</c:v>
                </c:pt>
                <c:pt idx="332">
                  <c:v>96.8</c:v>
                </c:pt>
                <c:pt idx="333">
                  <c:v>98.6</c:v>
                </c:pt>
                <c:pt idx="334">
                  <c:v>92.2</c:v>
                </c:pt>
                <c:pt idx="335">
                  <c:v>99.5</c:v>
                </c:pt>
                <c:pt idx="336">
                  <c:v>97</c:v>
                </c:pt>
                <c:pt idx="337">
                  <c:v>94.8</c:v>
                </c:pt>
                <c:pt idx="338">
                  <c:v>98.9</c:v>
                </c:pt>
                <c:pt idx="339">
                  <c:v>92.5</c:v>
                </c:pt>
                <c:pt idx="340">
                  <c:v>95.9</c:v>
                </c:pt>
                <c:pt idx="341">
                  <c:v>97.7</c:v>
                </c:pt>
                <c:pt idx="342">
                  <c:v>97.3</c:v>
                </c:pt>
                <c:pt idx="343">
                  <c:v>95.9</c:v>
                </c:pt>
                <c:pt idx="344">
                  <c:v>98.1</c:v>
                </c:pt>
                <c:pt idx="345">
                  <c:v>98.3</c:v>
                </c:pt>
                <c:pt idx="346">
                  <c:v>92.1</c:v>
                </c:pt>
                <c:pt idx="347">
                  <c:v>97.3</c:v>
                </c:pt>
                <c:pt idx="348">
                  <c:v>99.1</c:v>
                </c:pt>
                <c:pt idx="349">
                  <c:v>91.2</c:v>
                </c:pt>
                <c:pt idx="350">
                  <c:v>95.4</c:v>
                </c:pt>
                <c:pt idx="351">
                  <c:v>98.5</c:v>
                </c:pt>
                <c:pt idx="352">
                  <c:v>98.7</c:v>
                </c:pt>
                <c:pt idx="353">
                  <c:v>92.7</c:v>
                </c:pt>
                <c:pt idx="354">
                  <c:v>94.7</c:v>
                </c:pt>
                <c:pt idx="355">
                  <c:v>95.4</c:v>
                </c:pt>
                <c:pt idx="356">
                  <c:v>98.5</c:v>
                </c:pt>
                <c:pt idx="357">
                  <c:v>92.1</c:v>
                </c:pt>
                <c:pt idx="358">
                  <c:v>91.9</c:v>
                </c:pt>
                <c:pt idx="359">
                  <c:v>97.3</c:v>
                </c:pt>
                <c:pt idx="360">
                  <c:v>98.2</c:v>
                </c:pt>
                <c:pt idx="361">
                  <c:v>93.2</c:v>
                </c:pt>
                <c:pt idx="362">
                  <c:v>97.2</c:v>
                </c:pt>
                <c:pt idx="363">
                  <c:v>98.6</c:v>
                </c:pt>
                <c:pt idx="364">
                  <c:v>98.2</c:v>
                </c:pt>
                <c:pt idx="365">
                  <c:v>92.4</c:v>
                </c:pt>
                <c:pt idx="366">
                  <c:v>94.6</c:v>
                </c:pt>
                <c:pt idx="367">
                  <c:v>99.1</c:v>
                </c:pt>
                <c:pt idx="368">
                  <c:v>96.4</c:v>
                </c:pt>
                <c:pt idx="369">
                  <c:v>95.3</c:v>
                </c:pt>
                <c:pt idx="370">
                  <c:v>97.8</c:v>
                </c:pt>
                <c:pt idx="371">
                  <c:v>98.1</c:v>
                </c:pt>
                <c:pt idx="372">
                  <c:v>97</c:v>
                </c:pt>
                <c:pt idx="373">
                  <c:v>95</c:v>
                </c:pt>
                <c:pt idx="374">
                  <c:v>96.9</c:v>
                </c:pt>
                <c:pt idx="375">
                  <c:v>99</c:v>
                </c:pt>
                <c:pt idx="376">
                  <c:v>99.3</c:v>
                </c:pt>
                <c:pt idx="377">
                  <c:v>98.9</c:v>
                </c:pt>
                <c:pt idx="378">
                  <c:v>91.9</c:v>
                </c:pt>
                <c:pt idx="379">
                  <c:v>97.9</c:v>
                </c:pt>
                <c:pt idx="380">
                  <c:v>98.3</c:v>
                </c:pt>
                <c:pt idx="381">
                  <c:v>93.3</c:v>
                </c:pt>
                <c:pt idx="382">
                  <c:v>98.2</c:v>
                </c:pt>
                <c:pt idx="383">
                  <c:v>94.1</c:v>
                </c:pt>
                <c:pt idx="384">
                  <c:v>98.3</c:v>
                </c:pt>
                <c:pt idx="385">
                  <c:v>97.9</c:v>
                </c:pt>
                <c:pt idx="386">
                  <c:v>96.9</c:v>
                </c:pt>
                <c:pt idx="387">
                  <c:v>98.4</c:v>
                </c:pt>
                <c:pt idx="388">
                  <c:v>92.5</c:v>
                </c:pt>
                <c:pt idx="389">
                  <c:v>97</c:v>
                </c:pt>
                <c:pt idx="390">
                  <c:v>98.8</c:v>
                </c:pt>
                <c:pt idx="391">
                  <c:v>97.3</c:v>
                </c:pt>
                <c:pt idx="392">
                  <c:v>99</c:v>
                </c:pt>
                <c:pt idx="393">
                  <c:v>94.2</c:v>
                </c:pt>
                <c:pt idx="394">
                  <c:v>95.9</c:v>
                </c:pt>
                <c:pt idx="395">
                  <c:v>98.8</c:v>
                </c:pt>
                <c:pt idx="396">
                  <c:v>95.1</c:v>
                </c:pt>
                <c:pt idx="397">
                  <c:v>95.7</c:v>
                </c:pt>
                <c:pt idx="398">
                  <c:v>98.3</c:v>
                </c:pt>
                <c:pt idx="399">
                  <c:v>98.5</c:v>
                </c:pt>
                <c:pt idx="400">
                  <c:v>93.1</c:v>
                </c:pt>
                <c:pt idx="401">
                  <c:v>97.9</c:v>
                </c:pt>
                <c:pt idx="402">
                  <c:v>93.7</c:v>
                </c:pt>
                <c:pt idx="403">
                  <c:v>98.5</c:v>
                </c:pt>
                <c:pt idx="404">
                  <c:v>98.9</c:v>
                </c:pt>
                <c:pt idx="405">
                  <c:v>95.3</c:v>
                </c:pt>
                <c:pt idx="406">
                  <c:v>98.1</c:v>
                </c:pt>
                <c:pt idx="407">
                  <c:v>95.9</c:v>
                </c:pt>
                <c:pt idx="408">
                  <c:v>98.3</c:v>
                </c:pt>
                <c:pt idx="409">
                  <c:v>94.1</c:v>
                </c:pt>
                <c:pt idx="410">
                  <c:v>97.9</c:v>
                </c:pt>
                <c:pt idx="411">
                  <c:v>98.7</c:v>
                </c:pt>
                <c:pt idx="412">
                  <c:v>95</c:v>
                </c:pt>
                <c:pt idx="413">
                  <c:v>98.2</c:v>
                </c:pt>
                <c:pt idx="414">
                  <c:v>95</c:v>
                </c:pt>
                <c:pt idx="415">
                  <c:v>97.9</c:v>
                </c:pt>
                <c:pt idx="416">
                  <c:v>98.9</c:v>
                </c:pt>
                <c:pt idx="417">
                  <c:v>98.8</c:v>
                </c:pt>
                <c:pt idx="418">
                  <c:v>91.5</c:v>
                </c:pt>
                <c:pt idx="419">
                  <c:v>96.6</c:v>
                </c:pt>
                <c:pt idx="420">
                  <c:v>98</c:v>
                </c:pt>
                <c:pt idx="421">
                  <c:v>96.2</c:v>
                </c:pt>
                <c:pt idx="422">
                  <c:v>97</c:v>
                </c:pt>
                <c:pt idx="423">
                  <c:v>98.6</c:v>
                </c:pt>
                <c:pt idx="424">
                  <c:v>98.3</c:v>
                </c:pt>
                <c:pt idx="425">
                  <c:v>96.7</c:v>
                </c:pt>
                <c:pt idx="426">
                  <c:v>92.8</c:v>
                </c:pt>
                <c:pt idx="427">
                  <c:v>99.7</c:v>
                </c:pt>
                <c:pt idx="428">
                  <c:v>99.7</c:v>
                </c:pt>
                <c:pt idx="429">
                  <c:v>98.6</c:v>
                </c:pt>
                <c:pt idx="430">
                  <c:v>97.7</c:v>
                </c:pt>
                <c:pt idx="431">
                  <c:v>98.8</c:v>
                </c:pt>
                <c:pt idx="432">
                  <c:v>97.2</c:v>
                </c:pt>
                <c:pt idx="433">
                  <c:v>92.9</c:v>
                </c:pt>
                <c:pt idx="434">
                  <c:v>99.1</c:v>
                </c:pt>
                <c:pt idx="435">
                  <c:v>93.7</c:v>
                </c:pt>
                <c:pt idx="436">
                  <c:v>98.3</c:v>
                </c:pt>
                <c:pt idx="437">
                  <c:v>98.8</c:v>
                </c:pt>
                <c:pt idx="438">
                  <c:v>92.5</c:v>
                </c:pt>
                <c:pt idx="439">
                  <c:v>98.4</c:v>
                </c:pt>
                <c:pt idx="440">
                  <c:v>99.1</c:v>
                </c:pt>
                <c:pt idx="441">
                  <c:v>91.3</c:v>
                </c:pt>
                <c:pt idx="442">
                  <c:v>97.1</c:v>
                </c:pt>
                <c:pt idx="443">
                  <c:v>98.7</c:v>
                </c:pt>
                <c:pt idx="444">
                  <c:v>98.5</c:v>
                </c:pt>
                <c:pt idx="445">
                  <c:v>92.4</c:v>
                </c:pt>
                <c:pt idx="446">
                  <c:v>98.4</c:v>
                </c:pt>
                <c:pt idx="447">
                  <c:v>99.1</c:v>
                </c:pt>
                <c:pt idx="448">
                  <c:v>99.3</c:v>
                </c:pt>
                <c:pt idx="449">
                  <c:v>99.3</c:v>
                </c:pt>
                <c:pt idx="450">
                  <c:v>96.5</c:v>
                </c:pt>
                <c:pt idx="451">
                  <c:v>99</c:v>
                </c:pt>
                <c:pt idx="452">
                  <c:v>95.8</c:v>
                </c:pt>
                <c:pt idx="453">
                  <c:v>99.4</c:v>
                </c:pt>
                <c:pt idx="454">
                  <c:v>94.6</c:v>
                </c:pt>
                <c:pt idx="455">
                  <c:v>94.9</c:v>
                </c:pt>
                <c:pt idx="456">
                  <c:v>98</c:v>
                </c:pt>
                <c:pt idx="457">
                  <c:v>98.5</c:v>
                </c:pt>
                <c:pt idx="458">
                  <c:v>97.8</c:v>
                </c:pt>
                <c:pt idx="459">
                  <c:v>99.2</c:v>
                </c:pt>
                <c:pt idx="460">
                  <c:v>97.7</c:v>
                </c:pt>
                <c:pt idx="461">
                  <c:v>95.2</c:v>
                </c:pt>
                <c:pt idx="462">
                  <c:v>99.2</c:v>
                </c:pt>
                <c:pt idx="463">
                  <c:v>97.2</c:v>
                </c:pt>
                <c:pt idx="464">
                  <c:v>98.4</c:v>
                </c:pt>
                <c:pt idx="465">
                  <c:v>93.2</c:v>
                </c:pt>
                <c:pt idx="466">
                  <c:v>97</c:v>
                </c:pt>
                <c:pt idx="467">
                  <c:v>99</c:v>
                </c:pt>
                <c:pt idx="468">
                  <c:v>91.9</c:v>
                </c:pt>
                <c:pt idx="469">
                  <c:v>96.8</c:v>
                </c:pt>
                <c:pt idx="470">
                  <c:v>94.5</c:v>
                </c:pt>
                <c:pt idx="471">
                  <c:v>95</c:v>
                </c:pt>
                <c:pt idx="472">
                  <c:v>98.1</c:v>
                </c:pt>
                <c:pt idx="473">
                  <c:v>98.9</c:v>
                </c:pt>
                <c:pt idx="474">
                  <c:v>94.3</c:v>
                </c:pt>
                <c:pt idx="475">
                  <c:v>99.6</c:v>
                </c:pt>
                <c:pt idx="476">
                  <c:v>98.6</c:v>
                </c:pt>
                <c:pt idx="477">
                  <c:v>99</c:v>
                </c:pt>
                <c:pt idx="478">
                  <c:v>94.3</c:v>
                </c:pt>
                <c:pt idx="479">
                  <c:v>98.8</c:v>
                </c:pt>
                <c:pt idx="480">
                  <c:v>97.1</c:v>
                </c:pt>
                <c:pt idx="481">
                  <c:v>95.6</c:v>
                </c:pt>
                <c:pt idx="482">
                  <c:v>99</c:v>
                </c:pt>
                <c:pt idx="483">
                  <c:v>95.8</c:v>
                </c:pt>
                <c:pt idx="484">
                  <c:v>93.9</c:v>
                </c:pt>
                <c:pt idx="485">
                  <c:v>98.4</c:v>
                </c:pt>
                <c:pt idx="486">
                  <c:v>94</c:v>
                </c:pt>
                <c:pt idx="487">
                  <c:v>98.4</c:v>
                </c:pt>
                <c:pt idx="488">
                  <c:v>98.8</c:v>
                </c:pt>
                <c:pt idx="489">
                  <c:v>92.2</c:v>
                </c:pt>
                <c:pt idx="490">
                  <c:v>97.2</c:v>
                </c:pt>
                <c:pt idx="491">
                  <c:v>98.3</c:v>
                </c:pt>
                <c:pt idx="492">
                  <c:v>93.8</c:v>
                </c:pt>
                <c:pt idx="493">
                  <c:v>94.9</c:v>
                </c:pt>
                <c:pt idx="494">
                  <c:v>98.7</c:v>
                </c:pt>
                <c:pt idx="495">
                  <c:v>91.8</c:v>
                </c:pt>
                <c:pt idx="496">
                  <c:v>97.3</c:v>
                </c:pt>
                <c:pt idx="497">
                  <c:v>95.2</c:v>
                </c:pt>
                <c:pt idx="498">
                  <c:v>93.2</c:v>
                </c:pt>
                <c:pt idx="499">
                  <c:v>98.6</c:v>
                </c:pt>
                <c:pt idx="500">
                  <c:v>99.4</c:v>
                </c:pt>
                <c:pt idx="501">
                  <c:v>96.9</c:v>
                </c:pt>
                <c:pt idx="502">
                  <c:v>96</c:v>
                </c:pt>
                <c:pt idx="503">
                  <c:v>98.4</c:v>
                </c:pt>
                <c:pt idx="504">
                  <c:v>98.4</c:v>
                </c:pt>
                <c:pt idx="505">
                  <c:v>99</c:v>
                </c:pt>
                <c:pt idx="506">
                  <c:v>94</c:v>
                </c:pt>
                <c:pt idx="507">
                  <c:v>98.3</c:v>
                </c:pt>
                <c:pt idx="508">
                  <c:v>98.9</c:v>
                </c:pt>
                <c:pt idx="509">
                  <c:v>99</c:v>
                </c:pt>
                <c:pt idx="510">
                  <c:v>92.6</c:v>
                </c:pt>
                <c:pt idx="511">
                  <c:v>98.3</c:v>
                </c:pt>
                <c:pt idx="512">
                  <c:v>98.8</c:v>
                </c:pt>
                <c:pt idx="513">
                  <c:v>98.7</c:v>
                </c:pt>
                <c:pt idx="514">
                  <c:v>91.8</c:v>
                </c:pt>
                <c:pt idx="515">
                  <c:v>97.1</c:v>
                </c:pt>
                <c:pt idx="516">
                  <c:v>98.7</c:v>
                </c:pt>
                <c:pt idx="517">
                  <c:v>98.9</c:v>
                </c:pt>
                <c:pt idx="518">
                  <c:v>98.7</c:v>
                </c:pt>
                <c:pt idx="519">
                  <c:v>91.9</c:v>
                </c:pt>
                <c:pt idx="520">
                  <c:v>94.8</c:v>
                </c:pt>
                <c:pt idx="521">
                  <c:v>97.8</c:v>
                </c:pt>
                <c:pt idx="522">
                  <c:v>92.8</c:v>
                </c:pt>
                <c:pt idx="523">
                  <c:v>98.9</c:v>
                </c:pt>
                <c:pt idx="524">
                  <c:v>99.3</c:v>
                </c:pt>
                <c:pt idx="525">
                  <c:v>96.8</c:v>
                </c:pt>
                <c:pt idx="526">
                  <c:v>98.4</c:v>
                </c:pt>
                <c:pt idx="527">
                  <c:v>98.9</c:v>
                </c:pt>
                <c:pt idx="528">
                  <c:v>98.7</c:v>
                </c:pt>
                <c:pt idx="529">
                  <c:v>94.1</c:v>
                </c:pt>
                <c:pt idx="530">
                  <c:v>99.1</c:v>
                </c:pt>
                <c:pt idx="531">
                  <c:v>94.9</c:v>
                </c:pt>
                <c:pt idx="532">
                  <c:v>94.7</c:v>
                </c:pt>
                <c:pt idx="533">
                  <c:v>98.9</c:v>
                </c:pt>
                <c:pt idx="534">
                  <c:v>95.4</c:v>
                </c:pt>
                <c:pt idx="535">
                  <c:v>97.5</c:v>
                </c:pt>
                <c:pt idx="536">
                  <c:v>98.9</c:v>
                </c:pt>
                <c:pt idx="537">
                  <c:v>98.3</c:v>
                </c:pt>
                <c:pt idx="538">
                  <c:v>96.5</c:v>
                </c:pt>
                <c:pt idx="539">
                  <c:v>99.3</c:v>
                </c:pt>
                <c:pt idx="540">
                  <c:v>99.3</c:v>
                </c:pt>
                <c:pt idx="541">
                  <c:v>98.6</c:v>
                </c:pt>
                <c:pt idx="542">
                  <c:v>93.1</c:v>
                </c:pt>
                <c:pt idx="543">
                  <c:v>97.6</c:v>
                </c:pt>
                <c:pt idx="544">
                  <c:v>99.2</c:v>
                </c:pt>
                <c:pt idx="545">
                  <c:v>98.8</c:v>
                </c:pt>
                <c:pt idx="546">
                  <c:v>92.4</c:v>
                </c:pt>
                <c:pt idx="547">
                  <c:v>99</c:v>
                </c:pt>
                <c:pt idx="548">
                  <c:v>94.1</c:v>
                </c:pt>
                <c:pt idx="549">
                  <c:v>99.7</c:v>
                </c:pt>
                <c:pt idx="550">
                  <c:v>99.4</c:v>
                </c:pt>
                <c:pt idx="551">
                  <c:v>96.6</c:v>
                </c:pt>
                <c:pt idx="552">
                  <c:v>98.5</c:v>
                </c:pt>
                <c:pt idx="553">
                  <c:v>99.1</c:v>
                </c:pt>
                <c:pt idx="554">
                  <c:v>94.5</c:v>
                </c:pt>
                <c:pt idx="555">
                  <c:v>92.1</c:v>
                </c:pt>
                <c:pt idx="556">
                  <c:v>95.1</c:v>
                </c:pt>
                <c:pt idx="557">
                  <c:v>98</c:v>
                </c:pt>
                <c:pt idx="558">
                  <c:v>99.6</c:v>
                </c:pt>
                <c:pt idx="559">
                  <c:v>95.2</c:v>
                </c:pt>
                <c:pt idx="560">
                  <c:v>98.3</c:v>
                </c:pt>
                <c:pt idx="561">
                  <c:v>98.5</c:v>
                </c:pt>
                <c:pt idx="562">
                  <c:v>92</c:v>
                </c:pt>
                <c:pt idx="563">
                  <c:v>95.7</c:v>
                </c:pt>
                <c:pt idx="564">
                  <c:v>98.1</c:v>
                </c:pt>
                <c:pt idx="565">
                  <c:v>99</c:v>
                </c:pt>
                <c:pt idx="566">
                  <c:v>98.6</c:v>
                </c:pt>
                <c:pt idx="567">
                  <c:v>92.5</c:v>
                </c:pt>
                <c:pt idx="568">
                  <c:v>96.9</c:v>
                </c:pt>
                <c:pt idx="569">
                  <c:v>96.1</c:v>
                </c:pt>
                <c:pt idx="570">
                  <c:v>92.5</c:v>
                </c:pt>
                <c:pt idx="571">
                  <c:v>98.1</c:v>
                </c:pt>
                <c:pt idx="572">
                  <c:v>99</c:v>
                </c:pt>
                <c:pt idx="573">
                  <c:v>94.1</c:v>
                </c:pt>
                <c:pt idx="574">
                  <c:v>99.1</c:v>
                </c:pt>
                <c:pt idx="575">
                  <c:v>99.5</c:v>
                </c:pt>
                <c:pt idx="576">
                  <c:v>93.2</c:v>
                </c:pt>
                <c:pt idx="577">
                  <c:v>98.4</c:v>
                </c:pt>
                <c:pt idx="578">
                  <c:v>92.6</c:v>
                </c:pt>
                <c:pt idx="579">
                  <c:v>99.2</c:v>
                </c:pt>
                <c:pt idx="580">
                  <c:v>99.1</c:v>
                </c:pt>
                <c:pt idx="581">
                  <c:v>91.6</c:v>
                </c:pt>
                <c:pt idx="582">
                  <c:v>96.9</c:v>
                </c:pt>
                <c:pt idx="583">
                  <c:v>98.4</c:v>
                </c:pt>
                <c:pt idx="584">
                  <c:v>98.9</c:v>
                </c:pt>
                <c:pt idx="585">
                  <c:v>97.5</c:v>
                </c:pt>
                <c:pt idx="586">
                  <c:v>94.9</c:v>
                </c:pt>
                <c:pt idx="587">
                  <c:v>99</c:v>
                </c:pt>
                <c:pt idx="588">
                  <c:v>99.1</c:v>
                </c:pt>
                <c:pt idx="589">
                  <c:v>99.4</c:v>
                </c:pt>
                <c:pt idx="590">
                  <c:v>99.1</c:v>
                </c:pt>
                <c:pt idx="591">
                  <c:v>93.6</c:v>
                </c:pt>
                <c:pt idx="592">
                  <c:v>93.8</c:v>
                </c:pt>
                <c:pt idx="593">
                  <c:v>93.7</c:v>
                </c:pt>
                <c:pt idx="594">
                  <c:v>92.3</c:v>
                </c:pt>
                <c:pt idx="595">
                  <c:v>99</c:v>
                </c:pt>
                <c:pt idx="596">
                  <c:v>91.9</c:v>
                </c:pt>
                <c:pt idx="597">
                  <c:v>95.1</c:v>
                </c:pt>
                <c:pt idx="598">
                  <c:v>99.3</c:v>
                </c:pt>
                <c:pt idx="599">
                  <c:v>97</c:v>
                </c:pt>
                <c:pt idx="600">
                  <c:v>99.7</c:v>
                </c:pt>
                <c:pt idx="601">
                  <c:v>94.2</c:v>
                </c:pt>
                <c:pt idx="602">
                  <c:v>99.9</c:v>
                </c:pt>
                <c:pt idx="603">
                  <c:v>93</c:v>
                </c:pt>
                <c:pt idx="604">
                  <c:v>96.5</c:v>
                </c:pt>
                <c:pt idx="605">
                  <c:v>99.2</c:v>
                </c:pt>
                <c:pt idx="606">
                  <c:v>92</c:v>
                </c:pt>
                <c:pt idx="607">
                  <c:v>95.7</c:v>
                </c:pt>
                <c:pt idx="608">
                  <c:v>98.6</c:v>
                </c:pt>
                <c:pt idx="609">
                  <c:v>99.6</c:v>
                </c:pt>
                <c:pt idx="610">
                  <c:v>99.8</c:v>
                </c:pt>
                <c:pt idx="611">
                  <c:v>99.5</c:v>
                </c:pt>
                <c:pt idx="612">
                  <c:v>92.1</c:v>
                </c:pt>
                <c:pt idx="613">
                  <c:v>95.2</c:v>
                </c:pt>
                <c:pt idx="614">
                  <c:v>98.3</c:v>
                </c:pt>
                <c:pt idx="615">
                  <c:v>98.9</c:v>
                </c:pt>
                <c:pt idx="616">
                  <c:v>99.6</c:v>
                </c:pt>
                <c:pt idx="617">
                  <c:v>94.2</c:v>
                </c:pt>
                <c:pt idx="618">
                  <c:v>99.9</c:v>
                </c:pt>
                <c:pt idx="619">
                  <c:v>98</c:v>
                </c:pt>
                <c:pt idx="620">
                  <c:v>98</c:v>
                </c:pt>
                <c:pt idx="621">
                  <c:v>92.9</c:v>
                </c:pt>
                <c:pt idx="622">
                  <c:v>90.8</c:v>
                </c:pt>
                <c:pt idx="623">
                  <c:v>99</c:v>
                </c:pt>
                <c:pt idx="624">
                  <c:v>94.6</c:v>
                </c:pt>
                <c:pt idx="625">
                  <c:v>99.1</c:v>
                </c:pt>
                <c:pt idx="626">
                  <c:v>99.3</c:v>
                </c:pt>
                <c:pt idx="627">
                  <c:v>99.2</c:v>
                </c:pt>
                <c:pt idx="628">
                  <c:v>94.4</c:v>
                </c:pt>
                <c:pt idx="629">
                  <c:v>99.2</c:v>
                </c:pt>
                <c:pt idx="630">
                  <c:v>95.8</c:v>
                </c:pt>
                <c:pt idx="631">
                  <c:v>98.7</c:v>
                </c:pt>
                <c:pt idx="632">
                  <c:v>99.3</c:v>
                </c:pt>
                <c:pt idx="633">
                  <c:v>99.2</c:v>
                </c:pt>
                <c:pt idx="634">
                  <c:v>91.8</c:v>
                </c:pt>
                <c:pt idx="635">
                  <c:v>96.9</c:v>
                </c:pt>
                <c:pt idx="636">
                  <c:v>99.4</c:v>
                </c:pt>
                <c:pt idx="637">
                  <c:v>99.9</c:v>
                </c:pt>
                <c:pt idx="638">
                  <c:v>99.7</c:v>
                </c:pt>
                <c:pt idx="639">
                  <c:v>92.9</c:v>
                </c:pt>
                <c:pt idx="640">
                  <c:v>97.7</c:v>
                </c:pt>
                <c:pt idx="641">
                  <c:v>96</c:v>
                </c:pt>
                <c:pt idx="642">
                  <c:v>97.2</c:v>
                </c:pt>
                <c:pt idx="643">
                  <c:v>98.7</c:v>
                </c:pt>
                <c:pt idx="644">
                  <c:v>97.9</c:v>
                </c:pt>
                <c:pt idx="645">
                  <c:v>99.2</c:v>
                </c:pt>
                <c:pt idx="646">
                  <c:v>93.5</c:v>
                </c:pt>
                <c:pt idx="647">
                  <c:v>99</c:v>
                </c:pt>
                <c:pt idx="648">
                  <c:v>96.1</c:v>
                </c:pt>
                <c:pt idx="649">
                  <c:v>98.8</c:v>
                </c:pt>
                <c:pt idx="650">
                  <c:v>98.7</c:v>
                </c:pt>
                <c:pt idx="651">
                  <c:v>91.3</c:v>
                </c:pt>
                <c:pt idx="652">
                  <c:v>98.6</c:v>
                </c:pt>
                <c:pt idx="653">
                  <c:v>92.1</c:v>
                </c:pt>
                <c:pt idx="654">
                  <c:v>98.7</c:v>
                </c:pt>
                <c:pt idx="655">
                  <c:v>97.8</c:v>
                </c:pt>
                <c:pt idx="656">
                  <c:v>91.6</c:v>
                </c:pt>
                <c:pt idx="657">
                  <c:v>98.3</c:v>
                </c:pt>
                <c:pt idx="658">
                  <c:v>94.4</c:v>
                </c:pt>
                <c:pt idx="659">
                  <c:v>98.5</c:v>
                </c:pt>
                <c:pt idx="660">
                  <c:v>98.1</c:v>
                </c:pt>
                <c:pt idx="661">
                  <c:v>90.5</c:v>
                </c:pt>
                <c:pt idx="662">
                  <c:v>98.4</c:v>
                </c:pt>
                <c:pt idx="663">
                  <c:v>92.1</c:v>
                </c:pt>
                <c:pt idx="664">
                  <c:v>99.7</c:v>
                </c:pt>
                <c:pt idx="665">
                  <c:v>94.8</c:v>
                </c:pt>
                <c:pt idx="666">
                  <c:v>92</c:v>
                </c:pt>
                <c:pt idx="667">
                  <c:v>97.9</c:v>
                </c:pt>
                <c:pt idx="668">
                  <c:v>99.9</c:v>
                </c:pt>
                <c:pt idx="669">
                  <c:v>98.4</c:v>
                </c:pt>
                <c:pt idx="670">
                  <c:v>99.4</c:v>
                </c:pt>
                <c:pt idx="671">
                  <c:v>99.9</c:v>
                </c:pt>
                <c:pt idx="672">
                  <c:v>99.9</c:v>
                </c:pt>
                <c:pt idx="673">
                  <c:v>99.9</c:v>
                </c:pt>
                <c:pt idx="674">
                  <c:v>95.8</c:v>
                </c:pt>
                <c:pt idx="675">
                  <c:v>99.1</c:v>
                </c:pt>
                <c:pt idx="676">
                  <c:v>99.9</c:v>
                </c:pt>
                <c:pt idx="677">
                  <c:v>99.9</c:v>
                </c:pt>
                <c:pt idx="678">
                  <c:v>99.3</c:v>
                </c:pt>
                <c:pt idx="679">
                  <c:v>99.9</c:v>
                </c:pt>
                <c:pt idx="680">
                  <c:v>98.5</c:v>
                </c:pt>
                <c:pt idx="681">
                  <c:v>97.9</c:v>
                </c:pt>
                <c:pt idx="682">
                  <c:v>99.9</c:v>
                </c:pt>
                <c:pt idx="683">
                  <c:v>99.9</c:v>
                </c:pt>
                <c:pt idx="684">
                  <c:v>99.9</c:v>
                </c:pt>
                <c:pt idx="685">
                  <c:v>95.4</c:v>
                </c:pt>
                <c:pt idx="686">
                  <c:v>99.5</c:v>
                </c:pt>
                <c:pt idx="687">
                  <c:v>99.9</c:v>
                </c:pt>
                <c:pt idx="688">
                  <c:v>99.9</c:v>
                </c:pt>
                <c:pt idx="689">
                  <c:v>94.6</c:v>
                </c:pt>
                <c:pt idx="690">
                  <c:v>99.9</c:v>
                </c:pt>
                <c:pt idx="691">
                  <c:v>99.6</c:v>
                </c:pt>
                <c:pt idx="692">
                  <c:v>97.5</c:v>
                </c:pt>
                <c:pt idx="693">
                  <c:v>99.9</c:v>
                </c:pt>
                <c:pt idx="694">
                  <c:v>96.9</c:v>
                </c:pt>
                <c:pt idx="695">
                  <c:v>99.9</c:v>
                </c:pt>
                <c:pt idx="696">
                  <c:v>99.9</c:v>
                </c:pt>
                <c:pt idx="697">
                  <c:v>96.4</c:v>
                </c:pt>
                <c:pt idx="698">
                  <c:v>99.9</c:v>
                </c:pt>
                <c:pt idx="699">
                  <c:v>99.9</c:v>
                </c:pt>
                <c:pt idx="700">
                  <c:v>96.3</c:v>
                </c:pt>
                <c:pt idx="701">
                  <c:v>99.9</c:v>
                </c:pt>
                <c:pt idx="702">
                  <c:v>97.3</c:v>
                </c:pt>
                <c:pt idx="703">
                  <c:v>99.9</c:v>
                </c:pt>
                <c:pt idx="704">
                  <c:v>99.9</c:v>
                </c:pt>
                <c:pt idx="705">
                  <c:v>94</c:v>
                </c:pt>
                <c:pt idx="706">
                  <c:v>98.5</c:v>
                </c:pt>
                <c:pt idx="707">
                  <c:v>99.9</c:v>
                </c:pt>
                <c:pt idx="708">
                  <c:v>99.9</c:v>
                </c:pt>
                <c:pt idx="709">
                  <c:v>95.5</c:v>
                </c:pt>
                <c:pt idx="710">
                  <c:v>99.5</c:v>
                </c:pt>
                <c:pt idx="711">
                  <c:v>99.9</c:v>
                </c:pt>
                <c:pt idx="712">
                  <c:v>99.9</c:v>
                </c:pt>
                <c:pt idx="713">
                  <c:v>94.4</c:v>
                </c:pt>
                <c:pt idx="714">
                  <c:v>99.3</c:v>
                </c:pt>
                <c:pt idx="715">
                  <c:v>99.9</c:v>
                </c:pt>
                <c:pt idx="716">
                  <c:v>99.9</c:v>
                </c:pt>
                <c:pt idx="717">
                  <c:v>99</c:v>
                </c:pt>
                <c:pt idx="718">
                  <c:v>99.9</c:v>
                </c:pt>
                <c:pt idx="719">
                  <c:v>98.9</c:v>
                </c:pt>
                <c:pt idx="720">
                  <c:v>99.9</c:v>
                </c:pt>
                <c:pt idx="721">
                  <c:v>98.2</c:v>
                </c:pt>
                <c:pt idx="722">
                  <c:v>99.9</c:v>
                </c:pt>
                <c:pt idx="723">
                  <c:v>99.1</c:v>
                </c:pt>
                <c:pt idx="724">
                  <c:v>98</c:v>
                </c:pt>
                <c:pt idx="725">
                  <c:v>99.5</c:v>
                </c:pt>
                <c:pt idx="726">
                  <c:v>97.6</c:v>
                </c:pt>
                <c:pt idx="727">
                  <c:v>99.8</c:v>
                </c:pt>
                <c:pt idx="728">
                  <c:v>99.9</c:v>
                </c:pt>
                <c:pt idx="729">
                  <c:v>99.9</c:v>
                </c:pt>
                <c:pt idx="730">
                  <c:v>96</c:v>
                </c:pt>
                <c:pt idx="731">
                  <c:v>99.8</c:v>
                </c:pt>
                <c:pt idx="732">
                  <c:v>99.9</c:v>
                </c:pt>
                <c:pt idx="733">
                  <c:v>99.9</c:v>
                </c:pt>
                <c:pt idx="734">
                  <c:v>95.9</c:v>
                </c:pt>
                <c:pt idx="735">
                  <c:v>99.9</c:v>
                </c:pt>
                <c:pt idx="736">
                  <c:v>99.9</c:v>
                </c:pt>
                <c:pt idx="737">
                  <c:v>94.6</c:v>
                </c:pt>
                <c:pt idx="738">
                  <c:v>99.9</c:v>
                </c:pt>
                <c:pt idx="739">
                  <c:v>99.9</c:v>
                </c:pt>
                <c:pt idx="740">
                  <c:v>99.9</c:v>
                </c:pt>
                <c:pt idx="741">
                  <c:v>96.9</c:v>
                </c:pt>
                <c:pt idx="742">
                  <c:v>99.9</c:v>
                </c:pt>
                <c:pt idx="743">
                  <c:v>99.9</c:v>
                </c:pt>
                <c:pt idx="744">
                  <c:v>94.6</c:v>
                </c:pt>
                <c:pt idx="745">
                  <c:v>99.8</c:v>
                </c:pt>
                <c:pt idx="746">
                  <c:v>99.9</c:v>
                </c:pt>
                <c:pt idx="747">
                  <c:v>94.6</c:v>
                </c:pt>
                <c:pt idx="748">
                  <c:v>99.8</c:v>
                </c:pt>
                <c:pt idx="749">
                  <c:v>96.2</c:v>
                </c:pt>
                <c:pt idx="750">
                  <c:v>99.8</c:v>
                </c:pt>
                <c:pt idx="751">
                  <c:v>99.9</c:v>
                </c:pt>
                <c:pt idx="752">
                  <c:v>94.3</c:v>
                </c:pt>
                <c:pt idx="753">
                  <c:v>99</c:v>
                </c:pt>
                <c:pt idx="754">
                  <c:v>99.9</c:v>
                </c:pt>
                <c:pt idx="755">
                  <c:v>99.9</c:v>
                </c:pt>
                <c:pt idx="756">
                  <c:v>95.5</c:v>
                </c:pt>
                <c:pt idx="757">
                  <c:v>99.5</c:v>
                </c:pt>
                <c:pt idx="758">
                  <c:v>99.9</c:v>
                </c:pt>
                <c:pt idx="759">
                  <c:v>99.9</c:v>
                </c:pt>
                <c:pt idx="760">
                  <c:v>94.7</c:v>
                </c:pt>
                <c:pt idx="761">
                  <c:v>96.9</c:v>
                </c:pt>
                <c:pt idx="762">
                  <c:v>99.9</c:v>
                </c:pt>
                <c:pt idx="763">
                  <c:v>95</c:v>
                </c:pt>
                <c:pt idx="764">
                  <c:v>99.5</c:v>
                </c:pt>
                <c:pt idx="765">
                  <c:v>99.9</c:v>
                </c:pt>
                <c:pt idx="766">
                  <c:v>99.9</c:v>
                </c:pt>
                <c:pt idx="767">
                  <c:v>99.5</c:v>
                </c:pt>
                <c:pt idx="768">
                  <c:v>99.9</c:v>
                </c:pt>
                <c:pt idx="769">
                  <c:v>99.9</c:v>
                </c:pt>
                <c:pt idx="770">
                  <c:v>96.8</c:v>
                </c:pt>
                <c:pt idx="771">
                  <c:v>99.8</c:v>
                </c:pt>
                <c:pt idx="772">
                  <c:v>98.9</c:v>
                </c:pt>
                <c:pt idx="773">
                  <c:v>97</c:v>
                </c:pt>
                <c:pt idx="774">
                  <c:v>99.9</c:v>
                </c:pt>
                <c:pt idx="775">
                  <c:v>98.6</c:v>
                </c:pt>
                <c:pt idx="776">
                  <c:v>99.9</c:v>
                </c:pt>
                <c:pt idx="777">
                  <c:v>97.5</c:v>
                </c:pt>
                <c:pt idx="778">
                  <c:v>99.9</c:v>
                </c:pt>
                <c:pt idx="779">
                  <c:v>96.2</c:v>
                </c:pt>
                <c:pt idx="780">
                  <c:v>99.9</c:v>
                </c:pt>
                <c:pt idx="781">
                  <c:v>96.4</c:v>
                </c:pt>
                <c:pt idx="782">
                  <c:v>99.9</c:v>
                </c:pt>
                <c:pt idx="783">
                  <c:v>95.3</c:v>
                </c:pt>
                <c:pt idx="784">
                  <c:v>99.9</c:v>
                </c:pt>
                <c:pt idx="785">
                  <c:v>97.6</c:v>
                </c:pt>
                <c:pt idx="786">
                  <c:v>99.9</c:v>
                </c:pt>
                <c:pt idx="787">
                  <c:v>95</c:v>
                </c:pt>
                <c:pt idx="788">
                  <c:v>99.9</c:v>
                </c:pt>
                <c:pt idx="789">
                  <c:v>97.3</c:v>
                </c:pt>
                <c:pt idx="790">
                  <c:v>99.9</c:v>
                </c:pt>
                <c:pt idx="791">
                  <c:v>99.6</c:v>
                </c:pt>
                <c:pt idx="792">
                  <c:v>97.1</c:v>
                </c:pt>
                <c:pt idx="793">
                  <c:v>99.9</c:v>
                </c:pt>
                <c:pt idx="794">
                  <c:v>99.9</c:v>
                </c:pt>
                <c:pt idx="795">
                  <c:v>97.7</c:v>
                </c:pt>
                <c:pt idx="796">
                  <c:v>95.8</c:v>
                </c:pt>
                <c:pt idx="797">
                  <c:v>99.8</c:v>
                </c:pt>
                <c:pt idx="798">
                  <c:v>99.9</c:v>
                </c:pt>
                <c:pt idx="799">
                  <c:v>99.9</c:v>
                </c:pt>
                <c:pt idx="800">
                  <c:v>97.2</c:v>
                </c:pt>
                <c:pt idx="801">
                  <c:v>99.9</c:v>
                </c:pt>
                <c:pt idx="802">
                  <c:v>99.9</c:v>
                </c:pt>
                <c:pt idx="803">
                  <c:v>98.8</c:v>
                </c:pt>
                <c:pt idx="804">
                  <c:v>99.9</c:v>
                </c:pt>
                <c:pt idx="805">
                  <c:v>97.6</c:v>
                </c:pt>
                <c:pt idx="806">
                  <c:v>98.7</c:v>
                </c:pt>
                <c:pt idx="807">
                  <c:v>99.9</c:v>
                </c:pt>
                <c:pt idx="808">
                  <c:v>99.9</c:v>
                </c:pt>
                <c:pt idx="809">
                  <c:v>96.4</c:v>
                </c:pt>
                <c:pt idx="810">
                  <c:v>99.9</c:v>
                </c:pt>
                <c:pt idx="811">
                  <c:v>98.4</c:v>
                </c:pt>
                <c:pt idx="812">
                  <c:v>95.6</c:v>
                </c:pt>
                <c:pt idx="813">
                  <c:v>99.9</c:v>
                </c:pt>
                <c:pt idx="814">
                  <c:v>97.3</c:v>
                </c:pt>
                <c:pt idx="815">
                  <c:v>99.9</c:v>
                </c:pt>
                <c:pt idx="816">
                  <c:v>99.7</c:v>
                </c:pt>
                <c:pt idx="817">
                  <c:v>99.2</c:v>
                </c:pt>
                <c:pt idx="818">
                  <c:v>99.9</c:v>
                </c:pt>
                <c:pt idx="819">
                  <c:v>99.9</c:v>
                </c:pt>
                <c:pt idx="820">
                  <c:v>98</c:v>
                </c:pt>
                <c:pt idx="821">
                  <c:v>99.9</c:v>
                </c:pt>
                <c:pt idx="822">
                  <c:v>99.5</c:v>
                </c:pt>
                <c:pt idx="823">
                  <c:v>99.9</c:v>
                </c:pt>
                <c:pt idx="824">
                  <c:v>96.1</c:v>
                </c:pt>
                <c:pt idx="825">
                  <c:v>99.9</c:v>
                </c:pt>
                <c:pt idx="826">
                  <c:v>99.9</c:v>
                </c:pt>
                <c:pt idx="827">
                  <c:v>99.2</c:v>
                </c:pt>
                <c:pt idx="828">
                  <c:v>99.9</c:v>
                </c:pt>
                <c:pt idx="829">
                  <c:v>99.4</c:v>
                </c:pt>
                <c:pt idx="830">
                  <c:v>99.9</c:v>
                </c:pt>
                <c:pt idx="831">
                  <c:v>97.4</c:v>
                </c:pt>
                <c:pt idx="832">
                  <c:v>97.9</c:v>
                </c:pt>
                <c:pt idx="833">
                  <c:v>99.4</c:v>
                </c:pt>
                <c:pt idx="834">
                  <c:v>99.9</c:v>
                </c:pt>
                <c:pt idx="835">
                  <c:v>99.6</c:v>
                </c:pt>
                <c:pt idx="836">
                  <c:v>99.9</c:v>
                </c:pt>
                <c:pt idx="837">
                  <c:v>95.6</c:v>
                </c:pt>
                <c:pt idx="838">
                  <c:v>99.4</c:v>
                </c:pt>
                <c:pt idx="839">
                  <c:v>99.9</c:v>
                </c:pt>
                <c:pt idx="840">
                  <c:v>99.9</c:v>
                </c:pt>
                <c:pt idx="841">
                  <c:v>99.9</c:v>
                </c:pt>
                <c:pt idx="842">
                  <c:v>99.9</c:v>
                </c:pt>
                <c:pt idx="843">
                  <c:v>96.4</c:v>
                </c:pt>
                <c:pt idx="844">
                  <c:v>99.5</c:v>
                </c:pt>
                <c:pt idx="845">
                  <c:v>99.9</c:v>
                </c:pt>
                <c:pt idx="846">
                  <c:v>98.1</c:v>
                </c:pt>
                <c:pt idx="847">
                  <c:v>99.9</c:v>
                </c:pt>
                <c:pt idx="848">
                  <c:v>99.9</c:v>
                </c:pt>
                <c:pt idx="849">
                  <c:v>95</c:v>
                </c:pt>
                <c:pt idx="850">
                  <c:v>98.1</c:v>
                </c:pt>
                <c:pt idx="851">
                  <c:v>99.9</c:v>
                </c:pt>
                <c:pt idx="852">
                  <c:v>99.9</c:v>
                </c:pt>
                <c:pt idx="853">
                  <c:v>98.7</c:v>
                </c:pt>
                <c:pt idx="854">
                  <c:v>99.9</c:v>
                </c:pt>
                <c:pt idx="855">
                  <c:v>97.3</c:v>
                </c:pt>
                <c:pt idx="856">
                  <c:v>99.9</c:v>
                </c:pt>
                <c:pt idx="857">
                  <c:v>95.4</c:v>
                </c:pt>
                <c:pt idx="858">
                  <c:v>99.9</c:v>
                </c:pt>
                <c:pt idx="859">
                  <c:v>99.7</c:v>
                </c:pt>
                <c:pt idx="860">
                  <c:v>99.9</c:v>
                </c:pt>
                <c:pt idx="861">
                  <c:v>99.9</c:v>
                </c:pt>
                <c:pt idx="862">
                  <c:v>97.9</c:v>
                </c:pt>
                <c:pt idx="863">
                  <c:v>99.9</c:v>
                </c:pt>
                <c:pt idx="864">
                  <c:v>94.9</c:v>
                </c:pt>
                <c:pt idx="865">
                  <c:v>99.9</c:v>
                </c:pt>
                <c:pt idx="866">
                  <c:v>99.9</c:v>
                </c:pt>
                <c:pt idx="867">
                  <c:v>99.9</c:v>
                </c:pt>
                <c:pt idx="868">
                  <c:v>99.9</c:v>
                </c:pt>
                <c:pt idx="869">
                  <c:v>96.4</c:v>
                </c:pt>
                <c:pt idx="870">
                  <c:v>99.9</c:v>
                </c:pt>
                <c:pt idx="871">
                  <c:v>99.9</c:v>
                </c:pt>
                <c:pt idx="872">
                  <c:v>97.3</c:v>
                </c:pt>
                <c:pt idx="873">
                  <c:v>96.9</c:v>
                </c:pt>
                <c:pt idx="874">
                  <c:v>99.9</c:v>
                </c:pt>
                <c:pt idx="875">
                  <c:v>99.9</c:v>
                </c:pt>
                <c:pt idx="876">
                  <c:v>97.2</c:v>
                </c:pt>
                <c:pt idx="877">
                  <c:v>99.9</c:v>
                </c:pt>
                <c:pt idx="878">
                  <c:v>99.9</c:v>
                </c:pt>
                <c:pt idx="879">
                  <c:v>94.8</c:v>
                </c:pt>
                <c:pt idx="880">
                  <c:v>98.5</c:v>
                </c:pt>
                <c:pt idx="881">
                  <c:v>99.9</c:v>
                </c:pt>
                <c:pt idx="882">
                  <c:v>95.1</c:v>
                </c:pt>
                <c:pt idx="883">
                  <c:v>99.9</c:v>
                </c:pt>
                <c:pt idx="884">
                  <c:v>95.9</c:v>
                </c:pt>
                <c:pt idx="885">
                  <c:v>99.4</c:v>
                </c:pt>
                <c:pt idx="886">
                  <c:v>94</c:v>
                </c:pt>
                <c:pt idx="887">
                  <c:v>99.9</c:v>
                </c:pt>
                <c:pt idx="888">
                  <c:v>97.4</c:v>
                </c:pt>
                <c:pt idx="889">
                  <c:v>99.9</c:v>
                </c:pt>
                <c:pt idx="890">
                  <c:v>99.4</c:v>
                </c:pt>
                <c:pt idx="891">
                  <c:v>95.2</c:v>
                </c:pt>
                <c:pt idx="892">
                  <c:v>99.9</c:v>
                </c:pt>
                <c:pt idx="893">
                  <c:v>96.6</c:v>
                </c:pt>
                <c:pt idx="894">
                  <c:v>95.2</c:v>
                </c:pt>
                <c:pt idx="895">
                  <c:v>99</c:v>
                </c:pt>
                <c:pt idx="896">
                  <c:v>98</c:v>
                </c:pt>
                <c:pt idx="897">
                  <c:v>94.3</c:v>
                </c:pt>
                <c:pt idx="898">
                  <c:v>97.7</c:v>
                </c:pt>
                <c:pt idx="899">
                  <c:v>99.6</c:v>
                </c:pt>
                <c:pt idx="900">
                  <c:v>96.8</c:v>
                </c:pt>
                <c:pt idx="901">
                  <c:v>93.7</c:v>
                </c:pt>
                <c:pt idx="902">
                  <c:v>99.7</c:v>
                </c:pt>
                <c:pt idx="903">
                  <c:v>98</c:v>
                </c:pt>
                <c:pt idx="904">
                  <c:v>94.1</c:v>
                </c:pt>
                <c:pt idx="905">
                  <c:v>92.9</c:v>
                </c:pt>
                <c:pt idx="906">
                  <c:v>99.9</c:v>
                </c:pt>
                <c:pt idx="907">
                  <c:v>98.3</c:v>
                </c:pt>
                <c:pt idx="908">
                  <c:v>92.9</c:v>
                </c:pt>
                <c:pt idx="909">
                  <c:v>99.9</c:v>
                </c:pt>
                <c:pt idx="910">
                  <c:v>94.9</c:v>
                </c:pt>
                <c:pt idx="911">
                  <c:v>99.9</c:v>
                </c:pt>
                <c:pt idx="912">
                  <c:v>99.9</c:v>
                </c:pt>
                <c:pt idx="913">
                  <c:v>96.3</c:v>
                </c:pt>
                <c:pt idx="914">
                  <c:v>99.9</c:v>
                </c:pt>
                <c:pt idx="915">
                  <c:v>99.9</c:v>
                </c:pt>
                <c:pt idx="916">
                  <c:v>96.1</c:v>
                </c:pt>
                <c:pt idx="917">
                  <c:v>98.9</c:v>
                </c:pt>
                <c:pt idx="918">
                  <c:v>98.8</c:v>
                </c:pt>
                <c:pt idx="919">
                  <c:v>99.9</c:v>
                </c:pt>
                <c:pt idx="920">
                  <c:v>96.1</c:v>
                </c:pt>
                <c:pt idx="921">
                  <c:v>98.4</c:v>
                </c:pt>
                <c:pt idx="922">
                  <c:v>99.9</c:v>
                </c:pt>
                <c:pt idx="923">
                  <c:v>94.8</c:v>
                </c:pt>
                <c:pt idx="924">
                  <c:v>98.9</c:v>
                </c:pt>
                <c:pt idx="925">
                  <c:v>99.9</c:v>
                </c:pt>
                <c:pt idx="926">
                  <c:v>95.4</c:v>
                </c:pt>
                <c:pt idx="927">
                  <c:v>99.9</c:v>
                </c:pt>
                <c:pt idx="928">
                  <c:v>99.9</c:v>
                </c:pt>
                <c:pt idx="929">
                  <c:v>96.1</c:v>
                </c:pt>
                <c:pt idx="930">
                  <c:v>96.8</c:v>
                </c:pt>
                <c:pt idx="931">
                  <c:v>99.9</c:v>
                </c:pt>
                <c:pt idx="932">
                  <c:v>96.6</c:v>
                </c:pt>
                <c:pt idx="933">
                  <c:v>99.9</c:v>
                </c:pt>
                <c:pt idx="934">
                  <c:v>97.5</c:v>
                </c:pt>
                <c:pt idx="935">
                  <c:v>99.5</c:v>
                </c:pt>
                <c:pt idx="936">
                  <c:v>99.9</c:v>
                </c:pt>
                <c:pt idx="937">
                  <c:v>97.1</c:v>
                </c:pt>
                <c:pt idx="938">
                  <c:v>99.9</c:v>
                </c:pt>
                <c:pt idx="939">
                  <c:v>99.9</c:v>
                </c:pt>
                <c:pt idx="940">
                  <c:v>93.8</c:v>
                </c:pt>
                <c:pt idx="941">
                  <c:v>97.9</c:v>
                </c:pt>
                <c:pt idx="942">
                  <c:v>99.9</c:v>
                </c:pt>
                <c:pt idx="943">
                  <c:v>98.9</c:v>
                </c:pt>
                <c:pt idx="944">
                  <c:v>97.6</c:v>
                </c:pt>
                <c:pt idx="945">
                  <c:v>99.9</c:v>
                </c:pt>
                <c:pt idx="946">
                  <c:v>95</c:v>
                </c:pt>
                <c:pt idx="947">
                  <c:v>98.8</c:v>
                </c:pt>
                <c:pt idx="948">
                  <c:v>99.9</c:v>
                </c:pt>
                <c:pt idx="949">
                  <c:v>94.2</c:v>
                </c:pt>
                <c:pt idx="950">
                  <c:v>98.9</c:v>
                </c:pt>
                <c:pt idx="951">
                  <c:v>99.9</c:v>
                </c:pt>
                <c:pt idx="952">
                  <c:v>96.2</c:v>
                </c:pt>
                <c:pt idx="953">
                  <c:v>86.2</c:v>
                </c:pt>
                <c:pt idx="954">
                  <c:v>96.6</c:v>
                </c:pt>
                <c:pt idx="955">
                  <c:v>99.3</c:v>
                </c:pt>
                <c:pt idx="956">
                  <c:v>99.7</c:v>
                </c:pt>
                <c:pt idx="957">
                  <c:v>99.9</c:v>
                </c:pt>
                <c:pt idx="958">
                  <c:v>99.8</c:v>
                </c:pt>
                <c:pt idx="959">
                  <c:v>99.7</c:v>
                </c:pt>
                <c:pt idx="960">
                  <c:v>99.5</c:v>
                </c:pt>
                <c:pt idx="961">
                  <c:v>99.5</c:v>
                </c:pt>
                <c:pt idx="962">
                  <c:v>99.5</c:v>
                </c:pt>
                <c:pt idx="963">
                  <c:v>99.5</c:v>
                </c:pt>
                <c:pt idx="964">
                  <c:v>99.5</c:v>
                </c:pt>
                <c:pt idx="965">
                  <c:v>99.4</c:v>
                </c:pt>
                <c:pt idx="966">
                  <c:v>99.4</c:v>
                </c:pt>
                <c:pt idx="967">
                  <c:v>99.4</c:v>
                </c:pt>
                <c:pt idx="968">
                  <c:v>99.5</c:v>
                </c:pt>
                <c:pt idx="969">
                  <c:v>99.4</c:v>
                </c:pt>
                <c:pt idx="970">
                  <c:v>99.4</c:v>
                </c:pt>
                <c:pt idx="971">
                  <c:v>99.4</c:v>
                </c:pt>
                <c:pt idx="972">
                  <c:v>99.4</c:v>
                </c:pt>
                <c:pt idx="973">
                  <c:v>99.4</c:v>
                </c:pt>
                <c:pt idx="974">
                  <c:v>99.4</c:v>
                </c:pt>
                <c:pt idx="975">
                  <c:v>99.3</c:v>
                </c:pt>
                <c:pt idx="976">
                  <c:v>99.4</c:v>
                </c:pt>
                <c:pt idx="977">
                  <c:v>99.4</c:v>
                </c:pt>
                <c:pt idx="978">
                  <c:v>99.4</c:v>
                </c:pt>
                <c:pt idx="979">
                  <c:v>99.5</c:v>
                </c:pt>
                <c:pt idx="980">
                  <c:v>99.4</c:v>
                </c:pt>
                <c:pt idx="981">
                  <c:v>99.3</c:v>
                </c:pt>
                <c:pt idx="982">
                  <c:v>99.5</c:v>
                </c:pt>
                <c:pt idx="983">
                  <c:v>99.5</c:v>
                </c:pt>
                <c:pt idx="984">
                  <c:v>99.5</c:v>
                </c:pt>
                <c:pt idx="985">
                  <c:v>99.4</c:v>
                </c:pt>
                <c:pt idx="986">
                  <c:v>99.4</c:v>
                </c:pt>
                <c:pt idx="987">
                  <c:v>99.5</c:v>
                </c:pt>
                <c:pt idx="988">
                  <c:v>99.5</c:v>
                </c:pt>
                <c:pt idx="989">
                  <c:v>99.5</c:v>
                </c:pt>
                <c:pt idx="990">
                  <c:v>99.5</c:v>
                </c:pt>
                <c:pt idx="991">
                  <c:v>99.5</c:v>
                </c:pt>
                <c:pt idx="992">
                  <c:v>99.6</c:v>
                </c:pt>
                <c:pt idx="993">
                  <c:v>99.6</c:v>
                </c:pt>
                <c:pt idx="994">
                  <c:v>99.6</c:v>
                </c:pt>
                <c:pt idx="995">
                  <c:v>99.6</c:v>
                </c:pt>
                <c:pt idx="996">
                  <c:v>99.6</c:v>
                </c:pt>
                <c:pt idx="997">
                  <c:v>99.6</c:v>
                </c:pt>
                <c:pt idx="998">
                  <c:v>99.5</c:v>
                </c:pt>
                <c:pt idx="999">
                  <c:v>99.5</c:v>
                </c:pt>
                <c:pt idx="1000">
                  <c:v>99.6</c:v>
                </c:pt>
                <c:pt idx="1001">
                  <c:v>99.6</c:v>
                </c:pt>
                <c:pt idx="1002">
                  <c:v>99.6</c:v>
                </c:pt>
                <c:pt idx="1003">
                  <c:v>99.6</c:v>
                </c:pt>
                <c:pt idx="1004">
                  <c:v>99.6</c:v>
                </c:pt>
                <c:pt idx="1005">
                  <c:v>99.6</c:v>
                </c:pt>
                <c:pt idx="1006">
                  <c:v>99.6</c:v>
                </c:pt>
                <c:pt idx="1007">
                  <c:v>99.5</c:v>
                </c:pt>
                <c:pt idx="1008">
                  <c:v>99.6</c:v>
                </c:pt>
                <c:pt idx="1009">
                  <c:v>99.6</c:v>
                </c:pt>
                <c:pt idx="1010">
                  <c:v>99.5</c:v>
                </c:pt>
                <c:pt idx="1011">
                  <c:v>99.7</c:v>
                </c:pt>
                <c:pt idx="1012">
                  <c:v>99.7</c:v>
                </c:pt>
                <c:pt idx="1013">
                  <c:v>99.7</c:v>
                </c:pt>
                <c:pt idx="1014">
                  <c:v>99.7</c:v>
                </c:pt>
                <c:pt idx="1015">
                  <c:v>99.7</c:v>
                </c:pt>
                <c:pt idx="1016">
                  <c:v>99.7</c:v>
                </c:pt>
                <c:pt idx="1017">
                  <c:v>99.7</c:v>
                </c:pt>
                <c:pt idx="1018">
                  <c:v>99.7</c:v>
                </c:pt>
                <c:pt idx="1019">
                  <c:v>99.7</c:v>
                </c:pt>
                <c:pt idx="1020">
                  <c:v>99.7</c:v>
                </c:pt>
                <c:pt idx="1021">
                  <c:v>99.7</c:v>
                </c:pt>
                <c:pt idx="1022">
                  <c:v>99.7</c:v>
                </c:pt>
                <c:pt idx="1023">
                  <c:v>99.6</c:v>
                </c:pt>
                <c:pt idx="1024">
                  <c:v>99.7</c:v>
                </c:pt>
                <c:pt idx="1025">
                  <c:v>99.7</c:v>
                </c:pt>
                <c:pt idx="1026">
                  <c:v>99.8</c:v>
                </c:pt>
                <c:pt idx="1027">
                  <c:v>99.8</c:v>
                </c:pt>
                <c:pt idx="1028">
                  <c:v>99.8</c:v>
                </c:pt>
                <c:pt idx="1029">
                  <c:v>99.8</c:v>
                </c:pt>
                <c:pt idx="1030">
                  <c:v>99.9</c:v>
                </c:pt>
                <c:pt idx="1031">
                  <c:v>99.8</c:v>
                </c:pt>
                <c:pt idx="1032">
                  <c:v>99.8</c:v>
                </c:pt>
                <c:pt idx="1033">
                  <c:v>99.7</c:v>
                </c:pt>
                <c:pt idx="1034">
                  <c:v>99.6</c:v>
                </c:pt>
                <c:pt idx="1035">
                  <c:v>99.7</c:v>
                </c:pt>
                <c:pt idx="1036">
                  <c:v>99.7</c:v>
                </c:pt>
                <c:pt idx="1037">
                  <c:v>99.7</c:v>
                </c:pt>
                <c:pt idx="1038">
                  <c:v>99.8</c:v>
                </c:pt>
                <c:pt idx="1039">
                  <c:v>99.8</c:v>
                </c:pt>
                <c:pt idx="1040">
                  <c:v>99.8</c:v>
                </c:pt>
                <c:pt idx="1041">
                  <c:v>99.8</c:v>
                </c:pt>
                <c:pt idx="1042">
                  <c:v>99.8</c:v>
                </c:pt>
                <c:pt idx="1043">
                  <c:v>99.8</c:v>
                </c:pt>
                <c:pt idx="1044">
                  <c:v>99.8</c:v>
                </c:pt>
                <c:pt idx="1045">
                  <c:v>99.7</c:v>
                </c:pt>
                <c:pt idx="1046">
                  <c:v>99.8</c:v>
                </c:pt>
                <c:pt idx="1047">
                  <c:v>99.8</c:v>
                </c:pt>
                <c:pt idx="1048">
                  <c:v>99.9</c:v>
                </c:pt>
                <c:pt idx="1049">
                  <c:v>99.7</c:v>
                </c:pt>
                <c:pt idx="1050">
                  <c:v>99.7</c:v>
                </c:pt>
                <c:pt idx="1051">
                  <c:v>99.8</c:v>
                </c:pt>
                <c:pt idx="1052">
                  <c:v>99.8</c:v>
                </c:pt>
                <c:pt idx="1053">
                  <c:v>99.9</c:v>
                </c:pt>
                <c:pt idx="1054">
                  <c:v>99.9</c:v>
                </c:pt>
                <c:pt idx="1055">
                  <c:v>99.9</c:v>
                </c:pt>
                <c:pt idx="1056">
                  <c:v>99.9</c:v>
                </c:pt>
                <c:pt idx="1057">
                  <c:v>99.8</c:v>
                </c:pt>
                <c:pt idx="1058">
                  <c:v>99.7</c:v>
                </c:pt>
                <c:pt idx="1059">
                  <c:v>99.8</c:v>
                </c:pt>
                <c:pt idx="1060">
                  <c:v>99.8</c:v>
                </c:pt>
                <c:pt idx="1061">
                  <c:v>99.9</c:v>
                </c:pt>
                <c:pt idx="1062">
                  <c:v>99.9</c:v>
                </c:pt>
                <c:pt idx="1063">
                  <c:v>99.8</c:v>
                </c:pt>
                <c:pt idx="1064">
                  <c:v>99.8</c:v>
                </c:pt>
                <c:pt idx="1065">
                  <c:v>99.9</c:v>
                </c:pt>
                <c:pt idx="1066">
                  <c:v>99.9</c:v>
                </c:pt>
                <c:pt idx="1067">
                  <c:v>99.9</c:v>
                </c:pt>
                <c:pt idx="1068">
                  <c:v>99.8</c:v>
                </c:pt>
                <c:pt idx="1069">
                  <c:v>99.9</c:v>
                </c:pt>
                <c:pt idx="1070">
                  <c:v>99.9</c:v>
                </c:pt>
                <c:pt idx="1071">
                  <c:v>99.9</c:v>
                </c:pt>
                <c:pt idx="1072">
                  <c:v>99.9</c:v>
                </c:pt>
                <c:pt idx="1073">
                  <c:v>99.9</c:v>
                </c:pt>
                <c:pt idx="1074">
                  <c:v>99.9</c:v>
                </c:pt>
                <c:pt idx="1075">
                  <c:v>99.9</c:v>
                </c:pt>
                <c:pt idx="1076">
                  <c:v>99.8</c:v>
                </c:pt>
                <c:pt idx="1077">
                  <c:v>99.9</c:v>
                </c:pt>
                <c:pt idx="1078">
                  <c:v>99.9</c:v>
                </c:pt>
                <c:pt idx="1079">
                  <c:v>99.9</c:v>
                </c:pt>
                <c:pt idx="1080">
                  <c:v>99.9</c:v>
                </c:pt>
                <c:pt idx="1081">
                  <c:v>99.9</c:v>
                </c:pt>
                <c:pt idx="1082">
                  <c:v>99.8</c:v>
                </c:pt>
                <c:pt idx="1083">
                  <c:v>99.8</c:v>
                </c:pt>
                <c:pt idx="1084">
                  <c:v>99.9</c:v>
                </c:pt>
                <c:pt idx="1085">
                  <c:v>99.9</c:v>
                </c:pt>
                <c:pt idx="1086">
                  <c:v>99.9</c:v>
                </c:pt>
                <c:pt idx="1087">
                  <c:v>99.9</c:v>
                </c:pt>
                <c:pt idx="1088">
                  <c:v>99.9</c:v>
                </c:pt>
                <c:pt idx="1089">
                  <c:v>99.8</c:v>
                </c:pt>
                <c:pt idx="1090">
                  <c:v>99.8</c:v>
                </c:pt>
                <c:pt idx="1091">
                  <c:v>99.8</c:v>
                </c:pt>
                <c:pt idx="1092">
                  <c:v>99.9</c:v>
                </c:pt>
                <c:pt idx="1093">
                  <c:v>99.8</c:v>
                </c:pt>
                <c:pt idx="1094">
                  <c:v>99.8</c:v>
                </c:pt>
                <c:pt idx="1095">
                  <c:v>99.7</c:v>
                </c:pt>
                <c:pt idx="1096">
                  <c:v>99.8</c:v>
                </c:pt>
                <c:pt idx="1097">
                  <c:v>99.9</c:v>
                </c:pt>
                <c:pt idx="1098">
                  <c:v>99.9</c:v>
                </c:pt>
                <c:pt idx="1099">
                  <c:v>99.9</c:v>
                </c:pt>
                <c:pt idx="1100">
                  <c:v>99.9</c:v>
                </c:pt>
                <c:pt idx="1101">
                  <c:v>99.9</c:v>
                </c:pt>
                <c:pt idx="1102">
                  <c:v>99.9</c:v>
                </c:pt>
                <c:pt idx="1103">
                  <c:v>99.9</c:v>
                </c:pt>
                <c:pt idx="1104">
                  <c:v>99.9</c:v>
                </c:pt>
                <c:pt idx="1105">
                  <c:v>99.9</c:v>
                </c:pt>
                <c:pt idx="1106">
                  <c:v>99.9</c:v>
                </c:pt>
                <c:pt idx="1107">
                  <c:v>99.9</c:v>
                </c:pt>
                <c:pt idx="1108">
                  <c:v>99.9</c:v>
                </c:pt>
                <c:pt idx="1109">
                  <c:v>99.9</c:v>
                </c:pt>
                <c:pt idx="1110">
                  <c:v>99.9</c:v>
                </c:pt>
                <c:pt idx="1111">
                  <c:v>99.9</c:v>
                </c:pt>
                <c:pt idx="1112">
                  <c:v>99.9</c:v>
                </c:pt>
                <c:pt idx="1113">
                  <c:v>99.9</c:v>
                </c:pt>
                <c:pt idx="1114">
                  <c:v>99.9</c:v>
                </c:pt>
                <c:pt idx="1115">
                  <c:v>99.9</c:v>
                </c:pt>
                <c:pt idx="1116">
                  <c:v>99.9</c:v>
                </c:pt>
                <c:pt idx="1117">
                  <c:v>99.9</c:v>
                </c:pt>
                <c:pt idx="1118">
                  <c:v>99.9</c:v>
                </c:pt>
                <c:pt idx="1119">
                  <c:v>99.9</c:v>
                </c:pt>
                <c:pt idx="1120">
                  <c:v>99.9</c:v>
                </c:pt>
                <c:pt idx="1121">
                  <c:v>99.9</c:v>
                </c:pt>
                <c:pt idx="1122">
                  <c:v>99.6</c:v>
                </c:pt>
                <c:pt idx="1123">
                  <c:v>99.9</c:v>
                </c:pt>
                <c:pt idx="1124">
                  <c:v>99.9</c:v>
                </c:pt>
                <c:pt idx="1125">
                  <c:v>99.9</c:v>
                </c:pt>
                <c:pt idx="1126">
                  <c:v>99.9</c:v>
                </c:pt>
                <c:pt idx="1127">
                  <c:v>99.9</c:v>
                </c:pt>
                <c:pt idx="1128">
                  <c:v>99.9</c:v>
                </c:pt>
                <c:pt idx="1129">
                  <c:v>99.9</c:v>
                </c:pt>
                <c:pt idx="1130">
                  <c:v>99.9</c:v>
                </c:pt>
                <c:pt idx="1131">
                  <c:v>99.9</c:v>
                </c:pt>
                <c:pt idx="1132">
                  <c:v>99.9</c:v>
                </c:pt>
                <c:pt idx="1133">
                  <c:v>99.9</c:v>
                </c:pt>
                <c:pt idx="1134">
                  <c:v>99.9</c:v>
                </c:pt>
                <c:pt idx="1135">
                  <c:v>99.9</c:v>
                </c:pt>
                <c:pt idx="1136">
                  <c:v>99.9</c:v>
                </c:pt>
                <c:pt idx="1137">
                  <c:v>99.9</c:v>
                </c:pt>
                <c:pt idx="1138">
                  <c:v>99.9</c:v>
                </c:pt>
                <c:pt idx="1139">
                  <c:v>99.9</c:v>
                </c:pt>
                <c:pt idx="1140">
                  <c:v>99.9</c:v>
                </c:pt>
                <c:pt idx="1141">
                  <c:v>99.9</c:v>
                </c:pt>
                <c:pt idx="1142">
                  <c:v>99.9</c:v>
                </c:pt>
                <c:pt idx="1143">
                  <c:v>99.9</c:v>
                </c:pt>
                <c:pt idx="1144">
                  <c:v>99.9</c:v>
                </c:pt>
                <c:pt idx="1145">
                  <c:v>99.9</c:v>
                </c:pt>
                <c:pt idx="1146">
                  <c:v>99.9</c:v>
                </c:pt>
                <c:pt idx="1147">
                  <c:v>99.9</c:v>
                </c:pt>
                <c:pt idx="1148">
                  <c:v>99.9</c:v>
                </c:pt>
                <c:pt idx="1149">
                  <c:v>99.9</c:v>
                </c:pt>
                <c:pt idx="1150">
                  <c:v>99.9</c:v>
                </c:pt>
                <c:pt idx="1151">
                  <c:v>99.9</c:v>
                </c:pt>
                <c:pt idx="1152">
                  <c:v>99.9</c:v>
                </c:pt>
                <c:pt idx="1153">
                  <c:v>99.9</c:v>
                </c:pt>
                <c:pt idx="1154">
                  <c:v>99.9</c:v>
                </c:pt>
                <c:pt idx="1155">
                  <c:v>99.9</c:v>
                </c:pt>
                <c:pt idx="1156">
                  <c:v>99.9</c:v>
                </c:pt>
                <c:pt idx="1157">
                  <c:v>99.9</c:v>
                </c:pt>
                <c:pt idx="1158">
                  <c:v>99.9</c:v>
                </c:pt>
                <c:pt idx="1159">
                  <c:v>99.9</c:v>
                </c:pt>
                <c:pt idx="1160">
                  <c:v>99.9</c:v>
                </c:pt>
                <c:pt idx="1161">
                  <c:v>99.9</c:v>
                </c:pt>
                <c:pt idx="1162">
                  <c:v>99.9</c:v>
                </c:pt>
                <c:pt idx="1163">
                  <c:v>99.9</c:v>
                </c:pt>
                <c:pt idx="1164">
                  <c:v>99.9</c:v>
                </c:pt>
                <c:pt idx="1165">
                  <c:v>99.9</c:v>
                </c:pt>
                <c:pt idx="1166">
                  <c:v>99.9</c:v>
                </c:pt>
                <c:pt idx="1167">
                  <c:v>99.9</c:v>
                </c:pt>
                <c:pt idx="1168">
                  <c:v>99.9</c:v>
                </c:pt>
                <c:pt idx="1169">
                  <c:v>99.9</c:v>
                </c:pt>
                <c:pt idx="1170">
                  <c:v>99.9</c:v>
                </c:pt>
                <c:pt idx="1171">
                  <c:v>99.9</c:v>
                </c:pt>
                <c:pt idx="1172">
                  <c:v>99.9</c:v>
                </c:pt>
                <c:pt idx="1173">
                  <c:v>99.9</c:v>
                </c:pt>
                <c:pt idx="1174">
                  <c:v>99.9</c:v>
                </c:pt>
                <c:pt idx="1175">
                  <c:v>99.9</c:v>
                </c:pt>
                <c:pt idx="1176">
                  <c:v>99.9</c:v>
                </c:pt>
                <c:pt idx="1177">
                  <c:v>99.9</c:v>
                </c:pt>
                <c:pt idx="1178">
                  <c:v>99.9</c:v>
                </c:pt>
                <c:pt idx="1179">
                  <c:v>99.9</c:v>
                </c:pt>
                <c:pt idx="1180">
                  <c:v>99.9</c:v>
                </c:pt>
                <c:pt idx="1181">
                  <c:v>99.9</c:v>
                </c:pt>
                <c:pt idx="1182">
                  <c:v>99.9</c:v>
                </c:pt>
                <c:pt idx="1183">
                  <c:v>99.9</c:v>
                </c:pt>
                <c:pt idx="1184">
                  <c:v>99.9</c:v>
                </c:pt>
                <c:pt idx="1185">
                  <c:v>99.9</c:v>
                </c:pt>
                <c:pt idx="1186">
                  <c:v>99.9</c:v>
                </c:pt>
                <c:pt idx="1187">
                  <c:v>99.9</c:v>
                </c:pt>
                <c:pt idx="1188">
                  <c:v>99.9</c:v>
                </c:pt>
                <c:pt idx="1189">
                  <c:v>99.9</c:v>
                </c:pt>
                <c:pt idx="1190">
                  <c:v>99.9</c:v>
                </c:pt>
                <c:pt idx="1191">
                  <c:v>99.9</c:v>
                </c:pt>
                <c:pt idx="1192">
                  <c:v>99.9</c:v>
                </c:pt>
                <c:pt idx="1193">
                  <c:v>99.9</c:v>
                </c:pt>
                <c:pt idx="1194">
                  <c:v>99.9</c:v>
                </c:pt>
                <c:pt idx="1195">
                  <c:v>99.9</c:v>
                </c:pt>
                <c:pt idx="1196">
                  <c:v>99.9</c:v>
                </c:pt>
                <c:pt idx="1197">
                  <c:v>99.9</c:v>
                </c:pt>
                <c:pt idx="1198">
                  <c:v>99.9</c:v>
                </c:pt>
                <c:pt idx="1199">
                  <c:v>99.9</c:v>
                </c:pt>
                <c:pt idx="1200">
                  <c:v>99.9</c:v>
                </c:pt>
                <c:pt idx="1201">
                  <c:v>99.9</c:v>
                </c:pt>
                <c:pt idx="1202">
                  <c:v>99.9</c:v>
                </c:pt>
                <c:pt idx="1203">
                  <c:v>99.9</c:v>
                </c:pt>
                <c:pt idx="1204">
                  <c:v>99.9</c:v>
                </c:pt>
                <c:pt idx="1205">
                  <c:v>99.9</c:v>
                </c:pt>
                <c:pt idx="1206">
                  <c:v>99.9</c:v>
                </c:pt>
                <c:pt idx="1207">
                  <c:v>99.9</c:v>
                </c:pt>
                <c:pt idx="1208">
                  <c:v>99.9</c:v>
                </c:pt>
                <c:pt idx="1209">
                  <c:v>99.9</c:v>
                </c:pt>
                <c:pt idx="1210">
                  <c:v>99.9</c:v>
                </c:pt>
                <c:pt idx="1211">
                  <c:v>99.9</c:v>
                </c:pt>
                <c:pt idx="1212">
                  <c:v>99.9</c:v>
                </c:pt>
                <c:pt idx="1213">
                  <c:v>99.9</c:v>
                </c:pt>
                <c:pt idx="1214">
                  <c:v>99.9</c:v>
                </c:pt>
                <c:pt idx="1215">
                  <c:v>99.9</c:v>
                </c:pt>
                <c:pt idx="1216">
                  <c:v>99.9</c:v>
                </c:pt>
                <c:pt idx="1217">
                  <c:v>99.9</c:v>
                </c:pt>
                <c:pt idx="1218">
                  <c:v>99.9</c:v>
                </c:pt>
                <c:pt idx="1219">
                  <c:v>99.9</c:v>
                </c:pt>
                <c:pt idx="1220">
                  <c:v>99.9</c:v>
                </c:pt>
                <c:pt idx="1221">
                  <c:v>99.9</c:v>
                </c:pt>
                <c:pt idx="1222">
                  <c:v>99.9</c:v>
                </c:pt>
                <c:pt idx="1223">
                  <c:v>99.9</c:v>
                </c:pt>
                <c:pt idx="1224">
                  <c:v>99.9</c:v>
                </c:pt>
                <c:pt idx="1225">
                  <c:v>99.9</c:v>
                </c:pt>
                <c:pt idx="1226">
                  <c:v>99.9</c:v>
                </c:pt>
                <c:pt idx="1227">
                  <c:v>99.9</c:v>
                </c:pt>
                <c:pt idx="1228">
                  <c:v>99.9</c:v>
                </c:pt>
                <c:pt idx="1229">
                  <c:v>99.9</c:v>
                </c:pt>
                <c:pt idx="1230">
                  <c:v>99.9</c:v>
                </c:pt>
                <c:pt idx="1231">
                  <c:v>99.9</c:v>
                </c:pt>
                <c:pt idx="1232">
                  <c:v>99.9</c:v>
                </c:pt>
                <c:pt idx="1233">
                  <c:v>99.9</c:v>
                </c:pt>
                <c:pt idx="1234">
                  <c:v>99.9</c:v>
                </c:pt>
                <c:pt idx="1235">
                  <c:v>99.9</c:v>
                </c:pt>
                <c:pt idx="1236">
                  <c:v>99.9</c:v>
                </c:pt>
                <c:pt idx="1237">
                  <c:v>99.9</c:v>
                </c:pt>
                <c:pt idx="1238">
                  <c:v>99.9</c:v>
                </c:pt>
                <c:pt idx="1239">
                  <c:v>99.9</c:v>
                </c:pt>
                <c:pt idx="1240">
                  <c:v>99.9</c:v>
                </c:pt>
                <c:pt idx="1241">
                  <c:v>99.9</c:v>
                </c:pt>
                <c:pt idx="1242">
                  <c:v>99.9</c:v>
                </c:pt>
                <c:pt idx="1243">
                  <c:v>99.9</c:v>
                </c:pt>
                <c:pt idx="1244">
                  <c:v>99.9</c:v>
                </c:pt>
                <c:pt idx="1245">
                  <c:v>99.9</c:v>
                </c:pt>
                <c:pt idx="1246">
                  <c:v>99.9</c:v>
                </c:pt>
                <c:pt idx="1247">
                  <c:v>99.9</c:v>
                </c:pt>
                <c:pt idx="1248">
                  <c:v>99.9</c:v>
                </c:pt>
                <c:pt idx="1249">
                  <c:v>99.9</c:v>
                </c:pt>
                <c:pt idx="1250">
                  <c:v>99.9</c:v>
                </c:pt>
                <c:pt idx="1251">
                  <c:v>99.9</c:v>
                </c:pt>
                <c:pt idx="1252">
                  <c:v>99.9</c:v>
                </c:pt>
                <c:pt idx="1253">
                  <c:v>99.9</c:v>
                </c:pt>
                <c:pt idx="1254">
                  <c:v>99.9</c:v>
                </c:pt>
                <c:pt idx="1255">
                  <c:v>99.9</c:v>
                </c:pt>
                <c:pt idx="1256">
                  <c:v>99.9</c:v>
                </c:pt>
                <c:pt idx="1257">
                  <c:v>99.9</c:v>
                </c:pt>
                <c:pt idx="1258">
                  <c:v>99.9</c:v>
                </c:pt>
                <c:pt idx="1259">
                  <c:v>99.9</c:v>
                </c:pt>
                <c:pt idx="1260">
                  <c:v>99.9</c:v>
                </c:pt>
                <c:pt idx="1261">
                  <c:v>99.9</c:v>
                </c:pt>
                <c:pt idx="1262">
                  <c:v>99.9</c:v>
                </c:pt>
                <c:pt idx="1263">
                  <c:v>99.9</c:v>
                </c:pt>
                <c:pt idx="1264">
                  <c:v>99.9</c:v>
                </c:pt>
                <c:pt idx="1265">
                  <c:v>99.9</c:v>
                </c:pt>
                <c:pt idx="1266">
                  <c:v>99.9</c:v>
                </c:pt>
                <c:pt idx="1267">
                  <c:v>99.9</c:v>
                </c:pt>
                <c:pt idx="1268">
                  <c:v>99.9</c:v>
                </c:pt>
                <c:pt idx="1269">
                  <c:v>99.9</c:v>
                </c:pt>
                <c:pt idx="1270">
                  <c:v>99.9</c:v>
                </c:pt>
                <c:pt idx="1271">
                  <c:v>99.9</c:v>
                </c:pt>
                <c:pt idx="1272">
                  <c:v>99.9</c:v>
                </c:pt>
                <c:pt idx="1273">
                  <c:v>99.9</c:v>
                </c:pt>
                <c:pt idx="1274">
                  <c:v>99.9</c:v>
                </c:pt>
                <c:pt idx="1275">
                  <c:v>99.9</c:v>
                </c:pt>
                <c:pt idx="1276">
                  <c:v>99.9</c:v>
                </c:pt>
                <c:pt idx="1277">
                  <c:v>99.9</c:v>
                </c:pt>
                <c:pt idx="1278">
                  <c:v>99.9</c:v>
                </c:pt>
                <c:pt idx="1279">
                  <c:v>99.9</c:v>
                </c:pt>
                <c:pt idx="1280">
                  <c:v>99.9</c:v>
                </c:pt>
                <c:pt idx="1281">
                  <c:v>99.9</c:v>
                </c:pt>
                <c:pt idx="1282">
                  <c:v>99.9</c:v>
                </c:pt>
                <c:pt idx="1283">
                  <c:v>99.9</c:v>
                </c:pt>
                <c:pt idx="1284">
                  <c:v>99.9</c:v>
                </c:pt>
                <c:pt idx="1285">
                  <c:v>99.9</c:v>
                </c:pt>
                <c:pt idx="1286">
                  <c:v>99.9</c:v>
                </c:pt>
                <c:pt idx="1287">
                  <c:v>99.9</c:v>
                </c:pt>
                <c:pt idx="1288">
                  <c:v>99.9</c:v>
                </c:pt>
                <c:pt idx="1289">
                  <c:v>99.9</c:v>
                </c:pt>
                <c:pt idx="1290">
                  <c:v>99.9</c:v>
                </c:pt>
                <c:pt idx="1291">
                  <c:v>99.9</c:v>
                </c:pt>
                <c:pt idx="1292">
                  <c:v>99.9</c:v>
                </c:pt>
                <c:pt idx="1293">
                  <c:v>99.9</c:v>
                </c:pt>
                <c:pt idx="1294">
                  <c:v>99.9</c:v>
                </c:pt>
                <c:pt idx="1295">
                  <c:v>99.9</c:v>
                </c:pt>
                <c:pt idx="1296">
                  <c:v>99.9</c:v>
                </c:pt>
                <c:pt idx="1297">
                  <c:v>99.9</c:v>
                </c:pt>
                <c:pt idx="1298">
                  <c:v>99.9</c:v>
                </c:pt>
                <c:pt idx="1299">
                  <c:v>99.9</c:v>
                </c:pt>
                <c:pt idx="1300">
                  <c:v>99.9</c:v>
                </c:pt>
                <c:pt idx="1301">
                  <c:v>99.9</c:v>
                </c:pt>
                <c:pt idx="1302">
                  <c:v>99.9</c:v>
                </c:pt>
                <c:pt idx="1303">
                  <c:v>99.9</c:v>
                </c:pt>
                <c:pt idx="1304">
                  <c:v>99.9</c:v>
                </c:pt>
                <c:pt idx="1305">
                  <c:v>99.9</c:v>
                </c:pt>
                <c:pt idx="1306">
                  <c:v>99.9</c:v>
                </c:pt>
                <c:pt idx="1307">
                  <c:v>99.9</c:v>
                </c:pt>
                <c:pt idx="1308">
                  <c:v>99.9</c:v>
                </c:pt>
                <c:pt idx="1309">
                  <c:v>99.9</c:v>
                </c:pt>
                <c:pt idx="1310">
                  <c:v>99.9</c:v>
                </c:pt>
                <c:pt idx="1311">
                  <c:v>99.9</c:v>
                </c:pt>
                <c:pt idx="1312">
                  <c:v>99.9</c:v>
                </c:pt>
                <c:pt idx="1313">
                  <c:v>99.9</c:v>
                </c:pt>
                <c:pt idx="1314">
                  <c:v>99.9</c:v>
                </c:pt>
                <c:pt idx="1315">
                  <c:v>99.9</c:v>
                </c:pt>
                <c:pt idx="1316">
                  <c:v>99.9</c:v>
                </c:pt>
                <c:pt idx="1317">
                  <c:v>99.9</c:v>
                </c:pt>
                <c:pt idx="1318">
                  <c:v>99.9</c:v>
                </c:pt>
                <c:pt idx="1319">
                  <c:v>99.9</c:v>
                </c:pt>
                <c:pt idx="1320">
                  <c:v>99.9</c:v>
                </c:pt>
                <c:pt idx="1321">
                  <c:v>99.9</c:v>
                </c:pt>
                <c:pt idx="1322">
                  <c:v>99.9</c:v>
                </c:pt>
                <c:pt idx="1323">
                  <c:v>99.9</c:v>
                </c:pt>
                <c:pt idx="1324">
                  <c:v>99.9</c:v>
                </c:pt>
                <c:pt idx="1325">
                  <c:v>99.9</c:v>
                </c:pt>
                <c:pt idx="1326">
                  <c:v>99.9</c:v>
                </c:pt>
                <c:pt idx="1327">
                  <c:v>99.9</c:v>
                </c:pt>
                <c:pt idx="1328">
                  <c:v>99.9</c:v>
                </c:pt>
                <c:pt idx="1329">
                  <c:v>99.9</c:v>
                </c:pt>
                <c:pt idx="1330">
                  <c:v>99.9</c:v>
                </c:pt>
                <c:pt idx="1331">
                  <c:v>99.9</c:v>
                </c:pt>
                <c:pt idx="1332">
                  <c:v>99.9</c:v>
                </c:pt>
                <c:pt idx="1333">
                  <c:v>99.9</c:v>
                </c:pt>
                <c:pt idx="1334">
                  <c:v>99.9</c:v>
                </c:pt>
                <c:pt idx="1335">
                  <c:v>99.9</c:v>
                </c:pt>
                <c:pt idx="1336">
                  <c:v>99.9</c:v>
                </c:pt>
                <c:pt idx="1337">
                  <c:v>99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AB2-40A4-919E-6D451ADE32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6368088"/>
        <c:axId val="1"/>
      </c:scatterChart>
      <c:valAx>
        <c:axId val="186368088"/>
        <c:scaling>
          <c:orientation val="minMax"/>
          <c:max val="8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de-DE" sz="1300" b="0" baseline="0" dirty="0">
                    <a:latin typeface="Calibri" panose="020F0502020204030204" pitchFamily="34" charset="0"/>
                    <a:cs typeface="Calibri" panose="020F0502020204030204" pitchFamily="34" charset="0"/>
                  </a:rPr>
                  <a:t>Storage time [</a:t>
                </a:r>
                <a:r>
                  <a:rPr lang="de-DE" sz="1300" b="0" baseline="0" dirty="0" err="1">
                    <a:latin typeface="Calibri" panose="020F0502020204030204" pitchFamily="34" charset="0"/>
                    <a:cs typeface="Calibri" panose="020F0502020204030204" pitchFamily="34" charset="0"/>
                  </a:rPr>
                  <a:t>weeks</a:t>
                </a:r>
                <a:r>
                  <a:rPr lang="de-DE" sz="1300" b="0" baseline="0" dirty="0">
                    <a:latin typeface="Calibri" panose="020F0502020204030204" pitchFamily="34" charset="0"/>
                    <a:cs typeface="Calibri" panose="020F0502020204030204" pitchFamily="34" charset="0"/>
                  </a:rPr>
                  <a:t>]</a:t>
                </a:r>
                <a:endParaRPr lang="de-DE" sz="1300" b="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de-DE"/>
          </a:p>
        </c:txPr>
        <c:crossAx val="1"/>
        <c:crosses val="autoZero"/>
        <c:crossBetween val="midCat"/>
        <c:majorUnit val="2"/>
      </c:valAx>
      <c:valAx>
        <c:axId val="1"/>
        <c:scaling>
          <c:orientation val="minMax"/>
          <c:max val="100"/>
        </c:scaling>
        <c:delete val="0"/>
        <c:axPos val="l"/>
        <c:majorGridlines/>
        <c:title>
          <c:tx>
            <c:rich>
              <a:bodyPr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1300" b="0" i="0" baseline="0" dirty="0" err="1">
                    <a:effectLst/>
                    <a:latin typeface="Calibri" panose="020F0502020204030204" pitchFamily="34" charset="0"/>
                    <a:cs typeface="Calibri" panose="020F0502020204030204" pitchFamily="34" charset="0"/>
                  </a:rPr>
                  <a:t>Temperature</a:t>
                </a:r>
                <a:r>
                  <a:rPr lang="de-DE" sz="1300" b="0" i="0" baseline="0" dirty="0">
                    <a:effectLst/>
                    <a:latin typeface="Calibri" panose="020F0502020204030204" pitchFamily="34" charset="0"/>
                    <a:cs typeface="Calibri" panose="020F0502020204030204" pitchFamily="34" charset="0"/>
                  </a:rPr>
                  <a:t> [°C] / Relative </a:t>
                </a:r>
                <a:r>
                  <a:rPr lang="de-DE" sz="1300" b="0" i="0" baseline="0" dirty="0" err="1">
                    <a:effectLst/>
                    <a:latin typeface="Calibri" panose="020F0502020204030204" pitchFamily="34" charset="0"/>
                    <a:cs typeface="Calibri" panose="020F0502020204030204" pitchFamily="34" charset="0"/>
                  </a:rPr>
                  <a:t>Humidity</a:t>
                </a:r>
                <a:r>
                  <a:rPr lang="de-DE" sz="1300" b="0" i="0" baseline="0" dirty="0">
                    <a:effectLst/>
                    <a:latin typeface="Calibri" panose="020F0502020204030204" pitchFamily="34" charset="0"/>
                    <a:cs typeface="Calibri" panose="020F0502020204030204" pitchFamily="34" charset="0"/>
                  </a:rPr>
                  <a:t> [%]</a:t>
                </a:r>
                <a:endParaRPr lang="de-DE" sz="1300" b="0" dirty="0">
                  <a:effectLst/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186368088"/>
        <c:crosses val="autoZero"/>
        <c:crossBetween val="midCat"/>
      </c:valAx>
    </c:plotArea>
    <c:legend>
      <c:legendPos val="t"/>
      <c:layout>
        <c:manualLayout>
          <c:xMode val="edge"/>
          <c:yMode val="edge"/>
          <c:x val="0.60939941135012776"/>
          <c:y val="0.36533238001593676"/>
          <c:w val="0.1857905545217198"/>
          <c:h val="0.23881484523917487"/>
        </c:manualLayout>
      </c:layout>
      <c:overlay val="0"/>
      <c:spPr>
        <a:solidFill>
          <a:sysClr val="window" lastClr="FFFFFF"/>
        </a:solidFill>
        <a:ln>
          <a:solidFill>
            <a:sysClr val="windowText" lastClr="000000"/>
          </a:solidFill>
        </a:ln>
      </c:spPr>
      <c:txPr>
        <a:bodyPr/>
        <a:lstStyle/>
        <a:p>
          <a:pPr>
            <a:defRPr>
              <a:latin typeface="Calibri" panose="020F0502020204030204" pitchFamily="34" charset="0"/>
              <a:cs typeface="Calibri" panose="020F0502020204030204" pitchFamily="34" charset="0"/>
            </a:defRPr>
          </a:pPr>
          <a:endParaRPr lang="de-DE"/>
        </a:p>
      </c:txPr>
    </c:legend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165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330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9495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2660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5825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8991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2156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5321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4D66AD9-A060-4019-99E6-0AAACAF408F5}" type="datetimeFigureOut">
              <a:rPr lang="de-DE" altLang="de-DE"/>
              <a:pPr>
                <a:defRPr/>
              </a:pPr>
              <a:t>13.10.2021</a:t>
            </a:fld>
            <a:endParaRPr lang="de-DE" alt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D6D86C-9447-43DA-A5F0-B8422FD1E1E8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7400602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EA53B0-5D30-415C-9BD1-56DB6CE3718E}" type="datetimeFigureOut">
              <a:rPr lang="de-DE" altLang="de-DE"/>
              <a:pPr>
                <a:defRPr/>
              </a:pPr>
              <a:t>13.10.2021</a:t>
            </a:fld>
            <a:endParaRPr lang="de-DE" alt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758D108-02F5-40AF-B839-4933C9C68992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8942300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5386387" y="366714"/>
            <a:ext cx="1671638" cy="780097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71477" y="366714"/>
            <a:ext cx="4849813" cy="780097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D38E43-D25F-412F-8E82-96376E515767}" type="datetimeFigureOut">
              <a:rPr lang="de-DE" altLang="de-DE"/>
              <a:pPr>
                <a:defRPr/>
              </a:pPr>
              <a:t>13.10.2021</a:t>
            </a:fld>
            <a:endParaRPr lang="de-DE" alt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8AAD6F-A41B-48C2-954B-3107B29BB2D5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9474644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142D77-691F-4623-BE62-4E80AEC3DC91}" type="datetimeFigureOut">
              <a:rPr lang="de-DE" altLang="de-DE"/>
              <a:pPr>
                <a:defRPr/>
              </a:pPr>
              <a:t>13.10.2021</a:t>
            </a:fld>
            <a:endParaRPr lang="de-DE" alt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D649A4-26AD-456A-A637-8DA4252D02EB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772994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82506" y="4406900"/>
            <a:ext cx="8420100" cy="1362075"/>
          </a:xfrm>
        </p:spPr>
        <p:txBody>
          <a:bodyPr anchor="t"/>
          <a:lstStyle>
            <a:lvl1pPr algn="l">
              <a:defRPr sz="2769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82506" y="2906714"/>
            <a:ext cx="8420100" cy="1500186"/>
          </a:xfrm>
        </p:spPr>
        <p:txBody>
          <a:bodyPr anchor="b"/>
          <a:lstStyle>
            <a:lvl1pPr marL="0" indent="0">
              <a:buNone/>
              <a:defRPr sz="1385">
                <a:solidFill>
                  <a:schemeClr val="tx1">
                    <a:tint val="75000"/>
                  </a:schemeClr>
                </a:solidFill>
              </a:defRPr>
            </a:lvl1pPr>
            <a:lvl2pPr marL="316520" indent="0">
              <a:buNone/>
              <a:defRPr sz="1246">
                <a:solidFill>
                  <a:schemeClr val="tx1">
                    <a:tint val="75000"/>
                  </a:schemeClr>
                </a:solidFill>
              </a:defRPr>
            </a:lvl2pPr>
            <a:lvl3pPr marL="633039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3pPr>
            <a:lvl4pPr marL="949559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4pPr>
            <a:lvl5pPr marL="1266078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5pPr>
            <a:lvl6pPr marL="1582598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6pPr>
            <a:lvl7pPr marL="1899117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7pPr>
            <a:lvl8pPr marL="2215637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8pPr>
            <a:lvl9pPr marL="2532156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A27496-8396-455E-AED6-02A3235F7E44}" type="datetimeFigureOut">
              <a:rPr lang="de-DE" altLang="de-DE"/>
              <a:pPr>
                <a:defRPr/>
              </a:pPr>
              <a:t>13.10.2021</a:t>
            </a:fld>
            <a:endParaRPr lang="de-DE" alt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5CC4226-326C-4D9D-B010-5D9171F04486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3430939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71477" y="2133601"/>
            <a:ext cx="3260725" cy="6034088"/>
          </a:xfrm>
        </p:spPr>
        <p:txBody>
          <a:bodyPr/>
          <a:lstStyle>
            <a:lvl1pPr>
              <a:defRPr sz="1938"/>
            </a:lvl1pPr>
            <a:lvl2pPr>
              <a:defRPr sz="1662"/>
            </a:lvl2pPr>
            <a:lvl3pPr>
              <a:defRPr sz="1385"/>
            </a:lvl3pPr>
            <a:lvl4pPr>
              <a:defRPr sz="1246"/>
            </a:lvl4pPr>
            <a:lvl5pPr>
              <a:defRPr sz="1246"/>
            </a:lvl5pPr>
            <a:lvl6pPr>
              <a:defRPr sz="1246"/>
            </a:lvl6pPr>
            <a:lvl7pPr>
              <a:defRPr sz="1246"/>
            </a:lvl7pPr>
            <a:lvl8pPr>
              <a:defRPr sz="1246"/>
            </a:lvl8pPr>
            <a:lvl9pPr>
              <a:defRPr sz="1246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797302" y="2133601"/>
            <a:ext cx="3260725" cy="6034088"/>
          </a:xfrm>
        </p:spPr>
        <p:txBody>
          <a:bodyPr/>
          <a:lstStyle>
            <a:lvl1pPr>
              <a:defRPr sz="1938"/>
            </a:lvl1pPr>
            <a:lvl2pPr>
              <a:defRPr sz="1662"/>
            </a:lvl2pPr>
            <a:lvl3pPr>
              <a:defRPr sz="1385"/>
            </a:lvl3pPr>
            <a:lvl4pPr>
              <a:defRPr sz="1246"/>
            </a:lvl4pPr>
            <a:lvl5pPr>
              <a:defRPr sz="1246"/>
            </a:lvl5pPr>
            <a:lvl6pPr>
              <a:defRPr sz="1246"/>
            </a:lvl6pPr>
            <a:lvl7pPr>
              <a:defRPr sz="1246"/>
            </a:lvl7pPr>
            <a:lvl8pPr>
              <a:defRPr sz="1246"/>
            </a:lvl8pPr>
            <a:lvl9pPr>
              <a:defRPr sz="1246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33925A-B2E8-4789-870E-D3650DD4A430}" type="datetimeFigureOut">
              <a:rPr lang="de-DE" altLang="de-DE"/>
              <a:pPr>
                <a:defRPr/>
              </a:pPr>
              <a:t>13.10.2021</a:t>
            </a:fld>
            <a:endParaRPr lang="de-DE" alt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40A531-56CC-41E4-BE8A-B4E2E80767F9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77423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1662" b="1"/>
            </a:lvl1pPr>
            <a:lvl2pPr marL="316520" indent="0">
              <a:buNone/>
              <a:defRPr sz="1385" b="1"/>
            </a:lvl2pPr>
            <a:lvl3pPr marL="633039" indent="0">
              <a:buNone/>
              <a:defRPr sz="1246" b="1"/>
            </a:lvl3pPr>
            <a:lvl4pPr marL="949559" indent="0">
              <a:buNone/>
              <a:defRPr sz="1108" b="1"/>
            </a:lvl4pPr>
            <a:lvl5pPr marL="1266078" indent="0">
              <a:buNone/>
              <a:defRPr sz="1108" b="1"/>
            </a:lvl5pPr>
            <a:lvl6pPr marL="1582598" indent="0">
              <a:buNone/>
              <a:defRPr sz="1108" b="1"/>
            </a:lvl6pPr>
            <a:lvl7pPr marL="1899117" indent="0">
              <a:buNone/>
              <a:defRPr sz="1108" b="1"/>
            </a:lvl7pPr>
            <a:lvl8pPr marL="2215637" indent="0">
              <a:buNone/>
              <a:defRPr sz="1108" b="1"/>
            </a:lvl8pPr>
            <a:lvl9pPr marL="2532156" indent="0">
              <a:buNone/>
              <a:defRPr sz="1108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1662"/>
            </a:lvl1pPr>
            <a:lvl2pPr>
              <a:defRPr sz="1385"/>
            </a:lvl2pPr>
            <a:lvl3pPr>
              <a:defRPr sz="1246"/>
            </a:lvl3pPr>
            <a:lvl4pPr>
              <a:defRPr sz="1108"/>
            </a:lvl4pPr>
            <a:lvl5pPr>
              <a:defRPr sz="1108"/>
            </a:lvl5pPr>
            <a:lvl6pPr>
              <a:defRPr sz="1108"/>
            </a:lvl6pPr>
            <a:lvl7pPr>
              <a:defRPr sz="1108"/>
            </a:lvl7pPr>
            <a:lvl8pPr>
              <a:defRPr sz="1108"/>
            </a:lvl8pPr>
            <a:lvl9pPr>
              <a:defRPr sz="1108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5032113" y="1535113"/>
            <a:ext cx="4378589" cy="639762"/>
          </a:xfrm>
        </p:spPr>
        <p:txBody>
          <a:bodyPr anchor="b"/>
          <a:lstStyle>
            <a:lvl1pPr marL="0" indent="0">
              <a:buNone/>
              <a:defRPr sz="1662" b="1"/>
            </a:lvl1pPr>
            <a:lvl2pPr marL="316520" indent="0">
              <a:buNone/>
              <a:defRPr sz="1385" b="1"/>
            </a:lvl2pPr>
            <a:lvl3pPr marL="633039" indent="0">
              <a:buNone/>
              <a:defRPr sz="1246" b="1"/>
            </a:lvl3pPr>
            <a:lvl4pPr marL="949559" indent="0">
              <a:buNone/>
              <a:defRPr sz="1108" b="1"/>
            </a:lvl4pPr>
            <a:lvl5pPr marL="1266078" indent="0">
              <a:buNone/>
              <a:defRPr sz="1108" b="1"/>
            </a:lvl5pPr>
            <a:lvl6pPr marL="1582598" indent="0">
              <a:buNone/>
              <a:defRPr sz="1108" b="1"/>
            </a:lvl6pPr>
            <a:lvl7pPr marL="1899117" indent="0">
              <a:buNone/>
              <a:defRPr sz="1108" b="1"/>
            </a:lvl7pPr>
            <a:lvl8pPr marL="2215637" indent="0">
              <a:buNone/>
              <a:defRPr sz="1108" b="1"/>
            </a:lvl8pPr>
            <a:lvl9pPr marL="2532156" indent="0">
              <a:buNone/>
              <a:defRPr sz="1108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5032113" y="2174875"/>
            <a:ext cx="4378589" cy="3951288"/>
          </a:xfrm>
        </p:spPr>
        <p:txBody>
          <a:bodyPr/>
          <a:lstStyle>
            <a:lvl1pPr>
              <a:defRPr sz="1662"/>
            </a:lvl1pPr>
            <a:lvl2pPr>
              <a:defRPr sz="1385"/>
            </a:lvl2pPr>
            <a:lvl3pPr>
              <a:defRPr sz="1246"/>
            </a:lvl3pPr>
            <a:lvl4pPr>
              <a:defRPr sz="1108"/>
            </a:lvl4pPr>
            <a:lvl5pPr>
              <a:defRPr sz="1108"/>
            </a:lvl5pPr>
            <a:lvl6pPr>
              <a:defRPr sz="1108"/>
            </a:lvl6pPr>
            <a:lvl7pPr>
              <a:defRPr sz="1108"/>
            </a:lvl7pPr>
            <a:lvl8pPr>
              <a:defRPr sz="1108"/>
            </a:lvl8pPr>
            <a:lvl9pPr>
              <a:defRPr sz="1108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B0E83F-C5FD-43C1-907B-100106187235}" type="datetimeFigureOut">
              <a:rPr lang="de-DE" altLang="de-DE"/>
              <a:pPr>
                <a:defRPr/>
              </a:pPr>
              <a:t>13.10.2021</a:t>
            </a:fld>
            <a:endParaRPr lang="de-DE" altLang="de-DE"/>
          </a:p>
        </p:txBody>
      </p:sp>
      <p:sp>
        <p:nvSpPr>
          <p:cNvPr id="8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65D6B9-F21E-48AF-93AA-E6CD324A3166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8022403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6E1B28-3995-4057-BAE8-8CFB55D05FD6}" type="datetimeFigureOut">
              <a:rPr lang="de-DE" altLang="de-DE"/>
              <a:pPr>
                <a:defRPr/>
              </a:pPr>
              <a:t>13.10.2021</a:t>
            </a:fld>
            <a:endParaRPr lang="de-DE" altLang="de-DE"/>
          </a:p>
        </p:txBody>
      </p:sp>
      <p:sp>
        <p:nvSpPr>
          <p:cNvPr id="4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1B58B8-E53D-4B69-B081-9BB73B6ECC88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5068914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B5622C-A48C-48A4-9C58-BD22861939B8}" type="datetimeFigureOut">
              <a:rPr lang="de-DE" altLang="de-DE"/>
              <a:pPr>
                <a:defRPr/>
              </a:pPr>
              <a:t>13.10.2021</a:t>
            </a:fld>
            <a:endParaRPr lang="de-DE" altLang="de-DE"/>
          </a:p>
        </p:txBody>
      </p:sp>
      <p:sp>
        <p:nvSpPr>
          <p:cNvPr id="3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DC4D93-760F-4096-AD50-DADDCB4B2B96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931101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95302" y="273051"/>
            <a:ext cx="3259006" cy="1162050"/>
          </a:xfrm>
        </p:spPr>
        <p:txBody>
          <a:bodyPr anchor="b"/>
          <a:lstStyle>
            <a:lvl1pPr algn="l">
              <a:defRPr sz="1385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872972" y="273051"/>
            <a:ext cx="5537730" cy="5853113"/>
          </a:xfrm>
        </p:spPr>
        <p:txBody>
          <a:bodyPr/>
          <a:lstStyle>
            <a:lvl1pPr>
              <a:defRPr sz="2215"/>
            </a:lvl1pPr>
            <a:lvl2pPr>
              <a:defRPr sz="1938"/>
            </a:lvl2pPr>
            <a:lvl3pPr>
              <a:defRPr sz="1662"/>
            </a:lvl3pPr>
            <a:lvl4pPr>
              <a:defRPr sz="1385"/>
            </a:lvl4pPr>
            <a:lvl5pPr>
              <a:defRPr sz="1385"/>
            </a:lvl5pPr>
            <a:lvl6pPr>
              <a:defRPr sz="1385"/>
            </a:lvl6pPr>
            <a:lvl7pPr>
              <a:defRPr sz="1385"/>
            </a:lvl7pPr>
            <a:lvl8pPr>
              <a:defRPr sz="1385"/>
            </a:lvl8pPr>
            <a:lvl9pPr>
              <a:defRPr sz="1385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95302" y="1435101"/>
            <a:ext cx="3259006" cy="4691063"/>
          </a:xfrm>
        </p:spPr>
        <p:txBody>
          <a:bodyPr/>
          <a:lstStyle>
            <a:lvl1pPr marL="0" indent="0">
              <a:buNone/>
              <a:defRPr sz="969"/>
            </a:lvl1pPr>
            <a:lvl2pPr marL="316520" indent="0">
              <a:buNone/>
              <a:defRPr sz="831"/>
            </a:lvl2pPr>
            <a:lvl3pPr marL="633039" indent="0">
              <a:buNone/>
              <a:defRPr sz="692"/>
            </a:lvl3pPr>
            <a:lvl4pPr marL="949559" indent="0">
              <a:buNone/>
              <a:defRPr sz="623"/>
            </a:lvl4pPr>
            <a:lvl5pPr marL="1266078" indent="0">
              <a:buNone/>
              <a:defRPr sz="623"/>
            </a:lvl5pPr>
            <a:lvl6pPr marL="1582598" indent="0">
              <a:buNone/>
              <a:defRPr sz="623"/>
            </a:lvl6pPr>
            <a:lvl7pPr marL="1899117" indent="0">
              <a:buNone/>
              <a:defRPr sz="623"/>
            </a:lvl7pPr>
            <a:lvl8pPr marL="2215637" indent="0">
              <a:buNone/>
              <a:defRPr sz="623"/>
            </a:lvl8pPr>
            <a:lvl9pPr marL="2532156" indent="0">
              <a:buNone/>
              <a:defRPr sz="623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71F3C2-A6AE-4C89-8230-16F997222786}" type="datetimeFigureOut">
              <a:rPr lang="de-DE" altLang="de-DE"/>
              <a:pPr>
                <a:defRPr/>
              </a:pPr>
              <a:t>13.10.2021</a:t>
            </a:fld>
            <a:endParaRPr lang="de-DE" alt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87CE8F-3BEE-4233-B32B-61AEC98EE067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9200466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941645" y="4800601"/>
            <a:ext cx="5943600" cy="566738"/>
          </a:xfrm>
        </p:spPr>
        <p:txBody>
          <a:bodyPr anchor="b"/>
          <a:lstStyle>
            <a:lvl1pPr algn="l">
              <a:defRPr sz="1385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2215"/>
            </a:lvl1pPr>
            <a:lvl2pPr marL="316520" indent="0">
              <a:buNone/>
              <a:defRPr sz="1938"/>
            </a:lvl2pPr>
            <a:lvl3pPr marL="633039" indent="0">
              <a:buNone/>
              <a:defRPr sz="1662"/>
            </a:lvl3pPr>
            <a:lvl4pPr marL="949559" indent="0">
              <a:buNone/>
              <a:defRPr sz="1385"/>
            </a:lvl4pPr>
            <a:lvl5pPr marL="1266078" indent="0">
              <a:buNone/>
              <a:defRPr sz="1385"/>
            </a:lvl5pPr>
            <a:lvl6pPr marL="1582598" indent="0">
              <a:buNone/>
              <a:defRPr sz="1385"/>
            </a:lvl6pPr>
            <a:lvl7pPr marL="1899117" indent="0">
              <a:buNone/>
              <a:defRPr sz="1385"/>
            </a:lvl7pPr>
            <a:lvl8pPr marL="2215637" indent="0">
              <a:buNone/>
              <a:defRPr sz="1385"/>
            </a:lvl8pPr>
            <a:lvl9pPr marL="2532156" indent="0">
              <a:buNone/>
              <a:defRPr sz="1385"/>
            </a:lvl9pPr>
          </a:lstStyle>
          <a:p>
            <a:pPr lvl="0"/>
            <a:endParaRPr lang="de-DE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941645" y="5367339"/>
            <a:ext cx="5943600" cy="804862"/>
          </a:xfrm>
        </p:spPr>
        <p:txBody>
          <a:bodyPr/>
          <a:lstStyle>
            <a:lvl1pPr marL="0" indent="0">
              <a:buNone/>
              <a:defRPr sz="969"/>
            </a:lvl1pPr>
            <a:lvl2pPr marL="316520" indent="0">
              <a:buNone/>
              <a:defRPr sz="831"/>
            </a:lvl2pPr>
            <a:lvl3pPr marL="633039" indent="0">
              <a:buNone/>
              <a:defRPr sz="692"/>
            </a:lvl3pPr>
            <a:lvl4pPr marL="949559" indent="0">
              <a:buNone/>
              <a:defRPr sz="623"/>
            </a:lvl4pPr>
            <a:lvl5pPr marL="1266078" indent="0">
              <a:buNone/>
              <a:defRPr sz="623"/>
            </a:lvl5pPr>
            <a:lvl6pPr marL="1582598" indent="0">
              <a:buNone/>
              <a:defRPr sz="623"/>
            </a:lvl6pPr>
            <a:lvl7pPr marL="1899117" indent="0">
              <a:buNone/>
              <a:defRPr sz="623"/>
            </a:lvl7pPr>
            <a:lvl8pPr marL="2215637" indent="0">
              <a:buNone/>
              <a:defRPr sz="623"/>
            </a:lvl8pPr>
            <a:lvl9pPr marL="2532156" indent="0">
              <a:buNone/>
              <a:defRPr sz="623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207A7C-4AC4-444F-8D68-6C808677D848}" type="datetimeFigureOut">
              <a:rPr lang="de-DE" altLang="de-DE"/>
              <a:pPr>
                <a:defRPr/>
              </a:pPr>
              <a:t>13.10.2021</a:t>
            </a:fld>
            <a:endParaRPr lang="de-DE" alt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29DCDF-039C-4530-AADB-0720087ACD05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7463275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elplatzhalter 1"/>
          <p:cNvSpPr>
            <a:spLocks noGrp="1"/>
          </p:cNvSpPr>
          <p:nvPr>
            <p:ph type="title"/>
          </p:nvPr>
        </p:nvSpPr>
        <p:spPr bwMode="auto">
          <a:xfrm>
            <a:off x="495300" y="274760"/>
            <a:ext cx="89154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itelmasterformat durch Klicken bearbeiten</a:t>
            </a:r>
          </a:p>
        </p:txBody>
      </p:sp>
      <p:sp>
        <p:nvSpPr>
          <p:cNvPr id="1027" name="Textplatzhalter 2"/>
          <p:cNvSpPr>
            <a:spLocks noGrp="1"/>
          </p:cNvSpPr>
          <p:nvPr>
            <p:ph type="body" idx="1"/>
          </p:nvPr>
        </p:nvSpPr>
        <p:spPr bwMode="auto">
          <a:xfrm>
            <a:off x="495300" y="1600201"/>
            <a:ext cx="8915400" cy="45258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extmasterformat bearbeiten</a:t>
            </a:r>
          </a:p>
          <a:p>
            <a:pPr lvl="1"/>
            <a:r>
              <a:rPr lang="de-DE" altLang="de-DE" smtClean="0"/>
              <a:t>Zweite Ebene</a:t>
            </a:r>
          </a:p>
          <a:p>
            <a:pPr lvl="2"/>
            <a:r>
              <a:rPr lang="de-DE" altLang="de-DE" smtClean="0"/>
              <a:t>Dritte Ebene</a:t>
            </a:r>
          </a:p>
          <a:p>
            <a:pPr lvl="3"/>
            <a:r>
              <a:rPr lang="de-DE" altLang="de-DE" smtClean="0"/>
              <a:t>Vierte Ebene</a:t>
            </a:r>
          </a:p>
          <a:p>
            <a:pPr lvl="4"/>
            <a:r>
              <a:rPr lang="de-DE" altLang="de-DE" smtClean="0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95300" y="6356838"/>
            <a:ext cx="2311400" cy="364881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831">
                <a:solidFill>
                  <a:srgbClr val="898989"/>
                </a:solidFill>
                <a:cs typeface="Arial" pitchFamily="34" charset="0"/>
              </a:defRPr>
            </a:lvl1pPr>
          </a:lstStyle>
          <a:p>
            <a:pPr>
              <a:defRPr/>
            </a:pPr>
            <a:fld id="{049DF2AC-F919-47D1-8D4F-7129870CC8FA}" type="datetimeFigureOut">
              <a:rPr lang="de-DE" altLang="de-DE"/>
              <a:pPr>
                <a:defRPr/>
              </a:pPr>
              <a:t>13.10.2021</a:t>
            </a:fld>
            <a:endParaRPr lang="de-DE" alt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384550" y="6356838"/>
            <a:ext cx="3136900" cy="3648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831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7099300" y="6356838"/>
            <a:ext cx="2311400" cy="364881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831">
                <a:solidFill>
                  <a:srgbClr val="898989"/>
                </a:solidFill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A93C978B-3109-4B9F-8A47-8154757AB769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3046" kern="1200">
          <a:solidFill>
            <a:schemeClr val="tx1"/>
          </a:solidFill>
          <a:latin typeface="+mj-lt"/>
          <a:ea typeface="MS PGothic" pitchFamily="34" charset="-128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046">
          <a:solidFill>
            <a:schemeClr val="tx1"/>
          </a:solidFill>
          <a:latin typeface="Calibri" charset="0"/>
          <a:ea typeface="MS PGothic" pitchFamily="34" charset="-128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046">
          <a:solidFill>
            <a:schemeClr val="tx1"/>
          </a:solidFill>
          <a:latin typeface="Calibri" charset="0"/>
          <a:ea typeface="MS PGothic" pitchFamily="34" charset="-128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046">
          <a:solidFill>
            <a:schemeClr val="tx1"/>
          </a:solidFill>
          <a:latin typeface="Calibri" charset="0"/>
          <a:ea typeface="MS PGothic" pitchFamily="34" charset="-128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046">
          <a:solidFill>
            <a:schemeClr val="tx1"/>
          </a:solidFill>
          <a:latin typeface="Calibri" charset="0"/>
          <a:ea typeface="MS PGothic" pitchFamily="34" charset="-128"/>
          <a:cs typeface="ＭＳ Ｐゴシック" charset="0"/>
        </a:defRPr>
      </a:lvl5pPr>
      <a:lvl6pPr marL="316520" algn="ctr" rtl="0" fontAlgn="base">
        <a:spcBef>
          <a:spcPct val="0"/>
        </a:spcBef>
        <a:spcAft>
          <a:spcPct val="0"/>
        </a:spcAft>
        <a:defRPr sz="3046">
          <a:solidFill>
            <a:schemeClr val="tx1"/>
          </a:solidFill>
          <a:latin typeface="Calibri" charset="0"/>
          <a:ea typeface="ＭＳ Ｐゴシック" charset="0"/>
        </a:defRPr>
      </a:lvl6pPr>
      <a:lvl7pPr marL="633039" algn="ctr" rtl="0" fontAlgn="base">
        <a:spcBef>
          <a:spcPct val="0"/>
        </a:spcBef>
        <a:spcAft>
          <a:spcPct val="0"/>
        </a:spcAft>
        <a:defRPr sz="3046">
          <a:solidFill>
            <a:schemeClr val="tx1"/>
          </a:solidFill>
          <a:latin typeface="Calibri" charset="0"/>
          <a:ea typeface="ＭＳ Ｐゴシック" charset="0"/>
        </a:defRPr>
      </a:lvl7pPr>
      <a:lvl8pPr marL="949559" algn="ctr" rtl="0" fontAlgn="base">
        <a:spcBef>
          <a:spcPct val="0"/>
        </a:spcBef>
        <a:spcAft>
          <a:spcPct val="0"/>
        </a:spcAft>
        <a:defRPr sz="3046">
          <a:solidFill>
            <a:schemeClr val="tx1"/>
          </a:solidFill>
          <a:latin typeface="Calibri" charset="0"/>
          <a:ea typeface="ＭＳ Ｐゴシック" charset="0"/>
        </a:defRPr>
      </a:lvl8pPr>
      <a:lvl9pPr marL="1266078" algn="ctr" rtl="0" fontAlgn="base">
        <a:spcBef>
          <a:spcPct val="0"/>
        </a:spcBef>
        <a:spcAft>
          <a:spcPct val="0"/>
        </a:spcAft>
        <a:defRPr sz="3046">
          <a:solidFill>
            <a:schemeClr val="tx1"/>
          </a:solidFill>
          <a:latin typeface="Calibri" charset="0"/>
          <a:ea typeface="ＭＳ Ｐゴシック" charset="0"/>
        </a:defRPr>
      </a:lvl9pPr>
    </p:titleStyle>
    <p:bodyStyle>
      <a:lvl1pPr marL="237390" indent="-23739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215" kern="1200">
          <a:solidFill>
            <a:schemeClr val="tx1"/>
          </a:solidFill>
          <a:latin typeface="+mn-lt"/>
          <a:ea typeface="MS PGothic" pitchFamily="34" charset="-128"/>
          <a:cs typeface="ＭＳ Ｐゴシック" charset="0"/>
        </a:defRPr>
      </a:lvl1pPr>
      <a:lvl2pPr marL="514344" indent="-197825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1938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2pPr>
      <a:lvl3pPr marL="791299" indent="-15826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1662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3pPr>
      <a:lvl4pPr marL="1107818" indent="-15826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1385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4pPr>
      <a:lvl5pPr marL="1424338" indent="-15826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1385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5pPr>
      <a:lvl6pPr marL="1740858" indent="-158260" algn="l" defTabSz="633039" rtl="0" eaLnBrk="1" latinLnBrk="0" hangingPunct="1">
        <a:spcBef>
          <a:spcPct val="20000"/>
        </a:spcBef>
        <a:buFont typeface="Arial" panose="020B0604020202020204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6pPr>
      <a:lvl7pPr marL="2057377" indent="-158260" algn="l" defTabSz="633039" rtl="0" eaLnBrk="1" latinLnBrk="0" hangingPunct="1">
        <a:spcBef>
          <a:spcPct val="20000"/>
        </a:spcBef>
        <a:buFont typeface="Arial" panose="020B0604020202020204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7pPr>
      <a:lvl8pPr marL="2373897" indent="-158260" algn="l" defTabSz="633039" rtl="0" eaLnBrk="1" latinLnBrk="0" hangingPunct="1">
        <a:spcBef>
          <a:spcPct val="20000"/>
        </a:spcBef>
        <a:buFont typeface="Arial" panose="020B0604020202020204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8pPr>
      <a:lvl9pPr marL="2690416" indent="-158260" algn="l" defTabSz="633039" rtl="0" eaLnBrk="1" latinLnBrk="0" hangingPunct="1">
        <a:spcBef>
          <a:spcPct val="20000"/>
        </a:spcBef>
        <a:buFont typeface="Arial" panose="020B0604020202020204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1pPr>
      <a:lvl2pPr marL="316520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2pPr>
      <a:lvl3pPr marL="633039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3pPr>
      <a:lvl4pPr marL="949559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4pPr>
      <a:lvl5pPr marL="1266078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5pPr>
      <a:lvl6pPr marL="1582598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6pPr>
      <a:lvl7pPr marL="1899117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7pPr>
      <a:lvl8pPr marL="2215637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8pPr>
      <a:lvl9pPr marL="2532156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extfeld 37"/>
          <p:cNvSpPr txBox="1">
            <a:spLocks noChangeArrowheads="1"/>
          </p:cNvSpPr>
          <p:nvPr/>
        </p:nvSpPr>
        <p:spPr bwMode="auto">
          <a:xfrm>
            <a:off x="1496616" y="188640"/>
            <a:ext cx="5614422" cy="7386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de-DE" sz="1400" b="1" dirty="0" smtClean="0"/>
              <a:t>Supplementary </a:t>
            </a:r>
            <a:r>
              <a:rPr lang="en-US" altLang="de-DE" sz="1400" b="1" dirty="0"/>
              <a:t>Data </a:t>
            </a:r>
            <a:r>
              <a:rPr lang="en-US" altLang="de-DE" sz="1400" b="1" dirty="0" smtClean="0"/>
              <a:t>1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de-DE" sz="1400" b="1" dirty="0" smtClean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de-DE" sz="1400" b="1" dirty="0" smtClean="0"/>
              <a:t>Wolff </a:t>
            </a:r>
            <a:r>
              <a:rPr lang="en-US" altLang="de-DE" sz="1400" b="1" i="1" dirty="0" smtClean="0"/>
              <a:t>et al.</a:t>
            </a:r>
            <a:r>
              <a:rPr lang="en-US" altLang="de-DE" sz="1400" b="1" dirty="0" smtClean="0"/>
              <a:t>: Stability </a:t>
            </a:r>
            <a:r>
              <a:rPr lang="en-US" altLang="de-DE" sz="1400" b="1" dirty="0"/>
              <a:t>of </a:t>
            </a:r>
            <a:r>
              <a:rPr lang="en-US" altLang="de-DE" sz="1400" b="1" dirty="0" smtClean="0"/>
              <a:t>hepatitis E virus after drying on different surfaces</a:t>
            </a:r>
            <a:endParaRPr lang="de-DE" altLang="de-DE" sz="1400" b="1" dirty="0"/>
          </a:p>
        </p:txBody>
      </p:sp>
      <p:sp>
        <p:nvSpPr>
          <p:cNvPr id="8" name="Textfeld 7"/>
          <p:cNvSpPr txBox="1"/>
          <p:nvPr/>
        </p:nvSpPr>
        <p:spPr>
          <a:xfrm>
            <a:off x="1064568" y="5672861"/>
            <a:ext cx="6209965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300" b="1" dirty="0" err="1" smtClean="0"/>
              <a:t>Suppl</a:t>
            </a:r>
            <a:r>
              <a:rPr lang="de-DE" sz="1300" b="1" dirty="0" smtClean="0"/>
              <a:t>. Data S1.</a:t>
            </a:r>
            <a:r>
              <a:rPr lang="de-DE" sz="1300" dirty="0" smtClean="0"/>
              <a:t> </a:t>
            </a:r>
            <a:r>
              <a:rPr lang="de-DE" sz="1300" dirty="0" err="1" smtClean="0"/>
              <a:t>Temperature</a:t>
            </a:r>
            <a:r>
              <a:rPr lang="de-DE" sz="1300" dirty="0" smtClean="0"/>
              <a:t> </a:t>
            </a:r>
            <a:r>
              <a:rPr lang="de-DE" sz="1300" dirty="0" err="1" smtClean="0"/>
              <a:t>and</a:t>
            </a:r>
            <a:r>
              <a:rPr lang="de-DE" sz="1300" dirty="0" smtClean="0"/>
              <a:t> </a:t>
            </a:r>
            <a:r>
              <a:rPr lang="de-DE" sz="1300" dirty="0" smtClean="0"/>
              <a:t>relative </a:t>
            </a:r>
            <a:r>
              <a:rPr lang="de-DE" sz="1300" dirty="0" err="1" smtClean="0"/>
              <a:t>humidity</a:t>
            </a:r>
            <a:r>
              <a:rPr lang="de-DE" sz="1300" dirty="0" smtClean="0"/>
              <a:t> </a:t>
            </a:r>
            <a:r>
              <a:rPr lang="de-DE" sz="1300" dirty="0" err="1" smtClean="0"/>
              <a:t>profiles</a:t>
            </a:r>
            <a:r>
              <a:rPr lang="de-DE" sz="1300" dirty="0" smtClean="0"/>
              <a:t> </a:t>
            </a:r>
            <a:r>
              <a:rPr lang="de-DE" sz="1300" dirty="0" err="1" smtClean="0"/>
              <a:t>during</a:t>
            </a:r>
            <a:r>
              <a:rPr lang="de-DE" sz="1300" dirty="0" smtClean="0"/>
              <a:t> </a:t>
            </a:r>
            <a:r>
              <a:rPr lang="de-DE" sz="1300" dirty="0" err="1" smtClean="0"/>
              <a:t>storage</a:t>
            </a:r>
            <a:r>
              <a:rPr lang="de-DE" sz="1300" dirty="0" smtClean="0"/>
              <a:t> </a:t>
            </a:r>
            <a:r>
              <a:rPr lang="de-DE" sz="1300" dirty="0" err="1" smtClean="0"/>
              <a:t>of</a:t>
            </a:r>
            <a:r>
              <a:rPr lang="de-DE" sz="1300" dirty="0" smtClean="0"/>
              <a:t> </a:t>
            </a:r>
            <a:r>
              <a:rPr lang="de-DE" sz="1300" dirty="0" err="1" smtClean="0"/>
              <a:t>dried</a:t>
            </a:r>
            <a:r>
              <a:rPr lang="de-DE" sz="1300" dirty="0" smtClean="0"/>
              <a:t> HEV </a:t>
            </a:r>
            <a:r>
              <a:rPr lang="de-DE" sz="1300" dirty="0" err="1" smtClean="0"/>
              <a:t>samples</a:t>
            </a:r>
            <a:r>
              <a:rPr lang="de-DE" sz="1300" dirty="0" smtClean="0"/>
              <a:t> at 23 °C </a:t>
            </a:r>
            <a:r>
              <a:rPr lang="de-DE" sz="1300" dirty="0" err="1" smtClean="0"/>
              <a:t>as</a:t>
            </a:r>
            <a:r>
              <a:rPr lang="de-DE" sz="1300" dirty="0" smtClean="0"/>
              <a:t> </a:t>
            </a:r>
            <a:r>
              <a:rPr lang="de-DE" sz="1300" dirty="0" err="1" smtClean="0"/>
              <a:t>recorded</a:t>
            </a:r>
            <a:r>
              <a:rPr lang="de-DE" sz="1300" dirty="0" smtClean="0"/>
              <a:t> </a:t>
            </a:r>
            <a:r>
              <a:rPr lang="de-DE" sz="1300" dirty="0" err="1" smtClean="0"/>
              <a:t>by</a:t>
            </a:r>
            <a:r>
              <a:rPr lang="de-DE" sz="1300" dirty="0" smtClean="0"/>
              <a:t> </a:t>
            </a:r>
            <a:r>
              <a:rPr lang="de-DE" sz="1300" dirty="0" smtClean="0"/>
              <a:t>a </a:t>
            </a:r>
            <a:r>
              <a:rPr lang="de-DE" sz="1300" dirty="0" err="1" smtClean="0"/>
              <a:t>data</a:t>
            </a:r>
            <a:r>
              <a:rPr lang="de-DE" sz="1300" dirty="0" smtClean="0"/>
              <a:t> </a:t>
            </a:r>
            <a:r>
              <a:rPr lang="de-DE" sz="1300" dirty="0" err="1" smtClean="0"/>
              <a:t>logger</a:t>
            </a:r>
            <a:r>
              <a:rPr lang="de-DE" sz="1300" dirty="0" smtClean="0"/>
              <a:t>. The </a:t>
            </a:r>
            <a:r>
              <a:rPr lang="de-DE" sz="1300" dirty="0" err="1" smtClean="0"/>
              <a:t>measuring</a:t>
            </a:r>
            <a:r>
              <a:rPr lang="de-DE" sz="1300" dirty="0" smtClean="0"/>
              <a:t> </a:t>
            </a:r>
            <a:r>
              <a:rPr lang="de-DE" sz="1300" dirty="0" err="1" smtClean="0"/>
              <a:t>interval</a:t>
            </a:r>
            <a:r>
              <a:rPr lang="de-DE" sz="1300" dirty="0" smtClean="0"/>
              <a:t> was 1 </a:t>
            </a:r>
            <a:r>
              <a:rPr lang="de-DE" sz="1300" dirty="0" err="1" smtClean="0"/>
              <a:t>hour</a:t>
            </a:r>
            <a:r>
              <a:rPr lang="de-DE" sz="1300" dirty="0" smtClean="0"/>
              <a:t>.</a:t>
            </a:r>
            <a:endParaRPr lang="de-DE" sz="1300" dirty="0"/>
          </a:p>
        </p:txBody>
      </p:sp>
      <p:graphicFrame>
        <p:nvGraphicFramePr>
          <p:cNvPr id="14" name="Diagramm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27104881"/>
              </p:ext>
            </p:extLst>
          </p:nvPr>
        </p:nvGraphicFramePr>
        <p:xfrm>
          <a:off x="344488" y="706188"/>
          <a:ext cx="9217024" cy="46776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3776424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extfeld 37"/>
          <p:cNvSpPr txBox="1">
            <a:spLocks noChangeArrowheads="1"/>
          </p:cNvSpPr>
          <p:nvPr/>
        </p:nvSpPr>
        <p:spPr bwMode="auto">
          <a:xfrm>
            <a:off x="1496616" y="188640"/>
            <a:ext cx="5614422" cy="7386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de-DE" sz="1400" b="1" dirty="0" smtClean="0"/>
              <a:t>Supplementary </a:t>
            </a:r>
            <a:r>
              <a:rPr lang="en-US" altLang="de-DE" sz="1400" b="1" dirty="0"/>
              <a:t>Data 2</a:t>
            </a:r>
            <a:endParaRPr lang="en-US" altLang="de-DE" sz="1400" b="1" dirty="0" smtClean="0"/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de-DE" sz="1400" b="1" dirty="0" smtClean="0"/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de-DE" sz="1400" b="1" dirty="0" smtClean="0"/>
              <a:t>Wolff </a:t>
            </a:r>
            <a:r>
              <a:rPr lang="en-US" altLang="de-DE" sz="1400" b="1" i="1" dirty="0" smtClean="0"/>
              <a:t>et al.</a:t>
            </a:r>
            <a:r>
              <a:rPr lang="en-US" altLang="de-DE" sz="1400" b="1" dirty="0" smtClean="0"/>
              <a:t>: Stability </a:t>
            </a:r>
            <a:r>
              <a:rPr lang="en-US" altLang="de-DE" sz="1400" b="1" dirty="0"/>
              <a:t>of </a:t>
            </a:r>
            <a:r>
              <a:rPr lang="en-US" altLang="de-DE" sz="1400" b="1" dirty="0" smtClean="0"/>
              <a:t>hepatitis E virus after drying on different surfaces</a:t>
            </a:r>
            <a:endParaRPr lang="de-DE" altLang="de-DE" sz="1400" b="1" dirty="0"/>
          </a:p>
        </p:txBody>
      </p:sp>
      <p:sp>
        <p:nvSpPr>
          <p:cNvPr id="8" name="Textfeld 7"/>
          <p:cNvSpPr txBox="1"/>
          <p:nvPr/>
        </p:nvSpPr>
        <p:spPr>
          <a:xfrm>
            <a:off x="1064568" y="5672861"/>
            <a:ext cx="6209965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300" b="1" dirty="0" err="1" smtClean="0"/>
              <a:t>Suppl</a:t>
            </a:r>
            <a:r>
              <a:rPr lang="de-DE" sz="1300" b="1" dirty="0" smtClean="0"/>
              <a:t>. Data S2.</a:t>
            </a:r>
            <a:r>
              <a:rPr lang="de-DE" sz="1300" dirty="0" smtClean="0"/>
              <a:t> </a:t>
            </a:r>
            <a:r>
              <a:rPr lang="de-DE" sz="1300" dirty="0" err="1" smtClean="0"/>
              <a:t>Temperature</a:t>
            </a:r>
            <a:r>
              <a:rPr lang="de-DE" sz="1300" dirty="0" smtClean="0"/>
              <a:t> </a:t>
            </a:r>
            <a:r>
              <a:rPr lang="de-DE" sz="1300" dirty="0" err="1" smtClean="0"/>
              <a:t>and</a:t>
            </a:r>
            <a:r>
              <a:rPr lang="de-DE" sz="1300" dirty="0" smtClean="0"/>
              <a:t> </a:t>
            </a:r>
            <a:r>
              <a:rPr lang="de-DE" sz="1300" dirty="0" smtClean="0"/>
              <a:t>relative </a:t>
            </a:r>
            <a:r>
              <a:rPr lang="de-DE" sz="1300" dirty="0" err="1" smtClean="0"/>
              <a:t>humidity</a:t>
            </a:r>
            <a:r>
              <a:rPr lang="de-DE" sz="1300" dirty="0" smtClean="0"/>
              <a:t> </a:t>
            </a:r>
            <a:r>
              <a:rPr lang="de-DE" sz="1300" dirty="0" err="1" smtClean="0"/>
              <a:t>profiles</a:t>
            </a:r>
            <a:r>
              <a:rPr lang="de-DE" sz="1300" dirty="0" smtClean="0"/>
              <a:t> </a:t>
            </a:r>
            <a:r>
              <a:rPr lang="de-DE" sz="1300" dirty="0" err="1" smtClean="0"/>
              <a:t>during</a:t>
            </a:r>
            <a:r>
              <a:rPr lang="de-DE" sz="1300" dirty="0" smtClean="0"/>
              <a:t> </a:t>
            </a:r>
            <a:r>
              <a:rPr lang="de-DE" sz="1300" dirty="0" err="1" smtClean="0"/>
              <a:t>storage</a:t>
            </a:r>
            <a:r>
              <a:rPr lang="de-DE" sz="1300" dirty="0" smtClean="0"/>
              <a:t> </a:t>
            </a:r>
            <a:r>
              <a:rPr lang="de-DE" sz="1300" dirty="0" err="1" smtClean="0"/>
              <a:t>of</a:t>
            </a:r>
            <a:r>
              <a:rPr lang="de-DE" sz="1300" dirty="0" smtClean="0"/>
              <a:t> </a:t>
            </a:r>
            <a:r>
              <a:rPr lang="de-DE" sz="1300" dirty="0" err="1" smtClean="0"/>
              <a:t>dried</a:t>
            </a:r>
            <a:r>
              <a:rPr lang="de-DE" sz="1300" dirty="0" smtClean="0"/>
              <a:t> HEV </a:t>
            </a:r>
            <a:r>
              <a:rPr lang="de-DE" sz="1300" dirty="0" err="1" smtClean="0"/>
              <a:t>samples</a:t>
            </a:r>
            <a:r>
              <a:rPr lang="de-DE" sz="1300" dirty="0" smtClean="0"/>
              <a:t> at 3 </a:t>
            </a:r>
            <a:r>
              <a:rPr lang="de-DE" sz="1300" dirty="0" smtClean="0"/>
              <a:t>°C </a:t>
            </a:r>
            <a:r>
              <a:rPr lang="de-DE" sz="1300" dirty="0" err="1" smtClean="0"/>
              <a:t>as</a:t>
            </a:r>
            <a:r>
              <a:rPr lang="de-DE" sz="1300" dirty="0" smtClean="0"/>
              <a:t> </a:t>
            </a:r>
            <a:r>
              <a:rPr lang="de-DE" sz="1300" dirty="0" err="1" smtClean="0"/>
              <a:t>recorded</a:t>
            </a:r>
            <a:r>
              <a:rPr lang="de-DE" sz="1300" dirty="0" smtClean="0"/>
              <a:t> </a:t>
            </a:r>
            <a:r>
              <a:rPr lang="de-DE" sz="1300" dirty="0" err="1" smtClean="0"/>
              <a:t>by</a:t>
            </a:r>
            <a:r>
              <a:rPr lang="de-DE" sz="1300" dirty="0" smtClean="0"/>
              <a:t> </a:t>
            </a:r>
            <a:r>
              <a:rPr lang="de-DE" sz="1300" dirty="0" smtClean="0"/>
              <a:t>a </a:t>
            </a:r>
            <a:r>
              <a:rPr lang="de-DE" sz="1300" dirty="0" err="1" smtClean="0"/>
              <a:t>data</a:t>
            </a:r>
            <a:r>
              <a:rPr lang="de-DE" sz="1300" dirty="0" smtClean="0"/>
              <a:t> </a:t>
            </a:r>
            <a:r>
              <a:rPr lang="de-DE" sz="1300" dirty="0" err="1" smtClean="0"/>
              <a:t>logger</a:t>
            </a:r>
            <a:r>
              <a:rPr lang="de-DE" sz="1300" dirty="0" smtClean="0"/>
              <a:t>. The </a:t>
            </a:r>
            <a:r>
              <a:rPr lang="de-DE" sz="1300" dirty="0" err="1" smtClean="0"/>
              <a:t>measuring</a:t>
            </a:r>
            <a:r>
              <a:rPr lang="de-DE" sz="1300" dirty="0" smtClean="0"/>
              <a:t> </a:t>
            </a:r>
            <a:r>
              <a:rPr lang="de-DE" sz="1300" dirty="0" err="1" smtClean="0"/>
              <a:t>interval</a:t>
            </a:r>
            <a:r>
              <a:rPr lang="de-DE" sz="1300" dirty="0" smtClean="0"/>
              <a:t> was 1 </a:t>
            </a:r>
            <a:r>
              <a:rPr lang="de-DE" sz="1300" dirty="0" err="1" smtClean="0"/>
              <a:t>hour</a:t>
            </a:r>
            <a:r>
              <a:rPr lang="de-DE" sz="1300" dirty="0" smtClean="0"/>
              <a:t>. </a:t>
            </a:r>
            <a:endParaRPr lang="de-DE" sz="1300" dirty="0"/>
          </a:p>
        </p:txBody>
      </p:sp>
      <p:graphicFrame>
        <p:nvGraphicFramePr>
          <p:cNvPr id="6" name="Diagramm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0917093"/>
              </p:ext>
            </p:extLst>
          </p:nvPr>
        </p:nvGraphicFramePr>
        <p:xfrm>
          <a:off x="344488" y="692697"/>
          <a:ext cx="9217024" cy="47525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3912865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8</Words>
  <Application>Microsoft Office PowerPoint</Application>
  <PresentationFormat>A4-Papier (210 x 297 mm)</PresentationFormat>
  <Paragraphs>12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ＭＳ Ｐゴシック</vt:lpstr>
      <vt:lpstr>ＭＳ Ｐゴシック</vt:lpstr>
      <vt:lpstr>Arial</vt:lpstr>
      <vt:lpstr>Calibri</vt:lpstr>
      <vt:lpstr>Larissa</vt:lpstr>
      <vt:lpstr>PowerPoint-Präsentation</vt:lpstr>
      <vt:lpstr>PowerPoint-Präsentation</vt:lpstr>
    </vt:vector>
  </TitlesOfParts>
  <Company>Bundesinstitut fuer Risikobewertun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eimar Johne</dc:creator>
  <cp:lastModifiedBy>Herr Prof. Dr. Reimar Johne</cp:lastModifiedBy>
  <cp:revision>150</cp:revision>
  <dcterms:created xsi:type="dcterms:W3CDTF">2020-04-14T09:17:48Z</dcterms:created>
  <dcterms:modified xsi:type="dcterms:W3CDTF">2021-10-13T16:05:11Z</dcterms:modified>
</cp:coreProperties>
</file>